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5"/>
  </p:sldMasterIdLst>
  <p:notesMasterIdLst>
    <p:notesMasterId r:id="rId13"/>
  </p:notesMasterIdLst>
  <p:sldIdLst>
    <p:sldId id="281" r:id="rId6"/>
    <p:sldId id="286" r:id="rId7"/>
    <p:sldId id="284" r:id="rId8"/>
    <p:sldId id="703" r:id="rId9"/>
    <p:sldId id="704" r:id="rId10"/>
    <p:sldId id="280" r:id="rId11"/>
    <p:sldId id="702" r:id="rId12"/>
  </p:sldIdLst>
  <p:sldSz cx="6858000" cy="9906000" type="A4"/>
  <p:notesSz cx="6886575" cy="100171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0F7CA1A-DF9B-50D9-949F-25B8DE210AD9}" name="Hopcroft, Lorna" initials="HL" userId="S::kgsk887@astrazeneca.net::67a1a19a-5520-4fba-b489-dbb2959a0dc0" providerId="AD"/>
  <p188:author id="{AC15B167-D9BC-6524-46DF-767F1D064BEC}" name="Wigmore, Eleanor" initials="WE" userId="S::krrf893@astrazeneca.net::154496fa-10d7-4fd7-9fba-3614c367c37c"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08080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235636B-2F35-4CD8-94E3-98F05EA9FDA6}" v="11" dt="2023-06-28T12:08:55.64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80" d="100"/>
          <a:sy n="80" d="100"/>
        </p:scale>
        <p:origin x="3006"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customXml" Target="../customXml/item3.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20" Type="http://schemas.microsoft.com/office/2018/10/relationships/authors" Target="authors.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1.xml"/><Relationship Id="rId15" Type="http://schemas.openxmlformats.org/officeDocument/2006/relationships/viewProps" Target="viewProps.xml"/><Relationship Id="rId10" Type="http://schemas.openxmlformats.org/officeDocument/2006/relationships/slide" Target="slides/slide5.xml"/><Relationship Id="rId19" Type="http://schemas.microsoft.com/office/2015/10/relationships/revisionInfo" Target="revisionInfo.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Wigmore, Eleanor" userId="S::krrf893@astrazeneca.net::154496fa-10d7-4fd7-9fba-3614c367c37c" providerId="AD" clId="Web-{A16D7CD5-609E-9BF6-64F2-9BB57C0A97CE}"/>
    <pc:docChg chg="mod">
      <pc:chgData name="Wigmore, Eleanor" userId="S::krrf893@astrazeneca.net::154496fa-10d7-4fd7-9fba-3614c367c37c" providerId="AD" clId="Web-{A16D7CD5-609E-9BF6-64F2-9BB57C0A97CE}" dt="2023-06-19T09:00:06.522" v="1"/>
      <pc:docMkLst>
        <pc:docMk/>
      </pc:docMkLst>
      <pc:sldChg chg="modCm">
        <pc:chgData name="Wigmore, Eleanor" userId="S::krrf893@astrazeneca.net::154496fa-10d7-4fd7-9fba-3614c367c37c" providerId="AD" clId="Web-{A16D7CD5-609E-9BF6-64F2-9BB57C0A97CE}" dt="2023-06-19T09:00:06.522" v="1"/>
        <pc:sldMkLst>
          <pc:docMk/>
          <pc:sldMk cId="4136609356" sldId="284"/>
        </pc:sldMkLst>
      </pc:sldChg>
    </pc:docChg>
  </pc:docChgLst>
  <pc:docChgLst>
    <pc:chgData name="Barry, Simon" userId="cf786a99-d83b-49a2-aca2-9cbf10732fd4" providerId="ADAL" clId="{1235636B-2F35-4CD8-94E3-98F05EA9FDA6}"/>
    <pc:docChg chg="undo custSel modSld">
      <pc:chgData name="Barry, Simon" userId="cf786a99-d83b-49a2-aca2-9cbf10732fd4" providerId="ADAL" clId="{1235636B-2F35-4CD8-94E3-98F05EA9FDA6}" dt="2023-06-28T12:12:51.487" v="381" actId="1076"/>
      <pc:docMkLst>
        <pc:docMk/>
      </pc:docMkLst>
      <pc:sldChg chg="addSp delSp modSp mod">
        <pc:chgData name="Barry, Simon" userId="cf786a99-d83b-49a2-aca2-9cbf10732fd4" providerId="ADAL" clId="{1235636B-2F35-4CD8-94E3-98F05EA9FDA6}" dt="2023-06-28T12:12:51.487" v="381" actId="1076"/>
        <pc:sldMkLst>
          <pc:docMk/>
          <pc:sldMk cId="2783461508" sldId="702"/>
        </pc:sldMkLst>
        <pc:spChg chg="mod">
          <ac:chgData name="Barry, Simon" userId="cf786a99-d83b-49a2-aca2-9cbf10732fd4" providerId="ADAL" clId="{1235636B-2F35-4CD8-94E3-98F05EA9FDA6}" dt="2023-06-28T09:29:12.086" v="76" actId="1076"/>
          <ac:spMkLst>
            <pc:docMk/>
            <pc:sldMk cId="2783461508" sldId="702"/>
            <ac:spMk id="2" creationId="{BE2508A1-9A9A-E18E-A7B4-4FE48DAA8314}"/>
          </ac:spMkLst>
        </pc:spChg>
        <pc:spChg chg="mod">
          <ac:chgData name="Barry, Simon" userId="cf786a99-d83b-49a2-aca2-9cbf10732fd4" providerId="ADAL" clId="{1235636B-2F35-4CD8-94E3-98F05EA9FDA6}" dt="2023-06-28T11:30:31.070" v="271" actId="1076"/>
          <ac:spMkLst>
            <pc:docMk/>
            <pc:sldMk cId="2783461508" sldId="702"/>
            <ac:spMk id="7" creationId="{690B4F0A-23A9-327F-F2C4-F9A788044BCE}"/>
          </ac:spMkLst>
        </pc:spChg>
        <pc:spChg chg="mod">
          <ac:chgData name="Barry, Simon" userId="cf786a99-d83b-49a2-aca2-9cbf10732fd4" providerId="ADAL" clId="{1235636B-2F35-4CD8-94E3-98F05EA9FDA6}" dt="2023-06-28T12:12:51.487" v="381" actId="1076"/>
          <ac:spMkLst>
            <pc:docMk/>
            <pc:sldMk cId="2783461508" sldId="702"/>
            <ac:spMk id="15" creationId="{0475FDF5-3F28-F449-F6B0-9C2E08286F81}"/>
          </ac:spMkLst>
        </pc:spChg>
        <pc:spChg chg="mod">
          <ac:chgData name="Barry, Simon" userId="cf786a99-d83b-49a2-aca2-9cbf10732fd4" providerId="ADAL" clId="{1235636B-2F35-4CD8-94E3-98F05EA9FDA6}" dt="2023-06-28T12:12:39.121" v="380" actId="1076"/>
          <ac:spMkLst>
            <pc:docMk/>
            <pc:sldMk cId="2783461508" sldId="702"/>
            <ac:spMk id="16" creationId="{3526AB64-B27B-87D2-21E8-A0AF9FEB2CAD}"/>
          </ac:spMkLst>
        </pc:spChg>
        <pc:spChg chg="mod">
          <ac:chgData name="Barry, Simon" userId="cf786a99-d83b-49a2-aca2-9cbf10732fd4" providerId="ADAL" clId="{1235636B-2F35-4CD8-94E3-98F05EA9FDA6}" dt="2023-06-28T11:30:31.070" v="271" actId="1076"/>
          <ac:spMkLst>
            <pc:docMk/>
            <pc:sldMk cId="2783461508" sldId="702"/>
            <ac:spMk id="24" creationId="{17F050F3-5194-D186-0D19-8152169D6E3F}"/>
          </ac:spMkLst>
        </pc:spChg>
        <pc:spChg chg="mod">
          <ac:chgData name="Barry, Simon" userId="cf786a99-d83b-49a2-aca2-9cbf10732fd4" providerId="ADAL" clId="{1235636B-2F35-4CD8-94E3-98F05EA9FDA6}" dt="2023-06-28T12:11:28.535" v="349" actId="1037"/>
          <ac:spMkLst>
            <pc:docMk/>
            <pc:sldMk cId="2783461508" sldId="702"/>
            <ac:spMk id="41" creationId="{2DB41E03-24E5-EEDD-7046-25B06366DAA3}"/>
          </ac:spMkLst>
        </pc:spChg>
        <pc:graphicFrameChg chg="del mod">
          <ac:chgData name="Barry, Simon" userId="cf786a99-d83b-49a2-aca2-9cbf10732fd4" providerId="ADAL" clId="{1235636B-2F35-4CD8-94E3-98F05EA9FDA6}" dt="2023-06-28T09:31:39.685" v="155" actId="21"/>
          <ac:graphicFrameMkLst>
            <pc:docMk/>
            <pc:sldMk cId="2783461508" sldId="702"/>
            <ac:graphicFrameMk id="3" creationId="{86AFC003-3E9E-C2FC-3A44-F09BCA847E37}"/>
          </ac:graphicFrameMkLst>
        </pc:graphicFrameChg>
        <pc:graphicFrameChg chg="add del mod">
          <ac:chgData name="Barry, Simon" userId="cf786a99-d83b-49a2-aca2-9cbf10732fd4" providerId="ADAL" clId="{1235636B-2F35-4CD8-94E3-98F05EA9FDA6}" dt="2023-06-28T09:32:19.863" v="162" actId="21"/>
          <ac:graphicFrameMkLst>
            <pc:docMk/>
            <pc:sldMk cId="2783461508" sldId="702"/>
            <ac:graphicFrameMk id="4" creationId="{3A22B1D2-1FF1-02B6-65EE-6F1CEB9927F3}"/>
          </ac:graphicFrameMkLst>
        </pc:graphicFrameChg>
        <pc:graphicFrameChg chg="add del mod">
          <ac:chgData name="Barry, Simon" userId="cf786a99-d83b-49a2-aca2-9cbf10732fd4" providerId="ADAL" clId="{1235636B-2F35-4CD8-94E3-98F05EA9FDA6}" dt="2023-06-28T09:33:16.809" v="179" actId="21"/>
          <ac:graphicFrameMkLst>
            <pc:docMk/>
            <pc:sldMk cId="2783461508" sldId="702"/>
            <ac:graphicFrameMk id="8" creationId="{6AB68F0A-15F8-A0A5-6DC4-8DC240762606}"/>
          </ac:graphicFrameMkLst>
        </pc:graphicFrameChg>
        <pc:graphicFrameChg chg="mod">
          <ac:chgData name="Barry, Simon" userId="cf786a99-d83b-49a2-aca2-9cbf10732fd4" providerId="ADAL" clId="{1235636B-2F35-4CD8-94E3-98F05EA9FDA6}" dt="2023-06-28T11:30:31.070" v="271" actId="1076"/>
          <ac:graphicFrameMkLst>
            <pc:docMk/>
            <pc:sldMk cId="2783461508" sldId="702"/>
            <ac:graphicFrameMk id="35" creationId="{A4058A3D-3223-33B0-2E24-C41CA2CD53EB}"/>
          </ac:graphicFrameMkLst>
        </pc:graphicFrameChg>
        <pc:graphicFrameChg chg="mod">
          <ac:chgData name="Barry, Simon" userId="cf786a99-d83b-49a2-aca2-9cbf10732fd4" providerId="ADAL" clId="{1235636B-2F35-4CD8-94E3-98F05EA9FDA6}" dt="2023-06-28T11:30:31.070" v="271" actId="1076"/>
          <ac:graphicFrameMkLst>
            <pc:docMk/>
            <pc:sldMk cId="2783461508" sldId="702"/>
            <ac:graphicFrameMk id="36" creationId="{9BD7B739-1E3D-955C-2E6F-F70A120EE103}"/>
          </ac:graphicFrameMkLst>
        </pc:graphicFrameChg>
        <pc:graphicFrameChg chg="mod">
          <ac:chgData name="Barry, Simon" userId="cf786a99-d83b-49a2-aca2-9cbf10732fd4" providerId="ADAL" clId="{1235636B-2F35-4CD8-94E3-98F05EA9FDA6}" dt="2023-06-28T11:30:31.070" v="271" actId="1076"/>
          <ac:graphicFrameMkLst>
            <pc:docMk/>
            <pc:sldMk cId="2783461508" sldId="702"/>
            <ac:graphicFrameMk id="37" creationId="{55709A9B-B64A-093A-A42B-A66E14DEF1C9}"/>
          </ac:graphicFrameMkLst>
        </pc:graphicFrameChg>
        <pc:graphicFrameChg chg="mod">
          <ac:chgData name="Barry, Simon" userId="cf786a99-d83b-49a2-aca2-9cbf10732fd4" providerId="ADAL" clId="{1235636B-2F35-4CD8-94E3-98F05EA9FDA6}" dt="2023-06-28T11:30:31.070" v="271" actId="1076"/>
          <ac:graphicFrameMkLst>
            <pc:docMk/>
            <pc:sldMk cId="2783461508" sldId="702"/>
            <ac:graphicFrameMk id="38" creationId="{06CB48F0-8299-287A-A155-249ECD8715AC}"/>
          </ac:graphicFrameMkLst>
        </pc:graphicFrameChg>
        <pc:graphicFrameChg chg="mod">
          <ac:chgData name="Barry, Simon" userId="cf786a99-d83b-49a2-aca2-9cbf10732fd4" providerId="ADAL" clId="{1235636B-2F35-4CD8-94E3-98F05EA9FDA6}" dt="2023-06-28T11:30:31.070" v="271" actId="1076"/>
          <ac:graphicFrameMkLst>
            <pc:docMk/>
            <pc:sldMk cId="2783461508" sldId="702"/>
            <ac:graphicFrameMk id="39" creationId="{CF9B2906-1C81-85C8-C863-A620A2E4297C}"/>
          </ac:graphicFrameMkLst>
        </pc:graphicFrameChg>
        <pc:graphicFrameChg chg="mod">
          <ac:chgData name="Barry, Simon" userId="cf786a99-d83b-49a2-aca2-9cbf10732fd4" providerId="ADAL" clId="{1235636B-2F35-4CD8-94E3-98F05EA9FDA6}" dt="2023-06-28T11:30:31.070" v="271" actId="1076"/>
          <ac:graphicFrameMkLst>
            <pc:docMk/>
            <pc:sldMk cId="2783461508" sldId="702"/>
            <ac:graphicFrameMk id="40" creationId="{9DD8CAB0-B12F-E2FB-72C6-58CA717977C9}"/>
          </ac:graphicFrameMkLst>
        </pc:graphicFrameChg>
        <pc:graphicFrameChg chg="mod">
          <ac:chgData name="Barry, Simon" userId="cf786a99-d83b-49a2-aca2-9cbf10732fd4" providerId="ADAL" clId="{1235636B-2F35-4CD8-94E3-98F05EA9FDA6}" dt="2023-06-28T11:30:31.070" v="271" actId="1076"/>
          <ac:graphicFrameMkLst>
            <pc:docMk/>
            <pc:sldMk cId="2783461508" sldId="702"/>
            <ac:graphicFrameMk id="45" creationId="{4A14629F-CFCD-DEC4-864C-A14EA62EC529}"/>
          </ac:graphicFrameMkLst>
        </pc:graphicFrameChg>
        <pc:picChg chg="del mod">
          <ac:chgData name="Barry, Simon" userId="cf786a99-d83b-49a2-aca2-9cbf10732fd4" providerId="ADAL" clId="{1235636B-2F35-4CD8-94E3-98F05EA9FDA6}" dt="2023-06-28T11:29:43.451" v="265" actId="478"/>
          <ac:picMkLst>
            <pc:docMk/>
            <pc:sldMk cId="2783461508" sldId="702"/>
            <ac:picMk id="5" creationId="{648C92D0-09A2-6E96-5382-5D478C206215}"/>
          </ac:picMkLst>
        </pc:picChg>
        <pc:picChg chg="add mod modCrop">
          <ac:chgData name="Barry, Simon" userId="cf786a99-d83b-49a2-aca2-9cbf10732fd4" providerId="ADAL" clId="{1235636B-2F35-4CD8-94E3-98F05EA9FDA6}" dt="2023-06-28T12:11:48.859" v="358" actId="1037"/>
          <ac:picMkLst>
            <pc:docMk/>
            <pc:sldMk cId="2783461508" sldId="702"/>
            <ac:picMk id="6" creationId="{8B93F78C-5465-C3B4-55BB-B0B78FAE47BA}"/>
          </ac:picMkLst>
        </pc:picChg>
        <pc:picChg chg="add del mod modCrop">
          <ac:chgData name="Barry, Simon" userId="cf786a99-d83b-49a2-aca2-9cbf10732fd4" providerId="ADAL" clId="{1235636B-2F35-4CD8-94E3-98F05EA9FDA6}" dt="2023-06-28T09:33:10.412" v="175"/>
          <ac:picMkLst>
            <pc:docMk/>
            <pc:sldMk cId="2783461508" sldId="702"/>
            <ac:picMk id="9" creationId="{D2C0CC9F-CEF5-1DFA-F9E8-FE280C910A70}"/>
          </ac:picMkLst>
        </pc:picChg>
        <pc:picChg chg="add mod modCrop">
          <ac:chgData name="Barry, Simon" userId="cf786a99-d83b-49a2-aca2-9cbf10732fd4" providerId="ADAL" clId="{1235636B-2F35-4CD8-94E3-98F05EA9FDA6}" dt="2023-06-28T12:12:25.280" v="379" actId="1036"/>
          <ac:picMkLst>
            <pc:docMk/>
            <pc:sldMk cId="2783461508" sldId="702"/>
            <ac:picMk id="10" creationId="{74B9AF25-111D-744A-9834-77CD88FB1CD0}"/>
          </ac:picMkLst>
        </pc:picChg>
        <pc:picChg chg="add mod modCrop">
          <ac:chgData name="Barry, Simon" userId="cf786a99-d83b-49a2-aca2-9cbf10732fd4" providerId="ADAL" clId="{1235636B-2F35-4CD8-94E3-98F05EA9FDA6}" dt="2023-06-28T12:11:39.336" v="351" actId="1038"/>
          <ac:picMkLst>
            <pc:docMk/>
            <pc:sldMk cId="2783461508" sldId="702"/>
            <ac:picMk id="11" creationId="{18C17C1E-4216-6857-83AB-2F372086566C}"/>
          </ac:picMkLst>
        </pc:picChg>
        <pc:picChg chg="add mod modCrop">
          <ac:chgData name="Barry, Simon" userId="cf786a99-d83b-49a2-aca2-9cbf10732fd4" providerId="ADAL" clId="{1235636B-2F35-4CD8-94E3-98F05EA9FDA6}" dt="2023-06-28T12:11:41.344" v="353" actId="1038"/>
          <ac:picMkLst>
            <pc:docMk/>
            <pc:sldMk cId="2783461508" sldId="702"/>
            <ac:picMk id="12" creationId="{88E0439D-DBC0-DB70-4CCC-6DE4EFB20DF1}"/>
          </ac:picMkLst>
        </pc:picChg>
      </pc:sldChg>
    </pc:docChg>
  </pc:docChgLst>
  <pc:docChgLst>
    <pc:chgData name="Wigmore, Eleanor" userId="S::krrf893@astrazeneca.net::154496fa-10d7-4fd7-9fba-3614c367c37c" providerId="AD" clId="Web-{0208909F-8979-C93A-9EE0-363F382556AA}"/>
    <pc:docChg chg="modSld">
      <pc:chgData name="Wigmore, Eleanor" userId="S::krrf893@astrazeneca.net::154496fa-10d7-4fd7-9fba-3614c367c37c" providerId="AD" clId="Web-{0208909F-8979-C93A-9EE0-363F382556AA}" dt="2023-06-12T19:03:28.254" v="2" actId="20577"/>
      <pc:docMkLst>
        <pc:docMk/>
      </pc:docMkLst>
      <pc:sldChg chg="addSp modSp">
        <pc:chgData name="Wigmore, Eleanor" userId="S::krrf893@astrazeneca.net::154496fa-10d7-4fd7-9fba-3614c367c37c" providerId="AD" clId="Web-{0208909F-8979-C93A-9EE0-363F382556AA}" dt="2023-06-12T19:03:28.254" v="2" actId="20577"/>
        <pc:sldMkLst>
          <pc:docMk/>
          <pc:sldMk cId="586963921" sldId="281"/>
        </pc:sldMkLst>
        <pc:spChg chg="add mod">
          <ac:chgData name="Wigmore, Eleanor" userId="S::krrf893@astrazeneca.net::154496fa-10d7-4fd7-9fba-3614c367c37c" providerId="AD" clId="Web-{0208909F-8979-C93A-9EE0-363F382556AA}" dt="2023-06-12T19:03:28.254" v="2" actId="20577"/>
          <ac:spMkLst>
            <pc:docMk/>
            <pc:sldMk cId="586963921" sldId="281"/>
            <ac:spMk id="3" creationId="{2AA4D702-384A-4A31-C9AA-0978B445134A}"/>
          </ac:spMkLst>
        </pc:spChg>
      </pc:sldChg>
    </pc:docChg>
  </pc:docChgLst>
  <pc:docChgLst>
    <pc:chgData name="Hopcroft, Lorna" userId="S::kgsk887@astrazeneca.net::67a1a19a-5520-4fba-b489-dbb2959a0dc0" providerId="AD" clId="Web-{C4AA7B4D-20FF-26D0-EED9-326D8FEB7B74}"/>
    <pc:docChg chg="modSld">
      <pc:chgData name="Hopcroft, Lorna" userId="S::kgsk887@astrazeneca.net::67a1a19a-5520-4fba-b489-dbb2959a0dc0" providerId="AD" clId="Web-{C4AA7B4D-20FF-26D0-EED9-326D8FEB7B74}" dt="2023-06-01T09:28:10.087" v="8"/>
      <pc:docMkLst>
        <pc:docMk/>
      </pc:docMkLst>
      <pc:sldChg chg="addSp delSp modSp">
        <pc:chgData name="Hopcroft, Lorna" userId="S::kgsk887@astrazeneca.net::67a1a19a-5520-4fba-b489-dbb2959a0dc0" providerId="AD" clId="Web-{C4AA7B4D-20FF-26D0-EED9-326D8FEB7B74}" dt="2023-06-01T09:28:10.087" v="8"/>
        <pc:sldMkLst>
          <pc:docMk/>
          <pc:sldMk cId="586963921" sldId="281"/>
        </pc:sldMkLst>
        <pc:picChg chg="add del mod">
          <ac:chgData name="Hopcroft, Lorna" userId="S::kgsk887@astrazeneca.net::67a1a19a-5520-4fba-b489-dbb2959a0dc0" providerId="AD" clId="Web-{C4AA7B4D-20FF-26D0-EED9-326D8FEB7B74}" dt="2023-06-01T09:26:48.131" v="1"/>
          <ac:picMkLst>
            <pc:docMk/>
            <pc:sldMk cId="586963921" sldId="281"/>
            <ac:picMk id="3" creationId="{2E0C88CC-1253-16D3-F13E-C572E800EF0C}"/>
          </ac:picMkLst>
        </pc:picChg>
        <pc:picChg chg="add del mod">
          <ac:chgData name="Hopcroft, Lorna" userId="S::kgsk887@astrazeneca.net::67a1a19a-5520-4fba-b489-dbb2959a0dc0" providerId="AD" clId="Web-{C4AA7B4D-20FF-26D0-EED9-326D8FEB7B74}" dt="2023-06-01T09:28:10.087" v="8"/>
          <ac:picMkLst>
            <pc:docMk/>
            <pc:sldMk cId="586963921" sldId="281"/>
            <ac:picMk id="4" creationId="{68414F96-37E7-D2E2-1812-DFB68FB98A25}"/>
          </ac:picMkLst>
        </pc:picChg>
        <pc:picChg chg="add del mod">
          <ac:chgData name="Hopcroft, Lorna" userId="S::kgsk887@astrazeneca.net::67a1a19a-5520-4fba-b489-dbb2959a0dc0" providerId="AD" clId="Web-{C4AA7B4D-20FF-26D0-EED9-326D8FEB7B74}" dt="2023-06-01T09:27:58.430" v="5"/>
          <ac:picMkLst>
            <pc:docMk/>
            <pc:sldMk cId="586963921" sldId="281"/>
            <ac:picMk id="5" creationId="{624A967C-144A-4580-FFA3-4F5ECC00B468}"/>
          </ac:picMkLst>
        </pc:picChg>
      </pc:sldChg>
    </pc:docChg>
  </pc:docChgLst>
  <pc:docChgLst>
    <pc:chgData name="Wigmore, Eleanor" userId="S::krrf893@astrazeneca.net::154496fa-10d7-4fd7-9fba-3614c367c37c" providerId="AD" clId="Web-{F5B0707F-F749-5AD1-F9B3-59E68A54C1D9}"/>
    <pc:docChg chg="modSld">
      <pc:chgData name="Wigmore, Eleanor" userId="S::krrf893@astrazeneca.net::154496fa-10d7-4fd7-9fba-3614c367c37c" providerId="AD" clId="Web-{F5B0707F-F749-5AD1-F9B3-59E68A54C1D9}" dt="2023-06-07T16:31:48.938" v="27" actId="20577"/>
      <pc:docMkLst>
        <pc:docMk/>
      </pc:docMkLst>
      <pc:sldChg chg="addSp delSp modSp">
        <pc:chgData name="Wigmore, Eleanor" userId="S::krrf893@astrazeneca.net::154496fa-10d7-4fd7-9fba-3614c367c37c" providerId="AD" clId="Web-{F5B0707F-F749-5AD1-F9B3-59E68A54C1D9}" dt="2023-06-07T16:31:48.938" v="27" actId="20577"/>
        <pc:sldMkLst>
          <pc:docMk/>
          <pc:sldMk cId="586963921" sldId="281"/>
        </pc:sldMkLst>
        <pc:spChg chg="add del mod">
          <ac:chgData name="Wigmore, Eleanor" userId="S::krrf893@astrazeneca.net::154496fa-10d7-4fd7-9fba-3614c367c37c" providerId="AD" clId="Web-{F5B0707F-F749-5AD1-F9B3-59E68A54C1D9}" dt="2023-06-07T16:30:14.482" v="12"/>
          <ac:spMkLst>
            <pc:docMk/>
            <pc:sldMk cId="586963921" sldId="281"/>
            <ac:spMk id="2" creationId="{6B6219CE-3505-1C97-7923-F67DF02AA6DE}"/>
          </ac:spMkLst>
        </pc:spChg>
        <pc:spChg chg="add del mod">
          <ac:chgData name="Wigmore, Eleanor" userId="S::krrf893@astrazeneca.net::154496fa-10d7-4fd7-9fba-3614c367c37c" providerId="AD" clId="Web-{F5B0707F-F749-5AD1-F9B3-59E68A54C1D9}" dt="2023-06-07T16:30:16.857" v="13"/>
          <ac:spMkLst>
            <pc:docMk/>
            <pc:sldMk cId="586963921" sldId="281"/>
            <ac:spMk id="8" creationId="{80CC500B-E47F-5996-0160-E21589A11206}"/>
          </ac:spMkLst>
        </pc:spChg>
        <pc:spChg chg="add mod">
          <ac:chgData name="Wigmore, Eleanor" userId="S::krrf893@astrazeneca.net::154496fa-10d7-4fd7-9fba-3614c367c37c" providerId="AD" clId="Web-{F5B0707F-F749-5AD1-F9B3-59E68A54C1D9}" dt="2023-06-07T16:31:48.938" v="27" actId="20577"/>
          <ac:spMkLst>
            <pc:docMk/>
            <pc:sldMk cId="586963921" sldId="281"/>
            <ac:spMk id="9" creationId="{140121A6-4F0A-EF2C-5E7D-07D6C0558721}"/>
          </ac:spMkLst>
        </pc:spChg>
        <pc:spChg chg="mod">
          <ac:chgData name="Wigmore, Eleanor" userId="S::krrf893@astrazeneca.net::154496fa-10d7-4fd7-9fba-3614c367c37c" providerId="AD" clId="Web-{F5B0707F-F749-5AD1-F9B3-59E68A54C1D9}" dt="2023-06-07T16:31:28.875" v="22" actId="1076"/>
          <ac:spMkLst>
            <pc:docMk/>
            <pc:sldMk cId="586963921" sldId="281"/>
            <ac:spMk id="35" creationId="{3CE29AB5-28B1-4DB3-8D3A-CB5D434B155D}"/>
          </ac:spMkLst>
        </pc:spChg>
        <pc:spChg chg="mod">
          <ac:chgData name="Wigmore, Eleanor" userId="S::krrf893@astrazeneca.net::154496fa-10d7-4fd7-9fba-3614c367c37c" providerId="AD" clId="Web-{F5B0707F-F749-5AD1-F9B3-59E68A54C1D9}" dt="2023-06-07T16:31:23.062" v="19" actId="1076"/>
          <ac:spMkLst>
            <pc:docMk/>
            <pc:sldMk cId="586963921" sldId="281"/>
            <ac:spMk id="48" creationId="{BD5A70AE-D167-4073-B87E-B94112D817E1}"/>
          </ac:spMkLst>
        </pc:spChg>
        <pc:spChg chg="del mod">
          <ac:chgData name="Wigmore, Eleanor" userId="S::krrf893@astrazeneca.net::154496fa-10d7-4fd7-9fba-3614c367c37c" providerId="AD" clId="Web-{F5B0707F-F749-5AD1-F9B3-59E68A54C1D9}" dt="2023-06-07T16:31:37.250" v="23"/>
          <ac:spMkLst>
            <pc:docMk/>
            <pc:sldMk cId="586963921" sldId="281"/>
            <ac:spMk id="68" creationId="{7726A3AF-3BD0-43A2-BD9E-0C1328287638}"/>
          </ac:spMkLst>
        </pc:spChg>
        <pc:grpChg chg="mod">
          <ac:chgData name="Wigmore, Eleanor" userId="S::krrf893@astrazeneca.net::154496fa-10d7-4fd7-9fba-3614c367c37c" providerId="AD" clId="Web-{F5B0707F-F749-5AD1-F9B3-59E68A54C1D9}" dt="2023-06-07T16:30:44.092" v="15" actId="1076"/>
          <ac:grpSpMkLst>
            <pc:docMk/>
            <pc:sldMk cId="586963921" sldId="281"/>
            <ac:grpSpMk id="4" creationId="{1548FF75-10F6-C26E-EE50-7C2CEBBB6089}"/>
          </ac:grpSpMkLst>
        </pc:grpChg>
        <pc:picChg chg="mod">
          <ac:chgData name="Wigmore, Eleanor" userId="S::krrf893@astrazeneca.net::154496fa-10d7-4fd7-9fba-3614c367c37c" providerId="AD" clId="Web-{F5B0707F-F749-5AD1-F9B3-59E68A54C1D9}" dt="2023-06-07T16:31:23.094" v="21" actId="1076"/>
          <ac:picMkLst>
            <pc:docMk/>
            <pc:sldMk cId="586963921" sldId="281"/>
            <ac:picMk id="3" creationId="{721CEB35-2DFB-1BE1-41EF-CC318D043FC2}"/>
          </ac:picMkLst>
        </pc:picChg>
      </pc:sldChg>
    </pc:docChg>
  </pc:docChgLst>
  <pc:docChgLst>
    <pc:chgData name="Hopcroft, Lorna" userId="67a1a19a-5520-4fba-b489-dbb2959a0dc0" providerId="ADAL" clId="{17698B96-A31F-43B4-B455-D694C8AFA03B}"/>
    <pc:docChg chg="custSel modSld">
      <pc:chgData name="Hopcroft, Lorna" userId="67a1a19a-5520-4fba-b489-dbb2959a0dc0" providerId="ADAL" clId="{17698B96-A31F-43B4-B455-D694C8AFA03B}" dt="2023-06-14T10:14:39.674" v="62"/>
      <pc:docMkLst>
        <pc:docMk/>
      </pc:docMkLst>
      <pc:sldChg chg="delSp modSp mod">
        <pc:chgData name="Hopcroft, Lorna" userId="67a1a19a-5520-4fba-b489-dbb2959a0dc0" providerId="ADAL" clId="{17698B96-A31F-43B4-B455-D694C8AFA03B}" dt="2023-06-14T09:58:41.369" v="56" actId="1038"/>
        <pc:sldMkLst>
          <pc:docMk/>
          <pc:sldMk cId="586963921" sldId="281"/>
        </pc:sldMkLst>
        <pc:spChg chg="mod">
          <ac:chgData name="Hopcroft, Lorna" userId="67a1a19a-5520-4fba-b489-dbb2959a0dc0" providerId="ADAL" clId="{17698B96-A31F-43B4-B455-D694C8AFA03B}" dt="2023-06-14T09:58:41.369" v="56" actId="1038"/>
          <ac:spMkLst>
            <pc:docMk/>
            <pc:sldMk cId="586963921" sldId="281"/>
            <ac:spMk id="3" creationId="{2AA4D702-384A-4A31-C9AA-0978B445134A}"/>
          </ac:spMkLst>
        </pc:spChg>
        <pc:spChg chg="del">
          <ac:chgData name="Hopcroft, Lorna" userId="67a1a19a-5520-4fba-b489-dbb2959a0dc0" providerId="ADAL" clId="{17698B96-A31F-43B4-B455-D694C8AFA03B}" dt="2023-06-08T10:56:22.810" v="1" actId="478"/>
          <ac:spMkLst>
            <pc:docMk/>
            <pc:sldMk cId="586963921" sldId="281"/>
            <ac:spMk id="9" creationId="{140121A6-4F0A-EF2C-5E7D-07D6C0558721}"/>
          </ac:spMkLst>
        </pc:spChg>
        <pc:spChg chg="mod">
          <ac:chgData name="Hopcroft, Lorna" userId="67a1a19a-5520-4fba-b489-dbb2959a0dc0" providerId="ADAL" clId="{17698B96-A31F-43B4-B455-D694C8AFA03B}" dt="2023-06-14T09:58:41.369" v="56" actId="1038"/>
          <ac:spMkLst>
            <pc:docMk/>
            <pc:sldMk cId="586963921" sldId="281"/>
            <ac:spMk id="15" creationId="{228FEBB8-0390-8D1B-723D-F09E5466C48F}"/>
          </ac:spMkLst>
        </pc:spChg>
        <pc:spChg chg="mod">
          <ac:chgData name="Hopcroft, Lorna" userId="67a1a19a-5520-4fba-b489-dbb2959a0dc0" providerId="ADAL" clId="{17698B96-A31F-43B4-B455-D694C8AFA03B}" dt="2023-06-14T09:58:20.781" v="41" actId="6549"/>
          <ac:spMkLst>
            <pc:docMk/>
            <pc:sldMk cId="586963921" sldId="281"/>
            <ac:spMk id="25" creationId="{B0E6D0CD-0C30-37AA-4373-6E6247A67433}"/>
          </ac:spMkLst>
        </pc:spChg>
        <pc:spChg chg="mod">
          <ac:chgData name="Hopcroft, Lorna" userId="67a1a19a-5520-4fba-b489-dbb2959a0dc0" providerId="ADAL" clId="{17698B96-A31F-43B4-B455-D694C8AFA03B}" dt="2023-06-14T09:58:26.660" v="44" actId="20577"/>
          <ac:spMkLst>
            <pc:docMk/>
            <pc:sldMk cId="586963921" sldId="281"/>
            <ac:spMk id="26" creationId="{5C4B99EA-B8A8-CB5B-BB1B-4A666CFB5B88}"/>
          </ac:spMkLst>
        </pc:spChg>
        <pc:spChg chg="mod">
          <ac:chgData name="Hopcroft, Lorna" userId="67a1a19a-5520-4fba-b489-dbb2959a0dc0" providerId="ADAL" clId="{17698B96-A31F-43B4-B455-D694C8AFA03B}" dt="2023-06-08T10:56:38.234" v="4" actId="1076"/>
          <ac:spMkLst>
            <pc:docMk/>
            <pc:sldMk cId="586963921" sldId="281"/>
            <ac:spMk id="34" creationId="{17875CF9-229F-4130-AFEB-CDFD8B3CD650}"/>
          </ac:spMkLst>
        </pc:spChg>
        <pc:spChg chg="mod">
          <ac:chgData name="Hopcroft, Lorna" userId="67a1a19a-5520-4fba-b489-dbb2959a0dc0" providerId="ADAL" clId="{17698B96-A31F-43B4-B455-D694C8AFA03B}" dt="2023-06-08T10:56:50.559" v="17" actId="1037"/>
          <ac:spMkLst>
            <pc:docMk/>
            <pc:sldMk cId="586963921" sldId="281"/>
            <ac:spMk id="48" creationId="{BD5A70AE-D167-4073-B87E-B94112D817E1}"/>
          </ac:spMkLst>
        </pc:spChg>
        <pc:grpChg chg="mod">
          <ac:chgData name="Hopcroft, Lorna" userId="67a1a19a-5520-4fba-b489-dbb2959a0dc0" providerId="ADAL" clId="{17698B96-A31F-43B4-B455-D694C8AFA03B}" dt="2023-06-08T10:58:45.329" v="33" actId="1035"/>
          <ac:grpSpMkLst>
            <pc:docMk/>
            <pc:sldMk cId="586963921" sldId="281"/>
            <ac:grpSpMk id="4" creationId="{1548FF75-10F6-C26E-EE50-7C2CEBBB6089}"/>
          </ac:grpSpMkLst>
        </pc:grpChg>
        <pc:picChg chg="del">
          <ac:chgData name="Hopcroft, Lorna" userId="67a1a19a-5520-4fba-b489-dbb2959a0dc0" providerId="ADAL" clId="{17698B96-A31F-43B4-B455-D694C8AFA03B}" dt="2023-06-08T10:56:08.468" v="0" actId="478"/>
          <ac:picMkLst>
            <pc:docMk/>
            <pc:sldMk cId="586963921" sldId="281"/>
            <ac:picMk id="45" creationId="{56A8B68E-9651-4D81-90EA-2324397075B0}"/>
          </ac:picMkLst>
        </pc:picChg>
      </pc:sldChg>
      <pc:sldChg chg="modSp mod">
        <pc:chgData name="Hopcroft, Lorna" userId="67a1a19a-5520-4fba-b489-dbb2959a0dc0" providerId="ADAL" clId="{17698B96-A31F-43B4-B455-D694C8AFA03B}" dt="2023-06-14T10:09:26.265" v="58" actId="20577"/>
        <pc:sldMkLst>
          <pc:docMk/>
          <pc:sldMk cId="4136609356" sldId="284"/>
        </pc:sldMkLst>
        <pc:spChg chg="mod">
          <ac:chgData name="Hopcroft, Lorna" userId="67a1a19a-5520-4fba-b489-dbb2959a0dc0" providerId="ADAL" clId="{17698B96-A31F-43B4-B455-D694C8AFA03B}" dt="2023-06-14T10:09:26.265" v="58" actId="20577"/>
          <ac:spMkLst>
            <pc:docMk/>
            <pc:sldMk cId="4136609356" sldId="284"/>
            <ac:spMk id="14" creationId="{08E831A7-03B9-0D52-7025-40F70F885FF9}"/>
          </ac:spMkLst>
        </pc:spChg>
      </pc:sldChg>
      <pc:sldChg chg="modSp">
        <pc:chgData name="Hopcroft, Lorna" userId="67a1a19a-5520-4fba-b489-dbb2959a0dc0" providerId="ADAL" clId="{17698B96-A31F-43B4-B455-D694C8AFA03B}" dt="2023-06-14T10:14:39.674" v="62"/>
        <pc:sldMkLst>
          <pc:docMk/>
          <pc:sldMk cId="2783461508" sldId="702"/>
        </pc:sldMkLst>
        <pc:graphicFrameChg chg="mod">
          <ac:chgData name="Hopcroft, Lorna" userId="67a1a19a-5520-4fba-b489-dbb2959a0dc0" providerId="ADAL" clId="{17698B96-A31F-43B4-B455-D694C8AFA03B}" dt="2023-06-14T10:14:29.171" v="60"/>
          <ac:graphicFrameMkLst>
            <pc:docMk/>
            <pc:sldMk cId="2783461508" sldId="702"/>
            <ac:graphicFrameMk id="35" creationId="{A4058A3D-3223-33B0-2E24-C41CA2CD53EB}"/>
          </ac:graphicFrameMkLst>
        </pc:graphicFrameChg>
        <pc:graphicFrameChg chg="mod">
          <ac:chgData name="Hopcroft, Lorna" userId="67a1a19a-5520-4fba-b489-dbb2959a0dc0" providerId="ADAL" clId="{17698B96-A31F-43B4-B455-D694C8AFA03B}" dt="2023-06-14T10:14:39.674" v="62"/>
          <ac:graphicFrameMkLst>
            <pc:docMk/>
            <pc:sldMk cId="2783461508" sldId="702"/>
            <ac:graphicFrameMk id="37" creationId="{55709A9B-B64A-093A-A42B-A66E14DEF1C9}"/>
          </ac:graphicFrameMkLst>
        </pc:graphicFrameChg>
      </pc:sldChg>
    </pc:docChg>
  </pc:docChgLst>
  <pc:docChgLst>
    <pc:chgData name="Wigmore, Eleanor" userId="154496fa-10d7-4fd7-9fba-3614c367c37c" providerId="ADAL" clId="{DB100BF2-9E91-4732-AB89-AFAB26CA84C1}"/>
    <pc:docChg chg="undo custSel modSld">
      <pc:chgData name="Wigmore, Eleanor" userId="154496fa-10d7-4fd7-9fba-3614c367c37c" providerId="ADAL" clId="{DB100BF2-9E91-4732-AB89-AFAB26CA84C1}" dt="2023-06-19T08:57:53.779" v="682" actId="478"/>
      <pc:docMkLst>
        <pc:docMk/>
      </pc:docMkLst>
      <pc:sldChg chg="addSp delSp modSp mod">
        <pc:chgData name="Wigmore, Eleanor" userId="154496fa-10d7-4fd7-9fba-3614c367c37c" providerId="ADAL" clId="{DB100BF2-9E91-4732-AB89-AFAB26CA84C1}" dt="2023-06-19T08:55:31.829" v="611"/>
        <pc:sldMkLst>
          <pc:docMk/>
          <pc:sldMk cId="586963921" sldId="281"/>
        </pc:sldMkLst>
        <pc:spChg chg="add del mod">
          <ac:chgData name="Wigmore, Eleanor" userId="154496fa-10d7-4fd7-9fba-3614c367c37c" providerId="ADAL" clId="{DB100BF2-9E91-4732-AB89-AFAB26CA84C1}" dt="2023-06-19T08:55:29.996" v="515"/>
          <ac:spMkLst>
            <pc:docMk/>
            <pc:sldMk cId="586963921" sldId="281"/>
            <ac:spMk id="2" creationId="{2C339649-775A-A8F6-4FA3-CDE3D790840D}"/>
          </ac:spMkLst>
        </pc:spChg>
        <pc:spChg chg="add del mod">
          <ac:chgData name="Wigmore, Eleanor" userId="154496fa-10d7-4fd7-9fba-3614c367c37c" providerId="ADAL" clId="{DB100BF2-9E91-4732-AB89-AFAB26CA84C1}" dt="2023-06-19T08:55:30.016" v="520"/>
          <ac:spMkLst>
            <pc:docMk/>
            <pc:sldMk cId="586963921" sldId="281"/>
            <ac:spMk id="4" creationId="{B84206E0-D55A-2958-1098-2CDA33CBFC09}"/>
          </ac:spMkLst>
        </pc:spChg>
        <pc:spChg chg="add del mod">
          <ac:chgData name="Wigmore, Eleanor" userId="154496fa-10d7-4fd7-9fba-3614c367c37c" providerId="ADAL" clId="{DB100BF2-9E91-4732-AB89-AFAB26CA84C1}" dt="2023-06-19T08:55:30.034" v="525"/>
          <ac:spMkLst>
            <pc:docMk/>
            <pc:sldMk cId="586963921" sldId="281"/>
            <ac:spMk id="6" creationId="{2A1BF17C-823E-9CFC-66CA-D005CC572102}"/>
          </ac:spMkLst>
        </pc:spChg>
        <pc:spChg chg="add del mod">
          <ac:chgData name="Wigmore, Eleanor" userId="154496fa-10d7-4fd7-9fba-3614c367c37c" providerId="ADAL" clId="{DB100BF2-9E91-4732-AB89-AFAB26CA84C1}" dt="2023-06-19T08:55:30.054" v="530"/>
          <ac:spMkLst>
            <pc:docMk/>
            <pc:sldMk cId="586963921" sldId="281"/>
            <ac:spMk id="7" creationId="{C68AE5C7-BACF-AFF8-16A1-DD8679C4AD54}"/>
          </ac:spMkLst>
        </pc:spChg>
        <pc:spChg chg="add del mod">
          <ac:chgData name="Wigmore, Eleanor" userId="154496fa-10d7-4fd7-9fba-3614c367c37c" providerId="ADAL" clId="{DB100BF2-9E91-4732-AB89-AFAB26CA84C1}" dt="2023-06-19T08:55:30.074" v="535"/>
          <ac:spMkLst>
            <pc:docMk/>
            <pc:sldMk cId="586963921" sldId="281"/>
            <ac:spMk id="34" creationId="{D71FF572-61E4-9FFA-0B20-6B3B2E7E67AB}"/>
          </ac:spMkLst>
        </pc:spChg>
        <pc:spChg chg="add del mod">
          <ac:chgData name="Wigmore, Eleanor" userId="154496fa-10d7-4fd7-9fba-3614c367c37c" providerId="ADAL" clId="{DB100BF2-9E91-4732-AB89-AFAB26CA84C1}" dt="2023-06-19T08:55:30.094" v="540"/>
          <ac:spMkLst>
            <pc:docMk/>
            <pc:sldMk cId="586963921" sldId="281"/>
            <ac:spMk id="39" creationId="{3934D5F0-5B71-51C4-5D6F-50E2A5F9675A}"/>
          </ac:spMkLst>
        </pc:spChg>
        <pc:spChg chg="add del mod">
          <ac:chgData name="Wigmore, Eleanor" userId="154496fa-10d7-4fd7-9fba-3614c367c37c" providerId="ADAL" clId="{DB100BF2-9E91-4732-AB89-AFAB26CA84C1}" dt="2023-06-19T08:55:30.114" v="545"/>
          <ac:spMkLst>
            <pc:docMk/>
            <pc:sldMk cId="586963921" sldId="281"/>
            <ac:spMk id="40" creationId="{1B3B9E95-C0E1-EBFC-5B3C-DCD657A8BCE6}"/>
          </ac:spMkLst>
        </pc:spChg>
        <pc:spChg chg="add del mod">
          <ac:chgData name="Wigmore, Eleanor" userId="154496fa-10d7-4fd7-9fba-3614c367c37c" providerId="ADAL" clId="{DB100BF2-9E91-4732-AB89-AFAB26CA84C1}" dt="2023-06-19T08:55:30.134" v="550"/>
          <ac:spMkLst>
            <pc:docMk/>
            <pc:sldMk cId="586963921" sldId="281"/>
            <ac:spMk id="41" creationId="{C28BF5B3-18C1-9C2E-E7BA-17A45DC2244D}"/>
          </ac:spMkLst>
        </pc:spChg>
        <pc:spChg chg="add del mod">
          <ac:chgData name="Wigmore, Eleanor" userId="154496fa-10d7-4fd7-9fba-3614c367c37c" providerId="ADAL" clId="{DB100BF2-9E91-4732-AB89-AFAB26CA84C1}" dt="2023-06-19T08:55:30.153" v="555"/>
          <ac:spMkLst>
            <pc:docMk/>
            <pc:sldMk cId="586963921" sldId="281"/>
            <ac:spMk id="42" creationId="{0080A77C-09C2-037A-02A6-C60E60917547}"/>
          </ac:spMkLst>
        </pc:spChg>
        <pc:spChg chg="add del mod">
          <ac:chgData name="Wigmore, Eleanor" userId="154496fa-10d7-4fd7-9fba-3614c367c37c" providerId="ADAL" clId="{DB100BF2-9E91-4732-AB89-AFAB26CA84C1}" dt="2023-06-19T08:55:30.172" v="560"/>
          <ac:spMkLst>
            <pc:docMk/>
            <pc:sldMk cId="586963921" sldId="281"/>
            <ac:spMk id="43" creationId="{C297DD8B-8983-9CD7-441F-9716FDA0ACE6}"/>
          </ac:spMkLst>
        </pc:spChg>
        <pc:spChg chg="add del mod">
          <ac:chgData name="Wigmore, Eleanor" userId="154496fa-10d7-4fd7-9fba-3614c367c37c" providerId="ADAL" clId="{DB100BF2-9E91-4732-AB89-AFAB26CA84C1}" dt="2023-06-19T08:55:31.661" v="566"/>
          <ac:spMkLst>
            <pc:docMk/>
            <pc:sldMk cId="586963921" sldId="281"/>
            <ac:spMk id="44" creationId="{9B5E2B0F-9A9F-00C9-7FAA-82F8244B1370}"/>
          </ac:spMkLst>
        </pc:spChg>
        <pc:spChg chg="add del mod">
          <ac:chgData name="Wigmore, Eleanor" userId="154496fa-10d7-4fd7-9fba-3614c367c37c" providerId="ADAL" clId="{DB100BF2-9E91-4732-AB89-AFAB26CA84C1}" dt="2023-06-19T08:55:31.679" v="571"/>
          <ac:spMkLst>
            <pc:docMk/>
            <pc:sldMk cId="586963921" sldId="281"/>
            <ac:spMk id="45" creationId="{6D7C21B5-04B8-9369-C772-91775E697B11}"/>
          </ac:spMkLst>
        </pc:spChg>
        <pc:spChg chg="add del mod">
          <ac:chgData name="Wigmore, Eleanor" userId="154496fa-10d7-4fd7-9fba-3614c367c37c" providerId="ADAL" clId="{DB100BF2-9E91-4732-AB89-AFAB26CA84C1}" dt="2023-06-19T08:55:31.696" v="576"/>
          <ac:spMkLst>
            <pc:docMk/>
            <pc:sldMk cId="586963921" sldId="281"/>
            <ac:spMk id="46" creationId="{BB1B61B7-51D2-0A2D-06FC-3A5A66163CE3}"/>
          </ac:spMkLst>
        </pc:spChg>
        <pc:spChg chg="add del mod">
          <ac:chgData name="Wigmore, Eleanor" userId="154496fa-10d7-4fd7-9fba-3614c367c37c" providerId="ADAL" clId="{DB100BF2-9E91-4732-AB89-AFAB26CA84C1}" dt="2023-06-19T08:55:31.713" v="581"/>
          <ac:spMkLst>
            <pc:docMk/>
            <pc:sldMk cId="586963921" sldId="281"/>
            <ac:spMk id="47" creationId="{CA3E7D24-84C9-134A-7435-0B31744E3377}"/>
          </ac:spMkLst>
        </pc:spChg>
        <pc:spChg chg="add del mod">
          <ac:chgData name="Wigmore, Eleanor" userId="154496fa-10d7-4fd7-9fba-3614c367c37c" providerId="ADAL" clId="{DB100BF2-9E91-4732-AB89-AFAB26CA84C1}" dt="2023-06-19T08:55:31.731" v="586"/>
          <ac:spMkLst>
            <pc:docMk/>
            <pc:sldMk cId="586963921" sldId="281"/>
            <ac:spMk id="48" creationId="{D8173850-8D06-2605-5319-E371A7B6BEEF}"/>
          </ac:spMkLst>
        </pc:spChg>
        <pc:spChg chg="add del mod">
          <ac:chgData name="Wigmore, Eleanor" userId="154496fa-10d7-4fd7-9fba-3614c367c37c" providerId="ADAL" clId="{DB100BF2-9E91-4732-AB89-AFAB26CA84C1}" dt="2023-06-19T08:55:31.749" v="591"/>
          <ac:spMkLst>
            <pc:docMk/>
            <pc:sldMk cId="586963921" sldId="281"/>
            <ac:spMk id="49" creationId="{3095218B-D6F3-64E6-3837-D0206A324504}"/>
          </ac:spMkLst>
        </pc:spChg>
        <pc:spChg chg="add del mod">
          <ac:chgData name="Wigmore, Eleanor" userId="154496fa-10d7-4fd7-9fba-3614c367c37c" providerId="ADAL" clId="{DB100BF2-9E91-4732-AB89-AFAB26CA84C1}" dt="2023-06-19T08:55:31.769" v="596"/>
          <ac:spMkLst>
            <pc:docMk/>
            <pc:sldMk cId="586963921" sldId="281"/>
            <ac:spMk id="50" creationId="{BF00AB93-075B-9456-FCA0-92B883D16FEC}"/>
          </ac:spMkLst>
        </pc:spChg>
        <pc:spChg chg="add del mod">
          <ac:chgData name="Wigmore, Eleanor" userId="154496fa-10d7-4fd7-9fba-3614c367c37c" providerId="ADAL" clId="{DB100BF2-9E91-4732-AB89-AFAB26CA84C1}" dt="2023-06-19T08:55:31.789" v="601"/>
          <ac:spMkLst>
            <pc:docMk/>
            <pc:sldMk cId="586963921" sldId="281"/>
            <ac:spMk id="51" creationId="{56822689-A193-CF08-D15C-46316CDC14B4}"/>
          </ac:spMkLst>
        </pc:spChg>
        <pc:spChg chg="add del mod">
          <ac:chgData name="Wigmore, Eleanor" userId="154496fa-10d7-4fd7-9fba-3614c367c37c" providerId="ADAL" clId="{DB100BF2-9E91-4732-AB89-AFAB26CA84C1}" dt="2023-06-19T08:55:31.809" v="606"/>
          <ac:spMkLst>
            <pc:docMk/>
            <pc:sldMk cId="586963921" sldId="281"/>
            <ac:spMk id="52" creationId="{0D8C54E7-FC82-9B64-6DC4-AE4D1F2433E3}"/>
          </ac:spMkLst>
        </pc:spChg>
        <pc:spChg chg="add del mod">
          <ac:chgData name="Wigmore, Eleanor" userId="154496fa-10d7-4fd7-9fba-3614c367c37c" providerId="ADAL" clId="{DB100BF2-9E91-4732-AB89-AFAB26CA84C1}" dt="2023-06-19T08:55:31.829" v="611"/>
          <ac:spMkLst>
            <pc:docMk/>
            <pc:sldMk cId="586963921" sldId="281"/>
            <ac:spMk id="53" creationId="{18A13F69-E573-D601-38D2-1E069DD1A00D}"/>
          </ac:spMkLst>
        </pc:spChg>
      </pc:sldChg>
      <pc:sldChg chg="addSp delSp modSp mod">
        <pc:chgData name="Wigmore, Eleanor" userId="154496fa-10d7-4fd7-9fba-3614c367c37c" providerId="ADAL" clId="{DB100BF2-9E91-4732-AB89-AFAB26CA84C1}" dt="2023-06-19T08:56:21.228" v="660" actId="164"/>
        <pc:sldMkLst>
          <pc:docMk/>
          <pc:sldMk cId="4136609356" sldId="284"/>
        </pc:sldMkLst>
        <pc:spChg chg="add mod">
          <ac:chgData name="Wigmore, Eleanor" userId="154496fa-10d7-4fd7-9fba-3614c367c37c" providerId="ADAL" clId="{DB100BF2-9E91-4732-AB89-AFAB26CA84C1}" dt="2023-06-19T08:56:21.228" v="660" actId="164"/>
          <ac:spMkLst>
            <pc:docMk/>
            <pc:sldMk cId="4136609356" sldId="284"/>
            <ac:spMk id="8" creationId="{B6BA3623-A7EB-2F68-96A5-8C43EFDEA587}"/>
          </ac:spMkLst>
        </pc:spChg>
        <pc:spChg chg="add mod">
          <ac:chgData name="Wigmore, Eleanor" userId="154496fa-10d7-4fd7-9fba-3614c367c37c" providerId="ADAL" clId="{DB100BF2-9E91-4732-AB89-AFAB26CA84C1}" dt="2023-06-19T08:56:21.228" v="660" actId="164"/>
          <ac:spMkLst>
            <pc:docMk/>
            <pc:sldMk cId="4136609356" sldId="284"/>
            <ac:spMk id="10" creationId="{30B09771-6180-4EF3-AFBE-A23F83CF9F83}"/>
          </ac:spMkLst>
        </pc:spChg>
        <pc:spChg chg="add mod">
          <ac:chgData name="Wigmore, Eleanor" userId="154496fa-10d7-4fd7-9fba-3614c367c37c" providerId="ADAL" clId="{DB100BF2-9E91-4732-AB89-AFAB26CA84C1}" dt="2023-06-19T08:56:21.228" v="660" actId="164"/>
          <ac:spMkLst>
            <pc:docMk/>
            <pc:sldMk cId="4136609356" sldId="284"/>
            <ac:spMk id="12" creationId="{50BBC505-EA88-CEB5-6B4A-E30B801244D3}"/>
          </ac:spMkLst>
        </pc:spChg>
        <pc:spChg chg="add mod">
          <ac:chgData name="Wigmore, Eleanor" userId="154496fa-10d7-4fd7-9fba-3614c367c37c" providerId="ADAL" clId="{DB100BF2-9E91-4732-AB89-AFAB26CA84C1}" dt="2023-06-19T08:56:21.228" v="660" actId="164"/>
          <ac:spMkLst>
            <pc:docMk/>
            <pc:sldMk cId="4136609356" sldId="284"/>
            <ac:spMk id="16" creationId="{AF3A6E43-682D-EF53-F078-1900AE3D8DC0}"/>
          </ac:spMkLst>
        </pc:spChg>
        <pc:spChg chg="add mod">
          <ac:chgData name="Wigmore, Eleanor" userId="154496fa-10d7-4fd7-9fba-3614c367c37c" providerId="ADAL" clId="{DB100BF2-9E91-4732-AB89-AFAB26CA84C1}" dt="2023-06-19T08:56:21.228" v="660" actId="164"/>
          <ac:spMkLst>
            <pc:docMk/>
            <pc:sldMk cId="4136609356" sldId="284"/>
            <ac:spMk id="17" creationId="{A4FB7150-4B5E-E8E7-48C4-E224FBDEF808}"/>
          </ac:spMkLst>
        </pc:spChg>
        <pc:spChg chg="add mod">
          <ac:chgData name="Wigmore, Eleanor" userId="154496fa-10d7-4fd7-9fba-3614c367c37c" providerId="ADAL" clId="{DB100BF2-9E91-4732-AB89-AFAB26CA84C1}" dt="2023-06-19T08:56:21.228" v="660" actId="164"/>
          <ac:spMkLst>
            <pc:docMk/>
            <pc:sldMk cId="4136609356" sldId="284"/>
            <ac:spMk id="18" creationId="{4C8236DB-175D-000E-B785-39667AF2CBC1}"/>
          </ac:spMkLst>
        </pc:spChg>
        <pc:spChg chg="add del mod">
          <ac:chgData name="Wigmore, Eleanor" userId="154496fa-10d7-4fd7-9fba-3614c367c37c" providerId="ADAL" clId="{DB100BF2-9E91-4732-AB89-AFAB26CA84C1}" dt="2023-06-19T08:54:53.122" v="485"/>
          <ac:spMkLst>
            <pc:docMk/>
            <pc:sldMk cId="4136609356" sldId="284"/>
            <ac:spMk id="19" creationId="{9ECAAFBB-C845-F906-5BE0-FEA3E5185C5B}"/>
          </ac:spMkLst>
        </pc:spChg>
        <pc:spChg chg="add mod">
          <ac:chgData name="Wigmore, Eleanor" userId="154496fa-10d7-4fd7-9fba-3614c367c37c" providerId="ADAL" clId="{DB100BF2-9E91-4732-AB89-AFAB26CA84C1}" dt="2023-06-19T08:56:21.228" v="660" actId="164"/>
          <ac:spMkLst>
            <pc:docMk/>
            <pc:sldMk cId="4136609356" sldId="284"/>
            <ac:spMk id="21" creationId="{AED033FC-36BC-4701-64FD-3F65A941CE6A}"/>
          </ac:spMkLst>
        </pc:spChg>
        <pc:grpChg chg="add mod">
          <ac:chgData name="Wigmore, Eleanor" userId="154496fa-10d7-4fd7-9fba-3614c367c37c" providerId="ADAL" clId="{DB100BF2-9E91-4732-AB89-AFAB26CA84C1}" dt="2023-06-19T08:56:21.228" v="660" actId="164"/>
          <ac:grpSpMkLst>
            <pc:docMk/>
            <pc:sldMk cId="4136609356" sldId="284"/>
            <ac:grpSpMk id="23" creationId="{5A2C3450-EF05-CF04-5CBC-0FC8F5ECFA12}"/>
          </ac:grpSpMkLst>
        </pc:grpChg>
        <pc:picChg chg="mod modCrop">
          <ac:chgData name="Wigmore, Eleanor" userId="154496fa-10d7-4fd7-9fba-3614c367c37c" providerId="ADAL" clId="{DB100BF2-9E91-4732-AB89-AFAB26CA84C1}" dt="2023-06-19T08:56:21.228" v="660" actId="164"/>
          <ac:picMkLst>
            <pc:docMk/>
            <pc:sldMk cId="4136609356" sldId="284"/>
            <ac:picMk id="3" creationId="{2F723C05-8B0B-1B08-AEF4-C124DB79F567}"/>
          </ac:picMkLst>
        </pc:picChg>
      </pc:sldChg>
      <pc:sldChg chg="addSp delSp modSp mod">
        <pc:chgData name="Wigmore, Eleanor" userId="154496fa-10d7-4fd7-9fba-3614c367c37c" providerId="ADAL" clId="{DB100BF2-9E91-4732-AB89-AFAB26CA84C1}" dt="2023-06-19T08:57:53.779" v="682" actId="478"/>
        <pc:sldMkLst>
          <pc:docMk/>
          <pc:sldMk cId="1783606474" sldId="703"/>
        </pc:sldMkLst>
        <pc:spChg chg="mod topLvl">
          <ac:chgData name="Wigmore, Eleanor" userId="154496fa-10d7-4fd7-9fba-3614c367c37c" providerId="ADAL" clId="{DB100BF2-9E91-4732-AB89-AFAB26CA84C1}" dt="2023-06-19T08:57:42.389" v="679" actId="1076"/>
          <ac:spMkLst>
            <pc:docMk/>
            <pc:sldMk cId="1783606474" sldId="703"/>
            <ac:spMk id="37" creationId="{7F86F4FE-14F2-5C3A-3417-9334942D7DEF}"/>
          </ac:spMkLst>
        </pc:spChg>
        <pc:spChg chg="mod topLvl">
          <ac:chgData name="Wigmore, Eleanor" userId="154496fa-10d7-4fd7-9fba-3614c367c37c" providerId="ADAL" clId="{DB100BF2-9E91-4732-AB89-AFAB26CA84C1}" dt="2023-06-19T08:57:49.202" v="681" actId="1076"/>
          <ac:spMkLst>
            <pc:docMk/>
            <pc:sldMk cId="1783606474" sldId="703"/>
            <ac:spMk id="43" creationId="{48211725-DD34-61D3-38DC-A43239F9D2CA}"/>
          </ac:spMkLst>
        </pc:spChg>
        <pc:spChg chg="mod topLvl">
          <ac:chgData name="Wigmore, Eleanor" userId="154496fa-10d7-4fd7-9fba-3614c367c37c" providerId="ADAL" clId="{DB100BF2-9E91-4732-AB89-AFAB26CA84C1}" dt="2023-06-19T08:57:31.119" v="676" actId="554"/>
          <ac:spMkLst>
            <pc:docMk/>
            <pc:sldMk cId="1783606474" sldId="703"/>
            <ac:spMk id="60" creationId="{D0ECAC58-2999-4390-38E6-552739C585FB}"/>
          </ac:spMkLst>
        </pc:spChg>
        <pc:spChg chg="mod topLvl">
          <ac:chgData name="Wigmore, Eleanor" userId="154496fa-10d7-4fd7-9fba-3614c367c37c" providerId="ADAL" clId="{DB100BF2-9E91-4732-AB89-AFAB26CA84C1}" dt="2023-06-19T08:57:31.119" v="676" actId="554"/>
          <ac:spMkLst>
            <pc:docMk/>
            <pc:sldMk cId="1783606474" sldId="703"/>
            <ac:spMk id="326" creationId="{25D23673-F9CA-39E6-69D5-900BD91B8300}"/>
          </ac:spMkLst>
        </pc:spChg>
        <pc:spChg chg="mod topLvl">
          <ac:chgData name="Wigmore, Eleanor" userId="154496fa-10d7-4fd7-9fba-3614c367c37c" providerId="ADAL" clId="{DB100BF2-9E91-4732-AB89-AFAB26CA84C1}" dt="2023-06-19T08:57:35.903" v="677" actId="1076"/>
          <ac:spMkLst>
            <pc:docMk/>
            <pc:sldMk cId="1783606474" sldId="703"/>
            <ac:spMk id="327" creationId="{48071B57-688B-A7E7-4E0D-F474437B1E3F}"/>
          </ac:spMkLst>
        </pc:spChg>
        <pc:spChg chg="mod topLvl">
          <ac:chgData name="Wigmore, Eleanor" userId="154496fa-10d7-4fd7-9fba-3614c367c37c" providerId="ADAL" clId="{DB100BF2-9E91-4732-AB89-AFAB26CA84C1}" dt="2023-06-19T08:57:07.073" v="669" actId="1076"/>
          <ac:spMkLst>
            <pc:docMk/>
            <pc:sldMk cId="1783606474" sldId="703"/>
            <ac:spMk id="328" creationId="{2C2E9226-C637-323F-96DE-CE746D639CF5}"/>
          </ac:spMkLst>
        </pc:spChg>
        <pc:spChg chg="mod topLvl">
          <ac:chgData name="Wigmore, Eleanor" userId="154496fa-10d7-4fd7-9fba-3614c367c37c" providerId="ADAL" clId="{DB100BF2-9E91-4732-AB89-AFAB26CA84C1}" dt="2023-06-19T08:57:11.852" v="672" actId="1037"/>
          <ac:spMkLst>
            <pc:docMk/>
            <pc:sldMk cId="1783606474" sldId="703"/>
            <ac:spMk id="329" creationId="{984B4CB8-F099-FA52-C3F9-D0FF2DFB0B01}"/>
          </ac:spMkLst>
        </pc:spChg>
        <pc:grpChg chg="add del mod">
          <ac:chgData name="Wigmore, Eleanor" userId="154496fa-10d7-4fd7-9fba-3614c367c37c" providerId="ADAL" clId="{DB100BF2-9E91-4732-AB89-AFAB26CA84C1}" dt="2023-06-19T08:56:39.309" v="664" actId="165"/>
          <ac:grpSpMkLst>
            <pc:docMk/>
            <pc:sldMk cId="1783606474" sldId="703"/>
            <ac:grpSpMk id="3" creationId="{43103182-80D5-C836-275E-7652742F666A}"/>
          </ac:grpSpMkLst>
        </pc:grpChg>
        <pc:picChg chg="del mod topLvl">
          <ac:chgData name="Wigmore, Eleanor" userId="154496fa-10d7-4fd7-9fba-3614c367c37c" providerId="ADAL" clId="{DB100BF2-9E91-4732-AB89-AFAB26CA84C1}" dt="2023-06-19T08:57:53.779" v="682" actId="478"/>
          <ac:picMkLst>
            <pc:docMk/>
            <pc:sldMk cId="1783606474" sldId="703"/>
            <ac:picMk id="8" creationId="{C5E00DA1-2C69-B29B-8191-075A0A7D171E}"/>
          </ac:picMkLst>
        </pc:picChg>
        <pc:picChg chg="mod modCrop">
          <ac:chgData name="Wigmore, Eleanor" userId="154496fa-10d7-4fd7-9fba-3614c367c37c" providerId="ADAL" clId="{DB100BF2-9E91-4732-AB89-AFAB26CA84C1}" dt="2023-06-19T08:57:03.069" v="668" actId="732"/>
          <ac:picMkLst>
            <pc:docMk/>
            <pc:sldMk cId="1783606474" sldId="703"/>
            <ac:picMk id="12" creationId="{80780961-2844-3E71-7545-778AB32E6E21}"/>
          </ac:picMkLst>
        </pc:picChg>
      </pc:sldChg>
      <pc:sldChg chg="addSp delSp modSp mod">
        <pc:chgData name="Wigmore, Eleanor" userId="154496fa-10d7-4fd7-9fba-3614c367c37c" providerId="ADAL" clId="{DB100BF2-9E91-4732-AB89-AFAB26CA84C1}" dt="2023-06-15T14:10:01.244" v="355" actId="20577"/>
        <pc:sldMkLst>
          <pc:docMk/>
          <pc:sldMk cId="3220786227" sldId="704"/>
        </pc:sldMkLst>
        <pc:spChg chg="add mod">
          <ac:chgData name="Wigmore, Eleanor" userId="154496fa-10d7-4fd7-9fba-3614c367c37c" providerId="ADAL" clId="{DB100BF2-9E91-4732-AB89-AFAB26CA84C1}" dt="2023-06-15T14:09:52.865" v="345" actId="20577"/>
          <ac:spMkLst>
            <pc:docMk/>
            <pc:sldMk cId="3220786227" sldId="704"/>
            <ac:spMk id="10" creationId="{872303DE-6925-57CD-A06B-15C783D5AAF9}"/>
          </ac:spMkLst>
        </pc:spChg>
        <pc:spChg chg="add mod">
          <ac:chgData name="Wigmore, Eleanor" userId="154496fa-10d7-4fd7-9fba-3614c367c37c" providerId="ADAL" clId="{DB100BF2-9E91-4732-AB89-AFAB26CA84C1}" dt="2023-06-15T14:10:01.244" v="355" actId="20577"/>
          <ac:spMkLst>
            <pc:docMk/>
            <pc:sldMk cId="3220786227" sldId="704"/>
            <ac:spMk id="12" creationId="{0187B152-845C-98A6-EE54-54AD2E906E4E}"/>
          </ac:spMkLst>
        </pc:spChg>
        <pc:spChg chg="mod">
          <ac:chgData name="Wigmore, Eleanor" userId="154496fa-10d7-4fd7-9fba-3614c367c37c" providerId="ADAL" clId="{DB100BF2-9E91-4732-AB89-AFAB26CA84C1}" dt="2023-06-15T14:08:37.761" v="264" actId="20577"/>
          <ac:spMkLst>
            <pc:docMk/>
            <pc:sldMk cId="3220786227" sldId="704"/>
            <ac:spMk id="47" creationId="{6B92FF38-380F-BEBD-A501-D7C60EDC8E82}"/>
          </ac:spMkLst>
        </pc:spChg>
        <pc:spChg chg="mod">
          <ac:chgData name="Wigmore, Eleanor" userId="154496fa-10d7-4fd7-9fba-3614c367c37c" providerId="ADAL" clId="{DB100BF2-9E91-4732-AB89-AFAB26CA84C1}" dt="2023-06-15T14:08:46.185" v="274" actId="20577"/>
          <ac:spMkLst>
            <pc:docMk/>
            <pc:sldMk cId="3220786227" sldId="704"/>
            <ac:spMk id="49" creationId="{B58D13CD-5E78-E71C-136F-F06ECA725B0D}"/>
          </ac:spMkLst>
        </pc:spChg>
        <pc:spChg chg="mod">
          <ac:chgData name="Wigmore, Eleanor" userId="154496fa-10d7-4fd7-9fba-3614c367c37c" providerId="ADAL" clId="{DB100BF2-9E91-4732-AB89-AFAB26CA84C1}" dt="2023-06-15T14:08:59.060" v="285" actId="20577"/>
          <ac:spMkLst>
            <pc:docMk/>
            <pc:sldMk cId="3220786227" sldId="704"/>
            <ac:spMk id="57" creationId="{3FC7077D-FC72-9E36-582F-E9B5F13378A7}"/>
          </ac:spMkLst>
        </pc:spChg>
        <pc:spChg chg="mod">
          <ac:chgData name="Wigmore, Eleanor" userId="154496fa-10d7-4fd7-9fba-3614c367c37c" providerId="ADAL" clId="{DB100BF2-9E91-4732-AB89-AFAB26CA84C1}" dt="2023-06-15T14:09:12.289" v="303" actId="20577"/>
          <ac:spMkLst>
            <pc:docMk/>
            <pc:sldMk cId="3220786227" sldId="704"/>
            <ac:spMk id="59" creationId="{286DA675-929D-E5C0-E2D1-54BC287F6809}"/>
          </ac:spMkLst>
        </pc:spChg>
        <pc:spChg chg="mod">
          <ac:chgData name="Wigmore, Eleanor" userId="154496fa-10d7-4fd7-9fba-3614c367c37c" providerId="ADAL" clId="{DB100BF2-9E91-4732-AB89-AFAB26CA84C1}" dt="2023-06-15T14:09:29.616" v="314" actId="20577"/>
          <ac:spMkLst>
            <pc:docMk/>
            <pc:sldMk cId="3220786227" sldId="704"/>
            <ac:spMk id="66" creationId="{DCCB3315-2A4F-E5FF-3DDD-88729D11F16B}"/>
          </ac:spMkLst>
        </pc:spChg>
        <pc:spChg chg="mod">
          <ac:chgData name="Wigmore, Eleanor" userId="154496fa-10d7-4fd7-9fba-3614c367c37c" providerId="ADAL" clId="{DB100BF2-9E91-4732-AB89-AFAB26CA84C1}" dt="2023-06-15T14:09:40.851" v="335" actId="20577"/>
          <ac:spMkLst>
            <pc:docMk/>
            <pc:sldMk cId="3220786227" sldId="704"/>
            <ac:spMk id="68" creationId="{0461FF12-1B9A-2790-8E5F-0498FFF8D80A}"/>
          </ac:spMkLst>
        </pc:spChg>
        <pc:spChg chg="del">
          <ac:chgData name="Wigmore, Eleanor" userId="154496fa-10d7-4fd7-9fba-3614c367c37c" providerId="ADAL" clId="{DB100BF2-9E91-4732-AB89-AFAB26CA84C1}" dt="2023-06-15T13:31:05.547" v="244" actId="478"/>
          <ac:spMkLst>
            <pc:docMk/>
            <pc:sldMk cId="3220786227" sldId="704"/>
            <ac:spMk id="75" creationId="{A40A7E7A-3C24-A421-ED14-7D545558C9DA}"/>
          </ac:spMkLst>
        </pc:spChg>
        <pc:spChg chg="del">
          <ac:chgData name="Wigmore, Eleanor" userId="154496fa-10d7-4fd7-9fba-3614c367c37c" providerId="ADAL" clId="{DB100BF2-9E91-4732-AB89-AFAB26CA84C1}" dt="2023-06-15T13:31:04.752" v="243" actId="478"/>
          <ac:spMkLst>
            <pc:docMk/>
            <pc:sldMk cId="3220786227" sldId="704"/>
            <ac:spMk id="77" creationId="{6067368F-0786-5965-6A71-0AC5936536F3}"/>
          </ac:spMkLst>
        </pc:spChg>
      </pc:sldChg>
    </pc:docChg>
  </pc:docChgLst>
  <pc:docChgLst>
    <pc:chgData name="Hopcroft, Lorna" userId="S::kgsk887@astrazeneca.net::67a1a19a-5520-4fba-b489-dbb2959a0dc0" providerId="AD" clId="Web-{764C7BA8-45BC-8161-ACF1-A3821E9971FA}"/>
    <pc:docChg chg="addSld modSld sldOrd">
      <pc:chgData name="Hopcroft, Lorna" userId="S::kgsk887@astrazeneca.net::67a1a19a-5520-4fba-b489-dbb2959a0dc0" providerId="AD" clId="Web-{764C7BA8-45BC-8161-ACF1-A3821E9971FA}" dt="2023-06-07T13:37:40.066" v="64" actId="20577"/>
      <pc:docMkLst>
        <pc:docMk/>
      </pc:docMkLst>
      <pc:sldChg chg="modSp">
        <pc:chgData name="Hopcroft, Lorna" userId="S::kgsk887@astrazeneca.net::67a1a19a-5520-4fba-b489-dbb2959a0dc0" providerId="AD" clId="Web-{764C7BA8-45BC-8161-ACF1-A3821E9971FA}" dt="2023-06-07T13:37:17.581" v="63" actId="20577"/>
        <pc:sldMkLst>
          <pc:docMk/>
          <pc:sldMk cId="2672170052" sldId="277"/>
        </pc:sldMkLst>
        <pc:spChg chg="mod">
          <ac:chgData name="Hopcroft, Lorna" userId="S::kgsk887@astrazeneca.net::67a1a19a-5520-4fba-b489-dbb2959a0dc0" providerId="AD" clId="Web-{764C7BA8-45BC-8161-ACF1-A3821E9971FA}" dt="2023-06-07T13:37:17.581" v="63" actId="20577"/>
          <ac:spMkLst>
            <pc:docMk/>
            <pc:sldMk cId="2672170052" sldId="277"/>
            <ac:spMk id="11" creationId="{A07066BB-B788-47E5-AD9E-431C88455864}"/>
          </ac:spMkLst>
        </pc:spChg>
      </pc:sldChg>
      <pc:sldChg chg="modSp">
        <pc:chgData name="Hopcroft, Lorna" userId="S::kgsk887@astrazeneca.net::67a1a19a-5520-4fba-b489-dbb2959a0dc0" providerId="AD" clId="Web-{764C7BA8-45BC-8161-ACF1-A3821E9971FA}" dt="2023-06-07T13:37:40.066" v="64" actId="20577"/>
        <pc:sldMkLst>
          <pc:docMk/>
          <pc:sldMk cId="1992358590" sldId="280"/>
        </pc:sldMkLst>
        <pc:spChg chg="mod">
          <ac:chgData name="Hopcroft, Lorna" userId="S::kgsk887@astrazeneca.net::67a1a19a-5520-4fba-b489-dbb2959a0dc0" providerId="AD" clId="Web-{764C7BA8-45BC-8161-ACF1-A3821E9971FA}" dt="2023-06-07T13:37:40.066" v="64" actId="20577"/>
          <ac:spMkLst>
            <pc:docMk/>
            <pc:sldMk cId="1992358590" sldId="280"/>
            <ac:spMk id="9" creationId="{5ED4491D-E78B-441E-80CE-35F22141D8AA}"/>
          </ac:spMkLst>
        </pc:spChg>
      </pc:sldChg>
      <pc:sldChg chg="addSp delSp modSp">
        <pc:chgData name="Hopcroft, Lorna" userId="S::kgsk887@astrazeneca.net::67a1a19a-5520-4fba-b489-dbb2959a0dc0" providerId="AD" clId="Web-{764C7BA8-45BC-8161-ACF1-A3821E9971FA}" dt="2023-06-07T12:26:40.730" v="16" actId="1076"/>
        <pc:sldMkLst>
          <pc:docMk/>
          <pc:sldMk cId="586963921" sldId="281"/>
        </pc:sldMkLst>
        <pc:spChg chg="add">
          <ac:chgData name="Hopcroft, Lorna" userId="S::kgsk887@astrazeneca.net::67a1a19a-5520-4fba-b489-dbb2959a0dc0" providerId="AD" clId="Web-{764C7BA8-45BC-8161-ACF1-A3821E9971FA}" dt="2023-06-07T12:17:49.695" v="0"/>
          <ac:spMkLst>
            <pc:docMk/>
            <pc:sldMk cId="586963921" sldId="281"/>
            <ac:spMk id="5" creationId="{A168FA20-53A6-30BD-2410-044BB14FCE7F}"/>
          </ac:spMkLst>
        </pc:spChg>
        <pc:spChg chg="add">
          <ac:chgData name="Hopcroft, Lorna" userId="S::kgsk887@astrazeneca.net::67a1a19a-5520-4fba-b489-dbb2959a0dc0" providerId="AD" clId="Web-{764C7BA8-45BC-8161-ACF1-A3821E9971FA}" dt="2023-06-07T12:17:49.695" v="0"/>
          <ac:spMkLst>
            <pc:docMk/>
            <pc:sldMk cId="586963921" sldId="281"/>
            <ac:spMk id="7" creationId="{F19490B8-90F2-C8C4-9FFF-4222EED3FE0B}"/>
          </ac:spMkLst>
        </pc:spChg>
        <pc:spChg chg="del">
          <ac:chgData name="Hopcroft, Lorna" userId="S::kgsk887@astrazeneca.net::67a1a19a-5520-4fba-b489-dbb2959a0dc0" providerId="AD" clId="Web-{764C7BA8-45BC-8161-ACF1-A3821E9971FA}" dt="2023-06-07T12:19:23.603" v="14"/>
          <ac:spMkLst>
            <pc:docMk/>
            <pc:sldMk cId="586963921" sldId="281"/>
            <ac:spMk id="12" creationId="{2F42296E-9862-689F-FE72-4957819DCF3D}"/>
          </ac:spMkLst>
        </pc:spChg>
        <pc:spChg chg="del">
          <ac:chgData name="Hopcroft, Lorna" userId="S::kgsk887@astrazeneca.net::67a1a19a-5520-4fba-b489-dbb2959a0dc0" providerId="AD" clId="Web-{764C7BA8-45BC-8161-ACF1-A3821E9971FA}" dt="2023-06-07T12:19:23.603" v="13"/>
          <ac:spMkLst>
            <pc:docMk/>
            <pc:sldMk cId="586963921" sldId="281"/>
            <ac:spMk id="13" creationId="{95DC0E1E-BE05-CD5F-F579-04632FAD7B3C}"/>
          </ac:spMkLst>
        </pc:spChg>
        <pc:spChg chg="del">
          <ac:chgData name="Hopcroft, Lorna" userId="S::kgsk887@astrazeneca.net::67a1a19a-5520-4fba-b489-dbb2959a0dc0" providerId="AD" clId="Web-{764C7BA8-45BC-8161-ACF1-A3821E9971FA}" dt="2023-06-07T12:19:23.603" v="12"/>
          <ac:spMkLst>
            <pc:docMk/>
            <pc:sldMk cId="586963921" sldId="281"/>
            <ac:spMk id="16" creationId="{586018A2-5AD3-C0E2-CB0B-09213E65A1A0}"/>
          </ac:spMkLst>
        </pc:spChg>
        <pc:spChg chg="del">
          <ac:chgData name="Hopcroft, Lorna" userId="S::kgsk887@astrazeneca.net::67a1a19a-5520-4fba-b489-dbb2959a0dc0" providerId="AD" clId="Web-{764C7BA8-45BC-8161-ACF1-A3821E9971FA}" dt="2023-06-07T12:19:23.603" v="11"/>
          <ac:spMkLst>
            <pc:docMk/>
            <pc:sldMk cId="586963921" sldId="281"/>
            <ac:spMk id="17" creationId="{EC480E70-5412-0E03-797F-D2700523083C}"/>
          </ac:spMkLst>
        </pc:spChg>
        <pc:spChg chg="add">
          <ac:chgData name="Hopcroft, Lorna" userId="S::kgsk887@astrazeneca.net::67a1a19a-5520-4fba-b489-dbb2959a0dc0" providerId="AD" clId="Web-{764C7BA8-45BC-8161-ACF1-A3821E9971FA}" dt="2023-06-07T12:17:49.695" v="0"/>
          <ac:spMkLst>
            <pc:docMk/>
            <pc:sldMk cId="586963921" sldId="281"/>
            <ac:spMk id="39" creationId="{EE8C7F73-B3C2-59CF-A4BD-2AD3D8F348DB}"/>
          </ac:spMkLst>
        </pc:spChg>
        <pc:spChg chg="del">
          <ac:chgData name="Hopcroft, Lorna" userId="S::kgsk887@astrazeneca.net::67a1a19a-5520-4fba-b489-dbb2959a0dc0" providerId="AD" clId="Web-{764C7BA8-45BC-8161-ACF1-A3821E9971FA}" dt="2023-06-07T12:19:23.603" v="9"/>
          <ac:spMkLst>
            <pc:docMk/>
            <pc:sldMk cId="586963921" sldId="281"/>
            <ac:spMk id="49" creationId="{137D68D8-730E-141D-5EB9-8E043E2527FA}"/>
          </ac:spMkLst>
        </pc:spChg>
        <pc:spChg chg="add">
          <ac:chgData name="Hopcroft, Lorna" userId="S::kgsk887@astrazeneca.net::67a1a19a-5520-4fba-b489-dbb2959a0dc0" providerId="AD" clId="Web-{764C7BA8-45BC-8161-ACF1-A3821E9971FA}" dt="2023-06-07T12:17:49.695" v="0"/>
          <ac:spMkLst>
            <pc:docMk/>
            <pc:sldMk cId="586963921" sldId="281"/>
            <ac:spMk id="50" creationId="{9E6CF6D7-07BC-4FC9-97C0-C5FFEEC4307D}"/>
          </ac:spMkLst>
        </pc:spChg>
        <pc:spChg chg="del">
          <ac:chgData name="Hopcroft, Lorna" userId="S::kgsk887@astrazeneca.net::67a1a19a-5520-4fba-b489-dbb2959a0dc0" providerId="AD" clId="Web-{764C7BA8-45BC-8161-ACF1-A3821E9971FA}" dt="2023-06-07T12:19:23.603" v="7"/>
          <ac:spMkLst>
            <pc:docMk/>
            <pc:sldMk cId="586963921" sldId="281"/>
            <ac:spMk id="82" creationId="{935DC64D-7533-3DC2-81E2-E20ED0A7F919}"/>
          </ac:spMkLst>
        </pc:spChg>
        <pc:spChg chg="add">
          <ac:chgData name="Hopcroft, Lorna" userId="S::kgsk887@astrazeneca.net::67a1a19a-5520-4fba-b489-dbb2959a0dc0" providerId="AD" clId="Web-{764C7BA8-45BC-8161-ACF1-A3821E9971FA}" dt="2023-06-07T12:17:49.695" v="0"/>
          <ac:spMkLst>
            <pc:docMk/>
            <pc:sldMk cId="586963921" sldId="281"/>
            <ac:spMk id="83" creationId="{D92B9832-0541-04E6-A123-5D0C8D28BB55}"/>
          </ac:spMkLst>
        </pc:spChg>
        <pc:spChg chg="add">
          <ac:chgData name="Hopcroft, Lorna" userId="S::kgsk887@astrazeneca.net::67a1a19a-5520-4fba-b489-dbb2959a0dc0" providerId="AD" clId="Web-{764C7BA8-45BC-8161-ACF1-A3821E9971FA}" dt="2023-06-07T12:17:49.695" v="0"/>
          <ac:spMkLst>
            <pc:docMk/>
            <pc:sldMk cId="586963921" sldId="281"/>
            <ac:spMk id="85" creationId="{32618232-E93F-F214-743E-70759BD6D4A9}"/>
          </ac:spMkLst>
        </pc:spChg>
        <pc:spChg chg="add">
          <ac:chgData name="Hopcroft, Lorna" userId="S::kgsk887@astrazeneca.net::67a1a19a-5520-4fba-b489-dbb2959a0dc0" providerId="AD" clId="Web-{764C7BA8-45BC-8161-ACF1-A3821E9971FA}" dt="2023-06-07T12:17:49.695" v="0"/>
          <ac:spMkLst>
            <pc:docMk/>
            <pc:sldMk cId="586963921" sldId="281"/>
            <ac:spMk id="86" creationId="{960B1305-B53B-9E54-398E-F6E45074B3ED}"/>
          </ac:spMkLst>
        </pc:spChg>
        <pc:spChg chg="add">
          <ac:chgData name="Hopcroft, Lorna" userId="S::kgsk887@astrazeneca.net::67a1a19a-5520-4fba-b489-dbb2959a0dc0" providerId="AD" clId="Web-{764C7BA8-45BC-8161-ACF1-A3821E9971FA}" dt="2023-06-07T12:17:49.695" v="0"/>
          <ac:spMkLst>
            <pc:docMk/>
            <pc:sldMk cId="586963921" sldId="281"/>
            <ac:spMk id="112" creationId="{4AE31BFE-E69F-C9DF-6C99-5F68D5849DB5}"/>
          </ac:spMkLst>
        </pc:spChg>
        <pc:spChg chg="add">
          <ac:chgData name="Hopcroft, Lorna" userId="S::kgsk887@astrazeneca.net::67a1a19a-5520-4fba-b489-dbb2959a0dc0" providerId="AD" clId="Web-{764C7BA8-45BC-8161-ACF1-A3821E9971FA}" dt="2023-06-07T12:17:49.695" v="0"/>
          <ac:spMkLst>
            <pc:docMk/>
            <pc:sldMk cId="586963921" sldId="281"/>
            <ac:spMk id="113" creationId="{0BD8DA65-19D4-2B5C-F57F-3C4011341B5C}"/>
          </ac:spMkLst>
        </pc:spChg>
        <pc:spChg chg="del">
          <ac:chgData name="Hopcroft, Lorna" userId="S::kgsk887@astrazeneca.net::67a1a19a-5520-4fba-b489-dbb2959a0dc0" providerId="AD" clId="Web-{764C7BA8-45BC-8161-ACF1-A3821E9971FA}" dt="2023-06-07T12:19:23.603" v="5"/>
          <ac:spMkLst>
            <pc:docMk/>
            <pc:sldMk cId="586963921" sldId="281"/>
            <ac:spMk id="116" creationId="{99FB48C1-78E2-40BB-DECC-21D36EBD63A7}"/>
          </ac:spMkLst>
        </pc:spChg>
        <pc:spChg chg="del">
          <ac:chgData name="Hopcroft, Lorna" userId="S::kgsk887@astrazeneca.net::67a1a19a-5520-4fba-b489-dbb2959a0dc0" providerId="AD" clId="Web-{764C7BA8-45BC-8161-ACF1-A3821E9971FA}" dt="2023-06-07T12:19:23.603" v="3"/>
          <ac:spMkLst>
            <pc:docMk/>
            <pc:sldMk cId="586963921" sldId="281"/>
            <ac:spMk id="148" creationId="{93D262E5-E7BA-8C47-9A67-4C642E0A3556}"/>
          </ac:spMkLst>
        </pc:spChg>
        <pc:spChg chg="add">
          <ac:chgData name="Hopcroft, Lorna" userId="S::kgsk887@astrazeneca.net::67a1a19a-5520-4fba-b489-dbb2959a0dc0" providerId="AD" clId="Web-{764C7BA8-45BC-8161-ACF1-A3821E9971FA}" dt="2023-06-07T12:17:49.695" v="0"/>
          <ac:spMkLst>
            <pc:docMk/>
            <pc:sldMk cId="586963921" sldId="281"/>
            <ac:spMk id="150" creationId="{BB4DB031-7878-1799-E84A-60E07EA44719}"/>
          </ac:spMkLst>
        </pc:spChg>
        <pc:grpChg chg="add mod">
          <ac:chgData name="Hopcroft, Lorna" userId="S::kgsk887@astrazeneca.net::67a1a19a-5520-4fba-b489-dbb2959a0dc0" providerId="AD" clId="Web-{764C7BA8-45BC-8161-ACF1-A3821E9971FA}" dt="2023-06-07T12:26:40.730" v="16" actId="1076"/>
          <ac:grpSpMkLst>
            <pc:docMk/>
            <pc:sldMk cId="586963921" sldId="281"/>
            <ac:grpSpMk id="4" creationId="{1548FF75-10F6-C26E-EE50-7C2CEBBB6089}"/>
          </ac:grpSpMkLst>
        </pc:grpChg>
        <pc:grpChg chg="del">
          <ac:chgData name="Hopcroft, Lorna" userId="S::kgsk887@astrazeneca.net::67a1a19a-5520-4fba-b489-dbb2959a0dc0" providerId="AD" clId="Web-{764C7BA8-45BC-8161-ACF1-A3821E9971FA}" dt="2023-06-07T12:19:23.603" v="4"/>
          <ac:grpSpMkLst>
            <pc:docMk/>
            <pc:sldMk cId="586963921" sldId="281"/>
            <ac:grpSpMk id="151" creationId="{EFE0936F-284B-646A-FE16-2F14C76DE5A7}"/>
          </ac:grpSpMkLst>
        </pc:grpChg>
        <pc:grpChg chg="del">
          <ac:chgData name="Hopcroft, Lorna" userId="S::kgsk887@astrazeneca.net::67a1a19a-5520-4fba-b489-dbb2959a0dc0" providerId="AD" clId="Web-{764C7BA8-45BC-8161-ACF1-A3821E9971FA}" dt="2023-06-07T12:19:23.603" v="8"/>
          <ac:grpSpMkLst>
            <pc:docMk/>
            <pc:sldMk cId="586963921" sldId="281"/>
            <ac:grpSpMk id="152" creationId="{0E334E02-A93C-03FE-DB84-4F4CCC1ED296}"/>
          </ac:grpSpMkLst>
        </pc:grpChg>
        <pc:picChg chg="add mod">
          <ac:chgData name="Hopcroft, Lorna" userId="S::kgsk887@astrazeneca.net::67a1a19a-5520-4fba-b489-dbb2959a0dc0" providerId="AD" clId="Web-{764C7BA8-45BC-8161-ACF1-A3821E9971FA}" dt="2023-06-07T12:26:38.995" v="15" actId="1076"/>
          <ac:picMkLst>
            <pc:docMk/>
            <pc:sldMk cId="586963921" sldId="281"/>
            <ac:picMk id="3" creationId="{721CEB35-2DFB-1BE1-41EF-CC318D043FC2}"/>
          </ac:picMkLst>
        </pc:picChg>
        <pc:picChg chg="add">
          <ac:chgData name="Hopcroft, Lorna" userId="S::kgsk887@astrazeneca.net::67a1a19a-5520-4fba-b489-dbb2959a0dc0" providerId="AD" clId="Web-{764C7BA8-45BC-8161-ACF1-A3821E9971FA}" dt="2023-06-07T12:17:49.695" v="0"/>
          <ac:picMkLst>
            <pc:docMk/>
            <pc:sldMk cId="586963921" sldId="281"/>
            <ac:picMk id="6" creationId="{ACDE573E-1A5E-136E-02DC-CE877B0E5F3F}"/>
          </ac:picMkLst>
        </pc:picChg>
        <pc:picChg chg="del">
          <ac:chgData name="Hopcroft, Lorna" userId="S::kgsk887@astrazeneca.net::67a1a19a-5520-4fba-b489-dbb2959a0dc0" providerId="AD" clId="Web-{764C7BA8-45BC-8161-ACF1-A3821E9971FA}" dt="2023-06-07T12:19:23.603" v="6"/>
          <ac:picMkLst>
            <pc:docMk/>
            <pc:sldMk cId="586963921" sldId="281"/>
            <ac:picMk id="84" creationId="{26E3AFC5-5D2A-1FCA-554A-3403F6750861}"/>
          </ac:picMkLst>
        </pc:picChg>
        <pc:picChg chg="add">
          <ac:chgData name="Hopcroft, Lorna" userId="S::kgsk887@astrazeneca.net::67a1a19a-5520-4fba-b489-dbb2959a0dc0" providerId="AD" clId="Web-{764C7BA8-45BC-8161-ACF1-A3821E9971FA}" dt="2023-06-07T12:17:49.695" v="0"/>
          <ac:picMkLst>
            <pc:docMk/>
            <pc:sldMk cId="586963921" sldId="281"/>
            <ac:picMk id="149" creationId="{02A583D6-AE16-E073-E081-120EE78B7749}"/>
          </ac:picMkLst>
        </pc:picChg>
        <pc:picChg chg="add">
          <ac:chgData name="Hopcroft, Lorna" userId="S::kgsk887@astrazeneca.net::67a1a19a-5520-4fba-b489-dbb2959a0dc0" providerId="AD" clId="Web-{764C7BA8-45BC-8161-ACF1-A3821E9971FA}" dt="2023-06-07T12:17:49.695" v="0"/>
          <ac:picMkLst>
            <pc:docMk/>
            <pc:sldMk cId="586963921" sldId="281"/>
            <ac:picMk id="153" creationId="{DC8A9916-1448-4C4D-CC77-1D99293A069A}"/>
          </ac:picMkLst>
        </pc:picChg>
        <pc:picChg chg="add">
          <ac:chgData name="Hopcroft, Lorna" userId="S::kgsk887@astrazeneca.net::67a1a19a-5520-4fba-b489-dbb2959a0dc0" providerId="AD" clId="Web-{764C7BA8-45BC-8161-ACF1-A3821E9971FA}" dt="2023-06-07T12:17:49.695" v="0"/>
          <ac:picMkLst>
            <pc:docMk/>
            <pc:sldMk cId="586963921" sldId="281"/>
            <ac:picMk id="155" creationId="{3F0D5E1F-02B8-6C36-5360-67CE2C2AAF31}"/>
          </ac:picMkLst>
        </pc:picChg>
        <pc:cxnChg chg="del">
          <ac:chgData name="Hopcroft, Lorna" userId="S::kgsk887@astrazeneca.net::67a1a19a-5520-4fba-b489-dbb2959a0dc0" providerId="AD" clId="Web-{764C7BA8-45BC-8161-ACF1-A3821E9971FA}" dt="2023-06-07T12:19:23.603" v="10"/>
          <ac:cxnSpMkLst>
            <pc:docMk/>
            <pc:sldMk cId="586963921" sldId="281"/>
            <ac:cxnSpMk id="19" creationId="{9B3854C7-F615-D506-7FCE-4DF8743912B3}"/>
          </ac:cxnSpMkLst>
        </pc:cxnChg>
      </pc:sldChg>
      <pc:sldChg chg="modSp">
        <pc:chgData name="Hopcroft, Lorna" userId="S::kgsk887@astrazeneca.net::67a1a19a-5520-4fba-b489-dbb2959a0dc0" providerId="AD" clId="Web-{764C7BA8-45BC-8161-ACF1-A3821E9971FA}" dt="2023-06-07T13:37:01.878" v="59" actId="20577"/>
        <pc:sldMkLst>
          <pc:docMk/>
          <pc:sldMk cId="4136609356" sldId="284"/>
        </pc:sldMkLst>
        <pc:spChg chg="mod">
          <ac:chgData name="Hopcroft, Lorna" userId="S::kgsk887@astrazeneca.net::67a1a19a-5520-4fba-b489-dbb2959a0dc0" providerId="AD" clId="Web-{764C7BA8-45BC-8161-ACF1-A3821E9971FA}" dt="2023-06-07T13:37:01.878" v="59" actId="20577"/>
          <ac:spMkLst>
            <pc:docMk/>
            <pc:sldMk cId="4136609356" sldId="284"/>
            <ac:spMk id="2" creationId="{87CEF116-AFC8-44FA-B66B-71B5263D6FFB}"/>
          </ac:spMkLst>
        </pc:spChg>
      </pc:sldChg>
      <pc:sldChg chg="modSp">
        <pc:chgData name="Hopcroft, Lorna" userId="S::kgsk887@astrazeneca.net::67a1a19a-5520-4fba-b489-dbb2959a0dc0" providerId="AD" clId="Web-{764C7BA8-45BC-8161-ACF1-A3821E9971FA}" dt="2023-06-07T13:37:10.081" v="61" actId="20577"/>
        <pc:sldMkLst>
          <pc:docMk/>
          <pc:sldMk cId="1575602334" sldId="285"/>
        </pc:sldMkLst>
        <pc:spChg chg="mod">
          <ac:chgData name="Hopcroft, Lorna" userId="S::kgsk887@astrazeneca.net::67a1a19a-5520-4fba-b489-dbb2959a0dc0" providerId="AD" clId="Web-{764C7BA8-45BC-8161-ACF1-A3821E9971FA}" dt="2023-06-07T13:37:10.081" v="61" actId="20577"/>
          <ac:spMkLst>
            <pc:docMk/>
            <pc:sldMk cId="1575602334" sldId="285"/>
            <ac:spMk id="2" creationId="{87CEF116-AFC8-44FA-B66B-71B5263D6FFB}"/>
          </ac:spMkLst>
        </pc:spChg>
      </pc:sldChg>
      <pc:sldChg chg="addSp delSp modSp new ord">
        <pc:chgData name="Hopcroft, Lorna" userId="S::kgsk887@astrazeneca.net::67a1a19a-5520-4fba-b489-dbb2959a0dc0" providerId="AD" clId="Web-{764C7BA8-45BC-8161-ACF1-A3821E9971FA}" dt="2023-06-07T13:25:32.187" v="58" actId="1076"/>
        <pc:sldMkLst>
          <pc:docMk/>
          <pc:sldMk cId="2487637579" sldId="286"/>
        </pc:sldMkLst>
        <pc:spChg chg="add mod">
          <ac:chgData name="Hopcroft, Lorna" userId="S::kgsk887@astrazeneca.net::67a1a19a-5520-4fba-b489-dbb2959a0dc0" providerId="AD" clId="Web-{764C7BA8-45BC-8161-ACF1-A3821E9971FA}" dt="2023-06-07T13:14:28.496" v="20" actId="20577"/>
          <ac:spMkLst>
            <pc:docMk/>
            <pc:sldMk cId="2487637579" sldId="286"/>
            <ac:spMk id="3" creationId="{B1334944-548F-4DA2-3697-905434F3224D}"/>
          </ac:spMkLst>
        </pc:spChg>
        <pc:spChg chg="add mod">
          <ac:chgData name="Hopcroft, Lorna" userId="S::kgsk887@astrazeneca.net::67a1a19a-5520-4fba-b489-dbb2959a0dc0" providerId="AD" clId="Web-{764C7BA8-45BC-8161-ACF1-A3821E9971FA}" dt="2023-06-07T13:25:32.187" v="58" actId="1076"/>
          <ac:spMkLst>
            <pc:docMk/>
            <pc:sldMk cId="2487637579" sldId="286"/>
            <ac:spMk id="6" creationId="{9DDE1708-E215-4D93-5BEA-58AB30411A90}"/>
          </ac:spMkLst>
        </pc:spChg>
        <pc:spChg chg="add">
          <ac:chgData name="Hopcroft, Lorna" userId="S::kgsk887@astrazeneca.net::67a1a19a-5520-4fba-b489-dbb2959a0dc0" providerId="AD" clId="Web-{764C7BA8-45BC-8161-ACF1-A3821E9971FA}" dt="2023-06-07T13:17:16.938" v="28"/>
          <ac:spMkLst>
            <pc:docMk/>
            <pc:sldMk cId="2487637579" sldId="286"/>
            <ac:spMk id="8" creationId="{03B37B17-6FF5-7DA8-74F9-0B6ADFA7361A}"/>
          </ac:spMkLst>
        </pc:spChg>
        <pc:spChg chg="add mod">
          <ac:chgData name="Hopcroft, Lorna" userId="S::kgsk887@astrazeneca.net::67a1a19a-5520-4fba-b489-dbb2959a0dc0" providerId="AD" clId="Web-{764C7BA8-45BC-8161-ACF1-A3821E9971FA}" dt="2023-06-07T13:25:05.342" v="53" actId="1076"/>
          <ac:spMkLst>
            <pc:docMk/>
            <pc:sldMk cId="2487637579" sldId="286"/>
            <ac:spMk id="10" creationId="{9440F98B-9E64-0769-49A3-928C55A67FC9}"/>
          </ac:spMkLst>
        </pc:spChg>
        <pc:picChg chg="add mod">
          <ac:chgData name="Hopcroft, Lorna" userId="S::kgsk887@astrazeneca.net::67a1a19a-5520-4fba-b489-dbb2959a0dc0" providerId="AD" clId="Web-{764C7BA8-45BC-8161-ACF1-A3821E9971FA}" dt="2023-06-07T13:18:55.550" v="36" actId="14100"/>
          <ac:picMkLst>
            <pc:docMk/>
            <pc:sldMk cId="2487637579" sldId="286"/>
            <ac:picMk id="4" creationId="{4382C3F2-05DF-53EE-34F3-AA4D36F1DE3A}"/>
          </ac:picMkLst>
        </pc:picChg>
        <pc:picChg chg="add del mod">
          <ac:chgData name="Hopcroft, Lorna" userId="S::kgsk887@astrazeneca.net::67a1a19a-5520-4fba-b489-dbb2959a0dc0" providerId="AD" clId="Web-{764C7BA8-45BC-8161-ACF1-A3821E9971FA}" dt="2023-06-07T13:23:32.246" v="46"/>
          <ac:picMkLst>
            <pc:docMk/>
            <pc:sldMk cId="2487637579" sldId="286"/>
            <ac:picMk id="11" creationId="{697549D2-9D21-75B8-16BE-33BFA8D2AF1C}"/>
          </ac:picMkLst>
        </pc:picChg>
        <pc:picChg chg="add mod">
          <ac:chgData name="Hopcroft, Lorna" userId="S::kgsk887@astrazeneca.net::67a1a19a-5520-4fba-b489-dbb2959a0dc0" providerId="AD" clId="Web-{764C7BA8-45BC-8161-ACF1-A3821E9971FA}" dt="2023-06-07T13:25:05.420" v="54" actId="1076"/>
          <ac:picMkLst>
            <pc:docMk/>
            <pc:sldMk cId="2487637579" sldId="286"/>
            <ac:picMk id="12" creationId="{B1F2CD61-29DB-3F69-2E39-024EBD0704D1}"/>
          </ac:picMkLst>
        </pc:picChg>
        <pc:picChg chg="add mod">
          <ac:chgData name="Hopcroft, Lorna" userId="S::kgsk887@astrazeneca.net::67a1a19a-5520-4fba-b489-dbb2959a0dc0" providerId="AD" clId="Web-{764C7BA8-45BC-8161-ACF1-A3821E9971FA}" dt="2023-06-07T13:25:22.264" v="57" actId="1076"/>
          <ac:picMkLst>
            <pc:docMk/>
            <pc:sldMk cId="2487637579" sldId="286"/>
            <ac:picMk id="13" creationId="{D8FB6ED2-2AD7-9672-EE4D-121979B86BE1}"/>
          </ac:picMkLst>
        </pc:picChg>
      </pc:sldChg>
    </pc:docChg>
  </pc:docChgLst>
  <pc:docChgLst>
    <pc:chgData name="Wigmore, Eleanor" userId="S::krrf893@astrazeneca.net::154496fa-10d7-4fd7-9fba-3614c367c37c" providerId="AD" clId="Web-{A40CDC60-F649-40A2-E325-04E636F3BB1D}"/>
    <pc:docChg chg="modSld">
      <pc:chgData name="Wigmore, Eleanor" userId="S::krrf893@astrazeneca.net::154496fa-10d7-4fd7-9fba-3614c367c37c" providerId="AD" clId="Web-{A40CDC60-F649-40A2-E325-04E636F3BB1D}" dt="2023-06-15T13:19:21.838" v="11" actId="20577"/>
      <pc:docMkLst>
        <pc:docMk/>
      </pc:docMkLst>
      <pc:sldChg chg="modSp">
        <pc:chgData name="Wigmore, Eleanor" userId="S::krrf893@astrazeneca.net::154496fa-10d7-4fd7-9fba-3614c367c37c" providerId="AD" clId="Web-{A40CDC60-F649-40A2-E325-04E636F3BB1D}" dt="2023-06-15T13:19:21.838" v="11" actId="20577"/>
        <pc:sldMkLst>
          <pc:docMk/>
          <pc:sldMk cId="3220786227" sldId="704"/>
        </pc:sldMkLst>
        <pc:spChg chg="mod">
          <ac:chgData name="Wigmore, Eleanor" userId="S::krrf893@astrazeneca.net::154496fa-10d7-4fd7-9fba-3614c367c37c" providerId="AD" clId="Web-{A40CDC60-F649-40A2-E325-04E636F3BB1D}" dt="2023-06-15T13:19:21.838" v="11" actId="20577"/>
          <ac:spMkLst>
            <pc:docMk/>
            <pc:sldMk cId="3220786227" sldId="704"/>
            <ac:spMk id="47" creationId="{6B92FF38-380F-BEBD-A501-D7C60EDC8E82}"/>
          </ac:spMkLst>
        </pc:spChg>
      </pc:sldChg>
    </pc:docChg>
  </pc:docChgLst>
  <pc:docChgLst>
    <pc:chgData name="Hopcroft, Lorna" userId="67a1a19a-5520-4fba-b489-dbb2959a0dc0" providerId="ADAL" clId="{FA828CC2-BD33-4E7F-89D7-4E0C5C1375F0}"/>
    <pc:docChg chg="undo custSel delSld modSld modNotesMaster">
      <pc:chgData name="Hopcroft, Lorna" userId="67a1a19a-5520-4fba-b489-dbb2959a0dc0" providerId="ADAL" clId="{FA828CC2-BD33-4E7F-89D7-4E0C5C1375F0}" dt="2023-06-23T14:03:01.290" v="748"/>
      <pc:docMkLst>
        <pc:docMk/>
      </pc:docMkLst>
      <pc:sldChg chg="addSp delSp modSp mod modNotes">
        <pc:chgData name="Hopcroft, Lorna" userId="67a1a19a-5520-4fba-b489-dbb2959a0dc0" providerId="ADAL" clId="{FA828CC2-BD33-4E7F-89D7-4E0C5C1375F0}" dt="2023-06-19T20:29:57.869" v="735"/>
        <pc:sldMkLst>
          <pc:docMk/>
          <pc:sldMk cId="586963921" sldId="281"/>
        </pc:sldMkLst>
        <pc:spChg chg="mod">
          <ac:chgData name="Hopcroft, Lorna" userId="67a1a19a-5520-4fba-b489-dbb2959a0dc0" providerId="ADAL" clId="{FA828CC2-BD33-4E7F-89D7-4E0C5C1375F0}" dt="2023-06-16T15:38:13.433" v="259" actId="1076"/>
          <ac:spMkLst>
            <pc:docMk/>
            <pc:sldMk cId="586963921" sldId="281"/>
            <ac:spMk id="3" creationId="{2AA4D702-384A-4A31-C9AA-0978B445134A}"/>
          </ac:spMkLst>
        </pc:spChg>
        <pc:spChg chg="mod">
          <ac:chgData name="Hopcroft, Lorna" userId="67a1a19a-5520-4fba-b489-dbb2959a0dc0" providerId="ADAL" clId="{FA828CC2-BD33-4E7F-89D7-4E0C5C1375F0}" dt="2023-06-16T15:38:34.293" v="260" actId="552"/>
          <ac:spMkLst>
            <pc:docMk/>
            <pc:sldMk cId="586963921" sldId="281"/>
            <ac:spMk id="8" creationId="{DD5EF8AF-295B-81F5-BF24-27CC755B2B5A}"/>
          </ac:spMkLst>
        </pc:spChg>
        <pc:spChg chg="mod">
          <ac:chgData name="Hopcroft, Lorna" userId="67a1a19a-5520-4fba-b489-dbb2959a0dc0" providerId="ADAL" clId="{FA828CC2-BD33-4E7F-89D7-4E0C5C1375F0}" dt="2023-06-16T15:39:00.066" v="263" actId="1038"/>
          <ac:spMkLst>
            <pc:docMk/>
            <pc:sldMk cId="586963921" sldId="281"/>
            <ac:spMk id="9" creationId="{297E8DD9-301D-314C-4943-A35964D1AA08}"/>
          </ac:spMkLst>
        </pc:spChg>
        <pc:spChg chg="mod">
          <ac:chgData name="Hopcroft, Lorna" userId="67a1a19a-5520-4fba-b489-dbb2959a0dc0" providerId="ADAL" clId="{FA828CC2-BD33-4E7F-89D7-4E0C5C1375F0}" dt="2023-06-16T15:38:13.433" v="259" actId="1076"/>
          <ac:spMkLst>
            <pc:docMk/>
            <pc:sldMk cId="586963921" sldId="281"/>
            <ac:spMk id="12" creationId="{93FA6A69-3DE7-7127-4E79-92BD0082C292}"/>
          </ac:spMkLst>
        </pc:spChg>
        <pc:spChg chg="mod">
          <ac:chgData name="Hopcroft, Lorna" userId="67a1a19a-5520-4fba-b489-dbb2959a0dc0" providerId="ADAL" clId="{FA828CC2-BD33-4E7F-89D7-4E0C5C1375F0}" dt="2023-06-16T15:38:13.433" v="259" actId="1076"/>
          <ac:spMkLst>
            <pc:docMk/>
            <pc:sldMk cId="586963921" sldId="281"/>
            <ac:spMk id="13" creationId="{909E9A58-93D6-38DF-65EC-1C1ED6F313A3}"/>
          </ac:spMkLst>
        </pc:spChg>
        <pc:spChg chg="mod">
          <ac:chgData name="Hopcroft, Lorna" userId="67a1a19a-5520-4fba-b489-dbb2959a0dc0" providerId="ADAL" clId="{FA828CC2-BD33-4E7F-89D7-4E0C5C1375F0}" dt="2023-06-16T15:38:13.433" v="259" actId="1076"/>
          <ac:spMkLst>
            <pc:docMk/>
            <pc:sldMk cId="586963921" sldId="281"/>
            <ac:spMk id="14" creationId="{F30AEB6D-B2B4-86BA-1757-734CD16965DB}"/>
          </ac:spMkLst>
        </pc:spChg>
        <pc:spChg chg="mod">
          <ac:chgData name="Hopcroft, Lorna" userId="67a1a19a-5520-4fba-b489-dbb2959a0dc0" providerId="ADAL" clId="{FA828CC2-BD33-4E7F-89D7-4E0C5C1375F0}" dt="2023-06-16T15:38:13.433" v="259" actId="1076"/>
          <ac:spMkLst>
            <pc:docMk/>
            <pc:sldMk cId="586963921" sldId="281"/>
            <ac:spMk id="15" creationId="{228FEBB8-0390-8D1B-723D-F09E5466C48F}"/>
          </ac:spMkLst>
        </pc:spChg>
        <pc:spChg chg="mod">
          <ac:chgData name="Hopcroft, Lorna" userId="67a1a19a-5520-4fba-b489-dbb2959a0dc0" providerId="ADAL" clId="{FA828CC2-BD33-4E7F-89D7-4E0C5C1375F0}" dt="2023-06-16T15:38:13.433" v="259" actId="1076"/>
          <ac:spMkLst>
            <pc:docMk/>
            <pc:sldMk cId="586963921" sldId="281"/>
            <ac:spMk id="16" creationId="{98108D97-2E21-C00C-7C3D-B00397AFCF1E}"/>
          </ac:spMkLst>
        </pc:spChg>
        <pc:spChg chg="mod">
          <ac:chgData name="Hopcroft, Lorna" userId="67a1a19a-5520-4fba-b489-dbb2959a0dc0" providerId="ADAL" clId="{FA828CC2-BD33-4E7F-89D7-4E0C5C1375F0}" dt="2023-06-16T15:38:13.433" v="259" actId="1076"/>
          <ac:spMkLst>
            <pc:docMk/>
            <pc:sldMk cId="586963921" sldId="281"/>
            <ac:spMk id="17" creationId="{F1A7AD55-6D98-2CF5-640D-A1914DE48B87}"/>
          </ac:spMkLst>
        </pc:spChg>
        <pc:spChg chg="mod">
          <ac:chgData name="Hopcroft, Lorna" userId="67a1a19a-5520-4fba-b489-dbb2959a0dc0" providerId="ADAL" clId="{FA828CC2-BD33-4E7F-89D7-4E0C5C1375F0}" dt="2023-06-16T15:38:13.433" v="259" actId="1076"/>
          <ac:spMkLst>
            <pc:docMk/>
            <pc:sldMk cId="586963921" sldId="281"/>
            <ac:spMk id="19" creationId="{3B79A0DA-7376-EC19-AF14-1E514934AFE3}"/>
          </ac:spMkLst>
        </pc:spChg>
        <pc:spChg chg="mod">
          <ac:chgData name="Hopcroft, Lorna" userId="67a1a19a-5520-4fba-b489-dbb2959a0dc0" providerId="ADAL" clId="{FA828CC2-BD33-4E7F-89D7-4E0C5C1375F0}" dt="2023-06-16T15:38:13.433" v="259" actId="1076"/>
          <ac:spMkLst>
            <pc:docMk/>
            <pc:sldMk cId="586963921" sldId="281"/>
            <ac:spMk id="21" creationId="{D09C4768-533A-1C94-2806-D22CC9093A3F}"/>
          </ac:spMkLst>
        </pc:spChg>
        <pc:spChg chg="mod">
          <ac:chgData name="Hopcroft, Lorna" userId="67a1a19a-5520-4fba-b489-dbb2959a0dc0" providerId="ADAL" clId="{FA828CC2-BD33-4E7F-89D7-4E0C5C1375F0}" dt="2023-06-16T15:38:13.433" v="259" actId="1076"/>
          <ac:spMkLst>
            <pc:docMk/>
            <pc:sldMk cId="586963921" sldId="281"/>
            <ac:spMk id="22" creationId="{00CEC6E7-03EC-5337-C6F6-578DD1203325}"/>
          </ac:spMkLst>
        </pc:spChg>
        <pc:spChg chg="mod">
          <ac:chgData name="Hopcroft, Lorna" userId="67a1a19a-5520-4fba-b489-dbb2959a0dc0" providerId="ADAL" clId="{FA828CC2-BD33-4E7F-89D7-4E0C5C1375F0}" dt="2023-06-16T15:38:13.433" v="259" actId="1076"/>
          <ac:spMkLst>
            <pc:docMk/>
            <pc:sldMk cId="586963921" sldId="281"/>
            <ac:spMk id="24" creationId="{A1C1BE1D-C09C-0FB9-94AF-C8A8E719CDD3}"/>
          </ac:spMkLst>
        </pc:spChg>
        <pc:spChg chg="mod">
          <ac:chgData name="Hopcroft, Lorna" userId="67a1a19a-5520-4fba-b489-dbb2959a0dc0" providerId="ADAL" clId="{FA828CC2-BD33-4E7F-89D7-4E0C5C1375F0}" dt="2023-06-16T15:38:13.433" v="259" actId="1076"/>
          <ac:spMkLst>
            <pc:docMk/>
            <pc:sldMk cId="586963921" sldId="281"/>
            <ac:spMk id="25" creationId="{B0E6D0CD-0C30-37AA-4373-6E6247A67433}"/>
          </ac:spMkLst>
        </pc:spChg>
        <pc:spChg chg="mod">
          <ac:chgData name="Hopcroft, Lorna" userId="67a1a19a-5520-4fba-b489-dbb2959a0dc0" providerId="ADAL" clId="{FA828CC2-BD33-4E7F-89D7-4E0C5C1375F0}" dt="2023-06-16T15:38:13.433" v="259" actId="1076"/>
          <ac:spMkLst>
            <pc:docMk/>
            <pc:sldMk cId="586963921" sldId="281"/>
            <ac:spMk id="26" creationId="{5C4B99EA-B8A8-CB5B-BB1B-4A666CFB5B88}"/>
          </ac:spMkLst>
        </pc:spChg>
        <pc:spChg chg="mod">
          <ac:chgData name="Hopcroft, Lorna" userId="67a1a19a-5520-4fba-b489-dbb2959a0dc0" providerId="ADAL" clId="{FA828CC2-BD33-4E7F-89D7-4E0C5C1375F0}" dt="2023-06-16T15:38:13.433" v="259" actId="1076"/>
          <ac:spMkLst>
            <pc:docMk/>
            <pc:sldMk cId="586963921" sldId="281"/>
            <ac:spMk id="27" creationId="{A2ADF71B-2F7F-AE23-5D5B-D00B0CDC8942}"/>
          </ac:spMkLst>
        </pc:spChg>
        <pc:spChg chg="mod">
          <ac:chgData name="Hopcroft, Lorna" userId="67a1a19a-5520-4fba-b489-dbb2959a0dc0" providerId="ADAL" clId="{FA828CC2-BD33-4E7F-89D7-4E0C5C1375F0}" dt="2023-06-16T15:38:13.433" v="259" actId="1076"/>
          <ac:spMkLst>
            <pc:docMk/>
            <pc:sldMk cId="586963921" sldId="281"/>
            <ac:spMk id="28" creationId="{B9FBF815-2EAE-8D46-EBB6-16A0C4C91550}"/>
          </ac:spMkLst>
        </pc:spChg>
        <pc:spChg chg="mod">
          <ac:chgData name="Hopcroft, Lorna" userId="67a1a19a-5520-4fba-b489-dbb2959a0dc0" providerId="ADAL" clId="{FA828CC2-BD33-4E7F-89D7-4E0C5C1375F0}" dt="2023-06-16T15:38:13.433" v="259" actId="1076"/>
          <ac:spMkLst>
            <pc:docMk/>
            <pc:sldMk cId="586963921" sldId="281"/>
            <ac:spMk id="29" creationId="{9CB9E91F-5E5C-8C6A-45E2-C1AB3532E832}"/>
          </ac:spMkLst>
        </pc:spChg>
        <pc:spChg chg="mod">
          <ac:chgData name="Hopcroft, Lorna" userId="67a1a19a-5520-4fba-b489-dbb2959a0dc0" providerId="ADAL" clId="{FA828CC2-BD33-4E7F-89D7-4E0C5C1375F0}" dt="2023-06-16T15:38:13.433" v="259" actId="1076"/>
          <ac:spMkLst>
            <pc:docMk/>
            <pc:sldMk cId="586963921" sldId="281"/>
            <ac:spMk id="30" creationId="{CCA5EF83-F0DF-2D02-5C3E-C0276B97F898}"/>
          </ac:spMkLst>
        </pc:spChg>
        <pc:spChg chg="mod">
          <ac:chgData name="Hopcroft, Lorna" userId="67a1a19a-5520-4fba-b489-dbb2959a0dc0" providerId="ADAL" clId="{FA828CC2-BD33-4E7F-89D7-4E0C5C1375F0}" dt="2023-06-16T15:38:13.433" v="259" actId="1076"/>
          <ac:spMkLst>
            <pc:docMk/>
            <pc:sldMk cId="586963921" sldId="281"/>
            <ac:spMk id="31" creationId="{AB6790D9-6D8A-DDA6-E7B4-21B501E14008}"/>
          </ac:spMkLst>
        </pc:spChg>
        <pc:spChg chg="mod">
          <ac:chgData name="Hopcroft, Lorna" userId="67a1a19a-5520-4fba-b489-dbb2959a0dc0" providerId="ADAL" clId="{FA828CC2-BD33-4E7F-89D7-4E0C5C1375F0}" dt="2023-06-16T15:38:13.433" v="259" actId="1076"/>
          <ac:spMkLst>
            <pc:docMk/>
            <pc:sldMk cId="586963921" sldId="281"/>
            <ac:spMk id="33" creationId="{F6E03C92-5999-B2B1-5CED-35A8036E2807}"/>
          </ac:spMkLst>
        </pc:spChg>
        <pc:spChg chg="mod">
          <ac:chgData name="Hopcroft, Lorna" userId="67a1a19a-5520-4fba-b489-dbb2959a0dc0" providerId="ADAL" clId="{FA828CC2-BD33-4E7F-89D7-4E0C5C1375F0}" dt="2023-06-16T15:38:50.079" v="261" actId="552"/>
          <ac:spMkLst>
            <pc:docMk/>
            <pc:sldMk cId="586963921" sldId="281"/>
            <ac:spMk id="35" creationId="{3CE29AB5-28B1-4DB3-8D3A-CB5D434B155D}"/>
          </ac:spMkLst>
        </pc:spChg>
        <pc:spChg chg="mod">
          <ac:chgData name="Hopcroft, Lorna" userId="67a1a19a-5520-4fba-b489-dbb2959a0dc0" providerId="ADAL" clId="{FA828CC2-BD33-4E7F-89D7-4E0C5C1375F0}" dt="2023-06-16T15:38:34.293" v="260" actId="552"/>
          <ac:spMkLst>
            <pc:docMk/>
            <pc:sldMk cId="586963921" sldId="281"/>
            <ac:spMk id="38" creationId="{55FB8DEA-A1C0-0D21-7E0D-5C65787422E5}"/>
          </ac:spMkLst>
        </pc:spChg>
        <pc:picChg chg="del">
          <ac:chgData name="Hopcroft, Lorna" userId="67a1a19a-5520-4fba-b489-dbb2959a0dc0" providerId="ADAL" clId="{FA828CC2-BD33-4E7F-89D7-4E0C5C1375F0}" dt="2023-06-15T10:29:25.547" v="4" actId="478"/>
          <ac:picMkLst>
            <pc:docMk/>
            <pc:sldMk cId="586963921" sldId="281"/>
            <ac:picMk id="2" creationId="{42015B23-9CD2-B311-1C04-F3D0C8BDAD41}"/>
          </ac:picMkLst>
        </pc:picChg>
        <pc:picChg chg="add mod">
          <ac:chgData name="Hopcroft, Lorna" userId="67a1a19a-5520-4fba-b489-dbb2959a0dc0" providerId="ADAL" clId="{FA828CC2-BD33-4E7F-89D7-4E0C5C1375F0}" dt="2023-06-16T16:12:22.192" v="710" actId="1076"/>
          <ac:picMkLst>
            <pc:docMk/>
            <pc:sldMk cId="586963921" sldId="281"/>
            <ac:picMk id="5" creationId="{AA10CFEC-5F2E-5FB9-B390-35F0AF277C2A}"/>
          </ac:picMkLst>
        </pc:picChg>
        <pc:picChg chg="mod">
          <ac:chgData name="Hopcroft, Lorna" userId="67a1a19a-5520-4fba-b489-dbb2959a0dc0" providerId="ADAL" clId="{FA828CC2-BD33-4E7F-89D7-4E0C5C1375F0}" dt="2023-06-16T15:38:13.433" v="259" actId="1076"/>
          <ac:picMkLst>
            <pc:docMk/>
            <pc:sldMk cId="586963921" sldId="281"/>
            <ac:picMk id="10" creationId="{27224344-FABC-938E-A1FF-0F04C2E18FAF}"/>
          </ac:picMkLst>
        </pc:picChg>
        <pc:picChg chg="mod">
          <ac:chgData name="Hopcroft, Lorna" userId="67a1a19a-5520-4fba-b489-dbb2959a0dc0" providerId="ADAL" clId="{FA828CC2-BD33-4E7F-89D7-4E0C5C1375F0}" dt="2023-06-16T15:38:13.433" v="259" actId="1076"/>
          <ac:picMkLst>
            <pc:docMk/>
            <pc:sldMk cId="586963921" sldId="281"/>
            <ac:picMk id="11" creationId="{7DBD2678-06EB-7FA3-8D3E-4C0CA8B8B47F}"/>
          </ac:picMkLst>
        </pc:picChg>
        <pc:picChg chg="mod">
          <ac:chgData name="Hopcroft, Lorna" userId="67a1a19a-5520-4fba-b489-dbb2959a0dc0" providerId="ADAL" clId="{FA828CC2-BD33-4E7F-89D7-4E0C5C1375F0}" dt="2023-06-16T15:38:13.433" v="259" actId="1076"/>
          <ac:picMkLst>
            <pc:docMk/>
            <pc:sldMk cId="586963921" sldId="281"/>
            <ac:picMk id="18" creationId="{67D9274D-1DC1-5584-EF52-AA0C376954F7}"/>
          </ac:picMkLst>
        </pc:picChg>
        <pc:picChg chg="mod">
          <ac:chgData name="Hopcroft, Lorna" userId="67a1a19a-5520-4fba-b489-dbb2959a0dc0" providerId="ADAL" clId="{FA828CC2-BD33-4E7F-89D7-4E0C5C1375F0}" dt="2023-06-16T15:38:13.433" v="259" actId="1076"/>
          <ac:picMkLst>
            <pc:docMk/>
            <pc:sldMk cId="586963921" sldId="281"/>
            <ac:picMk id="20" creationId="{F4D43267-01F6-7473-4522-3FE968D7CDDA}"/>
          </ac:picMkLst>
        </pc:picChg>
        <pc:picChg chg="mod">
          <ac:chgData name="Hopcroft, Lorna" userId="67a1a19a-5520-4fba-b489-dbb2959a0dc0" providerId="ADAL" clId="{FA828CC2-BD33-4E7F-89D7-4E0C5C1375F0}" dt="2023-06-16T15:38:13.433" v="259" actId="1076"/>
          <ac:picMkLst>
            <pc:docMk/>
            <pc:sldMk cId="586963921" sldId="281"/>
            <ac:picMk id="23" creationId="{A29C8993-DA54-D240-3F35-A59C42CDD73A}"/>
          </ac:picMkLst>
        </pc:picChg>
        <pc:picChg chg="mod">
          <ac:chgData name="Hopcroft, Lorna" userId="67a1a19a-5520-4fba-b489-dbb2959a0dc0" providerId="ADAL" clId="{FA828CC2-BD33-4E7F-89D7-4E0C5C1375F0}" dt="2023-06-16T15:38:13.433" v="259" actId="1076"/>
          <ac:picMkLst>
            <pc:docMk/>
            <pc:sldMk cId="586963921" sldId="281"/>
            <ac:picMk id="32" creationId="{CB6DF7A1-F087-0F21-C0E8-A41A5A1DCA92}"/>
          </ac:picMkLst>
        </pc:picChg>
        <pc:picChg chg="mod">
          <ac:chgData name="Hopcroft, Lorna" userId="67a1a19a-5520-4fba-b489-dbb2959a0dc0" providerId="ADAL" clId="{FA828CC2-BD33-4E7F-89D7-4E0C5C1375F0}" dt="2023-06-16T15:38:13.433" v="259" actId="1076"/>
          <ac:picMkLst>
            <pc:docMk/>
            <pc:sldMk cId="586963921" sldId="281"/>
            <ac:picMk id="36" creationId="{7312AE34-883E-5A1B-C8EA-2E1A778CF595}"/>
          </ac:picMkLst>
        </pc:picChg>
        <pc:picChg chg="mod">
          <ac:chgData name="Hopcroft, Lorna" userId="67a1a19a-5520-4fba-b489-dbb2959a0dc0" providerId="ADAL" clId="{FA828CC2-BD33-4E7F-89D7-4E0C5C1375F0}" dt="2023-06-16T15:38:13.433" v="259" actId="1076"/>
          <ac:picMkLst>
            <pc:docMk/>
            <pc:sldMk cId="586963921" sldId="281"/>
            <ac:picMk id="37" creationId="{79AA0C18-B2C1-9167-66B4-E4D13917BBC9}"/>
          </ac:picMkLst>
        </pc:picChg>
        <pc:picChg chg="mod">
          <ac:chgData name="Hopcroft, Lorna" userId="67a1a19a-5520-4fba-b489-dbb2959a0dc0" providerId="ADAL" clId="{FA828CC2-BD33-4E7F-89D7-4E0C5C1375F0}" dt="2023-06-16T16:12:56.622" v="734" actId="1038"/>
          <ac:picMkLst>
            <pc:docMk/>
            <pc:sldMk cId="586963921" sldId="281"/>
            <ac:picMk id="154" creationId="{406B7FE6-6F82-211D-72DD-CC3956DC78F5}"/>
          </ac:picMkLst>
        </pc:picChg>
      </pc:sldChg>
      <pc:sldChg chg="delSp modSp mod addCm delCm modCm modNotes">
        <pc:chgData name="Hopcroft, Lorna" userId="67a1a19a-5520-4fba-b489-dbb2959a0dc0" providerId="ADAL" clId="{FA828CC2-BD33-4E7F-89D7-4E0C5C1375F0}" dt="2023-06-19T20:32:44.218" v="737"/>
        <pc:sldMkLst>
          <pc:docMk/>
          <pc:sldMk cId="4136609356" sldId="284"/>
        </pc:sldMkLst>
        <pc:spChg chg="mod">
          <ac:chgData name="Hopcroft, Lorna" userId="67a1a19a-5520-4fba-b489-dbb2959a0dc0" providerId="ADAL" clId="{FA828CC2-BD33-4E7F-89D7-4E0C5C1375F0}" dt="2023-06-16T15:40:05.585" v="264" actId="207"/>
          <ac:spMkLst>
            <pc:docMk/>
            <pc:sldMk cId="4136609356" sldId="284"/>
            <ac:spMk id="4" creationId="{94088B88-84D0-4D06-9494-E283F85D81C5}"/>
          </ac:spMkLst>
        </pc:spChg>
        <pc:spChg chg="del">
          <ac:chgData name="Hopcroft, Lorna" userId="67a1a19a-5520-4fba-b489-dbb2959a0dc0" providerId="ADAL" clId="{FA828CC2-BD33-4E7F-89D7-4E0C5C1375F0}" dt="2023-06-16T15:42:21.977" v="266" actId="478"/>
          <ac:spMkLst>
            <pc:docMk/>
            <pc:sldMk cId="4136609356" sldId="284"/>
            <ac:spMk id="14" creationId="{08E831A7-03B9-0D52-7025-40F70F885FF9}"/>
          </ac:spMkLst>
        </pc:spChg>
      </pc:sldChg>
      <pc:sldChg chg="addSp delSp modSp mod">
        <pc:chgData name="Hopcroft, Lorna" userId="67a1a19a-5520-4fba-b489-dbb2959a0dc0" providerId="ADAL" clId="{FA828CC2-BD33-4E7F-89D7-4E0C5C1375F0}" dt="2023-06-15T10:53:03.307" v="252" actId="1035"/>
        <pc:sldMkLst>
          <pc:docMk/>
          <pc:sldMk cId="2487637579" sldId="286"/>
        </pc:sldMkLst>
        <pc:spChg chg="mod">
          <ac:chgData name="Hopcroft, Lorna" userId="67a1a19a-5520-4fba-b489-dbb2959a0dc0" providerId="ADAL" clId="{FA828CC2-BD33-4E7F-89D7-4E0C5C1375F0}" dt="2023-06-15T10:53:03.307" v="252" actId="1035"/>
          <ac:spMkLst>
            <pc:docMk/>
            <pc:sldMk cId="2487637579" sldId="286"/>
            <ac:spMk id="6" creationId="{9DDE1708-E215-4D93-5BEA-58AB30411A90}"/>
          </ac:spMkLst>
        </pc:spChg>
        <pc:spChg chg="mod">
          <ac:chgData name="Hopcroft, Lorna" userId="67a1a19a-5520-4fba-b489-dbb2959a0dc0" providerId="ADAL" clId="{FA828CC2-BD33-4E7F-89D7-4E0C5C1375F0}" dt="2023-06-15T10:52:52.412" v="243" actId="1036"/>
          <ac:spMkLst>
            <pc:docMk/>
            <pc:sldMk cId="2487637579" sldId="286"/>
            <ac:spMk id="10" creationId="{9440F98B-9E64-0769-49A3-928C55A67FC9}"/>
          </ac:spMkLst>
        </pc:spChg>
        <pc:graphicFrameChg chg="add mod">
          <ac:chgData name="Hopcroft, Lorna" userId="67a1a19a-5520-4fba-b489-dbb2959a0dc0" providerId="ADAL" clId="{FA828CC2-BD33-4E7F-89D7-4E0C5C1375F0}" dt="2023-06-15T10:41:32.875" v="180" actId="1076"/>
          <ac:graphicFrameMkLst>
            <pc:docMk/>
            <pc:sldMk cId="2487637579" sldId="286"/>
            <ac:graphicFrameMk id="2" creationId="{6E3D9797-DACA-5CD9-47B1-8D2AF69F2060}"/>
          </ac:graphicFrameMkLst>
        </pc:graphicFrameChg>
        <pc:graphicFrameChg chg="add del mod">
          <ac:chgData name="Hopcroft, Lorna" userId="67a1a19a-5520-4fba-b489-dbb2959a0dc0" providerId="ADAL" clId="{FA828CC2-BD33-4E7F-89D7-4E0C5C1375F0}" dt="2023-06-15T10:44:37.472" v="192" actId="478"/>
          <ac:graphicFrameMkLst>
            <pc:docMk/>
            <pc:sldMk cId="2487637579" sldId="286"/>
            <ac:graphicFrameMk id="5" creationId="{0AC7FEF4-BD47-40B8-277C-C38BBCE243A4}"/>
          </ac:graphicFrameMkLst>
        </pc:graphicFrameChg>
        <pc:graphicFrameChg chg="add mod">
          <ac:chgData name="Hopcroft, Lorna" userId="67a1a19a-5520-4fba-b489-dbb2959a0dc0" providerId="ADAL" clId="{FA828CC2-BD33-4E7F-89D7-4E0C5C1375F0}" dt="2023-06-15T10:53:03.307" v="252" actId="1035"/>
          <ac:graphicFrameMkLst>
            <pc:docMk/>
            <pc:sldMk cId="2487637579" sldId="286"/>
            <ac:graphicFrameMk id="7" creationId="{93315321-C7FF-F0E5-00A6-234067AFC343}"/>
          </ac:graphicFrameMkLst>
        </pc:graphicFrameChg>
        <pc:graphicFrameChg chg="add del mod">
          <ac:chgData name="Hopcroft, Lorna" userId="67a1a19a-5520-4fba-b489-dbb2959a0dc0" providerId="ADAL" clId="{FA828CC2-BD33-4E7F-89D7-4E0C5C1375F0}" dt="2023-06-15T10:51:22.141" v="212" actId="478"/>
          <ac:graphicFrameMkLst>
            <pc:docMk/>
            <pc:sldMk cId="2487637579" sldId="286"/>
            <ac:graphicFrameMk id="9" creationId="{4E0CDE45-BF27-4024-6E24-AD660C81CD58}"/>
          </ac:graphicFrameMkLst>
        </pc:graphicFrameChg>
        <pc:graphicFrameChg chg="add mod">
          <ac:chgData name="Hopcroft, Lorna" userId="67a1a19a-5520-4fba-b489-dbb2959a0dc0" providerId="ADAL" clId="{FA828CC2-BD33-4E7F-89D7-4E0C5C1375F0}" dt="2023-06-15T10:52:52.412" v="243" actId="1036"/>
          <ac:graphicFrameMkLst>
            <pc:docMk/>
            <pc:sldMk cId="2487637579" sldId="286"/>
            <ac:graphicFrameMk id="11" creationId="{D1676BB6-7E4A-369F-73C1-FE5B0EDEFB84}"/>
          </ac:graphicFrameMkLst>
        </pc:graphicFrameChg>
        <pc:picChg chg="del">
          <ac:chgData name="Hopcroft, Lorna" userId="67a1a19a-5520-4fba-b489-dbb2959a0dc0" providerId="ADAL" clId="{FA828CC2-BD33-4E7F-89D7-4E0C5C1375F0}" dt="2023-06-15T10:41:26.460" v="179" actId="478"/>
          <ac:picMkLst>
            <pc:docMk/>
            <pc:sldMk cId="2487637579" sldId="286"/>
            <ac:picMk id="4" creationId="{4382C3F2-05DF-53EE-34F3-AA4D36F1DE3A}"/>
          </ac:picMkLst>
        </pc:picChg>
        <pc:picChg chg="del">
          <ac:chgData name="Hopcroft, Lorna" userId="67a1a19a-5520-4fba-b489-dbb2959a0dc0" providerId="ADAL" clId="{FA828CC2-BD33-4E7F-89D7-4E0C5C1375F0}" dt="2023-06-15T10:45:52.777" v="203" actId="478"/>
          <ac:picMkLst>
            <pc:docMk/>
            <pc:sldMk cId="2487637579" sldId="286"/>
            <ac:picMk id="12" creationId="{B1F2CD61-29DB-3F69-2E39-024EBD0704D1}"/>
          </ac:picMkLst>
        </pc:picChg>
        <pc:picChg chg="del">
          <ac:chgData name="Hopcroft, Lorna" userId="67a1a19a-5520-4fba-b489-dbb2959a0dc0" providerId="ADAL" clId="{FA828CC2-BD33-4E7F-89D7-4E0C5C1375F0}" dt="2023-06-15T10:43:45.916" v="184" actId="478"/>
          <ac:picMkLst>
            <pc:docMk/>
            <pc:sldMk cId="2487637579" sldId="286"/>
            <ac:picMk id="13" creationId="{D8FB6ED2-2AD7-9672-EE4D-121979B86BE1}"/>
          </ac:picMkLst>
        </pc:picChg>
      </pc:sldChg>
      <pc:sldChg chg="del">
        <pc:chgData name="Hopcroft, Lorna" userId="67a1a19a-5520-4fba-b489-dbb2959a0dc0" providerId="ADAL" clId="{FA828CC2-BD33-4E7F-89D7-4E0C5C1375F0}" dt="2023-06-16T16:11:00.533" v="709" actId="47"/>
        <pc:sldMkLst>
          <pc:docMk/>
          <pc:sldMk cId="3083837531" sldId="619"/>
        </pc:sldMkLst>
      </pc:sldChg>
      <pc:sldChg chg="modSp mod">
        <pc:chgData name="Hopcroft, Lorna" userId="67a1a19a-5520-4fba-b489-dbb2959a0dc0" providerId="ADAL" clId="{FA828CC2-BD33-4E7F-89D7-4E0C5C1375F0}" dt="2023-06-23T14:03:01.290" v="748"/>
        <pc:sldMkLst>
          <pc:docMk/>
          <pc:sldMk cId="2783461508" sldId="702"/>
        </pc:sldMkLst>
        <pc:spChg chg="mod">
          <ac:chgData name="Hopcroft, Lorna" userId="67a1a19a-5520-4fba-b489-dbb2959a0dc0" providerId="ADAL" clId="{FA828CC2-BD33-4E7F-89D7-4E0C5C1375F0}" dt="2023-06-16T16:09:43.905" v="708" actId="404"/>
          <ac:spMkLst>
            <pc:docMk/>
            <pc:sldMk cId="2783461508" sldId="702"/>
            <ac:spMk id="7" creationId="{690B4F0A-23A9-327F-F2C4-F9A788044BCE}"/>
          </ac:spMkLst>
        </pc:spChg>
        <pc:spChg chg="mod">
          <ac:chgData name="Hopcroft, Lorna" userId="67a1a19a-5520-4fba-b489-dbb2959a0dc0" providerId="ADAL" clId="{FA828CC2-BD33-4E7F-89D7-4E0C5C1375F0}" dt="2023-06-16T16:09:43.905" v="708" actId="404"/>
          <ac:spMkLst>
            <pc:docMk/>
            <pc:sldMk cId="2783461508" sldId="702"/>
            <ac:spMk id="41" creationId="{2DB41E03-24E5-EEDD-7046-25B06366DAA3}"/>
          </ac:spMkLst>
        </pc:spChg>
        <pc:graphicFrameChg chg="mod">
          <ac:chgData name="Hopcroft, Lorna" userId="67a1a19a-5520-4fba-b489-dbb2959a0dc0" providerId="ADAL" clId="{FA828CC2-BD33-4E7F-89D7-4E0C5C1375F0}" dt="2023-06-23T14:02:39.858" v="746"/>
          <ac:graphicFrameMkLst>
            <pc:docMk/>
            <pc:sldMk cId="2783461508" sldId="702"/>
            <ac:graphicFrameMk id="35" creationId="{A4058A3D-3223-33B0-2E24-C41CA2CD53EB}"/>
          </ac:graphicFrameMkLst>
        </pc:graphicFrameChg>
        <pc:graphicFrameChg chg="mod">
          <ac:chgData name="Hopcroft, Lorna" userId="67a1a19a-5520-4fba-b489-dbb2959a0dc0" providerId="ADAL" clId="{FA828CC2-BD33-4E7F-89D7-4E0C5C1375F0}" dt="2023-06-16T16:05:42.559" v="682" actId="554"/>
          <ac:graphicFrameMkLst>
            <pc:docMk/>
            <pc:sldMk cId="2783461508" sldId="702"/>
            <ac:graphicFrameMk id="36" creationId="{9BD7B739-1E3D-955C-2E6F-F70A120EE103}"/>
          </ac:graphicFrameMkLst>
        </pc:graphicFrameChg>
        <pc:graphicFrameChg chg="mod">
          <ac:chgData name="Hopcroft, Lorna" userId="67a1a19a-5520-4fba-b489-dbb2959a0dc0" providerId="ADAL" clId="{FA828CC2-BD33-4E7F-89D7-4E0C5C1375F0}" dt="2023-06-16T16:05:21.788" v="679" actId="408"/>
          <ac:graphicFrameMkLst>
            <pc:docMk/>
            <pc:sldMk cId="2783461508" sldId="702"/>
            <ac:graphicFrameMk id="37" creationId="{55709A9B-B64A-093A-A42B-A66E14DEF1C9}"/>
          </ac:graphicFrameMkLst>
        </pc:graphicFrameChg>
        <pc:graphicFrameChg chg="mod">
          <ac:chgData name="Hopcroft, Lorna" userId="67a1a19a-5520-4fba-b489-dbb2959a0dc0" providerId="ADAL" clId="{FA828CC2-BD33-4E7F-89D7-4E0C5C1375F0}" dt="2023-06-23T14:03:01.290" v="748"/>
          <ac:graphicFrameMkLst>
            <pc:docMk/>
            <pc:sldMk cId="2783461508" sldId="702"/>
            <ac:graphicFrameMk id="38" creationId="{06CB48F0-8299-287A-A155-249ECD8715AC}"/>
          </ac:graphicFrameMkLst>
        </pc:graphicFrameChg>
        <pc:graphicFrameChg chg="mod">
          <ac:chgData name="Hopcroft, Lorna" userId="67a1a19a-5520-4fba-b489-dbb2959a0dc0" providerId="ADAL" clId="{FA828CC2-BD33-4E7F-89D7-4E0C5C1375F0}" dt="2023-06-16T16:06:56.851" v="690"/>
          <ac:graphicFrameMkLst>
            <pc:docMk/>
            <pc:sldMk cId="2783461508" sldId="702"/>
            <ac:graphicFrameMk id="39" creationId="{CF9B2906-1C81-85C8-C863-A620A2E4297C}"/>
          </ac:graphicFrameMkLst>
        </pc:graphicFrameChg>
        <pc:graphicFrameChg chg="mod">
          <ac:chgData name="Hopcroft, Lorna" userId="67a1a19a-5520-4fba-b489-dbb2959a0dc0" providerId="ADAL" clId="{FA828CC2-BD33-4E7F-89D7-4E0C5C1375F0}" dt="2023-06-16T16:06:16.035" v="686" actId="552"/>
          <ac:graphicFrameMkLst>
            <pc:docMk/>
            <pc:sldMk cId="2783461508" sldId="702"/>
            <ac:graphicFrameMk id="40" creationId="{9DD8CAB0-B12F-E2FB-72C6-58CA717977C9}"/>
          </ac:graphicFrameMkLst>
        </pc:graphicFrameChg>
        <pc:graphicFrameChg chg="mod">
          <ac:chgData name="Hopcroft, Lorna" userId="67a1a19a-5520-4fba-b489-dbb2959a0dc0" providerId="ADAL" clId="{FA828CC2-BD33-4E7F-89D7-4E0C5C1375F0}" dt="2023-06-20T12:29:32.866" v="744"/>
          <ac:graphicFrameMkLst>
            <pc:docMk/>
            <pc:sldMk cId="2783461508" sldId="702"/>
            <ac:graphicFrameMk id="45" creationId="{4A14629F-CFCD-DEC4-864C-A14EA62EC529}"/>
          </ac:graphicFrameMkLst>
        </pc:graphicFrameChg>
      </pc:sldChg>
      <pc:sldChg chg="delSp mod modNotes">
        <pc:chgData name="Hopcroft, Lorna" userId="67a1a19a-5520-4fba-b489-dbb2959a0dc0" providerId="ADAL" clId="{FA828CC2-BD33-4E7F-89D7-4E0C5C1375F0}" dt="2023-06-19T20:29:57.869" v="735"/>
        <pc:sldMkLst>
          <pc:docMk/>
          <pc:sldMk cId="1783606474" sldId="703"/>
        </pc:sldMkLst>
        <pc:spChg chg="del">
          <ac:chgData name="Hopcroft, Lorna" userId="67a1a19a-5520-4fba-b489-dbb2959a0dc0" providerId="ADAL" clId="{FA828CC2-BD33-4E7F-89D7-4E0C5C1375F0}" dt="2023-06-16T15:42:27.804" v="267" actId="478"/>
          <ac:spMkLst>
            <pc:docMk/>
            <pc:sldMk cId="1783606474" sldId="703"/>
            <ac:spMk id="58" creationId="{8A92CC75-CDFE-8631-FE6B-BF688B9AE4C6}"/>
          </ac:spMkLst>
        </pc:spChg>
      </pc:sldChg>
      <pc:sldChg chg="addSp delSp modSp mod modNotes">
        <pc:chgData name="Hopcroft, Lorna" userId="67a1a19a-5520-4fba-b489-dbb2959a0dc0" providerId="ADAL" clId="{FA828CC2-BD33-4E7F-89D7-4E0C5C1375F0}" dt="2023-06-19T20:29:57.869" v="735"/>
        <pc:sldMkLst>
          <pc:docMk/>
          <pc:sldMk cId="3220786227" sldId="704"/>
        </pc:sldMkLst>
        <pc:spChg chg="mod">
          <ac:chgData name="Hopcroft, Lorna" userId="67a1a19a-5520-4fba-b489-dbb2959a0dc0" providerId="ADAL" clId="{FA828CC2-BD33-4E7F-89D7-4E0C5C1375F0}" dt="2023-06-16T15:56:30.633" v="609" actId="554"/>
          <ac:spMkLst>
            <pc:docMk/>
            <pc:sldMk cId="3220786227" sldId="704"/>
            <ac:spMk id="7" creationId="{DA10C712-1CC6-1220-C9B7-E6A3DBBC7B16}"/>
          </ac:spMkLst>
        </pc:spChg>
        <pc:spChg chg="mod">
          <ac:chgData name="Hopcroft, Lorna" userId="67a1a19a-5520-4fba-b489-dbb2959a0dc0" providerId="ADAL" clId="{FA828CC2-BD33-4E7F-89D7-4E0C5C1375F0}" dt="2023-06-16T15:51:45.585" v="486" actId="554"/>
          <ac:spMkLst>
            <pc:docMk/>
            <pc:sldMk cId="3220786227" sldId="704"/>
            <ac:spMk id="8" creationId="{A898017B-4EA9-917C-71B6-63BB6E99402E}"/>
          </ac:spMkLst>
        </pc:spChg>
        <pc:spChg chg="mod">
          <ac:chgData name="Hopcroft, Lorna" userId="67a1a19a-5520-4fba-b489-dbb2959a0dc0" providerId="ADAL" clId="{FA828CC2-BD33-4E7F-89D7-4E0C5C1375F0}" dt="2023-06-16T15:51:45.585" v="486" actId="554"/>
          <ac:spMkLst>
            <pc:docMk/>
            <pc:sldMk cId="3220786227" sldId="704"/>
            <ac:spMk id="9" creationId="{514B49CF-16CB-E2B0-F1A1-B713D7F08EC2}"/>
          </ac:spMkLst>
        </pc:spChg>
        <pc:spChg chg="mod">
          <ac:chgData name="Hopcroft, Lorna" userId="67a1a19a-5520-4fba-b489-dbb2959a0dc0" providerId="ADAL" clId="{FA828CC2-BD33-4E7F-89D7-4E0C5C1375F0}" dt="2023-06-16T15:47:29.748" v="365" actId="555"/>
          <ac:spMkLst>
            <pc:docMk/>
            <pc:sldMk cId="3220786227" sldId="704"/>
            <ac:spMk id="13" creationId="{A252DAE2-ED94-B91A-0FA2-BA1842318B3D}"/>
          </ac:spMkLst>
        </pc:spChg>
        <pc:spChg chg="mod">
          <ac:chgData name="Hopcroft, Lorna" userId="67a1a19a-5520-4fba-b489-dbb2959a0dc0" providerId="ADAL" clId="{FA828CC2-BD33-4E7F-89D7-4E0C5C1375F0}" dt="2023-06-16T15:47:29.748" v="365" actId="555"/>
          <ac:spMkLst>
            <pc:docMk/>
            <pc:sldMk cId="3220786227" sldId="704"/>
            <ac:spMk id="14" creationId="{3FBF8DFD-4646-B736-BF8B-CCD208758FAE}"/>
          </ac:spMkLst>
        </pc:spChg>
        <pc:spChg chg="mod">
          <ac:chgData name="Hopcroft, Lorna" userId="67a1a19a-5520-4fba-b489-dbb2959a0dc0" providerId="ADAL" clId="{FA828CC2-BD33-4E7F-89D7-4E0C5C1375F0}" dt="2023-06-16T15:51:45.585" v="486" actId="554"/>
          <ac:spMkLst>
            <pc:docMk/>
            <pc:sldMk cId="3220786227" sldId="704"/>
            <ac:spMk id="15" creationId="{F8562B7B-CECD-420F-1A53-D33D77D107B6}"/>
          </ac:spMkLst>
        </pc:spChg>
        <pc:spChg chg="mod">
          <ac:chgData name="Hopcroft, Lorna" userId="67a1a19a-5520-4fba-b489-dbb2959a0dc0" providerId="ADAL" clId="{FA828CC2-BD33-4E7F-89D7-4E0C5C1375F0}" dt="2023-06-16T15:47:29.748" v="365" actId="555"/>
          <ac:spMkLst>
            <pc:docMk/>
            <pc:sldMk cId="3220786227" sldId="704"/>
            <ac:spMk id="17" creationId="{DAD5CD2D-FB34-76C2-AFC2-E7C4776AD1C3}"/>
          </ac:spMkLst>
        </pc:spChg>
        <pc:spChg chg="mod">
          <ac:chgData name="Hopcroft, Lorna" userId="67a1a19a-5520-4fba-b489-dbb2959a0dc0" providerId="ADAL" clId="{FA828CC2-BD33-4E7F-89D7-4E0C5C1375F0}" dt="2023-06-16T15:57:22.035" v="633" actId="1037"/>
          <ac:spMkLst>
            <pc:docMk/>
            <pc:sldMk cId="3220786227" sldId="704"/>
            <ac:spMk id="18" creationId="{F3340808-A7B5-D87D-BEED-63B193AD5EC3}"/>
          </ac:spMkLst>
        </pc:spChg>
        <pc:spChg chg="mod">
          <ac:chgData name="Hopcroft, Lorna" userId="67a1a19a-5520-4fba-b489-dbb2959a0dc0" providerId="ADAL" clId="{FA828CC2-BD33-4E7F-89D7-4E0C5C1375F0}" dt="2023-06-16T15:57:55.794" v="657" actId="1038"/>
          <ac:spMkLst>
            <pc:docMk/>
            <pc:sldMk cId="3220786227" sldId="704"/>
            <ac:spMk id="22" creationId="{557AA382-4895-7F10-B8D6-0479A8FC7615}"/>
          </ac:spMkLst>
        </pc:spChg>
        <pc:spChg chg="mod">
          <ac:chgData name="Hopcroft, Lorna" userId="67a1a19a-5520-4fba-b489-dbb2959a0dc0" providerId="ADAL" clId="{FA828CC2-BD33-4E7F-89D7-4E0C5C1375F0}" dt="2023-06-16T15:47:29.748" v="365" actId="555"/>
          <ac:spMkLst>
            <pc:docMk/>
            <pc:sldMk cId="3220786227" sldId="704"/>
            <ac:spMk id="23" creationId="{8601994B-901E-A6BE-C029-4EB6A6021926}"/>
          </ac:spMkLst>
        </pc:spChg>
        <pc:spChg chg="mod">
          <ac:chgData name="Hopcroft, Lorna" userId="67a1a19a-5520-4fba-b489-dbb2959a0dc0" providerId="ADAL" clId="{FA828CC2-BD33-4E7F-89D7-4E0C5C1375F0}" dt="2023-06-16T15:47:29.748" v="365" actId="555"/>
          <ac:spMkLst>
            <pc:docMk/>
            <pc:sldMk cId="3220786227" sldId="704"/>
            <ac:spMk id="24" creationId="{81089332-DEEA-E983-A187-F0A7E8CAE5F6}"/>
          </ac:spMkLst>
        </pc:spChg>
        <pc:spChg chg="mod">
          <ac:chgData name="Hopcroft, Lorna" userId="67a1a19a-5520-4fba-b489-dbb2959a0dc0" providerId="ADAL" clId="{FA828CC2-BD33-4E7F-89D7-4E0C5C1375F0}" dt="2023-06-16T15:57:55.794" v="657" actId="1038"/>
          <ac:spMkLst>
            <pc:docMk/>
            <pc:sldMk cId="3220786227" sldId="704"/>
            <ac:spMk id="25" creationId="{41632CC1-87BB-A1FD-6F0F-C7898E77BC04}"/>
          </ac:spMkLst>
        </pc:spChg>
        <pc:spChg chg="mod">
          <ac:chgData name="Hopcroft, Lorna" userId="67a1a19a-5520-4fba-b489-dbb2959a0dc0" providerId="ADAL" clId="{FA828CC2-BD33-4E7F-89D7-4E0C5C1375F0}" dt="2023-06-16T15:57:55.794" v="657" actId="1038"/>
          <ac:spMkLst>
            <pc:docMk/>
            <pc:sldMk cId="3220786227" sldId="704"/>
            <ac:spMk id="26" creationId="{3F6567F8-948C-3776-04AE-1F4997F2DC06}"/>
          </ac:spMkLst>
        </pc:spChg>
        <pc:spChg chg="mod">
          <ac:chgData name="Hopcroft, Lorna" userId="67a1a19a-5520-4fba-b489-dbb2959a0dc0" providerId="ADAL" clId="{FA828CC2-BD33-4E7F-89D7-4E0C5C1375F0}" dt="2023-06-16T15:59:04.756" v="661" actId="408"/>
          <ac:spMkLst>
            <pc:docMk/>
            <pc:sldMk cId="3220786227" sldId="704"/>
            <ac:spMk id="47" creationId="{6B92FF38-380F-BEBD-A501-D7C60EDC8E82}"/>
          </ac:spMkLst>
        </pc:spChg>
        <pc:spChg chg="mod">
          <ac:chgData name="Hopcroft, Lorna" userId="67a1a19a-5520-4fba-b489-dbb2959a0dc0" providerId="ADAL" clId="{FA828CC2-BD33-4E7F-89D7-4E0C5C1375F0}" dt="2023-06-16T15:49:06.326" v="418" actId="554"/>
          <ac:spMkLst>
            <pc:docMk/>
            <pc:sldMk cId="3220786227" sldId="704"/>
            <ac:spMk id="48" creationId="{87C71E5F-0FFD-2F68-A166-79BDB8E0A3E9}"/>
          </ac:spMkLst>
        </pc:spChg>
        <pc:spChg chg="mod">
          <ac:chgData name="Hopcroft, Lorna" userId="67a1a19a-5520-4fba-b489-dbb2959a0dc0" providerId="ADAL" clId="{FA828CC2-BD33-4E7F-89D7-4E0C5C1375F0}" dt="2023-06-16T15:49:06.326" v="418" actId="554"/>
          <ac:spMkLst>
            <pc:docMk/>
            <pc:sldMk cId="3220786227" sldId="704"/>
            <ac:spMk id="49" creationId="{B58D13CD-5E78-E71C-136F-F06ECA725B0D}"/>
          </ac:spMkLst>
        </pc:spChg>
        <pc:spChg chg="mod">
          <ac:chgData name="Hopcroft, Lorna" userId="67a1a19a-5520-4fba-b489-dbb2959a0dc0" providerId="ADAL" clId="{FA828CC2-BD33-4E7F-89D7-4E0C5C1375F0}" dt="2023-06-16T15:49:18.723" v="419" actId="555"/>
          <ac:spMkLst>
            <pc:docMk/>
            <pc:sldMk cId="3220786227" sldId="704"/>
            <ac:spMk id="50" creationId="{A55A861A-964D-E34E-DC7C-C54EE138D129}"/>
          </ac:spMkLst>
        </pc:spChg>
        <pc:spChg chg="mod">
          <ac:chgData name="Hopcroft, Lorna" userId="67a1a19a-5520-4fba-b489-dbb2959a0dc0" providerId="ADAL" clId="{FA828CC2-BD33-4E7F-89D7-4E0C5C1375F0}" dt="2023-06-16T15:49:18.723" v="419" actId="555"/>
          <ac:spMkLst>
            <pc:docMk/>
            <pc:sldMk cId="3220786227" sldId="704"/>
            <ac:spMk id="51" creationId="{6AFD9CB6-235F-7501-6D52-965F014C4D2F}"/>
          </ac:spMkLst>
        </pc:spChg>
        <pc:spChg chg="mod">
          <ac:chgData name="Hopcroft, Lorna" userId="67a1a19a-5520-4fba-b489-dbb2959a0dc0" providerId="ADAL" clId="{FA828CC2-BD33-4E7F-89D7-4E0C5C1375F0}" dt="2023-06-16T15:53:10.789" v="508" actId="1038"/>
          <ac:spMkLst>
            <pc:docMk/>
            <pc:sldMk cId="3220786227" sldId="704"/>
            <ac:spMk id="52" creationId="{8EECABB6-EB54-EC48-D101-3A84490D35CD}"/>
          </ac:spMkLst>
        </pc:spChg>
        <pc:spChg chg="mod">
          <ac:chgData name="Hopcroft, Lorna" userId="67a1a19a-5520-4fba-b489-dbb2959a0dc0" providerId="ADAL" clId="{FA828CC2-BD33-4E7F-89D7-4E0C5C1375F0}" dt="2023-06-16T15:49:18.723" v="419" actId="555"/>
          <ac:spMkLst>
            <pc:docMk/>
            <pc:sldMk cId="3220786227" sldId="704"/>
            <ac:spMk id="53" creationId="{4A272DF7-8D3B-C054-1814-C9AB868071D5}"/>
          </ac:spMkLst>
        </pc:spChg>
        <pc:spChg chg="mod">
          <ac:chgData name="Hopcroft, Lorna" userId="67a1a19a-5520-4fba-b489-dbb2959a0dc0" providerId="ADAL" clId="{FA828CC2-BD33-4E7F-89D7-4E0C5C1375F0}" dt="2023-06-16T15:49:18.723" v="419" actId="555"/>
          <ac:spMkLst>
            <pc:docMk/>
            <pc:sldMk cId="3220786227" sldId="704"/>
            <ac:spMk id="54" creationId="{3B85F7CD-0D98-E094-6238-23CFF7C33F01}"/>
          </ac:spMkLst>
        </pc:spChg>
        <pc:spChg chg="mod">
          <ac:chgData name="Hopcroft, Lorna" userId="67a1a19a-5520-4fba-b489-dbb2959a0dc0" providerId="ADAL" clId="{FA828CC2-BD33-4E7F-89D7-4E0C5C1375F0}" dt="2023-06-16T15:49:18.723" v="419" actId="555"/>
          <ac:spMkLst>
            <pc:docMk/>
            <pc:sldMk cId="3220786227" sldId="704"/>
            <ac:spMk id="55" creationId="{960AEACA-9700-D1BC-6904-AE91F015BD58}"/>
          </ac:spMkLst>
        </pc:spChg>
        <pc:spChg chg="mod">
          <ac:chgData name="Hopcroft, Lorna" userId="67a1a19a-5520-4fba-b489-dbb2959a0dc0" providerId="ADAL" clId="{FA828CC2-BD33-4E7F-89D7-4E0C5C1375F0}" dt="2023-06-16T15:47:29.748" v="365" actId="555"/>
          <ac:spMkLst>
            <pc:docMk/>
            <pc:sldMk cId="3220786227" sldId="704"/>
            <ac:spMk id="56" creationId="{E24C2910-9259-7F18-A27D-CB54463A8B1D}"/>
          </ac:spMkLst>
        </pc:spChg>
        <pc:spChg chg="mod">
          <ac:chgData name="Hopcroft, Lorna" userId="67a1a19a-5520-4fba-b489-dbb2959a0dc0" providerId="ADAL" clId="{FA828CC2-BD33-4E7F-89D7-4E0C5C1375F0}" dt="2023-06-16T15:58:29.806" v="658" actId="408"/>
          <ac:spMkLst>
            <pc:docMk/>
            <pc:sldMk cId="3220786227" sldId="704"/>
            <ac:spMk id="57" creationId="{3FC7077D-FC72-9E36-582F-E9B5F13378A7}"/>
          </ac:spMkLst>
        </pc:spChg>
        <pc:spChg chg="mod">
          <ac:chgData name="Hopcroft, Lorna" userId="67a1a19a-5520-4fba-b489-dbb2959a0dc0" providerId="ADAL" clId="{FA828CC2-BD33-4E7F-89D7-4E0C5C1375F0}" dt="2023-06-16T15:49:06.326" v="418" actId="554"/>
          <ac:spMkLst>
            <pc:docMk/>
            <pc:sldMk cId="3220786227" sldId="704"/>
            <ac:spMk id="58" creationId="{424E8B91-37D2-AABC-B4D1-B59E4F3FC8E5}"/>
          </ac:spMkLst>
        </pc:spChg>
        <pc:spChg chg="mod">
          <ac:chgData name="Hopcroft, Lorna" userId="67a1a19a-5520-4fba-b489-dbb2959a0dc0" providerId="ADAL" clId="{FA828CC2-BD33-4E7F-89D7-4E0C5C1375F0}" dt="2023-06-16T15:49:06.326" v="418" actId="554"/>
          <ac:spMkLst>
            <pc:docMk/>
            <pc:sldMk cId="3220786227" sldId="704"/>
            <ac:spMk id="59" creationId="{286DA675-929D-E5C0-E2D1-54BC287F6809}"/>
          </ac:spMkLst>
        </pc:spChg>
        <pc:spChg chg="mod">
          <ac:chgData name="Hopcroft, Lorna" userId="67a1a19a-5520-4fba-b489-dbb2959a0dc0" providerId="ADAL" clId="{FA828CC2-BD33-4E7F-89D7-4E0C5C1375F0}" dt="2023-06-16T15:49:18.723" v="419" actId="555"/>
          <ac:spMkLst>
            <pc:docMk/>
            <pc:sldMk cId="3220786227" sldId="704"/>
            <ac:spMk id="60" creationId="{10662019-6F45-78D5-0111-087FC48E63E5}"/>
          </ac:spMkLst>
        </pc:spChg>
        <pc:spChg chg="mod">
          <ac:chgData name="Hopcroft, Lorna" userId="67a1a19a-5520-4fba-b489-dbb2959a0dc0" providerId="ADAL" clId="{FA828CC2-BD33-4E7F-89D7-4E0C5C1375F0}" dt="2023-06-16T15:49:18.723" v="419" actId="555"/>
          <ac:spMkLst>
            <pc:docMk/>
            <pc:sldMk cId="3220786227" sldId="704"/>
            <ac:spMk id="61" creationId="{A0EAFFD8-C588-2ADD-3446-FFCEEA4FBE74}"/>
          </ac:spMkLst>
        </pc:spChg>
        <pc:spChg chg="mod">
          <ac:chgData name="Hopcroft, Lorna" userId="67a1a19a-5520-4fba-b489-dbb2959a0dc0" providerId="ADAL" clId="{FA828CC2-BD33-4E7F-89D7-4E0C5C1375F0}" dt="2023-06-16T15:49:18.723" v="419" actId="555"/>
          <ac:spMkLst>
            <pc:docMk/>
            <pc:sldMk cId="3220786227" sldId="704"/>
            <ac:spMk id="62" creationId="{E7BB07D2-9F51-5591-C89A-701E17F3D4BB}"/>
          </ac:spMkLst>
        </pc:spChg>
        <pc:spChg chg="mod">
          <ac:chgData name="Hopcroft, Lorna" userId="67a1a19a-5520-4fba-b489-dbb2959a0dc0" providerId="ADAL" clId="{FA828CC2-BD33-4E7F-89D7-4E0C5C1375F0}" dt="2023-06-16T15:49:18.723" v="419" actId="555"/>
          <ac:spMkLst>
            <pc:docMk/>
            <pc:sldMk cId="3220786227" sldId="704"/>
            <ac:spMk id="63" creationId="{BF342161-046B-D863-36B1-3E7F273DBED8}"/>
          </ac:spMkLst>
        </pc:spChg>
        <pc:spChg chg="mod">
          <ac:chgData name="Hopcroft, Lorna" userId="67a1a19a-5520-4fba-b489-dbb2959a0dc0" providerId="ADAL" clId="{FA828CC2-BD33-4E7F-89D7-4E0C5C1375F0}" dt="2023-06-16T15:49:18.723" v="419" actId="555"/>
          <ac:spMkLst>
            <pc:docMk/>
            <pc:sldMk cId="3220786227" sldId="704"/>
            <ac:spMk id="64" creationId="{5560BF61-7709-04DB-EFE6-B2C5BB7CAC4D}"/>
          </ac:spMkLst>
        </pc:spChg>
        <pc:spChg chg="mod">
          <ac:chgData name="Hopcroft, Lorna" userId="67a1a19a-5520-4fba-b489-dbb2959a0dc0" providerId="ADAL" clId="{FA828CC2-BD33-4E7F-89D7-4E0C5C1375F0}" dt="2023-06-16T15:49:18.723" v="419" actId="555"/>
          <ac:spMkLst>
            <pc:docMk/>
            <pc:sldMk cId="3220786227" sldId="704"/>
            <ac:spMk id="65" creationId="{F1F4E139-A43D-EBB8-63C8-184AD796231A}"/>
          </ac:spMkLst>
        </pc:spChg>
        <pc:spChg chg="mod">
          <ac:chgData name="Hopcroft, Lorna" userId="67a1a19a-5520-4fba-b489-dbb2959a0dc0" providerId="ADAL" clId="{FA828CC2-BD33-4E7F-89D7-4E0C5C1375F0}" dt="2023-06-16T15:59:10.883" v="662" actId="408"/>
          <ac:spMkLst>
            <pc:docMk/>
            <pc:sldMk cId="3220786227" sldId="704"/>
            <ac:spMk id="66" creationId="{DCCB3315-2A4F-E5FF-3DDD-88729D11F16B}"/>
          </ac:spMkLst>
        </pc:spChg>
        <pc:spChg chg="mod">
          <ac:chgData name="Hopcroft, Lorna" userId="67a1a19a-5520-4fba-b489-dbb2959a0dc0" providerId="ADAL" clId="{FA828CC2-BD33-4E7F-89D7-4E0C5C1375F0}" dt="2023-06-16T15:55:44.936" v="605" actId="555"/>
          <ac:spMkLst>
            <pc:docMk/>
            <pc:sldMk cId="3220786227" sldId="704"/>
            <ac:spMk id="67" creationId="{7172F67C-E399-B320-5DAB-CED5E38E0849}"/>
          </ac:spMkLst>
        </pc:spChg>
        <pc:spChg chg="mod">
          <ac:chgData name="Hopcroft, Lorna" userId="67a1a19a-5520-4fba-b489-dbb2959a0dc0" providerId="ADAL" clId="{FA828CC2-BD33-4E7F-89D7-4E0C5C1375F0}" dt="2023-06-16T15:55:44.936" v="605" actId="555"/>
          <ac:spMkLst>
            <pc:docMk/>
            <pc:sldMk cId="3220786227" sldId="704"/>
            <ac:spMk id="68" creationId="{0461FF12-1B9A-2790-8E5F-0498FFF8D80A}"/>
          </ac:spMkLst>
        </pc:spChg>
        <pc:spChg chg="mod">
          <ac:chgData name="Hopcroft, Lorna" userId="67a1a19a-5520-4fba-b489-dbb2959a0dc0" providerId="ADAL" clId="{FA828CC2-BD33-4E7F-89D7-4E0C5C1375F0}" dt="2023-06-16T15:53:52.969" v="532" actId="1038"/>
          <ac:spMkLst>
            <pc:docMk/>
            <pc:sldMk cId="3220786227" sldId="704"/>
            <ac:spMk id="69" creationId="{F9407A1F-A5B8-514F-9924-2686B7F9B5BF}"/>
          </ac:spMkLst>
        </pc:spChg>
        <pc:spChg chg="mod">
          <ac:chgData name="Hopcroft, Lorna" userId="67a1a19a-5520-4fba-b489-dbb2959a0dc0" providerId="ADAL" clId="{FA828CC2-BD33-4E7F-89D7-4E0C5C1375F0}" dt="2023-06-16T15:53:40.423" v="520" actId="554"/>
          <ac:spMkLst>
            <pc:docMk/>
            <pc:sldMk cId="3220786227" sldId="704"/>
            <ac:spMk id="70" creationId="{0FB86B55-C36F-10F9-0E76-14FBDFC79695}"/>
          </ac:spMkLst>
        </pc:spChg>
        <pc:spChg chg="mod">
          <ac:chgData name="Hopcroft, Lorna" userId="67a1a19a-5520-4fba-b489-dbb2959a0dc0" providerId="ADAL" clId="{FA828CC2-BD33-4E7F-89D7-4E0C5C1375F0}" dt="2023-06-16T15:53:40.423" v="520" actId="554"/>
          <ac:spMkLst>
            <pc:docMk/>
            <pc:sldMk cId="3220786227" sldId="704"/>
            <ac:spMk id="71" creationId="{D31FE4FE-2B07-246A-6D61-CB94FEDC7D8D}"/>
          </ac:spMkLst>
        </pc:spChg>
        <pc:spChg chg="mod">
          <ac:chgData name="Hopcroft, Lorna" userId="67a1a19a-5520-4fba-b489-dbb2959a0dc0" providerId="ADAL" clId="{FA828CC2-BD33-4E7F-89D7-4E0C5C1375F0}" dt="2023-06-16T15:53:57.714" v="538" actId="1037"/>
          <ac:spMkLst>
            <pc:docMk/>
            <pc:sldMk cId="3220786227" sldId="704"/>
            <ac:spMk id="72" creationId="{F6F6D018-DF1F-218C-AE75-068195864F75}"/>
          </ac:spMkLst>
        </pc:spChg>
        <pc:spChg chg="mod">
          <ac:chgData name="Hopcroft, Lorna" userId="67a1a19a-5520-4fba-b489-dbb2959a0dc0" providerId="ADAL" clId="{FA828CC2-BD33-4E7F-89D7-4E0C5C1375F0}" dt="2023-06-16T15:54:01.683" v="541" actId="1037"/>
          <ac:spMkLst>
            <pc:docMk/>
            <pc:sldMk cId="3220786227" sldId="704"/>
            <ac:spMk id="73" creationId="{2E17E45C-EB2C-690C-887B-72AA7DFD9C6A}"/>
          </ac:spMkLst>
        </pc:spChg>
        <pc:spChg chg="mod">
          <ac:chgData name="Hopcroft, Lorna" userId="67a1a19a-5520-4fba-b489-dbb2959a0dc0" providerId="ADAL" clId="{FA828CC2-BD33-4E7F-89D7-4E0C5C1375F0}" dt="2023-06-16T15:53:48.063" v="530" actId="1037"/>
          <ac:spMkLst>
            <pc:docMk/>
            <pc:sldMk cId="3220786227" sldId="704"/>
            <ac:spMk id="74" creationId="{01F58F48-26F2-53AA-1B01-1A5C88B7B08B}"/>
          </ac:spMkLst>
        </pc:spChg>
        <pc:spChg chg="mod">
          <ac:chgData name="Hopcroft, Lorna" userId="67a1a19a-5520-4fba-b489-dbb2959a0dc0" providerId="ADAL" clId="{FA828CC2-BD33-4E7F-89D7-4E0C5C1375F0}" dt="2023-06-16T15:58:45.957" v="660" actId="408"/>
          <ac:spMkLst>
            <pc:docMk/>
            <pc:sldMk cId="3220786227" sldId="704"/>
            <ac:spMk id="75" creationId="{A40A7E7A-3C24-A421-ED14-7D545558C9DA}"/>
          </ac:spMkLst>
        </pc:spChg>
        <pc:spChg chg="mod">
          <ac:chgData name="Hopcroft, Lorna" userId="67a1a19a-5520-4fba-b489-dbb2959a0dc0" providerId="ADAL" clId="{FA828CC2-BD33-4E7F-89D7-4E0C5C1375F0}" dt="2023-06-16T15:58:33.897" v="659" actId="1076"/>
          <ac:spMkLst>
            <pc:docMk/>
            <pc:sldMk cId="3220786227" sldId="704"/>
            <ac:spMk id="76" creationId="{47952009-CEC1-F39D-0BA0-F9E0750F020C}"/>
          </ac:spMkLst>
        </pc:spChg>
        <pc:spChg chg="mod">
          <ac:chgData name="Hopcroft, Lorna" userId="67a1a19a-5520-4fba-b489-dbb2959a0dc0" providerId="ADAL" clId="{FA828CC2-BD33-4E7F-89D7-4E0C5C1375F0}" dt="2023-06-16T15:57:55.794" v="657" actId="1038"/>
          <ac:spMkLst>
            <pc:docMk/>
            <pc:sldMk cId="3220786227" sldId="704"/>
            <ac:spMk id="77" creationId="{6067368F-0786-5965-6A71-0AC5936536F3}"/>
          </ac:spMkLst>
        </pc:spChg>
        <pc:spChg chg="mod">
          <ac:chgData name="Hopcroft, Lorna" userId="67a1a19a-5520-4fba-b489-dbb2959a0dc0" providerId="ADAL" clId="{FA828CC2-BD33-4E7F-89D7-4E0C5C1375F0}" dt="2023-06-16T15:57:55.794" v="657" actId="1038"/>
          <ac:spMkLst>
            <pc:docMk/>
            <pc:sldMk cId="3220786227" sldId="704"/>
            <ac:spMk id="78" creationId="{D9431240-81E7-8E6E-0013-8881AAF55974}"/>
          </ac:spMkLst>
        </pc:spChg>
        <pc:spChg chg="mod">
          <ac:chgData name="Hopcroft, Lorna" userId="67a1a19a-5520-4fba-b489-dbb2959a0dc0" providerId="ADAL" clId="{FA828CC2-BD33-4E7F-89D7-4E0C5C1375F0}" dt="2023-06-16T15:57:55.794" v="657" actId="1038"/>
          <ac:spMkLst>
            <pc:docMk/>
            <pc:sldMk cId="3220786227" sldId="704"/>
            <ac:spMk id="79" creationId="{BA860EC9-211F-7556-A355-AE3C68BD8805}"/>
          </ac:spMkLst>
        </pc:spChg>
        <pc:spChg chg="mod">
          <ac:chgData name="Hopcroft, Lorna" userId="67a1a19a-5520-4fba-b489-dbb2959a0dc0" providerId="ADAL" clId="{FA828CC2-BD33-4E7F-89D7-4E0C5C1375F0}" dt="2023-06-16T15:57:55.794" v="657" actId="1038"/>
          <ac:spMkLst>
            <pc:docMk/>
            <pc:sldMk cId="3220786227" sldId="704"/>
            <ac:spMk id="80" creationId="{FEEEAF26-48A9-444E-BCEC-8982B929454A}"/>
          </ac:spMkLst>
        </pc:spChg>
        <pc:spChg chg="mod">
          <ac:chgData name="Hopcroft, Lorna" userId="67a1a19a-5520-4fba-b489-dbb2959a0dc0" providerId="ADAL" clId="{FA828CC2-BD33-4E7F-89D7-4E0C5C1375F0}" dt="2023-06-16T15:57:55.794" v="657" actId="1038"/>
          <ac:spMkLst>
            <pc:docMk/>
            <pc:sldMk cId="3220786227" sldId="704"/>
            <ac:spMk id="81" creationId="{380720B3-70C1-7EB0-68F0-BF1DD7DF704C}"/>
          </ac:spMkLst>
        </pc:spChg>
        <pc:spChg chg="mod">
          <ac:chgData name="Hopcroft, Lorna" userId="67a1a19a-5520-4fba-b489-dbb2959a0dc0" providerId="ADAL" clId="{FA828CC2-BD33-4E7F-89D7-4E0C5C1375F0}" dt="2023-06-16T15:58:33.897" v="659" actId="1076"/>
          <ac:spMkLst>
            <pc:docMk/>
            <pc:sldMk cId="3220786227" sldId="704"/>
            <ac:spMk id="82" creationId="{9047B7C2-24DF-3E98-AA5E-3E89D7294E53}"/>
          </ac:spMkLst>
        </pc:spChg>
        <pc:spChg chg="mod">
          <ac:chgData name="Hopcroft, Lorna" userId="67a1a19a-5520-4fba-b489-dbb2959a0dc0" providerId="ADAL" clId="{FA828CC2-BD33-4E7F-89D7-4E0C5C1375F0}" dt="2023-06-16T15:57:55.794" v="657" actId="1038"/>
          <ac:spMkLst>
            <pc:docMk/>
            <pc:sldMk cId="3220786227" sldId="704"/>
            <ac:spMk id="83" creationId="{FB07AD9E-6F69-A0DB-8803-71DC9D11BD8C}"/>
          </ac:spMkLst>
        </pc:spChg>
        <pc:picChg chg="del">
          <ac:chgData name="Hopcroft, Lorna" userId="67a1a19a-5520-4fba-b489-dbb2959a0dc0" providerId="ADAL" clId="{FA828CC2-BD33-4E7F-89D7-4E0C5C1375F0}" dt="2023-06-16T15:56:11.146" v="606" actId="478"/>
          <ac:picMkLst>
            <pc:docMk/>
            <pc:sldMk cId="3220786227" sldId="704"/>
            <ac:picMk id="2" creationId="{5AE1D2A7-02EB-3A12-EE74-8283E03095DF}"/>
          </ac:picMkLst>
        </pc:picChg>
        <pc:picChg chg="mod">
          <ac:chgData name="Hopcroft, Lorna" userId="67a1a19a-5520-4fba-b489-dbb2959a0dc0" providerId="ADAL" clId="{FA828CC2-BD33-4E7F-89D7-4E0C5C1375F0}" dt="2023-06-16T15:57:05.131" v="613" actId="1037"/>
          <ac:picMkLst>
            <pc:docMk/>
            <pc:sldMk cId="3220786227" sldId="704"/>
            <ac:picMk id="6" creationId="{A77ADCCE-0E6B-EACD-B527-00C5281465B5}"/>
          </ac:picMkLst>
        </pc:picChg>
        <pc:picChg chg="add mod">
          <ac:chgData name="Hopcroft, Lorna" userId="67a1a19a-5520-4fba-b489-dbb2959a0dc0" providerId="ADAL" clId="{FA828CC2-BD33-4E7F-89D7-4E0C5C1375F0}" dt="2023-06-16T15:57:22.035" v="633" actId="1037"/>
          <ac:picMkLst>
            <pc:docMk/>
            <pc:sldMk cId="3220786227" sldId="704"/>
            <ac:picMk id="10" creationId="{9A77F6DA-6E29-A54E-CF26-B84597DB730D}"/>
          </ac:picMkLst>
        </pc:picChg>
        <pc:picChg chg="mod">
          <ac:chgData name="Hopcroft, Lorna" userId="67a1a19a-5520-4fba-b489-dbb2959a0dc0" providerId="ADAL" clId="{FA828CC2-BD33-4E7F-89D7-4E0C5C1375F0}" dt="2023-06-16T15:57:55.794" v="657" actId="1038"/>
          <ac:picMkLst>
            <pc:docMk/>
            <pc:sldMk cId="3220786227" sldId="704"/>
            <ac:picMk id="19" creationId="{CA762B03-9C42-0F38-DFE1-0ED8C90E53CA}"/>
          </ac:picMkLst>
        </pc:picChg>
        <pc:picChg chg="mod">
          <ac:chgData name="Hopcroft, Lorna" userId="67a1a19a-5520-4fba-b489-dbb2959a0dc0" providerId="ADAL" clId="{FA828CC2-BD33-4E7F-89D7-4E0C5C1375F0}" dt="2023-06-16T15:57:55.794" v="657" actId="1038"/>
          <ac:picMkLst>
            <pc:docMk/>
            <pc:sldMk cId="3220786227" sldId="704"/>
            <ac:picMk id="20" creationId="{70F5E9C9-0561-A0C1-2E1C-95EACF5B4DD6}"/>
          </ac:picMkLst>
        </pc:picChg>
        <pc:picChg chg="mod">
          <ac:chgData name="Hopcroft, Lorna" userId="67a1a19a-5520-4fba-b489-dbb2959a0dc0" providerId="ADAL" clId="{FA828CC2-BD33-4E7F-89D7-4E0C5C1375F0}" dt="2023-06-16T15:57:55.794" v="657" actId="1038"/>
          <ac:picMkLst>
            <pc:docMk/>
            <pc:sldMk cId="3220786227" sldId="704"/>
            <ac:picMk id="21" creationId="{F19C678C-8134-00F7-F405-61BA1A7DD959}"/>
          </ac:picMkLst>
        </pc:picChg>
      </pc:sldChg>
      <pc:sldMasterChg chg="delSldLayout">
        <pc:chgData name="Hopcroft, Lorna" userId="67a1a19a-5520-4fba-b489-dbb2959a0dc0" providerId="ADAL" clId="{FA828CC2-BD33-4E7F-89D7-4E0C5C1375F0}" dt="2023-06-16T16:11:00.533" v="709" actId="47"/>
        <pc:sldMasterMkLst>
          <pc:docMk/>
          <pc:sldMasterMk cId="3545955105" sldId="2147483660"/>
        </pc:sldMasterMkLst>
        <pc:sldLayoutChg chg="del">
          <pc:chgData name="Hopcroft, Lorna" userId="67a1a19a-5520-4fba-b489-dbb2959a0dc0" providerId="ADAL" clId="{FA828CC2-BD33-4E7F-89D7-4E0C5C1375F0}" dt="2023-06-16T16:11:00.533" v="709" actId="47"/>
          <pc:sldLayoutMkLst>
            <pc:docMk/>
            <pc:sldMasterMk cId="3545955105" sldId="2147483660"/>
            <pc:sldLayoutMk cId="2213880155" sldId="2147483672"/>
          </pc:sldLayoutMkLst>
        </pc:sldLayoutChg>
      </pc:sldMasterChg>
    </pc:docChg>
  </pc:docChgLst>
  <pc:docChgLst>
    <pc:chgData name="Williamson, Stuart" userId="54aab27b-417e-41e8-91b7-477b07ca9cac" providerId="ADAL" clId="{BBE5AF44-67FA-4892-8C5C-BB3B868EBFDB}"/>
    <pc:docChg chg="undo custSel addSld modSld sldOrd">
      <pc:chgData name="Williamson, Stuart" userId="54aab27b-417e-41e8-91b7-477b07ca9cac" providerId="ADAL" clId="{BBE5AF44-67FA-4892-8C5C-BB3B868EBFDB}" dt="2023-06-16T14:42:13.967" v="198" actId="1076"/>
      <pc:docMkLst>
        <pc:docMk/>
      </pc:docMkLst>
      <pc:sldChg chg="delSp modSp mod ord">
        <pc:chgData name="Williamson, Stuart" userId="54aab27b-417e-41e8-91b7-477b07ca9cac" providerId="ADAL" clId="{BBE5AF44-67FA-4892-8C5C-BB3B868EBFDB}" dt="2023-06-14T10:14:31.169" v="197"/>
        <pc:sldMkLst>
          <pc:docMk/>
          <pc:sldMk cId="1992358590" sldId="280"/>
        </pc:sldMkLst>
        <pc:spChg chg="del">
          <ac:chgData name="Williamson, Stuart" userId="54aab27b-417e-41e8-91b7-477b07ca9cac" providerId="ADAL" clId="{BBE5AF44-67FA-4892-8C5C-BB3B868EBFDB}" dt="2023-06-08T11:05:57.378" v="4" actId="478"/>
          <ac:spMkLst>
            <pc:docMk/>
            <pc:sldMk cId="1992358590" sldId="280"/>
            <ac:spMk id="5" creationId="{39B8438E-CC4B-4258-A4F5-C72063E9D2D5}"/>
          </ac:spMkLst>
        </pc:spChg>
        <pc:spChg chg="mod">
          <ac:chgData name="Williamson, Stuart" userId="54aab27b-417e-41e8-91b7-477b07ca9cac" providerId="ADAL" clId="{BBE5AF44-67FA-4892-8C5C-BB3B868EBFDB}" dt="2023-06-14T10:12:57.053" v="196"/>
          <ac:spMkLst>
            <pc:docMk/>
            <pc:sldMk cId="1992358590" sldId="280"/>
            <ac:spMk id="8" creationId="{BAA779E0-A6DB-4690-9B6D-7EE4C82E7B1A}"/>
          </ac:spMkLst>
        </pc:spChg>
        <pc:grpChg chg="mod">
          <ac:chgData name="Williamson, Stuart" userId="54aab27b-417e-41e8-91b7-477b07ca9cac" providerId="ADAL" clId="{BBE5AF44-67FA-4892-8C5C-BB3B868EBFDB}" dt="2023-06-14T10:12:57.053" v="196"/>
          <ac:grpSpMkLst>
            <pc:docMk/>
            <pc:sldMk cId="1992358590" sldId="280"/>
            <ac:grpSpMk id="4" creationId="{569CAF28-BD1B-48C9-9E51-BAB32D06F495}"/>
          </ac:grpSpMkLst>
        </pc:grpChg>
        <pc:graphicFrameChg chg="mod">
          <ac:chgData name="Williamson, Stuart" userId="54aab27b-417e-41e8-91b7-477b07ca9cac" providerId="ADAL" clId="{BBE5AF44-67FA-4892-8C5C-BB3B868EBFDB}" dt="2023-06-14T10:14:31.169" v="197"/>
          <ac:graphicFrameMkLst>
            <pc:docMk/>
            <pc:sldMk cId="1992358590" sldId="280"/>
            <ac:graphicFrameMk id="2" creationId="{C5A22C0E-C103-4BC0-A70C-7F1503A8C1C5}"/>
          </ac:graphicFrameMkLst>
        </pc:graphicFrameChg>
        <pc:graphicFrameChg chg="del">
          <ac:chgData name="Williamson, Stuart" userId="54aab27b-417e-41e8-91b7-477b07ca9cac" providerId="ADAL" clId="{BBE5AF44-67FA-4892-8C5C-BB3B868EBFDB}" dt="2023-06-08T11:05:55.441" v="3" actId="478"/>
          <ac:graphicFrameMkLst>
            <pc:docMk/>
            <pc:sldMk cId="1992358590" sldId="280"/>
            <ac:graphicFrameMk id="6" creationId="{60F75933-DAD5-41D3-8508-CADED9DE2B56}"/>
          </ac:graphicFrameMkLst>
        </pc:graphicFrameChg>
      </pc:sldChg>
      <pc:sldChg chg="modSp mod">
        <pc:chgData name="Williamson, Stuart" userId="54aab27b-417e-41e8-91b7-477b07ca9cac" providerId="ADAL" clId="{BBE5AF44-67FA-4892-8C5C-BB3B868EBFDB}" dt="2023-06-16T14:42:13.967" v="198" actId="1076"/>
        <pc:sldMkLst>
          <pc:docMk/>
          <pc:sldMk cId="586963921" sldId="281"/>
        </pc:sldMkLst>
        <pc:picChg chg="mod">
          <ac:chgData name="Williamson, Stuart" userId="54aab27b-417e-41e8-91b7-477b07ca9cac" providerId="ADAL" clId="{BBE5AF44-67FA-4892-8C5C-BB3B868EBFDB}" dt="2023-06-16T14:42:13.967" v="198" actId="1076"/>
          <ac:picMkLst>
            <pc:docMk/>
            <pc:sldMk cId="586963921" sldId="281"/>
            <ac:picMk id="154" creationId="{406B7FE6-6F82-211D-72DD-CC3956DC78F5}"/>
          </ac:picMkLst>
        </pc:picChg>
      </pc:sldChg>
      <pc:sldChg chg="addSp delSp modSp add mod modNotesTx">
        <pc:chgData name="Williamson, Stuart" userId="54aab27b-417e-41e8-91b7-477b07ca9cac" providerId="ADAL" clId="{BBE5AF44-67FA-4892-8C5C-BB3B868EBFDB}" dt="2023-06-13T17:05:21.257" v="188" actId="1076"/>
        <pc:sldMkLst>
          <pc:docMk/>
          <pc:sldMk cId="3083837531" sldId="619"/>
        </pc:sldMkLst>
        <pc:spChg chg="add mod">
          <ac:chgData name="Williamson, Stuart" userId="54aab27b-417e-41e8-91b7-477b07ca9cac" providerId="ADAL" clId="{BBE5AF44-67FA-4892-8C5C-BB3B868EBFDB}" dt="2023-06-13T16:51:43.204" v="85" actId="20577"/>
          <ac:spMkLst>
            <pc:docMk/>
            <pc:sldMk cId="3083837531" sldId="619"/>
            <ac:spMk id="2" creationId="{6F449820-B207-40CE-0DBA-916866854A58}"/>
          </ac:spMkLst>
        </pc:spChg>
        <pc:spChg chg="add mod">
          <ac:chgData name="Williamson, Stuart" userId="54aab27b-417e-41e8-91b7-477b07ca9cac" providerId="ADAL" clId="{BBE5AF44-67FA-4892-8C5C-BB3B868EBFDB}" dt="2023-06-13T17:05:12.687" v="187"/>
          <ac:spMkLst>
            <pc:docMk/>
            <pc:sldMk cId="3083837531" sldId="619"/>
            <ac:spMk id="3" creationId="{009EBB83-1872-4C25-81C0-7969E073F1DD}"/>
          </ac:spMkLst>
        </pc:spChg>
        <pc:spChg chg="add mod">
          <ac:chgData name="Williamson, Stuart" userId="54aab27b-417e-41e8-91b7-477b07ca9cac" providerId="ADAL" clId="{BBE5AF44-67FA-4892-8C5C-BB3B868EBFDB}" dt="2023-06-13T17:05:21.257" v="188" actId="1076"/>
          <ac:spMkLst>
            <pc:docMk/>
            <pc:sldMk cId="3083837531" sldId="619"/>
            <ac:spMk id="4" creationId="{54957997-7E57-4403-2BFD-EA9C81F62723}"/>
          </ac:spMkLst>
        </pc:spChg>
        <pc:spChg chg="del">
          <ac:chgData name="Williamson, Stuart" userId="54aab27b-417e-41e8-91b7-477b07ca9cac" providerId="ADAL" clId="{BBE5AF44-67FA-4892-8C5C-BB3B868EBFDB}" dt="2023-06-08T16:19:16.562" v="15" actId="478"/>
          <ac:spMkLst>
            <pc:docMk/>
            <pc:sldMk cId="3083837531" sldId="619"/>
            <ac:spMk id="70" creationId="{C603C020-C345-3C6D-BB52-70D7AD65E3AB}"/>
          </ac:spMkLst>
        </pc:spChg>
      </pc:sldChg>
      <pc:sldChg chg="addSp delSp modSp add mod modNotesTx">
        <pc:chgData name="Williamson, Stuart" userId="54aab27b-417e-41e8-91b7-477b07ca9cac" providerId="ADAL" clId="{BBE5AF44-67FA-4892-8C5C-BB3B868EBFDB}" dt="2023-06-13T16:50:27.715" v="83"/>
        <pc:sldMkLst>
          <pc:docMk/>
          <pc:sldMk cId="2783461508" sldId="702"/>
        </pc:sldMkLst>
        <pc:spChg chg="add mod">
          <ac:chgData name="Williamson, Stuart" userId="54aab27b-417e-41e8-91b7-477b07ca9cac" providerId="ADAL" clId="{BBE5AF44-67FA-4892-8C5C-BB3B868EBFDB}" dt="2023-06-08T16:19:06.402" v="13" actId="20577"/>
          <ac:spMkLst>
            <pc:docMk/>
            <pc:sldMk cId="2783461508" sldId="702"/>
            <ac:spMk id="2" creationId="{BE2508A1-9A9A-E18E-A7B4-4FE48DAA8314}"/>
          </ac:spMkLst>
        </pc:spChg>
        <pc:spChg chg="del">
          <ac:chgData name="Williamson, Stuart" userId="54aab27b-417e-41e8-91b7-477b07ca9cac" providerId="ADAL" clId="{BBE5AF44-67FA-4892-8C5C-BB3B868EBFDB}" dt="2023-06-08T16:19:01.323" v="8" actId="478"/>
          <ac:spMkLst>
            <pc:docMk/>
            <pc:sldMk cId="2783461508" sldId="702"/>
            <ac:spMk id="4" creationId="{A78F6BDF-5D8D-154B-743B-466C1DD599D7}"/>
          </ac:spMkLst>
        </pc:spChg>
        <pc:spChg chg="mod">
          <ac:chgData name="Williamson, Stuart" userId="54aab27b-417e-41e8-91b7-477b07ca9cac" providerId="ADAL" clId="{BBE5AF44-67FA-4892-8C5C-BB3B868EBFDB}" dt="2023-06-08T17:29:27.687" v="30" actId="1038"/>
          <ac:spMkLst>
            <pc:docMk/>
            <pc:sldMk cId="2783461508" sldId="702"/>
            <ac:spMk id="16" creationId="{3526AB64-B27B-87D2-21E8-A0AF9FEB2CAD}"/>
          </ac:spMkLst>
        </pc:spChg>
        <pc:spChg chg="mod">
          <ac:chgData name="Williamson, Stuart" userId="54aab27b-417e-41e8-91b7-477b07ca9cac" providerId="ADAL" clId="{BBE5AF44-67FA-4892-8C5C-BB3B868EBFDB}" dt="2023-06-08T17:29:34.214" v="31" actId="1076"/>
          <ac:spMkLst>
            <pc:docMk/>
            <pc:sldMk cId="2783461508" sldId="702"/>
            <ac:spMk id="41" creationId="{2DB41E03-24E5-EEDD-7046-25B06366DAA3}"/>
          </ac:spMkLst>
        </pc:spChg>
        <pc:graphicFrameChg chg="mod">
          <ac:chgData name="Williamson, Stuart" userId="54aab27b-417e-41e8-91b7-477b07ca9cac" providerId="ADAL" clId="{BBE5AF44-67FA-4892-8C5C-BB3B868EBFDB}" dt="2023-06-13T14:47:05.486" v="59"/>
          <ac:graphicFrameMkLst>
            <pc:docMk/>
            <pc:sldMk cId="2783461508" sldId="702"/>
            <ac:graphicFrameMk id="3" creationId="{86AFC003-3E9E-C2FC-3A44-F09BCA847E37}"/>
          </ac:graphicFrameMkLst>
        </pc:graphicFrameChg>
        <pc:graphicFrameChg chg="mod">
          <ac:chgData name="Williamson, Stuart" userId="54aab27b-417e-41e8-91b7-477b07ca9cac" providerId="ADAL" clId="{BBE5AF44-67FA-4892-8C5C-BB3B868EBFDB}" dt="2023-06-13T14:47:48.855" v="78" actId="1038"/>
          <ac:graphicFrameMkLst>
            <pc:docMk/>
            <pc:sldMk cId="2783461508" sldId="702"/>
            <ac:graphicFrameMk id="45" creationId="{4A14629F-CFCD-DEC4-864C-A14EA62EC529}"/>
          </ac:graphicFrameMkLst>
        </pc:graphicFrameChg>
        <pc:picChg chg="add del mod">
          <ac:chgData name="Williamson, Stuart" userId="54aab27b-417e-41e8-91b7-477b07ca9cac" providerId="ADAL" clId="{BBE5AF44-67FA-4892-8C5C-BB3B868EBFDB}" dt="2023-06-13T15:20:27.456" v="81" actId="478"/>
          <ac:picMkLst>
            <pc:docMk/>
            <pc:sldMk cId="2783461508" sldId="702"/>
            <ac:picMk id="4" creationId="{FD74BAA1-1ACD-F85E-9972-2E41AABDA7C7}"/>
          </ac:picMkLst>
        </pc:picChg>
        <pc:picChg chg="add mod">
          <ac:chgData name="Williamson, Stuart" userId="54aab27b-417e-41e8-91b7-477b07ca9cac" providerId="ADAL" clId="{BBE5AF44-67FA-4892-8C5C-BB3B868EBFDB}" dt="2023-06-13T15:20:27.959" v="82"/>
          <ac:picMkLst>
            <pc:docMk/>
            <pc:sldMk cId="2783461508" sldId="702"/>
            <ac:picMk id="5" creationId="{648C92D0-09A2-6E96-5382-5D478C206215}"/>
          </ac:picMkLst>
        </pc:picChg>
        <pc:picChg chg="del">
          <ac:chgData name="Williamson, Stuart" userId="54aab27b-417e-41e8-91b7-477b07ca9cac" providerId="ADAL" clId="{BBE5AF44-67FA-4892-8C5C-BB3B868EBFDB}" dt="2023-06-13T14:46:02.447" v="52" actId="478"/>
          <ac:picMkLst>
            <pc:docMk/>
            <pc:sldMk cId="2783461508" sldId="702"/>
            <ac:picMk id="6" creationId="{EBBA5729-F710-28C8-C520-2F67977D0DDA}"/>
          </ac:picMkLst>
        </pc:picChg>
      </pc:sldChg>
    </pc:docChg>
  </pc:docChgLst>
  <pc:docChgLst>
    <pc:chgData name="Wigmore, Eleanor" userId="S::krrf893@astrazeneca.net::154496fa-10d7-4fd7-9fba-3614c367c37c" providerId="AD" clId="Web-{DA8353A6-EE1A-F5BA-8FA6-B699CC279389}"/>
    <pc:docChg chg="modSld">
      <pc:chgData name="Wigmore, Eleanor" userId="S::krrf893@astrazeneca.net::154496fa-10d7-4fd7-9fba-3614c367c37c" providerId="AD" clId="Web-{DA8353A6-EE1A-F5BA-8FA6-B699CC279389}" dt="2023-06-15T14:15:29.327" v="211" actId="1076"/>
      <pc:docMkLst>
        <pc:docMk/>
      </pc:docMkLst>
      <pc:sldChg chg="modSp">
        <pc:chgData name="Wigmore, Eleanor" userId="S::krrf893@astrazeneca.net::154496fa-10d7-4fd7-9fba-3614c367c37c" providerId="AD" clId="Web-{DA8353A6-EE1A-F5BA-8FA6-B699CC279389}" dt="2023-06-15T14:15:29.327" v="211" actId="1076"/>
        <pc:sldMkLst>
          <pc:docMk/>
          <pc:sldMk cId="3220786227" sldId="704"/>
        </pc:sldMkLst>
        <pc:spChg chg="mod">
          <ac:chgData name="Wigmore, Eleanor" userId="S::krrf893@astrazeneca.net::154496fa-10d7-4fd7-9fba-3614c367c37c" providerId="AD" clId="Web-{DA8353A6-EE1A-F5BA-8FA6-B699CC279389}" dt="2023-06-15T14:13:37.432" v="130" actId="20577"/>
          <ac:spMkLst>
            <pc:docMk/>
            <pc:sldMk cId="3220786227" sldId="704"/>
            <ac:spMk id="47" creationId="{6B92FF38-380F-BEBD-A501-D7C60EDC8E82}"/>
          </ac:spMkLst>
        </pc:spChg>
        <pc:spChg chg="mod">
          <ac:chgData name="Wigmore, Eleanor" userId="S::krrf893@astrazeneca.net::154496fa-10d7-4fd7-9fba-3614c367c37c" providerId="AD" clId="Web-{DA8353A6-EE1A-F5BA-8FA6-B699CC279389}" dt="2023-06-15T14:14:02.871" v="155" actId="20577"/>
          <ac:spMkLst>
            <pc:docMk/>
            <pc:sldMk cId="3220786227" sldId="704"/>
            <ac:spMk id="49" creationId="{B58D13CD-5E78-E71C-136F-F06ECA725B0D}"/>
          </ac:spMkLst>
        </pc:spChg>
        <pc:spChg chg="mod">
          <ac:chgData name="Wigmore, Eleanor" userId="S::krrf893@astrazeneca.net::154496fa-10d7-4fd7-9fba-3614c367c37c" providerId="AD" clId="Web-{DA8353A6-EE1A-F5BA-8FA6-B699CC279389}" dt="2023-06-15T14:15:29.327" v="211" actId="1076"/>
          <ac:spMkLst>
            <pc:docMk/>
            <pc:sldMk cId="3220786227" sldId="704"/>
            <ac:spMk id="57" creationId="{3FC7077D-FC72-9E36-582F-E9B5F13378A7}"/>
          </ac:spMkLst>
        </pc:spChg>
        <pc:spChg chg="mod">
          <ac:chgData name="Wigmore, Eleanor" userId="S::krrf893@astrazeneca.net::154496fa-10d7-4fd7-9fba-3614c367c37c" providerId="AD" clId="Web-{DA8353A6-EE1A-F5BA-8FA6-B699CC279389}" dt="2023-06-15T14:15:19.920" v="210" actId="1076"/>
          <ac:spMkLst>
            <pc:docMk/>
            <pc:sldMk cId="3220786227" sldId="704"/>
            <ac:spMk id="59" creationId="{286DA675-929D-E5C0-E2D1-54BC287F6809}"/>
          </ac:spMkLst>
        </pc:spChg>
        <pc:spChg chg="mod">
          <ac:chgData name="Wigmore, Eleanor" userId="S::krrf893@astrazeneca.net::154496fa-10d7-4fd7-9fba-3614c367c37c" providerId="AD" clId="Web-{DA8353A6-EE1A-F5BA-8FA6-B699CC279389}" dt="2023-06-15T14:11:18.865" v="22" actId="20577"/>
          <ac:spMkLst>
            <pc:docMk/>
            <pc:sldMk cId="3220786227" sldId="704"/>
            <ac:spMk id="66" creationId="{DCCB3315-2A4F-E5FF-3DDD-88729D11F16B}"/>
          </ac:spMkLst>
        </pc:spChg>
        <pc:spChg chg="mod">
          <ac:chgData name="Wigmore, Eleanor" userId="S::krrf893@astrazeneca.net::154496fa-10d7-4fd7-9fba-3614c367c37c" providerId="AD" clId="Web-{DA8353A6-EE1A-F5BA-8FA6-B699CC279389}" dt="2023-06-15T14:11:50.632" v="48" actId="20577"/>
          <ac:spMkLst>
            <pc:docMk/>
            <pc:sldMk cId="3220786227" sldId="704"/>
            <ac:spMk id="68" creationId="{0461FF12-1B9A-2790-8E5F-0498FFF8D80A}"/>
          </ac:spMkLst>
        </pc:spChg>
        <pc:spChg chg="mod">
          <ac:chgData name="Wigmore, Eleanor" userId="S::krrf893@astrazeneca.net::154496fa-10d7-4fd7-9fba-3614c367c37c" providerId="AD" clId="Web-{DA8353A6-EE1A-F5BA-8FA6-B699CC279389}" dt="2023-06-15T14:12:24.320" v="74" actId="20577"/>
          <ac:spMkLst>
            <pc:docMk/>
            <pc:sldMk cId="3220786227" sldId="704"/>
            <ac:spMk id="75" creationId="{A40A7E7A-3C24-A421-ED14-7D545558C9DA}"/>
          </ac:spMkLst>
        </pc:spChg>
        <pc:spChg chg="mod">
          <ac:chgData name="Wigmore, Eleanor" userId="S::krrf893@astrazeneca.net::154496fa-10d7-4fd7-9fba-3614c367c37c" providerId="AD" clId="Web-{DA8353A6-EE1A-F5BA-8FA6-B699CC279389}" dt="2023-06-15T14:12:55.259" v="100" actId="20577"/>
          <ac:spMkLst>
            <pc:docMk/>
            <pc:sldMk cId="3220786227" sldId="704"/>
            <ac:spMk id="77" creationId="{6067368F-0786-5965-6A71-0AC5936536F3}"/>
          </ac:spMkLst>
        </pc:spChg>
      </pc:sldChg>
    </pc:docChg>
  </pc:docChgLst>
  <pc:docChgLst>
    <pc:chgData name="Wigmore, Eleanor" userId="154496fa-10d7-4fd7-9fba-3614c367c37c" providerId="ADAL" clId="{992F413B-BF72-4AB6-BD27-7B771EC0A0A2}"/>
    <pc:docChg chg="custSel addSld delSld modSld">
      <pc:chgData name="Wigmore, Eleanor" userId="154496fa-10d7-4fd7-9fba-3614c367c37c" providerId="ADAL" clId="{992F413B-BF72-4AB6-BD27-7B771EC0A0A2}" dt="2023-06-12T17:01:01.611" v="17" actId="47"/>
      <pc:docMkLst>
        <pc:docMk/>
      </pc:docMkLst>
      <pc:sldChg chg="del">
        <pc:chgData name="Wigmore, Eleanor" userId="154496fa-10d7-4fd7-9fba-3614c367c37c" providerId="ADAL" clId="{992F413B-BF72-4AB6-BD27-7B771EC0A0A2}" dt="2023-06-12T17:01:01.611" v="17" actId="47"/>
        <pc:sldMkLst>
          <pc:docMk/>
          <pc:sldMk cId="2672170052" sldId="277"/>
        </pc:sldMkLst>
      </pc:sldChg>
      <pc:sldChg chg="addSp delSp modSp mod">
        <pc:chgData name="Wigmore, Eleanor" userId="154496fa-10d7-4fd7-9fba-3614c367c37c" providerId="ADAL" clId="{992F413B-BF72-4AB6-BD27-7B771EC0A0A2}" dt="2023-06-12T16:59:09.518" v="1"/>
        <pc:sldMkLst>
          <pc:docMk/>
          <pc:sldMk cId="586963921" sldId="281"/>
        </pc:sldMkLst>
        <pc:spChg chg="add mod">
          <ac:chgData name="Wigmore, Eleanor" userId="154496fa-10d7-4fd7-9fba-3614c367c37c" providerId="ADAL" clId="{992F413B-BF72-4AB6-BD27-7B771EC0A0A2}" dt="2023-06-12T16:59:09.518" v="1"/>
          <ac:spMkLst>
            <pc:docMk/>
            <pc:sldMk cId="586963921" sldId="281"/>
            <ac:spMk id="9" creationId="{297E8DD9-301D-314C-4943-A35964D1AA08}"/>
          </ac:spMkLst>
        </pc:spChg>
        <pc:spChg chg="add mod">
          <ac:chgData name="Wigmore, Eleanor" userId="154496fa-10d7-4fd7-9fba-3614c367c37c" providerId="ADAL" clId="{992F413B-BF72-4AB6-BD27-7B771EC0A0A2}" dt="2023-06-12T16:59:09.518" v="1"/>
          <ac:spMkLst>
            <pc:docMk/>
            <pc:sldMk cId="586963921" sldId="281"/>
            <ac:spMk id="12" creationId="{93FA6A69-3DE7-7127-4E79-92BD0082C292}"/>
          </ac:spMkLst>
        </pc:spChg>
        <pc:spChg chg="add mod">
          <ac:chgData name="Wigmore, Eleanor" userId="154496fa-10d7-4fd7-9fba-3614c367c37c" providerId="ADAL" clId="{992F413B-BF72-4AB6-BD27-7B771EC0A0A2}" dt="2023-06-12T16:59:09.518" v="1"/>
          <ac:spMkLst>
            <pc:docMk/>
            <pc:sldMk cId="586963921" sldId="281"/>
            <ac:spMk id="13" creationId="{909E9A58-93D6-38DF-65EC-1C1ED6F313A3}"/>
          </ac:spMkLst>
        </pc:spChg>
        <pc:spChg chg="add mod">
          <ac:chgData name="Wigmore, Eleanor" userId="154496fa-10d7-4fd7-9fba-3614c367c37c" providerId="ADAL" clId="{992F413B-BF72-4AB6-BD27-7B771EC0A0A2}" dt="2023-06-12T16:59:09.518" v="1"/>
          <ac:spMkLst>
            <pc:docMk/>
            <pc:sldMk cId="586963921" sldId="281"/>
            <ac:spMk id="14" creationId="{F30AEB6D-B2B4-86BA-1757-734CD16965DB}"/>
          </ac:spMkLst>
        </pc:spChg>
        <pc:spChg chg="add mod">
          <ac:chgData name="Wigmore, Eleanor" userId="154496fa-10d7-4fd7-9fba-3614c367c37c" providerId="ADAL" clId="{992F413B-BF72-4AB6-BD27-7B771EC0A0A2}" dt="2023-06-12T16:59:09.518" v="1"/>
          <ac:spMkLst>
            <pc:docMk/>
            <pc:sldMk cId="586963921" sldId="281"/>
            <ac:spMk id="15" creationId="{228FEBB8-0390-8D1B-723D-F09E5466C48F}"/>
          </ac:spMkLst>
        </pc:spChg>
        <pc:spChg chg="add mod">
          <ac:chgData name="Wigmore, Eleanor" userId="154496fa-10d7-4fd7-9fba-3614c367c37c" providerId="ADAL" clId="{992F413B-BF72-4AB6-BD27-7B771EC0A0A2}" dt="2023-06-12T16:59:09.518" v="1"/>
          <ac:spMkLst>
            <pc:docMk/>
            <pc:sldMk cId="586963921" sldId="281"/>
            <ac:spMk id="16" creationId="{98108D97-2E21-C00C-7C3D-B00397AFCF1E}"/>
          </ac:spMkLst>
        </pc:spChg>
        <pc:spChg chg="add mod">
          <ac:chgData name="Wigmore, Eleanor" userId="154496fa-10d7-4fd7-9fba-3614c367c37c" providerId="ADAL" clId="{992F413B-BF72-4AB6-BD27-7B771EC0A0A2}" dt="2023-06-12T16:59:09.518" v="1"/>
          <ac:spMkLst>
            <pc:docMk/>
            <pc:sldMk cId="586963921" sldId="281"/>
            <ac:spMk id="17" creationId="{F1A7AD55-6D98-2CF5-640D-A1914DE48B87}"/>
          </ac:spMkLst>
        </pc:spChg>
        <pc:spChg chg="add mod">
          <ac:chgData name="Wigmore, Eleanor" userId="154496fa-10d7-4fd7-9fba-3614c367c37c" providerId="ADAL" clId="{992F413B-BF72-4AB6-BD27-7B771EC0A0A2}" dt="2023-06-12T16:59:09.518" v="1"/>
          <ac:spMkLst>
            <pc:docMk/>
            <pc:sldMk cId="586963921" sldId="281"/>
            <ac:spMk id="19" creationId="{3B79A0DA-7376-EC19-AF14-1E514934AFE3}"/>
          </ac:spMkLst>
        </pc:spChg>
        <pc:spChg chg="add mod">
          <ac:chgData name="Wigmore, Eleanor" userId="154496fa-10d7-4fd7-9fba-3614c367c37c" providerId="ADAL" clId="{992F413B-BF72-4AB6-BD27-7B771EC0A0A2}" dt="2023-06-12T16:59:09.518" v="1"/>
          <ac:spMkLst>
            <pc:docMk/>
            <pc:sldMk cId="586963921" sldId="281"/>
            <ac:spMk id="21" creationId="{D09C4768-533A-1C94-2806-D22CC9093A3F}"/>
          </ac:spMkLst>
        </pc:spChg>
        <pc:spChg chg="add mod">
          <ac:chgData name="Wigmore, Eleanor" userId="154496fa-10d7-4fd7-9fba-3614c367c37c" providerId="ADAL" clId="{992F413B-BF72-4AB6-BD27-7B771EC0A0A2}" dt="2023-06-12T16:59:09.518" v="1"/>
          <ac:spMkLst>
            <pc:docMk/>
            <pc:sldMk cId="586963921" sldId="281"/>
            <ac:spMk id="22" creationId="{00CEC6E7-03EC-5337-C6F6-578DD1203325}"/>
          </ac:spMkLst>
        </pc:spChg>
        <pc:spChg chg="add mod">
          <ac:chgData name="Wigmore, Eleanor" userId="154496fa-10d7-4fd7-9fba-3614c367c37c" providerId="ADAL" clId="{992F413B-BF72-4AB6-BD27-7B771EC0A0A2}" dt="2023-06-12T16:59:09.518" v="1"/>
          <ac:spMkLst>
            <pc:docMk/>
            <pc:sldMk cId="586963921" sldId="281"/>
            <ac:spMk id="24" creationId="{A1C1BE1D-C09C-0FB9-94AF-C8A8E719CDD3}"/>
          </ac:spMkLst>
        </pc:spChg>
        <pc:spChg chg="add mod">
          <ac:chgData name="Wigmore, Eleanor" userId="154496fa-10d7-4fd7-9fba-3614c367c37c" providerId="ADAL" clId="{992F413B-BF72-4AB6-BD27-7B771EC0A0A2}" dt="2023-06-12T16:59:09.518" v="1"/>
          <ac:spMkLst>
            <pc:docMk/>
            <pc:sldMk cId="586963921" sldId="281"/>
            <ac:spMk id="25" creationId="{B0E6D0CD-0C30-37AA-4373-6E6247A67433}"/>
          </ac:spMkLst>
        </pc:spChg>
        <pc:spChg chg="add mod">
          <ac:chgData name="Wigmore, Eleanor" userId="154496fa-10d7-4fd7-9fba-3614c367c37c" providerId="ADAL" clId="{992F413B-BF72-4AB6-BD27-7B771EC0A0A2}" dt="2023-06-12T16:59:09.518" v="1"/>
          <ac:spMkLst>
            <pc:docMk/>
            <pc:sldMk cId="586963921" sldId="281"/>
            <ac:spMk id="26" creationId="{5C4B99EA-B8A8-CB5B-BB1B-4A666CFB5B88}"/>
          </ac:spMkLst>
        </pc:spChg>
        <pc:spChg chg="add mod">
          <ac:chgData name="Wigmore, Eleanor" userId="154496fa-10d7-4fd7-9fba-3614c367c37c" providerId="ADAL" clId="{992F413B-BF72-4AB6-BD27-7B771EC0A0A2}" dt="2023-06-12T16:59:09.518" v="1"/>
          <ac:spMkLst>
            <pc:docMk/>
            <pc:sldMk cId="586963921" sldId="281"/>
            <ac:spMk id="27" creationId="{A2ADF71B-2F7F-AE23-5D5B-D00B0CDC8942}"/>
          </ac:spMkLst>
        </pc:spChg>
        <pc:spChg chg="add mod">
          <ac:chgData name="Wigmore, Eleanor" userId="154496fa-10d7-4fd7-9fba-3614c367c37c" providerId="ADAL" clId="{992F413B-BF72-4AB6-BD27-7B771EC0A0A2}" dt="2023-06-12T16:59:09.518" v="1"/>
          <ac:spMkLst>
            <pc:docMk/>
            <pc:sldMk cId="586963921" sldId="281"/>
            <ac:spMk id="28" creationId="{B9FBF815-2EAE-8D46-EBB6-16A0C4C91550}"/>
          </ac:spMkLst>
        </pc:spChg>
        <pc:spChg chg="add mod">
          <ac:chgData name="Wigmore, Eleanor" userId="154496fa-10d7-4fd7-9fba-3614c367c37c" providerId="ADAL" clId="{992F413B-BF72-4AB6-BD27-7B771EC0A0A2}" dt="2023-06-12T16:59:09.518" v="1"/>
          <ac:spMkLst>
            <pc:docMk/>
            <pc:sldMk cId="586963921" sldId="281"/>
            <ac:spMk id="29" creationId="{9CB9E91F-5E5C-8C6A-45E2-C1AB3532E832}"/>
          </ac:spMkLst>
        </pc:spChg>
        <pc:spChg chg="add mod">
          <ac:chgData name="Wigmore, Eleanor" userId="154496fa-10d7-4fd7-9fba-3614c367c37c" providerId="ADAL" clId="{992F413B-BF72-4AB6-BD27-7B771EC0A0A2}" dt="2023-06-12T16:59:09.518" v="1"/>
          <ac:spMkLst>
            <pc:docMk/>
            <pc:sldMk cId="586963921" sldId="281"/>
            <ac:spMk id="30" creationId="{CCA5EF83-F0DF-2D02-5C3E-C0276B97F898}"/>
          </ac:spMkLst>
        </pc:spChg>
        <pc:spChg chg="add mod">
          <ac:chgData name="Wigmore, Eleanor" userId="154496fa-10d7-4fd7-9fba-3614c367c37c" providerId="ADAL" clId="{992F413B-BF72-4AB6-BD27-7B771EC0A0A2}" dt="2023-06-12T16:59:09.518" v="1"/>
          <ac:spMkLst>
            <pc:docMk/>
            <pc:sldMk cId="586963921" sldId="281"/>
            <ac:spMk id="31" creationId="{AB6790D9-6D8A-DDA6-E7B4-21B501E14008}"/>
          </ac:spMkLst>
        </pc:spChg>
        <pc:spChg chg="add mod">
          <ac:chgData name="Wigmore, Eleanor" userId="154496fa-10d7-4fd7-9fba-3614c367c37c" providerId="ADAL" clId="{992F413B-BF72-4AB6-BD27-7B771EC0A0A2}" dt="2023-06-12T16:59:09.518" v="1"/>
          <ac:spMkLst>
            <pc:docMk/>
            <pc:sldMk cId="586963921" sldId="281"/>
            <ac:spMk id="33" creationId="{F6E03C92-5999-B2B1-5CED-35A8036E2807}"/>
          </ac:spMkLst>
        </pc:spChg>
        <pc:spChg chg="del">
          <ac:chgData name="Wigmore, Eleanor" userId="154496fa-10d7-4fd7-9fba-3614c367c37c" providerId="ADAL" clId="{992F413B-BF72-4AB6-BD27-7B771EC0A0A2}" dt="2023-06-12T16:59:08.554" v="0" actId="478"/>
          <ac:spMkLst>
            <pc:docMk/>
            <pc:sldMk cId="586963921" sldId="281"/>
            <ac:spMk id="34" creationId="{17875CF9-229F-4130-AFEB-CDFD8B3CD650}"/>
          </ac:spMkLst>
        </pc:spChg>
        <pc:spChg chg="add mod">
          <ac:chgData name="Wigmore, Eleanor" userId="154496fa-10d7-4fd7-9fba-3614c367c37c" providerId="ADAL" clId="{992F413B-BF72-4AB6-BD27-7B771EC0A0A2}" dt="2023-06-12T16:59:09.518" v="1"/>
          <ac:spMkLst>
            <pc:docMk/>
            <pc:sldMk cId="586963921" sldId="281"/>
            <ac:spMk id="38" creationId="{55FB8DEA-A1C0-0D21-7E0D-5C65787422E5}"/>
          </ac:spMkLst>
        </pc:spChg>
        <pc:spChg chg="del">
          <ac:chgData name="Wigmore, Eleanor" userId="154496fa-10d7-4fd7-9fba-3614c367c37c" providerId="ADAL" clId="{992F413B-BF72-4AB6-BD27-7B771EC0A0A2}" dt="2023-06-12T16:59:08.554" v="0" actId="478"/>
          <ac:spMkLst>
            <pc:docMk/>
            <pc:sldMk cId="586963921" sldId="281"/>
            <ac:spMk id="48" creationId="{BD5A70AE-D167-4073-B87E-B94112D817E1}"/>
          </ac:spMkLst>
        </pc:spChg>
        <pc:grpChg chg="del">
          <ac:chgData name="Wigmore, Eleanor" userId="154496fa-10d7-4fd7-9fba-3614c367c37c" providerId="ADAL" clId="{992F413B-BF72-4AB6-BD27-7B771EC0A0A2}" dt="2023-06-12T16:59:08.554" v="0" actId="478"/>
          <ac:grpSpMkLst>
            <pc:docMk/>
            <pc:sldMk cId="586963921" sldId="281"/>
            <ac:grpSpMk id="4" creationId="{1548FF75-10F6-C26E-EE50-7C2CEBBB6089}"/>
          </ac:grpSpMkLst>
        </pc:grpChg>
        <pc:picChg chg="del">
          <ac:chgData name="Wigmore, Eleanor" userId="154496fa-10d7-4fd7-9fba-3614c367c37c" providerId="ADAL" clId="{992F413B-BF72-4AB6-BD27-7B771EC0A0A2}" dt="2023-06-12T16:59:08.554" v="0" actId="478"/>
          <ac:picMkLst>
            <pc:docMk/>
            <pc:sldMk cId="586963921" sldId="281"/>
            <ac:picMk id="3" creationId="{721CEB35-2DFB-1BE1-41EF-CC318D043FC2}"/>
          </ac:picMkLst>
        </pc:picChg>
        <pc:picChg chg="add mod">
          <ac:chgData name="Wigmore, Eleanor" userId="154496fa-10d7-4fd7-9fba-3614c367c37c" providerId="ADAL" clId="{992F413B-BF72-4AB6-BD27-7B771EC0A0A2}" dt="2023-06-12T16:59:09.518" v="1"/>
          <ac:picMkLst>
            <pc:docMk/>
            <pc:sldMk cId="586963921" sldId="281"/>
            <ac:picMk id="10" creationId="{27224344-FABC-938E-A1FF-0F04C2E18FAF}"/>
          </ac:picMkLst>
        </pc:picChg>
        <pc:picChg chg="add mod">
          <ac:chgData name="Wigmore, Eleanor" userId="154496fa-10d7-4fd7-9fba-3614c367c37c" providerId="ADAL" clId="{992F413B-BF72-4AB6-BD27-7B771EC0A0A2}" dt="2023-06-12T16:59:09.518" v="1"/>
          <ac:picMkLst>
            <pc:docMk/>
            <pc:sldMk cId="586963921" sldId="281"/>
            <ac:picMk id="11" creationId="{7DBD2678-06EB-7FA3-8D3E-4C0CA8B8B47F}"/>
          </ac:picMkLst>
        </pc:picChg>
        <pc:picChg chg="add mod">
          <ac:chgData name="Wigmore, Eleanor" userId="154496fa-10d7-4fd7-9fba-3614c367c37c" providerId="ADAL" clId="{992F413B-BF72-4AB6-BD27-7B771EC0A0A2}" dt="2023-06-12T16:59:09.518" v="1"/>
          <ac:picMkLst>
            <pc:docMk/>
            <pc:sldMk cId="586963921" sldId="281"/>
            <ac:picMk id="18" creationId="{67D9274D-1DC1-5584-EF52-AA0C376954F7}"/>
          </ac:picMkLst>
        </pc:picChg>
        <pc:picChg chg="add mod">
          <ac:chgData name="Wigmore, Eleanor" userId="154496fa-10d7-4fd7-9fba-3614c367c37c" providerId="ADAL" clId="{992F413B-BF72-4AB6-BD27-7B771EC0A0A2}" dt="2023-06-12T16:59:09.518" v="1"/>
          <ac:picMkLst>
            <pc:docMk/>
            <pc:sldMk cId="586963921" sldId="281"/>
            <ac:picMk id="20" creationId="{F4D43267-01F6-7473-4522-3FE968D7CDDA}"/>
          </ac:picMkLst>
        </pc:picChg>
        <pc:picChg chg="add mod">
          <ac:chgData name="Wigmore, Eleanor" userId="154496fa-10d7-4fd7-9fba-3614c367c37c" providerId="ADAL" clId="{992F413B-BF72-4AB6-BD27-7B771EC0A0A2}" dt="2023-06-12T16:59:09.518" v="1"/>
          <ac:picMkLst>
            <pc:docMk/>
            <pc:sldMk cId="586963921" sldId="281"/>
            <ac:picMk id="23" creationId="{A29C8993-DA54-D240-3F35-A59C42CDD73A}"/>
          </ac:picMkLst>
        </pc:picChg>
        <pc:picChg chg="add mod">
          <ac:chgData name="Wigmore, Eleanor" userId="154496fa-10d7-4fd7-9fba-3614c367c37c" providerId="ADAL" clId="{992F413B-BF72-4AB6-BD27-7B771EC0A0A2}" dt="2023-06-12T16:59:09.518" v="1"/>
          <ac:picMkLst>
            <pc:docMk/>
            <pc:sldMk cId="586963921" sldId="281"/>
            <ac:picMk id="32" creationId="{CB6DF7A1-F087-0F21-C0E8-A41A5A1DCA92}"/>
          </ac:picMkLst>
        </pc:picChg>
        <pc:picChg chg="add mod">
          <ac:chgData name="Wigmore, Eleanor" userId="154496fa-10d7-4fd7-9fba-3614c367c37c" providerId="ADAL" clId="{992F413B-BF72-4AB6-BD27-7B771EC0A0A2}" dt="2023-06-12T16:59:09.518" v="1"/>
          <ac:picMkLst>
            <pc:docMk/>
            <pc:sldMk cId="586963921" sldId="281"/>
            <ac:picMk id="36" creationId="{7312AE34-883E-5A1B-C8EA-2E1A778CF595}"/>
          </ac:picMkLst>
        </pc:picChg>
        <pc:picChg chg="add mod">
          <ac:chgData name="Wigmore, Eleanor" userId="154496fa-10d7-4fd7-9fba-3614c367c37c" providerId="ADAL" clId="{992F413B-BF72-4AB6-BD27-7B771EC0A0A2}" dt="2023-06-12T16:59:09.518" v="1"/>
          <ac:picMkLst>
            <pc:docMk/>
            <pc:sldMk cId="586963921" sldId="281"/>
            <ac:picMk id="37" creationId="{79AA0C18-B2C1-9167-66B4-E4D13917BBC9}"/>
          </ac:picMkLst>
        </pc:picChg>
      </pc:sldChg>
      <pc:sldChg chg="del">
        <pc:chgData name="Wigmore, Eleanor" userId="154496fa-10d7-4fd7-9fba-3614c367c37c" providerId="ADAL" clId="{992F413B-BF72-4AB6-BD27-7B771EC0A0A2}" dt="2023-06-12T17:00:16.633" v="5" actId="47"/>
        <pc:sldMkLst>
          <pc:docMk/>
          <pc:sldMk cId="1575602334" sldId="285"/>
        </pc:sldMkLst>
      </pc:sldChg>
      <pc:sldChg chg="modSp add mod">
        <pc:chgData name="Wigmore, Eleanor" userId="154496fa-10d7-4fd7-9fba-3614c367c37c" providerId="ADAL" clId="{992F413B-BF72-4AB6-BD27-7B771EC0A0A2}" dt="2023-06-12T17:00:23.220" v="13" actId="1036"/>
        <pc:sldMkLst>
          <pc:docMk/>
          <pc:sldMk cId="1783606474" sldId="703"/>
        </pc:sldMkLst>
        <pc:spChg chg="mod">
          <ac:chgData name="Wigmore, Eleanor" userId="154496fa-10d7-4fd7-9fba-3614c367c37c" providerId="ADAL" clId="{992F413B-BF72-4AB6-BD27-7B771EC0A0A2}" dt="2023-06-12T16:59:45.629" v="4" actId="20577"/>
          <ac:spMkLst>
            <pc:docMk/>
            <pc:sldMk cId="1783606474" sldId="703"/>
            <ac:spMk id="2" creationId="{87CEF116-AFC8-44FA-B66B-71B5263D6FFB}"/>
          </ac:spMkLst>
        </pc:spChg>
        <pc:picChg chg="mod">
          <ac:chgData name="Wigmore, Eleanor" userId="154496fa-10d7-4fd7-9fba-3614c367c37c" providerId="ADAL" clId="{992F413B-BF72-4AB6-BD27-7B771EC0A0A2}" dt="2023-06-12T17:00:23.220" v="13" actId="1036"/>
          <ac:picMkLst>
            <pc:docMk/>
            <pc:sldMk cId="1783606474" sldId="703"/>
            <ac:picMk id="10" creationId="{43BF7F59-18D2-0A93-5304-67A39CBD234C}"/>
          </ac:picMkLst>
        </pc:picChg>
      </pc:sldChg>
      <pc:sldChg chg="modSp add mod">
        <pc:chgData name="Wigmore, Eleanor" userId="154496fa-10d7-4fd7-9fba-3614c367c37c" providerId="ADAL" clId="{992F413B-BF72-4AB6-BD27-7B771EC0A0A2}" dt="2023-06-12T17:00:44.792" v="16" actId="20577"/>
        <pc:sldMkLst>
          <pc:docMk/>
          <pc:sldMk cId="3220786227" sldId="704"/>
        </pc:sldMkLst>
        <pc:spChg chg="mod">
          <ac:chgData name="Wigmore, Eleanor" userId="154496fa-10d7-4fd7-9fba-3614c367c37c" providerId="ADAL" clId="{992F413B-BF72-4AB6-BD27-7B771EC0A0A2}" dt="2023-06-12T17:00:44.792" v="16" actId="20577"/>
          <ac:spMkLst>
            <pc:docMk/>
            <pc:sldMk cId="3220786227" sldId="704"/>
            <ac:spMk id="11" creationId="{A07066BB-B788-47E5-AD9E-431C88455864}"/>
          </ac:spMkLst>
        </pc:spChg>
      </pc:sldChg>
    </pc:docChg>
  </pc:docChgLst>
  <pc:docChgLst>
    <pc:chgData name="Hopcroft, Lorna" userId="S::kgsk887@astrazeneca.net::67a1a19a-5520-4fba-b489-dbb2959a0dc0" providerId="AD" clId="Web-{C518C38D-657A-C5A0-E93C-E0A1B8F59FD5}"/>
    <pc:docChg chg="modSld">
      <pc:chgData name="Hopcroft, Lorna" userId="S::kgsk887@astrazeneca.net::67a1a19a-5520-4fba-b489-dbb2959a0dc0" providerId="AD" clId="Web-{C518C38D-657A-C5A0-E93C-E0A1B8F59FD5}" dt="2023-06-12T14:52:41.073" v="18" actId="20577"/>
      <pc:docMkLst>
        <pc:docMk/>
      </pc:docMkLst>
      <pc:sldChg chg="addSp delSp modSp">
        <pc:chgData name="Hopcroft, Lorna" userId="S::kgsk887@astrazeneca.net::67a1a19a-5520-4fba-b489-dbb2959a0dc0" providerId="AD" clId="Web-{C518C38D-657A-C5A0-E93C-E0A1B8F59FD5}" dt="2023-06-12T14:52:41.073" v="18" actId="20577"/>
        <pc:sldMkLst>
          <pc:docMk/>
          <pc:sldMk cId="586963921" sldId="281"/>
        </pc:sldMkLst>
        <pc:spChg chg="add mod">
          <ac:chgData name="Hopcroft, Lorna" userId="S::kgsk887@astrazeneca.net::67a1a19a-5520-4fba-b489-dbb2959a0dc0" providerId="AD" clId="Web-{C518C38D-657A-C5A0-E93C-E0A1B8F59FD5}" dt="2023-06-12T14:51:59.601" v="12" actId="20577"/>
          <ac:spMkLst>
            <pc:docMk/>
            <pc:sldMk cId="586963921" sldId="281"/>
            <ac:spMk id="8" creationId="{DD5EF8AF-295B-81F5-BF24-27CC755B2B5A}"/>
          </ac:spMkLst>
        </pc:spChg>
        <pc:spChg chg="mod">
          <ac:chgData name="Hopcroft, Lorna" userId="S::kgsk887@astrazeneca.net::67a1a19a-5520-4fba-b489-dbb2959a0dc0" providerId="AD" clId="Web-{C518C38D-657A-C5A0-E93C-E0A1B8F59FD5}" dt="2023-06-12T14:52:12.852" v="14" actId="20577"/>
          <ac:spMkLst>
            <pc:docMk/>
            <pc:sldMk cId="586963921" sldId="281"/>
            <ac:spMk id="34" creationId="{17875CF9-229F-4130-AFEB-CDFD8B3CD650}"/>
          </ac:spMkLst>
        </pc:spChg>
        <pc:spChg chg="mod">
          <ac:chgData name="Hopcroft, Lorna" userId="S::kgsk887@astrazeneca.net::67a1a19a-5520-4fba-b489-dbb2959a0dc0" providerId="AD" clId="Web-{C518C38D-657A-C5A0-E93C-E0A1B8F59FD5}" dt="2023-06-12T14:52:41.073" v="18" actId="20577"/>
          <ac:spMkLst>
            <pc:docMk/>
            <pc:sldMk cId="586963921" sldId="281"/>
            <ac:spMk id="48" creationId="{BD5A70AE-D167-4073-B87E-B94112D817E1}"/>
          </ac:spMkLst>
        </pc:spChg>
        <pc:picChg chg="add mod">
          <ac:chgData name="Hopcroft, Lorna" userId="S::kgsk887@astrazeneca.net::67a1a19a-5520-4fba-b489-dbb2959a0dc0" providerId="AD" clId="Web-{C518C38D-657A-C5A0-E93C-E0A1B8F59FD5}" dt="2023-06-12T14:05:52.252" v="5" actId="1076"/>
          <ac:picMkLst>
            <pc:docMk/>
            <pc:sldMk cId="586963921" sldId="281"/>
            <ac:picMk id="2" creationId="{42015B23-9CD2-B311-1C04-F3D0C8BDAD41}"/>
          </ac:picMkLst>
        </pc:picChg>
        <pc:picChg chg="add del mod">
          <ac:chgData name="Hopcroft, Lorna" userId="S::kgsk887@astrazeneca.net::67a1a19a-5520-4fba-b489-dbb2959a0dc0" providerId="AD" clId="Web-{C518C38D-657A-C5A0-E93C-E0A1B8F59FD5}" dt="2023-06-12T14:06:05.566" v="7"/>
          <ac:picMkLst>
            <pc:docMk/>
            <pc:sldMk cId="586963921" sldId="281"/>
            <ac:picMk id="8" creationId="{5D8AB5E3-78CD-6FF2-D91E-CC8336576247}"/>
          </ac:picMkLst>
        </pc:picChg>
      </pc:sldChg>
    </pc:docChg>
  </pc:docChgLst>
  <pc:docChgLst>
    <pc:chgData name="Wigmore, Eleanor" userId="S::krrf893@astrazeneca.net::154496fa-10d7-4fd7-9fba-3614c367c37c" providerId="AD" clId="Web-{F611EE3C-1B80-FE3A-0E82-2005A5DB6450}"/>
    <pc:docChg chg="modSld">
      <pc:chgData name="Wigmore, Eleanor" userId="S::krrf893@astrazeneca.net::154496fa-10d7-4fd7-9fba-3614c367c37c" providerId="AD" clId="Web-{F611EE3C-1B80-FE3A-0E82-2005A5DB6450}" dt="2023-06-15T15:16:25.545" v="2" actId="20577"/>
      <pc:docMkLst>
        <pc:docMk/>
      </pc:docMkLst>
      <pc:sldChg chg="modSp">
        <pc:chgData name="Wigmore, Eleanor" userId="S::krrf893@astrazeneca.net::154496fa-10d7-4fd7-9fba-3614c367c37c" providerId="AD" clId="Web-{F611EE3C-1B80-FE3A-0E82-2005A5DB6450}" dt="2023-06-15T15:16:25.545" v="2" actId="20577"/>
        <pc:sldMkLst>
          <pc:docMk/>
          <pc:sldMk cId="3220786227" sldId="704"/>
        </pc:sldMkLst>
        <pc:spChg chg="mod">
          <ac:chgData name="Wigmore, Eleanor" userId="S::krrf893@astrazeneca.net::154496fa-10d7-4fd7-9fba-3614c367c37c" providerId="AD" clId="Web-{F611EE3C-1B80-FE3A-0E82-2005A5DB6450}" dt="2023-06-15T15:16:25.545" v="2" actId="20577"/>
          <ac:spMkLst>
            <pc:docMk/>
            <pc:sldMk cId="3220786227" sldId="704"/>
            <ac:spMk id="66" creationId="{DCCB3315-2A4F-E5FF-3DDD-88729D11F16B}"/>
          </ac:spMkLst>
        </pc:spChg>
      </pc:sldChg>
    </pc:docChg>
  </pc:docChgLst>
  <pc:docChgLst>
    <pc:chgData name="Wigmore, Eleanor" userId="S::krrf893@astrazeneca.net::154496fa-10d7-4fd7-9fba-3614c367c37c" providerId="AD" clId="Web-{4EA6E3EE-AC0F-985F-B704-88FFD20FFF77}"/>
    <pc:docChg chg="addSld delSld modSld">
      <pc:chgData name="Wigmore, Eleanor" userId="S::krrf893@astrazeneca.net::154496fa-10d7-4fd7-9fba-3614c367c37c" providerId="AD" clId="Web-{4EA6E3EE-AC0F-985F-B704-88FFD20FFF77}" dt="2023-06-07T12:19:55.825" v="26" actId="14100"/>
      <pc:docMkLst>
        <pc:docMk/>
      </pc:docMkLst>
      <pc:sldChg chg="addSp delSp modSp">
        <pc:chgData name="Wigmore, Eleanor" userId="S::krrf893@astrazeneca.net::154496fa-10d7-4fd7-9fba-3614c367c37c" providerId="AD" clId="Web-{4EA6E3EE-AC0F-985F-B704-88FFD20FFF77}" dt="2023-06-07T12:19:35.465" v="22" actId="1076"/>
        <pc:sldMkLst>
          <pc:docMk/>
          <pc:sldMk cId="4136609356" sldId="284"/>
        </pc:sldMkLst>
        <pc:picChg chg="add del mod">
          <ac:chgData name="Wigmore, Eleanor" userId="S::krrf893@astrazeneca.net::154496fa-10d7-4fd7-9fba-3614c367c37c" providerId="AD" clId="Web-{4EA6E3EE-AC0F-985F-B704-88FFD20FFF77}" dt="2023-06-07T12:18:03.166" v="6"/>
          <ac:picMkLst>
            <pc:docMk/>
            <pc:sldMk cId="4136609356" sldId="284"/>
            <ac:picMk id="8" creationId="{1187507C-9C16-631D-BC1F-3A0E9F84108B}"/>
          </ac:picMkLst>
        </pc:picChg>
        <pc:picChg chg="del">
          <ac:chgData name="Wigmore, Eleanor" userId="S::krrf893@astrazeneca.net::154496fa-10d7-4fd7-9fba-3614c367c37c" providerId="AD" clId="Web-{4EA6E3EE-AC0F-985F-B704-88FFD20FFF77}" dt="2023-06-07T12:17:33.931" v="2"/>
          <ac:picMkLst>
            <pc:docMk/>
            <pc:sldMk cId="4136609356" sldId="284"/>
            <ac:picMk id="10" creationId="{26908ECA-BD74-B6E7-4586-887776B2AD85}"/>
          </ac:picMkLst>
        </pc:picChg>
        <pc:picChg chg="add del mod">
          <ac:chgData name="Wigmore, Eleanor" userId="S::krrf893@astrazeneca.net::154496fa-10d7-4fd7-9fba-3614c367c37c" providerId="AD" clId="Web-{4EA6E3EE-AC0F-985F-B704-88FFD20FFF77}" dt="2023-06-07T12:18:54.995" v="13"/>
          <ac:picMkLst>
            <pc:docMk/>
            <pc:sldMk cId="4136609356" sldId="284"/>
            <ac:picMk id="12" creationId="{10F44D75-0315-5D7C-3E6A-C201DD065D69}"/>
          </ac:picMkLst>
        </pc:picChg>
        <pc:picChg chg="add mod">
          <ac:chgData name="Wigmore, Eleanor" userId="S::krrf893@astrazeneca.net::154496fa-10d7-4fd7-9fba-3614c367c37c" providerId="AD" clId="Web-{4EA6E3EE-AC0F-985F-B704-88FFD20FFF77}" dt="2023-06-07T12:19:35.465" v="22" actId="1076"/>
          <ac:picMkLst>
            <pc:docMk/>
            <pc:sldMk cId="4136609356" sldId="284"/>
            <ac:picMk id="15" creationId="{F88DB939-9BC3-22F2-7CC2-594235E45D0D}"/>
          </ac:picMkLst>
        </pc:picChg>
      </pc:sldChg>
      <pc:sldChg chg="addSp delSp modSp">
        <pc:chgData name="Wigmore, Eleanor" userId="S::krrf893@astrazeneca.net::154496fa-10d7-4fd7-9fba-3614c367c37c" providerId="AD" clId="Web-{4EA6E3EE-AC0F-985F-B704-88FFD20FFF77}" dt="2023-06-07T12:19:55.825" v="26" actId="14100"/>
        <pc:sldMkLst>
          <pc:docMk/>
          <pc:sldMk cId="1575602334" sldId="285"/>
        </pc:sldMkLst>
        <pc:picChg chg="add mod">
          <ac:chgData name="Wigmore, Eleanor" userId="S::krrf893@astrazeneca.net::154496fa-10d7-4fd7-9fba-3614c367c37c" providerId="AD" clId="Web-{4EA6E3EE-AC0F-985F-B704-88FFD20FFF77}" dt="2023-06-07T12:19:55.825" v="26" actId="14100"/>
          <ac:picMkLst>
            <pc:docMk/>
            <pc:sldMk cId="1575602334" sldId="285"/>
            <ac:picMk id="3" creationId="{794A1904-13D3-D03F-2F0E-7D41B5EEB3DC}"/>
          </ac:picMkLst>
        </pc:picChg>
        <pc:picChg chg="del">
          <ac:chgData name="Wigmore, Eleanor" userId="S::krrf893@astrazeneca.net::154496fa-10d7-4fd7-9fba-3614c367c37c" providerId="AD" clId="Web-{4EA6E3EE-AC0F-985F-B704-88FFD20FFF77}" dt="2023-06-07T12:19:49.388" v="23"/>
          <ac:picMkLst>
            <pc:docMk/>
            <pc:sldMk cId="1575602334" sldId="285"/>
            <ac:picMk id="4" creationId="{15253FFC-665B-51BF-6CEC-0542E3D37A65}"/>
          </ac:picMkLst>
        </pc:picChg>
      </pc:sldChg>
      <pc:sldChg chg="add del replId">
        <pc:chgData name="Wigmore, Eleanor" userId="S::krrf893@astrazeneca.net::154496fa-10d7-4fd7-9fba-3614c367c37c" providerId="AD" clId="Web-{4EA6E3EE-AC0F-985F-B704-88FFD20FFF77}" dt="2023-06-07T12:19:08.402" v="15"/>
        <pc:sldMkLst>
          <pc:docMk/>
          <pc:sldMk cId="1432859529" sldId="286"/>
        </pc:sldMkLst>
      </pc:sldChg>
    </pc:docChg>
  </pc:docChgLst>
  <pc:docChgLst>
    <pc:chgData name="Wigmore, Eleanor" userId="154496fa-10d7-4fd7-9fba-3614c367c37c" providerId="ADAL" clId="{AA3EDCC2-F595-42A0-8358-45CA77012066}"/>
    <pc:docChg chg="undo redo custSel addSld modSld sldOrd">
      <pc:chgData name="Wigmore, Eleanor" userId="154496fa-10d7-4fd7-9fba-3614c367c37c" providerId="ADAL" clId="{AA3EDCC2-F595-42A0-8358-45CA77012066}" dt="2023-05-25T12:01:05.972" v="5975" actId="1037"/>
      <pc:docMkLst>
        <pc:docMk/>
      </pc:docMkLst>
      <pc:sldChg chg="addSp delSp modSp mod ord">
        <pc:chgData name="Wigmore, Eleanor" userId="154496fa-10d7-4fd7-9fba-3614c367c37c" providerId="ADAL" clId="{AA3EDCC2-F595-42A0-8358-45CA77012066}" dt="2023-05-22T15:13:50.506" v="2303" actId="1037"/>
        <pc:sldMkLst>
          <pc:docMk/>
          <pc:sldMk cId="2672170052" sldId="277"/>
        </pc:sldMkLst>
        <pc:spChg chg="del">
          <ac:chgData name="Wigmore, Eleanor" userId="154496fa-10d7-4fd7-9fba-3614c367c37c" providerId="ADAL" clId="{AA3EDCC2-F595-42A0-8358-45CA77012066}" dt="2023-05-11T14:26:11.595" v="525" actId="478"/>
          <ac:spMkLst>
            <pc:docMk/>
            <pc:sldMk cId="2672170052" sldId="277"/>
            <ac:spMk id="2" creationId="{EECB60DD-4F33-4C2A-89D0-C8A804E8A851}"/>
          </ac:spMkLst>
        </pc:spChg>
        <pc:spChg chg="del mod">
          <ac:chgData name="Wigmore, Eleanor" userId="154496fa-10d7-4fd7-9fba-3614c367c37c" providerId="ADAL" clId="{AA3EDCC2-F595-42A0-8358-45CA77012066}" dt="2023-05-19T14:52:27.605" v="1381" actId="478"/>
          <ac:spMkLst>
            <pc:docMk/>
            <pc:sldMk cId="2672170052" sldId="277"/>
            <ac:spMk id="5" creationId="{762D62AF-5AC1-48BC-8FF5-1715BE0279B7}"/>
          </ac:spMkLst>
        </pc:spChg>
        <pc:spChg chg="add mod">
          <ac:chgData name="Wigmore, Eleanor" userId="154496fa-10d7-4fd7-9fba-3614c367c37c" providerId="ADAL" clId="{AA3EDCC2-F595-42A0-8358-45CA77012066}" dt="2023-05-22T13:56:52.227" v="1680" actId="1038"/>
          <ac:spMkLst>
            <pc:docMk/>
            <pc:sldMk cId="2672170052" sldId="277"/>
            <ac:spMk id="7" creationId="{DA10C712-1CC6-1220-C9B7-E6A3DBBC7B16}"/>
          </ac:spMkLst>
        </pc:spChg>
        <pc:spChg chg="add mod">
          <ac:chgData name="Wigmore, Eleanor" userId="154496fa-10d7-4fd7-9fba-3614c367c37c" providerId="ADAL" clId="{AA3EDCC2-F595-42A0-8358-45CA77012066}" dt="2023-05-22T15:11:56.114" v="2168" actId="113"/>
          <ac:spMkLst>
            <pc:docMk/>
            <pc:sldMk cId="2672170052" sldId="277"/>
            <ac:spMk id="8" creationId="{A898017B-4EA9-917C-71B6-63BB6E99402E}"/>
          </ac:spMkLst>
        </pc:spChg>
        <pc:spChg chg="add mod">
          <ac:chgData name="Wigmore, Eleanor" userId="154496fa-10d7-4fd7-9fba-3614c367c37c" providerId="ADAL" clId="{AA3EDCC2-F595-42A0-8358-45CA77012066}" dt="2023-05-22T15:11:52.777" v="2167" actId="113"/>
          <ac:spMkLst>
            <pc:docMk/>
            <pc:sldMk cId="2672170052" sldId="277"/>
            <ac:spMk id="9" creationId="{514B49CF-16CB-E2B0-F1A1-B713D7F08EC2}"/>
          </ac:spMkLst>
        </pc:spChg>
        <pc:spChg chg="add mod">
          <ac:chgData name="Wigmore, Eleanor" userId="154496fa-10d7-4fd7-9fba-3614c367c37c" providerId="ADAL" clId="{AA3EDCC2-F595-42A0-8358-45CA77012066}" dt="2023-05-19T14:52:46.060" v="1393" actId="20577"/>
          <ac:spMkLst>
            <pc:docMk/>
            <pc:sldMk cId="2672170052" sldId="277"/>
            <ac:spMk id="10" creationId="{395F69C6-0048-793E-5497-DF3926CEB1B0}"/>
          </ac:spMkLst>
        </pc:spChg>
        <pc:spChg chg="mod">
          <ac:chgData name="Wigmore, Eleanor" userId="154496fa-10d7-4fd7-9fba-3614c367c37c" providerId="ADAL" clId="{AA3EDCC2-F595-42A0-8358-45CA77012066}" dt="2023-05-19T14:52:35.239" v="1383" actId="20577"/>
          <ac:spMkLst>
            <pc:docMk/>
            <pc:sldMk cId="2672170052" sldId="277"/>
            <ac:spMk id="11" creationId="{A07066BB-B788-47E5-AD9E-431C88455864}"/>
          </ac:spMkLst>
        </pc:spChg>
        <pc:spChg chg="add mod">
          <ac:chgData name="Wigmore, Eleanor" userId="154496fa-10d7-4fd7-9fba-3614c367c37c" providerId="ADAL" clId="{AA3EDCC2-F595-42A0-8358-45CA77012066}" dt="2023-05-19T14:52:41.504" v="1388" actId="20577"/>
          <ac:spMkLst>
            <pc:docMk/>
            <pc:sldMk cId="2672170052" sldId="277"/>
            <ac:spMk id="12" creationId="{E8220497-09B8-9B26-DC34-833532E73601}"/>
          </ac:spMkLst>
        </pc:spChg>
        <pc:spChg chg="add mod">
          <ac:chgData name="Wigmore, Eleanor" userId="154496fa-10d7-4fd7-9fba-3614c367c37c" providerId="ADAL" clId="{AA3EDCC2-F595-42A0-8358-45CA77012066}" dt="2023-05-19T14:52:31.336" v="1382" actId="1076"/>
          <ac:spMkLst>
            <pc:docMk/>
            <pc:sldMk cId="2672170052" sldId="277"/>
            <ac:spMk id="13" creationId="{A252DAE2-ED94-B91A-0FA2-BA1842318B3D}"/>
          </ac:spMkLst>
        </pc:spChg>
        <pc:spChg chg="add mod">
          <ac:chgData name="Wigmore, Eleanor" userId="154496fa-10d7-4fd7-9fba-3614c367c37c" providerId="ADAL" clId="{AA3EDCC2-F595-42A0-8358-45CA77012066}" dt="2023-05-22T14:54:55.477" v="1748" actId="6549"/>
          <ac:spMkLst>
            <pc:docMk/>
            <pc:sldMk cId="2672170052" sldId="277"/>
            <ac:spMk id="14" creationId="{3FBF8DFD-4646-B736-BF8B-CCD208758FAE}"/>
          </ac:spMkLst>
        </pc:spChg>
        <pc:spChg chg="add mod">
          <ac:chgData name="Wigmore, Eleanor" userId="154496fa-10d7-4fd7-9fba-3614c367c37c" providerId="ADAL" clId="{AA3EDCC2-F595-42A0-8358-45CA77012066}" dt="2023-05-22T15:11:58.553" v="2169" actId="113"/>
          <ac:spMkLst>
            <pc:docMk/>
            <pc:sldMk cId="2672170052" sldId="277"/>
            <ac:spMk id="15" creationId="{F8562B7B-CECD-420F-1A53-D33D77D107B6}"/>
          </ac:spMkLst>
        </pc:spChg>
        <pc:spChg chg="add mod">
          <ac:chgData name="Wigmore, Eleanor" userId="154496fa-10d7-4fd7-9fba-3614c367c37c" providerId="ADAL" clId="{AA3EDCC2-F595-42A0-8358-45CA77012066}" dt="2023-05-19T14:52:31.336" v="1382" actId="1076"/>
          <ac:spMkLst>
            <pc:docMk/>
            <pc:sldMk cId="2672170052" sldId="277"/>
            <ac:spMk id="16" creationId="{CF4461EA-2797-9607-A690-7837C644B454}"/>
          </ac:spMkLst>
        </pc:spChg>
        <pc:spChg chg="add mod">
          <ac:chgData name="Wigmore, Eleanor" userId="154496fa-10d7-4fd7-9fba-3614c367c37c" providerId="ADAL" clId="{AA3EDCC2-F595-42A0-8358-45CA77012066}" dt="2023-05-19T14:52:31.336" v="1382" actId="1076"/>
          <ac:spMkLst>
            <pc:docMk/>
            <pc:sldMk cId="2672170052" sldId="277"/>
            <ac:spMk id="17" creationId="{DAD5CD2D-FB34-76C2-AFC2-E7C4776AD1C3}"/>
          </ac:spMkLst>
        </pc:spChg>
        <pc:spChg chg="del">
          <ac:chgData name="Wigmore, Eleanor" userId="154496fa-10d7-4fd7-9fba-3614c367c37c" providerId="ADAL" clId="{AA3EDCC2-F595-42A0-8358-45CA77012066}" dt="2023-05-11T14:26:11.595" v="525" actId="478"/>
          <ac:spMkLst>
            <pc:docMk/>
            <pc:sldMk cId="2672170052" sldId="277"/>
            <ac:spMk id="18" creationId="{3F07F6CE-F9E8-4BD7-8F22-4067B05F2081}"/>
          </ac:spMkLst>
        </pc:spChg>
        <pc:spChg chg="add mod">
          <ac:chgData name="Wigmore, Eleanor" userId="154496fa-10d7-4fd7-9fba-3614c367c37c" providerId="ADAL" clId="{AA3EDCC2-F595-42A0-8358-45CA77012066}" dt="2023-05-22T15:10:07.827" v="2101" actId="1076"/>
          <ac:spMkLst>
            <pc:docMk/>
            <pc:sldMk cId="2672170052" sldId="277"/>
            <ac:spMk id="18" creationId="{F3340808-A7B5-D87D-BEED-63B193AD5EC3}"/>
          </ac:spMkLst>
        </pc:spChg>
        <pc:spChg chg="del">
          <ac:chgData name="Wigmore, Eleanor" userId="154496fa-10d7-4fd7-9fba-3614c367c37c" providerId="ADAL" clId="{AA3EDCC2-F595-42A0-8358-45CA77012066}" dt="2023-05-11T14:26:11.595" v="525" actId="478"/>
          <ac:spMkLst>
            <pc:docMk/>
            <pc:sldMk cId="2672170052" sldId="277"/>
            <ac:spMk id="19" creationId="{BBB0C97E-5FB6-4974-AF7E-A41B34529033}"/>
          </ac:spMkLst>
        </pc:spChg>
        <pc:spChg chg="del">
          <ac:chgData name="Wigmore, Eleanor" userId="154496fa-10d7-4fd7-9fba-3614c367c37c" providerId="ADAL" clId="{AA3EDCC2-F595-42A0-8358-45CA77012066}" dt="2023-05-11T14:26:11.595" v="525" actId="478"/>
          <ac:spMkLst>
            <pc:docMk/>
            <pc:sldMk cId="2672170052" sldId="277"/>
            <ac:spMk id="20" creationId="{2F516CA9-FF84-4732-A77A-4D43BEE718CB}"/>
          </ac:spMkLst>
        </pc:spChg>
        <pc:spChg chg="del">
          <ac:chgData name="Wigmore, Eleanor" userId="154496fa-10d7-4fd7-9fba-3614c367c37c" providerId="ADAL" clId="{AA3EDCC2-F595-42A0-8358-45CA77012066}" dt="2023-05-11T14:26:11.595" v="525" actId="478"/>
          <ac:spMkLst>
            <pc:docMk/>
            <pc:sldMk cId="2672170052" sldId="277"/>
            <ac:spMk id="21" creationId="{1487C6B3-A1D9-496D-B3B2-697CA712C631}"/>
          </ac:spMkLst>
        </pc:spChg>
        <pc:spChg chg="add mod">
          <ac:chgData name="Wigmore, Eleanor" userId="154496fa-10d7-4fd7-9fba-3614c367c37c" providerId="ADAL" clId="{AA3EDCC2-F595-42A0-8358-45CA77012066}" dt="2023-05-22T15:02:24.091" v="1913" actId="20577"/>
          <ac:spMkLst>
            <pc:docMk/>
            <pc:sldMk cId="2672170052" sldId="277"/>
            <ac:spMk id="22" creationId="{557AA382-4895-7F10-B8D6-0479A8FC7615}"/>
          </ac:spMkLst>
        </pc:spChg>
        <pc:spChg chg="del">
          <ac:chgData name="Wigmore, Eleanor" userId="154496fa-10d7-4fd7-9fba-3614c367c37c" providerId="ADAL" clId="{AA3EDCC2-F595-42A0-8358-45CA77012066}" dt="2023-05-11T14:26:17.935" v="527" actId="478"/>
          <ac:spMkLst>
            <pc:docMk/>
            <pc:sldMk cId="2672170052" sldId="277"/>
            <ac:spMk id="22" creationId="{FD104A41-51C6-485F-938C-39341C493ED6}"/>
          </ac:spMkLst>
        </pc:spChg>
        <pc:spChg chg="add mod">
          <ac:chgData name="Wigmore, Eleanor" userId="154496fa-10d7-4fd7-9fba-3614c367c37c" providerId="ADAL" clId="{AA3EDCC2-F595-42A0-8358-45CA77012066}" dt="2023-05-19T14:52:31.336" v="1382" actId="1076"/>
          <ac:spMkLst>
            <pc:docMk/>
            <pc:sldMk cId="2672170052" sldId="277"/>
            <ac:spMk id="23" creationId="{8601994B-901E-A6BE-C029-4EB6A6021926}"/>
          </ac:spMkLst>
        </pc:spChg>
        <pc:spChg chg="add mod">
          <ac:chgData name="Wigmore, Eleanor" userId="154496fa-10d7-4fd7-9fba-3614c367c37c" providerId="ADAL" clId="{AA3EDCC2-F595-42A0-8358-45CA77012066}" dt="2023-05-19T14:52:31.336" v="1382" actId="1076"/>
          <ac:spMkLst>
            <pc:docMk/>
            <pc:sldMk cId="2672170052" sldId="277"/>
            <ac:spMk id="24" creationId="{81089332-DEEA-E983-A187-F0A7E8CAE5F6}"/>
          </ac:spMkLst>
        </pc:spChg>
        <pc:spChg chg="add mod">
          <ac:chgData name="Wigmore, Eleanor" userId="154496fa-10d7-4fd7-9fba-3614c367c37c" providerId="ADAL" clId="{AA3EDCC2-F595-42A0-8358-45CA77012066}" dt="2023-05-22T15:05:03.279" v="1937" actId="20577"/>
          <ac:spMkLst>
            <pc:docMk/>
            <pc:sldMk cId="2672170052" sldId="277"/>
            <ac:spMk id="25" creationId="{41632CC1-87BB-A1FD-6F0F-C7898E77BC04}"/>
          </ac:spMkLst>
        </pc:spChg>
        <pc:spChg chg="del">
          <ac:chgData name="Wigmore, Eleanor" userId="154496fa-10d7-4fd7-9fba-3614c367c37c" providerId="ADAL" clId="{AA3EDCC2-F595-42A0-8358-45CA77012066}" dt="2023-05-11T14:26:43.014" v="580" actId="478"/>
          <ac:spMkLst>
            <pc:docMk/>
            <pc:sldMk cId="2672170052" sldId="277"/>
            <ac:spMk id="25" creationId="{50A8AA51-A0BD-4315-A49E-04E7119582AB}"/>
          </ac:spMkLst>
        </pc:spChg>
        <pc:spChg chg="add mod">
          <ac:chgData name="Wigmore, Eleanor" userId="154496fa-10d7-4fd7-9fba-3614c367c37c" providerId="ADAL" clId="{AA3EDCC2-F595-42A0-8358-45CA77012066}" dt="2023-05-22T15:05:24.580" v="1939" actId="20577"/>
          <ac:spMkLst>
            <pc:docMk/>
            <pc:sldMk cId="2672170052" sldId="277"/>
            <ac:spMk id="26" creationId="{3F6567F8-948C-3776-04AE-1F4997F2DC06}"/>
          </ac:spMkLst>
        </pc:spChg>
        <pc:spChg chg="del">
          <ac:chgData name="Wigmore, Eleanor" userId="154496fa-10d7-4fd7-9fba-3614c367c37c" providerId="ADAL" clId="{AA3EDCC2-F595-42A0-8358-45CA77012066}" dt="2023-05-11T14:26:11.595" v="525" actId="478"/>
          <ac:spMkLst>
            <pc:docMk/>
            <pc:sldMk cId="2672170052" sldId="277"/>
            <ac:spMk id="26" creationId="{90CE14D0-5D3D-4176-9E11-B076C3203333}"/>
          </ac:spMkLst>
        </pc:spChg>
        <pc:spChg chg="add mod">
          <ac:chgData name="Wigmore, Eleanor" userId="154496fa-10d7-4fd7-9fba-3614c367c37c" providerId="ADAL" clId="{AA3EDCC2-F595-42A0-8358-45CA77012066}" dt="2023-05-19T14:52:31.336" v="1382" actId="1076"/>
          <ac:spMkLst>
            <pc:docMk/>
            <pc:sldMk cId="2672170052" sldId="277"/>
            <ac:spMk id="27" creationId="{F6D18671-70D7-AED0-BB33-4EC057D7A107}"/>
          </ac:spMkLst>
        </pc:spChg>
        <pc:spChg chg="add mod">
          <ac:chgData name="Wigmore, Eleanor" userId="154496fa-10d7-4fd7-9fba-3614c367c37c" providerId="ADAL" clId="{AA3EDCC2-F595-42A0-8358-45CA77012066}" dt="2023-05-19T14:52:31.336" v="1382" actId="1076"/>
          <ac:spMkLst>
            <pc:docMk/>
            <pc:sldMk cId="2672170052" sldId="277"/>
            <ac:spMk id="28" creationId="{003C3A1C-7C4B-4DFA-331E-43142345CC66}"/>
          </ac:spMkLst>
        </pc:spChg>
        <pc:spChg chg="add mod">
          <ac:chgData name="Wigmore, Eleanor" userId="154496fa-10d7-4fd7-9fba-3614c367c37c" providerId="ADAL" clId="{AA3EDCC2-F595-42A0-8358-45CA77012066}" dt="2023-05-19T14:53:18.500" v="1407" actId="20577"/>
          <ac:spMkLst>
            <pc:docMk/>
            <pc:sldMk cId="2672170052" sldId="277"/>
            <ac:spMk id="31" creationId="{AC19B651-0AC5-2BE1-B38E-B577D0F01D59}"/>
          </ac:spMkLst>
        </pc:spChg>
        <pc:spChg chg="add mod">
          <ac:chgData name="Wigmore, Eleanor" userId="154496fa-10d7-4fd7-9fba-3614c367c37c" providerId="ADAL" clId="{AA3EDCC2-F595-42A0-8358-45CA77012066}" dt="2023-05-19T14:53:14.795" v="1403" actId="20577"/>
          <ac:spMkLst>
            <pc:docMk/>
            <pc:sldMk cId="2672170052" sldId="277"/>
            <ac:spMk id="32" creationId="{6866D49D-3813-C153-C50A-A0B6618F65B2}"/>
          </ac:spMkLst>
        </pc:spChg>
        <pc:spChg chg="add mod">
          <ac:chgData name="Wigmore, Eleanor" userId="154496fa-10d7-4fd7-9fba-3614c367c37c" providerId="ADAL" clId="{AA3EDCC2-F595-42A0-8358-45CA77012066}" dt="2023-05-19T14:53:08.666" v="1397" actId="20577"/>
          <ac:spMkLst>
            <pc:docMk/>
            <pc:sldMk cId="2672170052" sldId="277"/>
            <ac:spMk id="33" creationId="{54D1B0EA-54FA-A56A-6606-BF64B3146C45}"/>
          </ac:spMkLst>
        </pc:spChg>
        <pc:spChg chg="add mod">
          <ac:chgData name="Wigmore, Eleanor" userId="154496fa-10d7-4fd7-9fba-3614c367c37c" providerId="ADAL" clId="{AA3EDCC2-F595-42A0-8358-45CA77012066}" dt="2023-05-19T14:53:10.926" v="1399" actId="20577"/>
          <ac:spMkLst>
            <pc:docMk/>
            <pc:sldMk cId="2672170052" sldId="277"/>
            <ac:spMk id="34" creationId="{AEF02140-8286-A485-048F-31B51E71C859}"/>
          </ac:spMkLst>
        </pc:spChg>
        <pc:spChg chg="add del mod">
          <ac:chgData name="Wigmore, Eleanor" userId="154496fa-10d7-4fd7-9fba-3614c367c37c" providerId="ADAL" clId="{AA3EDCC2-F595-42A0-8358-45CA77012066}" dt="2023-05-22T15:01:45.753" v="1891"/>
          <ac:spMkLst>
            <pc:docMk/>
            <pc:sldMk cId="2672170052" sldId="277"/>
            <ac:spMk id="35" creationId="{3709CE8F-47E0-80C0-7D37-273BE5423C46}"/>
          </ac:spMkLst>
        </pc:spChg>
        <pc:spChg chg="add mod">
          <ac:chgData name="Wigmore, Eleanor" userId="154496fa-10d7-4fd7-9fba-3614c367c37c" providerId="ADAL" clId="{AA3EDCC2-F595-42A0-8358-45CA77012066}" dt="2023-05-22T15:11:15.385" v="2142" actId="404"/>
          <ac:spMkLst>
            <pc:docMk/>
            <pc:sldMk cId="2672170052" sldId="277"/>
            <ac:spMk id="35" creationId="{A86630B0-8AC0-1FED-EE8B-6E3BA117EF57}"/>
          </ac:spMkLst>
        </pc:spChg>
        <pc:spChg chg="add mod">
          <ac:chgData name="Wigmore, Eleanor" userId="154496fa-10d7-4fd7-9fba-3614c367c37c" providerId="ADAL" clId="{AA3EDCC2-F595-42A0-8358-45CA77012066}" dt="2023-05-22T15:11:22.863" v="2155" actId="14100"/>
          <ac:spMkLst>
            <pc:docMk/>
            <pc:sldMk cId="2672170052" sldId="277"/>
            <ac:spMk id="36" creationId="{E17D3142-FE54-AF04-637D-DFB9F2A39F75}"/>
          </ac:spMkLst>
        </pc:spChg>
        <pc:spChg chg="add mod">
          <ac:chgData name="Wigmore, Eleanor" userId="154496fa-10d7-4fd7-9fba-3614c367c37c" providerId="ADAL" clId="{AA3EDCC2-F595-42A0-8358-45CA77012066}" dt="2023-05-22T15:11:44.195" v="2161" actId="20577"/>
          <ac:spMkLst>
            <pc:docMk/>
            <pc:sldMk cId="2672170052" sldId="277"/>
            <ac:spMk id="37" creationId="{2E230739-22A9-219F-144D-BDB30A768A86}"/>
          </ac:spMkLst>
        </pc:spChg>
        <pc:spChg chg="add mod">
          <ac:chgData name="Wigmore, Eleanor" userId="154496fa-10d7-4fd7-9fba-3614c367c37c" providerId="ADAL" clId="{AA3EDCC2-F595-42A0-8358-45CA77012066}" dt="2023-05-22T15:11:47.614" v="2166" actId="20577"/>
          <ac:spMkLst>
            <pc:docMk/>
            <pc:sldMk cId="2672170052" sldId="277"/>
            <ac:spMk id="38" creationId="{4F1C925D-62ED-A673-977B-68DCE897E986}"/>
          </ac:spMkLst>
        </pc:spChg>
        <pc:spChg chg="add mod">
          <ac:chgData name="Wigmore, Eleanor" userId="154496fa-10d7-4fd7-9fba-3614c367c37c" providerId="ADAL" clId="{AA3EDCC2-F595-42A0-8358-45CA77012066}" dt="2023-05-22T15:12:34.518" v="2191" actId="14100"/>
          <ac:spMkLst>
            <pc:docMk/>
            <pc:sldMk cId="2672170052" sldId="277"/>
            <ac:spMk id="39" creationId="{4797B4A4-279E-0D5E-3B6C-56C442AB0768}"/>
          </ac:spMkLst>
        </pc:spChg>
        <pc:spChg chg="add mod">
          <ac:chgData name="Wigmore, Eleanor" userId="154496fa-10d7-4fd7-9fba-3614c367c37c" providerId="ADAL" clId="{AA3EDCC2-F595-42A0-8358-45CA77012066}" dt="2023-05-22T15:12:23.935" v="2182" actId="20577"/>
          <ac:spMkLst>
            <pc:docMk/>
            <pc:sldMk cId="2672170052" sldId="277"/>
            <ac:spMk id="40" creationId="{243398E4-B9EF-A978-12A0-52CE64283846}"/>
          </ac:spMkLst>
        </pc:spChg>
        <pc:spChg chg="add mod">
          <ac:chgData name="Wigmore, Eleanor" userId="154496fa-10d7-4fd7-9fba-3614c367c37c" providerId="ADAL" clId="{AA3EDCC2-F595-42A0-8358-45CA77012066}" dt="2023-05-22T15:13:15.958" v="2204" actId="1038"/>
          <ac:spMkLst>
            <pc:docMk/>
            <pc:sldMk cId="2672170052" sldId="277"/>
            <ac:spMk id="41" creationId="{48C636D4-9ECA-BC79-BE63-2B4B7D226453}"/>
          </ac:spMkLst>
        </pc:spChg>
        <pc:spChg chg="add mod">
          <ac:chgData name="Wigmore, Eleanor" userId="154496fa-10d7-4fd7-9fba-3614c367c37c" providerId="ADAL" clId="{AA3EDCC2-F595-42A0-8358-45CA77012066}" dt="2023-05-22T15:13:22.515" v="2226" actId="20577"/>
          <ac:spMkLst>
            <pc:docMk/>
            <pc:sldMk cId="2672170052" sldId="277"/>
            <ac:spMk id="42" creationId="{5B571861-BC12-6DC1-33C0-20D2D79C3E14}"/>
          </ac:spMkLst>
        </pc:spChg>
        <pc:spChg chg="add mod">
          <ac:chgData name="Wigmore, Eleanor" userId="154496fa-10d7-4fd7-9fba-3614c367c37c" providerId="ADAL" clId="{AA3EDCC2-F595-42A0-8358-45CA77012066}" dt="2023-05-22T15:13:28.336" v="2244" actId="1038"/>
          <ac:spMkLst>
            <pc:docMk/>
            <pc:sldMk cId="2672170052" sldId="277"/>
            <ac:spMk id="43" creationId="{2EBD2FD6-2E68-52C0-1DF6-7FCD038919C4}"/>
          </ac:spMkLst>
        </pc:spChg>
        <pc:spChg chg="add mod">
          <ac:chgData name="Wigmore, Eleanor" userId="154496fa-10d7-4fd7-9fba-3614c367c37c" providerId="ADAL" clId="{AA3EDCC2-F595-42A0-8358-45CA77012066}" dt="2023-05-22T15:13:35.433" v="2268" actId="1038"/>
          <ac:spMkLst>
            <pc:docMk/>
            <pc:sldMk cId="2672170052" sldId="277"/>
            <ac:spMk id="44" creationId="{EB6DC543-B270-BE48-E3E6-6E5A087514CB}"/>
          </ac:spMkLst>
        </pc:spChg>
        <pc:spChg chg="add mod">
          <ac:chgData name="Wigmore, Eleanor" userId="154496fa-10d7-4fd7-9fba-3614c367c37c" providerId="ADAL" clId="{AA3EDCC2-F595-42A0-8358-45CA77012066}" dt="2023-05-22T15:13:50.506" v="2303" actId="1037"/>
          <ac:spMkLst>
            <pc:docMk/>
            <pc:sldMk cId="2672170052" sldId="277"/>
            <ac:spMk id="45" creationId="{C5B11CB9-3B12-614E-5202-DBF000685537}"/>
          </ac:spMkLst>
        </pc:spChg>
        <pc:spChg chg="add mod">
          <ac:chgData name="Wigmore, Eleanor" userId="154496fa-10d7-4fd7-9fba-3614c367c37c" providerId="ADAL" clId="{AA3EDCC2-F595-42A0-8358-45CA77012066}" dt="2023-05-22T15:13:46.532" v="2301" actId="20577"/>
          <ac:spMkLst>
            <pc:docMk/>
            <pc:sldMk cId="2672170052" sldId="277"/>
            <ac:spMk id="46" creationId="{2B452893-CE8F-AF53-ADA4-9A5C0DF37D59}"/>
          </ac:spMkLst>
        </pc:spChg>
        <pc:grpChg chg="del">
          <ac:chgData name="Wigmore, Eleanor" userId="154496fa-10d7-4fd7-9fba-3614c367c37c" providerId="ADAL" clId="{AA3EDCC2-F595-42A0-8358-45CA77012066}" dt="2023-05-11T14:26:11.595" v="525" actId="478"/>
          <ac:grpSpMkLst>
            <pc:docMk/>
            <pc:sldMk cId="2672170052" sldId="277"/>
            <ac:grpSpMk id="7" creationId="{CE97BED6-B56F-4101-96A6-17FFB9BA83C8}"/>
          </ac:grpSpMkLst>
        </pc:grpChg>
        <pc:graphicFrameChg chg="del mod">
          <ac:chgData name="Wigmore, Eleanor" userId="154496fa-10d7-4fd7-9fba-3614c367c37c" providerId="ADAL" clId="{AA3EDCC2-F595-42A0-8358-45CA77012066}" dt="2023-05-19T14:27:32.725" v="1225" actId="478"/>
          <ac:graphicFrameMkLst>
            <pc:docMk/>
            <pc:sldMk cId="2672170052" sldId="277"/>
            <ac:graphicFrameMk id="3" creationId="{F34389F1-4605-4B13-A5AC-526EC051BD00}"/>
          </ac:graphicFrameMkLst>
        </pc:graphicFrameChg>
        <pc:graphicFrameChg chg="del">
          <ac:chgData name="Wigmore, Eleanor" userId="154496fa-10d7-4fd7-9fba-3614c367c37c" providerId="ADAL" clId="{AA3EDCC2-F595-42A0-8358-45CA77012066}" dt="2023-05-11T14:26:11.595" v="525" actId="478"/>
          <ac:graphicFrameMkLst>
            <pc:docMk/>
            <pc:sldMk cId="2672170052" sldId="277"/>
            <ac:graphicFrameMk id="15" creationId="{FE6462AE-B637-47DD-A35B-8245609138C5}"/>
          </ac:graphicFrameMkLst>
        </pc:graphicFrameChg>
        <pc:picChg chg="add mod modCrop">
          <ac:chgData name="Wigmore, Eleanor" userId="154496fa-10d7-4fd7-9fba-3614c367c37c" providerId="ADAL" clId="{AA3EDCC2-F595-42A0-8358-45CA77012066}" dt="2023-05-22T15:10:04.643" v="2100" actId="1076"/>
          <ac:picMkLst>
            <pc:docMk/>
            <pc:sldMk cId="2672170052" sldId="277"/>
            <ac:picMk id="2" creationId="{5AE1D2A7-02EB-3A12-EE74-8283E03095DF}"/>
          </ac:picMkLst>
        </pc:picChg>
        <pc:picChg chg="add mod modCrop">
          <ac:chgData name="Wigmore, Eleanor" userId="154496fa-10d7-4fd7-9fba-3614c367c37c" providerId="ADAL" clId="{AA3EDCC2-F595-42A0-8358-45CA77012066}" dt="2023-05-22T15:10:32.192" v="2103" actId="732"/>
          <ac:picMkLst>
            <pc:docMk/>
            <pc:sldMk cId="2672170052" sldId="277"/>
            <ac:picMk id="3" creationId="{72C277A1-2878-43DB-A1A6-A2B4E59625C0}"/>
          </ac:picMkLst>
        </pc:picChg>
        <pc:picChg chg="add mod modCrop">
          <ac:chgData name="Wigmore, Eleanor" userId="154496fa-10d7-4fd7-9fba-3614c367c37c" providerId="ADAL" clId="{AA3EDCC2-F595-42A0-8358-45CA77012066}" dt="2023-05-22T15:12:08.060" v="2170" actId="732"/>
          <ac:picMkLst>
            <pc:docMk/>
            <pc:sldMk cId="2672170052" sldId="277"/>
            <ac:picMk id="4" creationId="{5D4DB241-6071-9ABD-C64D-090547258C39}"/>
          </ac:picMkLst>
        </pc:picChg>
        <pc:picChg chg="add mod modCrop">
          <ac:chgData name="Wigmore, Eleanor" userId="154496fa-10d7-4fd7-9fba-3614c367c37c" providerId="ADAL" clId="{AA3EDCC2-F595-42A0-8358-45CA77012066}" dt="2023-05-22T15:11:29.592" v="2156" actId="732"/>
          <ac:picMkLst>
            <pc:docMk/>
            <pc:sldMk cId="2672170052" sldId="277"/>
            <ac:picMk id="5" creationId="{DEFF951A-F40D-D6B6-0BA4-F0F94ADB8D80}"/>
          </ac:picMkLst>
        </pc:picChg>
        <pc:picChg chg="add mod modCrop">
          <ac:chgData name="Wigmore, Eleanor" userId="154496fa-10d7-4fd7-9fba-3614c367c37c" providerId="ADAL" clId="{AA3EDCC2-F595-42A0-8358-45CA77012066}" dt="2023-05-22T15:10:14.925" v="2102" actId="732"/>
          <ac:picMkLst>
            <pc:docMk/>
            <pc:sldMk cId="2672170052" sldId="277"/>
            <ac:picMk id="6" creationId="{A77ADCCE-0E6B-EACD-B527-00C5281465B5}"/>
          </ac:picMkLst>
        </pc:picChg>
        <pc:picChg chg="add del mod modCrop">
          <ac:chgData name="Wigmore, Eleanor" userId="154496fa-10d7-4fd7-9fba-3614c367c37c" providerId="ADAL" clId="{AA3EDCC2-F595-42A0-8358-45CA77012066}" dt="2023-05-19T14:31:44.895" v="1237" actId="21"/>
          <ac:picMkLst>
            <pc:docMk/>
            <pc:sldMk cId="2672170052" sldId="277"/>
            <ac:picMk id="6" creationId="{DEE1E760-8EAD-DEF1-83D6-F5497107063C}"/>
          </ac:picMkLst>
        </pc:picChg>
        <pc:picChg chg="add mod modCrop">
          <ac:chgData name="Wigmore, Eleanor" userId="154496fa-10d7-4fd7-9fba-3614c367c37c" providerId="ADAL" clId="{AA3EDCC2-F595-42A0-8358-45CA77012066}" dt="2023-05-22T15:12:44.803" v="2192" actId="732"/>
          <ac:picMkLst>
            <pc:docMk/>
            <pc:sldMk cId="2672170052" sldId="277"/>
            <ac:picMk id="19" creationId="{CA762B03-9C42-0F38-DFE1-0ED8C90E53CA}"/>
          </ac:picMkLst>
        </pc:picChg>
        <pc:picChg chg="add mod modCrop">
          <ac:chgData name="Wigmore, Eleanor" userId="154496fa-10d7-4fd7-9fba-3614c367c37c" providerId="ADAL" clId="{AA3EDCC2-F595-42A0-8358-45CA77012066}" dt="2023-05-22T15:13:01.701" v="2194" actId="732"/>
          <ac:picMkLst>
            <pc:docMk/>
            <pc:sldMk cId="2672170052" sldId="277"/>
            <ac:picMk id="20" creationId="{70F5E9C9-0561-A0C1-2E1C-95EACF5B4DD6}"/>
          </ac:picMkLst>
        </pc:picChg>
        <pc:picChg chg="add mod modCrop">
          <ac:chgData name="Wigmore, Eleanor" userId="154496fa-10d7-4fd7-9fba-3614c367c37c" providerId="ADAL" clId="{AA3EDCC2-F595-42A0-8358-45CA77012066}" dt="2023-05-22T15:12:52.477" v="2193" actId="732"/>
          <ac:picMkLst>
            <pc:docMk/>
            <pc:sldMk cId="2672170052" sldId="277"/>
            <ac:picMk id="21" creationId="{F19C678C-8134-00F7-F405-61BA1A7DD959}"/>
          </ac:picMkLst>
        </pc:picChg>
        <pc:picChg chg="add mod">
          <ac:chgData name="Wigmore, Eleanor" userId="154496fa-10d7-4fd7-9fba-3614c367c37c" providerId="ADAL" clId="{AA3EDCC2-F595-42A0-8358-45CA77012066}" dt="2023-05-19T14:52:31.336" v="1382" actId="1076"/>
          <ac:picMkLst>
            <pc:docMk/>
            <pc:sldMk cId="2672170052" sldId="277"/>
            <ac:picMk id="29" creationId="{818F5A1C-4D3F-2AD6-1B08-29C1BAE83E0B}"/>
          </ac:picMkLst>
        </pc:picChg>
        <pc:picChg chg="add mod">
          <ac:chgData name="Wigmore, Eleanor" userId="154496fa-10d7-4fd7-9fba-3614c367c37c" providerId="ADAL" clId="{AA3EDCC2-F595-42A0-8358-45CA77012066}" dt="2023-05-19T14:52:31.336" v="1382" actId="1076"/>
          <ac:picMkLst>
            <pc:docMk/>
            <pc:sldMk cId="2672170052" sldId="277"/>
            <ac:picMk id="30" creationId="{78AF99D9-EB20-50C3-2D6C-7A0F16CCBC86}"/>
          </ac:picMkLst>
        </pc:picChg>
        <pc:picChg chg="add del">
          <ac:chgData name="Wigmore, Eleanor" userId="154496fa-10d7-4fd7-9fba-3614c367c37c" providerId="ADAL" clId="{AA3EDCC2-F595-42A0-8358-45CA77012066}" dt="2023-05-19T14:51:36.931" v="1378" actId="478"/>
          <ac:picMkLst>
            <pc:docMk/>
            <pc:sldMk cId="2672170052" sldId="277"/>
            <ac:picMk id="1026" creationId="{0FB6AB53-F193-A436-1AC1-EBF537F3FEA5}"/>
          </ac:picMkLst>
        </pc:picChg>
        <pc:picChg chg="add del">
          <ac:chgData name="Wigmore, Eleanor" userId="154496fa-10d7-4fd7-9fba-3614c367c37c" providerId="ADAL" clId="{AA3EDCC2-F595-42A0-8358-45CA77012066}" dt="2023-05-19T14:51:36.931" v="1378" actId="478"/>
          <ac:picMkLst>
            <pc:docMk/>
            <pc:sldMk cId="2672170052" sldId="277"/>
            <ac:picMk id="1027" creationId="{A002DD5B-1789-FE16-204B-F393A983AAAC}"/>
          </ac:picMkLst>
        </pc:picChg>
      </pc:sldChg>
      <pc:sldChg chg="modSp mod ord">
        <pc:chgData name="Wigmore, Eleanor" userId="154496fa-10d7-4fd7-9fba-3614c367c37c" providerId="ADAL" clId="{AA3EDCC2-F595-42A0-8358-45CA77012066}" dt="2023-05-24T11:14:01.822" v="2724" actId="20577"/>
        <pc:sldMkLst>
          <pc:docMk/>
          <pc:sldMk cId="1992358590" sldId="280"/>
        </pc:sldMkLst>
        <pc:spChg chg="mod">
          <ac:chgData name="Wigmore, Eleanor" userId="154496fa-10d7-4fd7-9fba-3614c367c37c" providerId="ADAL" clId="{AA3EDCC2-F595-42A0-8358-45CA77012066}" dt="2023-05-24T11:14:01.822" v="2724" actId="20577"/>
          <ac:spMkLst>
            <pc:docMk/>
            <pc:sldMk cId="1992358590" sldId="280"/>
            <ac:spMk id="9" creationId="{5ED4491D-E78B-441E-80CE-35F22141D8AA}"/>
          </ac:spMkLst>
        </pc:spChg>
      </pc:sldChg>
      <pc:sldChg chg="addSp delSp modSp mod">
        <pc:chgData name="Wigmore, Eleanor" userId="154496fa-10d7-4fd7-9fba-3614c367c37c" providerId="ADAL" clId="{AA3EDCC2-F595-42A0-8358-45CA77012066}" dt="2023-05-25T10:48:32.576" v="4682" actId="732"/>
        <pc:sldMkLst>
          <pc:docMk/>
          <pc:sldMk cId="586963921" sldId="281"/>
        </pc:sldMkLst>
        <pc:spChg chg="add del mod">
          <ac:chgData name="Wigmore, Eleanor" userId="154496fa-10d7-4fd7-9fba-3614c367c37c" providerId="ADAL" clId="{AA3EDCC2-F595-42A0-8358-45CA77012066}" dt="2023-05-22T15:39:49.041" v="2377"/>
          <ac:spMkLst>
            <pc:docMk/>
            <pc:sldMk cId="586963921" sldId="281"/>
            <ac:spMk id="2" creationId="{7B443C5E-D35F-2B61-0802-A8C76EE537E4}"/>
          </ac:spMkLst>
        </pc:spChg>
        <pc:spChg chg="add del mod">
          <ac:chgData name="Wigmore, Eleanor" userId="154496fa-10d7-4fd7-9fba-3614c367c37c" providerId="ADAL" clId="{AA3EDCC2-F595-42A0-8358-45CA77012066}" dt="2023-05-24T10:57:26.594" v="2562" actId="478"/>
          <ac:spMkLst>
            <pc:docMk/>
            <pc:sldMk cId="586963921" sldId="281"/>
            <ac:spMk id="2" creationId="{B9EED6A9-6BD3-BF7D-857D-8DC834048FD7}"/>
          </ac:spMkLst>
        </pc:spChg>
        <pc:spChg chg="add del mod">
          <ac:chgData name="Wigmore, Eleanor" userId="154496fa-10d7-4fd7-9fba-3614c367c37c" providerId="ADAL" clId="{AA3EDCC2-F595-42A0-8358-45CA77012066}" dt="2023-05-24T11:23:08.082" v="2772" actId="478"/>
          <ac:spMkLst>
            <pc:docMk/>
            <pc:sldMk cId="586963921" sldId="281"/>
            <ac:spMk id="3" creationId="{E608C66F-1318-AD58-44E7-1EC23F3319B4}"/>
          </ac:spMkLst>
        </pc:spChg>
        <pc:spChg chg="add del mod">
          <ac:chgData name="Wigmore, Eleanor" userId="154496fa-10d7-4fd7-9fba-3614c367c37c" providerId="ADAL" clId="{AA3EDCC2-F595-42A0-8358-45CA77012066}" dt="2023-05-22T15:39:49.056" v="2382"/>
          <ac:spMkLst>
            <pc:docMk/>
            <pc:sldMk cId="586963921" sldId="281"/>
            <ac:spMk id="4" creationId="{16AE786E-51BA-A45F-B6EB-B28B35BFD5A4}"/>
          </ac:spMkLst>
        </pc:spChg>
        <pc:spChg chg="add del mod">
          <ac:chgData name="Wigmore, Eleanor" userId="154496fa-10d7-4fd7-9fba-3614c367c37c" providerId="ADAL" clId="{AA3EDCC2-F595-42A0-8358-45CA77012066}" dt="2023-05-23T13:12:14.918" v="2441"/>
          <ac:spMkLst>
            <pc:docMk/>
            <pc:sldMk cId="586963921" sldId="281"/>
            <ac:spMk id="4" creationId="{22E5C3E8-30A3-925D-4D02-F84B82452116}"/>
          </ac:spMkLst>
        </pc:spChg>
        <pc:spChg chg="add del mod">
          <ac:chgData name="Wigmore, Eleanor" userId="154496fa-10d7-4fd7-9fba-3614c367c37c" providerId="ADAL" clId="{AA3EDCC2-F595-42A0-8358-45CA77012066}" dt="2023-05-24T11:23:10.068" v="2773" actId="478"/>
          <ac:spMkLst>
            <pc:docMk/>
            <pc:sldMk cId="586963921" sldId="281"/>
            <ac:spMk id="4" creationId="{90EFB0C3-6040-9687-284F-5CFF47DD0801}"/>
          </ac:spMkLst>
        </pc:spChg>
        <pc:spChg chg="add del mod">
          <ac:chgData name="Wigmore, Eleanor" userId="154496fa-10d7-4fd7-9fba-3614c367c37c" providerId="ADAL" clId="{AA3EDCC2-F595-42A0-8358-45CA77012066}" dt="2023-05-23T13:12:14.931" v="2446"/>
          <ac:spMkLst>
            <pc:docMk/>
            <pc:sldMk cId="586963921" sldId="281"/>
            <ac:spMk id="5" creationId="{0720F058-BA2F-E343-5A3F-1C8BAAE74ED8}"/>
          </ac:spMkLst>
        </pc:spChg>
        <pc:spChg chg="add del mod">
          <ac:chgData name="Wigmore, Eleanor" userId="154496fa-10d7-4fd7-9fba-3614c367c37c" providerId="ADAL" clId="{AA3EDCC2-F595-42A0-8358-45CA77012066}" dt="2023-05-24T11:56:41.032" v="3309" actId="478"/>
          <ac:spMkLst>
            <pc:docMk/>
            <pc:sldMk cId="586963921" sldId="281"/>
            <ac:spMk id="5" creationId="{1E7D3D67-57B6-1E2C-6735-12BF95B72524}"/>
          </ac:spMkLst>
        </pc:spChg>
        <pc:spChg chg="add del mod">
          <ac:chgData name="Wigmore, Eleanor" userId="154496fa-10d7-4fd7-9fba-3614c367c37c" providerId="ADAL" clId="{AA3EDCC2-F595-42A0-8358-45CA77012066}" dt="2023-05-22T15:39:49.068" v="2387"/>
          <ac:spMkLst>
            <pc:docMk/>
            <pc:sldMk cId="586963921" sldId="281"/>
            <ac:spMk id="5" creationId="{E2F6A877-67CD-BBE2-577D-C3B1495504AE}"/>
          </ac:spMkLst>
        </pc:spChg>
        <pc:spChg chg="add del mod">
          <ac:chgData name="Wigmore, Eleanor" userId="154496fa-10d7-4fd7-9fba-3614c367c37c" providerId="ADAL" clId="{AA3EDCC2-F595-42A0-8358-45CA77012066}" dt="2023-05-11T12:32:00.809" v="22" actId="478"/>
          <ac:spMkLst>
            <pc:docMk/>
            <pc:sldMk cId="586963921" sldId="281"/>
            <ac:spMk id="5" creationId="{FADCC158-012D-1471-5292-BEC1466AAC53}"/>
          </ac:spMkLst>
        </pc:spChg>
        <pc:spChg chg="add del mod">
          <ac:chgData name="Wigmore, Eleanor" userId="154496fa-10d7-4fd7-9fba-3614c367c37c" providerId="ADAL" clId="{AA3EDCC2-F595-42A0-8358-45CA77012066}" dt="2023-05-22T15:39:49.081" v="2392"/>
          <ac:spMkLst>
            <pc:docMk/>
            <pc:sldMk cId="586963921" sldId="281"/>
            <ac:spMk id="6" creationId="{254947D9-D795-1A5F-E9CC-1A59C783AB79}"/>
          </ac:spMkLst>
        </pc:spChg>
        <pc:spChg chg="add del mod">
          <ac:chgData name="Wigmore, Eleanor" userId="154496fa-10d7-4fd7-9fba-3614c367c37c" providerId="ADAL" clId="{AA3EDCC2-F595-42A0-8358-45CA77012066}" dt="2023-05-24T11:56:43.032" v="3310" actId="478"/>
          <ac:spMkLst>
            <pc:docMk/>
            <pc:sldMk cId="586963921" sldId="281"/>
            <ac:spMk id="6" creationId="{B7ED0823-7364-C6E0-2E92-202A030B0173}"/>
          </ac:spMkLst>
        </pc:spChg>
        <pc:spChg chg="add del mod">
          <ac:chgData name="Wigmore, Eleanor" userId="154496fa-10d7-4fd7-9fba-3614c367c37c" providerId="ADAL" clId="{AA3EDCC2-F595-42A0-8358-45CA77012066}" dt="2023-05-23T13:12:14.943" v="2451"/>
          <ac:spMkLst>
            <pc:docMk/>
            <pc:sldMk cId="586963921" sldId="281"/>
            <ac:spMk id="6" creationId="{E752F4EA-66DC-68CC-AE9E-6C662B9F6BB6}"/>
          </ac:spMkLst>
        </pc:spChg>
        <pc:spChg chg="add del mod">
          <ac:chgData name="Wigmore, Eleanor" userId="154496fa-10d7-4fd7-9fba-3614c367c37c" providerId="ADAL" clId="{AA3EDCC2-F595-42A0-8358-45CA77012066}" dt="2023-05-23T13:12:14.956" v="2456"/>
          <ac:spMkLst>
            <pc:docMk/>
            <pc:sldMk cId="586963921" sldId="281"/>
            <ac:spMk id="7" creationId="{38BB0C8A-0038-1DAD-4D82-B0E2C7AA3108}"/>
          </ac:spMkLst>
        </pc:spChg>
        <pc:spChg chg="add del mod">
          <ac:chgData name="Wigmore, Eleanor" userId="154496fa-10d7-4fd7-9fba-3614c367c37c" providerId="ADAL" clId="{AA3EDCC2-F595-42A0-8358-45CA77012066}" dt="2023-05-22T15:39:49.095" v="2397"/>
          <ac:spMkLst>
            <pc:docMk/>
            <pc:sldMk cId="586963921" sldId="281"/>
            <ac:spMk id="7" creationId="{F4F283C0-4076-4D43-45F9-C99AD5896FD1}"/>
          </ac:spMkLst>
        </pc:spChg>
        <pc:spChg chg="add del mod">
          <ac:chgData name="Wigmore, Eleanor" userId="154496fa-10d7-4fd7-9fba-3614c367c37c" providerId="ADAL" clId="{AA3EDCC2-F595-42A0-8358-45CA77012066}" dt="2023-05-23T13:12:14.970" v="2461"/>
          <ac:spMkLst>
            <pc:docMk/>
            <pc:sldMk cId="586963921" sldId="281"/>
            <ac:spMk id="8" creationId="{36954770-E6F1-C070-3264-8EF9F0336F3D}"/>
          </ac:spMkLst>
        </pc:spChg>
        <pc:spChg chg="add del mod">
          <ac:chgData name="Wigmore, Eleanor" userId="154496fa-10d7-4fd7-9fba-3614c367c37c" providerId="ADAL" clId="{AA3EDCC2-F595-42A0-8358-45CA77012066}" dt="2023-05-22T15:39:49.106" v="2402"/>
          <ac:spMkLst>
            <pc:docMk/>
            <pc:sldMk cId="586963921" sldId="281"/>
            <ac:spMk id="8" creationId="{5154AAEA-CC71-BAF6-6725-E299247B46A6}"/>
          </ac:spMkLst>
        </pc:spChg>
        <pc:spChg chg="add mod topLvl">
          <ac:chgData name="Wigmore, Eleanor" userId="154496fa-10d7-4fd7-9fba-3614c367c37c" providerId="ADAL" clId="{AA3EDCC2-F595-42A0-8358-45CA77012066}" dt="2023-05-25T10:42:12.599" v="4672" actId="164"/>
          <ac:spMkLst>
            <pc:docMk/>
            <pc:sldMk cId="586963921" sldId="281"/>
            <ac:spMk id="8" creationId="{6EFF8D16-ECEA-03AD-F0AF-51FCCE6D3B43}"/>
          </ac:spMkLst>
        </pc:spChg>
        <pc:spChg chg="add del mod">
          <ac:chgData name="Wigmore, Eleanor" userId="154496fa-10d7-4fd7-9fba-3614c367c37c" providerId="ADAL" clId="{AA3EDCC2-F595-42A0-8358-45CA77012066}" dt="2023-05-23T13:12:14.986" v="2466"/>
          <ac:spMkLst>
            <pc:docMk/>
            <pc:sldMk cId="586963921" sldId="281"/>
            <ac:spMk id="9" creationId="{37A854E1-F1A0-3765-A2FC-1526BC8EDF87}"/>
          </ac:spMkLst>
        </pc:spChg>
        <pc:spChg chg="add mod topLvl">
          <ac:chgData name="Wigmore, Eleanor" userId="154496fa-10d7-4fd7-9fba-3614c367c37c" providerId="ADAL" clId="{AA3EDCC2-F595-42A0-8358-45CA77012066}" dt="2023-05-25T10:42:12.599" v="4672" actId="164"/>
          <ac:spMkLst>
            <pc:docMk/>
            <pc:sldMk cId="586963921" sldId="281"/>
            <ac:spMk id="9" creationId="{B7F52AD2-905A-C188-A341-48308EE3801E}"/>
          </ac:spMkLst>
        </pc:spChg>
        <pc:spChg chg="add del mod">
          <ac:chgData name="Wigmore, Eleanor" userId="154496fa-10d7-4fd7-9fba-3614c367c37c" providerId="ADAL" clId="{AA3EDCC2-F595-42A0-8358-45CA77012066}" dt="2023-05-22T15:39:49.120" v="2407"/>
          <ac:spMkLst>
            <pc:docMk/>
            <pc:sldMk cId="586963921" sldId="281"/>
            <ac:spMk id="9" creationId="{D7717B85-1442-FBF1-F0C6-B5107F29BB9A}"/>
          </ac:spMkLst>
        </pc:spChg>
        <pc:spChg chg="add mod topLvl">
          <ac:chgData name="Wigmore, Eleanor" userId="154496fa-10d7-4fd7-9fba-3614c367c37c" providerId="ADAL" clId="{AA3EDCC2-F595-42A0-8358-45CA77012066}" dt="2023-05-25T10:42:12.599" v="4672" actId="164"/>
          <ac:spMkLst>
            <pc:docMk/>
            <pc:sldMk cId="586963921" sldId="281"/>
            <ac:spMk id="10" creationId="{6DE0BD59-CF14-D5D9-2AF1-7D8724E1C886}"/>
          </ac:spMkLst>
        </pc:spChg>
        <pc:spChg chg="add mod topLvl">
          <ac:chgData name="Wigmore, Eleanor" userId="154496fa-10d7-4fd7-9fba-3614c367c37c" providerId="ADAL" clId="{AA3EDCC2-F595-42A0-8358-45CA77012066}" dt="2023-05-25T10:42:12.599" v="4672" actId="164"/>
          <ac:spMkLst>
            <pc:docMk/>
            <pc:sldMk cId="586963921" sldId="281"/>
            <ac:spMk id="11" creationId="{860AF3F9-47BD-B7E0-7B05-A6B0232E7DD0}"/>
          </ac:spMkLst>
        </pc:spChg>
        <pc:spChg chg="add del mod">
          <ac:chgData name="Wigmore, Eleanor" userId="154496fa-10d7-4fd7-9fba-3614c367c37c" providerId="ADAL" clId="{AA3EDCC2-F595-42A0-8358-45CA77012066}" dt="2023-05-23T13:12:14.999" v="2471"/>
          <ac:spMkLst>
            <pc:docMk/>
            <pc:sldMk cId="586963921" sldId="281"/>
            <ac:spMk id="11" creationId="{D9DC746D-9C2C-84F9-BF2E-E6651F0B8346}"/>
          </ac:spMkLst>
        </pc:spChg>
        <pc:spChg chg="add del mod">
          <ac:chgData name="Wigmore, Eleanor" userId="154496fa-10d7-4fd7-9fba-3614c367c37c" providerId="ADAL" clId="{AA3EDCC2-F595-42A0-8358-45CA77012066}" dt="2023-05-22T15:39:49.134" v="2412"/>
          <ac:spMkLst>
            <pc:docMk/>
            <pc:sldMk cId="586963921" sldId="281"/>
            <ac:spMk id="11" creationId="{ECE32FE2-E5B6-ED91-9C44-43F9F3A966AA}"/>
          </ac:spMkLst>
        </pc:spChg>
        <pc:spChg chg="add mod topLvl">
          <ac:chgData name="Wigmore, Eleanor" userId="154496fa-10d7-4fd7-9fba-3614c367c37c" providerId="ADAL" clId="{AA3EDCC2-F595-42A0-8358-45CA77012066}" dt="2023-05-25T10:41:38.454" v="4668" actId="1037"/>
          <ac:spMkLst>
            <pc:docMk/>
            <pc:sldMk cId="586963921" sldId="281"/>
            <ac:spMk id="12" creationId="{2F42296E-9862-689F-FE72-4957819DCF3D}"/>
          </ac:spMkLst>
        </pc:spChg>
        <pc:spChg chg="add mod topLvl">
          <ac:chgData name="Wigmore, Eleanor" userId="154496fa-10d7-4fd7-9fba-3614c367c37c" providerId="ADAL" clId="{AA3EDCC2-F595-42A0-8358-45CA77012066}" dt="2023-05-25T10:21:25.004" v="4399" actId="1037"/>
          <ac:spMkLst>
            <pc:docMk/>
            <pc:sldMk cId="586963921" sldId="281"/>
            <ac:spMk id="13" creationId="{95DC0E1E-BE05-CD5F-F579-04632FAD7B3C}"/>
          </ac:spMkLst>
        </pc:spChg>
        <pc:spChg chg="add mod topLvl">
          <ac:chgData name="Wigmore, Eleanor" userId="154496fa-10d7-4fd7-9fba-3614c367c37c" providerId="ADAL" clId="{AA3EDCC2-F595-42A0-8358-45CA77012066}" dt="2023-05-25T10:42:12.599" v="4672" actId="164"/>
          <ac:spMkLst>
            <pc:docMk/>
            <pc:sldMk cId="586963921" sldId="281"/>
            <ac:spMk id="14" creationId="{2B5CCD2D-0662-5DCB-BC51-C6B3ACE901BA}"/>
          </ac:spMkLst>
        </pc:spChg>
        <pc:spChg chg="add del mod">
          <ac:chgData name="Wigmore, Eleanor" userId="154496fa-10d7-4fd7-9fba-3614c367c37c" providerId="ADAL" clId="{AA3EDCC2-F595-42A0-8358-45CA77012066}" dt="2023-05-22T15:39:49.147" v="2417"/>
          <ac:spMkLst>
            <pc:docMk/>
            <pc:sldMk cId="586963921" sldId="281"/>
            <ac:spMk id="14" creationId="{618BFA7D-E305-0734-1066-3B00062E98C1}"/>
          </ac:spMkLst>
        </pc:spChg>
        <pc:spChg chg="add del mod">
          <ac:chgData name="Wigmore, Eleanor" userId="154496fa-10d7-4fd7-9fba-3614c367c37c" providerId="ADAL" clId="{AA3EDCC2-F595-42A0-8358-45CA77012066}" dt="2023-05-23T13:12:15.009" v="2476"/>
          <ac:spMkLst>
            <pc:docMk/>
            <pc:sldMk cId="586963921" sldId="281"/>
            <ac:spMk id="14" creationId="{F8DE2871-B08E-197A-003A-4248DD27828C}"/>
          </ac:spMkLst>
        </pc:spChg>
        <pc:spChg chg="add mod topLvl">
          <ac:chgData name="Wigmore, Eleanor" userId="154496fa-10d7-4fd7-9fba-3614c367c37c" providerId="ADAL" clId="{AA3EDCC2-F595-42A0-8358-45CA77012066}" dt="2023-05-25T10:42:12.599" v="4672" actId="164"/>
          <ac:spMkLst>
            <pc:docMk/>
            <pc:sldMk cId="586963921" sldId="281"/>
            <ac:spMk id="15" creationId="{86AF0B00-4F6D-B33A-5F58-60E74C289ABC}"/>
          </ac:spMkLst>
        </pc:spChg>
        <pc:spChg chg="add mod topLvl">
          <ac:chgData name="Wigmore, Eleanor" userId="154496fa-10d7-4fd7-9fba-3614c367c37c" providerId="ADAL" clId="{AA3EDCC2-F595-42A0-8358-45CA77012066}" dt="2023-05-25T10:41:31.925" v="4667" actId="1037"/>
          <ac:spMkLst>
            <pc:docMk/>
            <pc:sldMk cId="586963921" sldId="281"/>
            <ac:spMk id="16" creationId="{586018A2-5AD3-C0E2-CB0B-09213E65A1A0}"/>
          </ac:spMkLst>
        </pc:spChg>
        <pc:spChg chg="add mod topLvl">
          <ac:chgData name="Wigmore, Eleanor" userId="154496fa-10d7-4fd7-9fba-3614c367c37c" providerId="ADAL" clId="{AA3EDCC2-F595-42A0-8358-45CA77012066}" dt="2023-05-25T10:21:30.326" v="4408" actId="1037"/>
          <ac:spMkLst>
            <pc:docMk/>
            <pc:sldMk cId="586963921" sldId="281"/>
            <ac:spMk id="17" creationId="{EC480E70-5412-0E03-797F-D2700523083C}"/>
          </ac:spMkLst>
        </pc:spChg>
        <pc:spChg chg="add mod topLvl">
          <ac:chgData name="Wigmore, Eleanor" userId="154496fa-10d7-4fd7-9fba-3614c367c37c" providerId="ADAL" clId="{AA3EDCC2-F595-42A0-8358-45CA77012066}" dt="2023-05-25T10:42:12.599" v="4672" actId="164"/>
          <ac:spMkLst>
            <pc:docMk/>
            <pc:sldMk cId="586963921" sldId="281"/>
            <ac:spMk id="18" creationId="{2DD65E61-C219-0A06-FF3F-3C34A529830F}"/>
          </ac:spMkLst>
        </pc:spChg>
        <pc:spChg chg="add del mod">
          <ac:chgData name="Wigmore, Eleanor" userId="154496fa-10d7-4fd7-9fba-3614c367c37c" providerId="ADAL" clId="{AA3EDCC2-F595-42A0-8358-45CA77012066}" dt="2023-05-22T15:39:49.159" v="2422"/>
          <ac:spMkLst>
            <pc:docMk/>
            <pc:sldMk cId="586963921" sldId="281"/>
            <ac:spMk id="18" creationId="{9F16078B-4B14-2C68-EDE3-EFCCFB62A598}"/>
          </ac:spMkLst>
        </pc:spChg>
        <pc:spChg chg="add del mod">
          <ac:chgData name="Wigmore, Eleanor" userId="154496fa-10d7-4fd7-9fba-3614c367c37c" providerId="ADAL" clId="{AA3EDCC2-F595-42A0-8358-45CA77012066}" dt="2023-05-23T13:12:15.021" v="2481"/>
          <ac:spMkLst>
            <pc:docMk/>
            <pc:sldMk cId="586963921" sldId="281"/>
            <ac:spMk id="18" creationId="{FD3A13CE-F3BE-24AF-A131-3DC6379074CE}"/>
          </ac:spMkLst>
        </pc:spChg>
        <pc:spChg chg="add del mod">
          <ac:chgData name="Wigmore, Eleanor" userId="154496fa-10d7-4fd7-9fba-3614c367c37c" providerId="ADAL" clId="{AA3EDCC2-F595-42A0-8358-45CA77012066}" dt="2023-05-23T13:12:15.033" v="2486"/>
          <ac:spMkLst>
            <pc:docMk/>
            <pc:sldMk cId="586963921" sldId="281"/>
            <ac:spMk id="20" creationId="{20716356-3201-9A62-FE64-93B9B2F391D8}"/>
          </ac:spMkLst>
        </pc:spChg>
        <pc:spChg chg="add mod topLvl">
          <ac:chgData name="Wigmore, Eleanor" userId="154496fa-10d7-4fd7-9fba-3614c367c37c" providerId="ADAL" clId="{AA3EDCC2-F595-42A0-8358-45CA77012066}" dt="2023-05-25T10:42:12.599" v="4672" actId="164"/>
          <ac:spMkLst>
            <pc:docMk/>
            <pc:sldMk cId="586963921" sldId="281"/>
            <ac:spMk id="20" creationId="{99530B34-92AB-9526-FA1D-DB5FBB613289}"/>
          </ac:spMkLst>
        </pc:spChg>
        <pc:spChg chg="add mod topLvl">
          <ac:chgData name="Wigmore, Eleanor" userId="154496fa-10d7-4fd7-9fba-3614c367c37c" providerId="ADAL" clId="{AA3EDCC2-F595-42A0-8358-45CA77012066}" dt="2023-05-25T10:42:12.599" v="4672" actId="164"/>
          <ac:spMkLst>
            <pc:docMk/>
            <pc:sldMk cId="586963921" sldId="281"/>
            <ac:spMk id="21" creationId="{EFCA66D1-1108-3154-427B-CB1990B6AA53}"/>
          </ac:spMkLst>
        </pc:spChg>
        <pc:spChg chg="add del mod">
          <ac:chgData name="Wigmore, Eleanor" userId="154496fa-10d7-4fd7-9fba-3614c367c37c" providerId="ADAL" clId="{AA3EDCC2-F595-42A0-8358-45CA77012066}" dt="2023-05-23T13:12:17.974" v="2492"/>
          <ac:spMkLst>
            <pc:docMk/>
            <pc:sldMk cId="586963921" sldId="281"/>
            <ac:spMk id="22" creationId="{B983D302-BE84-0287-F69D-7C787089328C}"/>
          </ac:spMkLst>
        </pc:spChg>
        <pc:spChg chg="add mod topLvl">
          <ac:chgData name="Wigmore, Eleanor" userId="154496fa-10d7-4fd7-9fba-3614c367c37c" providerId="ADAL" clId="{AA3EDCC2-F595-42A0-8358-45CA77012066}" dt="2023-05-25T10:42:12.599" v="4672" actId="164"/>
          <ac:spMkLst>
            <pc:docMk/>
            <pc:sldMk cId="586963921" sldId="281"/>
            <ac:spMk id="22" creationId="{C164DA9E-7943-E88D-9772-CD1F41D2152A}"/>
          </ac:spMkLst>
        </pc:spChg>
        <pc:spChg chg="add mod topLvl">
          <ac:chgData name="Wigmore, Eleanor" userId="154496fa-10d7-4fd7-9fba-3614c367c37c" providerId="ADAL" clId="{AA3EDCC2-F595-42A0-8358-45CA77012066}" dt="2023-05-25T10:42:12.599" v="4672" actId="164"/>
          <ac:spMkLst>
            <pc:docMk/>
            <pc:sldMk cId="586963921" sldId="281"/>
            <ac:spMk id="23" creationId="{D136695B-BC99-EEE1-59E5-4CCF301F0A92}"/>
          </ac:spMkLst>
        </pc:spChg>
        <pc:spChg chg="add del mod">
          <ac:chgData name="Wigmore, Eleanor" userId="154496fa-10d7-4fd7-9fba-3614c367c37c" providerId="ADAL" clId="{AA3EDCC2-F595-42A0-8358-45CA77012066}" dt="2023-05-23T13:12:17.987" v="2497"/>
          <ac:spMkLst>
            <pc:docMk/>
            <pc:sldMk cId="586963921" sldId="281"/>
            <ac:spMk id="24" creationId="{13966EE8-E0C6-7B46-41EA-B638F81CEAC8}"/>
          </ac:spMkLst>
        </pc:spChg>
        <pc:spChg chg="add mod topLvl">
          <ac:chgData name="Wigmore, Eleanor" userId="154496fa-10d7-4fd7-9fba-3614c367c37c" providerId="ADAL" clId="{AA3EDCC2-F595-42A0-8358-45CA77012066}" dt="2023-05-25T10:42:12.599" v="4672" actId="164"/>
          <ac:spMkLst>
            <pc:docMk/>
            <pc:sldMk cId="586963921" sldId="281"/>
            <ac:spMk id="24" creationId="{B0495BB4-2C8B-1C94-DC1D-877C8D03562D}"/>
          </ac:spMkLst>
        </pc:spChg>
        <pc:spChg chg="add del mod">
          <ac:chgData name="Wigmore, Eleanor" userId="154496fa-10d7-4fd7-9fba-3614c367c37c" providerId="ADAL" clId="{AA3EDCC2-F595-42A0-8358-45CA77012066}" dt="2023-05-19T14:50:46.234" v="1330"/>
          <ac:spMkLst>
            <pc:docMk/>
            <pc:sldMk cId="586963921" sldId="281"/>
            <ac:spMk id="24" creationId="{C40A8DD0-D672-4752-19C6-F90D88BD4A0F}"/>
          </ac:spMkLst>
        </pc:spChg>
        <pc:spChg chg="add del mod">
          <ac:chgData name="Wigmore, Eleanor" userId="154496fa-10d7-4fd7-9fba-3614c367c37c" providerId="ADAL" clId="{AA3EDCC2-F595-42A0-8358-45CA77012066}" dt="2023-05-19T14:50:46.250" v="1335"/>
          <ac:spMkLst>
            <pc:docMk/>
            <pc:sldMk cId="586963921" sldId="281"/>
            <ac:spMk id="25" creationId="{1AE746A1-411B-6A60-C5BA-FFDE4A535C44}"/>
          </ac:spMkLst>
        </pc:spChg>
        <pc:spChg chg="add mod topLvl">
          <ac:chgData name="Wigmore, Eleanor" userId="154496fa-10d7-4fd7-9fba-3614c367c37c" providerId="ADAL" clId="{AA3EDCC2-F595-42A0-8358-45CA77012066}" dt="2023-05-25T10:42:12.599" v="4672" actId="164"/>
          <ac:spMkLst>
            <pc:docMk/>
            <pc:sldMk cId="586963921" sldId="281"/>
            <ac:spMk id="25" creationId="{C0421F19-4348-35BD-A964-A06122AEFABB}"/>
          </ac:spMkLst>
        </pc:spChg>
        <pc:spChg chg="add del mod">
          <ac:chgData name="Wigmore, Eleanor" userId="154496fa-10d7-4fd7-9fba-3614c367c37c" providerId="ADAL" clId="{AA3EDCC2-F595-42A0-8358-45CA77012066}" dt="2023-05-23T13:12:18.003" v="2502"/>
          <ac:spMkLst>
            <pc:docMk/>
            <pc:sldMk cId="586963921" sldId="281"/>
            <ac:spMk id="25" creationId="{C1890A9E-802C-9201-7A6C-B7EB0E4D265B}"/>
          </ac:spMkLst>
        </pc:spChg>
        <pc:spChg chg="add del mod">
          <ac:chgData name="Wigmore, Eleanor" userId="154496fa-10d7-4fd7-9fba-3614c367c37c" providerId="ADAL" clId="{AA3EDCC2-F595-42A0-8358-45CA77012066}" dt="2023-05-19T14:50:46.264" v="1340"/>
          <ac:spMkLst>
            <pc:docMk/>
            <pc:sldMk cId="586963921" sldId="281"/>
            <ac:spMk id="26" creationId="{1B149A14-C698-F65E-6C2D-D6CBC6354301}"/>
          </ac:spMkLst>
        </pc:spChg>
        <pc:spChg chg="add mod topLvl">
          <ac:chgData name="Wigmore, Eleanor" userId="154496fa-10d7-4fd7-9fba-3614c367c37c" providerId="ADAL" clId="{AA3EDCC2-F595-42A0-8358-45CA77012066}" dt="2023-05-25T10:42:12.599" v="4672" actId="164"/>
          <ac:spMkLst>
            <pc:docMk/>
            <pc:sldMk cId="586963921" sldId="281"/>
            <ac:spMk id="26" creationId="{8EA940EC-B172-2D63-2244-5F25B9E6D9FA}"/>
          </ac:spMkLst>
        </pc:spChg>
        <pc:spChg chg="add del mod">
          <ac:chgData name="Wigmore, Eleanor" userId="154496fa-10d7-4fd7-9fba-3614c367c37c" providerId="ADAL" clId="{AA3EDCC2-F595-42A0-8358-45CA77012066}" dt="2023-05-23T13:12:18.017" v="2507"/>
          <ac:spMkLst>
            <pc:docMk/>
            <pc:sldMk cId="586963921" sldId="281"/>
            <ac:spMk id="26" creationId="{8FAC57EE-DE6B-967C-C14E-74485A2CB79E}"/>
          </ac:spMkLst>
        </pc:spChg>
        <pc:spChg chg="add del mod">
          <ac:chgData name="Wigmore, Eleanor" userId="154496fa-10d7-4fd7-9fba-3614c367c37c" providerId="ADAL" clId="{AA3EDCC2-F595-42A0-8358-45CA77012066}" dt="2023-05-19T14:50:46.280" v="1345"/>
          <ac:spMkLst>
            <pc:docMk/>
            <pc:sldMk cId="586963921" sldId="281"/>
            <ac:spMk id="27" creationId="{0CDB45FB-8E23-A929-E302-1A64DE86F98D}"/>
          </ac:spMkLst>
        </pc:spChg>
        <pc:spChg chg="add del mod">
          <ac:chgData name="Wigmore, Eleanor" userId="154496fa-10d7-4fd7-9fba-3614c367c37c" providerId="ADAL" clId="{AA3EDCC2-F595-42A0-8358-45CA77012066}" dt="2023-05-23T13:12:18.031" v="2512"/>
          <ac:spMkLst>
            <pc:docMk/>
            <pc:sldMk cId="586963921" sldId="281"/>
            <ac:spMk id="27" creationId="{19E27896-6E4F-4486-FAF1-CE378B6616F1}"/>
          </ac:spMkLst>
        </pc:spChg>
        <pc:spChg chg="add mod topLvl">
          <ac:chgData name="Wigmore, Eleanor" userId="154496fa-10d7-4fd7-9fba-3614c367c37c" providerId="ADAL" clId="{AA3EDCC2-F595-42A0-8358-45CA77012066}" dt="2023-05-25T10:42:12.599" v="4672" actId="164"/>
          <ac:spMkLst>
            <pc:docMk/>
            <pc:sldMk cId="586963921" sldId="281"/>
            <ac:spMk id="27" creationId="{6E545922-7977-B24F-F96F-EE15A75A00B3}"/>
          </ac:spMkLst>
        </pc:spChg>
        <pc:spChg chg="add del mod">
          <ac:chgData name="Wigmore, Eleanor" userId="154496fa-10d7-4fd7-9fba-3614c367c37c" providerId="ADAL" clId="{AA3EDCC2-F595-42A0-8358-45CA77012066}" dt="2023-05-19T14:50:46.294" v="1350"/>
          <ac:spMkLst>
            <pc:docMk/>
            <pc:sldMk cId="586963921" sldId="281"/>
            <ac:spMk id="28" creationId="{174AB42F-EFEF-8A9B-CDDF-73F267BD7DD1}"/>
          </ac:spMkLst>
        </pc:spChg>
        <pc:spChg chg="add del mod">
          <ac:chgData name="Wigmore, Eleanor" userId="154496fa-10d7-4fd7-9fba-3614c367c37c" providerId="ADAL" clId="{AA3EDCC2-F595-42A0-8358-45CA77012066}" dt="2023-05-23T13:12:18.043" v="2517"/>
          <ac:spMkLst>
            <pc:docMk/>
            <pc:sldMk cId="586963921" sldId="281"/>
            <ac:spMk id="28" creationId="{6E0FE67A-09C3-FB3E-83F1-83C74FF5E001}"/>
          </ac:spMkLst>
        </pc:spChg>
        <pc:spChg chg="add mod topLvl">
          <ac:chgData name="Wigmore, Eleanor" userId="154496fa-10d7-4fd7-9fba-3614c367c37c" providerId="ADAL" clId="{AA3EDCC2-F595-42A0-8358-45CA77012066}" dt="2023-05-25T10:42:12.599" v="4672" actId="164"/>
          <ac:spMkLst>
            <pc:docMk/>
            <pc:sldMk cId="586963921" sldId="281"/>
            <ac:spMk id="28" creationId="{C19BDD99-1C84-4001-4D54-38E991D909B8}"/>
          </ac:spMkLst>
        </pc:spChg>
        <pc:spChg chg="add mod topLvl">
          <ac:chgData name="Wigmore, Eleanor" userId="154496fa-10d7-4fd7-9fba-3614c367c37c" providerId="ADAL" clId="{AA3EDCC2-F595-42A0-8358-45CA77012066}" dt="2023-05-25T10:42:12.599" v="4672" actId="164"/>
          <ac:spMkLst>
            <pc:docMk/>
            <pc:sldMk cId="586963921" sldId="281"/>
            <ac:spMk id="29" creationId="{3F2142CD-6D62-BFE4-C00F-EE3C3DC75F17}"/>
          </ac:spMkLst>
        </pc:spChg>
        <pc:spChg chg="add del mod">
          <ac:chgData name="Wigmore, Eleanor" userId="154496fa-10d7-4fd7-9fba-3614c367c37c" providerId="ADAL" clId="{AA3EDCC2-F595-42A0-8358-45CA77012066}" dt="2023-05-23T13:12:18.057" v="2522"/>
          <ac:spMkLst>
            <pc:docMk/>
            <pc:sldMk cId="586963921" sldId="281"/>
            <ac:spMk id="29" creationId="{C3F85F04-BF16-9E69-27DD-7FBFD0B82732}"/>
          </ac:spMkLst>
        </pc:spChg>
        <pc:spChg chg="add del mod">
          <ac:chgData name="Wigmore, Eleanor" userId="154496fa-10d7-4fd7-9fba-3614c367c37c" providerId="ADAL" clId="{AA3EDCC2-F595-42A0-8358-45CA77012066}" dt="2023-05-19T14:50:46.308" v="1355"/>
          <ac:spMkLst>
            <pc:docMk/>
            <pc:sldMk cId="586963921" sldId="281"/>
            <ac:spMk id="29" creationId="{D05E0895-56F6-0D16-7560-AEF196CE733D}"/>
          </ac:spMkLst>
        </pc:spChg>
        <pc:spChg chg="add del mod">
          <ac:chgData name="Wigmore, Eleanor" userId="154496fa-10d7-4fd7-9fba-3614c367c37c" providerId="ADAL" clId="{AA3EDCC2-F595-42A0-8358-45CA77012066}" dt="2023-05-23T13:12:18.070" v="2527"/>
          <ac:spMkLst>
            <pc:docMk/>
            <pc:sldMk cId="586963921" sldId="281"/>
            <ac:spMk id="30" creationId="{214C8254-4631-A4CF-4AFC-6C468D16728A}"/>
          </ac:spMkLst>
        </pc:spChg>
        <pc:spChg chg="add mod topLvl">
          <ac:chgData name="Wigmore, Eleanor" userId="154496fa-10d7-4fd7-9fba-3614c367c37c" providerId="ADAL" clId="{AA3EDCC2-F595-42A0-8358-45CA77012066}" dt="2023-05-25T10:42:12.599" v="4672" actId="164"/>
          <ac:spMkLst>
            <pc:docMk/>
            <pc:sldMk cId="586963921" sldId="281"/>
            <ac:spMk id="30" creationId="{261064D9-7DC2-6BFE-45BF-FCD14FB1B223}"/>
          </ac:spMkLst>
        </pc:spChg>
        <pc:spChg chg="add del mod">
          <ac:chgData name="Wigmore, Eleanor" userId="154496fa-10d7-4fd7-9fba-3614c367c37c" providerId="ADAL" clId="{AA3EDCC2-F595-42A0-8358-45CA77012066}" dt="2023-05-19T14:50:46.323" v="1360"/>
          <ac:spMkLst>
            <pc:docMk/>
            <pc:sldMk cId="586963921" sldId="281"/>
            <ac:spMk id="30" creationId="{B80205DC-D904-8AA6-3096-C99BCD51B23D}"/>
          </ac:spMkLst>
        </pc:spChg>
        <pc:spChg chg="add del mod">
          <ac:chgData name="Wigmore, Eleanor" userId="154496fa-10d7-4fd7-9fba-3614c367c37c" providerId="ADAL" clId="{AA3EDCC2-F595-42A0-8358-45CA77012066}" dt="2023-05-23T13:12:18.083" v="2532"/>
          <ac:spMkLst>
            <pc:docMk/>
            <pc:sldMk cId="586963921" sldId="281"/>
            <ac:spMk id="31" creationId="{35BBF30F-9675-EFB7-A9E3-BF78368489D8}"/>
          </ac:spMkLst>
        </pc:spChg>
        <pc:spChg chg="add mod topLvl">
          <ac:chgData name="Wigmore, Eleanor" userId="154496fa-10d7-4fd7-9fba-3614c367c37c" providerId="ADAL" clId="{AA3EDCC2-F595-42A0-8358-45CA77012066}" dt="2023-05-25T10:42:12.599" v="4672" actId="164"/>
          <ac:spMkLst>
            <pc:docMk/>
            <pc:sldMk cId="586963921" sldId="281"/>
            <ac:spMk id="31" creationId="{9FBDC9B0-8718-8E17-21B2-A270BB72BE01}"/>
          </ac:spMkLst>
        </pc:spChg>
        <pc:spChg chg="add del mod">
          <ac:chgData name="Wigmore, Eleanor" userId="154496fa-10d7-4fd7-9fba-3614c367c37c" providerId="ADAL" clId="{AA3EDCC2-F595-42A0-8358-45CA77012066}" dt="2023-05-19T14:50:46.339" v="1365"/>
          <ac:spMkLst>
            <pc:docMk/>
            <pc:sldMk cId="586963921" sldId="281"/>
            <ac:spMk id="31" creationId="{E39131FF-360F-79C8-2FCF-917A56563175}"/>
          </ac:spMkLst>
        </pc:spChg>
        <pc:spChg chg="add mod topLvl">
          <ac:chgData name="Wigmore, Eleanor" userId="154496fa-10d7-4fd7-9fba-3614c367c37c" providerId="ADAL" clId="{AA3EDCC2-F595-42A0-8358-45CA77012066}" dt="2023-05-25T10:42:12.599" v="4672" actId="164"/>
          <ac:spMkLst>
            <pc:docMk/>
            <pc:sldMk cId="586963921" sldId="281"/>
            <ac:spMk id="32" creationId="{1D36CDE5-9353-03D3-DC71-AC56819DC359}"/>
          </ac:spMkLst>
        </pc:spChg>
        <pc:spChg chg="add del mod">
          <ac:chgData name="Wigmore, Eleanor" userId="154496fa-10d7-4fd7-9fba-3614c367c37c" providerId="ADAL" clId="{AA3EDCC2-F595-42A0-8358-45CA77012066}" dt="2023-05-23T13:12:18.097" v="2537"/>
          <ac:spMkLst>
            <pc:docMk/>
            <pc:sldMk cId="586963921" sldId="281"/>
            <ac:spMk id="32" creationId="{2522F676-5BCC-B58A-F169-C2B233FA4513}"/>
          </ac:spMkLst>
        </pc:spChg>
        <pc:spChg chg="add del mod">
          <ac:chgData name="Wigmore, Eleanor" userId="154496fa-10d7-4fd7-9fba-3614c367c37c" providerId="ADAL" clId="{AA3EDCC2-F595-42A0-8358-45CA77012066}" dt="2023-05-19T14:50:46.353" v="1370"/>
          <ac:spMkLst>
            <pc:docMk/>
            <pc:sldMk cId="586963921" sldId="281"/>
            <ac:spMk id="32" creationId="{A79EFD61-CA24-6E12-24AC-0C62FB85A3CA}"/>
          </ac:spMkLst>
        </pc:spChg>
        <pc:spChg chg="add del mod">
          <ac:chgData name="Wigmore, Eleanor" userId="154496fa-10d7-4fd7-9fba-3614c367c37c" providerId="ADAL" clId="{AA3EDCC2-F595-42A0-8358-45CA77012066}" dt="2023-05-24T11:10:37.798" v="2623" actId="478"/>
          <ac:spMkLst>
            <pc:docMk/>
            <pc:sldMk cId="586963921" sldId="281"/>
            <ac:spMk id="33" creationId="{7AA3560D-1CFB-6EE5-A9A3-D91F1FFBF56B}"/>
          </ac:spMkLst>
        </pc:spChg>
        <pc:spChg chg="add del mod">
          <ac:chgData name="Wigmore, Eleanor" userId="154496fa-10d7-4fd7-9fba-3614c367c37c" providerId="ADAL" clId="{AA3EDCC2-F595-42A0-8358-45CA77012066}" dt="2023-05-19T14:50:46.368" v="1375"/>
          <ac:spMkLst>
            <pc:docMk/>
            <pc:sldMk cId="586963921" sldId="281"/>
            <ac:spMk id="33" creationId="{9B8EBE4E-6724-5A92-EB0E-1A98C4CDAE2F}"/>
          </ac:spMkLst>
        </pc:spChg>
        <pc:spChg chg="add mod topLvl">
          <ac:chgData name="Wigmore, Eleanor" userId="154496fa-10d7-4fd7-9fba-3614c367c37c" providerId="ADAL" clId="{AA3EDCC2-F595-42A0-8358-45CA77012066}" dt="2023-05-25T10:42:12.599" v="4672" actId="164"/>
          <ac:spMkLst>
            <pc:docMk/>
            <pc:sldMk cId="586963921" sldId="281"/>
            <ac:spMk id="33" creationId="{D0682DED-3655-5BFC-F8CF-2DA0C0687E3E}"/>
          </ac:spMkLst>
        </pc:spChg>
        <pc:spChg chg="mod">
          <ac:chgData name="Wigmore, Eleanor" userId="154496fa-10d7-4fd7-9fba-3614c367c37c" providerId="ADAL" clId="{AA3EDCC2-F595-42A0-8358-45CA77012066}" dt="2023-05-11T12:28:16.552" v="12" actId="20577"/>
          <ac:spMkLst>
            <pc:docMk/>
            <pc:sldMk cId="586963921" sldId="281"/>
            <ac:spMk id="34" creationId="{17875CF9-229F-4130-AFEB-CDFD8B3CD650}"/>
          </ac:spMkLst>
        </pc:spChg>
        <pc:spChg chg="add mod topLvl">
          <ac:chgData name="Wigmore, Eleanor" userId="154496fa-10d7-4fd7-9fba-3614c367c37c" providerId="ADAL" clId="{AA3EDCC2-F595-42A0-8358-45CA77012066}" dt="2023-05-25T10:42:12.599" v="4672" actId="164"/>
          <ac:spMkLst>
            <pc:docMk/>
            <pc:sldMk cId="586963921" sldId="281"/>
            <ac:spMk id="36" creationId="{8161F8F3-3C9D-8AFB-B422-E80FB775F4CD}"/>
          </ac:spMkLst>
        </pc:spChg>
        <pc:spChg chg="add mod topLvl">
          <ac:chgData name="Wigmore, Eleanor" userId="154496fa-10d7-4fd7-9fba-3614c367c37c" providerId="ADAL" clId="{AA3EDCC2-F595-42A0-8358-45CA77012066}" dt="2023-05-25T10:42:12.599" v="4672" actId="164"/>
          <ac:spMkLst>
            <pc:docMk/>
            <pc:sldMk cId="586963921" sldId="281"/>
            <ac:spMk id="37" creationId="{EB35512A-BC0A-5E49-10B4-8A0DCFB18C88}"/>
          </ac:spMkLst>
        </pc:spChg>
        <pc:spChg chg="add del mod">
          <ac:chgData name="Wigmore, Eleanor" userId="154496fa-10d7-4fd7-9fba-3614c367c37c" providerId="ADAL" clId="{AA3EDCC2-F595-42A0-8358-45CA77012066}" dt="2023-05-19T14:56:37.807" v="1471"/>
          <ac:spMkLst>
            <pc:docMk/>
            <pc:sldMk cId="586963921" sldId="281"/>
            <ac:spMk id="38" creationId="{023A7AEF-70A6-78A9-F96B-6F057B65A48F}"/>
          </ac:spMkLst>
        </pc:spChg>
        <pc:spChg chg="add mod topLvl">
          <ac:chgData name="Wigmore, Eleanor" userId="154496fa-10d7-4fd7-9fba-3614c367c37c" providerId="ADAL" clId="{AA3EDCC2-F595-42A0-8358-45CA77012066}" dt="2023-05-25T10:42:12.599" v="4672" actId="164"/>
          <ac:spMkLst>
            <pc:docMk/>
            <pc:sldMk cId="586963921" sldId="281"/>
            <ac:spMk id="38" creationId="{6563A6D6-85F7-B698-7EC4-51473D5095FC}"/>
          </ac:spMkLst>
        </pc:spChg>
        <pc:spChg chg="add del mod">
          <ac:chgData name="Wigmore, Eleanor" userId="154496fa-10d7-4fd7-9fba-3614c367c37c" providerId="ADAL" clId="{AA3EDCC2-F595-42A0-8358-45CA77012066}" dt="2023-05-19T14:56:37.821" v="1476"/>
          <ac:spMkLst>
            <pc:docMk/>
            <pc:sldMk cId="586963921" sldId="281"/>
            <ac:spMk id="40" creationId="{A2D6F3F1-7C7D-5301-2696-3363AFF777D4}"/>
          </ac:spMkLst>
        </pc:spChg>
        <pc:spChg chg="add mod topLvl">
          <ac:chgData name="Wigmore, Eleanor" userId="154496fa-10d7-4fd7-9fba-3614c367c37c" providerId="ADAL" clId="{AA3EDCC2-F595-42A0-8358-45CA77012066}" dt="2023-05-25T10:42:12.599" v="4672" actId="164"/>
          <ac:spMkLst>
            <pc:docMk/>
            <pc:sldMk cId="586963921" sldId="281"/>
            <ac:spMk id="40" creationId="{AE298C17-AE3F-7E30-9D54-04DE96EF71DA}"/>
          </ac:spMkLst>
        </pc:spChg>
        <pc:spChg chg="add mod topLvl">
          <ac:chgData name="Wigmore, Eleanor" userId="154496fa-10d7-4fd7-9fba-3614c367c37c" providerId="ADAL" clId="{AA3EDCC2-F595-42A0-8358-45CA77012066}" dt="2023-05-25T10:42:12.599" v="4672" actId="164"/>
          <ac:spMkLst>
            <pc:docMk/>
            <pc:sldMk cId="586963921" sldId="281"/>
            <ac:spMk id="42" creationId="{8E46B175-084B-D195-E65C-73181F88C07B}"/>
          </ac:spMkLst>
        </pc:spChg>
        <pc:spChg chg="add mod topLvl">
          <ac:chgData name="Wigmore, Eleanor" userId="154496fa-10d7-4fd7-9fba-3614c367c37c" providerId="ADAL" clId="{AA3EDCC2-F595-42A0-8358-45CA77012066}" dt="2023-05-25T10:42:12.599" v="4672" actId="164"/>
          <ac:spMkLst>
            <pc:docMk/>
            <pc:sldMk cId="586963921" sldId="281"/>
            <ac:spMk id="43" creationId="{6274684B-5434-F6EB-5EF1-89FB92349D1E}"/>
          </ac:spMkLst>
        </pc:spChg>
        <pc:spChg chg="add mod topLvl">
          <ac:chgData name="Wigmore, Eleanor" userId="154496fa-10d7-4fd7-9fba-3614c367c37c" providerId="ADAL" clId="{AA3EDCC2-F595-42A0-8358-45CA77012066}" dt="2023-05-25T10:42:12.599" v="4672" actId="164"/>
          <ac:spMkLst>
            <pc:docMk/>
            <pc:sldMk cId="586963921" sldId="281"/>
            <ac:spMk id="44" creationId="{5EC6975A-23D9-6181-6336-12E72618D7FA}"/>
          </ac:spMkLst>
        </pc:spChg>
        <pc:spChg chg="add del mod">
          <ac:chgData name="Wigmore, Eleanor" userId="154496fa-10d7-4fd7-9fba-3614c367c37c" providerId="ADAL" clId="{AA3EDCC2-F595-42A0-8358-45CA77012066}" dt="2023-05-19T14:56:37.836" v="1481"/>
          <ac:spMkLst>
            <pc:docMk/>
            <pc:sldMk cId="586963921" sldId="281"/>
            <ac:spMk id="44" creationId="{AB4A7974-E990-47C6-C407-49AE69F96356}"/>
          </ac:spMkLst>
        </pc:spChg>
        <pc:spChg chg="add del mod">
          <ac:chgData name="Wigmore, Eleanor" userId="154496fa-10d7-4fd7-9fba-3614c367c37c" providerId="ADAL" clId="{AA3EDCC2-F595-42A0-8358-45CA77012066}" dt="2023-05-19T14:56:37.850" v="1486"/>
          <ac:spMkLst>
            <pc:docMk/>
            <pc:sldMk cId="586963921" sldId="281"/>
            <ac:spMk id="46" creationId="{58D9F56A-6BAE-59BA-1A0E-9A9228F7367F}"/>
          </ac:spMkLst>
        </pc:spChg>
        <pc:spChg chg="add mod topLvl">
          <ac:chgData name="Wigmore, Eleanor" userId="154496fa-10d7-4fd7-9fba-3614c367c37c" providerId="ADAL" clId="{AA3EDCC2-F595-42A0-8358-45CA77012066}" dt="2023-05-25T10:42:12.599" v="4672" actId="164"/>
          <ac:spMkLst>
            <pc:docMk/>
            <pc:sldMk cId="586963921" sldId="281"/>
            <ac:spMk id="47" creationId="{29A1A8B8-9506-242D-7C0A-BE19C81E5E90}"/>
          </ac:spMkLst>
        </pc:spChg>
        <pc:spChg chg="add del mod">
          <ac:chgData name="Wigmore, Eleanor" userId="154496fa-10d7-4fd7-9fba-3614c367c37c" providerId="ADAL" clId="{AA3EDCC2-F595-42A0-8358-45CA77012066}" dt="2023-05-19T14:56:37.870" v="1491"/>
          <ac:spMkLst>
            <pc:docMk/>
            <pc:sldMk cId="586963921" sldId="281"/>
            <ac:spMk id="47" creationId="{6100850C-D7B5-89C3-42F6-097B5E39CDF3}"/>
          </ac:spMkLst>
        </pc:spChg>
        <pc:spChg chg="mod">
          <ac:chgData name="Wigmore, Eleanor" userId="154496fa-10d7-4fd7-9fba-3614c367c37c" providerId="ADAL" clId="{AA3EDCC2-F595-42A0-8358-45CA77012066}" dt="2023-05-11T12:28:30.596" v="16" actId="1076"/>
          <ac:spMkLst>
            <pc:docMk/>
            <pc:sldMk cId="586963921" sldId="281"/>
            <ac:spMk id="48" creationId="{BD5A70AE-D167-4073-B87E-B94112D817E1}"/>
          </ac:spMkLst>
        </pc:spChg>
        <pc:spChg chg="add mod topLvl">
          <ac:chgData name="Wigmore, Eleanor" userId="154496fa-10d7-4fd7-9fba-3614c367c37c" providerId="ADAL" clId="{AA3EDCC2-F595-42A0-8358-45CA77012066}" dt="2023-05-25T10:40:40.234" v="4519" actId="165"/>
          <ac:spMkLst>
            <pc:docMk/>
            <pc:sldMk cId="586963921" sldId="281"/>
            <ac:spMk id="49" creationId="{137D68D8-730E-141D-5EB9-8E043E2527FA}"/>
          </ac:spMkLst>
        </pc:spChg>
        <pc:spChg chg="add del mod">
          <ac:chgData name="Wigmore, Eleanor" userId="154496fa-10d7-4fd7-9fba-3614c367c37c" providerId="ADAL" clId="{AA3EDCC2-F595-42A0-8358-45CA77012066}" dt="2023-05-19T14:56:37.883" v="1496"/>
          <ac:spMkLst>
            <pc:docMk/>
            <pc:sldMk cId="586963921" sldId="281"/>
            <ac:spMk id="49" creationId="{7EDDC51A-1A9E-A770-E8D2-7A94495E661A}"/>
          </ac:spMkLst>
        </pc:spChg>
        <pc:spChg chg="add del mod">
          <ac:chgData name="Wigmore, Eleanor" userId="154496fa-10d7-4fd7-9fba-3614c367c37c" providerId="ADAL" clId="{AA3EDCC2-F595-42A0-8358-45CA77012066}" dt="2023-05-19T14:56:37.897" v="1501"/>
          <ac:spMkLst>
            <pc:docMk/>
            <pc:sldMk cId="586963921" sldId="281"/>
            <ac:spMk id="50" creationId="{2B6B31A1-B469-16FD-077F-162CF8C2AE13}"/>
          </ac:spMkLst>
        </pc:spChg>
        <pc:spChg chg="add del mod">
          <ac:chgData name="Wigmore, Eleanor" userId="154496fa-10d7-4fd7-9fba-3614c367c37c" providerId="ADAL" clId="{AA3EDCC2-F595-42A0-8358-45CA77012066}" dt="2023-05-19T14:56:37.913" v="1506"/>
          <ac:spMkLst>
            <pc:docMk/>
            <pc:sldMk cId="586963921" sldId="281"/>
            <ac:spMk id="51" creationId="{69ABD540-50A6-4303-B926-FC18E89F9851}"/>
          </ac:spMkLst>
        </pc:spChg>
        <pc:spChg chg="add mod topLvl">
          <ac:chgData name="Wigmore, Eleanor" userId="154496fa-10d7-4fd7-9fba-3614c367c37c" providerId="ADAL" clId="{AA3EDCC2-F595-42A0-8358-45CA77012066}" dt="2023-05-25T10:42:12.599" v="4672" actId="164"/>
          <ac:spMkLst>
            <pc:docMk/>
            <pc:sldMk cId="586963921" sldId="281"/>
            <ac:spMk id="51" creationId="{ABCCA8E1-E08C-5D2F-5205-FA44FF47C6C0}"/>
          </ac:spMkLst>
        </pc:spChg>
        <pc:spChg chg="add del mod">
          <ac:chgData name="Wigmore, Eleanor" userId="154496fa-10d7-4fd7-9fba-3614c367c37c" providerId="ADAL" clId="{AA3EDCC2-F595-42A0-8358-45CA77012066}" dt="2023-05-19T14:56:37.926" v="1511"/>
          <ac:spMkLst>
            <pc:docMk/>
            <pc:sldMk cId="586963921" sldId="281"/>
            <ac:spMk id="52" creationId="{19FE34BB-D562-82C2-895E-13C9010659A3}"/>
          </ac:spMkLst>
        </pc:spChg>
        <pc:spChg chg="add mod topLvl">
          <ac:chgData name="Wigmore, Eleanor" userId="154496fa-10d7-4fd7-9fba-3614c367c37c" providerId="ADAL" clId="{AA3EDCC2-F595-42A0-8358-45CA77012066}" dt="2023-05-25T10:42:12.599" v="4672" actId="164"/>
          <ac:spMkLst>
            <pc:docMk/>
            <pc:sldMk cId="586963921" sldId="281"/>
            <ac:spMk id="52" creationId="{227ADC6A-24D2-365D-62FC-BE21FC027611}"/>
          </ac:spMkLst>
        </pc:spChg>
        <pc:spChg chg="add mod topLvl">
          <ac:chgData name="Wigmore, Eleanor" userId="154496fa-10d7-4fd7-9fba-3614c367c37c" providerId="ADAL" clId="{AA3EDCC2-F595-42A0-8358-45CA77012066}" dt="2023-05-25T10:42:12.599" v="4672" actId="164"/>
          <ac:spMkLst>
            <pc:docMk/>
            <pc:sldMk cId="586963921" sldId="281"/>
            <ac:spMk id="53" creationId="{6069BB7F-0855-E925-71E7-1A7415392391}"/>
          </ac:spMkLst>
        </pc:spChg>
        <pc:spChg chg="add del mod">
          <ac:chgData name="Wigmore, Eleanor" userId="154496fa-10d7-4fd7-9fba-3614c367c37c" providerId="ADAL" clId="{AA3EDCC2-F595-42A0-8358-45CA77012066}" dt="2023-05-19T14:56:37.940" v="1516"/>
          <ac:spMkLst>
            <pc:docMk/>
            <pc:sldMk cId="586963921" sldId="281"/>
            <ac:spMk id="53" creationId="{B4DA71D6-6BDE-75EC-3ABD-963597B7733C}"/>
          </ac:spMkLst>
        </pc:spChg>
        <pc:spChg chg="add mod topLvl">
          <ac:chgData name="Wigmore, Eleanor" userId="154496fa-10d7-4fd7-9fba-3614c367c37c" providerId="ADAL" clId="{AA3EDCC2-F595-42A0-8358-45CA77012066}" dt="2023-05-25T10:42:12.599" v="4672" actId="164"/>
          <ac:spMkLst>
            <pc:docMk/>
            <pc:sldMk cId="586963921" sldId="281"/>
            <ac:spMk id="54" creationId="{DABAA319-9CCD-4CF5-4D1E-1BDBF4C90EBE}"/>
          </ac:spMkLst>
        </pc:spChg>
        <pc:spChg chg="add mod topLvl">
          <ac:chgData name="Wigmore, Eleanor" userId="154496fa-10d7-4fd7-9fba-3614c367c37c" providerId="ADAL" clId="{AA3EDCC2-F595-42A0-8358-45CA77012066}" dt="2023-05-25T10:42:12.599" v="4672" actId="164"/>
          <ac:spMkLst>
            <pc:docMk/>
            <pc:sldMk cId="586963921" sldId="281"/>
            <ac:spMk id="55" creationId="{A2814B99-EA86-70E2-32DB-E496F31DDFC4}"/>
          </ac:spMkLst>
        </pc:spChg>
        <pc:spChg chg="add mod topLvl">
          <ac:chgData name="Wigmore, Eleanor" userId="154496fa-10d7-4fd7-9fba-3614c367c37c" providerId="ADAL" clId="{AA3EDCC2-F595-42A0-8358-45CA77012066}" dt="2023-05-25T10:42:12.599" v="4672" actId="164"/>
          <ac:spMkLst>
            <pc:docMk/>
            <pc:sldMk cId="586963921" sldId="281"/>
            <ac:spMk id="56" creationId="{13C8D3D0-70D5-9754-0358-9836D5D78711}"/>
          </ac:spMkLst>
        </pc:spChg>
        <pc:spChg chg="add mod topLvl">
          <ac:chgData name="Wigmore, Eleanor" userId="154496fa-10d7-4fd7-9fba-3614c367c37c" providerId="ADAL" clId="{AA3EDCC2-F595-42A0-8358-45CA77012066}" dt="2023-05-25T10:42:12.599" v="4672" actId="164"/>
          <ac:spMkLst>
            <pc:docMk/>
            <pc:sldMk cId="586963921" sldId="281"/>
            <ac:spMk id="57" creationId="{86DD92B8-7F51-0FB2-CFDB-6478974C0886}"/>
          </ac:spMkLst>
        </pc:spChg>
        <pc:spChg chg="add mod topLvl">
          <ac:chgData name="Wigmore, Eleanor" userId="154496fa-10d7-4fd7-9fba-3614c367c37c" providerId="ADAL" clId="{AA3EDCC2-F595-42A0-8358-45CA77012066}" dt="2023-05-25T10:42:12.599" v="4672" actId="164"/>
          <ac:spMkLst>
            <pc:docMk/>
            <pc:sldMk cId="586963921" sldId="281"/>
            <ac:spMk id="58" creationId="{5ED00D7C-18D9-9847-64F4-8D4DFA3F1B3B}"/>
          </ac:spMkLst>
        </pc:spChg>
        <pc:spChg chg="add mod topLvl">
          <ac:chgData name="Wigmore, Eleanor" userId="154496fa-10d7-4fd7-9fba-3614c367c37c" providerId="ADAL" clId="{AA3EDCC2-F595-42A0-8358-45CA77012066}" dt="2023-05-25T10:42:12.599" v="4672" actId="164"/>
          <ac:spMkLst>
            <pc:docMk/>
            <pc:sldMk cId="586963921" sldId="281"/>
            <ac:spMk id="59" creationId="{951D4D6B-00FD-D6BB-753E-61D4FA0CF0A0}"/>
          </ac:spMkLst>
        </pc:spChg>
        <pc:spChg chg="add mod topLvl">
          <ac:chgData name="Wigmore, Eleanor" userId="154496fa-10d7-4fd7-9fba-3614c367c37c" providerId="ADAL" clId="{AA3EDCC2-F595-42A0-8358-45CA77012066}" dt="2023-05-25T10:42:12.599" v="4672" actId="164"/>
          <ac:spMkLst>
            <pc:docMk/>
            <pc:sldMk cId="586963921" sldId="281"/>
            <ac:spMk id="60" creationId="{554F98E0-C4A8-448A-92A7-5AAE18333512}"/>
          </ac:spMkLst>
        </pc:spChg>
        <pc:spChg chg="add mod topLvl">
          <ac:chgData name="Wigmore, Eleanor" userId="154496fa-10d7-4fd7-9fba-3614c367c37c" providerId="ADAL" clId="{AA3EDCC2-F595-42A0-8358-45CA77012066}" dt="2023-05-25T10:42:12.599" v="4672" actId="164"/>
          <ac:spMkLst>
            <pc:docMk/>
            <pc:sldMk cId="586963921" sldId="281"/>
            <ac:spMk id="61" creationId="{53FDFB7F-DB97-DA9A-FC2D-EDDABF3DA493}"/>
          </ac:spMkLst>
        </pc:spChg>
        <pc:spChg chg="add mod topLvl">
          <ac:chgData name="Wigmore, Eleanor" userId="154496fa-10d7-4fd7-9fba-3614c367c37c" providerId="ADAL" clId="{AA3EDCC2-F595-42A0-8358-45CA77012066}" dt="2023-05-25T10:42:12.599" v="4672" actId="164"/>
          <ac:spMkLst>
            <pc:docMk/>
            <pc:sldMk cId="586963921" sldId="281"/>
            <ac:spMk id="62" creationId="{4F543CA4-0E19-3C02-2948-D3934D9A406F}"/>
          </ac:spMkLst>
        </pc:spChg>
        <pc:spChg chg="add mod topLvl">
          <ac:chgData name="Wigmore, Eleanor" userId="154496fa-10d7-4fd7-9fba-3614c367c37c" providerId="ADAL" clId="{AA3EDCC2-F595-42A0-8358-45CA77012066}" dt="2023-05-25T10:42:12.599" v="4672" actId="164"/>
          <ac:spMkLst>
            <pc:docMk/>
            <pc:sldMk cId="586963921" sldId="281"/>
            <ac:spMk id="63" creationId="{B8C71091-1BCA-7618-F1B5-6542802C983E}"/>
          </ac:spMkLst>
        </pc:spChg>
        <pc:spChg chg="add mod topLvl">
          <ac:chgData name="Wigmore, Eleanor" userId="154496fa-10d7-4fd7-9fba-3614c367c37c" providerId="ADAL" clId="{AA3EDCC2-F595-42A0-8358-45CA77012066}" dt="2023-05-25T10:42:12.599" v="4672" actId="164"/>
          <ac:spMkLst>
            <pc:docMk/>
            <pc:sldMk cId="586963921" sldId="281"/>
            <ac:spMk id="64" creationId="{DAB4BD61-FDE6-C05F-E557-EB663E7132DA}"/>
          </ac:spMkLst>
        </pc:spChg>
        <pc:spChg chg="add mod topLvl">
          <ac:chgData name="Wigmore, Eleanor" userId="154496fa-10d7-4fd7-9fba-3614c367c37c" providerId="ADAL" clId="{AA3EDCC2-F595-42A0-8358-45CA77012066}" dt="2023-05-25T10:42:12.599" v="4672" actId="164"/>
          <ac:spMkLst>
            <pc:docMk/>
            <pc:sldMk cId="586963921" sldId="281"/>
            <ac:spMk id="65" creationId="{7C5AEF67-0DAF-DB22-A922-00C7D9CA5C83}"/>
          </ac:spMkLst>
        </pc:spChg>
        <pc:spChg chg="add mod topLvl">
          <ac:chgData name="Wigmore, Eleanor" userId="154496fa-10d7-4fd7-9fba-3614c367c37c" providerId="ADAL" clId="{AA3EDCC2-F595-42A0-8358-45CA77012066}" dt="2023-05-25T10:42:12.599" v="4672" actId="164"/>
          <ac:spMkLst>
            <pc:docMk/>
            <pc:sldMk cId="586963921" sldId="281"/>
            <ac:spMk id="67" creationId="{40F48905-5EE5-2EE8-9095-2055EA3CD53A}"/>
          </ac:spMkLst>
        </pc:spChg>
        <pc:spChg chg="mod">
          <ac:chgData name="Wigmore, Eleanor" userId="154496fa-10d7-4fd7-9fba-3614c367c37c" providerId="ADAL" clId="{AA3EDCC2-F595-42A0-8358-45CA77012066}" dt="2023-05-11T13:13:32.178" v="241" actId="20577"/>
          <ac:spMkLst>
            <pc:docMk/>
            <pc:sldMk cId="586963921" sldId="281"/>
            <ac:spMk id="68" creationId="{7726A3AF-3BD0-43A2-BD9E-0C1328287638}"/>
          </ac:spMkLst>
        </pc:spChg>
        <pc:spChg chg="add mod topLvl">
          <ac:chgData name="Wigmore, Eleanor" userId="154496fa-10d7-4fd7-9fba-3614c367c37c" providerId="ADAL" clId="{AA3EDCC2-F595-42A0-8358-45CA77012066}" dt="2023-05-25T10:42:12.599" v="4672" actId="164"/>
          <ac:spMkLst>
            <pc:docMk/>
            <pc:sldMk cId="586963921" sldId="281"/>
            <ac:spMk id="69" creationId="{29BEE4F0-C378-75CC-F243-7CFBE82DA5B0}"/>
          </ac:spMkLst>
        </pc:spChg>
        <pc:spChg chg="add mod topLvl">
          <ac:chgData name="Wigmore, Eleanor" userId="154496fa-10d7-4fd7-9fba-3614c367c37c" providerId="ADAL" clId="{AA3EDCC2-F595-42A0-8358-45CA77012066}" dt="2023-05-25T10:42:12.599" v="4672" actId="164"/>
          <ac:spMkLst>
            <pc:docMk/>
            <pc:sldMk cId="586963921" sldId="281"/>
            <ac:spMk id="70" creationId="{893CE269-BF2F-7A19-BD8E-328BB3FEDF82}"/>
          </ac:spMkLst>
        </pc:spChg>
        <pc:spChg chg="add mod topLvl">
          <ac:chgData name="Wigmore, Eleanor" userId="154496fa-10d7-4fd7-9fba-3614c367c37c" providerId="ADAL" clId="{AA3EDCC2-F595-42A0-8358-45CA77012066}" dt="2023-05-25T10:42:12.599" v="4672" actId="164"/>
          <ac:spMkLst>
            <pc:docMk/>
            <pc:sldMk cId="586963921" sldId="281"/>
            <ac:spMk id="71" creationId="{16B436CF-AAFD-24EB-D91B-F560FCE1899A}"/>
          </ac:spMkLst>
        </pc:spChg>
        <pc:spChg chg="add mod topLvl">
          <ac:chgData name="Wigmore, Eleanor" userId="154496fa-10d7-4fd7-9fba-3614c367c37c" providerId="ADAL" clId="{AA3EDCC2-F595-42A0-8358-45CA77012066}" dt="2023-05-25T10:42:12.599" v="4672" actId="164"/>
          <ac:spMkLst>
            <pc:docMk/>
            <pc:sldMk cId="586963921" sldId="281"/>
            <ac:spMk id="72" creationId="{D45B16A3-DF58-408B-EE35-F03CC78C0D77}"/>
          </ac:spMkLst>
        </pc:spChg>
        <pc:spChg chg="add mod topLvl">
          <ac:chgData name="Wigmore, Eleanor" userId="154496fa-10d7-4fd7-9fba-3614c367c37c" providerId="ADAL" clId="{AA3EDCC2-F595-42A0-8358-45CA77012066}" dt="2023-05-25T10:42:12.599" v="4672" actId="164"/>
          <ac:spMkLst>
            <pc:docMk/>
            <pc:sldMk cId="586963921" sldId="281"/>
            <ac:spMk id="73" creationId="{A605B64C-ED94-5C21-5D76-9B199C17BBAE}"/>
          </ac:spMkLst>
        </pc:spChg>
        <pc:spChg chg="add mod topLvl">
          <ac:chgData name="Wigmore, Eleanor" userId="154496fa-10d7-4fd7-9fba-3614c367c37c" providerId="ADAL" clId="{AA3EDCC2-F595-42A0-8358-45CA77012066}" dt="2023-05-25T10:42:12.599" v="4672" actId="164"/>
          <ac:spMkLst>
            <pc:docMk/>
            <pc:sldMk cId="586963921" sldId="281"/>
            <ac:spMk id="74" creationId="{A2BA9CC7-2741-1B2D-3CC2-E14938BDBBC8}"/>
          </ac:spMkLst>
        </pc:spChg>
        <pc:spChg chg="add mod topLvl">
          <ac:chgData name="Wigmore, Eleanor" userId="154496fa-10d7-4fd7-9fba-3614c367c37c" providerId="ADAL" clId="{AA3EDCC2-F595-42A0-8358-45CA77012066}" dt="2023-05-25T10:42:12.599" v="4672" actId="164"/>
          <ac:spMkLst>
            <pc:docMk/>
            <pc:sldMk cId="586963921" sldId="281"/>
            <ac:spMk id="75" creationId="{D65F2A96-67E5-E519-7184-2C0C5D132375}"/>
          </ac:spMkLst>
        </pc:spChg>
        <pc:spChg chg="add mod topLvl">
          <ac:chgData name="Wigmore, Eleanor" userId="154496fa-10d7-4fd7-9fba-3614c367c37c" providerId="ADAL" clId="{AA3EDCC2-F595-42A0-8358-45CA77012066}" dt="2023-05-25T10:42:12.599" v="4672" actId="164"/>
          <ac:spMkLst>
            <pc:docMk/>
            <pc:sldMk cId="586963921" sldId="281"/>
            <ac:spMk id="76" creationId="{F68FC33F-FB67-F7CC-3033-98FD669B29B3}"/>
          </ac:spMkLst>
        </pc:spChg>
        <pc:spChg chg="add mod topLvl">
          <ac:chgData name="Wigmore, Eleanor" userId="154496fa-10d7-4fd7-9fba-3614c367c37c" providerId="ADAL" clId="{AA3EDCC2-F595-42A0-8358-45CA77012066}" dt="2023-05-25T10:42:12.599" v="4672" actId="164"/>
          <ac:spMkLst>
            <pc:docMk/>
            <pc:sldMk cId="586963921" sldId="281"/>
            <ac:spMk id="77" creationId="{BB3B8F59-45A2-2875-FA33-91302560AD3C}"/>
          </ac:spMkLst>
        </pc:spChg>
        <pc:spChg chg="add mod topLvl">
          <ac:chgData name="Wigmore, Eleanor" userId="154496fa-10d7-4fd7-9fba-3614c367c37c" providerId="ADAL" clId="{AA3EDCC2-F595-42A0-8358-45CA77012066}" dt="2023-05-25T10:42:12.599" v="4672" actId="164"/>
          <ac:spMkLst>
            <pc:docMk/>
            <pc:sldMk cId="586963921" sldId="281"/>
            <ac:spMk id="78" creationId="{97CE8BBB-8B23-38A0-1430-89840E544CA6}"/>
          </ac:spMkLst>
        </pc:spChg>
        <pc:spChg chg="add mod topLvl">
          <ac:chgData name="Wigmore, Eleanor" userId="154496fa-10d7-4fd7-9fba-3614c367c37c" providerId="ADAL" clId="{AA3EDCC2-F595-42A0-8358-45CA77012066}" dt="2023-05-25T10:42:12.599" v="4672" actId="164"/>
          <ac:spMkLst>
            <pc:docMk/>
            <pc:sldMk cId="586963921" sldId="281"/>
            <ac:spMk id="79" creationId="{C5598F3B-272E-DE99-636C-6D4200EE10F9}"/>
          </ac:spMkLst>
        </pc:spChg>
        <pc:spChg chg="add mod topLvl">
          <ac:chgData name="Wigmore, Eleanor" userId="154496fa-10d7-4fd7-9fba-3614c367c37c" providerId="ADAL" clId="{AA3EDCC2-F595-42A0-8358-45CA77012066}" dt="2023-05-25T10:42:12.599" v="4672" actId="164"/>
          <ac:spMkLst>
            <pc:docMk/>
            <pc:sldMk cId="586963921" sldId="281"/>
            <ac:spMk id="80" creationId="{84FE0238-9615-127E-417C-9AB9AF8A4E9E}"/>
          </ac:spMkLst>
        </pc:spChg>
        <pc:spChg chg="add mod topLvl">
          <ac:chgData name="Wigmore, Eleanor" userId="154496fa-10d7-4fd7-9fba-3614c367c37c" providerId="ADAL" clId="{AA3EDCC2-F595-42A0-8358-45CA77012066}" dt="2023-05-25T10:42:12.599" v="4672" actId="164"/>
          <ac:spMkLst>
            <pc:docMk/>
            <pc:sldMk cId="586963921" sldId="281"/>
            <ac:spMk id="81" creationId="{1E84C544-406A-26FC-231D-3A520348417A}"/>
          </ac:spMkLst>
        </pc:spChg>
        <pc:spChg chg="add mod topLvl">
          <ac:chgData name="Wigmore, Eleanor" userId="154496fa-10d7-4fd7-9fba-3614c367c37c" providerId="ADAL" clId="{AA3EDCC2-F595-42A0-8358-45CA77012066}" dt="2023-05-25T10:41:18.503" v="4666" actId="1038"/>
          <ac:spMkLst>
            <pc:docMk/>
            <pc:sldMk cId="586963921" sldId="281"/>
            <ac:spMk id="82" creationId="{935DC64D-7533-3DC2-81E2-E20ED0A7F919}"/>
          </ac:spMkLst>
        </pc:spChg>
        <pc:spChg chg="add del mod">
          <ac:chgData name="Wigmore, Eleanor" userId="154496fa-10d7-4fd7-9fba-3614c367c37c" providerId="ADAL" clId="{AA3EDCC2-F595-42A0-8358-45CA77012066}" dt="2023-05-25T10:20:13.171" v="4256" actId="478"/>
          <ac:spMkLst>
            <pc:docMk/>
            <pc:sldMk cId="586963921" sldId="281"/>
            <ac:spMk id="86" creationId="{EEB6BE86-4632-D857-0D0D-9D55819CE1EA}"/>
          </ac:spMkLst>
        </pc:spChg>
        <pc:spChg chg="add mod topLvl">
          <ac:chgData name="Wigmore, Eleanor" userId="154496fa-10d7-4fd7-9fba-3614c367c37c" providerId="ADAL" clId="{AA3EDCC2-F595-42A0-8358-45CA77012066}" dt="2023-05-25T10:42:01.797" v="4671" actId="164"/>
          <ac:spMkLst>
            <pc:docMk/>
            <pc:sldMk cId="586963921" sldId="281"/>
            <ac:spMk id="87" creationId="{452831E9-214D-2C45-2880-AB693C25CDDD}"/>
          </ac:spMkLst>
        </pc:spChg>
        <pc:spChg chg="add mod topLvl">
          <ac:chgData name="Wigmore, Eleanor" userId="154496fa-10d7-4fd7-9fba-3614c367c37c" providerId="ADAL" clId="{AA3EDCC2-F595-42A0-8358-45CA77012066}" dt="2023-05-25T10:42:01.797" v="4671" actId="164"/>
          <ac:spMkLst>
            <pc:docMk/>
            <pc:sldMk cId="586963921" sldId="281"/>
            <ac:spMk id="88" creationId="{2CCE014E-F476-6EB3-9080-139D4EB8D369}"/>
          </ac:spMkLst>
        </pc:spChg>
        <pc:spChg chg="add mod topLvl">
          <ac:chgData name="Wigmore, Eleanor" userId="154496fa-10d7-4fd7-9fba-3614c367c37c" providerId="ADAL" clId="{AA3EDCC2-F595-42A0-8358-45CA77012066}" dt="2023-05-25T10:42:01.797" v="4671" actId="164"/>
          <ac:spMkLst>
            <pc:docMk/>
            <pc:sldMk cId="586963921" sldId="281"/>
            <ac:spMk id="89" creationId="{F1CE1B33-D451-CA31-1819-2FB68EF4C26C}"/>
          </ac:spMkLst>
        </pc:spChg>
        <pc:spChg chg="add mod topLvl">
          <ac:chgData name="Wigmore, Eleanor" userId="154496fa-10d7-4fd7-9fba-3614c367c37c" providerId="ADAL" clId="{AA3EDCC2-F595-42A0-8358-45CA77012066}" dt="2023-05-25T10:42:01.797" v="4671" actId="164"/>
          <ac:spMkLst>
            <pc:docMk/>
            <pc:sldMk cId="586963921" sldId="281"/>
            <ac:spMk id="90" creationId="{F0867E8F-3863-CE23-6B51-C92A5ED3F66F}"/>
          </ac:spMkLst>
        </pc:spChg>
        <pc:spChg chg="add mod topLvl">
          <ac:chgData name="Wigmore, Eleanor" userId="154496fa-10d7-4fd7-9fba-3614c367c37c" providerId="ADAL" clId="{AA3EDCC2-F595-42A0-8358-45CA77012066}" dt="2023-05-25T10:42:01.797" v="4671" actId="164"/>
          <ac:spMkLst>
            <pc:docMk/>
            <pc:sldMk cId="586963921" sldId="281"/>
            <ac:spMk id="91" creationId="{83C3855B-2A2B-E4AF-5835-3C2CDA0D76E3}"/>
          </ac:spMkLst>
        </pc:spChg>
        <pc:spChg chg="add mod topLvl">
          <ac:chgData name="Wigmore, Eleanor" userId="154496fa-10d7-4fd7-9fba-3614c367c37c" providerId="ADAL" clId="{AA3EDCC2-F595-42A0-8358-45CA77012066}" dt="2023-05-25T10:42:01.797" v="4671" actId="164"/>
          <ac:spMkLst>
            <pc:docMk/>
            <pc:sldMk cId="586963921" sldId="281"/>
            <ac:spMk id="92" creationId="{E1766B07-73E3-2D8E-7B78-BA3BFBDB9FAD}"/>
          </ac:spMkLst>
        </pc:spChg>
        <pc:spChg chg="add mod topLvl">
          <ac:chgData name="Wigmore, Eleanor" userId="154496fa-10d7-4fd7-9fba-3614c367c37c" providerId="ADAL" clId="{AA3EDCC2-F595-42A0-8358-45CA77012066}" dt="2023-05-25T10:42:01.797" v="4671" actId="164"/>
          <ac:spMkLst>
            <pc:docMk/>
            <pc:sldMk cId="586963921" sldId="281"/>
            <ac:spMk id="93" creationId="{B18D5583-C8CC-5BA8-1087-FAD1AC2F3F6C}"/>
          </ac:spMkLst>
        </pc:spChg>
        <pc:spChg chg="add mod topLvl">
          <ac:chgData name="Wigmore, Eleanor" userId="154496fa-10d7-4fd7-9fba-3614c367c37c" providerId="ADAL" clId="{AA3EDCC2-F595-42A0-8358-45CA77012066}" dt="2023-05-25T10:42:01.797" v="4671" actId="164"/>
          <ac:spMkLst>
            <pc:docMk/>
            <pc:sldMk cId="586963921" sldId="281"/>
            <ac:spMk id="94" creationId="{3DAAA66D-2452-AC13-249C-7103D14C37B9}"/>
          </ac:spMkLst>
        </pc:spChg>
        <pc:spChg chg="add mod topLvl">
          <ac:chgData name="Wigmore, Eleanor" userId="154496fa-10d7-4fd7-9fba-3614c367c37c" providerId="ADAL" clId="{AA3EDCC2-F595-42A0-8358-45CA77012066}" dt="2023-05-25T10:42:01.797" v="4671" actId="164"/>
          <ac:spMkLst>
            <pc:docMk/>
            <pc:sldMk cId="586963921" sldId="281"/>
            <ac:spMk id="95" creationId="{88E1C7C9-825A-213E-0F3D-A6760CC0FF8C}"/>
          </ac:spMkLst>
        </pc:spChg>
        <pc:spChg chg="add mod topLvl">
          <ac:chgData name="Wigmore, Eleanor" userId="154496fa-10d7-4fd7-9fba-3614c367c37c" providerId="ADAL" clId="{AA3EDCC2-F595-42A0-8358-45CA77012066}" dt="2023-05-25T10:42:01.797" v="4671" actId="164"/>
          <ac:spMkLst>
            <pc:docMk/>
            <pc:sldMk cId="586963921" sldId="281"/>
            <ac:spMk id="96" creationId="{8CDB1AD6-4F42-C17C-604D-970726E74AE3}"/>
          </ac:spMkLst>
        </pc:spChg>
        <pc:spChg chg="add mod topLvl">
          <ac:chgData name="Wigmore, Eleanor" userId="154496fa-10d7-4fd7-9fba-3614c367c37c" providerId="ADAL" clId="{AA3EDCC2-F595-42A0-8358-45CA77012066}" dt="2023-05-25T10:42:01.797" v="4671" actId="164"/>
          <ac:spMkLst>
            <pc:docMk/>
            <pc:sldMk cId="586963921" sldId="281"/>
            <ac:spMk id="97" creationId="{8E6FB051-A944-9351-7BA8-F45573071C0E}"/>
          </ac:spMkLst>
        </pc:spChg>
        <pc:spChg chg="add mod topLvl">
          <ac:chgData name="Wigmore, Eleanor" userId="154496fa-10d7-4fd7-9fba-3614c367c37c" providerId="ADAL" clId="{AA3EDCC2-F595-42A0-8358-45CA77012066}" dt="2023-05-25T10:42:01.797" v="4671" actId="164"/>
          <ac:spMkLst>
            <pc:docMk/>
            <pc:sldMk cId="586963921" sldId="281"/>
            <ac:spMk id="98" creationId="{C78DC336-C294-FFEC-8CAA-F865A1732210}"/>
          </ac:spMkLst>
        </pc:spChg>
        <pc:spChg chg="add mod topLvl">
          <ac:chgData name="Wigmore, Eleanor" userId="154496fa-10d7-4fd7-9fba-3614c367c37c" providerId="ADAL" clId="{AA3EDCC2-F595-42A0-8358-45CA77012066}" dt="2023-05-25T10:42:01.797" v="4671" actId="164"/>
          <ac:spMkLst>
            <pc:docMk/>
            <pc:sldMk cId="586963921" sldId="281"/>
            <ac:spMk id="99" creationId="{715C0095-73ED-5127-160F-1B8125737970}"/>
          </ac:spMkLst>
        </pc:spChg>
        <pc:spChg chg="add mod topLvl">
          <ac:chgData name="Wigmore, Eleanor" userId="154496fa-10d7-4fd7-9fba-3614c367c37c" providerId="ADAL" clId="{AA3EDCC2-F595-42A0-8358-45CA77012066}" dt="2023-05-25T10:42:01.797" v="4671" actId="164"/>
          <ac:spMkLst>
            <pc:docMk/>
            <pc:sldMk cId="586963921" sldId="281"/>
            <ac:spMk id="100" creationId="{8405AD00-5A7D-AF52-4530-DAF3BDF3257C}"/>
          </ac:spMkLst>
        </pc:spChg>
        <pc:spChg chg="add mod topLvl">
          <ac:chgData name="Wigmore, Eleanor" userId="154496fa-10d7-4fd7-9fba-3614c367c37c" providerId="ADAL" clId="{AA3EDCC2-F595-42A0-8358-45CA77012066}" dt="2023-05-25T10:42:01.797" v="4671" actId="164"/>
          <ac:spMkLst>
            <pc:docMk/>
            <pc:sldMk cId="586963921" sldId="281"/>
            <ac:spMk id="101" creationId="{44A38DEE-6DBC-8823-3722-68B518075F31}"/>
          </ac:spMkLst>
        </pc:spChg>
        <pc:spChg chg="add mod topLvl">
          <ac:chgData name="Wigmore, Eleanor" userId="154496fa-10d7-4fd7-9fba-3614c367c37c" providerId="ADAL" clId="{AA3EDCC2-F595-42A0-8358-45CA77012066}" dt="2023-05-25T10:42:01.797" v="4671" actId="164"/>
          <ac:spMkLst>
            <pc:docMk/>
            <pc:sldMk cId="586963921" sldId="281"/>
            <ac:spMk id="102" creationId="{15DE890D-CDFA-63AF-4BE8-CFD66218DF38}"/>
          </ac:spMkLst>
        </pc:spChg>
        <pc:spChg chg="add mod topLvl">
          <ac:chgData name="Wigmore, Eleanor" userId="154496fa-10d7-4fd7-9fba-3614c367c37c" providerId="ADAL" clId="{AA3EDCC2-F595-42A0-8358-45CA77012066}" dt="2023-05-25T10:42:01.797" v="4671" actId="164"/>
          <ac:spMkLst>
            <pc:docMk/>
            <pc:sldMk cId="586963921" sldId="281"/>
            <ac:spMk id="103" creationId="{B18E0685-B983-E68A-DE73-3B39CE34AB12}"/>
          </ac:spMkLst>
        </pc:spChg>
        <pc:spChg chg="add mod topLvl">
          <ac:chgData name="Wigmore, Eleanor" userId="154496fa-10d7-4fd7-9fba-3614c367c37c" providerId="ADAL" clId="{AA3EDCC2-F595-42A0-8358-45CA77012066}" dt="2023-05-25T10:42:01.797" v="4671" actId="164"/>
          <ac:spMkLst>
            <pc:docMk/>
            <pc:sldMk cId="586963921" sldId="281"/>
            <ac:spMk id="104" creationId="{C9277098-EC1B-A084-0230-1B88E8826744}"/>
          </ac:spMkLst>
        </pc:spChg>
        <pc:spChg chg="add mod topLvl">
          <ac:chgData name="Wigmore, Eleanor" userId="154496fa-10d7-4fd7-9fba-3614c367c37c" providerId="ADAL" clId="{AA3EDCC2-F595-42A0-8358-45CA77012066}" dt="2023-05-25T10:42:01.797" v="4671" actId="164"/>
          <ac:spMkLst>
            <pc:docMk/>
            <pc:sldMk cId="586963921" sldId="281"/>
            <ac:spMk id="105" creationId="{6851AB40-9BAC-CE65-F422-BD364D075FFD}"/>
          </ac:spMkLst>
        </pc:spChg>
        <pc:spChg chg="add mod topLvl">
          <ac:chgData name="Wigmore, Eleanor" userId="154496fa-10d7-4fd7-9fba-3614c367c37c" providerId="ADAL" clId="{AA3EDCC2-F595-42A0-8358-45CA77012066}" dt="2023-05-25T10:42:01.797" v="4671" actId="164"/>
          <ac:spMkLst>
            <pc:docMk/>
            <pc:sldMk cId="586963921" sldId="281"/>
            <ac:spMk id="106" creationId="{1EE3ECE1-150F-3D4E-683F-722B6A11DB41}"/>
          </ac:spMkLst>
        </pc:spChg>
        <pc:spChg chg="add mod topLvl">
          <ac:chgData name="Wigmore, Eleanor" userId="154496fa-10d7-4fd7-9fba-3614c367c37c" providerId="ADAL" clId="{AA3EDCC2-F595-42A0-8358-45CA77012066}" dt="2023-05-25T10:42:01.797" v="4671" actId="164"/>
          <ac:spMkLst>
            <pc:docMk/>
            <pc:sldMk cId="586963921" sldId="281"/>
            <ac:spMk id="107" creationId="{C8CB3B1C-3857-E505-ABCA-66A2FE8B14EC}"/>
          </ac:spMkLst>
        </pc:spChg>
        <pc:spChg chg="add mod topLvl">
          <ac:chgData name="Wigmore, Eleanor" userId="154496fa-10d7-4fd7-9fba-3614c367c37c" providerId="ADAL" clId="{AA3EDCC2-F595-42A0-8358-45CA77012066}" dt="2023-05-25T10:42:01.797" v="4671" actId="164"/>
          <ac:spMkLst>
            <pc:docMk/>
            <pc:sldMk cId="586963921" sldId="281"/>
            <ac:spMk id="108" creationId="{A33172EC-D170-59C7-23AF-A811454E7824}"/>
          </ac:spMkLst>
        </pc:spChg>
        <pc:spChg chg="add mod topLvl">
          <ac:chgData name="Wigmore, Eleanor" userId="154496fa-10d7-4fd7-9fba-3614c367c37c" providerId="ADAL" clId="{AA3EDCC2-F595-42A0-8358-45CA77012066}" dt="2023-05-25T10:42:01.797" v="4671" actId="164"/>
          <ac:spMkLst>
            <pc:docMk/>
            <pc:sldMk cId="586963921" sldId="281"/>
            <ac:spMk id="109" creationId="{4B4FE30F-3B9F-FC0F-C9A6-C9B37C5EEB6B}"/>
          </ac:spMkLst>
        </pc:spChg>
        <pc:spChg chg="add mod topLvl">
          <ac:chgData name="Wigmore, Eleanor" userId="154496fa-10d7-4fd7-9fba-3614c367c37c" providerId="ADAL" clId="{AA3EDCC2-F595-42A0-8358-45CA77012066}" dt="2023-05-25T10:42:01.797" v="4671" actId="164"/>
          <ac:spMkLst>
            <pc:docMk/>
            <pc:sldMk cId="586963921" sldId="281"/>
            <ac:spMk id="110" creationId="{E3CFD8AC-0A7B-C9F6-4FD5-4DA7DB8A025C}"/>
          </ac:spMkLst>
        </pc:spChg>
        <pc:spChg chg="add mod topLvl">
          <ac:chgData name="Wigmore, Eleanor" userId="154496fa-10d7-4fd7-9fba-3614c367c37c" providerId="ADAL" clId="{AA3EDCC2-F595-42A0-8358-45CA77012066}" dt="2023-05-25T10:42:01.797" v="4671" actId="164"/>
          <ac:spMkLst>
            <pc:docMk/>
            <pc:sldMk cId="586963921" sldId="281"/>
            <ac:spMk id="111" creationId="{356B1697-BCC9-D87D-FD42-AF0B42A7AFD0}"/>
          </ac:spMkLst>
        </pc:spChg>
        <pc:spChg chg="add del mod">
          <ac:chgData name="Wigmore, Eleanor" userId="154496fa-10d7-4fd7-9fba-3614c367c37c" providerId="ADAL" clId="{AA3EDCC2-F595-42A0-8358-45CA77012066}" dt="2023-05-24T15:33:57.563" v="3872" actId="478"/>
          <ac:spMkLst>
            <pc:docMk/>
            <pc:sldMk cId="586963921" sldId="281"/>
            <ac:spMk id="112" creationId="{8A43DCEF-43A5-9808-F6EA-DE28A49CC73C}"/>
          </ac:spMkLst>
        </pc:spChg>
        <pc:spChg chg="add del mod">
          <ac:chgData name="Wigmore, Eleanor" userId="154496fa-10d7-4fd7-9fba-3614c367c37c" providerId="ADAL" clId="{AA3EDCC2-F595-42A0-8358-45CA77012066}" dt="2023-05-24T15:33:55.733" v="3871" actId="478"/>
          <ac:spMkLst>
            <pc:docMk/>
            <pc:sldMk cId="586963921" sldId="281"/>
            <ac:spMk id="113" creationId="{F146DBBA-6DA7-2D3B-AF41-575AE054845C}"/>
          </ac:spMkLst>
        </pc:spChg>
        <pc:spChg chg="add mod topLvl">
          <ac:chgData name="Wigmore, Eleanor" userId="154496fa-10d7-4fd7-9fba-3614c367c37c" providerId="ADAL" clId="{AA3EDCC2-F595-42A0-8358-45CA77012066}" dt="2023-05-25T10:42:01.797" v="4671" actId="164"/>
          <ac:spMkLst>
            <pc:docMk/>
            <pc:sldMk cId="586963921" sldId="281"/>
            <ac:spMk id="114" creationId="{0E6DDAA1-23C3-C505-0901-DAEB41985E0D}"/>
          </ac:spMkLst>
        </pc:spChg>
        <pc:spChg chg="add mod topLvl">
          <ac:chgData name="Wigmore, Eleanor" userId="154496fa-10d7-4fd7-9fba-3614c367c37c" providerId="ADAL" clId="{AA3EDCC2-F595-42A0-8358-45CA77012066}" dt="2023-05-25T10:42:01.797" v="4671" actId="164"/>
          <ac:spMkLst>
            <pc:docMk/>
            <pc:sldMk cId="586963921" sldId="281"/>
            <ac:spMk id="115" creationId="{5A123912-D4B8-CCCE-69EE-832136BD6095}"/>
          </ac:spMkLst>
        </pc:spChg>
        <pc:spChg chg="add mod topLvl">
          <ac:chgData name="Wigmore, Eleanor" userId="154496fa-10d7-4fd7-9fba-3614c367c37c" providerId="ADAL" clId="{AA3EDCC2-F595-42A0-8358-45CA77012066}" dt="2023-05-25T10:39:52.730" v="4438" actId="165"/>
          <ac:spMkLst>
            <pc:docMk/>
            <pc:sldMk cId="586963921" sldId="281"/>
            <ac:spMk id="116" creationId="{99FB48C1-78E2-40BB-DECC-21D36EBD63A7}"/>
          </ac:spMkLst>
        </pc:spChg>
        <pc:spChg chg="add mod ord topLvl">
          <ac:chgData name="Wigmore, Eleanor" userId="154496fa-10d7-4fd7-9fba-3614c367c37c" providerId="ADAL" clId="{AA3EDCC2-F595-42A0-8358-45CA77012066}" dt="2023-05-25T10:42:01.797" v="4671" actId="164"/>
          <ac:spMkLst>
            <pc:docMk/>
            <pc:sldMk cId="586963921" sldId="281"/>
            <ac:spMk id="117" creationId="{481E65B7-0CBC-AA8E-DBEE-F2860D244048}"/>
          </ac:spMkLst>
        </pc:spChg>
        <pc:spChg chg="add mod topLvl">
          <ac:chgData name="Wigmore, Eleanor" userId="154496fa-10d7-4fd7-9fba-3614c367c37c" providerId="ADAL" clId="{AA3EDCC2-F595-42A0-8358-45CA77012066}" dt="2023-05-25T10:42:01.797" v="4671" actId="164"/>
          <ac:spMkLst>
            <pc:docMk/>
            <pc:sldMk cId="586963921" sldId="281"/>
            <ac:spMk id="118" creationId="{FFA6D917-5ABB-2505-6C84-DBF2EECE0CEB}"/>
          </ac:spMkLst>
        </pc:spChg>
        <pc:spChg chg="add mod topLvl">
          <ac:chgData name="Wigmore, Eleanor" userId="154496fa-10d7-4fd7-9fba-3614c367c37c" providerId="ADAL" clId="{AA3EDCC2-F595-42A0-8358-45CA77012066}" dt="2023-05-25T10:42:01.797" v="4671" actId="164"/>
          <ac:spMkLst>
            <pc:docMk/>
            <pc:sldMk cId="586963921" sldId="281"/>
            <ac:spMk id="119" creationId="{EBBA18DF-7981-075C-C2E2-75C2E3E9D18E}"/>
          </ac:spMkLst>
        </pc:spChg>
        <pc:spChg chg="add mod topLvl">
          <ac:chgData name="Wigmore, Eleanor" userId="154496fa-10d7-4fd7-9fba-3614c367c37c" providerId="ADAL" clId="{AA3EDCC2-F595-42A0-8358-45CA77012066}" dt="2023-05-25T10:42:01.797" v="4671" actId="164"/>
          <ac:spMkLst>
            <pc:docMk/>
            <pc:sldMk cId="586963921" sldId="281"/>
            <ac:spMk id="120" creationId="{EDD2C5FE-F11B-DA8D-B67E-734542037C86}"/>
          </ac:spMkLst>
        </pc:spChg>
        <pc:spChg chg="add mod topLvl">
          <ac:chgData name="Wigmore, Eleanor" userId="154496fa-10d7-4fd7-9fba-3614c367c37c" providerId="ADAL" clId="{AA3EDCC2-F595-42A0-8358-45CA77012066}" dt="2023-05-25T10:42:01.797" v="4671" actId="164"/>
          <ac:spMkLst>
            <pc:docMk/>
            <pc:sldMk cId="586963921" sldId="281"/>
            <ac:spMk id="121" creationId="{F6A3DFAF-38C9-59CE-4812-4977432A10FB}"/>
          </ac:spMkLst>
        </pc:spChg>
        <pc:spChg chg="add mod topLvl">
          <ac:chgData name="Wigmore, Eleanor" userId="154496fa-10d7-4fd7-9fba-3614c367c37c" providerId="ADAL" clId="{AA3EDCC2-F595-42A0-8358-45CA77012066}" dt="2023-05-25T10:42:01.797" v="4671" actId="164"/>
          <ac:spMkLst>
            <pc:docMk/>
            <pc:sldMk cId="586963921" sldId="281"/>
            <ac:spMk id="122" creationId="{773A96CA-7EE8-3753-9680-26C5FB4A2950}"/>
          </ac:spMkLst>
        </pc:spChg>
        <pc:spChg chg="add mod topLvl">
          <ac:chgData name="Wigmore, Eleanor" userId="154496fa-10d7-4fd7-9fba-3614c367c37c" providerId="ADAL" clId="{AA3EDCC2-F595-42A0-8358-45CA77012066}" dt="2023-05-25T10:42:01.797" v="4671" actId="164"/>
          <ac:spMkLst>
            <pc:docMk/>
            <pc:sldMk cId="586963921" sldId="281"/>
            <ac:spMk id="123" creationId="{72EC82EB-E90F-AF0E-6921-0D9A5604B8E6}"/>
          </ac:spMkLst>
        </pc:spChg>
        <pc:spChg chg="add mod topLvl">
          <ac:chgData name="Wigmore, Eleanor" userId="154496fa-10d7-4fd7-9fba-3614c367c37c" providerId="ADAL" clId="{AA3EDCC2-F595-42A0-8358-45CA77012066}" dt="2023-05-25T10:42:01.797" v="4671" actId="164"/>
          <ac:spMkLst>
            <pc:docMk/>
            <pc:sldMk cId="586963921" sldId="281"/>
            <ac:spMk id="124" creationId="{DB97C49B-72E9-6EC9-C3C3-F62C2F3479B3}"/>
          </ac:spMkLst>
        </pc:spChg>
        <pc:spChg chg="add mod topLvl">
          <ac:chgData name="Wigmore, Eleanor" userId="154496fa-10d7-4fd7-9fba-3614c367c37c" providerId="ADAL" clId="{AA3EDCC2-F595-42A0-8358-45CA77012066}" dt="2023-05-25T10:42:01.797" v="4671" actId="164"/>
          <ac:spMkLst>
            <pc:docMk/>
            <pc:sldMk cId="586963921" sldId="281"/>
            <ac:spMk id="125" creationId="{FB920627-5CE0-16E1-B0E1-AFA0C693EA8E}"/>
          </ac:spMkLst>
        </pc:spChg>
        <pc:spChg chg="add mod topLvl">
          <ac:chgData name="Wigmore, Eleanor" userId="154496fa-10d7-4fd7-9fba-3614c367c37c" providerId="ADAL" clId="{AA3EDCC2-F595-42A0-8358-45CA77012066}" dt="2023-05-25T10:42:01.797" v="4671" actId="164"/>
          <ac:spMkLst>
            <pc:docMk/>
            <pc:sldMk cId="586963921" sldId="281"/>
            <ac:spMk id="126" creationId="{3AB2A042-ECED-CDF9-3332-9F513FF9E396}"/>
          </ac:spMkLst>
        </pc:spChg>
        <pc:spChg chg="add mod topLvl">
          <ac:chgData name="Wigmore, Eleanor" userId="154496fa-10d7-4fd7-9fba-3614c367c37c" providerId="ADAL" clId="{AA3EDCC2-F595-42A0-8358-45CA77012066}" dt="2023-05-25T10:42:01.797" v="4671" actId="164"/>
          <ac:spMkLst>
            <pc:docMk/>
            <pc:sldMk cId="586963921" sldId="281"/>
            <ac:spMk id="127" creationId="{43250EFD-F906-1C70-5520-C960ED42EEBF}"/>
          </ac:spMkLst>
        </pc:spChg>
        <pc:spChg chg="add mod topLvl">
          <ac:chgData name="Wigmore, Eleanor" userId="154496fa-10d7-4fd7-9fba-3614c367c37c" providerId="ADAL" clId="{AA3EDCC2-F595-42A0-8358-45CA77012066}" dt="2023-05-25T10:42:01.797" v="4671" actId="164"/>
          <ac:spMkLst>
            <pc:docMk/>
            <pc:sldMk cId="586963921" sldId="281"/>
            <ac:spMk id="128" creationId="{03BB4773-DDAD-0B10-35E1-EB81DF409872}"/>
          </ac:spMkLst>
        </pc:spChg>
        <pc:spChg chg="add mod topLvl">
          <ac:chgData name="Wigmore, Eleanor" userId="154496fa-10d7-4fd7-9fba-3614c367c37c" providerId="ADAL" clId="{AA3EDCC2-F595-42A0-8358-45CA77012066}" dt="2023-05-25T10:42:01.797" v="4671" actId="164"/>
          <ac:spMkLst>
            <pc:docMk/>
            <pc:sldMk cId="586963921" sldId="281"/>
            <ac:spMk id="129" creationId="{424ADB1F-D2FC-08EC-D6BC-BC2610145621}"/>
          </ac:spMkLst>
        </pc:spChg>
        <pc:spChg chg="add mod topLvl">
          <ac:chgData name="Wigmore, Eleanor" userId="154496fa-10d7-4fd7-9fba-3614c367c37c" providerId="ADAL" clId="{AA3EDCC2-F595-42A0-8358-45CA77012066}" dt="2023-05-25T10:42:01.797" v="4671" actId="164"/>
          <ac:spMkLst>
            <pc:docMk/>
            <pc:sldMk cId="586963921" sldId="281"/>
            <ac:spMk id="130" creationId="{74F0B1CB-35B5-D6DD-35F8-6C17DCB1CDBE}"/>
          </ac:spMkLst>
        </pc:spChg>
        <pc:spChg chg="add mod topLvl">
          <ac:chgData name="Wigmore, Eleanor" userId="154496fa-10d7-4fd7-9fba-3614c367c37c" providerId="ADAL" clId="{AA3EDCC2-F595-42A0-8358-45CA77012066}" dt="2023-05-25T10:42:01.797" v="4671" actId="164"/>
          <ac:spMkLst>
            <pc:docMk/>
            <pc:sldMk cId="586963921" sldId="281"/>
            <ac:spMk id="131" creationId="{96A023C1-9C58-082C-EE26-4F20C5557338}"/>
          </ac:spMkLst>
        </pc:spChg>
        <pc:spChg chg="add mod topLvl">
          <ac:chgData name="Wigmore, Eleanor" userId="154496fa-10d7-4fd7-9fba-3614c367c37c" providerId="ADAL" clId="{AA3EDCC2-F595-42A0-8358-45CA77012066}" dt="2023-05-25T10:42:01.797" v="4671" actId="164"/>
          <ac:spMkLst>
            <pc:docMk/>
            <pc:sldMk cId="586963921" sldId="281"/>
            <ac:spMk id="132" creationId="{B7FED14B-8674-C086-B961-490E4569FB65}"/>
          </ac:spMkLst>
        </pc:spChg>
        <pc:spChg chg="add mod topLvl">
          <ac:chgData name="Wigmore, Eleanor" userId="154496fa-10d7-4fd7-9fba-3614c367c37c" providerId="ADAL" clId="{AA3EDCC2-F595-42A0-8358-45CA77012066}" dt="2023-05-25T10:42:01.797" v="4671" actId="164"/>
          <ac:spMkLst>
            <pc:docMk/>
            <pc:sldMk cId="586963921" sldId="281"/>
            <ac:spMk id="133" creationId="{ABC1FCA6-48B7-4A92-B076-6E0D05558158}"/>
          </ac:spMkLst>
        </pc:spChg>
        <pc:spChg chg="add mod topLvl">
          <ac:chgData name="Wigmore, Eleanor" userId="154496fa-10d7-4fd7-9fba-3614c367c37c" providerId="ADAL" clId="{AA3EDCC2-F595-42A0-8358-45CA77012066}" dt="2023-05-25T10:42:01.797" v="4671" actId="164"/>
          <ac:spMkLst>
            <pc:docMk/>
            <pc:sldMk cId="586963921" sldId="281"/>
            <ac:spMk id="134" creationId="{28CB85C4-F584-4090-FAD3-51F6A628CD0F}"/>
          </ac:spMkLst>
        </pc:spChg>
        <pc:spChg chg="add mod topLvl">
          <ac:chgData name="Wigmore, Eleanor" userId="154496fa-10d7-4fd7-9fba-3614c367c37c" providerId="ADAL" clId="{AA3EDCC2-F595-42A0-8358-45CA77012066}" dt="2023-05-25T10:42:01.797" v="4671" actId="164"/>
          <ac:spMkLst>
            <pc:docMk/>
            <pc:sldMk cId="586963921" sldId="281"/>
            <ac:spMk id="135" creationId="{AF9A7E83-4ACB-29A9-0B13-A33D723CF180}"/>
          </ac:spMkLst>
        </pc:spChg>
        <pc:spChg chg="add mod topLvl">
          <ac:chgData name="Wigmore, Eleanor" userId="154496fa-10d7-4fd7-9fba-3614c367c37c" providerId="ADAL" clId="{AA3EDCC2-F595-42A0-8358-45CA77012066}" dt="2023-05-25T10:42:01.797" v="4671" actId="164"/>
          <ac:spMkLst>
            <pc:docMk/>
            <pc:sldMk cId="586963921" sldId="281"/>
            <ac:spMk id="136" creationId="{1B59E394-BDB1-38C2-16D5-5EA313F2D0E6}"/>
          </ac:spMkLst>
        </pc:spChg>
        <pc:spChg chg="add mod topLvl">
          <ac:chgData name="Wigmore, Eleanor" userId="154496fa-10d7-4fd7-9fba-3614c367c37c" providerId="ADAL" clId="{AA3EDCC2-F595-42A0-8358-45CA77012066}" dt="2023-05-25T10:42:01.797" v="4671" actId="164"/>
          <ac:spMkLst>
            <pc:docMk/>
            <pc:sldMk cId="586963921" sldId="281"/>
            <ac:spMk id="137" creationId="{93651F33-0E8C-5A6E-AFFF-4D446C737CD5}"/>
          </ac:spMkLst>
        </pc:spChg>
        <pc:spChg chg="add mod topLvl">
          <ac:chgData name="Wigmore, Eleanor" userId="154496fa-10d7-4fd7-9fba-3614c367c37c" providerId="ADAL" clId="{AA3EDCC2-F595-42A0-8358-45CA77012066}" dt="2023-05-25T10:42:01.797" v="4671" actId="164"/>
          <ac:spMkLst>
            <pc:docMk/>
            <pc:sldMk cId="586963921" sldId="281"/>
            <ac:spMk id="138" creationId="{D0F7F683-EFD0-12A0-7649-BBA34AFAAF7C}"/>
          </ac:spMkLst>
        </pc:spChg>
        <pc:spChg chg="add mod topLvl">
          <ac:chgData name="Wigmore, Eleanor" userId="154496fa-10d7-4fd7-9fba-3614c367c37c" providerId="ADAL" clId="{AA3EDCC2-F595-42A0-8358-45CA77012066}" dt="2023-05-25T10:42:01.797" v="4671" actId="164"/>
          <ac:spMkLst>
            <pc:docMk/>
            <pc:sldMk cId="586963921" sldId="281"/>
            <ac:spMk id="139" creationId="{B81766F5-8483-7F98-25C5-DD68315183DE}"/>
          </ac:spMkLst>
        </pc:spChg>
        <pc:spChg chg="add mod topLvl">
          <ac:chgData name="Wigmore, Eleanor" userId="154496fa-10d7-4fd7-9fba-3614c367c37c" providerId="ADAL" clId="{AA3EDCC2-F595-42A0-8358-45CA77012066}" dt="2023-05-25T10:42:01.797" v="4671" actId="164"/>
          <ac:spMkLst>
            <pc:docMk/>
            <pc:sldMk cId="586963921" sldId="281"/>
            <ac:spMk id="140" creationId="{1E777440-8357-B2CF-FB78-C83B780AE5D1}"/>
          </ac:spMkLst>
        </pc:spChg>
        <pc:spChg chg="add mod topLvl">
          <ac:chgData name="Wigmore, Eleanor" userId="154496fa-10d7-4fd7-9fba-3614c367c37c" providerId="ADAL" clId="{AA3EDCC2-F595-42A0-8358-45CA77012066}" dt="2023-05-25T10:42:01.797" v="4671" actId="164"/>
          <ac:spMkLst>
            <pc:docMk/>
            <pc:sldMk cId="586963921" sldId="281"/>
            <ac:spMk id="141" creationId="{A82B0CE7-6BB2-0765-8712-8A762673272C}"/>
          </ac:spMkLst>
        </pc:spChg>
        <pc:spChg chg="add mod topLvl">
          <ac:chgData name="Wigmore, Eleanor" userId="154496fa-10d7-4fd7-9fba-3614c367c37c" providerId="ADAL" clId="{AA3EDCC2-F595-42A0-8358-45CA77012066}" dt="2023-05-25T10:42:01.797" v="4671" actId="164"/>
          <ac:spMkLst>
            <pc:docMk/>
            <pc:sldMk cId="586963921" sldId="281"/>
            <ac:spMk id="142" creationId="{FC4DE1F9-A556-8D25-6E16-9F48AB505406}"/>
          </ac:spMkLst>
        </pc:spChg>
        <pc:spChg chg="add mod topLvl">
          <ac:chgData name="Wigmore, Eleanor" userId="154496fa-10d7-4fd7-9fba-3614c367c37c" providerId="ADAL" clId="{AA3EDCC2-F595-42A0-8358-45CA77012066}" dt="2023-05-25T10:42:01.797" v="4671" actId="164"/>
          <ac:spMkLst>
            <pc:docMk/>
            <pc:sldMk cId="586963921" sldId="281"/>
            <ac:spMk id="143" creationId="{3DEE8CF1-143D-51FE-F426-76057B74E889}"/>
          </ac:spMkLst>
        </pc:spChg>
        <pc:spChg chg="add mod topLvl">
          <ac:chgData name="Wigmore, Eleanor" userId="154496fa-10d7-4fd7-9fba-3614c367c37c" providerId="ADAL" clId="{AA3EDCC2-F595-42A0-8358-45CA77012066}" dt="2023-05-25T10:42:01.797" v="4671" actId="164"/>
          <ac:spMkLst>
            <pc:docMk/>
            <pc:sldMk cId="586963921" sldId="281"/>
            <ac:spMk id="144" creationId="{2A1956AE-018C-2549-4373-A712623024AB}"/>
          </ac:spMkLst>
        </pc:spChg>
        <pc:spChg chg="add mod topLvl">
          <ac:chgData name="Wigmore, Eleanor" userId="154496fa-10d7-4fd7-9fba-3614c367c37c" providerId="ADAL" clId="{AA3EDCC2-F595-42A0-8358-45CA77012066}" dt="2023-05-25T10:42:01.797" v="4671" actId="164"/>
          <ac:spMkLst>
            <pc:docMk/>
            <pc:sldMk cId="586963921" sldId="281"/>
            <ac:spMk id="145" creationId="{4BDF118E-7B34-3612-8A68-FC8C000D9354}"/>
          </ac:spMkLst>
        </pc:spChg>
        <pc:spChg chg="add mod topLvl">
          <ac:chgData name="Wigmore, Eleanor" userId="154496fa-10d7-4fd7-9fba-3614c367c37c" providerId="ADAL" clId="{AA3EDCC2-F595-42A0-8358-45CA77012066}" dt="2023-05-25T10:42:01.797" v="4671" actId="164"/>
          <ac:spMkLst>
            <pc:docMk/>
            <pc:sldMk cId="586963921" sldId="281"/>
            <ac:spMk id="146" creationId="{C79C0ECC-865A-C3CA-8DD5-3ED3B0D71043}"/>
          </ac:spMkLst>
        </pc:spChg>
        <pc:spChg chg="add mod topLvl">
          <ac:chgData name="Wigmore, Eleanor" userId="154496fa-10d7-4fd7-9fba-3614c367c37c" providerId="ADAL" clId="{AA3EDCC2-F595-42A0-8358-45CA77012066}" dt="2023-05-25T10:42:01.797" v="4671" actId="164"/>
          <ac:spMkLst>
            <pc:docMk/>
            <pc:sldMk cId="586963921" sldId="281"/>
            <ac:spMk id="147" creationId="{70FD1409-813B-61C7-95B5-032FB9484C95}"/>
          </ac:spMkLst>
        </pc:spChg>
        <pc:spChg chg="add mod topLvl">
          <ac:chgData name="Wigmore, Eleanor" userId="154496fa-10d7-4fd7-9fba-3614c367c37c" providerId="ADAL" clId="{AA3EDCC2-F595-42A0-8358-45CA77012066}" dt="2023-05-25T10:41:18.503" v="4666" actId="1038"/>
          <ac:spMkLst>
            <pc:docMk/>
            <pc:sldMk cId="586963921" sldId="281"/>
            <ac:spMk id="148" creationId="{93D262E5-E7BA-8C47-9A67-4C642E0A3556}"/>
          </ac:spMkLst>
        </pc:spChg>
        <pc:grpChg chg="add del mod">
          <ac:chgData name="Wigmore, Eleanor" userId="154496fa-10d7-4fd7-9fba-3614c367c37c" providerId="ADAL" clId="{AA3EDCC2-F595-42A0-8358-45CA77012066}" dt="2023-05-11T13:09:27.332" v="92" actId="165"/>
          <ac:grpSpMkLst>
            <pc:docMk/>
            <pc:sldMk cId="586963921" sldId="281"/>
            <ac:grpSpMk id="11" creationId="{E65ED293-A4C5-3412-D5A1-EBE2CBF72688}"/>
          </ac:grpSpMkLst>
        </pc:grpChg>
        <pc:grpChg chg="add del mod">
          <ac:chgData name="Wigmore, Eleanor" userId="154496fa-10d7-4fd7-9fba-3614c367c37c" providerId="ADAL" clId="{AA3EDCC2-F595-42A0-8358-45CA77012066}" dt="2023-05-11T13:18:43.142" v="243" actId="165"/>
          <ac:grpSpMkLst>
            <pc:docMk/>
            <pc:sldMk cId="586963921" sldId="281"/>
            <ac:grpSpMk id="18" creationId="{0E0ED1B3-4619-B1A5-F08D-74185DEA294E}"/>
          </ac:grpSpMkLst>
        </pc:grpChg>
        <pc:grpChg chg="del">
          <ac:chgData name="Wigmore, Eleanor" userId="154496fa-10d7-4fd7-9fba-3614c367c37c" providerId="ADAL" clId="{AA3EDCC2-F595-42A0-8358-45CA77012066}" dt="2023-05-11T12:27:43.653" v="0" actId="478"/>
          <ac:grpSpMkLst>
            <pc:docMk/>
            <pc:sldMk cId="586963921" sldId="281"/>
            <ac:grpSpMk id="43" creationId="{77373052-89A4-4DB5-86C6-EE2C699AC6E6}"/>
          </ac:grpSpMkLst>
        </pc:grpChg>
        <pc:grpChg chg="add del mod">
          <ac:chgData name="Wigmore, Eleanor" userId="154496fa-10d7-4fd7-9fba-3614c367c37c" providerId="ADAL" clId="{AA3EDCC2-F595-42A0-8358-45CA77012066}" dt="2023-05-25T10:40:40.234" v="4519" actId="165"/>
          <ac:grpSpMkLst>
            <pc:docMk/>
            <pc:sldMk cId="586963921" sldId="281"/>
            <ac:grpSpMk id="83" creationId="{5F2A8A46-46C7-5499-6058-C94A8FC6CACB}"/>
          </ac:grpSpMkLst>
        </pc:grpChg>
        <pc:grpChg chg="add del mod">
          <ac:chgData name="Wigmore, Eleanor" userId="154496fa-10d7-4fd7-9fba-3614c367c37c" providerId="ADAL" clId="{AA3EDCC2-F595-42A0-8358-45CA77012066}" dt="2023-05-25T10:39:52.730" v="4438" actId="165"/>
          <ac:grpSpMkLst>
            <pc:docMk/>
            <pc:sldMk cId="586963921" sldId="281"/>
            <ac:grpSpMk id="149" creationId="{B0B2E877-3BA7-FC4D-7E93-D44DB70F4E7B}"/>
          </ac:grpSpMkLst>
        </pc:grpChg>
        <pc:grpChg chg="add mod">
          <ac:chgData name="Wigmore, Eleanor" userId="154496fa-10d7-4fd7-9fba-3614c367c37c" providerId="ADAL" clId="{AA3EDCC2-F595-42A0-8358-45CA77012066}" dt="2023-05-25T10:42:01.797" v="4671" actId="164"/>
          <ac:grpSpMkLst>
            <pc:docMk/>
            <pc:sldMk cId="586963921" sldId="281"/>
            <ac:grpSpMk id="151" creationId="{EFE0936F-284B-646A-FE16-2F14C76DE5A7}"/>
          </ac:grpSpMkLst>
        </pc:grpChg>
        <pc:grpChg chg="add mod">
          <ac:chgData name="Wigmore, Eleanor" userId="154496fa-10d7-4fd7-9fba-3614c367c37c" providerId="ADAL" clId="{AA3EDCC2-F595-42A0-8358-45CA77012066}" dt="2023-05-25T10:42:12.599" v="4672" actId="164"/>
          <ac:grpSpMkLst>
            <pc:docMk/>
            <pc:sldMk cId="586963921" sldId="281"/>
            <ac:grpSpMk id="152" creationId="{0E334E02-A93C-03FE-DB84-4F4CCC1ED296}"/>
          </ac:grpSpMkLst>
        </pc:grpChg>
        <pc:picChg chg="add mod modCrop">
          <ac:chgData name="Wigmore, Eleanor" userId="154496fa-10d7-4fd7-9fba-3614c367c37c" providerId="ADAL" clId="{AA3EDCC2-F595-42A0-8358-45CA77012066}" dt="2023-05-25T10:42:12.599" v="4672" actId="164"/>
          <ac:picMkLst>
            <pc:docMk/>
            <pc:sldMk cId="586963921" sldId="281"/>
            <ac:picMk id="2" creationId="{EEE6EE68-8402-6AF5-45B1-CC84E8BE2155}"/>
          </ac:picMkLst>
        </pc:picChg>
        <pc:picChg chg="del mod">
          <ac:chgData name="Wigmore, Eleanor" userId="154496fa-10d7-4fd7-9fba-3614c367c37c" providerId="ADAL" clId="{AA3EDCC2-F595-42A0-8358-45CA77012066}" dt="2023-05-24T10:57:35.628" v="2568" actId="478"/>
          <ac:picMkLst>
            <pc:docMk/>
            <pc:sldMk cId="586963921" sldId="281"/>
            <ac:picMk id="3" creationId="{AA2D9EE3-D5EA-A2C7-27EF-CA9DD8008977}"/>
          </ac:picMkLst>
        </pc:picChg>
        <pc:picChg chg="del mod">
          <ac:chgData name="Wigmore, Eleanor" userId="154496fa-10d7-4fd7-9fba-3614c367c37c" providerId="ADAL" clId="{AA3EDCC2-F595-42A0-8358-45CA77012066}" dt="2023-05-11T13:13:13.666" v="220" actId="478"/>
          <ac:picMkLst>
            <pc:docMk/>
            <pc:sldMk cId="586963921" sldId="281"/>
            <ac:picMk id="4" creationId="{351CAD75-2F9A-9475-B4CF-DB7B093FD049}"/>
          </ac:picMkLst>
        </pc:picChg>
        <pc:picChg chg="add del mod">
          <ac:chgData name="Wigmore, Eleanor" userId="154496fa-10d7-4fd7-9fba-3614c367c37c" providerId="ADAL" clId="{AA3EDCC2-F595-42A0-8358-45CA77012066}" dt="2023-05-11T13:13:15.356" v="221" actId="478"/>
          <ac:picMkLst>
            <pc:docMk/>
            <pc:sldMk cId="586963921" sldId="281"/>
            <ac:picMk id="7" creationId="{DA05AA3F-C542-29E1-10CD-E94F74206990}"/>
          </ac:picMkLst>
        </pc:picChg>
        <pc:picChg chg="add del mod topLvl">
          <ac:chgData name="Wigmore, Eleanor" userId="154496fa-10d7-4fd7-9fba-3614c367c37c" providerId="ADAL" clId="{AA3EDCC2-F595-42A0-8358-45CA77012066}" dt="2023-05-11T13:09:30.357" v="93" actId="478"/>
          <ac:picMkLst>
            <pc:docMk/>
            <pc:sldMk cId="586963921" sldId="281"/>
            <ac:picMk id="9" creationId="{5B334A5D-611A-42B1-C398-79E45B88F8FF}"/>
          </ac:picMkLst>
        </pc:picChg>
        <pc:picChg chg="add del mod topLvl modCrop">
          <ac:chgData name="Wigmore, Eleanor" userId="154496fa-10d7-4fd7-9fba-3614c367c37c" providerId="ADAL" clId="{AA3EDCC2-F595-42A0-8358-45CA77012066}" dt="2023-05-24T11:08:19.669" v="2591" actId="478"/>
          <ac:picMkLst>
            <pc:docMk/>
            <pc:sldMk cId="586963921" sldId="281"/>
            <ac:picMk id="10" creationId="{7BF12EB0-1974-5001-E08F-1BEF8C909FF1}"/>
          </ac:picMkLst>
        </pc:picChg>
        <pc:picChg chg="add del mod topLvl">
          <ac:chgData name="Wigmore, Eleanor" userId="154496fa-10d7-4fd7-9fba-3614c367c37c" providerId="ADAL" clId="{AA3EDCC2-F595-42A0-8358-45CA77012066}" dt="2023-05-24T11:08:18.028" v="2590" actId="478"/>
          <ac:picMkLst>
            <pc:docMk/>
            <pc:sldMk cId="586963921" sldId="281"/>
            <ac:picMk id="15" creationId="{0469B89C-CFE5-0386-7FBA-9B4273762761}"/>
          </ac:picMkLst>
        </pc:picChg>
        <pc:picChg chg="add del mod">
          <ac:chgData name="Wigmore, Eleanor" userId="154496fa-10d7-4fd7-9fba-3614c367c37c" providerId="ADAL" clId="{AA3EDCC2-F595-42A0-8358-45CA77012066}" dt="2023-05-24T11:10:26.988" v="2619" actId="478"/>
          <ac:picMkLst>
            <pc:docMk/>
            <pc:sldMk cId="586963921" sldId="281"/>
            <ac:picMk id="21" creationId="{F3EB8947-850F-2B08-3515-F0F16F7BC945}"/>
          </ac:picMkLst>
        </pc:picChg>
        <pc:picChg chg="add del mod modCrop">
          <ac:chgData name="Wigmore, Eleanor" userId="154496fa-10d7-4fd7-9fba-3614c367c37c" providerId="ADAL" clId="{AA3EDCC2-F595-42A0-8358-45CA77012066}" dt="2023-05-24T11:10:28.282" v="2620" actId="478"/>
          <ac:picMkLst>
            <pc:docMk/>
            <pc:sldMk cId="586963921" sldId="281"/>
            <ac:picMk id="23" creationId="{9FC19B9B-81D3-401D-F88E-93BA81BCA972}"/>
          </ac:picMkLst>
        </pc:picChg>
        <pc:picChg chg="add del mod">
          <ac:chgData name="Wigmore, Eleanor" userId="154496fa-10d7-4fd7-9fba-3614c367c37c" providerId="ADAL" clId="{AA3EDCC2-F595-42A0-8358-45CA77012066}" dt="2023-05-24T10:58:06.454" v="2572" actId="478"/>
          <ac:picMkLst>
            <pc:docMk/>
            <pc:sldMk cId="586963921" sldId="281"/>
            <ac:picMk id="37" creationId="{08F3F174-979C-0F10-0596-CB9A786B5A31}"/>
          </ac:picMkLst>
        </pc:picChg>
        <pc:picChg chg="add del mod modCrop">
          <ac:chgData name="Wigmore, Eleanor" userId="154496fa-10d7-4fd7-9fba-3614c367c37c" providerId="ADAL" clId="{AA3EDCC2-F595-42A0-8358-45CA77012066}" dt="2023-05-25T10:48:11.022" v="4673" actId="478"/>
          <ac:picMkLst>
            <pc:docMk/>
            <pc:sldMk cId="586963921" sldId="281"/>
            <ac:picMk id="39" creationId="{7C5E49C6-24DA-BE53-BE4F-F9CD5C0E1271}"/>
          </ac:picMkLst>
        </pc:picChg>
        <pc:picChg chg="add mod topLvl modCrop">
          <ac:chgData name="Wigmore, Eleanor" userId="154496fa-10d7-4fd7-9fba-3614c367c37c" providerId="ADAL" clId="{AA3EDCC2-F595-42A0-8358-45CA77012066}" dt="2023-05-25T10:42:12.599" v="4672" actId="164"/>
          <ac:picMkLst>
            <pc:docMk/>
            <pc:sldMk cId="586963921" sldId="281"/>
            <ac:picMk id="41" creationId="{6F93F147-6809-1E58-F6FE-A2BCBAE6DCCC}"/>
          </ac:picMkLst>
        </pc:picChg>
        <pc:picChg chg="add del mod modCrop">
          <ac:chgData name="Wigmore, Eleanor" userId="154496fa-10d7-4fd7-9fba-3614c367c37c" providerId="ADAL" clId="{AA3EDCC2-F595-42A0-8358-45CA77012066}" dt="2023-05-24T11:09:52.238" v="2613" actId="478"/>
          <ac:picMkLst>
            <pc:docMk/>
            <pc:sldMk cId="586963921" sldId="281"/>
            <ac:picMk id="43" creationId="{6C6E994B-D741-FC0D-80C1-5511BBF5F35C}"/>
          </ac:picMkLst>
        </pc:picChg>
        <pc:picChg chg="mod">
          <ac:chgData name="Wigmore, Eleanor" userId="154496fa-10d7-4fd7-9fba-3614c367c37c" providerId="ADAL" clId="{AA3EDCC2-F595-42A0-8358-45CA77012066}" dt="2023-05-11T12:28:10.868" v="9" actId="1076"/>
          <ac:picMkLst>
            <pc:docMk/>
            <pc:sldMk cId="586963921" sldId="281"/>
            <ac:picMk id="45" creationId="{56A8B68E-9651-4D81-90EA-2324397075B0}"/>
          </ac:picMkLst>
        </pc:picChg>
        <pc:picChg chg="add mod topLvl modCrop">
          <ac:chgData name="Wigmore, Eleanor" userId="154496fa-10d7-4fd7-9fba-3614c367c37c" providerId="ADAL" clId="{AA3EDCC2-F595-42A0-8358-45CA77012066}" dt="2023-05-25T10:42:01.797" v="4671" actId="164"/>
          <ac:picMkLst>
            <pc:docMk/>
            <pc:sldMk cId="586963921" sldId="281"/>
            <ac:picMk id="46" creationId="{091D2208-5A89-4ABD-E6DE-9950377EEB41}"/>
          </ac:picMkLst>
        </pc:picChg>
        <pc:picChg chg="add mod modCrop">
          <ac:chgData name="Wigmore, Eleanor" userId="154496fa-10d7-4fd7-9fba-3614c367c37c" providerId="ADAL" clId="{AA3EDCC2-F595-42A0-8358-45CA77012066}" dt="2023-05-25T10:41:52.798" v="4670" actId="14100"/>
          <ac:picMkLst>
            <pc:docMk/>
            <pc:sldMk cId="586963921" sldId="281"/>
            <ac:picMk id="84" creationId="{26E3AFC5-5D2A-1FCA-554A-3403F6750861}"/>
          </ac:picMkLst>
        </pc:picChg>
        <pc:picChg chg="add del mod modCrop">
          <ac:chgData name="Wigmore, Eleanor" userId="154496fa-10d7-4fd7-9fba-3614c367c37c" providerId="ADAL" clId="{AA3EDCC2-F595-42A0-8358-45CA77012066}" dt="2023-05-25T10:24:28.634" v="4435"/>
          <ac:picMkLst>
            <pc:docMk/>
            <pc:sldMk cId="586963921" sldId="281"/>
            <ac:picMk id="150" creationId="{11FFCA8A-1A69-D962-56AB-859CE91C00B8}"/>
          </ac:picMkLst>
        </pc:picChg>
        <pc:picChg chg="add mod modCrop">
          <ac:chgData name="Wigmore, Eleanor" userId="154496fa-10d7-4fd7-9fba-3614c367c37c" providerId="ADAL" clId="{AA3EDCC2-F595-42A0-8358-45CA77012066}" dt="2023-05-25T10:48:32.576" v="4682" actId="732"/>
          <ac:picMkLst>
            <pc:docMk/>
            <pc:sldMk cId="586963921" sldId="281"/>
            <ac:picMk id="154" creationId="{406B7FE6-6F82-211D-72DD-CC3956DC78F5}"/>
          </ac:picMkLst>
        </pc:picChg>
        <pc:cxnChg chg="add mod">
          <ac:chgData name="Wigmore, Eleanor" userId="154496fa-10d7-4fd7-9fba-3614c367c37c" providerId="ADAL" clId="{AA3EDCC2-F595-42A0-8358-45CA77012066}" dt="2023-05-25T10:20:55.215" v="4350" actId="1038"/>
          <ac:cxnSpMkLst>
            <pc:docMk/>
            <pc:sldMk cId="586963921" sldId="281"/>
            <ac:cxnSpMk id="19" creationId="{9B3854C7-F615-D506-7FCE-4DF8743912B3}"/>
          </ac:cxnSpMkLst>
        </pc:cxnChg>
      </pc:sldChg>
      <pc:sldChg chg="addSp delSp modSp mod">
        <pc:chgData name="Wigmore, Eleanor" userId="154496fa-10d7-4fd7-9fba-3614c367c37c" providerId="ADAL" clId="{AA3EDCC2-F595-42A0-8358-45CA77012066}" dt="2023-05-24T12:47:31.312" v="3642" actId="1038"/>
        <pc:sldMkLst>
          <pc:docMk/>
          <pc:sldMk cId="4136609356" sldId="284"/>
        </pc:sldMkLst>
        <pc:spChg chg="mod">
          <ac:chgData name="Wigmore, Eleanor" userId="154496fa-10d7-4fd7-9fba-3614c367c37c" providerId="ADAL" clId="{AA3EDCC2-F595-42A0-8358-45CA77012066}" dt="2023-05-19T13:57:09.281" v="1206" actId="20577"/>
          <ac:spMkLst>
            <pc:docMk/>
            <pc:sldMk cId="4136609356" sldId="284"/>
            <ac:spMk id="2" creationId="{87CEF116-AFC8-44FA-B66B-71B5263D6FFB}"/>
          </ac:spMkLst>
        </pc:spChg>
        <pc:spChg chg="add mod">
          <ac:chgData name="Wigmore, Eleanor" userId="154496fa-10d7-4fd7-9fba-3614c367c37c" providerId="ADAL" clId="{AA3EDCC2-F595-42A0-8358-45CA77012066}" dt="2023-05-19T13:57:33.419" v="1224" actId="12788"/>
          <ac:spMkLst>
            <pc:docMk/>
            <pc:sldMk cId="4136609356" sldId="284"/>
            <ac:spMk id="6" creationId="{C0FCCDFA-1794-59FC-C9A5-7C99D01DB249}"/>
          </ac:spMkLst>
        </pc:spChg>
        <pc:spChg chg="add del mod">
          <ac:chgData name="Wigmore, Eleanor" userId="154496fa-10d7-4fd7-9fba-3614c367c37c" providerId="ADAL" clId="{AA3EDCC2-F595-42A0-8358-45CA77012066}" dt="2023-05-24T11:22:58.029" v="2771" actId="478"/>
          <ac:spMkLst>
            <pc:docMk/>
            <pc:sldMk cId="4136609356" sldId="284"/>
            <ac:spMk id="8" creationId="{6CE1BB4B-CC14-DB7F-CC19-26A975C562A9}"/>
          </ac:spMkLst>
        </pc:spChg>
        <pc:spChg chg="add del mod">
          <ac:chgData name="Wigmore, Eleanor" userId="154496fa-10d7-4fd7-9fba-3614c367c37c" providerId="ADAL" clId="{AA3EDCC2-F595-42A0-8358-45CA77012066}" dt="2023-05-19T13:57:11.787" v="1207" actId="478"/>
          <ac:spMkLst>
            <pc:docMk/>
            <pc:sldMk cId="4136609356" sldId="284"/>
            <ac:spMk id="8" creationId="{F98612E4-52AB-28E9-775F-D8D1703E43C7}"/>
          </ac:spMkLst>
        </pc:spChg>
        <pc:spChg chg="mod">
          <ac:chgData name="Wigmore, Eleanor" userId="154496fa-10d7-4fd7-9fba-3614c367c37c" providerId="ADAL" clId="{AA3EDCC2-F595-42A0-8358-45CA77012066}" dt="2023-05-19T13:57:22.621" v="1223" actId="1038"/>
          <ac:spMkLst>
            <pc:docMk/>
            <pc:sldMk cId="4136609356" sldId="284"/>
            <ac:spMk id="9" creationId="{D4EE5172-2217-41F7-8E3D-EC1A0EBF19A8}"/>
          </ac:spMkLst>
        </pc:spChg>
        <pc:spChg chg="add del mod">
          <ac:chgData name="Wigmore, Eleanor" userId="154496fa-10d7-4fd7-9fba-3614c367c37c" providerId="ADAL" clId="{AA3EDCC2-F595-42A0-8358-45CA77012066}" dt="2023-05-19T13:56:59.306" v="1189" actId="478"/>
          <ac:spMkLst>
            <pc:docMk/>
            <pc:sldMk cId="4136609356" sldId="284"/>
            <ac:spMk id="10" creationId="{A6802D49-1F9B-FF7B-769D-7FEE2D61BE3F}"/>
          </ac:spMkLst>
        </pc:spChg>
        <pc:spChg chg="add mod">
          <ac:chgData name="Wigmore, Eleanor" userId="154496fa-10d7-4fd7-9fba-3614c367c37c" providerId="ADAL" clId="{AA3EDCC2-F595-42A0-8358-45CA77012066}" dt="2023-05-19T14:32:41.581" v="1271" actId="1036"/>
          <ac:spMkLst>
            <pc:docMk/>
            <pc:sldMk cId="4136609356" sldId="284"/>
            <ac:spMk id="13" creationId="{74C8B477-927E-9839-DDE1-D673A6C5BC8B}"/>
          </ac:spMkLst>
        </pc:spChg>
        <pc:spChg chg="add mod">
          <ac:chgData name="Wigmore, Eleanor" userId="154496fa-10d7-4fd7-9fba-3614c367c37c" providerId="ADAL" clId="{AA3EDCC2-F595-42A0-8358-45CA77012066}" dt="2023-05-22T15:39:54.344" v="2423" actId="207"/>
          <ac:spMkLst>
            <pc:docMk/>
            <pc:sldMk cId="4136609356" sldId="284"/>
            <ac:spMk id="14" creationId="{08E831A7-03B9-0D52-7025-40F70F885FF9}"/>
          </ac:spMkLst>
        </pc:spChg>
        <pc:spChg chg="mod">
          <ac:chgData name="Wigmore, Eleanor" userId="154496fa-10d7-4fd7-9fba-3614c367c37c" providerId="ADAL" clId="{AA3EDCC2-F595-42A0-8358-45CA77012066}" dt="2023-05-19T13:57:22.621" v="1223" actId="1038"/>
          <ac:spMkLst>
            <pc:docMk/>
            <pc:sldMk cId="4136609356" sldId="284"/>
            <ac:spMk id="55" creationId="{0C13D1AF-2AE2-404C-ADBA-85D72E745637}"/>
          </ac:spMkLst>
        </pc:spChg>
        <pc:spChg chg="mod">
          <ac:chgData name="Wigmore, Eleanor" userId="154496fa-10d7-4fd7-9fba-3614c367c37c" providerId="ADAL" clId="{AA3EDCC2-F595-42A0-8358-45CA77012066}" dt="2023-05-11T14:23:09.669" v="405" actId="1076"/>
          <ac:spMkLst>
            <pc:docMk/>
            <pc:sldMk cId="4136609356" sldId="284"/>
            <ac:spMk id="379" creationId="{F7EAE217-741A-4F90-954F-B4B5D66AAAA6}"/>
          </ac:spMkLst>
        </pc:spChg>
        <pc:spChg chg="del">
          <ac:chgData name="Wigmore, Eleanor" userId="154496fa-10d7-4fd7-9fba-3614c367c37c" providerId="ADAL" clId="{AA3EDCC2-F595-42A0-8358-45CA77012066}" dt="2023-05-11T14:23:16.505" v="408" actId="478"/>
          <ac:spMkLst>
            <pc:docMk/>
            <pc:sldMk cId="4136609356" sldId="284"/>
            <ac:spMk id="391" creationId="{3E0AE021-F1ED-4D74-9AE4-B9298CA18F6C}"/>
          </ac:spMkLst>
        </pc:spChg>
        <pc:spChg chg="mod">
          <ac:chgData name="Wigmore, Eleanor" userId="154496fa-10d7-4fd7-9fba-3614c367c37c" providerId="ADAL" clId="{AA3EDCC2-F595-42A0-8358-45CA77012066}" dt="2023-05-11T14:30:50.127" v="598" actId="14100"/>
          <ac:spMkLst>
            <pc:docMk/>
            <pc:sldMk cId="4136609356" sldId="284"/>
            <ac:spMk id="393" creationId="{0612C58C-3DAE-4ECC-8845-735A5F92275D}"/>
          </ac:spMkLst>
        </pc:spChg>
        <pc:spChg chg="mod">
          <ac:chgData name="Wigmore, Eleanor" userId="154496fa-10d7-4fd7-9fba-3614c367c37c" providerId="ADAL" clId="{AA3EDCC2-F595-42A0-8358-45CA77012066}" dt="2023-05-11T14:30:50.127" v="598" actId="14100"/>
          <ac:spMkLst>
            <pc:docMk/>
            <pc:sldMk cId="4136609356" sldId="284"/>
            <ac:spMk id="394" creationId="{CF57FFEC-D28B-49EC-8ACE-D0ED98CBD19B}"/>
          </ac:spMkLst>
        </pc:spChg>
        <pc:spChg chg="mod">
          <ac:chgData name="Wigmore, Eleanor" userId="154496fa-10d7-4fd7-9fba-3614c367c37c" providerId="ADAL" clId="{AA3EDCC2-F595-42A0-8358-45CA77012066}" dt="2023-05-11T14:30:50.127" v="598" actId="14100"/>
          <ac:spMkLst>
            <pc:docMk/>
            <pc:sldMk cId="4136609356" sldId="284"/>
            <ac:spMk id="395" creationId="{5DFA08CD-3890-4722-A192-D49ECA1BFF08}"/>
          </ac:spMkLst>
        </pc:spChg>
        <pc:spChg chg="mod">
          <ac:chgData name="Wigmore, Eleanor" userId="154496fa-10d7-4fd7-9fba-3614c367c37c" providerId="ADAL" clId="{AA3EDCC2-F595-42A0-8358-45CA77012066}" dt="2023-05-11T14:30:50.127" v="598" actId="14100"/>
          <ac:spMkLst>
            <pc:docMk/>
            <pc:sldMk cId="4136609356" sldId="284"/>
            <ac:spMk id="396" creationId="{4A599E02-5E4E-4746-BE2C-EAEF53FA6845}"/>
          </ac:spMkLst>
        </pc:spChg>
        <pc:spChg chg="mod">
          <ac:chgData name="Wigmore, Eleanor" userId="154496fa-10d7-4fd7-9fba-3614c367c37c" providerId="ADAL" clId="{AA3EDCC2-F595-42A0-8358-45CA77012066}" dt="2023-05-11T14:30:50.127" v="598" actId="14100"/>
          <ac:spMkLst>
            <pc:docMk/>
            <pc:sldMk cId="4136609356" sldId="284"/>
            <ac:spMk id="397" creationId="{010BFE82-DDEF-4AAD-A705-DFEACF544B77}"/>
          </ac:spMkLst>
        </pc:spChg>
        <pc:spChg chg="mod">
          <ac:chgData name="Wigmore, Eleanor" userId="154496fa-10d7-4fd7-9fba-3614c367c37c" providerId="ADAL" clId="{AA3EDCC2-F595-42A0-8358-45CA77012066}" dt="2023-05-24T12:47:28.102" v="3636" actId="1037"/>
          <ac:spMkLst>
            <pc:docMk/>
            <pc:sldMk cId="4136609356" sldId="284"/>
            <ac:spMk id="398" creationId="{6311EDDC-E098-429C-A864-60FF50E514F3}"/>
          </ac:spMkLst>
        </pc:spChg>
        <pc:spChg chg="mod">
          <ac:chgData name="Wigmore, Eleanor" userId="154496fa-10d7-4fd7-9fba-3614c367c37c" providerId="ADAL" clId="{AA3EDCC2-F595-42A0-8358-45CA77012066}" dt="2023-05-24T12:47:31.312" v="3642" actId="1038"/>
          <ac:spMkLst>
            <pc:docMk/>
            <pc:sldMk cId="4136609356" sldId="284"/>
            <ac:spMk id="399" creationId="{F4C9AF81-E01F-4400-A37E-1E58D164071A}"/>
          </ac:spMkLst>
        </pc:spChg>
        <pc:spChg chg="mod">
          <ac:chgData name="Wigmore, Eleanor" userId="154496fa-10d7-4fd7-9fba-3614c367c37c" providerId="ADAL" clId="{AA3EDCC2-F595-42A0-8358-45CA77012066}" dt="2023-05-24T12:47:13.066" v="3623" actId="1038"/>
          <ac:spMkLst>
            <pc:docMk/>
            <pc:sldMk cId="4136609356" sldId="284"/>
            <ac:spMk id="400" creationId="{D747CBF3-3290-4B78-B5F6-979279D0C93F}"/>
          </ac:spMkLst>
        </pc:spChg>
        <pc:spChg chg="mod">
          <ac:chgData name="Wigmore, Eleanor" userId="154496fa-10d7-4fd7-9fba-3614c367c37c" providerId="ADAL" clId="{AA3EDCC2-F595-42A0-8358-45CA77012066}" dt="2023-05-24T12:47:17.685" v="3630" actId="1037"/>
          <ac:spMkLst>
            <pc:docMk/>
            <pc:sldMk cId="4136609356" sldId="284"/>
            <ac:spMk id="401" creationId="{11D9CEA8-2CE6-44C5-A4D1-FCFBCFBEDE8C}"/>
          </ac:spMkLst>
        </pc:spChg>
        <pc:spChg chg="mod">
          <ac:chgData name="Wigmore, Eleanor" userId="154496fa-10d7-4fd7-9fba-3614c367c37c" providerId="ADAL" clId="{AA3EDCC2-F595-42A0-8358-45CA77012066}" dt="2023-05-24T12:47:08.002" v="3612" actId="1035"/>
          <ac:spMkLst>
            <pc:docMk/>
            <pc:sldMk cId="4136609356" sldId="284"/>
            <ac:spMk id="402" creationId="{61F03688-DE89-4EA3-8D96-7942AE970503}"/>
          </ac:spMkLst>
        </pc:spChg>
        <pc:spChg chg="mod">
          <ac:chgData name="Wigmore, Eleanor" userId="154496fa-10d7-4fd7-9fba-3614c367c37c" providerId="ADAL" clId="{AA3EDCC2-F595-42A0-8358-45CA77012066}" dt="2023-05-24T12:47:05.471" v="3608" actId="1035"/>
          <ac:spMkLst>
            <pc:docMk/>
            <pc:sldMk cId="4136609356" sldId="284"/>
            <ac:spMk id="403" creationId="{732C05FA-CB7F-44DD-AF0D-959A2080AF31}"/>
          </ac:spMkLst>
        </pc:spChg>
        <pc:spChg chg="mod">
          <ac:chgData name="Wigmore, Eleanor" userId="154496fa-10d7-4fd7-9fba-3614c367c37c" providerId="ADAL" clId="{AA3EDCC2-F595-42A0-8358-45CA77012066}" dt="2023-05-24T12:47:11.306" v="3621" actId="1035"/>
          <ac:spMkLst>
            <pc:docMk/>
            <pc:sldMk cId="4136609356" sldId="284"/>
            <ac:spMk id="404" creationId="{CC2284CB-8784-4B4D-86C4-6DC569C0D9DA}"/>
          </ac:spMkLst>
        </pc:spChg>
        <pc:spChg chg="mod">
          <ac:chgData name="Wigmore, Eleanor" userId="154496fa-10d7-4fd7-9fba-3614c367c37c" providerId="ADAL" clId="{AA3EDCC2-F595-42A0-8358-45CA77012066}" dt="2023-05-24T12:47:08.002" v="3612" actId="1035"/>
          <ac:spMkLst>
            <pc:docMk/>
            <pc:sldMk cId="4136609356" sldId="284"/>
            <ac:spMk id="405" creationId="{FE8369F9-5B9F-4B3F-86D0-76F7DFADD1A0}"/>
          </ac:spMkLst>
        </pc:spChg>
        <pc:spChg chg="mod">
          <ac:chgData name="Wigmore, Eleanor" userId="154496fa-10d7-4fd7-9fba-3614c367c37c" providerId="ADAL" clId="{AA3EDCC2-F595-42A0-8358-45CA77012066}" dt="2023-05-19T13:57:33.419" v="1224" actId="12788"/>
          <ac:spMkLst>
            <pc:docMk/>
            <pc:sldMk cId="4136609356" sldId="284"/>
            <ac:spMk id="412" creationId="{3417305D-A822-4E05-8310-5D642A94BF46}"/>
          </ac:spMkLst>
        </pc:spChg>
        <pc:grpChg chg="mod">
          <ac:chgData name="Wigmore, Eleanor" userId="154496fa-10d7-4fd7-9fba-3614c367c37c" providerId="ADAL" clId="{AA3EDCC2-F595-42A0-8358-45CA77012066}" dt="2023-05-19T13:57:22.621" v="1223" actId="1038"/>
          <ac:grpSpMkLst>
            <pc:docMk/>
            <pc:sldMk cId="4136609356" sldId="284"/>
            <ac:grpSpMk id="5" creationId="{FEA934F4-8C71-4B30-95FA-43C705B5EE5B}"/>
          </ac:grpSpMkLst>
        </pc:grpChg>
        <pc:grpChg chg="del mod">
          <ac:chgData name="Wigmore, Eleanor" userId="154496fa-10d7-4fd7-9fba-3614c367c37c" providerId="ADAL" clId="{AA3EDCC2-F595-42A0-8358-45CA77012066}" dt="2023-05-11T14:23:12.797" v="407" actId="478"/>
          <ac:grpSpMkLst>
            <pc:docMk/>
            <pc:sldMk cId="4136609356" sldId="284"/>
            <ac:grpSpMk id="29" creationId="{9473CEB6-F4A6-D2B7-5FDE-4ED46340F689}"/>
          </ac:grpSpMkLst>
        </pc:grpChg>
        <pc:grpChg chg="mod">
          <ac:chgData name="Wigmore, Eleanor" userId="154496fa-10d7-4fd7-9fba-3614c367c37c" providerId="ADAL" clId="{AA3EDCC2-F595-42A0-8358-45CA77012066}" dt="2023-05-11T14:30:50.127" v="598" actId="14100"/>
          <ac:grpSpMkLst>
            <pc:docMk/>
            <pc:sldMk cId="4136609356" sldId="284"/>
            <ac:grpSpMk id="392" creationId="{8C75BE46-5DCC-488C-AB3B-A19C997E631D}"/>
          </ac:grpSpMkLst>
        </pc:grpChg>
        <pc:picChg chg="add mod modCrop">
          <ac:chgData name="Wigmore, Eleanor" userId="154496fa-10d7-4fd7-9fba-3614c367c37c" providerId="ADAL" clId="{AA3EDCC2-F595-42A0-8358-45CA77012066}" dt="2023-05-24T11:12:05.950" v="2722" actId="1076"/>
          <ac:picMkLst>
            <pc:docMk/>
            <pc:sldMk cId="4136609356" sldId="284"/>
            <ac:picMk id="3" creationId="{2F723C05-8B0B-1B08-AEF4-C124DB79F567}"/>
          </ac:picMkLst>
        </pc:picChg>
        <pc:picChg chg="add mod modCrop">
          <ac:chgData name="Wigmore, Eleanor" userId="154496fa-10d7-4fd7-9fba-3614c367c37c" providerId="ADAL" clId="{AA3EDCC2-F595-42A0-8358-45CA77012066}" dt="2023-05-22T15:40:59.643" v="2428" actId="1076"/>
          <ac:picMkLst>
            <pc:docMk/>
            <pc:sldMk cId="4136609356" sldId="284"/>
            <ac:picMk id="10" creationId="{26908ECA-BD74-B6E7-4586-887776B2AD85}"/>
          </ac:picMkLst>
        </pc:picChg>
        <pc:picChg chg="mod">
          <ac:chgData name="Wigmore, Eleanor" userId="154496fa-10d7-4fd7-9fba-3614c367c37c" providerId="ADAL" clId="{AA3EDCC2-F595-42A0-8358-45CA77012066}" dt="2023-05-11T14:23:19.375" v="409" actId="1076"/>
          <ac:picMkLst>
            <pc:docMk/>
            <pc:sldMk cId="4136609356" sldId="284"/>
            <ac:picMk id="11" creationId="{02088055-ED32-406A-9C05-A31B59E9C764}"/>
          </ac:picMkLst>
        </pc:picChg>
        <pc:picChg chg="add del mod">
          <ac:chgData name="Wigmore, Eleanor" userId="154496fa-10d7-4fd7-9fba-3614c367c37c" providerId="ADAL" clId="{AA3EDCC2-F595-42A0-8358-45CA77012066}" dt="2023-05-19T14:47:21.502" v="1310" actId="478"/>
          <ac:picMkLst>
            <pc:docMk/>
            <pc:sldMk cId="4136609356" sldId="284"/>
            <ac:picMk id="12" creationId="{6C0C517D-174C-6952-8DD6-6F83ED8C2543}"/>
          </ac:picMkLst>
        </pc:picChg>
        <pc:picChg chg="add del mod">
          <ac:chgData name="Wigmore, Eleanor" userId="154496fa-10d7-4fd7-9fba-3614c367c37c" providerId="ADAL" clId="{AA3EDCC2-F595-42A0-8358-45CA77012066}" dt="2023-05-19T14:47:27.177" v="1313" actId="478"/>
          <ac:picMkLst>
            <pc:docMk/>
            <pc:sldMk cId="4136609356" sldId="284"/>
            <ac:picMk id="16" creationId="{8CADBF02-DC47-6D5A-1FBD-DDDFBA7D7C2D}"/>
          </ac:picMkLst>
        </pc:picChg>
        <pc:picChg chg="add del">
          <ac:chgData name="Wigmore, Eleanor" userId="154496fa-10d7-4fd7-9fba-3614c367c37c" providerId="ADAL" clId="{AA3EDCC2-F595-42A0-8358-45CA77012066}" dt="2023-05-19T14:47:35.484" v="1315" actId="478"/>
          <ac:picMkLst>
            <pc:docMk/>
            <pc:sldMk cId="4136609356" sldId="284"/>
            <ac:picMk id="18" creationId="{9E120DEF-C5B2-0763-485B-0217DAA7ED02}"/>
          </ac:picMkLst>
        </pc:picChg>
        <pc:picChg chg="mod">
          <ac:chgData name="Wigmore, Eleanor" userId="154496fa-10d7-4fd7-9fba-3614c367c37c" providerId="ADAL" clId="{AA3EDCC2-F595-42A0-8358-45CA77012066}" dt="2023-05-19T13:57:22.621" v="1223" actId="1038"/>
          <ac:picMkLst>
            <pc:docMk/>
            <pc:sldMk cId="4136609356" sldId="284"/>
            <ac:picMk id="20" creationId="{E477A115-B87D-4D8A-BA68-58232E11E8A6}"/>
          </ac:picMkLst>
        </pc:picChg>
        <pc:picChg chg="add del mod modCrop">
          <ac:chgData name="Wigmore, Eleanor" userId="154496fa-10d7-4fd7-9fba-3614c367c37c" providerId="ADAL" clId="{AA3EDCC2-F595-42A0-8358-45CA77012066}" dt="2023-05-22T15:39:39.491" v="2368" actId="478"/>
          <ac:picMkLst>
            <pc:docMk/>
            <pc:sldMk cId="4136609356" sldId="284"/>
            <ac:picMk id="21" creationId="{894A6265-B128-A613-FF99-57869CF9865F}"/>
          </ac:picMkLst>
        </pc:picChg>
        <pc:cxnChg chg="mod">
          <ac:chgData name="Wigmore, Eleanor" userId="154496fa-10d7-4fd7-9fba-3614c367c37c" providerId="ADAL" clId="{AA3EDCC2-F595-42A0-8358-45CA77012066}" dt="2023-05-19T13:57:22.621" v="1223" actId="1038"/>
          <ac:cxnSpMkLst>
            <pc:docMk/>
            <pc:sldMk cId="4136609356" sldId="284"/>
            <ac:cxnSpMk id="7" creationId="{F5A12402-5D66-437D-B038-DEA5EF6575E4}"/>
          </ac:cxnSpMkLst>
        </pc:cxnChg>
      </pc:sldChg>
      <pc:sldChg chg="addSp delSp modSp add mod">
        <pc:chgData name="Wigmore, Eleanor" userId="154496fa-10d7-4fd7-9fba-3614c367c37c" providerId="ADAL" clId="{AA3EDCC2-F595-42A0-8358-45CA77012066}" dt="2023-05-25T12:01:05.972" v="5975" actId="1037"/>
        <pc:sldMkLst>
          <pc:docMk/>
          <pc:sldMk cId="1575602334" sldId="285"/>
        </pc:sldMkLst>
        <pc:spChg chg="mod">
          <ac:chgData name="Wigmore, Eleanor" userId="154496fa-10d7-4fd7-9fba-3614c367c37c" providerId="ADAL" clId="{AA3EDCC2-F595-42A0-8358-45CA77012066}" dt="2023-05-19T13:56:53.473" v="1188" actId="20577"/>
          <ac:spMkLst>
            <pc:docMk/>
            <pc:sldMk cId="1575602334" sldId="285"/>
            <ac:spMk id="2" creationId="{87CEF116-AFC8-44FA-B66B-71B5263D6FFB}"/>
          </ac:spMkLst>
        </pc:spChg>
        <pc:spChg chg="mod">
          <ac:chgData name="Wigmore, Eleanor" userId="154496fa-10d7-4fd7-9fba-3614c367c37c" providerId="ADAL" clId="{AA3EDCC2-F595-42A0-8358-45CA77012066}" dt="2023-05-19T13:55:56.743" v="1132" actId="1037"/>
          <ac:spMkLst>
            <pc:docMk/>
            <pc:sldMk cId="1575602334" sldId="285"/>
            <ac:spMk id="6" creationId="{C0FCCDFA-1794-59FC-C9A5-7C99D01DB249}"/>
          </ac:spMkLst>
        </pc:spChg>
        <pc:spChg chg="add del mod">
          <ac:chgData name="Wigmore, Eleanor" userId="154496fa-10d7-4fd7-9fba-3614c367c37c" providerId="ADAL" clId="{AA3EDCC2-F595-42A0-8358-45CA77012066}" dt="2023-05-25T11:55:40.008" v="5428" actId="478"/>
          <ac:spMkLst>
            <pc:docMk/>
            <pc:sldMk cId="1575602334" sldId="285"/>
            <ac:spMk id="8" creationId="{539C5033-B3A2-0A23-1116-C513E3A826FD}"/>
          </ac:spMkLst>
        </pc:spChg>
        <pc:spChg chg="del mod">
          <ac:chgData name="Wigmore, Eleanor" userId="154496fa-10d7-4fd7-9fba-3614c367c37c" providerId="ADAL" clId="{AA3EDCC2-F595-42A0-8358-45CA77012066}" dt="2023-05-19T13:56:10.656" v="1144" actId="478"/>
          <ac:spMkLst>
            <pc:docMk/>
            <pc:sldMk cId="1575602334" sldId="285"/>
            <ac:spMk id="8" creationId="{F98612E4-52AB-28E9-775F-D8D1703E43C7}"/>
          </ac:spMkLst>
        </pc:spChg>
        <pc:spChg chg="mod">
          <ac:chgData name="Wigmore, Eleanor" userId="154496fa-10d7-4fd7-9fba-3614c367c37c" providerId="ADAL" clId="{AA3EDCC2-F595-42A0-8358-45CA77012066}" dt="2023-05-19T13:56:37.971" v="1167" actId="1037"/>
          <ac:spMkLst>
            <pc:docMk/>
            <pc:sldMk cId="1575602334" sldId="285"/>
            <ac:spMk id="9" creationId="{D4EE5172-2217-41F7-8E3D-EC1A0EBF19A8}"/>
          </ac:spMkLst>
        </pc:spChg>
        <pc:spChg chg="del mod">
          <ac:chgData name="Wigmore, Eleanor" userId="154496fa-10d7-4fd7-9fba-3614c367c37c" providerId="ADAL" clId="{AA3EDCC2-F595-42A0-8358-45CA77012066}" dt="2023-05-19T13:56:44.046" v="1170"/>
          <ac:spMkLst>
            <pc:docMk/>
            <pc:sldMk cId="1575602334" sldId="285"/>
            <ac:spMk id="10" creationId="{A6802D49-1F9B-FF7B-769D-7FEE2D61BE3F}"/>
          </ac:spMkLst>
        </pc:spChg>
        <pc:spChg chg="mod">
          <ac:chgData name="Wigmore, Eleanor" userId="154496fa-10d7-4fd7-9fba-3614c367c37c" providerId="ADAL" clId="{AA3EDCC2-F595-42A0-8358-45CA77012066}" dt="2023-05-19T13:55:43.867" v="1120" actId="1037"/>
          <ac:spMkLst>
            <pc:docMk/>
            <pc:sldMk cId="1575602334" sldId="285"/>
            <ac:spMk id="14" creationId="{3B9109D6-3F37-CC33-67CC-8D0BFD690839}"/>
          </ac:spMkLst>
        </pc:spChg>
        <pc:spChg chg="mod">
          <ac:chgData name="Wigmore, Eleanor" userId="154496fa-10d7-4fd7-9fba-3614c367c37c" providerId="ADAL" clId="{AA3EDCC2-F595-42A0-8358-45CA77012066}" dt="2023-05-19T13:55:43.867" v="1120" actId="1037"/>
          <ac:spMkLst>
            <pc:docMk/>
            <pc:sldMk cId="1575602334" sldId="285"/>
            <ac:spMk id="15" creationId="{60EFB81B-5BCF-9E0C-2934-3ED23274299F}"/>
          </ac:spMkLst>
        </pc:spChg>
        <pc:spChg chg="mod">
          <ac:chgData name="Wigmore, Eleanor" userId="154496fa-10d7-4fd7-9fba-3614c367c37c" providerId="ADAL" clId="{AA3EDCC2-F595-42A0-8358-45CA77012066}" dt="2023-05-19T13:55:43.867" v="1120" actId="1037"/>
          <ac:spMkLst>
            <pc:docMk/>
            <pc:sldMk cId="1575602334" sldId="285"/>
            <ac:spMk id="16" creationId="{72F055BA-73CD-8C5B-3037-E856A4DE495C}"/>
          </ac:spMkLst>
        </pc:spChg>
        <pc:spChg chg="mod">
          <ac:chgData name="Wigmore, Eleanor" userId="154496fa-10d7-4fd7-9fba-3614c367c37c" providerId="ADAL" clId="{AA3EDCC2-F595-42A0-8358-45CA77012066}" dt="2023-05-19T13:55:43.867" v="1120" actId="1037"/>
          <ac:spMkLst>
            <pc:docMk/>
            <pc:sldMk cId="1575602334" sldId="285"/>
            <ac:spMk id="17" creationId="{1EFFA305-ADAE-B00D-1298-6178B48A7A23}"/>
          </ac:spMkLst>
        </pc:spChg>
        <pc:spChg chg="mod">
          <ac:chgData name="Wigmore, Eleanor" userId="154496fa-10d7-4fd7-9fba-3614c367c37c" providerId="ADAL" clId="{AA3EDCC2-F595-42A0-8358-45CA77012066}" dt="2023-05-19T13:55:43.867" v="1120" actId="1037"/>
          <ac:spMkLst>
            <pc:docMk/>
            <pc:sldMk cId="1575602334" sldId="285"/>
            <ac:spMk id="18" creationId="{78B78235-15F0-0423-E0C9-3CAAB7BD103D}"/>
          </ac:spMkLst>
        </pc:spChg>
        <pc:spChg chg="mod">
          <ac:chgData name="Wigmore, Eleanor" userId="154496fa-10d7-4fd7-9fba-3614c367c37c" providerId="ADAL" clId="{AA3EDCC2-F595-42A0-8358-45CA77012066}" dt="2023-05-24T12:47:38.143" v="3650" actId="1037"/>
          <ac:spMkLst>
            <pc:docMk/>
            <pc:sldMk cId="1575602334" sldId="285"/>
            <ac:spMk id="19" creationId="{230096F3-A9B3-B4E9-450B-F1AA980670CB}"/>
          </ac:spMkLst>
        </pc:spChg>
        <pc:spChg chg="add mod">
          <ac:chgData name="Wigmore, Eleanor" userId="154496fa-10d7-4fd7-9fba-3614c367c37c" providerId="ADAL" clId="{AA3EDCC2-F595-42A0-8358-45CA77012066}" dt="2023-05-25T11:56:43.134" v="5621" actId="164"/>
          <ac:spMkLst>
            <pc:docMk/>
            <pc:sldMk cId="1575602334" sldId="285"/>
            <ac:spMk id="20" creationId="{23B0AFF9-151B-403C-B4EC-C7D03DA51057}"/>
          </ac:spMkLst>
        </pc:spChg>
        <pc:spChg chg="mod">
          <ac:chgData name="Wigmore, Eleanor" userId="154496fa-10d7-4fd7-9fba-3614c367c37c" providerId="ADAL" clId="{AA3EDCC2-F595-42A0-8358-45CA77012066}" dt="2023-05-24T12:47:40.708" v="3657" actId="1038"/>
          <ac:spMkLst>
            <pc:docMk/>
            <pc:sldMk cId="1575602334" sldId="285"/>
            <ac:spMk id="21" creationId="{E285D30C-B424-C096-9E79-51BCDA88BE56}"/>
          </ac:spMkLst>
        </pc:spChg>
        <pc:spChg chg="add mod">
          <ac:chgData name="Wigmore, Eleanor" userId="154496fa-10d7-4fd7-9fba-3614c367c37c" providerId="ADAL" clId="{AA3EDCC2-F595-42A0-8358-45CA77012066}" dt="2023-05-25T11:56:43.134" v="5621" actId="164"/>
          <ac:spMkLst>
            <pc:docMk/>
            <pc:sldMk cId="1575602334" sldId="285"/>
            <ac:spMk id="22" creationId="{1E23FCBC-DF70-27FA-30FB-D80D4225BA61}"/>
          </ac:spMkLst>
        </pc:spChg>
        <pc:spChg chg="mod">
          <ac:chgData name="Wigmore, Eleanor" userId="154496fa-10d7-4fd7-9fba-3614c367c37c" providerId="ADAL" clId="{AA3EDCC2-F595-42A0-8358-45CA77012066}" dt="2023-05-24T12:46:40.349" v="3565" actId="1038"/>
          <ac:spMkLst>
            <pc:docMk/>
            <pc:sldMk cId="1575602334" sldId="285"/>
            <ac:spMk id="23" creationId="{92ED7E0E-B28E-4B3C-9624-CD3703E3B7E0}"/>
          </ac:spMkLst>
        </pc:spChg>
        <pc:spChg chg="mod">
          <ac:chgData name="Wigmore, Eleanor" userId="154496fa-10d7-4fd7-9fba-3614c367c37c" providerId="ADAL" clId="{AA3EDCC2-F595-42A0-8358-45CA77012066}" dt="2023-05-24T12:46:35.534" v="3560" actId="1037"/>
          <ac:spMkLst>
            <pc:docMk/>
            <pc:sldMk cId="1575602334" sldId="285"/>
            <ac:spMk id="24" creationId="{DE6B2C9C-070A-C9A3-75A8-A4FCC18E5709}"/>
          </ac:spMkLst>
        </pc:spChg>
        <pc:spChg chg="mod">
          <ac:chgData name="Wigmore, Eleanor" userId="154496fa-10d7-4fd7-9fba-3614c367c37c" providerId="ADAL" clId="{AA3EDCC2-F595-42A0-8358-45CA77012066}" dt="2023-05-24T12:46:49.855" v="3575" actId="1035"/>
          <ac:spMkLst>
            <pc:docMk/>
            <pc:sldMk cId="1575602334" sldId="285"/>
            <ac:spMk id="25" creationId="{36D55E4B-7BDE-0AE5-96B2-98D64E052601}"/>
          </ac:spMkLst>
        </pc:spChg>
        <pc:spChg chg="mod">
          <ac:chgData name="Wigmore, Eleanor" userId="154496fa-10d7-4fd7-9fba-3614c367c37c" providerId="ADAL" clId="{AA3EDCC2-F595-42A0-8358-45CA77012066}" dt="2023-05-24T12:46:55.535" v="3586" actId="1035"/>
          <ac:spMkLst>
            <pc:docMk/>
            <pc:sldMk cId="1575602334" sldId="285"/>
            <ac:spMk id="26" creationId="{C680E34C-21BE-AC65-4E3A-6C418D0687C0}"/>
          </ac:spMkLst>
        </pc:spChg>
        <pc:spChg chg="mod">
          <ac:chgData name="Wigmore, Eleanor" userId="154496fa-10d7-4fd7-9fba-3614c367c37c" providerId="ADAL" clId="{AA3EDCC2-F595-42A0-8358-45CA77012066}" dt="2023-05-24T12:46:59.216" v="3597" actId="1035"/>
          <ac:spMkLst>
            <pc:docMk/>
            <pc:sldMk cId="1575602334" sldId="285"/>
            <ac:spMk id="27" creationId="{5BE83CCF-6B30-FF98-6061-209BB434B52D}"/>
          </ac:spMkLst>
        </pc:spChg>
        <pc:spChg chg="mod">
          <ac:chgData name="Wigmore, Eleanor" userId="154496fa-10d7-4fd7-9fba-3614c367c37c" providerId="ADAL" clId="{AA3EDCC2-F595-42A0-8358-45CA77012066}" dt="2023-05-24T12:46:49.855" v="3575" actId="1035"/>
          <ac:spMkLst>
            <pc:docMk/>
            <pc:sldMk cId="1575602334" sldId="285"/>
            <ac:spMk id="28" creationId="{E53FBE04-90EB-B456-F36C-56C4D63EE0A5}"/>
          </ac:spMkLst>
        </pc:spChg>
        <pc:spChg chg="add mod">
          <ac:chgData name="Wigmore, Eleanor" userId="154496fa-10d7-4fd7-9fba-3614c367c37c" providerId="ADAL" clId="{AA3EDCC2-F595-42A0-8358-45CA77012066}" dt="2023-05-25T11:56:43.134" v="5621" actId="164"/>
          <ac:spMkLst>
            <pc:docMk/>
            <pc:sldMk cId="1575602334" sldId="285"/>
            <ac:spMk id="29" creationId="{2BB9CAD7-F003-D52A-67C0-1260BA53C1B3}"/>
          </ac:spMkLst>
        </pc:spChg>
        <pc:spChg chg="add mod">
          <ac:chgData name="Wigmore, Eleanor" userId="154496fa-10d7-4fd7-9fba-3614c367c37c" providerId="ADAL" clId="{AA3EDCC2-F595-42A0-8358-45CA77012066}" dt="2023-05-25T11:56:43.134" v="5621" actId="164"/>
          <ac:spMkLst>
            <pc:docMk/>
            <pc:sldMk cId="1575602334" sldId="285"/>
            <ac:spMk id="30" creationId="{4772F65A-3963-E115-0046-C04EF77C73DE}"/>
          </ac:spMkLst>
        </pc:spChg>
        <pc:spChg chg="add del mod">
          <ac:chgData name="Wigmore, Eleanor" userId="154496fa-10d7-4fd7-9fba-3614c367c37c" providerId="ADAL" clId="{AA3EDCC2-F595-42A0-8358-45CA77012066}" dt="2023-05-25T11:56:43.134" v="5621" actId="164"/>
          <ac:spMkLst>
            <pc:docMk/>
            <pc:sldMk cId="1575602334" sldId="285"/>
            <ac:spMk id="31" creationId="{7E2001E7-693F-AD05-A315-3A4A552FC524}"/>
          </ac:spMkLst>
        </pc:spChg>
        <pc:spChg chg="add mod">
          <ac:chgData name="Wigmore, Eleanor" userId="154496fa-10d7-4fd7-9fba-3614c367c37c" providerId="ADAL" clId="{AA3EDCC2-F595-42A0-8358-45CA77012066}" dt="2023-05-19T13:55:43.867" v="1120" actId="1037"/>
          <ac:spMkLst>
            <pc:docMk/>
            <pc:sldMk cId="1575602334" sldId="285"/>
            <ac:spMk id="32" creationId="{9F5A768F-8DA6-347A-BCA6-E0C8775525DE}"/>
          </ac:spMkLst>
        </pc:spChg>
        <pc:spChg chg="add mod">
          <ac:chgData name="Wigmore, Eleanor" userId="154496fa-10d7-4fd7-9fba-3614c367c37c" providerId="ADAL" clId="{AA3EDCC2-F595-42A0-8358-45CA77012066}" dt="2023-05-19T13:55:43.867" v="1120" actId="1037"/>
          <ac:spMkLst>
            <pc:docMk/>
            <pc:sldMk cId="1575602334" sldId="285"/>
            <ac:spMk id="33" creationId="{290BFEAF-B4F8-25E6-8D78-5E4B0430C3AA}"/>
          </ac:spMkLst>
        </pc:spChg>
        <pc:spChg chg="add mod">
          <ac:chgData name="Wigmore, Eleanor" userId="154496fa-10d7-4fd7-9fba-3614c367c37c" providerId="ADAL" clId="{AA3EDCC2-F595-42A0-8358-45CA77012066}" dt="2023-05-19T13:55:43.867" v="1120" actId="1037"/>
          <ac:spMkLst>
            <pc:docMk/>
            <pc:sldMk cId="1575602334" sldId="285"/>
            <ac:spMk id="34" creationId="{C01AF0B2-D2AB-28E2-B5EB-DAEE516D3B9D}"/>
          </ac:spMkLst>
        </pc:spChg>
        <pc:spChg chg="add mod">
          <ac:chgData name="Wigmore, Eleanor" userId="154496fa-10d7-4fd7-9fba-3614c367c37c" providerId="ADAL" clId="{AA3EDCC2-F595-42A0-8358-45CA77012066}" dt="2023-05-19T13:55:43.867" v="1120" actId="1037"/>
          <ac:spMkLst>
            <pc:docMk/>
            <pc:sldMk cId="1575602334" sldId="285"/>
            <ac:spMk id="35" creationId="{BBF5AA42-7457-B2C9-E459-447497F52412}"/>
          </ac:spMkLst>
        </pc:spChg>
        <pc:spChg chg="add mod">
          <ac:chgData name="Wigmore, Eleanor" userId="154496fa-10d7-4fd7-9fba-3614c367c37c" providerId="ADAL" clId="{AA3EDCC2-F595-42A0-8358-45CA77012066}" dt="2023-05-25T11:56:43.134" v="5621" actId="164"/>
          <ac:spMkLst>
            <pc:docMk/>
            <pc:sldMk cId="1575602334" sldId="285"/>
            <ac:spMk id="36" creationId="{3A70C355-1525-93D6-77B3-694188DEF2B4}"/>
          </ac:spMkLst>
        </pc:spChg>
        <pc:spChg chg="add mod">
          <ac:chgData name="Wigmore, Eleanor" userId="154496fa-10d7-4fd7-9fba-3614c367c37c" providerId="ADAL" clId="{AA3EDCC2-F595-42A0-8358-45CA77012066}" dt="2023-05-19T13:55:43.867" v="1120" actId="1037"/>
          <ac:spMkLst>
            <pc:docMk/>
            <pc:sldMk cId="1575602334" sldId="285"/>
            <ac:spMk id="39" creationId="{3896AEEB-35D5-66BE-B4E0-6F356669993D}"/>
          </ac:spMkLst>
        </pc:spChg>
        <pc:spChg chg="add mod">
          <ac:chgData name="Wigmore, Eleanor" userId="154496fa-10d7-4fd7-9fba-3614c367c37c" providerId="ADAL" clId="{AA3EDCC2-F595-42A0-8358-45CA77012066}" dt="2023-05-25T11:56:43.134" v="5621" actId="164"/>
          <ac:spMkLst>
            <pc:docMk/>
            <pc:sldMk cId="1575602334" sldId="285"/>
            <ac:spMk id="40" creationId="{3CE044B5-D61E-E02C-0230-FC5E5D268A18}"/>
          </ac:spMkLst>
        </pc:spChg>
        <pc:spChg chg="add mod">
          <ac:chgData name="Wigmore, Eleanor" userId="154496fa-10d7-4fd7-9fba-3614c367c37c" providerId="ADAL" clId="{AA3EDCC2-F595-42A0-8358-45CA77012066}" dt="2023-05-25T11:56:43.134" v="5621" actId="164"/>
          <ac:spMkLst>
            <pc:docMk/>
            <pc:sldMk cId="1575602334" sldId="285"/>
            <ac:spMk id="41" creationId="{82C5C81B-9A9B-D0D0-145A-484AD626AC09}"/>
          </ac:spMkLst>
        </pc:spChg>
        <pc:spChg chg="add mod">
          <ac:chgData name="Wigmore, Eleanor" userId="154496fa-10d7-4fd7-9fba-3614c367c37c" providerId="ADAL" clId="{AA3EDCC2-F595-42A0-8358-45CA77012066}" dt="2023-05-25T11:56:43.134" v="5621" actId="164"/>
          <ac:spMkLst>
            <pc:docMk/>
            <pc:sldMk cId="1575602334" sldId="285"/>
            <ac:spMk id="42" creationId="{64BEFF27-8208-F62E-8F3B-ADDDDBC927C4}"/>
          </ac:spMkLst>
        </pc:spChg>
        <pc:spChg chg="add mod">
          <ac:chgData name="Wigmore, Eleanor" userId="154496fa-10d7-4fd7-9fba-3614c367c37c" providerId="ADAL" clId="{AA3EDCC2-F595-42A0-8358-45CA77012066}" dt="2023-05-25T11:56:43.134" v="5621" actId="164"/>
          <ac:spMkLst>
            <pc:docMk/>
            <pc:sldMk cId="1575602334" sldId="285"/>
            <ac:spMk id="44" creationId="{D8B5DBB1-E373-42D3-5287-9FF94564D6E0}"/>
          </ac:spMkLst>
        </pc:spChg>
        <pc:spChg chg="add mod">
          <ac:chgData name="Wigmore, Eleanor" userId="154496fa-10d7-4fd7-9fba-3614c367c37c" providerId="ADAL" clId="{AA3EDCC2-F595-42A0-8358-45CA77012066}" dt="2023-05-25T11:56:43.134" v="5621" actId="164"/>
          <ac:spMkLst>
            <pc:docMk/>
            <pc:sldMk cId="1575602334" sldId="285"/>
            <ac:spMk id="46" creationId="{32DE49FB-1712-7F99-B938-36464119C875}"/>
          </ac:spMkLst>
        </pc:spChg>
        <pc:spChg chg="add del mod">
          <ac:chgData name="Wigmore, Eleanor" userId="154496fa-10d7-4fd7-9fba-3614c367c37c" providerId="ADAL" clId="{AA3EDCC2-F595-42A0-8358-45CA77012066}" dt="2023-05-19T13:28:22.424" v="1057" actId="478"/>
          <ac:spMkLst>
            <pc:docMk/>
            <pc:sldMk cId="1575602334" sldId="285"/>
            <ac:spMk id="46" creationId="{EA4FFDBA-E7BD-1BDE-A7D8-ACCF7B64CF30}"/>
          </ac:spMkLst>
        </pc:spChg>
        <pc:spChg chg="add mod">
          <ac:chgData name="Wigmore, Eleanor" userId="154496fa-10d7-4fd7-9fba-3614c367c37c" providerId="ADAL" clId="{AA3EDCC2-F595-42A0-8358-45CA77012066}" dt="2023-05-25T11:56:43.134" v="5621" actId="164"/>
          <ac:spMkLst>
            <pc:docMk/>
            <pc:sldMk cId="1575602334" sldId="285"/>
            <ac:spMk id="48" creationId="{54030E54-DC52-E4C6-1A3D-6C1A185645E6}"/>
          </ac:spMkLst>
        </pc:spChg>
        <pc:spChg chg="add mod">
          <ac:chgData name="Wigmore, Eleanor" userId="154496fa-10d7-4fd7-9fba-3614c367c37c" providerId="ADAL" clId="{AA3EDCC2-F595-42A0-8358-45CA77012066}" dt="2023-05-25T12:01:05.972" v="5975" actId="1037"/>
          <ac:spMkLst>
            <pc:docMk/>
            <pc:sldMk cId="1575602334" sldId="285"/>
            <ac:spMk id="49" creationId="{5F71A8F8-C9CE-215D-5FCE-61F768395EA2}"/>
          </ac:spMkLst>
        </pc:spChg>
        <pc:spChg chg="add mod">
          <ac:chgData name="Wigmore, Eleanor" userId="154496fa-10d7-4fd7-9fba-3614c367c37c" providerId="ADAL" clId="{AA3EDCC2-F595-42A0-8358-45CA77012066}" dt="2023-05-25T12:01:05.972" v="5975" actId="1037"/>
          <ac:spMkLst>
            <pc:docMk/>
            <pc:sldMk cId="1575602334" sldId="285"/>
            <ac:spMk id="50" creationId="{167B5454-CCEB-CCAD-0466-3F56A6291C98}"/>
          </ac:spMkLst>
        </pc:spChg>
        <pc:spChg chg="add mod">
          <ac:chgData name="Wigmore, Eleanor" userId="154496fa-10d7-4fd7-9fba-3614c367c37c" providerId="ADAL" clId="{AA3EDCC2-F595-42A0-8358-45CA77012066}" dt="2023-05-25T12:01:05.972" v="5975" actId="1037"/>
          <ac:spMkLst>
            <pc:docMk/>
            <pc:sldMk cId="1575602334" sldId="285"/>
            <ac:spMk id="51" creationId="{D9F722E2-D7B3-FF0F-3407-FDC144D0BA96}"/>
          </ac:spMkLst>
        </pc:spChg>
        <pc:spChg chg="add del mod">
          <ac:chgData name="Wigmore, Eleanor" userId="154496fa-10d7-4fd7-9fba-3614c367c37c" providerId="ADAL" clId="{AA3EDCC2-F595-42A0-8358-45CA77012066}" dt="2023-05-19T13:55:24.879" v="1093" actId="478"/>
          <ac:spMkLst>
            <pc:docMk/>
            <pc:sldMk cId="1575602334" sldId="285"/>
            <ac:spMk id="52" creationId="{18DA4035-1487-4051-8B7E-FC932A4653E4}"/>
          </ac:spMkLst>
        </pc:spChg>
        <pc:spChg chg="add mod">
          <ac:chgData name="Wigmore, Eleanor" userId="154496fa-10d7-4fd7-9fba-3614c367c37c" providerId="ADAL" clId="{AA3EDCC2-F595-42A0-8358-45CA77012066}" dt="2023-05-25T11:56:43.134" v="5621" actId="164"/>
          <ac:spMkLst>
            <pc:docMk/>
            <pc:sldMk cId="1575602334" sldId="285"/>
            <ac:spMk id="52" creationId="{1A260B0B-0708-0F9C-A4D2-6FA28170B166}"/>
          </ac:spMkLst>
        </pc:spChg>
        <pc:spChg chg="add mod">
          <ac:chgData name="Wigmore, Eleanor" userId="154496fa-10d7-4fd7-9fba-3614c367c37c" providerId="ADAL" clId="{AA3EDCC2-F595-42A0-8358-45CA77012066}" dt="2023-05-25T11:42:13.793" v="4938" actId="1035"/>
          <ac:spMkLst>
            <pc:docMk/>
            <pc:sldMk cId="1575602334" sldId="285"/>
            <ac:spMk id="53" creationId="{24FD6D41-FAF2-8238-304A-267EA8FC5A84}"/>
          </ac:spMkLst>
        </pc:spChg>
        <pc:spChg chg="add mod">
          <ac:chgData name="Wigmore, Eleanor" userId="154496fa-10d7-4fd7-9fba-3614c367c37c" providerId="ADAL" clId="{AA3EDCC2-F595-42A0-8358-45CA77012066}" dt="2023-05-25T11:56:43.134" v="5621" actId="164"/>
          <ac:spMkLst>
            <pc:docMk/>
            <pc:sldMk cId="1575602334" sldId="285"/>
            <ac:spMk id="54" creationId="{12761C50-774E-1F4B-1FD8-E97D4E08AECD}"/>
          </ac:spMkLst>
        </pc:spChg>
        <pc:spChg chg="mod">
          <ac:chgData name="Wigmore, Eleanor" userId="154496fa-10d7-4fd7-9fba-3614c367c37c" providerId="ADAL" clId="{AA3EDCC2-F595-42A0-8358-45CA77012066}" dt="2023-05-19T13:56:37.971" v="1167" actId="1037"/>
          <ac:spMkLst>
            <pc:docMk/>
            <pc:sldMk cId="1575602334" sldId="285"/>
            <ac:spMk id="55" creationId="{0C13D1AF-2AE2-404C-ADBA-85D72E745637}"/>
          </ac:spMkLst>
        </pc:spChg>
        <pc:spChg chg="add mod">
          <ac:chgData name="Wigmore, Eleanor" userId="154496fa-10d7-4fd7-9fba-3614c367c37c" providerId="ADAL" clId="{AA3EDCC2-F595-42A0-8358-45CA77012066}" dt="2023-05-19T14:56:22.450" v="1453" actId="1035"/>
          <ac:spMkLst>
            <pc:docMk/>
            <pc:sldMk cId="1575602334" sldId="285"/>
            <ac:spMk id="56" creationId="{8B26A75F-A6A5-F862-2937-17C3B588D183}"/>
          </ac:spMkLst>
        </pc:spChg>
        <pc:spChg chg="add mod">
          <ac:chgData name="Wigmore, Eleanor" userId="154496fa-10d7-4fd7-9fba-3614c367c37c" providerId="ADAL" clId="{AA3EDCC2-F595-42A0-8358-45CA77012066}" dt="2023-05-25T11:56:43.134" v="5621" actId="164"/>
          <ac:spMkLst>
            <pc:docMk/>
            <pc:sldMk cId="1575602334" sldId="285"/>
            <ac:spMk id="57" creationId="{ECB17E79-BF9C-C00D-9EAE-32B1E3BD73EB}"/>
          </ac:spMkLst>
        </pc:spChg>
        <pc:spChg chg="add mod">
          <ac:chgData name="Wigmore, Eleanor" userId="154496fa-10d7-4fd7-9fba-3614c367c37c" providerId="ADAL" clId="{AA3EDCC2-F595-42A0-8358-45CA77012066}" dt="2023-05-22T15:34:31.013" v="2335" actId="14100"/>
          <ac:spMkLst>
            <pc:docMk/>
            <pc:sldMk cId="1575602334" sldId="285"/>
            <ac:spMk id="58" creationId="{8A92CC75-CDFE-8631-FE6B-BF688B9AE4C6}"/>
          </ac:spMkLst>
        </pc:spChg>
        <pc:spChg chg="add mod">
          <ac:chgData name="Wigmore, Eleanor" userId="154496fa-10d7-4fd7-9fba-3614c367c37c" providerId="ADAL" clId="{AA3EDCC2-F595-42A0-8358-45CA77012066}" dt="2023-05-25T11:56:43.134" v="5621" actId="164"/>
          <ac:spMkLst>
            <pc:docMk/>
            <pc:sldMk cId="1575602334" sldId="285"/>
            <ac:spMk id="59" creationId="{C956F0C8-9139-0667-4949-B31C44E5C639}"/>
          </ac:spMkLst>
        </pc:spChg>
        <pc:spChg chg="add mod">
          <ac:chgData name="Wigmore, Eleanor" userId="154496fa-10d7-4fd7-9fba-3614c367c37c" providerId="ADAL" clId="{AA3EDCC2-F595-42A0-8358-45CA77012066}" dt="2023-05-25T11:56:43.134" v="5621" actId="164"/>
          <ac:spMkLst>
            <pc:docMk/>
            <pc:sldMk cId="1575602334" sldId="285"/>
            <ac:spMk id="61" creationId="{98E2DB37-B7BD-AAE7-9C71-0A6384527226}"/>
          </ac:spMkLst>
        </pc:spChg>
        <pc:spChg chg="add mod">
          <ac:chgData name="Wigmore, Eleanor" userId="154496fa-10d7-4fd7-9fba-3614c367c37c" providerId="ADAL" clId="{AA3EDCC2-F595-42A0-8358-45CA77012066}" dt="2023-05-25T11:56:43.134" v="5621" actId="164"/>
          <ac:spMkLst>
            <pc:docMk/>
            <pc:sldMk cId="1575602334" sldId="285"/>
            <ac:spMk id="62" creationId="{80534167-8835-3080-6BC0-874B75FC5538}"/>
          </ac:spMkLst>
        </pc:spChg>
        <pc:spChg chg="add mod">
          <ac:chgData name="Wigmore, Eleanor" userId="154496fa-10d7-4fd7-9fba-3614c367c37c" providerId="ADAL" clId="{AA3EDCC2-F595-42A0-8358-45CA77012066}" dt="2023-05-25T11:56:43.134" v="5621" actId="164"/>
          <ac:spMkLst>
            <pc:docMk/>
            <pc:sldMk cId="1575602334" sldId="285"/>
            <ac:spMk id="63" creationId="{60A1EE0C-8322-EB12-8672-31278A867220}"/>
          </ac:spMkLst>
        </pc:spChg>
        <pc:spChg chg="add mod">
          <ac:chgData name="Wigmore, Eleanor" userId="154496fa-10d7-4fd7-9fba-3614c367c37c" providerId="ADAL" clId="{AA3EDCC2-F595-42A0-8358-45CA77012066}" dt="2023-05-25T11:56:43.134" v="5621" actId="164"/>
          <ac:spMkLst>
            <pc:docMk/>
            <pc:sldMk cId="1575602334" sldId="285"/>
            <ac:spMk id="320" creationId="{955A3E79-06BE-828F-EF02-F9C56475F3F9}"/>
          </ac:spMkLst>
        </pc:spChg>
        <pc:spChg chg="add mod">
          <ac:chgData name="Wigmore, Eleanor" userId="154496fa-10d7-4fd7-9fba-3614c367c37c" providerId="ADAL" clId="{AA3EDCC2-F595-42A0-8358-45CA77012066}" dt="2023-05-25T11:56:43.134" v="5621" actId="164"/>
          <ac:spMkLst>
            <pc:docMk/>
            <pc:sldMk cId="1575602334" sldId="285"/>
            <ac:spMk id="321" creationId="{2FBD0238-9070-B6B4-362C-67FBECAC1113}"/>
          </ac:spMkLst>
        </pc:spChg>
        <pc:spChg chg="add mod">
          <ac:chgData name="Wigmore, Eleanor" userId="154496fa-10d7-4fd7-9fba-3614c367c37c" providerId="ADAL" clId="{AA3EDCC2-F595-42A0-8358-45CA77012066}" dt="2023-05-25T11:56:43.134" v="5621" actId="164"/>
          <ac:spMkLst>
            <pc:docMk/>
            <pc:sldMk cId="1575602334" sldId="285"/>
            <ac:spMk id="322" creationId="{12CBA125-A34F-DC1A-3D2E-C6C10A24A1E4}"/>
          </ac:spMkLst>
        </pc:spChg>
        <pc:spChg chg="add mod">
          <ac:chgData name="Wigmore, Eleanor" userId="154496fa-10d7-4fd7-9fba-3614c367c37c" providerId="ADAL" clId="{AA3EDCC2-F595-42A0-8358-45CA77012066}" dt="2023-05-25T11:56:43.134" v="5621" actId="164"/>
          <ac:spMkLst>
            <pc:docMk/>
            <pc:sldMk cId="1575602334" sldId="285"/>
            <ac:spMk id="323" creationId="{A58994EE-02B3-2566-E3F9-0C0C8DC7C98C}"/>
          </ac:spMkLst>
        </pc:spChg>
        <pc:spChg chg="add mod">
          <ac:chgData name="Wigmore, Eleanor" userId="154496fa-10d7-4fd7-9fba-3614c367c37c" providerId="ADAL" clId="{AA3EDCC2-F595-42A0-8358-45CA77012066}" dt="2023-05-25T11:56:43.134" v="5621" actId="164"/>
          <ac:spMkLst>
            <pc:docMk/>
            <pc:sldMk cId="1575602334" sldId="285"/>
            <ac:spMk id="324" creationId="{CEE0143F-DD20-6BB5-80A4-2EDBDAD6F9C1}"/>
          </ac:spMkLst>
        </pc:spChg>
        <pc:spChg chg="add mod">
          <ac:chgData name="Wigmore, Eleanor" userId="154496fa-10d7-4fd7-9fba-3614c367c37c" providerId="ADAL" clId="{AA3EDCC2-F595-42A0-8358-45CA77012066}" dt="2023-05-25T11:56:43.134" v="5621" actId="164"/>
          <ac:spMkLst>
            <pc:docMk/>
            <pc:sldMk cId="1575602334" sldId="285"/>
            <ac:spMk id="325" creationId="{21E338FE-03EF-A66D-899A-AF3BEC4862BF}"/>
          </ac:spMkLst>
        </pc:spChg>
        <pc:spChg chg="add mod">
          <ac:chgData name="Wigmore, Eleanor" userId="154496fa-10d7-4fd7-9fba-3614c367c37c" providerId="ADAL" clId="{AA3EDCC2-F595-42A0-8358-45CA77012066}" dt="2023-05-25T11:56:43.134" v="5621" actId="164"/>
          <ac:spMkLst>
            <pc:docMk/>
            <pc:sldMk cId="1575602334" sldId="285"/>
            <ac:spMk id="326" creationId="{A60893E2-EF1D-26BE-C295-6F83E30E0907}"/>
          </ac:spMkLst>
        </pc:spChg>
        <pc:spChg chg="add mod">
          <ac:chgData name="Wigmore, Eleanor" userId="154496fa-10d7-4fd7-9fba-3614c367c37c" providerId="ADAL" clId="{AA3EDCC2-F595-42A0-8358-45CA77012066}" dt="2023-05-25T11:56:43.134" v="5621" actId="164"/>
          <ac:spMkLst>
            <pc:docMk/>
            <pc:sldMk cId="1575602334" sldId="285"/>
            <ac:spMk id="327" creationId="{2E7FDCFB-A111-5898-14E7-47EEA3C3B541}"/>
          </ac:spMkLst>
        </pc:spChg>
        <pc:spChg chg="add mod">
          <ac:chgData name="Wigmore, Eleanor" userId="154496fa-10d7-4fd7-9fba-3614c367c37c" providerId="ADAL" clId="{AA3EDCC2-F595-42A0-8358-45CA77012066}" dt="2023-05-25T11:56:43.134" v="5621" actId="164"/>
          <ac:spMkLst>
            <pc:docMk/>
            <pc:sldMk cId="1575602334" sldId="285"/>
            <ac:spMk id="328" creationId="{943639D0-F4DB-5A2E-0CF0-56D986B17F49}"/>
          </ac:spMkLst>
        </pc:spChg>
        <pc:spChg chg="add mod">
          <ac:chgData name="Wigmore, Eleanor" userId="154496fa-10d7-4fd7-9fba-3614c367c37c" providerId="ADAL" clId="{AA3EDCC2-F595-42A0-8358-45CA77012066}" dt="2023-05-25T11:56:43.134" v="5621" actId="164"/>
          <ac:spMkLst>
            <pc:docMk/>
            <pc:sldMk cId="1575602334" sldId="285"/>
            <ac:spMk id="329" creationId="{855ED45C-FFEF-5CEC-2416-2EFEA5189A42}"/>
          </ac:spMkLst>
        </pc:spChg>
        <pc:spChg chg="add mod">
          <ac:chgData name="Wigmore, Eleanor" userId="154496fa-10d7-4fd7-9fba-3614c367c37c" providerId="ADAL" clId="{AA3EDCC2-F595-42A0-8358-45CA77012066}" dt="2023-05-25T11:56:43.134" v="5621" actId="164"/>
          <ac:spMkLst>
            <pc:docMk/>
            <pc:sldMk cId="1575602334" sldId="285"/>
            <ac:spMk id="330" creationId="{34AB34E0-13EE-08DC-6032-6063A0D7A7C6}"/>
          </ac:spMkLst>
        </pc:spChg>
        <pc:spChg chg="add del mod">
          <ac:chgData name="Wigmore, Eleanor" userId="154496fa-10d7-4fd7-9fba-3614c367c37c" providerId="ADAL" clId="{AA3EDCC2-F595-42A0-8358-45CA77012066}" dt="2023-05-25T11:49:04.703" v="5111"/>
          <ac:spMkLst>
            <pc:docMk/>
            <pc:sldMk cId="1575602334" sldId="285"/>
            <ac:spMk id="331" creationId="{CF1A8B4C-D500-5EC9-96F6-408F0FFE912E}"/>
          </ac:spMkLst>
        </pc:spChg>
        <pc:spChg chg="add mod">
          <ac:chgData name="Wigmore, Eleanor" userId="154496fa-10d7-4fd7-9fba-3614c367c37c" providerId="ADAL" clId="{AA3EDCC2-F595-42A0-8358-45CA77012066}" dt="2023-05-25T11:56:43.134" v="5621" actId="164"/>
          <ac:spMkLst>
            <pc:docMk/>
            <pc:sldMk cId="1575602334" sldId="285"/>
            <ac:spMk id="332" creationId="{CDD958A5-0AD6-1C46-915D-FAA36ED479A6}"/>
          </ac:spMkLst>
        </pc:spChg>
        <pc:spChg chg="add mod">
          <ac:chgData name="Wigmore, Eleanor" userId="154496fa-10d7-4fd7-9fba-3614c367c37c" providerId="ADAL" clId="{AA3EDCC2-F595-42A0-8358-45CA77012066}" dt="2023-05-25T11:56:43.134" v="5621" actId="164"/>
          <ac:spMkLst>
            <pc:docMk/>
            <pc:sldMk cId="1575602334" sldId="285"/>
            <ac:spMk id="333" creationId="{4282B94D-6D00-01E9-6DF7-FBF2B03D7578}"/>
          </ac:spMkLst>
        </pc:spChg>
        <pc:spChg chg="add del mod">
          <ac:chgData name="Wigmore, Eleanor" userId="154496fa-10d7-4fd7-9fba-3614c367c37c" providerId="ADAL" clId="{AA3EDCC2-F595-42A0-8358-45CA77012066}" dt="2023-05-25T11:50:01.802" v="5273"/>
          <ac:spMkLst>
            <pc:docMk/>
            <pc:sldMk cId="1575602334" sldId="285"/>
            <ac:spMk id="334" creationId="{C08B24A1-F4D9-BF76-A22D-7992F3C5CCBB}"/>
          </ac:spMkLst>
        </pc:spChg>
        <pc:spChg chg="add mod">
          <ac:chgData name="Wigmore, Eleanor" userId="154496fa-10d7-4fd7-9fba-3614c367c37c" providerId="ADAL" clId="{AA3EDCC2-F595-42A0-8358-45CA77012066}" dt="2023-05-25T11:56:43.134" v="5621" actId="164"/>
          <ac:spMkLst>
            <pc:docMk/>
            <pc:sldMk cId="1575602334" sldId="285"/>
            <ac:spMk id="335" creationId="{C9FEFA27-B085-F340-7F63-40067B16D884}"/>
          </ac:spMkLst>
        </pc:spChg>
        <pc:spChg chg="add mod">
          <ac:chgData name="Wigmore, Eleanor" userId="154496fa-10d7-4fd7-9fba-3614c367c37c" providerId="ADAL" clId="{AA3EDCC2-F595-42A0-8358-45CA77012066}" dt="2023-05-25T11:56:43.134" v="5621" actId="164"/>
          <ac:spMkLst>
            <pc:docMk/>
            <pc:sldMk cId="1575602334" sldId="285"/>
            <ac:spMk id="336" creationId="{75B76E55-8702-AD9A-BD78-B93E48CC23F6}"/>
          </ac:spMkLst>
        </pc:spChg>
        <pc:spChg chg="add mod">
          <ac:chgData name="Wigmore, Eleanor" userId="154496fa-10d7-4fd7-9fba-3614c367c37c" providerId="ADAL" clId="{AA3EDCC2-F595-42A0-8358-45CA77012066}" dt="2023-05-25T11:56:43.134" v="5621" actId="164"/>
          <ac:spMkLst>
            <pc:docMk/>
            <pc:sldMk cId="1575602334" sldId="285"/>
            <ac:spMk id="337" creationId="{FC71A8BF-61E2-34BF-1878-066EAC4E8564}"/>
          </ac:spMkLst>
        </pc:spChg>
        <pc:spChg chg="add mod">
          <ac:chgData name="Wigmore, Eleanor" userId="154496fa-10d7-4fd7-9fba-3614c367c37c" providerId="ADAL" clId="{AA3EDCC2-F595-42A0-8358-45CA77012066}" dt="2023-05-25T11:56:43.134" v="5621" actId="164"/>
          <ac:spMkLst>
            <pc:docMk/>
            <pc:sldMk cId="1575602334" sldId="285"/>
            <ac:spMk id="338" creationId="{74385C25-46FB-1C35-E67A-22702AAA9188}"/>
          </ac:spMkLst>
        </pc:spChg>
        <pc:spChg chg="add mod">
          <ac:chgData name="Wigmore, Eleanor" userId="154496fa-10d7-4fd7-9fba-3614c367c37c" providerId="ADAL" clId="{AA3EDCC2-F595-42A0-8358-45CA77012066}" dt="2023-05-25T11:56:43.134" v="5621" actId="164"/>
          <ac:spMkLst>
            <pc:docMk/>
            <pc:sldMk cId="1575602334" sldId="285"/>
            <ac:spMk id="339" creationId="{C8CF8F95-673F-B221-459E-D858748B364D}"/>
          </ac:spMkLst>
        </pc:spChg>
        <pc:spChg chg="add mod">
          <ac:chgData name="Wigmore, Eleanor" userId="154496fa-10d7-4fd7-9fba-3614c367c37c" providerId="ADAL" clId="{AA3EDCC2-F595-42A0-8358-45CA77012066}" dt="2023-05-25T11:56:43.134" v="5621" actId="164"/>
          <ac:spMkLst>
            <pc:docMk/>
            <pc:sldMk cId="1575602334" sldId="285"/>
            <ac:spMk id="340" creationId="{131C1213-F773-9A0A-D21E-47ACA826DEFB}"/>
          </ac:spMkLst>
        </pc:spChg>
        <pc:spChg chg="add mod">
          <ac:chgData name="Wigmore, Eleanor" userId="154496fa-10d7-4fd7-9fba-3614c367c37c" providerId="ADAL" clId="{AA3EDCC2-F595-42A0-8358-45CA77012066}" dt="2023-05-25T11:56:43.134" v="5621" actId="164"/>
          <ac:spMkLst>
            <pc:docMk/>
            <pc:sldMk cId="1575602334" sldId="285"/>
            <ac:spMk id="341" creationId="{4A0BD3C0-DECB-ECE9-E7B8-A703091FC46E}"/>
          </ac:spMkLst>
        </pc:spChg>
        <pc:spChg chg="add mod">
          <ac:chgData name="Wigmore, Eleanor" userId="154496fa-10d7-4fd7-9fba-3614c367c37c" providerId="ADAL" clId="{AA3EDCC2-F595-42A0-8358-45CA77012066}" dt="2023-05-25T11:56:43.134" v="5621" actId="164"/>
          <ac:spMkLst>
            <pc:docMk/>
            <pc:sldMk cId="1575602334" sldId="285"/>
            <ac:spMk id="342" creationId="{FEC344F9-BD5C-068E-CE86-04A817BA42C7}"/>
          </ac:spMkLst>
        </pc:spChg>
        <pc:spChg chg="add mod">
          <ac:chgData name="Wigmore, Eleanor" userId="154496fa-10d7-4fd7-9fba-3614c367c37c" providerId="ADAL" clId="{AA3EDCC2-F595-42A0-8358-45CA77012066}" dt="2023-05-25T11:56:43.134" v="5621" actId="164"/>
          <ac:spMkLst>
            <pc:docMk/>
            <pc:sldMk cId="1575602334" sldId="285"/>
            <ac:spMk id="343" creationId="{02B8D4FD-AFD8-3C3D-B11B-1E004426114B}"/>
          </ac:spMkLst>
        </pc:spChg>
        <pc:spChg chg="add mod">
          <ac:chgData name="Wigmore, Eleanor" userId="154496fa-10d7-4fd7-9fba-3614c367c37c" providerId="ADAL" clId="{AA3EDCC2-F595-42A0-8358-45CA77012066}" dt="2023-05-25T11:56:43.134" v="5621" actId="164"/>
          <ac:spMkLst>
            <pc:docMk/>
            <pc:sldMk cId="1575602334" sldId="285"/>
            <ac:spMk id="344" creationId="{30F5AA26-BE8E-5FD8-51C2-083CF1E72F79}"/>
          </ac:spMkLst>
        </pc:spChg>
        <pc:spChg chg="add mod">
          <ac:chgData name="Wigmore, Eleanor" userId="154496fa-10d7-4fd7-9fba-3614c367c37c" providerId="ADAL" clId="{AA3EDCC2-F595-42A0-8358-45CA77012066}" dt="2023-05-25T11:56:43.134" v="5621" actId="164"/>
          <ac:spMkLst>
            <pc:docMk/>
            <pc:sldMk cId="1575602334" sldId="285"/>
            <ac:spMk id="345" creationId="{55785445-C6DD-CA4B-6CFC-7DEADD124BBF}"/>
          </ac:spMkLst>
        </pc:spChg>
        <pc:spChg chg="add mod">
          <ac:chgData name="Wigmore, Eleanor" userId="154496fa-10d7-4fd7-9fba-3614c367c37c" providerId="ADAL" clId="{AA3EDCC2-F595-42A0-8358-45CA77012066}" dt="2023-05-25T11:56:43.134" v="5621" actId="164"/>
          <ac:spMkLst>
            <pc:docMk/>
            <pc:sldMk cId="1575602334" sldId="285"/>
            <ac:spMk id="346" creationId="{99E6679D-DA4B-6CBD-748F-1B7D57ACBA39}"/>
          </ac:spMkLst>
        </pc:spChg>
        <pc:spChg chg="add mod">
          <ac:chgData name="Wigmore, Eleanor" userId="154496fa-10d7-4fd7-9fba-3614c367c37c" providerId="ADAL" clId="{AA3EDCC2-F595-42A0-8358-45CA77012066}" dt="2023-05-25T11:56:43.134" v="5621" actId="164"/>
          <ac:spMkLst>
            <pc:docMk/>
            <pc:sldMk cId="1575602334" sldId="285"/>
            <ac:spMk id="347" creationId="{E69010B1-2174-17A9-93BF-CFC924B62212}"/>
          </ac:spMkLst>
        </pc:spChg>
        <pc:spChg chg="add mod">
          <ac:chgData name="Wigmore, Eleanor" userId="154496fa-10d7-4fd7-9fba-3614c367c37c" providerId="ADAL" clId="{AA3EDCC2-F595-42A0-8358-45CA77012066}" dt="2023-05-25T11:56:43.134" v="5621" actId="164"/>
          <ac:spMkLst>
            <pc:docMk/>
            <pc:sldMk cId="1575602334" sldId="285"/>
            <ac:spMk id="348" creationId="{BF8F40A6-7002-12C8-7DB4-92D079227193}"/>
          </ac:spMkLst>
        </pc:spChg>
        <pc:spChg chg="add mod">
          <ac:chgData name="Wigmore, Eleanor" userId="154496fa-10d7-4fd7-9fba-3614c367c37c" providerId="ADAL" clId="{AA3EDCC2-F595-42A0-8358-45CA77012066}" dt="2023-05-25T11:56:43.134" v="5621" actId="164"/>
          <ac:spMkLst>
            <pc:docMk/>
            <pc:sldMk cId="1575602334" sldId="285"/>
            <ac:spMk id="349" creationId="{1581E613-C731-B235-7EEC-44EDA6A148EC}"/>
          </ac:spMkLst>
        </pc:spChg>
        <pc:spChg chg="add mod">
          <ac:chgData name="Wigmore, Eleanor" userId="154496fa-10d7-4fd7-9fba-3614c367c37c" providerId="ADAL" clId="{AA3EDCC2-F595-42A0-8358-45CA77012066}" dt="2023-05-25T11:56:43.134" v="5621" actId="164"/>
          <ac:spMkLst>
            <pc:docMk/>
            <pc:sldMk cId="1575602334" sldId="285"/>
            <ac:spMk id="350" creationId="{8C1AA41A-01BF-7136-5B5F-A6454B6A02F2}"/>
          </ac:spMkLst>
        </pc:spChg>
        <pc:spChg chg="add mod">
          <ac:chgData name="Wigmore, Eleanor" userId="154496fa-10d7-4fd7-9fba-3614c367c37c" providerId="ADAL" clId="{AA3EDCC2-F595-42A0-8358-45CA77012066}" dt="2023-05-25T11:56:43.134" v="5621" actId="164"/>
          <ac:spMkLst>
            <pc:docMk/>
            <pc:sldMk cId="1575602334" sldId="285"/>
            <ac:spMk id="351" creationId="{2219B49C-0C03-C723-9B42-8C2635243B42}"/>
          </ac:spMkLst>
        </pc:spChg>
        <pc:spChg chg="add mod">
          <ac:chgData name="Wigmore, Eleanor" userId="154496fa-10d7-4fd7-9fba-3614c367c37c" providerId="ADAL" clId="{AA3EDCC2-F595-42A0-8358-45CA77012066}" dt="2023-05-25T11:56:43.134" v="5621" actId="164"/>
          <ac:spMkLst>
            <pc:docMk/>
            <pc:sldMk cId="1575602334" sldId="285"/>
            <ac:spMk id="352" creationId="{644F64E2-C4A1-EEF1-02F8-0D306895989A}"/>
          </ac:spMkLst>
        </pc:spChg>
        <pc:spChg chg="add mod">
          <ac:chgData name="Wigmore, Eleanor" userId="154496fa-10d7-4fd7-9fba-3614c367c37c" providerId="ADAL" clId="{AA3EDCC2-F595-42A0-8358-45CA77012066}" dt="2023-05-25T11:56:43.134" v="5621" actId="164"/>
          <ac:spMkLst>
            <pc:docMk/>
            <pc:sldMk cId="1575602334" sldId="285"/>
            <ac:spMk id="353" creationId="{33A5AB3E-B952-EBBC-D6DB-BA8B938BAAA9}"/>
          </ac:spMkLst>
        </pc:spChg>
        <pc:spChg chg="add mod">
          <ac:chgData name="Wigmore, Eleanor" userId="154496fa-10d7-4fd7-9fba-3614c367c37c" providerId="ADAL" clId="{AA3EDCC2-F595-42A0-8358-45CA77012066}" dt="2023-05-25T11:56:43.134" v="5621" actId="164"/>
          <ac:spMkLst>
            <pc:docMk/>
            <pc:sldMk cId="1575602334" sldId="285"/>
            <ac:spMk id="354" creationId="{84B1DB04-D374-4B44-19EF-42F1CE67CB36}"/>
          </ac:spMkLst>
        </pc:spChg>
        <pc:spChg chg="add mod">
          <ac:chgData name="Wigmore, Eleanor" userId="154496fa-10d7-4fd7-9fba-3614c367c37c" providerId="ADAL" clId="{AA3EDCC2-F595-42A0-8358-45CA77012066}" dt="2023-05-25T11:56:43.134" v="5621" actId="164"/>
          <ac:spMkLst>
            <pc:docMk/>
            <pc:sldMk cId="1575602334" sldId="285"/>
            <ac:spMk id="355" creationId="{66B33BC7-4811-D623-051B-EE2666AB7726}"/>
          </ac:spMkLst>
        </pc:spChg>
        <pc:spChg chg="add mod">
          <ac:chgData name="Wigmore, Eleanor" userId="154496fa-10d7-4fd7-9fba-3614c367c37c" providerId="ADAL" clId="{AA3EDCC2-F595-42A0-8358-45CA77012066}" dt="2023-05-25T11:56:43.134" v="5621" actId="164"/>
          <ac:spMkLst>
            <pc:docMk/>
            <pc:sldMk cId="1575602334" sldId="285"/>
            <ac:spMk id="356" creationId="{8FB60427-1E94-649F-955E-CC9432402BA2}"/>
          </ac:spMkLst>
        </pc:spChg>
        <pc:spChg chg="add mod">
          <ac:chgData name="Wigmore, Eleanor" userId="154496fa-10d7-4fd7-9fba-3614c367c37c" providerId="ADAL" clId="{AA3EDCC2-F595-42A0-8358-45CA77012066}" dt="2023-05-25T11:56:43.134" v="5621" actId="164"/>
          <ac:spMkLst>
            <pc:docMk/>
            <pc:sldMk cId="1575602334" sldId="285"/>
            <ac:spMk id="357" creationId="{FC284D50-2F2D-3C70-98C2-483477FA42B0}"/>
          </ac:spMkLst>
        </pc:spChg>
        <pc:spChg chg="add mod">
          <ac:chgData name="Wigmore, Eleanor" userId="154496fa-10d7-4fd7-9fba-3614c367c37c" providerId="ADAL" clId="{AA3EDCC2-F595-42A0-8358-45CA77012066}" dt="2023-05-25T11:56:43.134" v="5621" actId="164"/>
          <ac:spMkLst>
            <pc:docMk/>
            <pc:sldMk cId="1575602334" sldId="285"/>
            <ac:spMk id="358" creationId="{8058340B-C7DF-3EA1-5FE3-2F08C78F6B4B}"/>
          </ac:spMkLst>
        </pc:spChg>
        <pc:spChg chg="add mod">
          <ac:chgData name="Wigmore, Eleanor" userId="154496fa-10d7-4fd7-9fba-3614c367c37c" providerId="ADAL" clId="{AA3EDCC2-F595-42A0-8358-45CA77012066}" dt="2023-05-25T11:56:43.134" v="5621" actId="164"/>
          <ac:spMkLst>
            <pc:docMk/>
            <pc:sldMk cId="1575602334" sldId="285"/>
            <ac:spMk id="359" creationId="{C7E014A2-A978-30B2-196C-B6851602017C}"/>
          </ac:spMkLst>
        </pc:spChg>
        <pc:spChg chg="add mod">
          <ac:chgData name="Wigmore, Eleanor" userId="154496fa-10d7-4fd7-9fba-3614c367c37c" providerId="ADAL" clId="{AA3EDCC2-F595-42A0-8358-45CA77012066}" dt="2023-05-25T11:56:43.134" v="5621" actId="164"/>
          <ac:spMkLst>
            <pc:docMk/>
            <pc:sldMk cId="1575602334" sldId="285"/>
            <ac:spMk id="360" creationId="{2A061BD6-CF39-BD19-D999-D8979EAE371B}"/>
          </ac:spMkLst>
        </pc:spChg>
        <pc:spChg chg="add mod">
          <ac:chgData name="Wigmore, Eleanor" userId="154496fa-10d7-4fd7-9fba-3614c367c37c" providerId="ADAL" clId="{AA3EDCC2-F595-42A0-8358-45CA77012066}" dt="2023-05-25T11:56:43.134" v="5621" actId="164"/>
          <ac:spMkLst>
            <pc:docMk/>
            <pc:sldMk cId="1575602334" sldId="285"/>
            <ac:spMk id="361" creationId="{1DF497A3-9822-913A-85D5-7F8E5B572BA0}"/>
          </ac:spMkLst>
        </pc:spChg>
        <pc:spChg chg="add mod">
          <ac:chgData name="Wigmore, Eleanor" userId="154496fa-10d7-4fd7-9fba-3614c367c37c" providerId="ADAL" clId="{AA3EDCC2-F595-42A0-8358-45CA77012066}" dt="2023-05-25T11:56:43.134" v="5621" actId="164"/>
          <ac:spMkLst>
            <pc:docMk/>
            <pc:sldMk cId="1575602334" sldId="285"/>
            <ac:spMk id="362" creationId="{09EE1676-F28B-7026-C1BC-5DA8B6BD865A}"/>
          </ac:spMkLst>
        </pc:spChg>
        <pc:spChg chg="add mod">
          <ac:chgData name="Wigmore, Eleanor" userId="154496fa-10d7-4fd7-9fba-3614c367c37c" providerId="ADAL" clId="{AA3EDCC2-F595-42A0-8358-45CA77012066}" dt="2023-05-25T12:00:54.059" v="5922" actId="164"/>
          <ac:spMkLst>
            <pc:docMk/>
            <pc:sldMk cId="1575602334" sldId="285"/>
            <ac:spMk id="365" creationId="{CBAF4C9C-269A-36FE-9E74-8BEA6159FEF5}"/>
          </ac:spMkLst>
        </pc:spChg>
        <pc:spChg chg="add mod">
          <ac:chgData name="Wigmore, Eleanor" userId="154496fa-10d7-4fd7-9fba-3614c367c37c" providerId="ADAL" clId="{AA3EDCC2-F595-42A0-8358-45CA77012066}" dt="2023-05-25T12:00:54.059" v="5922" actId="164"/>
          <ac:spMkLst>
            <pc:docMk/>
            <pc:sldMk cId="1575602334" sldId="285"/>
            <ac:spMk id="366" creationId="{A28C456D-693B-ED05-3FEE-3D55F9AB153C}"/>
          </ac:spMkLst>
        </pc:spChg>
        <pc:spChg chg="add mod">
          <ac:chgData name="Wigmore, Eleanor" userId="154496fa-10d7-4fd7-9fba-3614c367c37c" providerId="ADAL" clId="{AA3EDCC2-F595-42A0-8358-45CA77012066}" dt="2023-05-25T12:00:30.363" v="5918" actId="1038"/>
          <ac:spMkLst>
            <pc:docMk/>
            <pc:sldMk cId="1575602334" sldId="285"/>
            <ac:spMk id="367" creationId="{1BB2BCB9-4665-7C92-65BE-CC9560C4333D}"/>
          </ac:spMkLst>
        </pc:spChg>
        <pc:spChg chg="add mod">
          <ac:chgData name="Wigmore, Eleanor" userId="154496fa-10d7-4fd7-9fba-3614c367c37c" providerId="ADAL" clId="{AA3EDCC2-F595-42A0-8358-45CA77012066}" dt="2023-05-25T12:00:30.363" v="5918" actId="1038"/>
          <ac:spMkLst>
            <pc:docMk/>
            <pc:sldMk cId="1575602334" sldId="285"/>
            <ac:spMk id="368" creationId="{9FFD20FC-E946-1599-A1D4-2B14A85591EE}"/>
          </ac:spMkLst>
        </pc:spChg>
        <pc:spChg chg="add mod">
          <ac:chgData name="Wigmore, Eleanor" userId="154496fa-10d7-4fd7-9fba-3614c367c37c" providerId="ADAL" clId="{AA3EDCC2-F595-42A0-8358-45CA77012066}" dt="2023-05-25T12:00:54.059" v="5922" actId="164"/>
          <ac:spMkLst>
            <pc:docMk/>
            <pc:sldMk cId="1575602334" sldId="285"/>
            <ac:spMk id="369" creationId="{42EBA218-E695-48E0-4D61-2CC46D09F0EF}"/>
          </ac:spMkLst>
        </pc:spChg>
        <pc:spChg chg="add mod">
          <ac:chgData name="Wigmore, Eleanor" userId="154496fa-10d7-4fd7-9fba-3614c367c37c" providerId="ADAL" clId="{AA3EDCC2-F595-42A0-8358-45CA77012066}" dt="2023-05-25T12:00:54.059" v="5922" actId="164"/>
          <ac:spMkLst>
            <pc:docMk/>
            <pc:sldMk cId="1575602334" sldId="285"/>
            <ac:spMk id="370" creationId="{AA728A0D-6807-DD81-9EC8-98DC16BF9708}"/>
          </ac:spMkLst>
        </pc:spChg>
        <pc:spChg chg="add mod">
          <ac:chgData name="Wigmore, Eleanor" userId="154496fa-10d7-4fd7-9fba-3614c367c37c" providerId="ADAL" clId="{AA3EDCC2-F595-42A0-8358-45CA77012066}" dt="2023-05-25T12:00:54.059" v="5922" actId="164"/>
          <ac:spMkLst>
            <pc:docMk/>
            <pc:sldMk cId="1575602334" sldId="285"/>
            <ac:spMk id="371" creationId="{C0D36A63-3CE6-D13A-44CF-5B92A1120628}"/>
          </ac:spMkLst>
        </pc:spChg>
        <pc:spChg chg="add mod">
          <ac:chgData name="Wigmore, Eleanor" userId="154496fa-10d7-4fd7-9fba-3614c367c37c" providerId="ADAL" clId="{AA3EDCC2-F595-42A0-8358-45CA77012066}" dt="2023-05-25T12:00:54.059" v="5922" actId="164"/>
          <ac:spMkLst>
            <pc:docMk/>
            <pc:sldMk cId="1575602334" sldId="285"/>
            <ac:spMk id="372" creationId="{B5692818-C5CE-AA67-3A9D-17E72153C31C}"/>
          </ac:spMkLst>
        </pc:spChg>
        <pc:spChg chg="mod">
          <ac:chgData name="Wigmore, Eleanor" userId="154496fa-10d7-4fd7-9fba-3614c367c37c" providerId="ADAL" clId="{AA3EDCC2-F595-42A0-8358-45CA77012066}" dt="2023-05-19T13:55:43.867" v="1120" actId="1037"/>
          <ac:spMkLst>
            <pc:docMk/>
            <pc:sldMk cId="1575602334" sldId="285"/>
            <ac:spMk id="379" creationId="{F7EAE217-741A-4F90-954F-B4B5D66AAAA6}"/>
          </ac:spMkLst>
        </pc:spChg>
        <pc:spChg chg="mod">
          <ac:chgData name="Wigmore, Eleanor" userId="154496fa-10d7-4fd7-9fba-3614c367c37c" providerId="ADAL" clId="{AA3EDCC2-F595-42A0-8358-45CA77012066}" dt="2023-05-19T13:55:43.867" v="1120" actId="1037"/>
          <ac:spMkLst>
            <pc:docMk/>
            <pc:sldMk cId="1575602334" sldId="285"/>
            <ac:spMk id="406" creationId="{0843C592-126D-4803-9804-8DD94C7B7085}"/>
          </ac:spMkLst>
        </pc:spChg>
        <pc:spChg chg="del mod">
          <ac:chgData name="Wigmore, Eleanor" userId="154496fa-10d7-4fd7-9fba-3614c367c37c" providerId="ADAL" clId="{AA3EDCC2-F595-42A0-8358-45CA77012066}" dt="2023-05-25T11:48:41.156" v="5105" actId="478"/>
          <ac:spMkLst>
            <pc:docMk/>
            <pc:sldMk cId="1575602334" sldId="285"/>
            <ac:spMk id="412" creationId="{3417305D-A822-4E05-8310-5D642A94BF46}"/>
          </ac:spMkLst>
        </pc:spChg>
        <pc:grpChg chg="del">
          <ac:chgData name="Wigmore, Eleanor" userId="154496fa-10d7-4fd7-9fba-3614c367c37c" providerId="ADAL" clId="{AA3EDCC2-F595-42A0-8358-45CA77012066}" dt="2023-05-11T14:31:09.705" v="602" actId="478"/>
          <ac:grpSpMkLst>
            <pc:docMk/>
            <pc:sldMk cId="1575602334" sldId="285"/>
            <ac:grpSpMk id="5" creationId="{FEA934F4-8C71-4B30-95FA-43C705B5EE5B}"/>
          </ac:grpSpMkLst>
        </pc:grpChg>
        <pc:grpChg chg="add mod">
          <ac:chgData name="Wigmore, Eleanor" userId="154496fa-10d7-4fd7-9fba-3614c367c37c" providerId="ADAL" clId="{AA3EDCC2-F595-42A0-8358-45CA77012066}" dt="2023-05-19T13:55:43.867" v="1120" actId="1037"/>
          <ac:grpSpMkLst>
            <pc:docMk/>
            <pc:sldMk cId="1575602334" sldId="285"/>
            <ac:grpSpMk id="13" creationId="{427551DD-DC2B-877D-021E-5F59541F329D}"/>
          </ac:grpSpMkLst>
        </pc:grpChg>
        <pc:grpChg chg="add mod">
          <ac:chgData name="Wigmore, Eleanor" userId="154496fa-10d7-4fd7-9fba-3614c367c37c" providerId="ADAL" clId="{AA3EDCC2-F595-42A0-8358-45CA77012066}" dt="2023-05-25T11:56:31.707" v="5618" actId="164"/>
          <ac:grpSpMkLst>
            <pc:docMk/>
            <pc:sldMk cId="1575602334" sldId="285"/>
            <ac:grpSpMk id="363" creationId="{3402DCB1-09DA-F5B2-13EB-B507D226EFAD}"/>
          </ac:grpSpMkLst>
        </pc:grpChg>
        <pc:grpChg chg="add mod">
          <ac:chgData name="Wigmore, Eleanor" userId="154496fa-10d7-4fd7-9fba-3614c367c37c" providerId="ADAL" clId="{AA3EDCC2-F595-42A0-8358-45CA77012066}" dt="2023-05-25T11:56:49.863" v="5670" actId="1037"/>
          <ac:grpSpMkLst>
            <pc:docMk/>
            <pc:sldMk cId="1575602334" sldId="285"/>
            <ac:grpSpMk id="364" creationId="{1D330571-B307-1265-2BB3-942C47332A5D}"/>
          </ac:grpSpMkLst>
        </pc:grpChg>
        <pc:grpChg chg="add mod">
          <ac:chgData name="Wigmore, Eleanor" userId="154496fa-10d7-4fd7-9fba-3614c367c37c" providerId="ADAL" clId="{AA3EDCC2-F595-42A0-8358-45CA77012066}" dt="2023-05-25T12:00:54.059" v="5922" actId="164"/>
          <ac:grpSpMkLst>
            <pc:docMk/>
            <pc:sldMk cId="1575602334" sldId="285"/>
            <ac:grpSpMk id="373" creationId="{35D91E4B-60C1-1299-639A-DA9708367D19}"/>
          </ac:grpSpMkLst>
        </pc:grpChg>
        <pc:grpChg chg="del">
          <ac:chgData name="Wigmore, Eleanor" userId="154496fa-10d7-4fd7-9fba-3614c367c37c" providerId="ADAL" clId="{AA3EDCC2-F595-42A0-8358-45CA77012066}" dt="2023-05-11T14:31:02.033" v="599" actId="478"/>
          <ac:grpSpMkLst>
            <pc:docMk/>
            <pc:sldMk cId="1575602334" sldId="285"/>
            <ac:grpSpMk id="392" creationId="{8C75BE46-5DCC-488C-AB3B-A19C997E631D}"/>
          </ac:grpSpMkLst>
        </pc:grpChg>
        <pc:picChg chg="del">
          <ac:chgData name="Wigmore, Eleanor" userId="154496fa-10d7-4fd7-9fba-3614c367c37c" providerId="ADAL" clId="{AA3EDCC2-F595-42A0-8358-45CA77012066}" dt="2023-05-11T14:29:44.176" v="585" actId="478"/>
          <ac:picMkLst>
            <pc:docMk/>
            <pc:sldMk cId="1575602334" sldId="285"/>
            <ac:picMk id="3" creationId="{2F723C05-8B0B-1B08-AEF4-C124DB79F567}"/>
          </ac:picMkLst>
        </pc:picChg>
        <pc:picChg chg="add mod modCrop">
          <ac:chgData name="Wigmore, Eleanor" userId="154496fa-10d7-4fd7-9fba-3614c367c37c" providerId="ADAL" clId="{AA3EDCC2-F595-42A0-8358-45CA77012066}" dt="2023-05-24T12:43:08.300" v="3545" actId="1076"/>
          <ac:picMkLst>
            <pc:docMk/>
            <pc:sldMk cId="1575602334" sldId="285"/>
            <ac:picMk id="4" creationId="{15253FFC-665B-51BF-6CEC-0542E3D37A65}"/>
          </ac:picMkLst>
        </pc:picChg>
        <pc:picChg chg="add mod modCrop">
          <ac:chgData name="Wigmore, Eleanor" userId="154496fa-10d7-4fd7-9fba-3614c367c37c" providerId="ADAL" clId="{AA3EDCC2-F595-42A0-8358-45CA77012066}" dt="2023-05-25T11:56:52.344" v="5671" actId="1076"/>
          <ac:picMkLst>
            <pc:docMk/>
            <pc:sldMk cId="1575602334" sldId="285"/>
            <ac:picMk id="10" creationId="{43BF7F59-18D2-0A93-5304-67A39CBD234C}"/>
          </ac:picMkLst>
        </pc:picChg>
        <pc:picChg chg="del">
          <ac:chgData name="Wigmore, Eleanor" userId="154496fa-10d7-4fd7-9fba-3614c367c37c" providerId="ADAL" clId="{AA3EDCC2-F595-42A0-8358-45CA77012066}" dt="2023-05-11T14:38:59.960" v="603" actId="478"/>
          <ac:picMkLst>
            <pc:docMk/>
            <pc:sldMk cId="1575602334" sldId="285"/>
            <ac:picMk id="11" creationId="{02088055-ED32-406A-9C05-A31B59E9C764}"/>
          </ac:picMkLst>
        </pc:picChg>
        <pc:picChg chg="add mod">
          <ac:chgData name="Wigmore, Eleanor" userId="154496fa-10d7-4fd7-9fba-3614c367c37c" providerId="ADAL" clId="{AA3EDCC2-F595-42A0-8358-45CA77012066}" dt="2023-05-19T13:56:26.135" v="1160" actId="1035"/>
          <ac:picMkLst>
            <pc:docMk/>
            <pc:sldMk cId="1575602334" sldId="285"/>
            <ac:picMk id="12" creationId="{80780961-2844-3E71-7545-778AB32E6E21}"/>
          </ac:picMkLst>
        </pc:picChg>
        <pc:picChg chg="del">
          <ac:chgData name="Wigmore, Eleanor" userId="154496fa-10d7-4fd7-9fba-3614c367c37c" providerId="ADAL" clId="{AA3EDCC2-F595-42A0-8358-45CA77012066}" dt="2023-05-11T14:31:08.436" v="601" actId="478"/>
          <ac:picMkLst>
            <pc:docMk/>
            <pc:sldMk cId="1575602334" sldId="285"/>
            <ac:picMk id="20" creationId="{E477A115-B87D-4D8A-BA68-58232E11E8A6}"/>
          </ac:picMkLst>
        </pc:picChg>
        <pc:picChg chg="add del mod">
          <ac:chgData name="Wigmore, Eleanor" userId="154496fa-10d7-4fd7-9fba-3614c367c37c" providerId="ADAL" clId="{AA3EDCC2-F595-42A0-8358-45CA77012066}" dt="2023-05-19T11:09:56.055" v="716" actId="478"/>
          <ac:picMkLst>
            <pc:docMk/>
            <pc:sldMk cId="1575602334" sldId="285"/>
            <ac:picMk id="29" creationId="{E15932B8-6097-5EB8-A4A9-7F5836D8C62F}"/>
          </ac:picMkLst>
        </pc:picChg>
        <pc:picChg chg="add del mod modCrop">
          <ac:chgData name="Wigmore, Eleanor" userId="154496fa-10d7-4fd7-9fba-3614c367c37c" providerId="ADAL" clId="{AA3EDCC2-F595-42A0-8358-45CA77012066}" dt="2023-05-19T11:12:36.848" v="822" actId="478"/>
          <ac:picMkLst>
            <pc:docMk/>
            <pc:sldMk cId="1575602334" sldId="285"/>
            <ac:picMk id="31" creationId="{79FC8112-3223-9128-23A1-246AEDF2A03F}"/>
          </ac:picMkLst>
        </pc:picChg>
        <pc:picChg chg="add mod modCrop">
          <ac:chgData name="Wigmore, Eleanor" userId="154496fa-10d7-4fd7-9fba-3614c367c37c" providerId="ADAL" clId="{AA3EDCC2-F595-42A0-8358-45CA77012066}" dt="2023-05-19T13:55:43.867" v="1120" actId="1037"/>
          <ac:picMkLst>
            <pc:docMk/>
            <pc:sldMk cId="1575602334" sldId="285"/>
            <ac:picMk id="37" creationId="{9341E3B8-6785-8EB7-3A4A-DB3FF5AA67C2}"/>
          </ac:picMkLst>
        </pc:picChg>
        <pc:picChg chg="add mod modCrop">
          <ac:chgData name="Wigmore, Eleanor" userId="154496fa-10d7-4fd7-9fba-3614c367c37c" providerId="ADAL" clId="{AA3EDCC2-F595-42A0-8358-45CA77012066}" dt="2023-05-19T13:55:43.867" v="1120" actId="1037"/>
          <ac:picMkLst>
            <pc:docMk/>
            <pc:sldMk cId="1575602334" sldId="285"/>
            <ac:picMk id="38" creationId="{ABE1D168-94E5-D806-A7AD-31BFDEACA5A5}"/>
          </ac:picMkLst>
        </pc:picChg>
        <pc:picChg chg="add del mod modCrop">
          <ac:chgData name="Wigmore, Eleanor" userId="154496fa-10d7-4fd7-9fba-3614c367c37c" providerId="ADAL" clId="{AA3EDCC2-F595-42A0-8358-45CA77012066}" dt="2023-05-19T13:22:29.868" v="928" actId="478"/>
          <ac:picMkLst>
            <pc:docMk/>
            <pc:sldMk cId="1575602334" sldId="285"/>
            <ac:picMk id="41" creationId="{940ECB24-A2EA-846B-2C6B-64B33F835362}"/>
          </ac:picMkLst>
        </pc:picChg>
        <pc:picChg chg="add mod modCrop">
          <ac:chgData name="Wigmore, Eleanor" userId="154496fa-10d7-4fd7-9fba-3614c367c37c" providerId="ADAL" clId="{AA3EDCC2-F595-42A0-8358-45CA77012066}" dt="2023-05-25T11:56:43.134" v="5621" actId="164"/>
          <ac:picMkLst>
            <pc:docMk/>
            <pc:sldMk cId="1575602334" sldId="285"/>
            <ac:picMk id="43" creationId="{6EF53F8D-82FB-90C5-1D9E-A0BB3CE44E76}"/>
          </ac:picMkLst>
        </pc:picChg>
        <pc:picChg chg="add mod modCrop">
          <ac:chgData name="Wigmore, Eleanor" userId="154496fa-10d7-4fd7-9fba-3614c367c37c" providerId="ADAL" clId="{AA3EDCC2-F595-42A0-8358-45CA77012066}" dt="2023-05-25T12:00:54.059" v="5922" actId="164"/>
          <ac:picMkLst>
            <pc:docMk/>
            <pc:sldMk cId="1575602334" sldId="285"/>
            <ac:picMk id="45" creationId="{5A1907BB-AEAF-32ED-DDB2-02F6D0D71735}"/>
          </ac:picMkLst>
        </pc:picChg>
        <pc:picChg chg="add mod modCrop">
          <ac:chgData name="Wigmore, Eleanor" userId="154496fa-10d7-4fd7-9fba-3614c367c37c" providerId="ADAL" clId="{AA3EDCC2-F595-42A0-8358-45CA77012066}" dt="2023-05-19T13:56:37.971" v="1167" actId="1037"/>
          <ac:picMkLst>
            <pc:docMk/>
            <pc:sldMk cId="1575602334" sldId="285"/>
            <ac:picMk id="47" creationId="{65BF2DBD-3536-ADD8-326E-37C236E777B9}"/>
          </ac:picMkLst>
        </pc:picChg>
        <pc:picChg chg="add del mod">
          <ac:chgData name="Wigmore, Eleanor" userId="154496fa-10d7-4fd7-9fba-3614c367c37c" providerId="ADAL" clId="{AA3EDCC2-F595-42A0-8358-45CA77012066}" dt="2023-05-19T14:32:15.841" v="1246" actId="21"/>
          <ac:picMkLst>
            <pc:docMk/>
            <pc:sldMk cId="1575602334" sldId="285"/>
            <ac:picMk id="54" creationId="{48CA46CD-86F0-9F91-2CD2-C7B9F64066E5}"/>
          </ac:picMkLst>
        </pc:picChg>
        <pc:picChg chg="add del mod">
          <ac:chgData name="Wigmore, Eleanor" userId="154496fa-10d7-4fd7-9fba-3614c367c37c" providerId="ADAL" clId="{AA3EDCC2-F595-42A0-8358-45CA77012066}" dt="2023-05-19T14:33:52.252" v="1309" actId="478"/>
          <ac:picMkLst>
            <pc:docMk/>
            <pc:sldMk cId="1575602334" sldId="285"/>
            <ac:picMk id="57" creationId="{FBD082D6-8F3A-C461-4E20-E98BAF293C8E}"/>
          </ac:picMkLst>
        </pc:picChg>
        <pc:picChg chg="add del mod modCrop">
          <ac:chgData name="Wigmore, Eleanor" userId="154496fa-10d7-4fd7-9fba-3614c367c37c" providerId="ADAL" clId="{AA3EDCC2-F595-42A0-8358-45CA77012066}" dt="2023-05-24T12:42:49.365" v="3539" actId="478"/>
          <ac:picMkLst>
            <pc:docMk/>
            <pc:sldMk cId="1575602334" sldId="285"/>
            <ac:picMk id="60" creationId="{6E8F2118-8793-6BF2-386E-214878799381}"/>
          </ac:picMkLst>
        </pc:picChg>
        <pc:cxnChg chg="mod">
          <ac:chgData name="Wigmore, Eleanor" userId="154496fa-10d7-4fd7-9fba-3614c367c37c" providerId="ADAL" clId="{AA3EDCC2-F595-42A0-8358-45CA77012066}" dt="2023-05-19T13:56:37.971" v="1167" actId="1037"/>
          <ac:cxnSpMkLst>
            <pc:docMk/>
            <pc:sldMk cId="1575602334" sldId="285"/>
            <ac:cxnSpMk id="7" creationId="{F5A12402-5D66-437D-B038-DEA5EF6575E4}"/>
          </ac:cxnSpMkLst>
        </pc:cxn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2984182" cy="502596"/>
          </a:xfrm>
          <a:prstGeom prst="rect">
            <a:avLst/>
          </a:prstGeom>
        </p:spPr>
        <p:txBody>
          <a:bodyPr vert="horz" lIns="92418" tIns="46209" rIns="92418" bIns="46209" rtlCol="0"/>
          <a:lstStyle>
            <a:lvl1pPr algn="l">
              <a:defRPr sz="1200"/>
            </a:lvl1pPr>
          </a:lstStyle>
          <a:p>
            <a:endParaRPr lang="en-GB"/>
          </a:p>
        </p:txBody>
      </p:sp>
      <p:sp>
        <p:nvSpPr>
          <p:cNvPr id="3" name="Date Placeholder 2"/>
          <p:cNvSpPr>
            <a:spLocks noGrp="1"/>
          </p:cNvSpPr>
          <p:nvPr>
            <p:ph type="dt" idx="1"/>
          </p:nvPr>
        </p:nvSpPr>
        <p:spPr>
          <a:xfrm>
            <a:off x="3900800" y="0"/>
            <a:ext cx="2984182" cy="502596"/>
          </a:xfrm>
          <a:prstGeom prst="rect">
            <a:avLst/>
          </a:prstGeom>
        </p:spPr>
        <p:txBody>
          <a:bodyPr vert="horz" lIns="92418" tIns="46209" rIns="92418" bIns="46209" rtlCol="0"/>
          <a:lstStyle>
            <a:lvl1pPr algn="r">
              <a:defRPr sz="1200"/>
            </a:lvl1pPr>
          </a:lstStyle>
          <a:p>
            <a:fld id="{771DABDA-1951-4688-8538-F2B2F58EDF05}" type="datetimeFigureOut">
              <a:rPr lang="en-GB" smtClean="0"/>
              <a:t>28/06/2023</a:t>
            </a:fld>
            <a:endParaRPr lang="en-GB"/>
          </a:p>
        </p:txBody>
      </p:sp>
      <p:sp>
        <p:nvSpPr>
          <p:cNvPr id="4" name="Slide Image Placeholder 3"/>
          <p:cNvSpPr>
            <a:spLocks noGrp="1" noRot="1" noChangeAspect="1"/>
          </p:cNvSpPr>
          <p:nvPr>
            <p:ph type="sldImg" idx="2"/>
          </p:nvPr>
        </p:nvSpPr>
        <p:spPr>
          <a:xfrm>
            <a:off x="2273300" y="1252538"/>
            <a:ext cx="2339975" cy="3379787"/>
          </a:xfrm>
          <a:prstGeom prst="rect">
            <a:avLst/>
          </a:prstGeom>
          <a:noFill/>
          <a:ln w="12700">
            <a:solidFill>
              <a:prstClr val="black"/>
            </a:solidFill>
          </a:ln>
        </p:spPr>
        <p:txBody>
          <a:bodyPr vert="horz" lIns="92418" tIns="46209" rIns="92418" bIns="46209" rtlCol="0" anchor="ctr"/>
          <a:lstStyle/>
          <a:p>
            <a:endParaRPr lang="en-GB"/>
          </a:p>
        </p:txBody>
      </p:sp>
      <p:sp>
        <p:nvSpPr>
          <p:cNvPr id="5" name="Notes Placeholder 4"/>
          <p:cNvSpPr>
            <a:spLocks noGrp="1"/>
          </p:cNvSpPr>
          <p:nvPr>
            <p:ph type="body" sz="quarter" idx="3"/>
          </p:nvPr>
        </p:nvSpPr>
        <p:spPr>
          <a:xfrm>
            <a:off x="688658" y="4820741"/>
            <a:ext cx="5509260" cy="3944243"/>
          </a:xfrm>
          <a:prstGeom prst="rect">
            <a:avLst/>
          </a:prstGeom>
        </p:spPr>
        <p:txBody>
          <a:bodyPr vert="horz" lIns="92418" tIns="46209" rIns="92418" bIns="4620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1" y="9514531"/>
            <a:ext cx="2984182" cy="502595"/>
          </a:xfrm>
          <a:prstGeom prst="rect">
            <a:avLst/>
          </a:prstGeom>
        </p:spPr>
        <p:txBody>
          <a:bodyPr vert="horz" lIns="92418" tIns="46209" rIns="92418" bIns="46209" rtlCol="0" anchor="b"/>
          <a:lstStyle>
            <a:lvl1pPr algn="l">
              <a:defRPr sz="1200"/>
            </a:lvl1pPr>
          </a:lstStyle>
          <a:p>
            <a:endParaRPr lang="en-GB"/>
          </a:p>
        </p:txBody>
      </p:sp>
      <p:sp>
        <p:nvSpPr>
          <p:cNvPr id="7" name="Slide Number Placeholder 6"/>
          <p:cNvSpPr>
            <a:spLocks noGrp="1"/>
          </p:cNvSpPr>
          <p:nvPr>
            <p:ph type="sldNum" sz="quarter" idx="5"/>
          </p:nvPr>
        </p:nvSpPr>
        <p:spPr>
          <a:xfrm>
            <a:off x="3900800" y="9514531"/>
            <a:ext cx="2984182" cy="502595"/>
          </a:xfrm>
          <a:prstGeom prst="rect">
            <a:avLst/>
          </a:prstGeom>
        </p:spPr>
        <p:txBody>
          <a:bodyPr vert="horz" lIns="92418" tIns="46209" rIns="92418" bIns="46209" rtlCol="0" anchor="b"/>
          <a:lstStyle>
            <a:lvl1pPr algn="r">
              <a:defRPr sz="1200"/>
            </a:lvl1pPr>
          </a:lstStyle>
          <a:p>
            <a:fld id="{126CE14E-9D97-4695-B04D-F29277B35AC8}" type="slidenum">
              <a:rPr lang="en-GB" smtClean="0"/>
              <a:t>‹#›</a:t>
            </a:fld>
            <a:endParaRPr lang="en-GB"/>
          </a:p>
        </p:txBody>
      </p:sp>
    </p:spTree>
    <p:extLst>
      <p:ext uri="{BB962C8B-B14F-4D97-AF65-F5344CB8AC3E}">
        <p14:creationId xmlns:p14="http://schemas.microsoft.com/office/powerpoint/2010/main" val="42498832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1360488"/>
            <a:ext cx="2540000" cy="3670300"/>
          </a:xfrm>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19AC1ABA-5528-4A39-B2C8-B913A9456DEF}" type="slidenum">
              <a:rPr lang="en-GB" smtClean="0"/>
              <a:t>1</a:t>
            </a:fld>
            <a:endParaRPr lang="en-GB"/>
          </a:p>
        </p:txBody>
      </p:sp>
    </p:spTree>
    <p:extLst>
      <p:ext uri="{BB962C8B-B14F-4D97-AF65-F5344CB8AC3E}">
        <p14:creationId xmlns:p14="http://schemas.microsoft.com/office/powerpoint/2010/main" val="98731056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3300" y="1252538"/>
            <a:ext cx="2339975" cy="3379787"/>
          </a:xfrm>
        </p:spPr>
      </p:sp>
      <p:sp>
        <p:nvSpPr>
          <p:cNvPr id="3" name="Notes Placeholder 2"/>
          <p:cNvSpPr>
            <a:spLocks noGrp="1"/>
          </p:cNvSpPr>
          <p:nvPr>
            <p:ph type="body" idx="1"/>
          </p:nvPr>
        </p:nvSpPr>
        <p:spPr/>
        <p:txBody>
          <a:bodyPr/>
          <a:lstStyle/>
          <a:p>
            <a:r>
              <a:rPr lang="en-GB"/>
              <a:t>Latest version of RNA-seq combination in T47D parental</a:t>
            </a:r>
          </a:p>
        </p:txBody>
      </p:sp>
      <p:sp>
        <p:nvSpPr>
          <p:cNvPr id="4" name="Slide Number Placeholder 3"/>
          <p:cNvSpPr>
            <a:spLocks noGrp="1"/>
          </p:cNvSpPr>
          <p:nvPr>
            <p:ph type="sldNum" sz="quarter" idx="5"/>
          </p:nvPr>
        </p:nvSpPr>
        <p:spPr/>
        <p:txBody>
          <a:bodyPr/>
          <a:lstStyle/>
          <a:p>
            <a:fld id="{19AC1ABA-5528-4A39-B2C8-B913A9456DEF}" type="slidenum">
              <a:rPr lang="en-GB" smtClean="0"/>
              <a:t>3</a:t>
            </a:fld>
            <a:endParaRPr lang="en-GB"/>
          </a:p>
        </p:txBody>
      </p:sp>
    </p:spTree>
    <p:extLst>
      <p:ext uri="{BB962C8B-B14F-4D97-AF65-F5344CB8AC3E}">
        <p14:creationId xmlns:p14="http://schemas.microsoft.com/office/powerpoint/2010/main" val="135750074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3300" y="1252538"/>
            <a:ext cx="2339975" cy="3379787"/>
          </a:xfrm>
        </p:spPr>
      </p:sp>
      <p:sp>
        <p:nvSpPr>
          <p:cNvPr id="3" name="Notes Placeholder 2"/>
          <p:cNvSpPr>
            <a:spLocks noGrp="1"/>
          </p:cNvSpPr>
          <p:nvPr>
            <p:ph type="body" idx="1"/>
          </p:nvPr>
        </p:nvSpPr>
        <p:spPr/>
        <p:txBody>
          <a:bodyPr/>
          <a:lstStyle/>
          <a:p>
            <a:r>
              <a:rPr lang="en-GB"/>
              <a:t>Latest version of RNA-seq combination in T47D parental</a:t>
            </a:r>
          </a:p>
        </p:txBody>
      </p:sp>
      <p:sp>
        <p:nvSpPr>
          <p:cNvPr id="4" name="Slide Number Placeholder 3"/>
          <p:cNvSpPr>
            <a:spLocks noGrp="1"/>
          </p:cNvSpPr>
          <p:nvPr>
            <p:ph type="sldNum" sz="quarter" idx="5"/>
          </p:nvPr>
        </p:nvSpPr>
        <p:spPr/>
        <p:txBody>
          <a:bodyPr/>
          <a:lstStyle/>
          <a:p>
            <a:fld id="{19AC1ABA-5528-4A39-B2C8-B913A9456DEF}" type="slidenum">
              <a:rPr lang="en-GB" smtClean="0"/>
              <a:t>4</a:t>
            </a:fld>
            <a:endParaRPr lang="en-GB"/>
          </a:p>
        </p:txBody>
      </p:sp>
    </p:spTree>
    <p:extLst>
      <p:ext uri="{BB962C8B-B14F-4D97-AF65-F5344CB8AC3E}">
        <p14:creationId xmlns:p14="http://schemas.microsoft.com/office/powerpoint/2010/main" val="2528183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43125" y="1360488"/>
            <a:ext cx="2540000" cy="3670300"/>
          </a:xfrm>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19AC1ABA-5528-4A39-B2C8-B913A9456DEF}" type="slidenum">
              <a:rPr lang="en-GB" smtClean="0"/>
              <a:t>5</a:t>
            </a:fld>
            <a:endParaRPr lang="en-GB"/>
          </a:p>
        </p:txBody>
      </p:sp>
    </p:spTree>
    <p:extLst>
      <p:ext uri="{BB962C8B-B14F-4D97-AF65-F5344CB8AC3E}">
        <p14:creationId xmlns:p14="http://schemas.microsoft.com/office/powerpoint/2010/main" val="7848829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fld id="{126CE14E-9D97-4695-B04D-F29277B35AC8}" type="slidenum">
              <a:rPr lang="en-GB" smtClean="0"/>
              <a:t>6</a:t>
            </a:fld>
            <a:endParaRPr lang="en-GB"/>
          </a:p>
        </p:txBody>
      </p:sp>
    </p:spTree>
    <p:extLst>
      <p:ext uri="{BB962C8B-B14F-4D97-AF65-F5344CB8AC3E}">
        <p14:creationId xmlns:p14="http://schemas.microsoft.com/office/powerpoint/2010/main" val="419648062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nSpc>
                <a:spcPct val="200000"/>
              </a:lnSpc>
              <a:spcAft>
                <a:spcPts val="809"/>
              </a:spcAft>
            </a:pPr>
            <a:r>
              <a:rPr lang="en-GB" sz="1800" b="1">
                <a:solidFill>
                  <a:srgbClr val="000000"/>
                </a:solidFill>
                <a:latin typeface="Calibri" panose="020F0502020204030204" pitchFamily="34" charset="0"/>
                <a:ea typeface="Calibri" panose="020F0502020204030204" pitchFamily="34" charset="0"/>
                <a:cs typeface="Calibri" panose="020F0502020204030204" pitchFamily="34" charset="0"/>
              </a:rPr>
              <a:t>Supplementary Figure 7 The combination of capivasertib and fulvestrant give anti-tumour efficacy </a:t>
            </a:r>
            <a:r>
              <a:rPr lang="en-GB" sz="1800" b="1" i="1">
                <a:solidFill>
                  <a:srgbClr val="000000"/>
                </a:solidFill>
                <a:latin typeface="Calibri" panose="020F0502020204030204" pitchFamily="34" charset="0"/>
                <a:ea typeface="Calibri" panose="020F0502020204030204" pitchFamily="34" charset="0"/>
                <a:cs typeface="Calibri" panose="020F0502020204030204" pitchFamily="34" charset="0"/>
              </a:rPr>
              <a:t>in vivo.</a:t>
            </a:r>
            <a:r>
              <a:rPr lang="en-GB" sz="1800" b="1">
                <a:solidFill>
                  <a:srgbClr val="000000"/>
                </a:solidFill>
                <a:latin typeface="Calibri" panose="020F0502020204030204" pitchFamily="34" charset="0"/>
                <a:ea typeface="Calibri" panose="020F0502020204030204" pitchFamily="34" charset="0"/>
                <a:cs typeface="Calibri" panose="020F0502020204030204" pitchFamily="34" charset="0"/>
              </a:rPr>
              <a:t> A) </a:t>
            </a:r>
            <a:r>
              <a:rPr lang="en-GB" sz="1800">
                <a:solidFill>
                  <a:srgbClr val="000000"/>
                </a:solidFill>
                <a:latin typeface="Calibri" panose="020F0502020204030204" pitchFamily="34" charset="0"/>
                <a:ea typeface="Calibri" panose="020F0502020204030204" pitchFamily="34" charset="0"/>
                <a:cs typeface="Calibri" panose="020F0502020204030204" pitchFamily="34" charset="0"/>
              </a:rPr>
              <a:t>Heat map depicting tumour TGI across a panel of PDX in response to </a:t>
            </a:r>
            <a:r>
              <a:rPr lang="en-GB" sz="1800" err="1">
                <a:solidFill>
                  <a:srgbClr val="000000"/>
                </a:solidFill>
                <a:latin typeface="Calibri" panose="020F0502020204030204" pitchFamily="34" charset="0"/>
                <a:ea typeface="Calibri" panose="020F0502020204030204" pitchFamily="34" charset="0"/>
                <a:cs typeface="Calibri" panose="020F0502020204030204" pitchFamily="34" charset="0"/>
              </a:rPr>
              <a:t>palbociclib</a:t>
            </a:r>
            <a:r>
              <a:rPr lang="en-GB" sz="1800">
                <a:solidFill>
                  <a:srgbClr val="000000"/>
                </a:solidFill>
                <a:latin typeface="Calibri" panose="020F0502020204030204" pitchFamily="34" charset="0"/>
                <a:ea typeface="Calibri" panose="020F0502020204030204" pitchFamily="34" charset="0"/>
                <a:cs typeface="Calibri" panose="020F0502020204030204" pitchFamily="34" charset="0"/>
              </a:rPr>
              <a:t>, fulvestrant, capivasertib, or fulvestrant and capivasertib. Right hand boxes indicate mutational status of models for ESR1, AKT, PIK3CA, PTEN and RB1. Numbers by PDX models name indicate individual schedules used in study, using maximum dose tolerated for mouse strain, (1) Palbociclib 50mg/kg, capivasertib 130mg/kg, fulvestrant 5mg/animal, (2) </a:t>
            </a:r>
            <a:r>
              <a:rPr lang="en-GB" sz="1800" err="1">
                <a:solidFill>
                  <a:srgbClr val="000000"/>
                </a:solidFill>
                <a:latin typeface="Calibri" panose="020F0502020204030204" pitchFamily="34" charset="0"/>
                <a:ea typeface="Calibri" panose="020F0502020204030204" pitchFamily="34" charset="0"/>
                <a:cs typeface="Calibri" panose="020F0502020204030204" pitchFamily="34" charset="0"/>
              </a:rPr>
              <a:t>palbociclib</a:t>
            </a:r>
            <a:r>
              <a:rPr lang="en-GB" sz="1800">
                <a:solidFill>
                  <a:srgbClr val="000000"/>
                </a:solidFill>
                <a:latin typeface="Calibri" panose="020F0502020204030204" pitchFamily="34" charset="0"/>
                <a:ea typeface="Calibri" panose="020F0502020204030204" pitchFamily="34" charset="0"/>
                <a:cs typeface="Calibri" panose="020F0502020204030204" pitchFamily="34" charset="0"/>
              </a:rPr>
              <a:t> 25mg/kg, capivasertib 100mg/kg, fulvestrant 5mg/animal, (3) </a:t>
            </a:r>
            <a:r>
              <a:rPr lang="en-GB" sz="1800" err="1">
                <a:solidFill>
                  <a:srgbClr val="000000"/>
                </a:solidFill>
                <a:latin typeface="Calibri" panose="020F0502020204030204" pitchFamily="34" charset="0"/>
                <a:ea typeface="Calibri" panose="020F0502020204030204" pitchFamily="34" charset="0"/>
                <a:cs typeface="Calibri" panose="020F0502020204030204" pitchFamily="34" charset="0"/>
              </a:rPr>
              <a:t>palbociclib</a:t>
            </a:r>
            <a:r>
              <a:rPr lang="en-GB" sz="1800">
                <a:solidFill>
                  <a:srgbClr val="000000"/>
                </a:solidFill>
                <a:latin typeface="Calibri" panose="020F0502020204030204" pitchFamily="34" charset="0"/>
                <a:ea typeface="Calibri" panose="020F0502020204030204" pitchFamily="34" charset="0"/>
                <a:cs typeface="Calibri" panose="020F0502020204030204" pitchFamily="34" charset="0"/>
              </a:rPr>
              <a:t> 25mg/kg, capivasertib 130mg/kg, fulvestrant 5mg/animal. Statistical analysis used was one tailed t-test versus vehicle, * P&lt;0.05, **P&lt;0.01. ***P&lt;0.005</a:t>
            </a:r>
            <a:r>
              <a:rPr lang="en-GB" sz="1800" b="1">
                <a:solidFill>
                  <a:srgbClr val="000000"/>
                </a:solidFill>
                <a:latin typeface="Calibri" panose="020F0502020204030204" pitchFamily="34" charset="0"/>
                <a:ea typeface="Calibri" panose="020F0502020204030204" pitchFamily="34" charset="0"/>
                <a:cs typeface="Calibri" panose="020F0502020204030204" pitchFamily="34" charset="0"/>
              </a:rPr>
              <a:t> B) </a:t>
            </a:r>
            <a:r>
              <a:rPr lang="en-GB" sz="1800">
                <a:solidFill>
                  <a:srgbClr val="000000"/>
                </a:solidFill>
                <a:latin typeface="Calibri" panose="020F0502020204030204" pitchFamily="34" charset="0"/>
                <a:ea typeface="Calibri" panose="020F0502020204030204" pitchFamily="34" charset="0"/>
                <a:cs typeface="Calibri" panose="020F0502020204030204" pitchFamily="34" charset="0"/>
              </a:rPr>
              <a:t>Dose response of capivasertib with and without a fixed dose of fulvestrant in ST1799 PBR. Line graphs depict geometric means, error bars represent SEM. Left hand plot capivasertib monotherapy groups, right hand plot shows fulvestrant monotherapy and capivasertib combination groups. C) ST1799PBR PDX PIK3CAm E542K: Pharmacodynamic changes phosphorylation and total protein levels of the AKT and mTOR downstream substrates and regulators AKT (Ser473), PRAS40 (Thr246), S6 (Ser235/236) after 4 days of treatment. Data was normalised to the housekeeping protein </a:t>
            </a:r>
            <a:r>
              <a:rPr lang="el-GR" sz="1800">
                <a:solidFill>
                  <a:srgbClr val="000000"/>
                </a:solidFill>
                <a:latin typeface="Calibri" panose="020F0502020204030204" pitchFamily="34" charset="0"/>
                <a:ea typeface="Calibri" panose="020F0502020204030204" pitchFamily="34" charset="0"/>
                <a:cs typeface="Calibri" panose="020F0502020204030204" pitchFamily="34" charset="0"/>
              </a:rPr>
              <a:t>β</a:t>
            </a:r>
            <a:r>
              <a:rPr lang="en-GB" sz="1800">
                <a:solidFill>
                  <a:srgbClr val="000000"/>
                </a:solidFill>
                <a:latin typeface="Calibri" panose="020F0502020204030204" pitchFamily="34" charset="0"/>
                <a:ea typeface="Calibri" panose="020F0502020204030204" pitchFamily="34" charset="0"/>
                <a:cs typeface="Calibri" panose="020F0502020204030204" pitchFamily="34" charset="0"/>
              </a:rPr>
              <a:t>-actin and percentage change from control plotted as mean and standard deviation of the mean (n = 5). Statistical analysis used was ANOVA test vs vehicle treated, *p&lt;0.05; **p&lt;0.005; ***p&lt;0.0005. Ki-67 was visualized using immunohistochemistry of tumour samples; results were exported and loaded into Prism for statistical analysis, plotted as mean and standard deviation of the mean (n = 5). Statistical analysis used was ANOVA test vs vehicle *p&lt;0.05; **p&lt;0.01; ***p&lt;0.005, ****p&lt;0.001.</a:t>
            </a:r>
            <a:endParaRPr lang="en-GB" sz="1800">
              <a:latin typeface="Calibri" panose="020F0502020204030204" pitchFamily="34" charset="0"/>
              <a:ea typeface="Calibri" panose="020F050202020403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19AC1ABA-5528-4A39-B2C8-B913A9456DEF}" type="slidenum">
              <a:rPr lang="en-GB" smtClean="0"/>
              <a:t>7</a:t>
            </a:fld>
            <a:endParaRPr lang="en-GB"/>
          </a:p>
        </p:txBody>
      </p:sp>
    </p:spTree>
    <p:extLst>
      <p:ext uri="{BB962C8B-B14F-4D97-AF65-F5344CB8AC3E}">
        <p14:creationId xmlns:p14="http://schemas.microsoft.com/office/powerpoint/2010/main" val="4119400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8DAB9667-7FBD-4C13-8F67-EF2FA83C5083}" type="datetimeFigureOut">
              <a:rPr lang="en-GB" smtClean="0"/>
              <a:t>28/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25543323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DAB9667-7FBD-4C13-8F67-EF2FA83C5083}" type="datetimeFigureOut">
              <a:rPr lang="en-GB" smtClean="0"/>
              <a:t>28/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36009682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DAB9667-7FBD-4C13-8F67-EF2FA83C5083}" type="datetimeFigureOut">
              <a:rPr lang="en-GB" smtClean="0"/>
              <a:t>28/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42739578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DAB9667-7FBD-4C13-8F67-EF2FA83C5083}" type="datetimeFigureOut">
              <a:rPr lang="en-GB" smtClean="0"/>
              <a:t>28/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41369219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DAB9667-7FBD-4C13-8F67-EF2FA83C5083}" type="datetimeFigureOut">
              <a:rPr lang="en-GB" smtClean="0"/>
              <a:t>28/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36138604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DAB9667-7FBD-4C13-8F67-EF2FA83C5083}" type="datetimeFigureOut">
              <a:rPr lang="en-GB" smtClean="0"/>
              <a:t>28/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33354459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DAB9667-7FBD-4C13-8F67-EF2FA83C5083}" type="datetimeFigureOut">
              <a:rPr lang="en-GB" smtClean="0"/>
              <a:t>28/06/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35353315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DAB9667-7FBD-4C13-8F67-EF2FA83C5083}" type="datetimeFigureOut">
              <a:rPr lang="en-GB" smtClean="0"/>
              <a:t>28/06/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26974846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AB9667-7FBD-4C13-8F67-EF2FA83C5083}" type="datetimeFigureOut">
              <a:rPr lang="en-GB" smtClean="0"/>
              <a:t>28/06/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41987960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DAB9667-7FBD-4C13-8F67-EF2FA83C5083}" type="datetimeFigureOut">
              <a:rPr lang="en-GB" smtClean="0"/>
              <a:t>28/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19458187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DAB9667-7FBD-4C13-8F67-EF2FA83C5083}" type="datetimeFigureOut">
              <a:rPr lang="en-GB" smtClean="0"/>
              <a:t>28/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D4A41FB-85B9-4DE7-90DF-B7920E7D5305}" type="slidenum">
              <a:rPr lang="en-GB" smtClean="0"/>
              <a:t>‹#›</a:t>
            </a:fld>
            <a:endParaRPr lang="en-GB"/>
          </a:p>
        </p:txBody>
      </p:sp>
    </p:spTree>
    <p:extLst>
      <p:ext uri="{BB962C8B-B14F-4D97-AF65-F5344CB8AC3E}">
        <p14:creationId xmlns:p14="http://schemas.microsoft.com/office/powerpoint/2010/main" val="23025150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DAB9667-7FBD-4C13-8F67-EF2FA83C5083}" type="datetimeFigureOut">
              <a:rPr lang="en-GB" smtClean="0"/>
              <a:t>28/06/2023</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D4A41FB-85B9-4DE7-90DF-B7920E7D5305}" type="slidenum">
              <a:rPr lang="en-GB" smtClean="0"/>
              <a:t>‹#›</a:t>
            </a:fld>
            <a:endParaRPr lang="en-GB"/>
          </a:p>
        </p:txBody>
      </p:sp>
    </p:spTree>
    <p:extLst>
      <p:ext uri="{BB962C8B-B14F-4D97-AF65-F5344CB8AC3E}">
        <p14:creationId xmlns:p14="http://schemas.microsoft.com/office/powerpoint/2010/main" val="35459551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3" Type="http://schemas.openxmlformats.org/officeDocument/2006/relationships/image" Target="../media/image10.emf"/><Relationship Id="rId7" Type="http://schemas.openxmlformats.org/officeDocument/2006/relationships/image" Target="../media/image12.emf"/><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oleObject" Target="../embeddings/oleObject3.bin"/><Relationship Id="rId5" Type="http://schemas.openxmlformats.org/officeDocument/2006/relationships/image" Target="../media/image11.e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4.xml.rels><?xml version="1.0" encoding="UTF-8" standalone="yes"?>
<Relationships xmlns="http://schemas.openxmlformats.org/package/2006/relationships"><Relationship Id="rId8" Type="http://schemas.openxmlformats.org/officeDocument/2006/relationships/image" Target="../media/image23.emf"/><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20.emf"/><Relationship Id="rId4" Type="http://schemas.openxmlformats.org/officeDocument/2006/relationships/image" Target="../media/image19.png"/><Relationship Id="rId9" Type="http://schemas.openxmlformats.org/officeDocument/2006/relationships/image" Target="../media/image24.emf"/></Relationships>
</file>

<file path=ppt/slides/_rels/slide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8.emf"/><Relationship Id="rId5" Type="http://schemas.openxmlformats.org/officeDocument/2006/relationships/image" Target="../media/image27.emf"/><Relationship Id="rId4" Type="http://schemas.openxmlformats.org/officeDocument/2006/relationships/image" Target="../media/image26.png"/></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29.emf"/></Relationships>
</file>

<file path=ppt/slides/_rels/slide7.xml.rels><?xml version="1.0" encoding="UTF-8" standalone="yes"?>
<Relationships xmlns="http://schemas.openxmlformats.org/package/2006/relationships"><Relationship Id="rId8" Type="http://schemas.openxmlformats.org/officeDocument/2006/relationships/image" Target="../media/image32.emf"/><Relationship Id="rId13" Type="http://schemas.openxmlformats.org/officeDocument/2006/relationships/oleObject" Target="../embeddings/oleObject10.bin"/><Relationship Id="rId18" Type="http://schemas.openxmlformats.org/officeDocument/2006/relationships/image" Target="../media/image38.emf"/><Relationship Id="rId3" Type="http://schemas.openxmlformats.org/officeDocument/2006/relationships/oleObject" Target="../embeddings/oleObject5.bin"/><Relationship Id="rId7" Type="http://schemas.openxmlformats.org/officeDocument/2006/relationships/oleObject" Target="../embeddings/oleObject7.bin"/><Relationship Id="rId12" Type="http://schemas.openxmlformats.org/officeDocument/2006/relationships/image" Target="../media/image34.emf"/><Relationship Id="rId17" Type="http://schemas.openxmlformats.org/officeDocument/2006/relationships/image" Target="../media/image37.emf"/><Relationship Id="rId2" Type="http://schemas.openxmlformats.org/officeDocument/2006/relationships/notesSlide" Target="../notesSlides/notesSlide6.xml"/><Relationship Id="rId16" Type="http://schemas.openxmlformats.org/officeDocument/2006/relationships/image" Target="../media/image36.emf"/><Relationship Id="rId20" Type="http://schemas.openxmlformats.org/officeDocument/2006/relationships/image" Target="../media/image40.png"/><Relationship Id="rId1" Type="http://schemas.openxmlformats.org/officeDocument/2006/relationships/slideLayout" Target="../slideLayouts/slideLayout1.xml"/><Relationship Id="rId6" Type="http://schemas.openxmlformats.org/officeDocument/2006/relationships/image" Target="../media/image31.emf"/><Relationship Id="rId11" Type="http://schemas.openxmlformats.org/officeDocument/2006/relationships/oleObject" Target="../embeddings/oleObject9.bin"/><Relationship Id="rId5" Type="http://schemas.openxmlformats.org/officeDocument/2006/relationships/oleObject" Target="../embeddings/oleObject6.bin"/><Relationship Id="rId15" Type="http://schemas.openxmlformats.org/officeDocument/2006/relationships/oleObject" Target="../embeddings/oleObject11.bin"/><Relationship Id="rId10" Type="http://schemas.openxmlformats.org/officeDocument/2006/relationships/image" Target="../media/image33.emf"/><Relationship Id="rId19" Type="http://schemas.openxmlformats.org/officeDocument/2006/relationships/image" Target="../media/image39.png"/><Relationship Id="rId4" Type="http://schemas.openxmlformats.org/officeDocument/2006/relationships/image" Target="../media/image30.emf"/><Relationship Id="rId9" Type="http://schemas.openxmlformats.org/officeDocument/2006/relationships/oleObject" Target="../embeddings/oleObject8.bin"/><Relationship Id="rId14" Type="http://schemas.openxmlformats.org/officeDocument/2006/relationships/image" Target="../media/image3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Box 34">
            <a:extLst>
              <a:ext uri="{FF2B5EF4-FFF2-40B4-BE49-F238E27FC236}">
                <a16:creationId xmlns:a16="http://schemas.microsoft.com/office/drawing/2014/main" id="{3CE29AB5-28B1-4DB3-8D3A-CB5D434B155D}"/>
              </a:ext>
            </a:extLst>
          </p:cNvPr>
          <p:cNvSpPr txBox="1"/>
          <p:nvPr/>
        </p:nvSpPr>
        <p:spPr>
          <a:xfrm>
            <a:off x="519964" y="402213"/>
            <a:ext cx="156287" cy="276999"/>
          </a:xfrm>
          <a:prstGeom prst="rect">
            <a:avLst/>
          </a:prstGeom>
          <a:noFill/>
        </p:spPr>
        <p:txBody>
          <a:bodyPr wrap="square" rtlCol="0">
            <a:spAutoFit/>
          </a:bodyPr>
          <a:lstStyle/>
          <a:p>
            <a:r>
              <a:rPr lang="en-GB" sz="1200" b="1"/>
              <a:t>A</a:t>
            </a:r>
          </a:p>
        </p:txBody>
      </p:sp>
      <p:sp>
        <p:nvSpPr>
          <p:cNvPr id="66" name="TextBox 65">
            <a:extLst>
              <a:ext uri="{FF2B5EF4-FFF2-40B4-BE49-F238E27FC236}">
                <a16:creationId xmlns:a16="http://schemas.microsoft.com/office/drawing/2014/main" id="{0510A06A-3C14-4B35-B9D8-0460B35804E2}"/>
              </a:ext>
            </a:extLst>
          </p:cNvPr>
          <p:cNvSpPr txBox="1"/>
          <p:nvPr/>
        </p:nvSpPr>
        <p:spPr>
          <a:xfrm>
            <a:off x="601397" y="66180"/>
            <a:ext cx="3355763" cy="292388"/>
          </a:xfrm>
          <a:prstGeom prst="rect">
            <a:avLst/>
          </a:prstGeom>
          <a:noFill/>
        </p:spPr>
        <p:txBody>
          <a:bodyPr wrap="square" rtlCol="0">
            <a:spAutoFit/>
          </a:bodyPr>
          <a:lstStyle/>
          <a:p>
            <a:r>
              <a:rPr lang="en-GB" sz="1300"/>
              <a:t>Supplementary Figure 1</a:t>
            </a:r>
          </a:p>
        </p:txBody>
      </p:sp>
      <p:pic>
        <p:nvPicPr>
          <p:cNvPr id="154" name="Picture 153">
            <a:extLst>
              <a:ext uri="{FF2B5EF4-FFF2-40B4-BE49-F238E27FC236}">
                <a16:creationId xmlns:a16="http://schemas.microsoft.com/office/drawing/2014/main" id="{406B7FE6-6F82-211D-72DD-CC3956DC78F5}"/>
              </a:ext>
            </a:extLst>
          </p:cNvPr>
          <p:cNvPicPr>
            <a:picLocks noChangeAspect="1"/>
          </p:cNvPicPr>
          <p:nvPr/>
        </p:nvPicPr>
        <p:blipFill rotWithShape="1">
          <a:blip r:embed="rId3"/>
          <a:srcRect l="1942" t="1645" b="-1"/>
          <a:stretch/>
        </p:blipFill>
        <p:spPr>
          <a:xfrm>
            <a:off x="773380" y="721333"/>
            <a:ext cx="2859977" cy="1956502"/>
          </a:xfrm>
          <a:prstGeom prst="rect">
            <a:avLst/>
          </a:prstGeom>
        </p:spPr>
      </p:pic>
      <p:sp>
        <p:nvSpPr>
          <p:cNvPr id="8" name="TextBox 7">
            <a:extLst>
              <a:ext uri="{FF2B5EF4-FFF2-40B4-BE49-F238E27FC236}">
                <a16:creationId xmlns:a16="http://schemas.microsoft.com/office/drawing/2014/main" id="{DD5EF8AF-295B-81F5-BF24-27CC755B2B5A}"/>
              </a:ext>
            </a:extLst>
          </p:cNvPr>
          <p:cNvSpPr txBox="1"/>
          <p:nvPr/>
        </p:nvSpPr>
        <p:spPr>
          <a:xfrm>
            <a:off x="3468388" y="402213"/>
            <a:ext cx="127693" cy="276999"/>
          </a:xfrm>
          <a:prstGeom prst="rect">
            <a:avLst/>
          </a:prstGeom>
          <a:noFill/>
        </p:spPr>
        <p:txBody>
          <a:bodyPr wrap="square" lIns="91440" tIns="45720" rIns="91440" bIns="45720" rtlCol="0" anchor="t">
            <a:spAutoFit/>
          </a:bodyPr>
          <a:lstStyle/>
          <a:p>
            <a:r>
              <a:rPr lang="en-GB" sz="1200" b="1">
                <a:cs typeface="Calibri"/>
              </a:rPr>
              <a:t>B</a:t>
            </a:r>
          </a:p>
        </p:txBody>
      </p:sp>
      <p:sp>
        <p:nvSpPr>
          <p:cNvPr id="9" name="TextBox 8">
            <a:extLst>
              <a:ext uri="{FF2B5EF4-FFF2-40B4-BE49-F238E27FC236}">
                <a16:creationId xmlns:a16="http://schemas.microsoft.com/office/drawing/2014/main" id="{297E8DD9-301D-314C-4943-A35964D1AA08}"/>
              </a:ext>
            </a:extLst>
          </p:cNvPr>
          <p:cNvSpPr txBox="1"/>
          <p:nvPr/>
        </p:nvSpPr>
        <p:spPr>
          <a:xfrm>
            <a:off x="528352" y="2835889"/>
            <a:ext cx="127693" cy="276999"/>
          </a:xfrm>
          <a:prstGeom prst="rect">
            <a:avLst/>
          </a:prstGeom>
          <a:noFill/>
        </p:spPr>
        <p:txBody>
          <a:bodyPr wrap="square" rtlCol="0">
            <a:spAutoFit/>
          </a:bodyPr>
          <a:lstStyle/>
          <a:p>
            <a:r>
              <a:rPr lang="en-GB" sz="1200" b="1"/>
              <a:t>C</a:t>
            </a:r>
          </a:p>
        </p:txBody>
      </p:sp>
      <p:pic>
        <p:nvPicPr>
          <p:cNvPr id="10" name="Content Placeholder 7">
            <a:extLst>
              <a:ext uri="{FF2B5EF4-FFF2-40B4-BE49-F238E27FC236}">
                <a16:creationId xmlns:a16="http://schemas.microsoft.com/office/drawing/2014/main" id="{27224344-FABC-938E-A1FF-0F04C2E18FAF}"/>
              </a:ext>
            </a:extLst>
          </p:cNvPr>
          <p:cNvPicPr>
            <a:picLocks noChangeAspect="1"/>
          </p:cNvPicPr>
          <p:nvPr/>
        </p:nvPicPr>
        <p:blipFill rotWithShape="1">
          <a:blip r:embed="rId4"/>
          <a:srcRect l="-1" r="37477" b="59614"/>
          <a:stretch/>
        </p:blipFill>
        <p:spPr>
          <a:xfrm>
            <a:off x="1128768" y="3156533"/>
            <a:ext cx="1746082" cy="563926"/>
          </a:xfrm>
          <a:prstGeom prst="rect">
            <a:avLst/>
          </a:prstGeom>
        </p:spPr>
      </p:pic>
      <p:pic>
        <p:nvPicPr>
          <p:cNvPr id="11" name="Picture 10">
            <a:extLst>
              <a:ext uri="{FF2B5EF4-FFF2-40B4-BE49-F238E27FC236}">
                <a16:creationId xmlns:a16="http://schemas.microsoft.com/office/drawing/2014/main" id="{7DBD2678-06EB-7FA3-8D3E-4C0CA8B8B47F}"/>
              </a:ext>
            </a:extLst>
          </p:cNvPr>
          <p:cNvPicPr>
            <a:picLocks noChangeAspect="1"/>
          </p:cNvPicPr>
          <p:nvPr/>
        </p:nvPicPr>
        <p:blipFill rotWithShape="1">
          <a:blip r:embed="rId5"/>
          <a:srcRect l="-1" r="37521" b="52509"/>
          <a:stretch/>
        </p:blipFill>
        <p:spPr>
          <a:xfrm>
            <a:off x="1128768" y="3948653"/>
            <a:ext cx="1747058" cy="925272"/>
          </a:xfrm>
          <a:prstGeom prst="rect">
            <a:avLst/>
          </a:prstGeom>
        </p:spPr>
      </p:pic>
      <p:sp>
        <p:nvSpPr>
          <p:cNvPr id="12" name="TextBox 11">
            <a:extLst>
              <a:ext uri="{FF2B5EF4-FFF2-40B4-BE49-F238E27FC236}">
                <a16:creationId xmlns:a16="http://schemas.microsoft.com/office/drawing/2014/main" id="{93FA6A69-3DE7-7127-4E79-92BD0082C292}"/>
              </a:ext>
            </a:extLst>
          </p:cNvPr>
          <p:cNvSpPr txBox="1"/>
          <p:nvPr/>
        </p:nvSpPr>
        <p:spPr>
          <a:xfrm>
            <a:off x="1246062" y="4869279"/>
            <a:ext cx="588840" cy="258532"/>
          </a:xfrm>
          <a:prstGeom prst="rect">
            <a:avLst/>
          </a:prstGeom>
          <a:noFill/>
        </p:spPr>
        <p:txBody>
          <a:bodyPr wrap="square" rtlCol="0">
            <a:spAutoFit/>
          </a:bodyPr>
          <a:lstStyle/>
          <a:p>
            <a:pPr algn="ctr">
              <a:lnSpc>
                <a:spcPct val="90000"/>
              </a:lnSpc>
              <a:spcAft>
                <a:spcPts val="600"/>
              </a:spcAft>
            </a:pPr>
            <a:r>
              <a:rPr lang="en-GB" sz="600"/>
              <a:t>T47D Parent DMSO</a:t>
            </a:r>
          </a:p>
        </p:txBody>
      </p:sp>
      <p:sp>
        <p:nvSpPr>
          <p:cNvPr id="13" name="TextBox 12">
            <a:extLst>
              <a:ext uri="{FF2B5EF4-FFF2-40B4-BE49-F238E27FC236}">
                <a16:creationId xmlns:a16="http://schemas.microsoft.com/office/drawing/2014/main" id="{909E9A58-93D6-38DF-65EC-1C1ED6F313A3}"/>
              </a:ext>
            </a:extLst>
          </p:cNvPr>
          <p:cNvSpPr txBox="1"/>
          <p:nvPr/>
        </p:nvSpPr>
        <p:spPr>
          <a:xfrm>
            <a:off x="1800086" y="4869279"/>
            <a:ext cx="566690" cy="341632"/>
          </a:xfrm>
          <a:prstGeom prst="rect">
            <a:avLst/>
          </a:prstGeom>
          <a:noFill/>
        </p:spPr>
        <p:txBody>
          <a:bodyPr wrap="square" rtlCol="0">
            <a:spAutoFit/>
          </a:bodyPr>
          <a:lstStyle/>
          <a:p>
            <a:pPr algn="ctr">
              <a:lnSpc>
                <a:spcPct val="90000"/>
              </a:lnSpc>
              <a:spcAft>
                <a:spcPts val="600"/>
              </a:spcAft>
            </a:pPr>
            <a:r>
              <a:rPr lang="en-GB" sz="600"/>
              <a:t>T47D RB- continuous palbociclib</a:t>
            </a:r>
          </a:p>
        </p:txBody>
      </p:sp>
      <p:sp>
        <p:nvSpPr>
          <p:cNvPr id="14" name="TextBox 13">
            <a:extLst>
              <a:ext uri="{FF2B5EF4-FFF2-40B4-BE49-F238E27FC236}">
                <a16:creationId xmlns:a16="http://schemas.microsoft.com/office/drawing/2014/main" id="{F30AEB6D-B2B4-86BA-1757-734CD16965DB}"/>
              </a:ext>
            </a:extLst>
          </p:cNvPr>
          <p:cNvSpPr txBox="1"/>
          <p:nvPr/>
        </p:nvSpPr>
        <p:spPr>
          <a:xfrm>
            <a:off x="2265344" y="4869279"/>
            <a:ext cx="657791" cy="341632"/>
          </a:xfrm>
          <a:prstGeom prst="rect">
            <a:avLst/>
          </a:prstGeom>
          <a:noFill/>
        </p:spPr>
        <p:txBody>
          <a:bodyPr wrap="square" rtlCol="0">
            <a:spAutoFit/>
          </a:bodyPr>
          <a:lstStyle/>
          <a:p>
            <a:pPr algn="ctr">
              <a:lnSpc>
                <a:spcPct val="90000"/>
              </a:lnSpc>
              <a:spcAft>
                <a:spcPts val="600"/>
              </a:spcAft>
            </a:pPr>
            <a:r>
              <a:rPr lang="en-GB" sz="600"/>
              <a:t>T47D CDK6H continuous palbociclib</a:t>
            </a:r>
          </a:p>
        </p:txBody>
      </p:sp>
      <p:sp>
        <p:nvSpPr>
          <p:cNvPr id="15" name="TextBox 14">
            <a:extLst>
              <a:ext uri="{FF2B5EF4-FFF2-40B4-BE49-F238E27FC236}">
                <a16:creationId xmlns:a16="http://schemas.microsoft.com/office/drawing/2014/main" id="{228FEBB8-0390-8D1B-723D-F09E5466C48F}"/>
              </a:ext>
            </a:extLst>
          </p:cNvPr>
          <p:cNvSpPr txBox="1"/>
          <p:nvPr/>
        </p:nvSpPr>
        <p:spPr>
          <a:xfrm>
            <a:off x="904174" y="3749573"/>
            <a:ext cx="281930" cy="203133"/>
          </a:xfrm>
          <a:prstGeom prst="rect">
            <a:avLst/>
          </a:prstGeom>
          <a:noFill/>
        </p:spPr>
        <p:txBody>
          <a:bodyPr wrap="square" rtlCol="0">
            <a:spAutoFit/>
          </a:bodyPr>
          <a:lstStyle/>
          <a:p>
            <a:pPr algn="l">
              <a:lnSpc>
                <a:spcPct val="90000"/>
              </a:lnSpc>
              <a:spcAft>
                <a:spcPts val="600"/>
              </a:spcAft>
            </a:pPr>
            <a:r>
              <a:rPr lang="en-GB" sz="800"/>
              <a:t>ii</a:t>
            </a:r>
          </a:p>
        </p:txBody>
      </p:sp>
      <p:sp>
        <p:nvSpPr>
          <p:cNvPr id="16" name="TextBox 15">
            <a:extLst>
              <a:ext uri="{FF2B5EF4-FFF2-40B4-BE49-F238E27FC236}">
                <a16:creationId xmlns:a16="http://schemas.microsoft.com/office/drawing/2014/main" id="{98108D97-2E21-C00C-7C3D-B00397AFCF1E}"/>
              </a:ext>
            </a:extLst>
          </p:cNvPr>
          <p:cNvSpPr txBox="1"/>
          <p:nvPr/>
        </p:nvSpPr>
        <p:spPr>
          <a:xfrm>
            <a:off x="1112885" y="2960648"/>
            <a:ext cx="1890899" cy="258532"/>
          </a:xfrm>
          <a:prstGeom prst="rect">
            <a:avLst/>
          </a:prstGeom>
          <a:noFill/>
        </p:spPr>
        <p:txBody>
          <a:bodyPr wrap="square" rtlCol="0">
            <a:spAutoFit/>
          </a:bodyPr>
          <a:lstStyle/>
          <a:p>
            <a:pPr algn="l">
              <a:lnSpc>
                <a:spcPct val="90000"/>
              </a:lnSpc>
              <a:spcAft>
                <a:spcPts val="600"/>
              </a:spcAft>
            </a:pPr>
            <a:r>
              <a:rPr lang="en-GB" sz="600"/>
              <a:t>Genes significant in </a:t>
            </a:r>
            <a:r>
              <a:rPr lang="en-GB" sz="600" b="1"/>
              <a:t>T47D RB- </a:t>
            </a:r>
            <a:r>
              <a:rPr lang="en-GB" sz="600"/>
              <a:t>continuous Palbociclib vs T47D parent DMSO (n=683)</a:t>
            </a:r>
          </a:p>
        </p:txBody>
      </p:sp>
      <p:sp>
        <p:nvSpPr>
          <p:cNvPr id="17" name="TextBox 16">
            <a:extLst>
              <a:ext uri="{FF2B5EF4-FFF2-40B4-BE49-F238E27FC236}">
                <a16:creationId xmlns:a16="http://schemas.microsoft.com/office/drawing/2014/main" id="{F1A7AD55-6D98-2CF5-640D-A1914DE48B87}"/>
              </a:ext>
            </a:extLst>
          </p:cNvPr>
          <p:cNvSpPr txBox="1"/>
          <p:nvPr/>
        </p:nvSpPr>
        <p:spPr>
          <a:xfrm>
            <a:off x="1112885" y="3740233"/>
            <a:ext cx="1856455" cy="258532"/>
          </a:xfrm>
          <a:prstGeom prst="rect">
            <a:avLst/>
          </a:prstGeom>
          <a:noFill/>
        </p:spPr>
        <p:txBody>
          <a:bodyPr wrap="square" rtlCol="0">
            <a:spAutoFit/>
          </a:bodyPr>
          <a:lstStyle/>
          <a:p>
            <a:pPr algn="l">
              <a:lnSpc>
                <a:spcPct val="90000"/>
              </a:lnSpc>
              <a:spcAft>
                <a:spcPts val="600"/>
              </a:spcAft>
            </a:pPr>
            <a:r>
              <a:rPr lang="en-GB" sz="600"/>
              <a:t>Genes significant in </a:t>
            </a:r>
            <a:r>
              <a:rPr lang="en-GB" sz="600" b="1"/>
              <a:t>T47D CDK6H </a:t>
            </a:r>
            <a:r>
              <a:rPr lang="en-GB" sz="600"/>
              <a:t>continuous Palbociclib vs T47D parent DMSO (n=1321)</a:t>
            </a:r>
          </a:p>
        </p:txBody>
      </p:sp>
      <p:pic>
        <p:nvPicPr>
          <p:cNvPr id="18" name="Content Placeholder 7">
            <a:extLst>
              <a:ext uri="{FF2B5EF4-FFF2-40B4-BE49-F238E27FC236}">
                <a16:creationId xmlns:a16="http://schemas.microsoft.com/office/drawing/2014/main" id="{67D9274D-1DC1-5584-EF52-AA0C376954F7}"/>
              </a:ext>
            </a:extLst>
          </p:cNvPr>
          <p:cNvPicPr>
            <a:picLocks noChangeAspect="1"/>
          </p:cNvPicPr>
          <p:nvPr/>
        </p:nvPicPr>
        <p:blipFill rotWithShape="1">
          <a:blip r:embed="rId4"/>
          <a:srcRect l="62287" r="32869" b="59614"/>
          <a:stretch/>
        </p:blipFill>
        <p:spPr>
          <a:xfrm>
            <a:off x="768650" y="3260438"/>
            <a:ext cx="145289" cy="605664"/>
          </a:xfrm>
          <a:prstGeom prst="rect">
            <a:avLst/>
          </a:prstGeom>
        </p:spPr>
      </p:pic>
      <p:sp>
        <p:nvSpPr>
          <p:cNvPr id="19" name="TextBox 18">
            <a:extLst>
              <a:ext uri="{FF2B5EF4-FFF2-40B4-BE49-F238E27FC236}">
                <a16:creationId xmlns:a16="http://schemas.microsoft.com/office/drawing/2014/main" id="{3B79A0DA-7376-EC19-AF14-1E514934AFE3}"/>
              </a:ext>
            </a:extLst>
          </p:cNvPr>
          <p:cNvSpPr txBox="1"/>
          <p:nvPr/>
        </p:nvSpPr>
        <p:spPr>
          <a:xfrm>
            <a:off x="639147" y="3038986"/>
            <a:ext cx="403054" cy="258532"/>
          </a:xfrm>
          <a:prstGeom prst="rect">
            <a:avLst/>
          </a:prstGeom>
          <a:noFill/>
        </p:spPr>
        <p:txBody>
          <a:bodyPr wrap="square" rtlCol="0">
            <a:spAutoFit/>
          </a:bodyPr>
          <a:lstStyle/>
          <a:p>
            <a:pPr algn="l">
              <a:lnSpc>
                <a:spcPct val="90000"/>
              </a:lnSpc>
              <a:spcAft>
                <a:spcPts val="600"/>
              </a:spcAft>
            </a:pPr>
            <a:r>
              <a:rPr lang="en-GB" sz="400" b="1">
                <a:solidFill>
                  <a:schemeClr val="tx1">
                    <a:lumMod val="65000"/>
                    <a:lumOff val="35000"/>
                  </a:schemeClr>
                </a:solidFill>
              </a:rPr>
              <a:t>Z-score of mean counts</a:t>
            </a:r>
          </a:p>
        </p:txBody>
      </p:sp>
      <p:pic>
        <p:nvPicPr>
          <p:cNvPr id="20" name="Picture 19">
            <a:extLst>
              <a:ext uri="{FF2B5EF4-FFF2-40B4-BE49-F238E27FC236}">
                <a16:creationId xmlns:a16="http://schemas.microsoft.com/office/drawing/2014/main" id="{F4D43267-01F6-7473-4522-3FE968D7CDDA}"/>
              </a:ext>
            </a:extLst>
          </p:cNvPr>
          <p:cNvPicPr>
            <a:picLocks noChangeAspect="1"/>
          </p:cNvPicPr>
          <p:nvPr/>
        </p:nvPicPr>
        <p:blipFill>
          <a:blip r:embed="rId6"/>
          <a:stretch>
            <a:fillRect/>
          </a:stretch>
        </p:blipFill>
        <p:spPr>
          <a:xfrm>
            <a:off x="2887987" y="3628560"/>
            <a:ext cx="106336" cy="394672"/>
          </a:xfrm>
          <a:prstGeom prst="rect">
            <a:avLst/>
          </a:prstGeom>
        </p:spPr>
      </p:pic>
      <p:sp>
        <p:nvSpPr>
          <p:cNvPr id="21" name="TextBox 20">
            <a:extLst>
              <a:ext uri="{FF2B5EF4-FFF2-40B4-BE49-F238E27FC236}">
                <a16:creationId xmlns:a16="http://schemas.microsoft.com/office/drawing/2014/main" id="{D09C4768-533A-1C94-2806-D22CC9093A3F}"/>
              </a:ext>
            </a:extLst>
          </p:cNvPr>
          <p:cNvSpPr txBox="1"/>
          <p:nvPr/>
        </p:nvSpPr>
        <p:spPr>
          <a:xfrm>
            <a:off x="2932015" y="3648378"/>
            <a:ext cx="490277" cy="341632"/>
          </a:xfrm>
          <a:prstGeom prst="rect">
            <a:avLst/>
          </a:prstGeom>
          <a:noFill/>
        </p:spPr>
        <p:txBody>
          <a:bodyPr wrap="square" rtlCol="0">
            <a:spAutoFit/>
          </a:bodyPr>
          <a:lstStyle/>
          <a:p>
            <a:pPr algn="l">
              <a:lnSpc>
                <a:spcPct val="90000"/>
              </a:lnSpc>
              <a:spcAft>
                <a:spcPts val="600"/>
              </a:spcAft>
            </a:pPr>
            <a:r>
              <a:rPr lang="en-GB" sz="600"/>
              <a:t>307 common genes</a:t>
            </a:r>
          </a:p>
        </p:txBody>
      </p:sp>
      <p:sp>
        <p:nvSpPr>
          <p:cNvPr id="22" name="Rectangle 21">
            <a:extLst>
              <a:ext uri="{FF2B5EF4-FFF2-40B4-BE49-F238E27FC236}">
                <a16:creationId xmlns:a16="http://schemas.microsoft.com/office/drawing/2014/main" id="{00CEC6E7-03EC-5337-C6F6-578DD1203325}"/>
              </a:ext>
            </a:extLst>
          </p:cNvPr>
          <p:cNvSpPr/>
          <p:nvPr/>
        </p:nvSpPr>
        <p:spPr>
          <a:xfrm>
            <a:off x="4385196" y="3772952"/>
            <a:ext cx="1319753" cy="13197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23" name="Picture 22">
            <a:extLst>
              <a:ext uri="{FF2B5EF4-FFF2-40B4-BE49-F238E27FC236}">
                <a16:creationId xmlns:a16="http://schemas.microsoft.com/office/drawing/2014/main" id="{A29C8993-DA54-D240-3F35-A59C42CDD73A}"/>
              </a:ext>
            </a:extLst>
          </p:cNvPr>
          <p:cNvPicPr>
            <a:picLocks noChangeAspect="1"/>
          </p:cNvPicPr>
          <p:nvPr/>
        </p:nvPicPr>
        <p:blipFill rotWithShape="1">
          <a:blip r:embed="rId7"/>
          <a:srcRect l="91941" b="27168"/>
          <a:stretch/>
        </p:blipFill>
        <p:spPr>
          <a:xfrm>
            <a:off x="3810543" y="3226000"/>
            <a:ext cx="121701" cy="599896"/>
          </a:xfrm>
          <a:prstGeom prst="rect">
            <a:avLst/>
          </a:prstGeom>
        </p:spPr>
      </p:pic>
      <p:sp>
        <p:nvSpPr>
          <p:cNvPr id="24" name="TextBox 23">
            <a:extLst>
              <a:ext uri="{FF2B5EF4-FFF2-40B4-BE49-F238E27FC236}">
                <a16:creationId xmlns:a16="http://schemas.microsoft.com/office/drawing/2014/main" id="{A1C1BE1D-C09C-0FB9-94AF-C8A8E719CDD3}"/>
              </a:ext>
            </a:extLst>
          </p:cNvPr>
          <p:cNvSpPr txBox="1"/>
          <p:nvPr/>
        </p:nvSpPr>
        <p:spPr>
          <a:xfrm>
            <a:off x="3663418" y="2927367"/>
            <a:ext cx="364343" cy="276999"/>
          </a:xfrm>
          <a:prstGeom prst="rect">
            <a:avLst/>
          </a:prstGeom>
          <a:noFill/>
        </p:spPr>
        <p:txBody>
          <a:bodyPr wrap="square" rtlCol="0">
            <a:spAutoFit/>
          </a:bodyPr>
          <a:lstStyle/>
          <a:p>
            <a:r>
              <a:rPr lang="en-GB" sz="400" b="1">
                <a:solidFill>
                  <a:srgbClr val="4A4F4F"/>
                </a:solidFill>
              </a:rPr>
              <a:t>Z-score of mean counts</a:t>
            </a:r>
          </a:p>
        </p:txBody>
      </p:sp>
      <p:sp>
        <p:nvSpPr>
          <p:cNvPr id="25" name="TextBox 24">
            <a:extLst>
              <a:ext uri="{FF2B5EF4-FFF2-40B4-BE49-F238E27FC236}">
                <a16:creationId xmlns:a16="http://schemas.microsoft.com/office/drawing/2014/main" id="{B0E6D0CD-0C30-37AA-4373-6E6247A67433}"/>
              </a:ext>
            </a:extLst>
          </p:cNvPr>
          <p:cNvSpPr txBox="1"/>
          <p:nvPr/>
        </p:nvSpPr>
        <p:spPr>
          <a:xfrm>
            <a:off x="3901936" y="2931720"/>
            <a:ext cx="364343" cy="215444"/>
          </a:xfrm>
          <a:prstGeom prst="rect">
            <a:avLst/>
          </a:prstGeom>
          <a:noFill/>
        </p:spPr>
        <p:txBody>
          <a:bodyPr wrap="square" rtlCol="0">
            <a:spAutoFit/>
          </a:bodyPr>
          <a:lstStyle/>
          <a:p>
            <a:r>
              <a:rPr lang="en-GB" sz="800"/>
              <a:t>i</a:t>
            </a:r>
          </a:p>
        </p:txBody>
      </p:sp>
      <p:sp>
        <p:nvSpPr>
          <p:cNvPr id="26" name="TextBox 25">
            <a:extLst>
              <a:ext uri="{FF2B5EF4-FFF2-40B4-BE49-F238E27FC236}">
                <a16:creationId xmlns:a16="http://schemas.microsoft.com/office/drawing/2014/main" id="{5C4B99EA-B8A8-CB5B-BB1B-4A666CFB5B88}"/>
              </a:ext>
            </a:extLst>
          </p:cNvPr>
          <p:cNvSpPr txBox="1"/>
          <p:nvPr/>
        </p:nvSpPr>
        <p:spPr>
          <a:xfrm>
            <a:off x="3901936" y="3945481"/>
            <a:ext cx="364343" cy="215444"/>
          </a:xfrm>
          <a:prstGeom prst="rect">
            <a:avLst/>
          </a:prstGeom>
          <a:noFill/>
        </p:spPr>
        <p:txBody>
          <a:bodyPr wrap="square" rtlCol="0">
            <a:spAutoFit/>
          </a:bodyPr>
          <a:lstStyle/>
          <a:p>
            <a:r>
              <a:rPr lang="en-GB" sz="800"/>
              <a:t>ii</a:t>
            </a:r>
          </a:p>
        </p:txBody>
      </p:sp>
      <p:sp>
        <p:nvSpPr>
          <p:cNvPr id="27" name="TextBox 26">
            <a:extLst>
              <a:ext uri="{FF2B5EF4-FFF2-40B4-BE49-F238E27FC236}">
                <a16:creationId xmlns:a16="http://schemas.microsoft.com/office/drawing/2014/main" id="{A2ADF71B-2F7F-AE23-5D5B-D00B0CDC8942}"/>
              </a:ext>
            </a:extLst>
          </p:cNvPr>
          <p:cNvSpPr txBox="1"/>
          <p:nvPr/>
        </p:nvSpPr>
        <p:spPr>
          <a:xfrm>
            <a:off x="4250744" y="5127811"/>
            <a:ext cx="580211" cy="369332"/>
          </a:xfrm>
          <a:prstGeom prst="rect">
            <a:avLst/>
          </a:prstGeom>
          <a:noFill/>
        </p:spPr>
        <p:txBody>
          <a:bodyPr wrap="square" rtlCol="0">
            <a:spAutoFit/>
          </a:bodyPr>
          <a:lstStyle/>
          <a:p>
            <a:pPr algn="ctr"/>
            <a:r>
              <a:rPr lang="en-GB" sz="600"/>
              <a:t>MCF7 Parent DMSO</a:t>
            </a:r>
          </a:p>
        </p:txBody>
      </p:sp>
      <p:sp>
        <p:nvSpPr>
          <p:cNvPr id="28" name="TextBox 27">
            <a:extLst>
              <a:ext uri="{FF2B5EF4-FFF2-40B4-BE49-F238E27FC236}">
                <a16:creationId xmlns:a16="http://schemas.microsoft.com/office/drawing/2014/main" id="{B9FBF815-2EAE-8D46-EBB6-16A0C4C91550}"/>
              </a:ext>
            </a:extLst>
          </p:cNvPr>
          <p:cNvSpPr txBox="1"/>
          <p:nvPr/>
        </p:nvSpPr>
        <p:spPr>
          <a:xfrm>
            <a:off x="5327866" y="5127811"/>
            <a:ext cx="580211" cy="369332"/>
          </a:xfrm>
          <a:prstGeom prst="rect">
            <a:avLst/>
          </a:prstGeom>
          <a:noFill/>
        </p:spPr>
        <p:txBody>
          <a:bodyPr wrap="square" rtlCol="0">
            <a:spAutoFit/>
          </a:bodyPr>
          <a:lstStyle/>
          <a:p>
            <a:pPr algn="ctr"/>
            <a:r>
              <a:rPr lang="en-GB" sz="600"/>
              <a:t>MCF7 </a:t>
            </a:r>
            <a:r>
              <a:rPr lang="en-GB" sz="600" err="1"/>
              <a:t>PacqR</a:t>
            </a:r>
            <a:r>
              <a:rPr lang="en-GB" sz="600"/>
              <a:t> continuous palbociclib</a:t>
            </a:r>
          </a:p>
        </p:txBody>
      </p:sp>
      <p:sp>
        <p:nvSpPr>
          <p:cNvPr id="29" name="TextBox 28">
            <a:extLst>
              <a:ext uri="{FF2B5EF4-FFF2-40B4-BE49-F238E27FC236}">
                <a16:creationId xmlns:a16="http://schemas.microsoft.com/office/drawing/2014/main" id="{9CB9E91F-5E5C-8C6A-45E2-C1AB3532E832}"/>
              </a:ext>
            </a:extLst>
          </p:cNvPr>
          <p:cNvSpPr txBox="1"/>
          <p:nvPr/>
        </p:nvSpPr>
        <p:spPr>
          <a:xfrm>
            <a:off x="4788807" y="5127811"/>
            <a:ext cx="566690" cy="369332"/>
          </a:xfrm>
          <a:prstGeom prst="rect">
            <a:avLst/>
          </a:prstGeom>
          <a:noFill/>
        </p:spPr>
        <p:txBody>
          <a:bodyPr wrap="square" rtlCol="0">
            <a:spAutoFit/>
          </a:bodyPr>
          <a:lstStyle/>
          <a:p>
            <a:pPr algn="ctr"/>
            <a:r>
              <a:rPr lang="en-GB" sz="600"/>
              <a:t>MCF7 RB- continuous palbociclib</a:t>
            </a:r>
          </a:p>
        </p:txBody>
      </p:sp>
      <p:sp>
        <p:nvSpPr>
          <p:cNvPr id="30" name="TextBox 29">
            <a:extLst>
              <a:ext uri="{FF2B5EF4-FFF2-40B4-BE49-F238E27FC236}">
                <a16:creationId xmlns:a16="http://schemas.microsoft.com/office/drawing/2014/main" id="{CCA5EF83-F0DF-2D02-5C3E-C0276B97F898}"/>
              </a:ext>
            </a:extLst>
          </p:cNvPr>
          <p:cNvSpPr txBox="1"/>
          <p:nvPr/>
        </p:nvSpPr>
        <p:spPr>
          <a:xfrm>
            <a:off x="4057348" y="3948573"/>
            <a:ext cx="1945026" cy="258532"/>
          </a:xfrm>
          <a:prstGeom prst="rect">
            <a:avLst/>
          </a:prstGeom>
          <a:noFill/>
        </p:spPr>
        <p:txBody>
          <a:bodyPr wrap="square" rtlCol="0">
            <a:spAutoFit/>
          </a:bodyPr>
          <a:lstStyle/>
          <a:p>
            <a:pPr algn="l">
              <a:lnSpc>
                <a:spcPct val="90000"/>
              </a:lnSpc>
              <a:spcAft>
                <a:spcPts val="600"/>
              </a:spcAft>
            </a:pPr>
            <a:r>
              <a:rPr lang="en-GB" sz="600"/>
              <a:t>Genes significant in </a:t>
            </a:r>
            <a:r>
              <a:rPr lang="en-GB" sz="600" b="1"/>
              <a:t>MCF7 </a:t>
            </a:r>
            <a:r>
              <a:rPr lang="en-GB" sz="600" b="1" err="1"/>
              <a:t>PacqR</a:t>
            </a:r>
            <a:r>
              <a:rPr lang="en-GB" sz="600" b="1"/>
              <a:t> </a:t>
            </a:r>
            <a:r>
              <a:rPr lang="en-GB" sz="600"/>
              <a:t>continuous Palbociclib vs MCF7 parental DMSO (n=2975)</a:t>
            </a:r>
          </a:p>
        </p:txBody>
      </p:sp>
      <p:sp>
        <p:nvSpPr>
          <p:cNvPr id="31" name="TextBox 30">
            <a:extLst>
              <a:ext uri="{FF2B5EF4-FFF2-40B4-BE49-F238E27FC236}">
                <a16:creationId xmlns:a16="http://schemas.microsoft.com/office/drawing/2014/main" id="{AB6790D9-6D8A-DDA6-E7B4-21B501E14008}"/>
              </a:ext>
            </a:extLst>
          </p:cNvPr>
          <p:cNvSpPr txBox="1"/>
          <p:nvPr/>
        </p:nvSpPr>
        <p:spPr>
          <a:xfrm>
            <a:off x="4057348" y="2923192"/>
            <a:ext cx="1919961" cy="258532"/>
          </a:xfrm>
          <a:prstGeom prst="rect">
            <a:avLst/>
          </a:prstGeom>
          <a:noFill/>
        </p:spPr>
        <p:txBody>
          <a:bodyPr wrap="square" rtlCol="0">
            <a:spAutoFit/>
          </a:bodyPr>
          <a:lstStyle/>
          <a:p>
            <a:pPr>
              <a:lnSpc>
                <a:spcPct val="90000"/>
              </a:lnSpc>
              <a:spcAft>
                <a:spcPts val="600"/>
              </a:spcAft>
            </a:pPr>
            <a:r>
              <a:rPr lang="en-GB" sz="600"/>
              <a:t>Genes significant in </a:t>
            </a:r>
            <a:r>
              <a:rPr lang="en-GB" sz="600" b="1"/>
              <a:t>MCF7 RB- </a:t>
            </a:r>
            <a:r>
              <a:rPr lang="en-GB" sz="600"/>
              <a:t>continuous Palbociclib vs MCF7 parental DMSO (n=3092)</a:t>
            </a:r>
          </a:p>
        </p:txBody>
      </p:sp>
      <p:pic>
        <p:nvPicPr>
          <p:cNvPr id="32" name="Picture 31">
            <a:extLst>
              <a:ext uri="{FF2B5EF4-FFF2-40B4-BE49-F238E27FC236}">
                <a16:creationId xmlns:a16="http://schemas.microsoft.com/office/drawing/2014/main" id="{CB6DF7A1-F087-0F21-C0E8-A41A5A1DCA92}"/>
              </a:ext>
            </a:extLst>
          </p:cNvPr>
          <p:cNvPicPr>
            <a:picLocks noChangeAspect="1"/>
          </p:cNvPicPr>
          <p:nvPr/>
        </p:nvPicPr>
        <p:blipFill>
          <a:blip r:embed="rId8"/>
          <a:stretch>
            <a:fillRect/>
          </a:stretch>
        </p:blipFill>
        <p:spPr>
          <a:xfrm>
            <a:off x="5880156" y="3828360"/>
            <a:ext cx="106336" cy="394671"/>
          </a:xfrm>
          <a:prstGeom prst="rect">
            <a:avLst/>
          </a:prstGeom>
        </p:spPr>
      </p:pic>
      <p:sp>
        <p:nvSpPr>
          <p:cNvPr id="33" name="TextBox 32">
            <a:extLst>
              <a:ext uri="{FF2B5EF4-FFF2-40B4-BE49-F238E27FC236}">
                <a16:creationId xmlns:a16="http://schemas.microsoft.com/office/drawing/2014/main" id="{F6E03C92-5999-B2B1-5CED-35A8036E2807}"/>
              </a:ext>
            </a:extLst>
          </p:cNvPr>
          <p:cNvSpPr txBox="1"/>
          <p:nvPr/>
        </p:nvSpPr>
        <p:spPr>
          <a:xfrm>
            <a:off x="5922292" y="3831466"/>
            <a:ext cx="483494" cy="341632"/>
          </a:xfrm>
          <a:prstGeom prst="rect">
            <a:avLst/>
          </a:prstGeom>
          <a:noFill/>
        </p:spPr>
        <p:txBody>
          <a:bodyPr wrap="square" rtlCol="0">
            <a:spAutoFit/>
          </a:bodyPr>
          <a:lstStyle/>
          <a:p>
            <a:pPr algn="l">
              <a:lnSpc>
                <a:spcPct val="90000"/>
              </a:lnSpc>
              <a:spcAft>
                <a:spcPts val="600"/>
              </a:spcAft>
            </a:pPr>
            <a:r>
              <a:rPr lang="en-GB" sz="600"/>
              <a:t>1819 common genes </a:t>
            </a:r>
          </a:p>
        </p:txBody>
      </p:sp>
      <p:pic>
        <p:nvPicPr>
          <p:cNvPr id="36" name="Picture 35">
            <a:extLst>
              <a:ext uri="{FF2B5EF4-FFF2-40B4-BE49-F238E27FC236}">
                <a16:creationId xmlns:a16="http://schemas.microsoft.com/office/drawing/2014/main" id="{7312AE34-883E-5A1B-C8EA-2E1A778CF595}"/>
              </a:ext>
            </a:extLst>
          </p:cNvPr>
          <p:cNvPicPr>
            <a:picLocks noChangeAspect="1"/>
          </p:cNvPicPr>
          <p:nvPr/>
        </p:nvPicPr>
        <p:blipFill rotWithShape="1">
          <a:blip r:embed="rId9"/>
          <a:srcRect r="38665" b="57797"/>
          <a:stretch/>
        </p:blipFill>
        <p:spPr>
          <a:xfrm>
            <a:off x="4050710" y="4163607"/>
            <a:ext cx="1808378" cy="984622"/>
          </a:xfrm>
          <a:prstGeom prst="rect">
            <a:avLst/>
          </a:prstGeom>
        </p:spPr>
      </p:pic>
      <p:pic>
        <p:nvPicPr>
          <p:cNvPr id="37" name="Picture 36">
            <a:extLst>
              <a:ext uri="{FF2B5EF4-FFF2-40B4-BE49-F238E27FC236}">
                <a16:creationId xmlns:a16="http://schemas.microsoft.com/office/drawing/2014/main" id="{79AA0C18-B2C1-9167-66B4-E4D13917BBC9}"/>
              </a:ext>
            </a:extLst>
          </p:cNvPr>
          <p:cNvPicPr>
            <a:picLocks noChangeAspect="1"/>
          </p:cNvPicPr>
          <p:nvPr/>
        </p:nvPicPr>
        <p:blipFill rotWithShape="1">
          <a:blip r:embed="rId10"/>
          <a:srcRect r="38399" b="57235"/>
          <a:stretch/>
        </p:blipFill>
        <p:spPr>
          <a:xfrm>
            <a:off x="4054961" y="3148682"/>
            <a:ext cx="1804127" cy="794117"/>
          </a:xfrm>
          <a:prstGeom prst="rect">
            <a:avLst/>
          </a:prstGeom>
        </p:spPr>
      </p:pic>
      <p:sp>
        <p:nvSpPr>
          <p:cNvPr id="38" name="TextBox 37">
            <a:extLst>
              <a:ext uri="{FF2B5EF4-FFF2-40B4-BE49-F238E27FC236}">
                <a16:creationId xmlns:a16="http://schemas.microsoft.com/office/drawing/2014/main" id="{55FB8DEA-A1C0-0D21-7E0D-5C65787422E5}"/>
              </a:ext>
            </a:extLst>
          </p:cNvPr>
          <p:cNvSpPr txBox="1"/>
          <p:nvPr/>
        </p:nvSpPr>
        <p:spPr>
          <a:xfrm>
            <a:off x="3468388" y="2835889"/>
            <a:ext cx="127693" cy="276999"/>
          </a:xfrm>
          <a:prstGeom prst="rect">
            <a:avLst/>
          </a:prstGeom>
          <a:noFill/>
        </p:spPr>
        <p:txBody>
          <a:bodyPr wrap="square" rtlCol="0">
            <a:spAutoFit/>
          </a:bodyPr>
          <a:lstStyle/>
          <a:p>
            <a:r>
              <a:rPr lang="en-GB" sz="1200" b="1"/>
              <a:t>D</a:t>
            </a:r>
          </a:p>
        </p:txBody>
      </p:sp>
      <p:sp>
        <p:nvSpPr>
          <p:cNvPr id="3" name="TextBox 2">
            <a:extLst>
              <a:ext uri="{FF2B5EF4-FFF2-40B4-BE49-F238E27FC236}">
                <a16:creationId xmlns:a16="http://schemas.microsoft.com/office/drawing/2014/main" id="{2AA4D702-384A-4A31-C9AA-0978B445134A}"/>
              </a:ext>
            </a:extLst>
          </p:cNvPr>
          <p:cNvSpPr txBox="1"/>
          <p:nvPr/>
        </p:nvSpPr>
        <p:spPr>
          <a:xfrm>
            <a:off x="896667" y="2955469"/>
            <a:ext cx="259339" cy="203133"/>
          </a:xfrm>
          <a:prstGeom prst="rect">
            <a:avLst/>
          </a:prstGeom>
          <a:noFill/>
        </p:spPr>
        <p:txBody>
          <a:bodyPr wrap="square" lIns="91440" tIns="45720" rIns="91440" bIns="45720" rtlCol="0" anchor="t">
            <a:spAutoFit/>
          </a:bodyPr>
          <a:lstStyle/>
          <a:p>
            <a:pPr algn="l">
              <a:lnSpc>
                <a:spcPct val="90000"/>
              </a:lnSpc>
              <a:spcAft>
                <a:spcPts val="600"/>
              </a:spcAft>
            </a:pPr>
            <a:r>
              <a:rPr lang="en-GB" sz="800"/>
              <a:t>i</a:t>
            </a:r>
          </a:p>
        </p:txBody>
      </p:sp>
      <p:pic>
        <p:nvPicPr>
          <p:cNvPr id="5" name="Picture 4">
            <a:extLst>
              <a:ext uri="{FF2B5EF4-FFF2-40B4-BE49-F238E27FC236}">
                <a16:creationId xmlns:a16="http://schemas.microsoft.com/office/drawing/2014/main" id="{AA10CFEC-5F2E-5FB9-B390-35F0AF277C2A}"/>
              </a:ext>
            </a:extLst>
          </p:cNvPr>
          <p:cNvPicPr>
            <a:picLocks noChangeAspect="1"/>
          </p:cNvPicPr>
          <p:nvPr/>
        </p:nvPicPr>
        <p:blipFill>
          <a:blip r:embed="rId11"/>
          <a:stretch>
            <a:fillRect/>
          </a:stretch>
        </p:blipFill>
        <p:spPr>
          <a:xfrm>
            <a:off x="4143210" y="611423"/>
            <a:ext cx="1561739" cy="1399591"/>
          </a:xfrm>
          <a:prstGeom prst="rect">
            <a:avLst/>
          </a:prstGeom>
        </p:spPr>
      </p:pic>
    </p:spTree>
    <p:extLst>
      <p:ext uri="{BB962C8B-B14F-4D97-AF65-F5344CB8AC3E}">
        <p14:creationId xmlns:p14="http://schemas.microsoft.com/office/powerpoint/2010/main" val="5869639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1334944-548F-4DA2-3697-905434F3224D}"/>
              </a:ext>
            </a:extLst>
          </p:cNvPr>
          <p:cNvSpPr txBox="1"/>
          <p:nvPr/>
        </p:nvSpPr>
        <p:spPr>
          <a:xfrm>
            <a:off x="601397" y="66180"/>
            <a:ext cx="3355763" cy="292388"/>
          </a:xfrm>
          <a:prstGeom prst="rect">
            <a:avLst/>
          </a:prstGeom>
          <a:noFill/>
        </p:spPr>
        <p:txBody>
          <a:bodyPr wrap="square" lIns="91440" tIns="45720" rIns="91440" bIns="45720" rtlCol="0" anchor="t">
            <a:spAutoFit/>
          </a:bodyPr>
          <a:lstStyle/>
          <a:p>
            <a:r>
              <a:rPr lang="en-GB" sz="1300"/>
              <a:t>Supplementary Figure 2</a:t>
            </a:r>
          </a:p>
        </p:txBody>
      </p:sp>
      <p:sp>
        <p:nvSpPr>
          <p:cNvPr id="6" name="TextBox 5">
            <a:extLst>
              <a:ext uri="{FF2B5EF4-FFF2-40B4-BE49-F238E27FC236}">
                <a16:creationId xmlns:a16="http://schemas.microsoft.com/office/drawing/2014/main" id="{9DDE1708-E215-4D93-5BEA-58AB30411A90}"/>
              </a:ext>
            </a:extLst>
          </p:cNvPr>
          <p:cNvSpPr txBox="1"/>
          <p:nvPr/>
        </p:nvSpPr>
        <p:spPr>
          <a:xfrm>
            <a:off x="625603" y="3154418"/>
            <a:ext cx="156287" cy="276999"/>
          </a:xfrm>
          <a:prstGeom prst="rect">
            <a:avLst/>
          </a:prstGeom>
          <a:noFill/>
        </p:spPr>
        <p:txBody>
          <a:bodyPr wrap="square" rtlCol="0">
            <a:spAutoFit/>
          </a:bodyPr>
          <a:lstStyle/>
          <a:p>
            <a:r>
              <a:rPr lang="en-GB" sz="1200" b="1"/>
              <a:t>B</a:t>
            </a:r>
          </a:p>
        </p:txBody>
      </p:sp>
      <p:sp>
        <p:nvSpPr>
          <p:cNvPr id="8" name="TextBox 7">
            <a:extLst>
              <a:ext uri="{FF2B5EF4-FFF2-40B4-BE49-F238E27FC236}">
                <a16:creationId xmlns:a16="http://schemas.microsoft.com/office/drawing/2014/main" id="{03B37B17-6FF5-7DA8-74F9-0B6ADFA7361A}"/>
              </a:ext>
            </a:extLst>
          </p:cNvPr>
          <p:cNvSpPr txBox="1"/>
          <p:nvPr/>
        </p:nvSpPr>
        <p:spPr>
          <a:xfrm>
            <a:off x="626783" y="402213"/>
            <a:ext cx="156287" cy="276999"/>
          </a:xfrm>
          <a:prstGeom prst="rect">
            <a:avLst/>
          </a:prstGeom>
          <a:noFill/>
        </p:spPr>
        <p:txBody>
          <a:bodyPr wrap="square" rtlCol="0">
            <a:spAutoFit/>
          </a:bodyPr>
          <a:lstStyle/>
          <a:p>
            <a:r>
              <a:rPr lang="en-GB" sz="1200" b="1"/>
              <a:t>A</a:t>
            </a:r>
          </a:p>
        </p:txBody>
      </p:sp>
      <p:sp>
        <p:nvSpPr>
          <p:cNvPr id="10" name="TextBox 9">
            <a:extLst>
              <a:ext uri="{FF2B5EF4-FFF2-40B4-BE49-F238E27FC236}">
                <a16:creationId xmlns:a16="http://schemas.microsoft.com/office/drawing/2014/main" id="{9440F98B-9E64-0769-49A3-928C55A67FC9}"/>
              </a:ext>
            </a:extLst>
          </p:cNvPr>
          <p:cNvSpPr txBox="1"/>
          <p:nvPr/>
        </p:nvSpPr>
        <p:spPr>
          <a:xfrm>
            <a:off x="653109" y="6108851"/>
            <a:ext cx="127693" cy="276999"/>
          </a:xfrm>
          <a:prstGeom prst="rect">
            <a:avLst/>
          </a:prstGeom>
          <a:noFill/>
        </p:spPr>
        <p:txBody>
          <a:bodyPr wrap="square" rtlCol="0">
            <a:spAutoFit/>
          </a:bodyPr>
          <a:lstStyle/>
          <a:p>
            <a:r>
              <a:rPr lang="en-GB" sz="1200" b="1"/>
              <a:t>C</a:t>
            </a:r>
          </a:p>
        </p:txBody>
      </p:sp>
      <p:graphicFrame>
        <p:nvGraphicFramePr>
          <p:cNvPr id="2" name="Object 1">
            <a:extLst>
              <a:ext uri="{FF2B5EF4-FFF2-40B4-BE49-F238E27FC236}">
                <a16:creationId xmlns:a16="http://schemas.microsoft.com/office/drawing/2014/main" id="{6E3D9797-DACA-5CD9-47B1-8D2AF69F2060}"/>
              </a:ext>
            </a:extLst>
          </p:cNvPr>
          <p:cNvGraphicFramePr>
            <a:graphicFrameLocks noChangeAspect="1"/>
          </p:cNvGraphicFramePr>
          <p:nvPr>
            <p:extLst>
              <p:ext uri="{D42A27DB-BD31-4B8C-83A1-F6EECF244321}">
                <p14:modId xmlns:p14="http://schemas.microsoft.com/office/powerpoint/2010/main" val="4217308886"/>
              </p:ext>
            </p:extLst>
          </p:nvPr>
        </p:nvGraphicFramePr>
        <p:xfrm>
          <a:off x="780802" y="413553"/>
          <a:ext cx="3382627" cy="2939277"/>
        </p:xfrm>
        <a:graphic>
          <a:graphicData uri="http://schemas.openxmlformats.org/presentationml/2006/ole">
            <mc:AlternateContent xmlns:mc="http://schemas.openxmlformats.org/markup-compatibility/2006">
              <mc:Choice xmlns:v="urn:schemas-microsoft-com:vml" Requires="v">
                <p:oleObj name="Prism 8" r:id="rId2" imgW="6770097" imgH="5883530" progId="Prism8.Document">
                  <p:embed/>
                </p:oleObj>
              </mc:Choice>
              <mc:Fallback>
                <p:oleObj name="Prism 8" r:id="rId2" imgW="6770097" imgH="5883530" progId="Prism8.Document">
                  <p:embed/>
                  <p:pic>
                    <p:nvPicPr>
                      <p:cNvPr id="2" name="Object 1">
                        <a:extLst>
                          <a:ext uri="{FF2B5EF4-FFF2-40B4-BE49-F238E27FC236}">
                            <a16:creationId xmlns:a16="http://schemas.microsoft.com/office/drawing/2014/main" id="{6E3D9797-DACA-5CD9-47B1-8D2AF69F2060}"/>
                          </a:ext>
                        </a:extLst>
                      </p:cNvPr>
                      <p:cNvPicPr/>
                      <p:nvPr/>
                    </p:nvPicPr>
                    <p:blipFill>
                      <a:blip r:embed="rId3"/>
                      <a:stretch>
                        <a:fillRect/>
                      </a:stretch>
                    </p:blipFill>
                    <p:spPr>
                      <a:xfrm>
                        <a:off x="780802" y="413553"/>
                        <a:ext cx="3382627" cy="2939277"/>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93315321-C7FF-F0E5-00A6-234067AFC343}"/>
              </a:ext>
            </a:extLst>
          </p:cNvPr>
          <p:cNvGraphicFramePr>
            <a:graphicFrameLocks noChangeAspect="1"/>
          </p:cNvGraphicFramePr>
          <p:nvPr>
            <p:extLst>
              <p:ext uri="{D42A27DB-BD31-4B8C-83A1-F6EECF244321}">
                <p14:modId xmlns:p14="http://schemas.microsoft.com/office/powerpoint/2010/main" val="3878433617"/>
              </p:ext>
            </p:extLst>
          </p:nvPr>
        </p:nvGraphicFramePr>
        <p:xfrm>
          <a:off x="780802" y="3329020"/>
          <a:ext cx="3382626" cy="2820301"/>
        </p:xfrm>
        <a:graphic>
          <a:graphicData uri="http://schemas.openxmlformats.org/presentationml/2006/ole">
            <mc:AlternateContent xmlns:mc="http://schemas.openxmlformats.org/markup-compatibility/2006">
              <mc:Choice xmlns:v="urn:schemas-microsoft-com:vml" Requires="v">
                <p:oleObj name="Prism 8" r:id="rId4" imgW="6808260" imgH="5676143" progId="Prism8.Document">
                  <p:embed/>
                </p:oleObj>
              </mc:Choice>
              <mc:Fallback>
                <p:oleObj name="Prism 8" r:id="rId4" imgW="6808260" imgH="5676143" progId="Prism8.Document">
                  <p:embed/>
                  <p:pic>
                    <p:nvPicPr>
                      <p:cNvPr id="7" name="Object 6">
                        <a:extLst>
                          <a:ext uri="{FF2B5EF4-FFF2-40B4-BE49-F238E27FC236}">
                            <a16:creationId xmlns:a16="http://schemas.microsoft.com/office/drawing/2014/main" id="{93315321-C7FF-F0E5-00A6-234067AFC343}"/>
                          </a:ext>
                        </a:extLst>
                      </p:cNvPr>
                      <p:cNvPicPr/>
                      <p:nvPr/>
                    </p:nvPicPr>
                    <p:blipFill>
                      <a:blip r:embed="rId5"/>
                      <a:stretch>
                        <a:fillRect/>
                      </a:stretch>
                    </p:blipFill>
                    <p:spPr>
                      <a:xfrm>
                        <a:off x="780802" y="3329020"/>
                        <a:ext cx="3382626" cy="2820301"/>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D1676BB6-7E4A-369F-73C1-FE5B0EDEFB84}"/>
              </a:ext>
            </a:extLst>
          </p:cNvPr>
          <p:cNvGraphicFramePr>
            <a:graphicFrameLocks noChangeAspect="1"/>
          </p:cNvGraphicFramePr>
          <p:nvPr>
            <p:extLst>
              <p:ext uri="{D42A27DB-BD31-4B8C-83A1-F6EECF244321}">
                <p14:modId xmlns:p14="http://schemas.microsoft.com/office/powerpoint/2010/main" val="1666897007"/>
              </p:ext>
            </p:extLst>
          </p:nvPr>
        </p:nvGraphicFramePr>
        <p:xfrm>
          <a:off x="780801" y="6162671"/>
          <a:ext cx="3435663" cy="3006727"/>
        </p:xfrm>
        <a:graphic>
          <a:graphicData uri="http://schemas.openxmlformats.org/presentationml/2006/ole">
            <mc:AlternateContent xmlns:mc="http://schemas.openxmlformats.org/markup-compatibility/2006">
              <mc:Choice xmlns:v="urn:schemas-microsoft-com:vml" Requires="v">
                <p:oleObj name="Prism 8" r:id="rId6" imgW="6978917" imgH="6107480" progId="Prism8.Document">
                  <p:embed/>
                </p:oleObj>
              </mc:Choice>
              <mc:Fallback>
                <p:oleObj name="Prism 8" r:id="rId6" imgW="6978917" imgH="6107480" progId="Prism8.Document">
                  <p:embed/>
                  <p:pic>
                    <p:nvPicPr>
                      <p:cNvPr id="11" name="Object 10">
                        <a:extLst>
                          <a:ext uri="{FF2B5EF4-FFF2-40B4-BE49-F238E27FC236}">
                            <a16:creationId xmlns:a16="http://schemas.microsoft.com/office/drawing/2014/main" id="{D1676BB6-7E4A-369F-73C1-FE5B0EDEFB84}"/>
                          </a:ext>
                        </a:extLst>
                      </p:cNvPr>
                      <p:cNvPicPr/>
                      <p:nvPr/>
                    </p:nvPicPr>
                    <p:blipFill>
                      <a:blip r:embed="rId7"/>
                      <a:stretch>
                        <a:fillRect/>
                      </a:stretch>
                    </p:blipFill>
                    <p:spPr>
                      <a:xfrm>
                        <a:off x="780801" y="6162671"/>
                        <a:ext cx="3435663" cy="3006727"/>
                      </a:xfrm>
                      <a:prstGeom prst="rect">
                        <a:avLst/>
                      </a:prstGeom>
                    </p:spPr>
                  </p:pic>
                </p:oleObj>
              </mc:Fallback>
            </mc:AlternateContent>
          </a:graphicData>
        </a:graphic>
      </p:graphicFrame>
    </p:spTree>
    <p:extLst>
      <p:ext uri="{BB962C8B-B14F-4D97-AF65-F5344CB8AC3E}">
        <p14:creationId xmlns:p14="http://schemas.microsoft.com/office/powerpoint/2010/main" val="24876375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CEF116-AFC8-44FA-B66B-71B5263D6FFB}"/>
              </a:ext>
            </a:extLst>
          </p:cNvPr>
          <p:cNvSpPr txBox="1">
            <a:spLocks/>
          </p:cNvSpPr>
          <p:nvPr/>
        </p:nvSpPr>
        <p:spPr>
          <a:xfrm>
            <a:off x="562757" y="214159"/>
            <a:ext cx="5333064" cy="266237"/>
          </a:xfrm>
          <a:prstGeom prst="rect">
            <a:avLst/>
          </a:prstGeom>
        </p:spPr>
        <p:txBody>
          <a:bodyPr lIns="91440" tIns="45720" rIns="91440" bIns="4572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300">
                <a:latin typeface="+mn-lt"/>
              </a:rPr>
              <a:t>Supplementary Figure 3. T47D parental.</a:t>
            </a:r>
          </a:p>
        </p:txBody>
      </p:sp>
      <p:sp>
        <p:nvSpPr>
          <p:cNvPr id="379" name="TextBox 378">
            <a:extLst>
              <a:ext uri="{FF2B5EF4-FFF2-40B4-BE49-F238E27FC236}">
                <a16:creationId xmlns:a16="http://schemas.microsoft.com/office/drawing/2014/main" id="{F7EAE217-741A-4F90-954F-B4B5D66AAAA6}"/>
              </a:ext>
            </a:extLst>
          </p:cNvPr>
          <p:cNvSpPr txBox="1"/>
          <p:nvPr/>
        </p:nvSpPr>
        <p:spPr>
          <a:xfrm>
            <a:off x="564414" y="773326"/>
            <a:ext cx="165159" cy="276999"/>
          </a:xfrm>
          <a:prstGeom prst="rect">
            <a:avLst/>
          </a:prstGeom>
          <a:noFill/>
        </p:spPr>
        <p:txBody>
          <a:bodyPr wrap="square" rtlCol="0">
            <a:spAutoFit/>
          </a:bodyPr>
          <a:lstStyle/>
          <a:p>
            <a:r>
              <a:rPr lang="en-GB" sz="1200" b="1"/>
              <a:t>A</a:t>
            </a:r>
          </a:p>
        </p:txBody>
      </p:sp>
      <p:sp>
        <p:nvSpPr>
          <p:cNvPr id="412" name="TextBox 411">
            <a:extLst>
              <a:ext uri="{FF2B5EF4-FFF2-40B4-BE49-F238E27FC236}">
                <a16:creationId xmlns:a16="http://schemas.microsoft.com/office/drawing/2014/main" id="{3417305D-A822-4E05-8310-5D642A94BF46}"/>
              </a:ext>
            </a:extLst>
          </p:cNvPr>
          <p:cNvSpPr txBox="1"/>
          <p:nvPr/>
        </p:nvSpPr>
        <p:spPr>
          <a:xfrm>
            <a:off x="3651272" y="2943854"/>
            <a:ext cx="165159" cy="276999"/>
          </a:xfrm>
          <a:prstGeom prst="rect">
            <a:avLst/>
          </a:prstGeom>
          <a:noFill/>
        </p:spPr>
        <p:txBody>
          <a:bodyPr wrap="square" rtlCol="0">
            <a:spAutoFit/>
          </a:bodyPr>
          <a:lstStyle/>
          <a:p>
            <a:r>
              <a:rPr lang="en-GB" sz="1200" b="1"/>
              <a:t>D</a:t>
            </a:r>
          </a:p>
        </p:txBody>
      </p:sp>
      <p:cxnSp>
        <p:nvCxnSpPr>
          <p:cNvPr id="7" name="Straight Connector 6">
            <a:extLst>
              <a:ext uri="{FF2B5EF4-FFF2-40B4-BE49-F238E27FC236}">
                <a16:creationId xmlns:a16="http://schemas.microsoft.com/office/drawing/2014/main" id="{F5A12402-5D66-437D-B038-DEA5EF6575E4}"/>
              </a:ext>
            </a:extLst>
          </p:cNvPr>
          <p:cNvCxnSpPr>
            <a:cxnSpLocks/>
          </p:cNvCxnSpPr>
          <p:nvPr/>
        </p:nvCxnSpPr>
        <p:spPr>
          <a:xfrm flipV="1">
            <a:off x="3347156" y="4363863"/>
            <a:ext cx="2770279" cy="6196"/>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9" name="TextBox 8">
            <a:extLst>
              <a:ext uri="{FF2B5EF4-FFF2-40B4-BE49-F238E27FC236}">
                <a16:creationId xmlns:a16="http://schemas.microsoft.com/office/drawing/2014/main" id="{D4EE5172-2217-41F7-8E3D-EC1A0EBF19A8}"/>
              </a:ext>
            </a:extLst>
          </p:cNvPr>
          <p:cNvSpPr txBox="1"/>
          <p:nvPr/>
        </p:nvSpPr>
        <p:spPr>
          <a:xfrm rot="16200000">
            <a:off x="5763592" y="3454270"/>
            <a:ext cx="1090368" cy="392415"/>
          </a:xfrm>
          <a:prstGeom prst="rect">
            <a:avLst/>
          </a:prstGeom>
          <a:noFill/>
        </p:spPr>
        <p:txBody>
          <a:bodyPr wrap="square" rtlCol="0">
            <a:spAutoFit/>
          </a:bodyPr>
          <a:lstStyle/>
          <a:p>
            <a:pPr algn="ctr"/>
            <a:r>
              <a:rPr lang="en-GB" sz="975">
                <a:solidFill>
                  <a:schemeClr val="accent1"/>
                </a:solidFill>
              </a:rPr>
              <a:t>Top 25 Downregulated</a:t>
            </a:r>
          </a:p>
        </p:txBody>
      </p:sp>
      <p:sp>
        <p:nvSpPr>
          <p:cNvPr id="55" name="TextBox 54">
            <a:extLst>
              <a:ext uri="{FF2B5EF4-FFF2-40B4-BE49-F238E27FC236}">
                <a16:creationId xmlns:a16="http://schemas.microsoft.com/office/drawing/2014/main" id="{0C13D1AF-2AE2-404C-ADBA-85D72E745637}"/>
              </a:ext>
            </a:extLst>
          </p:cNvPr>
          <p:cNvSpPr txBox="1"/>
          <p:nvPr/>
        </p:nvSpPr>
        <p:spPr>
          <a:xfrm rot="16200000">
            <a:off x="5753595" y="4681592"/>
            <a:ext cx="1090368" cy="392415"/>
          </a:xfrm>
          <a:prstGeom prst="rect">
            <a:avLst/>
          </a:prstGeom>
          <a:noFill/>
        </p:spPr>
        <p:txBody>
          <a:bodyPr wrap="square" rtlCol="0">
            <a:spAutoFit/>
          </a:bodyPr>
          <a:lstStyle/>
          <a:p>
            <a:pPr algn="ctr"/>
            <a:r>
              <a:rPr lang="en-GB" sz="975">
                <a:solidFill>
                  <a:srgbClr val="FF0000"/>
                </a:solidFill>
              </a:rPr>
              <a:t>Top 25 Upregulated</a:t>
            </a:r>
          </a:p>
        </p:txBody>
      </p:sp>
      <p:pic>
        <p:nvPicPr>
          <p:cNvPr id="20" name="Picture 19">
            <a:extLst>
              <a:ext uri="{FF2B5EF4-FFF2-40B4-BE49-F238E27FC236}">
                <a16:creationId xmlns:a16="http://schemas.microsoft.com/office/drawing/2014/main" id="{E477A115-B87D-4D8A-BA68-58232E11E8A6}"/>
              </a:ext>
            </a:extLst>
          </p:cNvPr>
          <p:cNvPicPr>
            <a:picLocks noChangeAspect="1"/>
          </p:cNvPicPr>
          <p:nvPr/>
        </p:nvPicPr>
        <p:blipFill rotWithShape="1">
          <a:blip r:embed="rId3"/>
          <a:srcRect l="2268" t="5292"/>
          <a:stretch/>
        </p:blipFill>
        <p:spPr>
          <a:xfrm>
            <a:off x="3924110" y="3065470"/>
            <a:ext cx="2197764" cy="1291208"/>
          </a:xfrm>
          <a:prstGeom prst="rect">
            <a:avLst/>
          </a:prstGeom>
        </p:spPr>
      </p:pic>
      <p:grpSp>
        <p:nvGrpSpPr>
          <p:cNvPr id="5" name="Group 4">
            <a:extLst>
              <a:ext uri="{FF2B5EF4-FFF2-40B4-BE49-F238E27FC236}">
                <a16:creationId xmlns:a16="http://schemas.microsoft.com/office/drawing/2014/main" id="{FEA934F4-8C71-4B30-95FA-43C705B5EE5B}"/>
              </a:ext>
            </a:extLst>
          </p:cNvPr>
          <p:cNvGrpSpPr/>
          <p:nvPr/>
        </p:nvGrpSpPr>
        <p:grpSpPr>
          <a:xfrm>
            <a:off x="2575987" y="4402133"/>
            <a:ext cx="3566019" cy="2443168"/>
            <a:chOff x="1835137" y="3220902"/>
            <a:chExt cx="3566019" cy="2443168"/>
          </a:xfrm>
        </p:grpSpPr>
        <p:sp>
          <p:nvSpPr>
            <p:cNvPr id="4" name="TextBox 3">
              <a:extLst>
                <a:ext uri="{FF2B5EF4-FFF2-40B4-BE49-F238E27FC236}">
                  <a16:creationId xmlns:a16="http://schemas.microsoft.com/office/drawing/2014/main" id="{94088B88-84D0-4D06-9494-E283F85D81C5}"/>
                </a:ext>
              </a:extLst>
            </p:cNvPr>
            <p:cNvSpPr txBox="1"/>
            <p:nvPr/>
          </p:nvSpPr>
          <p:spPr>
            <a:xfrm rot="5400000">
              <a:off x="4274578" y="4890935"/>
              <a:ext cx="1013239" cy="533031"/>
            </a:xfrm>
            <a:prstGeom prst="rect">
              <a:avLst/>
            </a:prstGeom>
            <a:solidFill>
              <a:schemeClr val="bg1"/>
            </a:solidFill>
          </p:spPr>
          <p:txBody>
            <a:bodyPr wrap="square" lIns="91440" tIns="45720" rIns="91440" bIns="45720" rtlCol="0" anchor="t">
              <a:spAutoFit/>
            </a:bodyPr>
            <a:lstStyle/>
            <a:p>
              <a:pPr>
                <a:lnSpc>
                  <a:spcPts val="1200"/>
                </a:lnSpc>
              </a:pPr>
              <a:r>
                <a:rPr lang="en-GB" sz="600">
                  <a:solidFill>
                    <a:srgbClr val="080808"/>
                  </a:solidFill>
                  <a:latin typeface="Arial" panose="020B0604020202020204" pitchFamily="34" charset="0"/>
                  <a:cs typeface="Arial" panose="020B0604020202020204" pitchFamily="34" charset="0"/>
                </a:rPr>
                <a:t>capiva/fulv vs DMSO</a:t>
              </a:r>
            </a:p>
            <a:p>
              <a:pPr>
                <a:lnSpc>
                  <a:spcPts val="1200"/>
                </a:lnSpc>
              </a:pPr>
              <a:r>
                <a:rPr lang="en-GB" sz="600">
                  <a:solidFill>
                    <a:srgbClr val="080808"/>
                  </a:solidFill>
                  <a:latin typeface="Arial" panose="020B0604020202020204" pitchFamily="34" charset="0"/>
                  <a:cs typeface="Arial" panose="020B0604020202020204" pitchFamily="34" charset="0"/>
                </a:rPr>
                <a:t>fulvestrant vs DMSO</a:t>
              </a:r>
            </a:p>
            <a:p>
              <a:pPr>
                <a:lnSpc>
                  <a:spcPts val="1200"/>
                </a:lnSpc>
              </a:pPr>
              <a:r>
                <a:rPr lang="en-GB" sz="600">
                  <a:solidFill>
                    <a:srgbClr val="080808"/>
                  </a:solidFill>
                  <a:latin typeface="Arial" panose="020B0604020202020204" pitchFamily="34" charset="0"/>
                  <a:cs typeface="Arial" panose="020B0604020202020204" pitchFamily="34" charset="0"/>
                </a:rPr>
                <a:t>capivasertib vs DMSO</a:t>
              </a:r>
            </a:p>
          </p:txBody>
        </p:sp>
        <p:pic>
          <p:nvPicPr>
            <p:cNvPr id="22" name="Picture 21">
              <a:extLst>
                <a:ext uri="{FF2B5EF4-FFF2-40B4-BE49-F238E27FC236}">
                  <a16:creationId xmlns:a16="http://schemas.microsoft.com/office/drawing/2014/main" id="{B981AF0C-BACF-4A05-AB73-637D473F27E5}"/>
                </a:ext>
              </a:extLst>
            </p:cNvPr>
            <p:cNvPicPr>
              <a:picLocks noChangeAspect="1"/>
            </p:cNvPicPr>
            <p:nvPr/>
          </p:nvPicPr>
          <p:blipFill rotWithShape="1">
            <a:blip r:embed="rId4"/>
            <a:srcRect l="941" t="3299" b="28131"/>
            <a:stretch/>
          </p:blipFill>
          <p:spPr>
            <a:xfrm>
              <a:off x="1835137" y="3220902"/>
              <a:ext cx="3566019" cy="1499327"/>
            </a:xfrm>
            <a:prstGeom prst="rect">
              <a:avLst/>
            </a:prstGeom>
          </p:spPr>
        </p:pic>
      </p:grpSp>
      <p:grpSp>
        <p:nvGrpSpPr>
          <p:cNvPr id="392" name="Group 391">
            <a:extLst>
              <a:ext uri="{FF2B5EF4-FFF2-40B4-BE49-F238E27FC236}">
                <a16:creationId xmlns:a16="http://schemas.microsoft.com/office/drawing/2014/main" id="{8C75BE46-5DCC-488C-AB3B-A19C997E631D}"/>
              </a:ext>
            </a:extLst>
          </p:cNvPr>
          <p:cNvGrpSpPr/>
          <p:nvPr/>
        </p:nvGrpSpPr>
        <p:grpSpPr>
          <a:xfrm>
            <a:off x="669200" y="3006969"/>
            <a:ext cx="1973934" cy="1662485"/>
            <a:chOff x="2981799" y="1438702"/>
            <a:chExt cx="4631925" cy="3783093"/>
          </a:xfrm>
        </p:grpSpPr>
        <p:sp>
          <p:nvSpPr>
            <p:cNvPr id="393" name="Oval 392">
              <a:extLst>
                <a:ext uri="{FF2B5EF4-FFF2-40B4-BE49-F238E27FC236}">
                  <a16:creationId xmlns:a16="http://schemas.microsoft.com/office/drawing/2014/main" id="{0612C58C-3DAE-4ECC-8845-735A5F92275D}"/>
                </a:ext>
              </a:extLst>
            </p:cNvPr>
            <p:cNvSpPr/>
            <p:nvPr/>
          </p:nvSpPr>
          <p:spPr>
            <a:xfrm>
              <a:off x="4055941" y="1438702"/>
              <a:ext cx="2622832" cy="2547723"/>
            </a:xfrm>
            <a:prstGeom prst="ellipse">
              <a:avLst/>
            </a:prstGeom>
            <a:noFill/>
            <a:ln w="9525">
              <a:solidFill>
                <a:schemeClr val="tx1"/>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normAutofit/>
            </a:bodyPr>
            <a:lstStyle/>
            <a:p>
              <a:pPr algn="ctr">
                <a:lnSpc>
                  <a:spcPct val="90000"/>
                </a:lnSpc>
                <a:spcAft>
                  <a:spcPts val="275"/>
                </a:spcAft>
              </a:pPr>
              <a:endParaRPr lang="en-GB" sz="600" err="1"/>
            </a:p>
          </p:txBody>
        </p:sp>
        <p:sp>
          <p:nvSpPr>
            <p:cNvPr id="394" name="Oval 393">
              <a:extLst>
                <a:ext uri="{FF2B5EF4-FFF2-40B4-BE49-F238E27FC236}">
                  <a16:creationId xmlns:a16="http://schemas.microsoft.com/office/drawing/2014/main" id="{CF57FFEC-D28B-49EC-8ACE-D0ED98CBD19B}"/>
                </a:ext>
              </a:extLst>
            </p:cNvPr>
            <p:cNvSpPr/>
            <p:nvPr/>
          </p:nvSpPr>
          <p:spPr>
            <a:xfrm>
              <a:off x="4766079" y="2674072"/>
              <a:ext cx="2622832" cy="2547723"/>
            </a:xfrm>
            <a:prstGeom prst="ellipse">
              <a:avLst/>
            </a:prstGeom>
            <a:noFill/>
            <a:ln w="9525">
              <a:solidFill>
                <a:schemeClr val="tx1"/>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normAutofit/>
            </a:bodyPr>
            <a:lstStyle/>
            <a:p>
              <a:pPr algn="ctr">
                <a:lnSpc>
                  <a:spcPct val="90000"/>
                </a:lnSpc>
                <a:spcAft>
                  <a:spcPts val="275"/>
                </a:spcAft>
              </a:pPr>
              <a:endParaRPr lang="en-GB" sz="548" err="1"/>
            </a:p>
          </p:txBody>
        </p:sp>
        <p:sp>
          <p:nvSpPr>
            <p:cNvPr id="395" name="Oval 394">
              <a:extLst>
                <a:ext uri="{FF2B5EF4-FFF2-40B4-BE49-F238E27FC236}">
                  <a16:creationId xmlns:a16="http://schemas.microsoft.com/office/drawing/2014/main" id="{5DFA08CD-3890-4722-A192-D49ECA1BFF08}"/>
                </a:ext>
              </a:extLst>
            </p:cNvPr>
            <p:cNvSpPr/>
            <p:nvPr/>
          </p:nvSpPr>
          <p:spPr>
            <a:xfrm>
              <a:off x="3272693" y="2674072"/>
              <a:ext cx="2622832" cy="2547723"/>
            </a:xfrm>
            <a:prstGeom prst="ellipse">
              <a:avLst/>
            </a:prstGeom>
            <a:noFill/>
            <a:ln w="9525">
              <a:solidFill>
                <a:schemeClr val="tx1"/>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normAutofit/>
            </a:bodyPr>
            <a:lstStyle/>
            <a:p>
              <a:pPr algn="ctr">
                <a:lnSpc>
                  <a:spcPct val="90000"/>
                </a:lnSpc>
                <a:spcAft>
                  <a:spcPts val="275"/>
                </a:spcAft>
              </a:pPr>
              <a:endParaRPr lang="en-GB" sz="548" err="1"/>
            </a:p>
          </p:txBody>
        </p:sp>
        <p:sp>
          <p:nvSpPr>
            <p:cNvPr id="396" name="TextBox 395">
              <a:extLst>
                <a:ext uri="{FF2B5EF4-FFF2-40B4-BE49-F238E27FC236}">
                  <a16:creationId xmlns:a16="http://schemas.microsoft.com/office/drawing/2014/main" id="{4A599E02-5E4E-4746-BE2C-EAEF53FA6845}"/>
                </a:ext>
              </a:extLst>
            </p:cNvPr>
            <p:cNvSpPr txBox="1"/>
            <p:nvPr/>
          </p:nvSpPr>
          <p:spPr>
            <a:xfrm>
              <a:off x="4358306" y="2067734"/>
              <a:ext cx="1994674" cy="738592"/>
            </a:xfrm>
            <a:prstGeom prst="rect">
              <a:avLst/>
            </a:prstGeom>
            <a:noFill/>
          </p:spPr>
          <p:txBody>
            <a:bodyPr wrap="square" lIns="91440" tIns="45720" rIns="91440" bIns="45720" rtlCol="0" anchor="t">
              <a:spAutoFit/>
            </a:bodyPr>
            <a:lstStyle/>
            <a:p>
              <a:pPr algn="ctr">
                <a:lnSpc>
                  <a:spcPct val="90000"/>
                </a:lnSpc>
                <a:spcAft>
                  <a:spcPts val="275"/>
                </a:spcAft>
              </a:pPr>
              <a:r>
                <a:rPr lang="en-GB" sz="600" b="1">
                  <a:solidFill>
                    <a:srgbClr val="0070C0"/>
                  </a:solidFill>
                </a:rPr>
                <a:t>5 downregulated</a:t>
              </a:r>
            </a:p>
            <a:p>
              <a:pPr algn="ctr">
                <a:lnSpc>
                  <a:spcPct val="90000"/>
                </a:lnSpc>
                <a:spcAft>
                  <a:spcPts val="275"/>
                </a:spcAft>
              </a:pPr>
              <a:r>
                <a:rPr lang="en-GB" sz="600" b="1">
                  <a:solidFill>
                    <a:srgbClr val="C00000"/>
                  </a:solidFill>
                </a:rPr>
                <a:t>0 upregulated</a:t>
              </a:r>
            </a:p>
          </p:txBody>
        </p:sp>
        <p:sp>
          <p:nvSpPr>
            <p:cNvPr id="397" name="TextBox 396">
              <a:extLst>
                <a:ext uri="{FF2B5EF4-FFF2-40B4-BE49-F238E27FC236}">
                  <a16:creationId xmlns:a16="http://schemas.microsoft.com/office/drawing/2014/main" id="{010BFE82-DDEF-4AAD-A705-DFEACF544B77}"/>
                </a:ext>
              </a:extLst>
            </p:cNvPr>
            <p:cNvSpPr txBox="1"/>
            <p:nvPr/>
          </p:nvSpPr>
          <p:spPr>
            <a:xfrm>
              <a:off x="4324804" y="1729940"/>
              <a:ext cx="2118201" cy="470710"/>
            </a:xfrm>
            <a:prstGeom prst="rect">
              <a:avLst/>
            </a:prstGeom>
            <a:noFill/>
          </p:spPr>
          <p:txBody>
            <a:bodyPr wrap="square" rtlCol="0">
              <a:spAutoFit/>
            </a:bodyPr>
            <a:lstStyle/>
            <a:p>
              <a:pPr algn="ctr">
                <a:lnSpc>
                  <a:spcPct val="90000"/>
                </a:lnSpc>
                <a:spcAft>
                  <a:spcPts val="275"/>
                </a:spcAft>
              </a:pPr>
              <a:r>
                <a:rPr lang="en-GB" sz="700" b="1"/>
                <a:t>capivasertib</a:t>
              </a:r>
            </a:p>
          </p:txBody>
        </p:sp>
        <p:sp>
          <p:nvSpPr>
            <p:cNvPr id="398" name="TextBox 397">
              <a:extLst>
                <a:ext uri="{FF2B5EF4-FFF2-40B4-BE49-F238E27FC236}">
                  <a16:creationId xmlns:a16="http://schemas.microsoft.com/office/drawing/2014/main" id="{6311EDDC-E098-429C-A864-60FF50E514F3}"/>
                </a:ext>
              </a:extLst>
            </p:cNvPr>
            <p:cNvSpPr txBox="1"/>
            <p:nvPr/>
          </p:nvSpPr>
          <p:spPr>
            <a:xfrm>
              <a:off x="6006765" y="3577517"/>
              <a:ext cx="1508742" cy="651340"/>
            </a:xfrm>
            <a:prstGeom prst="rect">
              <a:avLst/>
            </a:prstGeom>
            <a:noFill/>
          </p:spPr>
          <p:txBody>
            <a:bodyPr wrap="square" rtlCol="0">
              <a:spAutoFit/>
            </a:bodyPr>
            <a:lstStyle/>
            <a:p>
              <a:pPr>
                <a:lnSpc>
                  <a:spcPct val="90000"/>
                </a:lnSpc>
                <a:spcAft>
                  <a:spcPts val="275"/>
                </a:spcAft>
              </a:pPr>
              <a:r>
                <a:rPr lang="en-GB" sz="700" b="1"/>
                <a:t>capivasertib/</a:t>
              </a:r>
              <a:r>
                <a:rPr lang="en-GB" sz="700" b="1" err="1"/>
                <a:t>fulvestrant</a:t>
              </a:r>
              <a:endParaRPr lang="en-GB" sz="700" b="1"/>
            </a:p>
          </p:txBody>
        </p:sp>
        <p:sp>
          <p:nvSpPr>
            <p:cNvPr id="399" name="TextBox 398">
              <a:extLst>
                <a:ext uri="{FF2B5EF4-FFF2-40B4-BE49-F238E27FC236}">
                  <a16:creationId xmlns:a16="http://schemas.microsoft.com/office/drawing/2014/main" id="{F4C9AF81-E01F-4400-A37E-1E58D164071A}"/>
                </a:ext>
              </a:extLst>
            </p:cNvPr>
            <p:cNvSpPr txBox="1"/>
            <p:nvPr/>
          </p:nvSpPr>
          <p:spPr>
            <a:xfrm>
              <a:off x="2981799" y="3696302"/>
              <a:ext cx="2022544" cy="470710"/>
            </a:xfrm>
            <a:prstGeom prst="rect">
              <a:avLst/>
            </a:prstGeom>
            <a:noFill/>
          </p:spPr>
          <p:txBody>
            <a:bodyPr wrap="square" rtlCol="0">
              <a:spAutoFit/>
            </a:bodyPr>
            <a:lstStyle/>
            <a:p>
              <a:pPr algn="ctr">
                <a:lnSpc>
                  <a:spcPct val="90000"/>
                </a:lnSpc>
                <a:spcAft>
                  <a:spcPts val="275"/>
                </a:spcAft>
              </a:pPr>
              <a:r>
                <a:rPr lang="en-GB" sz="700" b="1" err="1"/>
                <a:t>fulvestrant</a:t>
              </a:r>
              <a:endParaRPr lang="en-GB" sz="700" b="1"/>
            </a:p>
          </p:txBody>
        </p:sp>
        <p:sp>
          <p:nvSpPr>
            <p:cNvPr id="400" name="TextBox 399">
              <a:extLst>
                <a:ext uri="{FF2B5EF4-FFF2-40B4-BE49-F238E27FC236}">
                  <a16:creationId xmlns:a16="http://schemas.microsoft.com/office/drawing/2014/main" id="{D747CBF3-3290-4B78-B5F6-979279D0C93F}"/>
                </a:ext>
              </a:extLst>
            </p:cNvPr>
            <p:cNvSpPr txBox="1"/>
            <p:nvPr/>
          </p:nvSpPr>
          <p:spPr>
            <a:xfrm>
              <a:off x="3146054" y="4095001"/>
              <a:ext cx="1903321" cy="738592"/>
            </a:xfrm>
            <a:prstGeom prst="rect">
              <a:avLst/>
            </a:prstGeom>
            <a:noFill/>
          </p:spPr>
          <p:txBody>
            <a:bodyPr wrap="square" lIns="91440" tIns="45720" rIns="91440" bIns="45720" rtlCol="0" anchor="t">
              <a:spAutoFit/>
            </a:bodyPr>
            <a:lstStyle/>
            <a:p>
              <a:pPr algn="ctr">
                <a:lnSpc>
                  <a:spcPct val="90000"/>
                </a:lnSpc>
                <a:spcAft>
                  <a:spcPts val="275"/>
                </a:spcAft>
              </a:pPr>
              <a:r>
                <a:rPr lang="en-GB" sz="600" b="1">
                  <a:solidFill>
                    <a:srgbClr val="0070C0"/>
                  </a:solidFill>
                </a:rPr>
                <a:t>1 downregulated</a:t>
              </a:r>
            </a:p>
            <a:p>
              <a:pPr algn="ctr">
                <a:lnSpc>
                  <a:spcPct val="90000"/>
                </a:lnSpc>
                <a:spcAft>
                  <a:spcPts val="275"/>
                </a:spcAft>
              </a:pPr>
              <a:r>
                <a:rPr lang="en-GB" sz="600" b="1">
                  <a:solidFill>
                    <a:srgbClr val="C00000"/>
                  </a:solidFill>
                </a:rPr>
                <a:t>0 upregulated</a:t>
              </a:r>
              <a:endParaRPr lang="en-GB" sz="600" b="1">
                <a:solidFill>
                  <a:srgbClr val="C00000"/>
                </a:solidFill>
                <a:cs typeface="Calibri"/>
              </a:endParaRPr>
            </a:p>
          </p:txBody>
        </p:sp>
        <p:sp>
          <p:nvSpPr>
            <p:cNvPr id="401" name="TextBox 400">
              <a:extLst>
                <a:ext uri="{FF2B5EF4-FFF2-40B4-BE49-F238E27FC236}">
                  <a16:creationId xmlns:a16="http://schemas.microsoft.com/office/drawing/2014/main" id="{11D9CEA8-2CE6-44C5-A4D1-FCFBCFBEDE8C}"/>
                </a:ext>
              </a:extLst>
            </p:cNvPr>
            <p:cNvSpPr txBox="1"/>
            <p:nvPr/>
          </p:nvSpPr>
          <p:spPr>
            <a:xfrm>
              <a:off x="5520868" y="4121923"/>
              <a:ext cx="2092856" cy="738592"/>
            </a:xfrm>
            <a:prstGeom prst="rect">
              <a:avLst/>
            </a:prstGeom>
            <a:noFill/>
          </p:spPr>
          <p:txBody>
            <a:bodyPr wrap="square" lIns="91440" tIns="45720" rIns="91440" bIns="45720" rtlCol="0" anchor="t">
              <a:spAutoFit/>
            </a:bodyPr>
            <a:lstStyle/>
            <a:p>
              <a:pPr algn="ctr">
                <a:lnSpc>
                  <a:spcPct val="90000"/>
                </a:lnSpc>
                <a:spcAft>
                  <a:spcPts val="275"/>
                </a:spcAft>
              </a:pPr>
              <a:r>
                <a:rPr lang="en-GB" sz="600" b="1">
                  <a:solidFill>
                    <a:srgbClr val="0070C0"/>
                  </a:solidFill>
                </a:rPr>
                <a:t>21 downregulated</a:t>
              </a:r>
            </a:p>
            <a:p>
              <a:pPr algn="ctr">
                <a:lnSpc>
                  <a:spcPct val="90000"/>
                </a:lnSpc>
                <a:spcAft>
                  <a:spcPts val="275"/>
                </a:spcAft>
              </a:pPr>
              <a:r>
                <a:rPr lang="en-GB" sz="600" b="1">
                  <a:solidFill>
                    <a:srgbClr val="C00000"/>
                  </a:solidFill>
                </a:rPr>
                <a:t>47 upregulated</a:t>
              </a:r>
              <a:endParaRPr lang="en-GB" sz="600" b="1">
                <a:solidFill>
                  <a:srgbClr val="C00000"/>
                </a:solidFill>
                <a:cs typeface="Calibri"/>
              </a:endParaRPr>
            </a:p>
          </p:txBody>
        </p:sp>
        <p:sp>
          <p:nvSpPr>
            <p:cNvPr id="402" name="TextBox 401">
              <a:extLst>
                <a:ext uri="{FF2B5EF4-FFF2-40B4-BE49-F238E27FC236}">
                  <a16:creationId xmlns:a16="http://schemas.microsoft.com/office/drawing/2014/main" id="{61F03688-DE89-4EA3-8D96-7942AE970503}"/>
                </a:ext>
              </a:extLst>
            </p:cNvPr>
            <p:cNvSpPr txBox="1"/>
            <p:nvPr/>
          </p:nvSpPr>
          <p:spPr>
            <a:xfrm>
              <a:off x="3746153" y="2828437"/>
              <a:ext cx="1857624"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0</a:t>
              </a:r>
            </a:p>
            <a:p>
              <a:pPr algn="ctr">
                <a:lnSpc>
                  <a:spcPct val="90000"/>
                </a:lnSpc>
                <a:spcAft>
                  <a:spcPts val="275"/>
                </a:spcAft>
              </a:pPr>
              <a:r>
                <a:rPr lang="en-GB" sz="600" b="1">
                  <a:solidFill>
                    <a:srgbClr val="C00000"/>
                  </a:solidFill>
                </a:rPr>
                <a:t>0 </a:t>
              </a:r>
            </a:p>
          </p:txBody>
        </p:sp>
        <p:sp>
          <p:nvSpPr>
            <p:cNvPr id="403" name="TextBox 402">
              <a:extLst>
                <a:ext uri="{FF2B5EF4-FFF2-40B4-BE49-F238E27FC236}">
                  <a16:creationId xmlns:a16="http://schemas.microsoft.com/office/drawing/2014/main" id="{732C05FA-CB7F-44DD-AF0D-959A2080AF31}"/>
                </a:ext>
              </a:extLst>
            </p:cNvPr>
            <p:cNvSpPr txBox="1"/>
            <p:nvPr/>
          </p:nvSpPr>
          <p:spPr>
            <a:xfrm>
              <a:off x="4396559" y="3167278"/>
              <a:ext cx="1857624"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3</a:t>
              </a:r>
            </a:p>
            <a:p>
              <a:pPr algn="ctr">
                <a:lnSpc>
                  <a:spcPct val="90000"/>
                </a:lnSpc>
                <a:spcAft>
                  <a:spcPts val="275"/>
                </a:spcAft>
              </a:pPr>
              <a:r>
                <a:rPr lang="en-GB" sz="600" b="1">
                  <a:solidFill>
                    <a:srgbClr val="C00000"/>
                  </a:solidFill>
                </a:rPr>
                <a:t>0 </a:t>
              </a:r>
            </a:p>
          </p:txBody>
        </p:sp>
        <p:sp>
          <p:nvSpPr>
            <p:cNvPr id="404" name="TextBox 403">
              <a:extLst>
                <a:ext uri="{FF2B5EF4-FFF2-40B4-BE49-F238E27FC236}">
                  <a16:creationId xmlns:a16="http://schemas.microsoft.com/office/drawing/2014/main" id="{CC2284CB-8784-4B4D-86C4-6DC569C0D9DA}"/>
                </a:ext>
              </a:extLst>
            </p:cNvPr>
            <p:cNvSpPr txBox="1"/>
            <p:nvPr/>
          </p:nvSpPr>
          <p:spPr>
            <a:xfrm>
              <a:off x="4334570" y="4083114"/>
              <a:ext cx="1903321"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3</a:t>
              </a:r>
            </a:p>
            <a:p>
              <a:pPr algn="ctr">
                <a:lnSpc>
                  <a:spcPct val="90000"/>
                </a:lnSpc>
                <a:spcAft>
                  <a:spcPts val="275"/>
                </a:spcAft>
              </a:pPr>
              <a:r>
                <a:rPr lang="en-GB" sz="600" b="1">
                  <a:solidFill>
                    <a:srgbClr val="C00000"/>
                  </a:solidFill>
                </a:rPr>
                <a:t>0 </a:t>
              </a:r>
            </a:p>
          </p:txBody>
        </p:sp>
        <p:sp>
          <p:nvSpPr>
            <p:cNvPr id="405" name="TextBox 404">
              <a:extLst>
                <a:ext uri="{FF2B5EF4-FFF2-40B4-BE49-F238E27FC236}">
                  <a16:creationId xmlns:a16="http://schemas.microsoft.com/office/drawing/2014/main" id="{FE8369F9-5B9F-4B3F-86D0-76F7DFADD1A0}"/>
                </a:ext>
              </a:extLst>
            </p:cNvPr>
            <p:cNvSpPr txBox="1"/>
            <p:nvPr/>
          </p:nvSpPr>
          <p:spPr>
            <a:xfrm>
              <a:off x="5130934" y="2811783"/>
              <a:ext cx="1857624"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122</a:t>
              </a:r>
            </a:p>
            <a:p>
              <a:pPr algn="ctr">
                <a:lnSpc>
                  <a:spcPct val="90000"/>
                </a:lnSpc>
                <a:spcAft>
                  <a:spcPts val="275"/>
                </a:spcAft>
              </a:pPr>
              <a:r>
                <a:rPr lang="en-GB" sz="600" b="1">
                  <a:solidFill>
                    <a:srgbClr val="C00000"/>
                  </a:solidFill>
                </a:rPr>
                <a:t>0 </a:t>
              </a:r>
            </a:p>
          </p:txBody>
        </p:sp>
      </p:grpSp>
      <p:sp>
        <p:nvSpPr>
          <p:cNvPr id="406" name="TextBox 405">
            <a:extLst>
              <a:ext uri="{FF2B5EF4-FFF2-40B4-BE49-F238E27FC236}">
                <a16:creationId xmlns:a16="http://schemas.microsoft.com/office/drawing/2014/main" id="{0843C592-126D-4803-9804-8DD94C7B7085}"/>
              </a:ext>
            </a:extLst>
          </p:cNvPr>
          <p:cNvSpPr txBox="1"/>
          <p:nvPr/>
        </p:nvSpPr>
        <p:spPr>
          <a:xfrm>
            <a:off x="640322" y="2945970"/>
            <a:ext cx="251407" cy="276999"/>
          </a:xfrm>
          <a:prstGeom prst="rect">
            <a:avLst/>
          </a:prstGeom>
          <a:noFill/>
        </p:spPr>
        <p:txBody>
          <a:bodyPr wrap="square" lIns="91440" tIns="45720" rIns="91440" bIns="45720" rtlCol="0" anchor="t">
            <a:spAutoFit/>
          </a:bodyPr>
          <a:lstStyle/>
          <a:p>
            <a:r>
              <a:rPr lang="en-GB" sz="1200" b="1"/>
              <a:t>C</a:t>
            </a:r>
          </a:p>
        </p:txBody>
      </p:sp>
      <p:pic>
        <p:nvPicPr>
          <p:cNvPr id="11" name="Picture 10">
            <a:extLst>
              <a:ext uri="{FF2B5EF4-FFF2-40B4-BE49-F238E27FC236}">
                <a16:creationId xmlns:a16="http://schemas.microsoft.com/office/drawing/2014/main" id="{02088055-ED32-406A-9C05-A31B59E9C764}"/>
              </a:ext>
            </a:extLst>
          </p:cNvPr>
          <p:cNvPicPr>
            <a:picLocks noChangeAspect="1"/>
          </p:cNvPicPr>
          <p:nvPr/>
        </p:nvPicPr>
        <p:blipFill>
          <a:blip r:embed="rId5"/>
          <a:stretch>
            <a:fillRect/>
          </a:stretch>
        </p:blipFill>
        <p:spPr>
          <a:xfrm>
            <a:off x="870232" y="827362"/>
            <a:ext cx="2547980" cy="1838909"/>
          </a:xfrm>
          <a:prstGeom prst="rect">
            <a:avLst/>
          </a:prstGeom>
        </p:spPr>
      </p:pic>
      <p:sp>
        <p:nvSpPr>
          <p:cNvPr id="6" name="TextBox 5">
            <a:extLst>
              <a:ext uri="{FF2B5EF4-FFF2-40B4-BE49-F238E27FC236}">
                <a16:creationId xmlns:a16="http://schemas.microsoft.com/office/drawing/2014/main" id="{C0FCCDFA-1794-59FC-C9A5-7C99D01DB249}"/>
              </a:ext>
            </a:extLst>
          </p:cNvPr>
          <p:cNvSpPr txBox="1"/>
          <p:nvPr/>
        </p:nvSpPr>
        <p:spPr>
          <a:xfrm>
            <a:off x="3651272" y="773326"/>
            <a:ext cx="165159" cy="276999"/>
          </a:xfrm>
          <a:prstGeom prst="rect">
            <a:avLst/>
          </a:prstGeom>
          <a:noFill/>
        </p:spPr>
        <p:txBody>
          <a:bodyPr wrap="square" rtlCol="0">
            <a:spAutoFit/>
          </a:bodyPr>
          <a:lstStyle/>
          <a:p>
            <a:r>
              <a:rPr lang="en-GB" sz="1200" b="1"/>
              <a:t>B</a:t>
            </a:r>
          </a:p>
        </p:txBody>
      </p:sp>
      <p:sp>
        <p:nvSpPr>
          <p:cNvPr id="13" name="TextBox 12">
            <a:extLst>
              <a:ext uri="{FF2B5EF4-FFF2-40B4-BE49-F238E27FC236}">
                <a16:creationId xmlns:a16="http://schemas.microsoft.com/office/drawing/2014/main" id="{74C8B477-927E-9839-DDE1-D673A6C5BC8B}"/>
              </a:ext>
            </a:extLst>
          </p:cNvPr>
          <p:cNvSpPr txBox="1"/>
          <p:nvPr/>
        </p:nvSpPr>
        <p:spPr>
          <a:xfrm>
            <a:off x="603869" y="6700740"/>
            <a:ext cx="251407" cy="276999"/>
          </a:xfrm>
          <a:prstGeom prst="rect">
            <a:avLst/>
          </a:prstGeom>
          <a:noFill/>
        </p:spPr>
        <p:txBody>
          <a:bodyPr wrap="square" lIns="91440" tIns="45720" rIns="91440" bIns="45720" rtlCol="0" anchor="t">
            <a:spAutoFit/>
          </a:bodyPr>
          <a:lstStyle/>
          <a:p>
            <a:r>
              <a:rPr lang="en-GB" sz="1200" b="1"/>
              <a:t>E</a:t>
            </a:r>
          </a:p>
        </p:txBody>
      </p:sp>
      <p:pic>
        <p:nvPicPr>
          <p:cNvPr id="15" name="Picture 15" descr="Chart, scatter chart&#10;&#10;Description automatically generated">
            <a:extLst>
              <a:ext uri="{FF2B5EF4-FFF2-40B4-BE49-F238E27FC236}">
                <a16:creationId xmlns:a16="http://schemas.microsoft.com/office/drawing/2014/main" id="{F88DB939-9BC3-22F2-7CC2-594235E45D0D}"/>
              </a:ext>
            </a:extLst>
          </p:cNvPr>
          <p:cNvPicPr>
            <a:picLocks noChangeAspect="1"/>
          </p:cNvPicPr>
          <p:nvPr/>
        </p:nvPicPr>
        <p:blipFill>
          <a:blip r:embed="rId6"/>
          <a:stretch>
            <a:fillRect/>
          </a:stretch>
        </p:blipFill>
        <p:spPr>
          <a:xfrm>
            <a:off x="568762" y="7122458"/>
            <a:ext cx="5552532" cy="2542198"/>
          </a:xfrm>
          <a:prstGeom prst="rect">
            <a:avLst/>
          </a:prstGeom>
        </p:spPr>
      </p:pic>
      <p:grpSp>
        <p:nvGrpSpPr>
          <p:cNvPr id="23" name="Group 22">
            <a:extLst>
              <a:ext uri="{FF2B5EF4-FFF2-40B4-BE49-F238E27FC236}">
                <a16:creationId xmlns:a16="http://schemas.microsoft.com/office/drawing/2014/main" id="{5A2C3450-EF05-CF04-5CBC-0FC8F5ECFA12}"/>
              </a:ext>
            </a:extLst>
          </p:cNvPr>
          <p:cNvGrpSpPr/>
          <p:nvPr/>
        </p:nvGrpSpPr>
        <p:grpSpPr>
          <a:xfrm>
            <a:off x="3680019" y="972922"/>
            <a:ext cx="3284694" cy="1827039"/>
            <a:chOff x="3680019" y="972922"/>
            <a:chExt cx="3284694" cy="1827039"/>
          </a:xfrm>
        </p:grpSpPr>
        <p:pic>
          <p:nvPicPr>
            <p:cNvPr id="3" name="Content Placeholder 7">
              <a:extLst>
                <a:ext uri="{FF2B5EF4-FFF2-40B4-BE49-F238E27FC236}">
                  <a16:creationId xmlns:a16="http://schemas.microsoft.com/office/drawing/2014/main" id="{2F723C05-8B0B-1B08-AEF4-C124DB79F567}"/>
                </a:ext>
              </a:extLst>
            </p:cNvPr>
            <p:cNvPicPr>
              <a:picLocks noChangeAspect="1"/>
            </p:cNvPicPr>
            <p:nvPr/>
          </p:nvPicPr>
          <p:blipFill rotWithShape="1">
            <a:blip r:embed="rId7"/>
            <a:srcRect l="3748" t="1229" r="23208" b="11726"/>
            <a:stretch/>
          </p:blipFill>
          <p:spPr>
            <a:xfrm>
              <a:off x="3924110" y="972922"/>
              <a:ext cx="2188458" cy="1457549"/>
            </a:xfrm>
            <a:prstGeom prst="rect">
              <a:avLst/>
            </a:prstGeom>
          </p:spPr>
        </p:pic>
        <p:sp>
          <p:nvSpPr>
            <p:cNvPr id="8" name="TextBox 7">
              <a:extLst>
                <a:ext uri="{FF2B5EF4-FFF2-40B4-BE49-F238E27FC236}">
                  <a16:creationId xmlns:a16="http://schemas.microsoft.com/office/drawing/2014/main" id="{B6BA3623-A7EB-2F68-96A5-8C43EFDEA587}"/>
                </a:ext>
              </a:extLst>
            </p:cNvPr>
            <p:cNvSpPr txBox="1"/>
            <p:nvPr/>
          </p:nvSpPr>
          <p:spPr>
            <a:xfrm>
              <a:off x="6025261" y="1601792"/>
              <a:ext cx="939452" cy="184666"/>
            </a:xfrm>
            <a:prstGeom prst="rect">
              <a:avLst/>
            </a:prstGeom>
            <a:noFill/>
          </p:spPr>
          <p:txBody>
            <a:bodyPr wrap="square" rtlCol="0">
              <a:spAutoFit/>
            </a:bodyPr>
            <a:lstStyle/>
            <a:p>
              <a:r>
                <a:rPr lang="en-GB" sz="600"/>
                <a:t>capivasertib difference</a:t>
              </a:r>
            </a:p>
          </p:txBody>
        </p:sp>
        <p:sp>
          <p:nvSpPr>
            <p:cNvPr id="10" name="TextBox 9">
              <a:extLst>
                <a:ext uri="{FF2B5EF4-FFF2-40B4-BE49-F238E27FC236}">
                  <a16:creationId xmlns:a16="http://schemas.microsoft.com/office/drawing/2014/main" id="{30B09771-6180-4EF3-AFBE-A23F83CF9F83}"/>
                </a:ext>
              </a:extLst>
            </p:cNvPr>
            <p:cNvSpPr txBox="1"/>
            <p:nvPr/>
          </p:nvSpPr>
          <p:spPr>
            <a:xfrm>
              <a:off x="6025261" y="1714270"/>
              <a:ext cx="939452" cy="184666"/>
            </a:xfrm>
            <a:prstGeom prst="rect">
              <a:avLst/>
            </a:prstGeom>
            <a:noFill/>
          </p:spPr>
          <p:txBody>
            <a:bodyPr wrap="square" rtlCol="0">
              <a:spAutoFit/>
            </a:bodyPr>
            <a:lstStyle/>
            <a:p>
              <a:r>
                <a:rPr lang="en-GB" sz="600" err="1"/>
                <a:t>fulvestrant</a:t>
              </a:r>
              <a:r>
                <a:rPr lang="en-GB" sz="600"/>
                <a:t> difference</a:t>
              </a:r>
            </a:p>
          </p:txBody>
        </p:sp>
        <p:sp>
          <p:nvSpPr>
            <p:cNvPr id="12" name="TextBox 11">
              <a:extLst>
                <a:ext uri="{FF2B5EF4-FFF2-40B4-BE49-F238E27FC236}">
                  <a16:creationId xmlns:a16="http://schemas.microsoft.com/office/drawing/2014/main" id="{50BBC505-EA88-CEB5-6B4A-E30B801244D3}"/>
                </a:ext>
              </a:extLst>
            </p:cNvPr>
            <p:cNvSpPr txBox="1"/>
            <p:nvPr/>
          </p:nvSpPr>
          <p:spPr>
            <a:xfrm>
              <a:off x="5071775" y="2388831"/>
              <a:ext cx="716788" cy="276999"/>
            </a:xfrm>
            <a:prstGeom prst="rect">
              <a:avLst/>
            </a:prstGeom>
            <a:noFill/>
          </p:spPr>
          <p:txBody>
            <a:bodyPr wrap="square" rtlCol="0">
              <a:spAutoFit/>
            </a:bodyPr>
            <a:lstStyle/>
            <a:p>
              <a:r>
                <a:rPr lang="en-GB" sz="600"/>
                <a:t>Positive log2FC in monotherapy</a:t>
              </a:r>
            </a:p>
          </p:txBody>
        </p:sp>
        <p:sp>
          <p:nvSpPr>
            <p:cNvPr id="16" name="TextBox 15">
              <a:extLst>
                <a:ext uri="{FF2B5EF4-FFF2-40B4-BE49-F238E27FC236}">
                  <a16:creationId xmlns:a16="http://schemas.microsoft.com/office/drawing/2014/main" id="{AF3A6E43-682D-EF53-F078-1900AE3D8DC0}"/>
                </a:ext>
              </a:extLst>
            </p:cNvPr>
            <p:cNvSpPr txBox="1"/>
            <p:nvPr/>
          </p:nvSpPr>
          <p:spPr>
            <a:xfrm>
              <a:off x="4251139" y="2388830"/>
              <a:ext cx="716788" cy="276999"/>
            </a:xfrm>
            <a:prstGeom prst="rect">
              <a:avLst/>
            </a:prstGeom>
            <a:noFill/>
          </p:spPr>
          <p:txBody>
            <a:bodyPr wrap="square" rtlCol="0">
              <a:spAutoFit/>
            </a:bodyPr>
            <a:lstStyle/>
            <a:p>
              <a:r>
                <a:rPr lang="en-GB" sz="600"/>
                <a:t>Negative log2FC in monotherapy</a:t>
              </a:r>
            </a:p>
          </p:txBody>
        </p:sp>
        <p:sp>
          <p:nvSpPr>
            <p:cNvPr id="17" name="TextBox 16">
              <a:extLst>
                <a:ext uri="{FF2B5EF4-FFF2-40B4-BE49-F238E27FC236}">
                  <a16:creationId xmlns:a16="http://schemas.microsoft.com/office/drawing/2014/main" id="{A4FB7150-4B5E-E8E7-48C4-E224FBDEF808}"/>
                </a:ext>
              </a:extLst>
            </p:cNvPr>
            <p:cNvSpPr txBox="1"/>
            <p:nvPr/>
          </p:nvSpPr>
          <p:spPr>
            <a:xfrm>
              <a:off x="4747770" y="2615295"/>
              <a:ext cx="716788" cy="184666"/>
            </a:xfrm>
            <a:prstGeom prst="rect">
              <a:avLst/>
            </a:prstGeom>
            <a:noFill/>
          </p:spPr>
          <p:txBody>
            <a:bodyPr wrap="square" rtlCol="0">
              <a:spAutoFit/>
            </a:bodyPr>
            <a:lstStyle/>
            <a:p>
              <a:r>
                <a:rPr lang="en-GB" sz="600" b="1"/>
                <a:t>Direction</a:t>
              </a:r>
            </a:p>
          </p:txBody>
        </p:sp>
        <p:sp>
          <p:nvSpPr>
            <p:cNvPr id="18" name="TextBox 17">
              <a:extLst>
                <a:ext uri="{FF2B5EF4-FFF2-40B4-BE49-F238E27FC236}">
                  <a16:creationId xmlns:a16="http://schemas.microsoft.com/office/drawing/2014/main" id="{4C8236DB-175D-000E-B785-39667AF2CBC1}"/>
                </a:ext>
              </a:extLst>
            </p:cNvPr>
            <p:cNvSpPr txBox="1"/>
            <p:nvPr/>
          </p:nvSpPr>
          <p:spPr>
            <a:xfrm rot="16200000">
              <a:off x="3231118" y="1516741"/>
              <a:ext cx="1174802" cy="276999"/>
            </a:xfrm>
            <a:prstGeom prst="rect">
              <a:avLst/>
            </a:prstGeom>
            <a:noFill/>
          </p:spPr>
          <p:txBody>
            <a:bodyPr wrap="square" rtlCol="0">
              <a:spAutoFit/>
            </a:bodyPr>
            <a:lstStyle/>
            <a:p>
              <a:r>
                <a:rPr lang="en-GB" sz="600"/>
                <a:t>Difference in log2FC between monotherapy and combination</a:t>
              </a:r>
            </a:p>
          </p:txBody>
        </p:sp>
        <p:sp>
          <p:nvSpPr>
            <p:cNvPr id="21" name="Rectangle 20">
              <a:extLst>
                <a:ext uri="{FF2B5EF4-FFF2-40B4-BE49-F238E27FC236}">
                  <a16:creationId xmlns:a16="http://schemas.microsoft.com/office/drawing/2014/main" id="{AED033FC-36BC-4701-64FD-3F65A941CE6A}"/>
                </a:ext>
              </a:extLst>
            </p:cNvPr>
            <p:cNvSpPr/>
            <p:nvPr/>
          </p:nvSpPr>
          <p:spPr>
            <a:xfrm>
              <a:off x="3889332" y="1759907"/>
              <a:ext cx="45719" cy="13902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41366093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CEF116-AFC8-44FA-B66B-71B5263D6FFB}"/>
              </a:ext>
            </a:extLst>
          </p:cNvPr>
          <p:cNvSpPr txBox="1">
            <a:spLocks/>
          </p:cNvSpPr>
          <p:nvPr/>
        </p:nvSpPr>
        <p:spPr>
          <a:xfrm>
            <a:off x="562757" y="214159"/>
            <a:ext cx="5333064" cy="289553"/>
          </a:xfrm>
          <a:prstGeom prst="rect">
            <a:avLst/>
          </a:prstGeom>
        </p:spPr>
        <p:txBody>
          <a:bodyP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300">
                <a:latin typeface="+mn-lt"/>
              </a:rPr>
              <a:t>Supplementary Figure 4. MCF7 parental.</a:t>
            </a:r>
          </a:p>
        </p:txBody>
      </p:sp>
      <p:sp>
        <p:nvSpPr>
          <p:cNvPr id="379" name="TextBox 378">
            <a:extLst>
              <a:ext uri="{FF2B5EF4-FFF2-40B4-BE49-F238E27FC236}">
                <a16:creationId xmlns:a16="http://schemas.microsoft.com/office/drawing/2014/main" id="{F7EAE217-741A-4F90-954F-B4B5D66AAAA6}"/>
              </a:ext>
            </a:extLst>
          </p:cNvPr>
          <p:cNvSpPr txBox="1"/>
          <p:nvPr/>
        </p:nvSpPr>
        <p:spPr>
          <a:xfrm>
            <a:off x="289111" y="773326"/>
            <a:ext cx="165159" cy="276999"/>
          </a:xfrm>
          <a:prstGeom prst="rect">
            <a:avLst/>
          </a:prstGeom>
          <a:noFill/>
        </p:spPr>
        <p:txBody>
          <a:bodyPr wrap="square" rtlCol="0">
            <a:spAutoFit/>
          </a:bodyPr>
          <a:lstStyle/>
          <a:p>
            <a:r>
              <a:rPr lang="en-GB" sz="1200" b="1"/>
              <a:t>A</a:t>
            </a:r>
          </a:p>
        </p:txBody>
      </p:sp>
      <p:cxnSp>
        <p:nvCxnSpPr>
          <p:cNvPr id="7" name="Straight Connector 6">
            <a:extLst>
              <a:ext uri="{FF2B5EF4-FFF2-40B4-BE49-F238E27FC236}">
                <a16:creationId xmlns:a16="http://schemas.microsoft.com/office/drawing/2014/main" id="{F5A12402-5D66-437D-B038-DEA5EF6575E4}"/>
              </a:ext>
            </a:extLst>
          </p:cNvPr>
          <p:cNvCxnSpPr>
            <a:cxnSpLocks/>
          </p:cNvCxnSpPr>
          <p:nvPr/>
        </p:nvCxnSpPr>
        <p:spPr>
          <a:xfrm flipV="1">
            <a:off x="3543803" y="4363863"/>
            <a:ext cx="2770279" cy="6196"/>
          </a:xfrm>
          <a:prstGeom prst="line">
            <a:avLst/>
          </a:prstGeom>
          <a:ln w="9525" cap="flat" cmpd="sng" algn="ctr">
            <a:solidFill>
              <a:schemeClr val="dk1"/>
            </a:solidFill>
            <a:prstDash val="dash"/>
            <a:round/>
            <a:headEnd type="none" w="med" len="med"/>
            <a:tailEnd type="none" w="med" len="med"/>
          </a:ln>
        </p:spPr>
        <p:style>
          <a:lnRef idx="0">
            <a:scrgbClr r="0" g="0" b="0"/>
          </a:lnRef>
          <a:fillRef idx="0">
            <a:scrgbClr r="0" g="0" b="0"/>
          </a:fillRef>
          <a:effectRef idx="0">
            <a:scrgbClr r="0" g="0" b="0"/>
          </a:effectRef>
          <a:fontRef idx="minor">
            <a:schemeClr val="tx1"/>
          </a:fontRef>
        </p:style>
      </p:cxnSp>
      <p:sp>
        <p:nvSpPr>
          <p:cNvPr id="9" name="TextBox 8">
            <a:extLst>
              <a:ext uri="{FF2B5EF4-FFF2-40B4-BE49-F238E27FC236}">
                <a16:creationId xmlns:a16="http://schemas.microsoft.com/office/drawing/2014/main" id="{D4EE5172-2217-41F7-8E3D-EC1A0EBF19A8}"/>
              </a:ext>
            </a:extLst>
          </p:cNvPr>
          <p:cNvSpPr txBox="1"/>
          <p:nvPr/>
        </p:nvSpPr>
        <p:spPr>
          <a:xfrm rot="16200000">
            <a:off x="5960239" y="3454270"/>
            <a:ext cx="1090368" cy="392415"/>
          </a:xfrm>
          <a:prstGeom prst="rect">
            <a:avLst/>
          </a:prstGeom>
          <a:noFill/>
        </p:spPr>
        <p:txBody>
          <a:bodyPr wrap="square" rtlCol="0">
            <a:spAutoFit/>
          </a:bodyPr>
          <a:lstStyle/>
          <a:p>
            <a:pPr algn="ctr"/>
            <a:r>
              <a:rPr lang="en-GB" sz="975">
                <a:solidFill>
                  <a:schemeClr val="accent1"/>
                </a:solidFill>
              </a:rPr>
              <a:t>Top 25 Downregulated</a:t>
            </a:r>
          </a:p>
        </p:txBody>
      </p:sp>
      <p:sp>
        <p:nvSpPr>
          <p:cNvPr id="55" name="TextBox 54">
            <a:extLst>
              <a:ext uri="{FF2B5EF4-FFF2-40B4-BE49-F238E27FC236}">
                <a16:creationId xmlns:a16="http://schemas.microsoft.com/office/drawing/2014/main" id="{0C13D1AF-2AE2-404C-ADBA-85D72E745637}"/>
              </a:ext>
            </a:extLst>
          </p:cNvPr>
          <p:cNvSpPr txBox="1"/>
          <p:nvPr/>
        </p:nvSpPr>
        <p:spPr>
          <a:xfrm rot="16200000">
            <a:off x="6044864" y="4769974"/>
            <a:ext cx="913603" cy="392415"/>
          </a:xfrm>
          <a:prstGeom prst="rect">
            <a:avLst/>
          </a:prstGeom>
          <a:noFill/>
        </p:spPr>
        <p:txBody>
          <a:bodyPr wrap="square" rtlCol="0">
            <a:spAutoFit/>
          </a:bodyPr>
          <a:lstStyle/>
          <a:p>
            <a:pPr algn="ctr"/>
            <a:r>
              <a:rPr lang="en-GB" sz="975">
                <a:solidFill>
                  <a:srgbClr val="FF0000"/>
                </a:solidFill>
              </a:rPr>
              <a:t>Top Upregulated</a:t>
            </a:r>
          </a:p>
        </p:txBody>
      </p:sp>
      <p:sp>
        <p:nvSpPr>
          <p:cNvPr id="406" name="TextBox 405">
            <a:extLst>
              <a:ext uri="{FF2B5EF4-FFF2-40B4-BE49-F238E27FC236}">
                <a16:creationId xmlns:a16="http://schemas.microsoft.com/office/drawing/2014/main" id="{0843C592-126D-4803-9804-8DD94C7B7085}"/>
              </a:ext>
            </a:extLst>
          </p:cNvPr>
          <p:cNvSpPr txBox="1"/>
          <p:nvPr/>
        </p:nvSpPr>
        <p:spPr>
          <a:xfrm>
            <a:off x="365019" y="2945970"/>
            <a:ext cx="251407" cy="276999"/>
          </a:xfrm>
          <a:prstGeom prst="rect">
            <a:avLst/>
          </a:prstGeom>
          <a:noFill/>
        </p:spPr>
        <p:txBody>
          <a:bodyPr wrap="square" lIns="91440" tIns="45720" rIns="91440" bIns="45720" rtlCol="0" anchor="t">
            <a:spAutoFit/>
          </a:bodyPr>
          <a:lstStyle/>
          <a:p>
            <a:r>
              <a:rPr lang="en-GB" sz="1200" b="1"/>
              <a:t>C</a:t>
            </a:r>
          </a:p>
        </p:txBody>
      </p:sp>
      <p:sp>
        <p:nvSpPr>
          <p:cNvPr id="6" name="TextBox 5">
            <a:extLst>
              <a:ext uri="{FF2B5EF4-FFF2-40B4-BE49-F238E27FC236}">
                <a16:creationId xmlns:a16="http://schemas.microsoft.com/office/drawing/2014/main" id="{C0FCCDFA-1794-59FC-C9A5-7C99D01DB249}"/>
              </a:ext>
            </a:extLst>
          </p:cNvPr>
          <p:cNvSpPr txBox="1"/>
          <p:nvPr/>
        </p:nvSpPr>
        <p:spPr>
          <a:xfrm>
            <a:off x="3387081" y="773326"/>
            <a:ext cx="165159" cy="276999"/>
          </a:xfrm>
          <a:prstGeom prst="rect">
            <a:avLst/>
          </a:prstGeom>
          <a:noFill/>
        </p:spPr>
        <p:txBody>
          <a:bodyPr wrap="square" rtlCol="0">
            <a:spAutoFit/>
          </a:bodyPr>
          <a:lstStyle/>
          <a:p>
            <a:r>
              <a:rPr lang="en-GB" sz="1200" b="1"/>
              <a:t>B</a:t>
            </a:r>
          </a:p>
        </p:txBody>
      </p:sp>
      <p:pic>
        <p:nvPicPr>
          <p:cNvPr id="12" name="Picture 11">
            <a:extLst>
              <a:ext uri="{FF2B5EF4-FFF2-40B4-BE49-F238E27FC236}">
                <a16:creationId xmlns:a16="http://schemas.microsoft.com/office/drawing/2014/main" id="{80780961-2844-3E71-7545-778AB32E6E21}"/>
              </a:ext>
            </a:extLst>
          </p:cNvPr>
          <p:cNvPicPr>
            <a:picLocks noChangeAspect="1"/>
          </p:cNvPicPr>
          <p:nvPr/>
        </p:nvPicPr>
        <p:blipFill rotWithShape="1">
          <a:blip r:embed="rId3"/>
          <a:srcRect l="3361" r="21933" b="8682"/>
          <a:stretch/>
        </p:blipFill>
        <p:spPr>
          <a:xfrm>
            <a:off x="4105632" y="929855"/>
            <a:ext cx="1750361" cy="1439400"/>
          </a:xfrm>
          <a:prstGeom prst="rect">
            <a:avLst/>
          </a:prstGeom>
        </p:spPr>
      </p:pic>
      <p:grpSp>
        <p:nvGrpSpPr>
          <p:cNvPr id="13" name="Group 12">
            <a:extLst>
              <a:ext uri="{FF2B5EF4-FFF2-40B4-BE49-F238E27FC236}">
                <a16:creationId xmlns:a16="http://schemas.microsoft.com/office/drawing/2014/main" id="{427551DD-DC2B-877D-021E-5F59541F329D}"/>
              </a:ext>
            </a:extLst>
          </p:cNvPr>
          <p:cNvGrpSpPr/>
          <p:nvPr/>
        </p:nvGrpSpPr>
        <p:grpSpPr>
          <a:xfrm>
            <a:off x="398710" y="3006969"/>
            <a:ext cx="1969121" cy="1662485"/>
            <a:chOff x="2993093" y="1438702"/>
            <a:chExt cx="4620631" cy="3783093"/>
          </a:xfrm>
        </p:grpSpPr>
        <p:sp>
          <p:nvSpPr>
            <p:cNvPr id="14" name="Oval 13">
              <a:extLst>
                <a:ext uri="{FF2B5EF4-FFF2-40B4-BE49-F238E27FC236}">
                  <a16:creationId xmlns:a16="http://schemas.microsoft.com/office/drawing/2014/main" id="{3B9109D6-3F37-CC33-67CC-8D0BFD690839}"/>
                </a:ext>
              </a:extLst>
            </p:cNvPr>
            <p:cNvSpPr/>
            <p:nvPr/>
          </p:nvSpPr>
          <p:spPr>
            <a:xfrm>
              <a:off x="4055941" y="1438702"/>
              <a:ext cx="2622832" cy="2547723"/>
            </a:xfrm>
            <a:prstGeom prst="ellipse">
              <a:avLst/>
            </a:prstGeom>
            <a:noFill/>
            <a:ln w="9525">
              <a:solidFill>
                <a:schemeClr val="tx1"/>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normAutofit/>
            </a:bodyPr>
            <a:lstStyle/>
            <a:p>
              <a:pPr algn="ctr">
                <a:lnSpc>
                  <a:spcPct val="90000"/>
                </a:lnSpc>
                <a:spcAft>
                  <a:spcPts val="275"/>
                </a:spcAft>
              </a:pPr>
              <a:endParaRPr lang="en-GB" sz="600" err="1"/>
            </a:p>
          </p:txBody>
        </p:sp>
        <p:sp>
          <p:nvSpPr>
            <p:cNvPr id="15" name="Oval 14">
              <a:extLst>
                <a:ext uri="{FF2B5EF4-FFF2-40B4-BE49-F238E27FC236}">
                  <a16:creationId xmlns:a16="http://schemas.microsoft.com/office/drawing/2014/main" id="{60EFB81B-5BCF-9E0C-2934-3ED23274299F}"/>
                </a:ext>
              </a:extLst>
            </p:cNvPr>
            <p:cNvSpPr/>
            <p:nvPr/>
          </p:nvSpPr>
          <p:spPr>
            <a:xfrm>
              <a:off x="4766079" y="2674072"/>
              <a:ext cx="2622832" cy="2547723"/>
            </a:xfrm>
            <a:prstGeom prst="ellipse">
              <a:avLst/>
            </a:prstGeom>
            <a:noFill/>
            <a:ln w="9525">
              <a:solidFill>
                <a:schemeClr val="tx1"/>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normAutofit/>
            </a:bodyPr>
            <a:lstStyle/>
            <a:p>
              <a:pPr algn="ctr">
                <a:lnSpc>
                  <a:spcPct val="90000"/>
                </a:lnSpc>
                <a:spcAft>
                  <a:spcPts val="275"/>
                </a:spcAft>
              </a:pPr>
              <a:endParaRPr lang="en-GB" sz="548" err="1"/>
            </a:p>
          </p:txBody>
        </p:sp>
        <p:sp>
          <p:nvSpPr>
            <p:cNvPr id="16" name="Oval 15">
              <a:extLst>
                <a:ext uri="{FF2B5EF4-FFF2-40B4-BE49-F238E27FC236}">
                  <a16:creationId xmlns:a16="http://schemas.microsoft.com/office/drawing/2014/main" id="{72F055BA-73CD-8C5B-3037-E856A4DE495C}"/>
                </a:ext>
              </a:extLst>
            </p:cNvPr>
            <p:cNvSpPr/>
            <p:nvPr/>
          </p:nvSpPr>
          <p:spPr>
            <a:xfrm>
              <a:off x="3272693" y="2674072"/>
              <a:ext cx="2622832" cy="2547723"/>
            </a:xfrm>
            <a:prstGeom prst="ellipse">
              <a:avLst/>
            </a:prstGeom>
            <a:noFill/>
            <a:ln w="9525">
              <a:solidFill>
                <a:schemeClr val="tx1"/>
              </a:solidFill>
            </a:ln>
            <a:extLst>
              <a:ext uri="{909E8E84-426E-40DD-AFC4-6F175D3DCCD1}">
                <a14:hiddenFill xmlns:a14="http://schemas.microsoft.com/office/drawing/2010/main">
                  <a:solidFill>
                    <a:schemeClr val="accent1"/>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normAutofit/>
            </a:bodyPr>
            <a:lstStyle/>
            <a:p>
              <a:pPr algn="ctr">
                <a:lnSpc>
                  <a:spcPct val="90000"/>
                </a:lnSpc>
                <a:spcAft>
                  <a:spcPts val="275"/>
                </a:spcAft>
              </a:pPr>
              <a:endParaRPr lang="en-GB" sz="548" err="1"/>
            </a:p>
          </p:txBody>
        </p:sp>
        <p:sp>
          <p:nvSpPr>
            <p:cNvPr id="17" name="TextBox 16">
              <a:extLst>
                <a:ext uri="{FF2B5EF4-FFF2-40B4-BE49-F238E27FC236}">
                  <a16:creationId xmlns:a16="http://schemas.microsoft.com/office/drawing/2014/main" id="{1EFFA305-ADAE-B00D-1298-6178B48A7A23}"/>
                </a:ext>
              </a:extLst>
            </p:cNvPr>
            <p:cNvSpPr txBox="1"/>
            <p:nvPr/>
          </p:nvSpPr>
          <p:spPr>
            <a:xfrm>
              <a:off x="4358306" y="2067734"/>
              <a:ext cx="1994674" cy="675852"/>
            </a:xfrm>
            <a:prstGeom prst="rect">
              <a:avLst/>
            </a:prstGeom>
            <a:noFill/>
          </p:spPr>
          <p:txBody>
            <a:bodyPr wrap="square" lIns="91440" tIns="45720" rIns="91440" bIns="45720" rtlCol="0" anchor="t">
              <a:spAutoFit/>
            </a:bodyPr>
            <a:lstStyle/>
            <a:p>
              <a:pPr algn="ctr">
                <a:lnSpc>
                  <a:spcPct val="90000"/>
                </a:lnSpc>
                <a:spcAft>
                  <a:spcPts val="275"/>
                </a:spcAft>
              </a:pPr>
              <a:r>
                <a:rPr lang="en-GB" sz="600" b="1">
                  <a:solidFill>
                    <a:srgbClr val="0070C0"/>
                  </a:solidFill>
                </a:rPr>
                <a:t>0 downregulated</a:t>
              </a:r>
            </a:p>
            <a:p>
              <a:pPr algn="ctr">
                <a:lnSpc>
                  <a:spcPct val="90000"/>
                </a:lnSpc>
                <a:spcAft>
                  <a:spcPts val="275"/>
                </a:spcAft>
              </a:pPr>
              <a:r>
                <a:rPr lang="en-GB" sz="600" b="1">
                  <a:solidFill>
                    <a:srgbClr val="C00000"/>
                  </a:solidFill>
                </a:rPr>
                <a:t>0 upregulated</a:t>
              </a:r>
            </a:p>
          </p:txBody>
        </p:sp>
        <p:sp>
          <p:nvSpPr>
            <p:cNvPr id="18" name="TextBox 17">
              <a:extLst>
                <a:ext uri="{FF2B5EF4-FFF2-40B4-BE49-F238E27FC236}">
                  <a16:creationId xmlns:a16="http://schemas.microsoft.com/office/drawing/2014/main" id="{78B78235-15F0-0423-E0C9-3CAAB7BD103D}"/>
                </a:ext>
              </a:extLst>
            </p:cNvPr>
            <p:cNvSpPr txBox="1"/>
            <p:nvPr/>
          </p:nvSpPr>
          <p:spPr>
            <a:xfrm>
              <a:off x="4324804" y="1729940"/>
              <a:ext cx="2118201" cy="470710"/>
            </a:xfrm>
            <a:prstGeom prst="rect">
              <a:avLst/>
            </a:prstGeom>
            <a:noFill/>
          </p:spPr>
          <p:txBody>
            <a:bodyPr wrap="square" rtlCol="0">
              <a:spAutoFit/>
            </a:bodyPr>
            <a:lstStyle/>
            <a:p>
              <a:pPr algn="ctr">
                <a:lnSpc>
                  <a:spcPct val="90000"/>
                </a:lnSpc>
                <a:spcAft>
                  <a:spcPts val="275"/>
                </a:spcAft>
              </a:pPr>
              <a:r>
                <a:rPr lang="en-GB" sz="700" b="1"/>
                <a:t>capivasertib</a:t>
              </a:r>
            </a:p>
          </p:txBody>
        </p:sp>
        <p:sp>
          <p:nvSpPr>
            <p:cNvPr id="19" name="TextBox 18">
              <a:extLst>
                <a:ext uri="{FF2B5EF4-FFF2-40B4-BE49-F238E27FC236}">
                  <a16:creationId xmlns:a16="http://schemas.microsoft.com/office/drawing/2014/main" id="{230096F3-A9B3-B4E9-450B-F1AA980670CB}"/>
                </a:ext>
              </a:extLst>
            </p:cNvPr>
            <p:cNvSpPr txBox="1"/>
            <p:nvPr/>
          </p:nvSpPr>
          <p:spPr>
            <a:xfrm>
              <a:off x="5984177" y="3577517"/>
              <a:ext cx="1508742" cy="651340"/>
            </a:xfrm>
            <a:prstGeom prst="rect">
              <a:avLst/>
            </a:prstGeom>
            <a:noFill/>
          </p:spPr>
          <p:txBody>
            <a:bodyPr wrap="square" rtlCol="0">
              <a:spAutoFit/>
            </a:bodyPr>
            <a:lstStyle/>
            <a:p>
              <a:pPr>
                <a:lnSpc>
                  <a:spcPct val="90000"/>
                </a:lnSpc>
                <a:spcAft>
                  <a:spcPts val="275"/>
                </a:spcAft>
              </a:pPr>
              <a:r>
                <a:rPr lang="en-GB" sz="700" b="1"/>
                <a:t>capivasertib/</a:t>
              </a:r>
              <a:r>
                <a:rPr lang="en-GB" sz="700" b="1" err="1"/>
                <a:t>fulvestrant</a:t>
              </a:r>
              <a:endParaRPr lang="en-GB" sz="700" b="1"/>
            </a:p>
          </p:txBody>
        </p:sp>
        <p:sp>
          <p:nvSpPr>
            <p:cNvPr id="21" name="TextBox 20">
              <a:extLst>
                <a:ext uri="{FF2B5EF4-FFF2-40B4-BE49-F238E27FC236}">
                  <a16:creationId xmlns:a16="http://schemas.microsoft.com/office/drawing/2014/main" id="{E285D30C-B424-C096-9E79-51BCDA88BE56}"/>
                </a:ext>
              </a:extLst>
            </p:cNvPr>
            <p:cNvSpPr txBox="1"/>
            <p:nvPr/>
          </p:nvSpPr>
          <p:spPr>
            <a:xfrm>
              <a:off x="2993093" y="3696302"/>
              <a:ext cx="2022543" cy="470710"/>
            </a:xfrm>
            <a:prstGeom prst="rect">
              <a:avLst/>
            </a:prstGeom>
            <a:noFill/>
          </p:spPr>
          <p:txBody>
            <a:bodyPr wrap="square" rtlCol="0">
              <a:spAutoFit/>
            </a:bodyPr>
            <a:lstStyle/>
            <a:p>
              <a:pPr algn="ctr">
                <a:lnSpc>
                  <a:spcPct val="90000"/>
                </a:lnSpc>
                <a:spcAft>
                  <a:spcPts val="275"/>
                </a:spcAft>
              </a:pPr>
              <a:r>
                <a:rPr lang="en-GB" sz="700" b="1"/>
                <a:t>fulvestrant</a:t>
              </a:r>
            </a:p>
          </p:txBody>
        </p:sp>
        <p:sp>
          <p:nvSpPr>
            <p:cNvPr id="23" name="TextBox 22">
              <a:extLst>
                <a:ext uri="{FF2B5EF4-FFF2-40B4-BE49-F238E27FC236}">
                  <a16:creationId xmlns:a16="http://schemas.microsoft.com/office/drawing/2014/main" id="{92ED7E0E-B28E-4B3C-9624-CD3703E3B7E0}"/>
                </a:ext>
              </a:extLst>
            </p:cNvPr>
            <p:cNvSpPr txBox="1"/>
            <p:nvPr/>
          </p:nvSpPr>
          <p:spPr>
            <a:xfrm>
              <a:off x="3157348" y="4095001"/>
              <a:ext cx="1903320" cy="675852"/>
            </a:xfrm>
            <a:prstGeom prst="rect">
              <a:avLst/>
            </a:prstGeom>
            <a:noFill/>
          </p:spPr>
          <p:txBody>
            <a:bodyPr wrap="square" lIns="91440" tIns="45720" rIns="91440" bIns="45720" rtlCol="0" anchor="t">
              <a:spAutoFit/>
            </a:bodyPr>
            <a:lstStyle/>
            <a:p>
              <a:pPr algn="ctr">
                <a:lnSpc>
                  <a:spcPct val="90000"/>
                </a:lnSpc>
                <a:spcAft>
                  <a:spcPts val="275"/>
                </a:spcAft>
              </a:pPr>
              <a:r>
                <a:rPr lang="en-GB" sz="600" b="1">
                  <a:solidFill>
                    <a:srgbClr val="0070C0"/>
                  </a:solidFill>
                </a:rPr>
                <a:t>4 downregulated</a:t>
              </a:r>
            </a:p>
            <a:p>
              <a:pPr algn="ctr">
                <a:lnSpc>
                  <a:spcPct val="90000"/>
                </a:lnSpc>
                <a:spcAft>
                  <a:spcPts val="275"/>
                </a:spcAft>
              </a:pPr>
              <a:r>
                <a:rPr lang="en-GB" sz="600" b="1">
                  <a:solidFill>
                    <a:srgbClr val="C00000"/>
                  </a:solidFill>
                </a:rPr>
                <a:t>0 upregulated</a:t>
              </a:r>
              <a:endParaRPr lang="en-GB" sz="600" b="1">
                <a:solidFill>
                  <a:srgbClr val="C00000"/>
                </a:solidFill>
                <a:cs typeface="Calibri"/>
              </a:endParaRPr>
            </a:p>
          </p:txBody>
        </p:sp>
        <p:sp>
          <p:nvSpPr>
            <p:cNvPr id="24" name="TextBox 23">
              <a:extLst>
                <a:ext uri="{FF2B5EF4-FFF2-40B4-BE49-F238E27FC236}">
                  <a16:creationId xmlns:a16="http://schemas.microsoft.com/office/drawing/2014/main" id="{DE6B2C9C-070A-C9A3-75A8-A4FCC18E5709}"/>
                </a:ext>
              </a:extLst>
            </p:cNvPr>
            <p:cNvSpPr txBox="1"/>
            <p:nvPr/>
          </p:nvSpPr>
          <p:spPr>
            <a:xfrm>
              <a:off x="5520868" y="4121923"/>
              <a:ext cx="2092856" cy="675852"/>
            </a:xfrm>
            <a:prstGeom prst="rect">
              <a:avLst/>
            </a:prstGeom>
            <a:noFill/>
          </p:spPr>
          <p:txBody>
            <a:bodyPr wrap="square" lIns="91440" tIns="45720" rIns="91440" bIns="45720" rtlCol="0" anchor="t">
              <a:spAutoFit/>
            </a:bodyPr>
            <a:lstStyle/>
            <a:p>
              <a:pPr algn="ctr">
                <a:lnSpc>
                  <a:spcPct val="90000"/>
                </a:lnSpc>
                <a:spcAft>
                  <a:spcPts val="275"/>
                </a:spcAft>
              </a:pPr>
              <a:r>
                <a:rPr lang="en-GB" sz="600" b="1">
                  <a:solidFill>
                    <a:srgbClr val="0070C0"/>
                  </a:solidFill>
                </a:rPr>
                <a:t>68 downregulated</a:t>
              </a:r>
            </a:p>
            <a:p>
              <a:pPr algn="ctr">
                <a:lnSpc>
                  <a:spcPct val="90000"/>
                </a:lnSpc>
                <a:spcAft>
                  <a:spcPts val="275"/>
                </a:spcAft>
              </a:pPr>
              <a:r>
                <a:rPr lang="en-GB" sz="600" b="1">
                  <a:solidFill>
                    <a:srgbClr val="C00000"/>
                  </a:solidFill>
                </a:rPr>
                <a:t>4 upregulated</a:t>
              </a:r>
              <a:endParaRPr lang="en-GB" sz="600" b="1">
                <a:solidFill>
                  <a:srgbClr val="C00000"/>
                </a:solidFill>
                <a:cs typeface="Calibri"/>
              </a:endParaRPr>
            </a:p>
          </p:txBody>
        </p:sp>
        <p:sp>
          <p:nvSpPr>
            <p:cNvPr id="25" name="TextBox 24">
              <a:extLst>
                <a:ext uri="{FF2B5EF4-FFF2-40B4-BE49-F238E27FC236}">
                  <a16:creationId xmlns:a16="http://schemas.microsoft.com/office/drawing/2014/main" id="{36D55E4B-7BDE-0AE5-96B2-98D64E052601}"/>
                </a:ext>
              </a:extLst>
            </p:cNvPr>
            <p:cNvSpPr txBox="1"/>
            <p:nvPr/>
          </p:nvSpPr>
          <p:spPr>
            <a:xfrm>
              <a:off x="3712271" y="2795581"/>
              <a:ext cx="1857624"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0</a:t>
              </a:r>
            </a:p>
            <a:p>
              <a:pPr algn="ctr">
                <a:lnSpc>
                  <a:spcPct val="90000"/>
                </a:lnSpc>
                <a:spcAft>
                  <a:spcPts val="275"/>
                </a:spcAft>
              </a:pPr>
              <a:r>
                <a:rPr lang="en-GB" sz="600" b="1">
                  <a:solidFill>
                    <a:srgbClr val="C00000"/>
                  </a:solidFill>
                </a:rPr>
                <a:t>0 </a:t>
              </a:r>
            </a:p>
          </p:txBody>
        </p:sp>
        <p:sp>
          <p:nvSpPr>
            <p:cNvPr id="26" name="TextBox 25">
              <a:extLst>
                <a:ext uri="{FF2B5EF4-FFF2-40B4-BE49-F238E27FC236}">
                  <a16:creationId xmlns:a16="http://schemas.microsoft.com/office/drawing/2014/main" id="{C680E34C-21BE-AC65-4E3A-6C418D0687C0}"/>
                </a:ext>
              </a:extLst>
            </p:cNvPr>
            <p:cNvSpPr txBox="1"/>
            <p:nvPr/>
          </p:nvSpPr>
          <p:spPr>
            <a:xfrm>
              <a:off x="4396559" y="3222031"/>
              <a:ext cx="1857624"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7</a:t>
              </a:r>
            </a:p>
            <a:p>
              <a:pPr algn="ctr">
                <a:lnSpc>
                  <a:spcPct val="90000"/>
                </a:lnSpc>
                <a:spcAft>
                  <a:spcPts val="275"/>
                </a:spcAft>
              </a:pPr>
              <a:r>
                <a:rPr lang="en-GB" sz="600" b="1">
                  <a:solidFill>
                    <a:srgbClr val="C00000"/>
                  </a:solidFill>
                </a:rPr>
                <a:t>0 </a:t>
              </a:r>
            </a:p>
          </p:txBody>
        </p:sp>
        <p:sp>
          <p:nvSpPr>
            <p:cNvPr id="27" name="TextBox 26">
              <a:extLst>
                <a:ext uri="{FF2B5EF4-FFF2-40B4-BE49-F238E27FC236}">
                  <a16:creationId xmlns:a16="http://schemas.microsoft.com/office/drawing/2014/main" id="{5BE83CCF-6B30-FF98-6061-209BB434B52D}"/>
                </a:ext>
              </a:extLst>
            </p:cNvPr>
            <p:cNvSpPr txBox="1"/>
            <p:nvPr/>
          </p:nvSpPr>
          <p:spPr>
            <a:xfrm>
              <a:off x="4334570" y="4061209"/>
              <a:ext cx="1903320"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177</a:t>
              </a:r>
            </a:p>
            <a:p>
              <a:pPr algn="ctr">
                <a:lnSpc>
                  <a:spcPct val="90000"/>
                </a:lnSpc>
                <a:spcAft>
                  <a:spcPts val="275"/>
                </a:spcAft>
              </a:pPr>
              <a:r>
                <a:rPr lang="en-GB" sz="600" b="1">
                  <a:solidFill>
                    <a:srgbClr val="C00000"/>
                  </a:solidFill>
                </a:rPr>
                <a:t>0 </a:t>
              </a:r>
            </a:p>
          </p:txBody>
        </p:sp>
        <p:sp>
          <p:nvSpPr>
            <p:cNvPr id="28" name="TextBox 27">
              <a:extLst>
                <a:ext uri="{FF2B5EF4-FFF2-40B4-BE49-F238E27FC236}">
                  <a16:creationId xmlns:a16="http://schemas.microsoft.com/office/drawing/2014/main" id="{E53FBE04-90EB-B456-F36C-56C4D63EE0A5}"/>
                </a:ext>
              </a:extLst>
            </p:cNvPr>
            <p:cNvSpPr txBox="1"/>
            <p:nvPr/>
          </p:nvSpPr>
          <p:spPr>
            <a:xfrm>
              <a:off x="5097052" y="2778926"/>
              <a:ext cx="1857624" cy="675852"/>
            </a:xfrm>
            <a:prstGeom prst="rect">
              <a:avLst/>
            </a:prstGeom>
            <a:noFill/>
          </p:spPr>
          <p:txBody>
            <a:bodyPr wrap="square" rtlCol="0">
              <a:spAutoFit/>
            </a:bodyPr>
            <a:lstStyle/>
            <a:p>
              <a:pPr algn="ctr">
                <a:lnSpc>
                  <a:spcPct val="90000"/>
                </a:lnSpc>
                <a:spcAft>
                  <a:spcPts val="275"/>
                </a:spcAft>
              </a:pPr>
              <a:r>
                <a:rPr lang="en-GB" sz="600" b="1">
                  <a:solidFill>
                    <a:srgbClr val="0070C0"/>
                  </a:solidFill>
                </a:rPr>
                <a:t>1</a:t>
              </a:r>
            </a:p>
            <a:p>
              <a:pPr algn="ctr">
                <a:lnSpc>
                  <a:spcPct val="90000"/>
                </a:lnSpc>
                <a:spcAft>
                  <a:spcPts val="275"/>
                </a:spcAft>
              </a:pPr>
              <a:r>
                <a:rPr lang="en-GB" sz="600" b="1">
                  <a:solidFill>
                    <a:srgbClr val="C00000"/>
                  </a:solidFill>
                </a:rPr>
                <a:t>0 </a:t>
              </a:r>
            </a:p>
          </p:txBody>
        </p:sp>
      </p:grpSp>
      <p:sp>
        <p:nvSpPr>
          <p:cNvPr id="32" name="TextBox 31">
            <a:extLst>
              <a:ext uri="{FF2B5EF4-FFF2-40B4-BE49-F238E27FC236}">
                <a16:creationId xmlns:a16="http://schemas.microsoft.com/office/drawing/2014/main" id="{9F5A768F-8DA6-347A-BCA6-E0C8775525DE}"/>
              </a:ext>
            </a:extLst>
          </p:cNvPr>
          <p:cNvSpPr txBox="1"/>
          <p:nvPr/>
        </p:nvSpPr>
        <p:spPr>
          <a:xfrm>
            <a:off x="1116439" y="2352800"/>
            <a:ext cx="565356" cy="246221"/>
          </a:xfrm>
          <a:prstGeom prst="rect">
            <a:avLst/>
          </a:prstGeom>
          <a:noFill/>
        </p:spPr>
        <p:txBody>
          <a:bodyPr wrap="square" rtlCol="0">
            <a:spAutoFit/>
          </a:bodyPr>
          <a:lstStyle/>
          <a:p>
            <a:pPr algn="ctr"/>
            <a:r>
              <a:rPr lang="en-GB" sz="500"/>
              <a:t>MCF7 parental DMSO</a:t>
            </a:r>
          </a:p>
        </p:txBody>
      </p:sp>
      <p:sp>
        <p:nvSpPr>
          <p:cNvPr id="33" name="TextBox 32">
            <a:extLst>
              <a:ext uri="{FF2B5EF4-FFF2-40B4-BE49-F238E27FC236}">
                <a16:creationId xmlns:a16="http://schemas.microsoft.com/office/drawing/2014/main" id="{290BFEAF-B4F8-25E6-8D78-5E4B0430C3AA}"/>
              </a:ext>
            </a:extLst>
          </p:cNvPr>
          <p:cNvSpPr txBox="1"/>
          <p:nvPr/>
        </p:nvSpPr>
        <p:spPr>
          <a:xfrm>
            <a:off x="1629432" y="2352800"/>
            <a:ext cx="565356" cy="246221"/>
          </a:xfrm>
          <a:prstGeom prst="rect">
            <a:avLst/>
          </a:prstGeom>
          <a:noFill/>
        </p:spPr>
        <p:txBody>
          <a:bodyPr wrap="square" rtlCol="0">
            <a:spAutoFit/>
          </a:bodyPr>
          <a:lstStyle/>
          <a:p>
            <a:pPr algn="ctr"/>
            <a:r>
              <a:rPr lang="en-GB" sz="500"/>
              <a:t>MCF7 parental capivasertib</a:t>
            </a:r>
          </a:p>
        </p:txBody>
      </p:sp>
      <p:sp>
        <p:nvSpPr>
          <p:cNvPr id="34" name="TextBox 33">
            <a:extLst>
              <a:ext uri="{FF2B5EF4-FFF2-40B4-BE49-F238E27FC236}">
                <a16:creationId xmlns:a16="http://schemas.microsoft.com/office/drawing/2014/main" id="{C01AF0B2-D2AB-28E2-B5EB-DAEE516D3B9D}"/>
              </a:ext>
            </a:extLst>
          </p:cNvPr>
          <p:cNvSpPr txBox="1"/>
          <p:nvPr/>
        </p:nvSpPr>
        <p:spPr>
          <a:xfrm>
            <a:off x="2128739" y="2352800"/>
            <a:ext cx="565356" cy="246221"/>
          </a:xfrm>
          <a:prstGeom prst="rect">
            <a:avLst/>
          </a:prstGeom>
          <a:noFill/>
        </p:spPr>
        <p:txBody>
          <a:bodyPr wrap="square" rtlCol="0">
            <a:spAutoFit/>
          </a:bodyPr>
          <a:lstStyle/>
          <a:p>
            <a:pPr algn="ctr"/>
            <a:r>
              <a:rPr lang="en-GB" sz="500"/>
              <a:t>MCF7 parental </a:t>
            </a:r>
            <a:r>
              <a:rPr lang="en-GB" sz="500" err="1"/>
              <a:t>fulvestrant</a:t>
            </a:r>
            <a:endParaRPr lang="en-GB" sz="500"/>
          </a:p>
        </p:txBody>
      </p:sp>
      <p:sp>
        <p:nvSpPr>
          <p:cNvPr id="35" name="TextBox 34">
            <a:extLst>
              <a:ext uri="{FF2B5EF4-FFF2-40B4-BE49-F238E27FC236}">
                <a16:creationId xmlns:a16="http://schemas.microsoft.com/office/drawing/2014/main" id="{BBF5AA42-7457-B2C9-E459-447497F52412}"/>
              </a:ext>
            </a:extLst>
          </p:cNvPr>
          <p:cNvSpPr txBox="1"/>
          <p:nvPr/>
        </p:nvSpPr>
        <p:spPr>
          <a:xfrm>
            <a:off x="2611036" y="2352800"/>
            <a:ext cx="565356" cy="323165"/>
          </a:xfrm>
          <a:prstGeom prst="rect">
            <a:avLst/>
          </a:prstGeom>
          <a:noFill/>
        </p:spPr>
        <p:txBody>
          <a:bodyPr wrap="square" rtlCol="0">
            <a:spAutoFit/>
          </a:bodyPr>
          <a:lstStyle/>
          <a:p>
            <a:pPr algn="ctr"/>
            <a:r>
              <a:rPr lang="en-GB" sz="500"/>
              <a:t>MCF7 parental </a:t>
            </a:r>
            <a:r>
              <a:rPr lang="en-GB" sz="500" err="1"/>
              <a:t>capiva</a:t>
            </a:r>
            <a:r>
              <a:rPr lang="en-GB" sz="500"/>
              <a:t>/</a:t>
            </a:r>
            <a:r>
              <a:rPr lang="en-GB" sz="500" err="1"/>
              <a:t>fulv</a:t>
            </a:r>
            <a:r>
              <a:rPr lang="en-GB" sz="500"/>
              <a:t> combination</a:t>
            </a:r>
          </a:p>
        </p:txBody>
      </p:sp>
      <p:pic>
        <p:nvPicPr>
          <p:cNvPr id="38" name="Picture 37">
            <a:extLst>
              <a:ext uri="{FF2B5EF4-FFF2-40B4-BE49-F238E27FC236}">
                <a16:creationId xmlns:a16="http://schemas.microsoft.com/office/drawing/2014/main" id="{ABE1D168-94E5-D806-A7AD-31BFDEACA5A5}"/>
              </a:ext>
            </a:extLst>
          </p:cNvPr>
          <p:cNvPicPr>
            <a:picLocks noChangeAspect="1"/>
          </p:cNvPicPr>
          <p:nvPr/>
        </p:nvPicPr>
        <p:blipFill rotWithShape="1">
          <a:blip r:embed="rId4"/>
          <a:srcRect l="89640" t="777" b="31784"/>
          <a:stretch/>
        </p:blipFill>
        <p:spPr>
          <a:xfrm>
            <a:off x="619799" y="1116110"/>
            <a:ext cx="153588" cy="961205"/>
          </a:xfrm>
          <a:prstGeom prst="rect">
            <a:avLst/>
          </a:prstGeom>
        </p:spPr>
      </p:pic>
      <p:sp>
        <p:nvSpPr>
          <p:cNvPr id="39" name="TextBox 38">
            <a:extLst>
              <a:ext uri="{FF2B5EF4-FFF2-40B4-BE49-F238E27FC236}">
                <a16:creationId xmlns:a16="http://schemas.microsoft.com/office/drawing/2014/main" id="{3896AEEB-35D5-66BE-B4E0-6F356669993D}"/>
              </a:ext>
            </a:extLst>
          </p:cNvPr>
          <p:cNvSpPr txBox="1"/>
          <p:nvPr/>
        </p:nvSpPr>
        <p:spPr>
          <a:xfrm>
            <a:off x="454270" y="824183"/>
            <a:ext cx="430437" cy="323165"/>
          </a:xfrm>
          <a:prstGeom prst="rect">
            <a:avLst/>
          </a:prstGeom>
          <a:noFill/>
        </p:spPr>
        <p:txBody>
          <a:bodyPr wrap="square" rtlCol="0">
            <a:spAutoFit/>
          </a:bodyPr>
          <a:lstStyle/>
          <a:p>
            <a:r>
              <a:rPr lang="en-GB" sz="500" b="1"/>
              <a:t>Z-scores of mean counts</a:t>
            </a:r>
          </a:p>
        </p:txBody>
      </p:sp>
      <p:pic>
        <p:nvPicPr>
          <p:cNvPr id="47" name="Picture 46">
            <a:extLst>
              <a:ext uri="{FF2B5EF4-FFF2-40B4-BE49-F238E27FC236}">
                <a16:creationId xmlns:a16="http://schemas.microsoft.com/office/drawing/2014/main" id="{65BF2DBD-3536-ADD8-326E-37C236E777B9}"/>
              </a:ext>
            </a:extLst>
          </p:cNvPr>
          <p:cNvPicPr>
            <a:picLocks noChangeAspect="1"/>
          </p:cNvPicPr>
          <p:nvPr/>
        </p:nvPicPr>
        <p:blipFill rotWithShape="1">
          <a:blip r:embed="rId5"/>
          <a:srcRect l="59047" r="30750" b="72134"/>
          <a:stretch/>
        </p:blipFill>
        <p:spPr>
          <a:xfrm>
            <a:off x="6000512" y="4413800"/>
            <a:ext cx="173783" cy="555843"/>
          </a:xfrm>
          <a:prstGeom prst="rect">
            <a:avLst/>
          </a:prstGeom>
        </p:spPr>
      </p:pic>
      <p:sp>
        <p:nvSpPr>
          <p:cNvPr id="49" name="TextBox 48">
            <a:extLst>
              <a:ext uri="{FF2B5EF4-FFF2-40B4-BE49-F238E27FC236}">
                <a16:creationId xmlns:a16="http://schemas.microsoft.com/office/drawing/2014/main" id="{5F71A8F8-C9CE-215D-5FCE-61F768395EA2}"/>
              </a:ext>
            </a:extLst>
          </p:cNvPr>
          <p:cNvSpPr txBox="1"/>
          <p:nvPr/>
        </p:nvSpPr>
        <p:spPr>
          <a:xfrm rot="5400000">
            <a:off x="4677085" y="5101653"/>
            <a:ext cx="1217528" cy="231089"/>
          </a:xfrm>
          <a:prstGeom prst="rect">
            <a:avLst/>
          </a:prstGeom>
          <a:noFill/>
        </p:spPr>
        <p:txBody>
          <a:bodyPr wrap="square">
            <a:spAutoFit/>
          </a:bodyPr>
          <a:lstStyle/>
          <a:p>
            <a:pPr>
              <a:lnSpc>
                <a:spcPts val="1200"/>
              </a:lnSpc>
            </a:pPr>
            <a:r>
              <a:rPr lang="en-GB" sz="600">
                <a:latin typeface="Arial" panose="020B0604020202020204" pitchFamily="34" charset="0"/>
                <a:cs typeface="Arial" panose="020B0604020202020204" pitchFamily="34" charset="0"/>
              </a:rPr>
              <a:t>capivasertib vs DMSO</a:t>
            </a:r>
          </a:p>
        </p:txBody>
      </p:sp>
      <p:sp>
        <p:nvSpPr>
          <p:cNvPr id="50" name="TextBox 49">
            <a:extLst>
              <a:ext uri="{FF2B5EF4-FFF2-40B4-BE49-F238E27FC236}">
                <a16:creationId xmlns:a16="http://schemas.microsoft.com/office/drawing/2014/main" id="{167B5454-CCEB-CCAD-0466-3F56A6291C98}"/>
              </a:ext>
            </a:extLst>
          </p:cNvPr>
          <p:cNvSpPr txBox="1"/>
          <p:nvPr/>
        </p:nvSpPr>
        <p:spPr>
          <a:xfrm rot="5400000">
            <a:off x="4892593" y="5108607"/>
            <a:ext cx="1217528" cy="231089"/>
          </a:xfrm>
          <a:prstGeom prst="rect">
            <a:avLst/>
          </a:prstGeom>
          <a:noFill/>
        </p:spPr>
        <p:txBody>
          <a:bodyPr wrap="square">
            <a:spAutoFit/>
          </a:bodyPr>
          <a:lstStyle/>
          <a:p>
            <a:pPr>
              <a:lnSpc>
                <a:spcPts val="1200"/>
              </a:lnSpc>
            </a:pPr>
            <a:r>
              <a:rPr lang="en-GB" sz="600">
                <a:latin typeface="Arial" panose="020B0604020202020204" pitchFamily="34" charset="0"/>
                <a:cs typeface="Arial" panose="020B0604020202020204" pitchFamily="34" charset="0"/>
              </a:rPr>
              <a:t>fulvestrant vs DMSO</a:t>
            </a:r>
          </a:p>
        </p:txBody>
      </p:sp>
      <p:sp>
        <p:nvSpPr>
          <p:cNvPr id="51" name="TextBox 50">
            <a:extLst>
              <a:ext uri="{FF2B5EF4-FFF2-40B4-BE49-F238E27FC236}">
                <a16:creationId xmlns:a16="http://schemas.microsoft.com/office/drawing/2014/main" id="{D9F722E2-D7B3-FF0F-3407-FDC144D0BA96}"/>
              </a:ext>
            </a:extLst>
          </p:cNvPr>
          <p:cNvSpPr txBox="1"/>
          <p:nvPr/>
        </p:nvSpPr>
        <p:spPr>
          <a:xfrm rot="5400000">
            <a:off x="5082853" y="5108607"/>
            <a:ext cx="1217528" cy="231089"/>
          </a:xfrm>
          <a:prstGeom prst="rect">
            <a:avLst/>
          </a:prstGeom>
          <a:noFill/>
        </p:spPr>
        <p:txBody>
          <a:bodyPr wrap="square">
            <a:spAutoFit/>
          </a:bodyPr>
          <a:lstStyle/>
          <a:p>
            <a:pPr>
              <a:lnSpc>
                <a:spcPts val="1200"/>
              </a:lnSpc>
            </a:pPr>
            <a:r>
              <a:rPr lang="en-GB" sz="600">
                <a:latin typeface="Arial" panose="020B0604020202020204" pitchFamily="34" charset="0"/>
                <a:cs typeface="Arial" panose="020B0604020202020204" pitchFamily="34" charset="0"/>
              </a:rPr>
              <a:t>capiva/fulv vs DMSO</a:t>
            </a:r>
          </a:p>
        </p:txBody>
      </p:sp>
      <p:sp>
        <p:nvSpPr>
          <p:cNvPr id="53" name="TextBox 52">
            <a:extLst>
              <a:ext uri="{FF2B5EF4-FFF2-40B4-BE49-F238E27FC236}">
                <a16:creationId xmlns:a16="http://schemas.microsoft.com/office/drawing/2014/main" id="{24FD6D41-FAF2-8238-304A-267EA8FC5A84}"/>
              </a:ext>
            </a:extLst>
          </p:cNvPr>
          <p:cNvSpPr txBox="1"/>
          <p:nvPr/>
        </p:nvSpPr>
        <p:spPr>
          <a:xfrm>
            <a:off x="3343957" y="2644843"/>
            <a:ext cx="251407" cy="276999"/>
          </a:xfrm>
          <a:prstGeom prst="rect">
            <a:avLst/>
          </a:prstGeom>
          <a:noFill/>
        </p:spPr>
        <p:txBody>
          <a:bodyPr wrap="square" lIns="91440" tIns="45720" rIns="91440" bIns="45720" rtlCol="0" anchor="t">
            <a:spAutoFit/>
          </a:bodyPr>
          <a:lstStyle/>
          <a:p>
            <a:r>
              <a:rPr lang="en-GB" sz="1200" b="1"/>
              <a:t>D</a:t>
            </a:r>
          </a:p>
        </p:txBody>
      </p:sp>
      <p:sp>
        <p:nvSpPr>
          <p:cNvPr id="56" name="TextBox 55">
            <a:extLst>
              <a:ext uri="{FF2B5EF4-FFF2-40B4-BE49-F238E27FC236}">
                <a16:creationId xmlns:a16="http://schemas.microsoft.com/office/drawing/2014/main" id="{8B26A75F-A6A5-F862-2937-17C3B588D183}"/>
              </a:ext>
            </a:extLst>
          </p:cNvPr>
          <p:cNvSpPr txBox="1"/>
          <p:nvPr/>
        </p:nvSpPr>
        <p:spPr>
          <a:xfrm>
            <a:off x="359933" y="5642409"/>
            <a:ext cx="251407" cy="276999"/>
          </a:xfrm>
          <a:prstGeom prst="rect">
            <a:avLst/>
          </a:prstGeom>
          <a:noFill/>
        </p:spPr>
        <p:txBody>
          <a:bodyPr wrap="square" lIns="91440" tIns="45720" rIns="91440" bIns="45720" rtlCol="0" anchor="t">
            <a:spAutoFit/>
          </a:bodyPr>
          <a:lstStyle/>
          <a:p>
            <a:r>
              <a:rPr lang="en-GB" sz="1200" b="1"/>
              <a:t>E</a:t>
            </a:r>
          </a:p>
        </p:txBody>
      </p:sp>
      <p:pic>
        <p:nvPicPr>
          <p:cNvPr id="10" name="Picture 9">
            <a:extLst>
              <a:ext uri="{FF2B5EF4-FFF2-40B4-BE49-F238E27FC236}">
                <a16:creationId xmlns:a16="http://schemas.microsoft.com/office/drawing/2014/main" id="{43BF7F59-18D2-0A93-5304-67A39CBD234C}"/>
              </a:ext>
            </a:extLst>
          </p:cNvPr>
          <p:cNvPicPr>
            <a:picLocks noChangeAspect="1"/>
          </p:cNvPicPr>
          <p:nvPr/>
        </p:nvPicPr>
        <p:blipFill rotWithShape="1">
          <a:blip r:embed="rId6"/>
          <a:srcRect l="60484" r="32709" b="84445"/>
          <a:stretch/>
        </p:blipFill>
        <p:spPr>
          <a:xfrm>
            <a:off x="5968286" y="3006924"/>
            <a:ext cx="238233" cy="631593"/>
          </a:xfrm>
          <a:prstGeom prst="rect">
            <a:avLst/>
          </a:prstGeom>
        </p:spPr>
      </p:pic>
      <p:sp>
        <p:nvSpPr>
          <p:cNvPr id="20" name="TextBox 19">
            <a:extLst>
              <a:ext uri="{FF2B5EF4-FFF2-40B4-BE49-F238E27FC236}">
                <a16:creationId xmlns:a16="http://schemas.microsoft.com/office/drawing/2014/main" id="{23B0AFF9-151B-403C-B4EC-C7D03DA51057}"/>
              </a:ext>
            </a:extLst>
          </p:cNvPr>
          <p:cNvSpPr txBox="1"/>
          <p:nvPr/>
        </p:nvSpPr>
        <p:spPr>
          <a:xfrm>
            <a:off x="4758907" y="2900324"/>
            <a:ext cx="488730" cy="153888"/>
          </a:xfrm>
          <a:prstGeom prst="rect">
            <a:avLst/>
          </a:prstGeom>
          <a:noFill/>
        </p:spPr>
        <p:txBody>
          <a:bodyPr wrap="square">
            <a:spAutoFit/>
          </a:bodyPr>
          <a:lstStyle/>
          <a:p>
            <a:pPr algn="r"/>
            <a:r>
              <a:rPr lang="en-GB" sz="400"/>
              <a:t>CELL CYCLE </a:t>
            </a:r>
          </a:p>
        </p:txBody>
      </p:sp>
      <p:sp>
        <p:nvSpPr>
          <p:cNvPr id="22" name="TextBox 21">
            <a:extLst>
              <a:ext uri="{FF2B5EF4-FFF2-40B4-BE49-F238E27FC236}">
                <a16:creationId xmlns:a16="http://schemas.microsoft.com/office/drawing/2014/main" id="{1E23FCBC-DF70-27FA-30FB-D80D4225BA61}"/>
              </a:ext>
            </a:extLst>
          </p:cNvPr>
          <p:cNvSpPr txBox="1"/>
          <p:nvPr/>
        </p:nvSpPr>
        <p:spPr>
          <a:xfrm>
            <a:off x="4564554" y="2955348"/>
            <a:ext cx="683083" cy="153888"/>
          </a:xfrm>
          <a:prstGeom prst="rect">
            <a:avLst/>
          </a:prstGeom>
          <a:noFill/>
        </p:spPr>
        <p:txBody>
          <a:bodyPr wrap="square">
            <a:spAutoFit/>
          </a:bodyPr>
          <a:lstStyle/>
          <a:p>
            <a:pPr algn="r"/>
            <a:r>
              <a:rPr lang="en-GB" sz="400"/>
              <a:t>CELL CYCLE MITOTIC</a:t>
            </a:r>
          </a:p>
        </p:txBody>
      </p:sp>
      <p:sp>
        <p:nvSpPr>
          <p:cNvPr id="29" name="TextBox 28">
            <a:extLst>
              <a:ext uri="{FF2B5EF4-FFF2-40B4-BE49-F238E27FC236}">
                <a16:creationId xmlns:a16="http://schemas.microsoft.com/office/drawing/2014/main" id="{2BB9CAD7-F003-D52A-67C0-1260BA53C1B3}"/>
              </a:ext>
            </a:extLst>
          </p:cNvPr>
          <p:cNvSpPr txBox="1"/>
          <p:nvPr/>
        </p:nvSpPr>
        <p:spPr>
          <a:xfrm>
            <a:off x="4758907" y="3011934"/>
            <a:ext cx="488730" cy="153888"/>
          </a:xfrm>
          <a:prstGeom prst="rect">
            <a:avLst/>
          </a:prstGeom>
          <a:noFill/>
        </p:spPr>
        <p:txBody>
          <a:bodyPr wrap="square">
            <a:spAutoFit/>
          </a:bodyPr>
          <a:lstStyle/>
          <a:p>
            <a:pPr algn="r"/>
            <a:r>
              <a:rPr lang="en-GB" sz="400"/>
              <a:t>E2F TARGETS</a:t>
            </a:r>
          </a:p>
        </p:txBody>
      </p:sp>
      <p:sp>
        <p:nvSpPr>
          <p:cNvPr id="30" name="TextBox 29">
            <a:extLst>
              <a:ext uri="{FF2B5EF4-FFF2-40B4-BE49-F238E27FC236}">
                <a16:creationId xmlns:a16="http://schemas.microsoft.com/office/drawing/2014/main" id="{4772F65A-3963-E115-0046-C04EF77C73DE}"/>
              </a:ext>
            </a:extLst>
          </p:cNvPr>
          <p:cNvSpPr txBox="1"/>
          <p:nvPr/>
        </p:nvSpPr>
        <p:spPr>
          <a:xfrm>
            <a:off x="4472265" y="3064493"/>
            <a:ext cx="775372" cy="153888"/>
          </a:xfrm>
          <a:prstGeom prst="rect">
            <a:avLst/>
          </a:prstGeom>
          <a:noFill/>
        </p:spPr>
        <p:txBody>
          <a:bodyPr wrap="square">
            <a:spAutoFit/>
          </a:bodyPr>
          <a:lstStyle/>
          <a:p>
            <a:pPr algn="r"/>
            <a:r>
              <a:rPr lang="en-GB" sz="400"/>
              <a:t>ESTROGEN RESPONSE LATE</a:t>
            </a:r>
          </a:p>
        </p:txBody>
      </p:sp>
      <p:sp>
        <p:nvSpPr>
          <p:cNvPr id="31" name="TextBox 30">
            <a:extLst>
              <a:ext uri="{FF2B5EF4-FFF2-40B4-BE49-F238E27FC236}">
                <a16:creationId xmlns:a16="http://schemas.microsoft.com/office/drawing/2014/main" id="{7E2001E7-693F-AD05-A315-3A4A552FC524}"/>
              </a:ext>
            </a:extLst>
          </p:cNvPr>
          <p:cNvSpPr txBox="1"/>
          <p:nvPr/>
        </p:nvSpPr>
        <p:spPr>
          <a:xfrm>
            <a:off x="4502073" y="3118787"/>
            <a:ext cx="745564" cy="153888"/>
          </a:xfrm>
          <a:prstGeom prst="rect">
            <a:avLst/>
          </a:prstGeom>
          <a:noFill/>
        </p:spPr>
        <p:txBody>
          <a:bodyPr wrap="square">
            <a:spAutoFit/>
          </a:bodyPr>
          <a:lstStyle/>
          <a:p>
            <a:pPr algn="r"/>
            <a:r>
              <a:rPr lang="en-GB" sz="400"/>
              <a:t>CELL CYCLE CHECKPOINTS</a:t>
            </a:r>
          </a:p>
        </p:txBody>
      </p:sp>
      <p:sp>
        <p:nvSpPr>
          <p:cNvPr id="36" name="TextBox 35">
            <a:extLst>
              <a:ext uri="{FF2B5EF4-FFF2-40B4-BE49-F238E27FC236}">
                <a16:creationId xmlns:a16="http://schemas.microsoft.com/office/drawing/2014/main" id="{3A70C355-1525-93D6-77B3-694188DEF2B4}"/>
              </a:ext>
            </a:extLst>
          </p:cNvPr>
          <p:cNvSpPr txBox="1"/>
          <p:nvPr/>
        </p:nvSpPr>
        <p:spPr>
          <a:xfrm>
            <a:off x="4444686" y="3176692"/>
            <a:ext cx="802951" cy="153888"/>
          </a:xfrm>
          <a:prstGeom prst="rect">
            <a:avLst/>
          </a:prstGeom>
          <a:noFill/>
        </p:spPr>
        <p:txBody>
          <a:bodyPr wrap="square">
            <a:spAutoFit/>
          </a:bodyPr>
          <a:lstStyle/>
          <a:p>
            <a:pPr algn="r"/>
            <a:r>
              <a:rPr lang="en-GB" sz="400"/>
              <a:t>ESTROGEN RESPONSE EARLY</a:t>
            </a:r>
          </a:p>
        </p:txBody>
      </p:sp>
      <p:sp>
        <p:nvSpPr>
          <p:cNvPr id="40" name="TextBox 39">
            <a:extLst>
              <a:ext uri="{FF2B5EF4-FFF2-40B4-BE49-F238E27FC236}">
                <a16:creationId xmlns:a16="http://schemas.microsoft.com/office/drawing/2014/main" id="{3CE044B5-D61E-E02C-0230-FC5E5D268A18}"/>
              </a:ext>
            </a:extLst>
          </p:cNvPr>
          <p:cNvSpPr txBox="1"/>
          <p:nvPr/>
        </p:nvSpPr>
        <p:spPr>
          <a:xfrm>
            <a:off x="4611517" y="3229930"/>
            <a:ext cx="636120" cy="153888"/>
          </a:xfrm>
          <a:prstGeom prst="rect">
            <a:avLst/>
          </a:prstGeom>
          <a:noFill/>
        </p:spPr>
        <p:txBody>
          <a:bodyPr wrap="square">
            <a:spAutoFit/>
          </a:bodyPr>
          <a:lstStyle/>
          <a:p>
            <a:pPr algn="r"/>
            <a:r>
              <a:rPr lang="en-GB" sz="400"/>
              <a:t>G2M CHECKPOINT</a:t>
            </a:r>
          </a:p>
        </p:txBody>
      </p:sp>
      <p:sp>
        <p:nvSpPr>
          <p:cNvPr id="41" name="TextBox 40">
            <a:extLst>
              <a:ext uri="{FF2B5EF4-FFF2-40B4-BE49-F238E27FC236}">
                <a16:creationId xmlns:a16="http://schemas.microsoft.com/office/drawing/2014/main" id="{82C5C81B-9A9B-D0D0-145A-484AD626AC09}"/>
              </a:ext>
            </a:extLst>
          </p:cNvPr>
          <p:cNvSpPr txBox="1"/>
          <p:nvPr/>
        </p:nvSpPr>
        <p:spPr>
          <a:xfrm>
            <a:off x="4758907" y="3285552"/>
            <a:ext cx="488730" cy="153888"/>
          </a:xfrm>
          <a:prstGeom prst="rect">
            <a:avLst/>
          </a:prstGeom>
          <a:noFill/>
        </p:spPr>
        <p:txBody>
          <a:bodyPr wrap="square">
            <a:spAutoFit/>
          </a:bodyPr>
          <a:lstStyle/>
          <a:p>
            <a:pPr algn="r"/>
            <a:r>
              <a:rPr lang="en-GB" sz="400"/>
              <a:t>M PHASE</a:t>
            </a:r>
          </a:p>
        </p:txBody>
      </p:sp>
      <p:sp>
        <p:nvSpPr>
          <p:cNvPr id="42" name="TextBox 41">
            <a:extLst>
              <a:ext uri="{FF2B5EF4-FFF2-40B4-BE49-F238E27FC236}">
                <a16:creationId xmlns:a16="http://schemas.microsoft.com/office/drawing/2014/main" id="{64BEFF27-8208-F62E-8F3B-ADDDDBC927C4}"/>
              </a:ext>
            </a:extLst>
          </p:cNvPr>
          <p:cNvSpPr txBox="1"/>
          <p:nvPr/>
        </p:nvSpPr>
        <p:spPr>
          <a:xfrm>
            <a:off x="4564554" y="3338657"/>
            <a:ext cx="683083" cy="153888"/>
          </a:xfrm>
          <a:prstGeom prst="rect">
            <a:avLst/>
          </a:prstGeom>
          <a:noFill/>
        </p:spPr>
        <p:txBody>
          <a:bodyPr wrap="square">
            <a:spAutoFit/>
          </a:bodyPr>
          <a:lstStyle/>
          <a:p>
            <a:pPr algn="r"/>
            <a:r>
              <a:rPr lang="en-GB" sz="400"/>
              <a:t>G2 M CHECKPOINTS</a:t>
            </a:r>
          </a:p>
        </p:txBody>
      </p:sp>
      <p:sp>
        <p:nvSpPr>
          <p:cNvPr id="44" name="TextBox 43">
            <a:extLst>
              <a:ext uri="{FF2B5EF4-FFF2-40B4-BE49-F238E27FC236}">
                <a16:creationId xmlns:a16="http://schemas.microsoft.com/office/drawing/2014/main" id="{D8B5DBB1-E373-42D3-5287-9FF94564D6E0}"/>
              </a:ext>
            </a:extLst>
          </p:cNvPr>
          <p:cNvSpPr txBox="1"/>
          <p:nvPr/>
        </p:nvSpPr>
        <p:spPr>
          <a:xfrm>
            <a:off x="4397295" y="3389969"/>
            <a:ext cx="850342" cy="153888"/>
          </a:xfrm>
          <a:prstGeom prst="rect">
            <a:avLst/>
          </a:prstGeom>
          <a:noFill/>
        </p:spPr>
        <p:txBody>
          <a:bodyPr wrap="square">
            <a:spAutoFit/>
          </a:bodyPr>
          <a:lstStyle/>
          <a:p>
            <a:pPr algn="r"/>
            <a:r>
              <a:rPr lang="en-GB" sz="400"/>
              <a:t>CHROMOSOME MAINTENANCE</a:t>
            </a:r>
          </a:p>
        </p:txBody>
      </p:sp>
      <p:sp>
        <p:nvSpPr>
          <p:cNvPr id="46" name="TextBox 45">
            <a:extLst>
              <a:ext uri="{FF2B5EF4-FFF2-40B4-BE49-F238E27FC236}">
                <a16:creationId xmlns:a16="http://schemas.microsoft.com/office/drawing/2014/main" id="{32DE49FB-1712-7F99-B938-36464119C875}"/>
              </a:ext>
            </a:extLst>
          </p:cNvPr>
          <p:cNvSpPr txBox="1"/>
          <p:nvPr/>
        </p:nvSpPr>
        <p:spPr>
          <a:xfrm>
            <a:off x="4407762" y="3443217"/>
            <a:ext cx="839875" cy="153888"/>
          </a:xfrm>
          <a:prstGeom prst="rect">
            <a:avLst/>
          </a:prstGeom>
          <a:noFill/>
        </p:spPr>
        <p:txBody>
          <a:bodyPr wrap="square">
            <a:spAutoFit/>
          </a:bodyPr>
          <a:lstStyle/>
          <a:p>
            <a:pPr algn="r"/>
            <a:r>
              <a:rPr lang="en-GB" sz="400"/>
              <a:t>HOMOLOGY DIRECTED REPAIR</a:t>
            </a:r>
          </a:p>
        </p:txBody>
      </p:sp>
      <p:sp>
        <p:nvSpPr>
          <p:cNvPr id="48" name="TextBox 47">
            <a:extLst>
              <a:ext uri="{FF2B5EF4-FFF2-40B4-BE49-F238E27FC236}">
                <a16:creationId xmlns:a16="http://schemas.microsoft.com/office/drawing/2014/main" id="{54030E54-DC52-E4C6-1A3D-6C1A185645E6}"/>
              </a:ext>
            </a:extLst>
          </p:cNvPr>
          <p:cNvSpPr txBox="1"/>
          <p:nvPr/>
        </p:nvSpPr>
        <p:spPr>
          <a:xfrm>
            <a:off x="4472265" y="3501049"/>
            <a:ext cx="775372" cy="153888"/>
          </a:xfrm>
          <a:prstGeom prst="rect">
            <a:avLst/>
          </a:prstGeom>
          <a:noFill/>
        </p:spPr>
        <p:txBody>
          <a:bodyPr wrap="square">
            <a:spAutoFit/>
          </a:bodyPr>
          <a:lstStyle/>
          <a:p>
            <a:pPr algn="r"/>
            <a:r>
              <a:rPr lang="en-GB" sz="400"/>
              <a:t>MITOTIC PROMETAPHASE</a:t>
            </a:r>
          </a:p>
        </p:txBody>
      </p:sp>
      <p:sp>
        <p:nvSpPr>
          <p:cNvPr id="52" name="TextBox 51">
            <a:extLst>
              <a:ext uri="{FF2B5EF4-FFF2-40B4-BE49-F238E27FC236}">
                <a16:creationId xmlns:a16="http://schemas.microsoft.com/office/drawing/2014/main" id="{1A260B0B-0708-0F9C-A4D2-6FA28170B166}"/>
              </a:ext>
            </a:extLst>
          </p:cNvPr>
          <p:cNvSpPr txBox="1"/>
          <p:nvPr/>
        </p:nvSpPr>
        <p:spPr>
          <a:xfrm>
            <a:off x="4291488" y="3554474"/>
            <a:ext cx="956149" cy="153888"/>
          </a:xfrm>
          <a:prstGeom prst="rect">
            <a:avLst/>
          </a:prstGeom>
          <a:noFill/>
        </p:spPr>
        <p:txBody>
          <a:bodyPr wrap="square">
            <a:spAutoFit/>
          </a:bodyPr>
          <a:lstStyle/>
          <a:p>
            <a:pPr algn="r"/>
            <a:r>
              <a:rPr lang="en-GB" sz="400"/>
              <a:t>DNA DOUBLE STRAND BREAK REPAIR</a:t>
            </a:r>
          </a:p>
        </p:txBody>
      </p:sp>
      <p:sp>
        <p:nvSpPr>
          <p:cNvPr id="54" name="TextBox 53">
            <a:extLst>
              <a:ext uri="{FF2B5EF4-FFF2-40B4-BE49-F238E27FC236}">
                <a16:creationId xmlns:a16="http://schemas.microsoft.com/office/drawing/2014/main" id="{12761C50-774E-1F4B-1FD8-E97D4E08AECD}"/>
              </a:ext>
            </a:extLst>
          </p:cNvPr>
          <p:cNvSpPr txBox="1"/>
          <p:nvPr/>
        </p:nvSpPr>
        <p:spPr>
          <a:xfrm>
            <a:off x="4430328" y="3609744"/>
            <a:ext cx="817309" cy="153888"/>
          </a:xfrm>
          <a:prstGeom prst="rect">
            <a:avLst/>
          </a:prstGeom>
          <a:noFill/>
        </p:spPr>
        <p:txBody>
          <a:bodyPr wrap="square">
            <a:spAutoFit/>
          </a:bodyPr>
          <a:lstStyle/>
          <a:p>
            <a:pPr algn="r"/>
            <a:r>
              <a:rPr lang="en-GB" sz="400"/>
              <a:t>DNA STRAND ELONGATION</a:t>
            </a:r>
          </a:p>
        </p:txBody>
      </p:sp>
      <p:sp>
        <p:nvSpPr>
          <p:cNvPr id="57" name="TextBox 56">
            <a:extLst>
              <a:ext uri="{FF2B5EF4-FFF2-40B4-BE49-F238E27FC236}">
                <a16:creationId xmlns:a16="http://schemas.microsoft.com/office/drawing/2014/main" id="{ECB17E79-BF9C-C00D-9EAE-32B1E3BD73EB}"/>
              </a:ext>
            </a:extLst>
          </p:cNvPr>
          <p:cNvSpPr txBox="1"/>
          <p:nvPr/>
        </p:nvSpPr>
        <p:spPr>
          <a:xfrm>
            <a:off x="4758907" y="3665960"/>
            <a:ext cx="488730" cy="153888"/>
          </a:xfrm>
          <a:prstGeom prst="rect">
            <a:avLst/>
          </a:prstGeom>
          <a:noFill/>
        </p:spPr>
        <p:txBody>
          <a:bodyPr wrap="square">
            <a:spAutoFit/>
          </a:bodyPr>
          <a:lstStyle/>
          <a:p>
            <a:pPr algn="r"/>
            <a:r>
              <a:rPr lang="en-GB" sz="400"/>
              <a:t>DNA REPAIR</a:t>
            </a:r>
          </a:p>
        </p:txBody>
      </p:sp>
      <p:sp>
        <p:nvSpPr>
          <p:cNvPr id="59" name="TextBox 58">
            <a:extLst>
              <a:ext uri="{FF2B5EF4-FFF2-40B4-BE49-F238E27FC236}">
                <a16:creationId xmlns:a16="http://schemas.microsoft.com/office/drawing/2014/main" id="{C956F0C8-9139-0667-4949-B31C44E5C639}"/>
              </a:ext>
            </a:extLst>
          </p:cNvPr>
          <p:cNvSpPr txBox="1"/>
          <p:nvPr/>
        </p:nvSpPr>
        <p:spPr>
          <a:xfrm>
            <a:off x="4497770" y="3719516"/>
            <a:ext cx="749867" cy="153888"/>
          </a:xfrm>
          <a:prstGeom prst="rect">
            <a:avLst/>
          </a:prstGeom>
          <a:noFill/>
        </p:spPr>
        <p:txBody>
          <a:bodyPr wrap="square">
            <a:spAutoFit/>
          </a:bodyPr>
          <a:lstStyle/>
          <a:p>
            <a:pPr algn="r"/>
            <a:r>
              <a:rPr lang="en-GB" sz="400"/>
              <a:t>RHO GTPASE EFFECTORS</a:t>
            </a:r>
          </a:p>
        </p:txBody>
      </p:sp>
      <p:sp>
        <p:nvSpPr>
          <p:cNvPr id="61" name="TextBox 60">
            <a:extLst>
              <a:ext uri="{FF2B5EF4-FFF2-40B4-BE49-F238E27FC236}">
                <a16:creationId xmlns:a16="http://schemas.microsoft.com/office/drawing/2014/main" id="{98E2DB37-B7BD-AAE7-9C71-0A6384527226}"/>
              </a:ext>
            </a:extLst>
          </p:cNvPr>
          <p:cNvSpPr txBox="1"/>
          <p:nvPr/>
        </p:nvSpPr>
        <p:spPr>
          <a:xfrm>
            <a:off x="3293242" y="3771415"/>
            <a:ext cx="1954395" cy="153888"/>
          </a:xfrm>
          <a:prstGeom prst="rect">
            <a:avLst/>
          </a:prstGeom>
          <a:noFill/>
        </p:spPr>
        <p:txBody>
          <a:bodyPr wrap="square">
            <a:spAutoFit/>
          </a:bodyPr>
          <a:lstStyle/>
          <a:p>
            <a:pPr algn="r"/>
            <a:r>
              <a:rPr lang="en-GB" sz="400"/>
              <a:t>DEPOSITION OF NEW CENPA CONTAINING NUCLEOSOMES AT THE CENTROMERE</a:t>
            </a:r>
          </a:p>
        </p:txBody>
      </p:sp>
      <p:sp>
        <p:nvSpPr>
          <p:cNvPr id="62" name="TextBox 61">
            <a:extLst>
              <a:ext uri="{FF2B5EF4-FFF2-40B4-BE49-F238E27FC236}">
                <a16:creationId xmlns:a16="http://schemas.microsoft.com/office/drawing/2014/main" id="{80534167-8835-3080-6BC0-874B75FC5538}"/>
              </a:ext>
            </a:extLst>
          </p:cNvPr>
          <p:cNvSpPr txBox="1"/>
          <p:nvPr/>
        </p:nvSpPr>
        <p:spPr>
          <a:xfrm>
            <a:off x="4589843" y="3822396"/>
            <a:ext cx="657794" cy="153888"/>
          </a:xfrm>
          <a:prstGeom prst="rect">
            <a:avLst/>
          </a:prstGeom>
          <a:noFill/>
        </p:spPr>
        <p:txBody>
          <a:bodyPr wrap="square">
            <a:spAutoFit/>
          </a:bodyPr>
          <a:lstStyle/>
          <a:p>
            <a:pPr algn="r"/>
            <a:r>
              <a:rPr lang="en-GB" sz="400"/>
              <a:t>DNA REPLICATION</a:t>
            </a:r>
          </a:p>
        </p:txBody>
      </p:sp>
      <p:sp>
        <p:nvSpPr>
          <p:cNvPr id="63" name="TextBox 62">
            <a:extLst>
              <a:ext uri="{FF2B5EF4-FFF2-40B4-BE49-F238E27FC236}">
                <a16:creationId xmlns:a16="http://schemas.microsoft.com/office/drawing/2014/main" id="{60A1EE0C-8322-EB12-8672-31278A867220}"/>
              </a:ext>
            </a:extLst>
          </p:cNvPr>
          <p:cNvSpPr txBox="1"/>
          <p:nvPr/>
        </p:nvSpPr>
        <p:spPr>
          <a:xfrm>
            <a:off x="4444686" y="3878946"/>
            <a:ext cx="802951" cy="153888"/>
          </a:xfrm>
          <a:prstGeom prst="rect">
            <a:avLst/>
          </a:prstGeom>
          <a:noFill/>
        </p:spPr>
        <p:txBody>
          <a:bodyPr wrap="square">
            <a:spAutoFit/>
          </a:bodyPr>
          <a:lstStyle/>
          <a:p>
            <a:pPr algn="r"/>
            <a:r>
              <a:rPr lang="en-GB" sz="400"/>
              <a:t>MEIOTIC RECOMBINATION</a:t>
            </a:r>
          </a:p>
        </p:txBody>
      </p:sp>
      <p:sp>
        <p:nvSpPr>
          <p:cNvPr id="320" name="TextBox 319">
            <a:extLst>
              <a:ext uri="{FF2B5EF4-FFF2-40B4-BE49-F238E27FC236}">
                <a16:creationId xmlns:a16="http://schemas.microsoft.com/office/drawing/2014/main" id="{955A3E79-06BE-828F-EF02-F9C56475F3F9}"/>
              </a:ext>
            </a:extLst>
          </p:cNvPr>
          <p:cNvSpPr txBox="1"/>
          <p:nvPr/>
        </p:nvSpPr>
        <p:spPr>
          <a:xfrm>
            <a:off x="3946710" y="3932138"/>
            <a:ext cx="1300927" cy="153888"/>
          </a:xfrm>
          <a:prstGeom prst="rect">
            <a:avLst/>
          </a:prstGeom>
          <a:noFill/>
        </p:spPr>
        <p:txBody>
          <a:bodyPr wrap="square">
            <a:spAutoFit/>
          </a:bodyPr>
          <a:lstStyle/>
          <a:p>
            <a:pPr algn="r"/>
            <a:r>
              <a:rPr lang="en-GB" sz="400"/>
              <a:t>RESOLUTION OF SISTER CHROMATID COHESION</a:t>
            </a:r>
          </a:p>
        </p:txBody>
      </p:sp>
      <p:sp>
        <p:nvSpPr>
          <p:cNvPr id="321" name="TextBox 320">
            <a:extLst>
              <a:ext uri="{FF2B5EF4-FFF2-40B4-BE49-F238E27FC236}">
                <a16:creationId xmlns:a16="http://schemas.microsoft.com/office/drawing/2014/main" id="{2FBD0238-9070-B6B4-362C-67FBECAC1113}"/>
              </a:ext>
            </a:extLst>
          </p:cNvPr>
          <p:cNvSpPr txBox="1"/>
          <p:nvPr/>
        </p:nvSpPr>
        <p:spPr>
          <a:xfrm>
            <a:off x="4758907" y="3990601"/>
            <a:ext cx="488730" cy="153888"/>
          </a:xfrm>
          <a:prstGeom prst="rect">
            <a:avLst/>
          </a:prstGeom>
          <a:noFill/>
        </p:spPr>
        <p:txBody>
          <a:bodyPr wrap="square">
            <a:spAutoFit/>
          </a:bodyPr>
          <a:lstStyle/>
          <a:p>
            <a:pPr algn="r"/>
            <a:r>
              <a:rPr lang="en-GB" sz="400"/>
              <a:t>S PHASE</a:t>
            </a:r>
          </a:p>
        </p:txBody>
      </p:sp>
      <p:sp>
        <p:nvSpPr>
          <p:cNvPr id="322" name="TextBox 321">
            <a:extLst>
              <a:ext uri="{FF2B5EF4-FFF2-40B4-BE49-F238E27FC236}">
                <a16:creationId xmlns:a16="http://schemas.microsoft.com/office/drawing/2014/main" id="{12CBA125-A34F-DC1A-3D2E-C6C10A24A1E4}"/>
              </a:ext>
            </a:extLst>
          </p:cNvPr>
          <p:cNvSpPr txBox="1"/>
          <p:nvPr/>
        </p:nvSpPr>
        <p:spPr>
          <a:xfrm>
            <a:off x="3956542" y="4044832"/>
            <a:ext cx="1291095" cy="153888"/>
          </a:xfrm>
          <a:prstGeom prst="rect">
            <a:avLst/>
          </a:prstGeom>
          <a:noFill/>
        </p:spPr>
        <p:txBody>
          <a:bodyPr wrap="square">
            <a:spAutoFit/>
          </a:bodyPr>
          <a:lstStyle/>
          <a:p>
            <a:pPr algn="r"/>
            <a:r>
              <a:rPr lang="en-GB" sz="400"/>
              <a:t>MITOTIC G1 PHASE AND G1 S TRANSITION</a:t>
            </a:r>
          </a:p>
        </p:txBody>
      </p:sp>
      <p:sp>
        <p:nvSpPr>
          <p:cNvPr id="323" name="TextBox 322">
            <a:extLst>
              <a:ext uri="{FF2B5EF4-FFF2-40B4-BE49-F238E27FC236}">
                <a16:creationId xmlns:a16="http://schemas.microsoft.com/office/drawing/2014/main" id="{A58994EE-02B3-2566-E3F9-0C0C8DC7C98C}"/>
              </a:ext>
            </a:extLst>
          </p:cNvPr>
          <p:cNvSpPr txBox="1"/>
          <p:nvPr/>
        </p:nvSpPr>
        <p:spPr>
          <a:xfrm>
            <a:off x="4539475" y="4098024"/>
            <a:ext cx="708162" cy="153888"/>
          </a:xfrm>
          <a:prstGeom prst="rect">
            <a:avLst/>
          </a:prstGeom>
          <a:noFill/>
        </p:spPr>
        <p:txBody>
          <a:bodyPr wrap="square">
            <a:spAutoFit/>
          </a:bodyPr>
          <a:lstStyle/>
          <a:p>
            <a:pPr algn="r"/>
            <a:r>
              <a:rPr lang="en-GB" sz="400"/>
              <a:t>BASE EXCISION REPAIR</a:t>
            </a:r>
          </a:p>
        </p:txBody>
      </p:sp>
      <p:sp>
        <p:nvSpPr>
          <p:cNvPr id="324" name="TextBox 323">
            <a:extLst>
              <a:ext uri="{FF2B5EF4-FFF2-40B4-BE49-F238E27FC236}">
                <a16:creationId xmlns:a16="http://schemas.microsoft.com/office/drawing/2014/main" id="{CEE0143F-DD20-6BB5-80A4-2EDBDAD6F9C1}"/>
              </a:ext>
            </a:extLst>
          </p:cNvPr>
          <p:cNvSpPr txBox="1"/>
          <p:nvPr/>
        </p:nvSpPr>
        <p:spPr>
          <a:xfrm>
            <a:off x="3721195" y="4155802"/>
            <a:ext cx="1526442" cy="153888"/>
          </a:xfrm>
          <a:prstGeom prst="rect">
            <a:avLst/>
          </a:prstGeom>
          <a:noFill/>
        </p:spPr>
        <p:txBody>
          <a:bodyPr wrap="square">
            <a:spAutoFit/>
          </a:bodyPr>
          <a:lstStyle/>
          <a:p>
            <a:pPr algn="r"/>
            <a:r>
              <a:rPr lang="en-GB" sz="400"/>
              <a:t>CONDENSATION OF PROPHASE CHROMOSOMES</a:t>
            </a:r>
          </a:p>
        </p:txBody>
      </p:sp>
      <p:sp>
        <p:nvSpPr>
          <p:cNvPr id="325" name="TextBox 324">
            <a:extLst>
              <a:ext uri="{FF2B5EF4-FFF2-40B4-BE49-F238E27FC236}">
                <a16:creationId xmlns:a16="http://schemas.microsoft.com/office/drawing/2014/main" id="{21E338FE-03EF-A66D-899A-AF3BEC4862BF}"/>
              </a:ext>
            </a:extLst>
          </p:cNvPr>
          <p:cNvSpPr txBox="1"/>
          <p:nvPr/>
        </p:nvSpPr>
        <p:spPr>
          <a:xfrm>
            <a:off x="4472265" y="4210718"/>
            <a:ext cx="775372" cy="153888"/>
          </a:xfrm>
          <a:prstGeom prst="rect">
            <a:avLst/>
          </a:prstGeom>
          <a:noFill/>
        </p:spPr>
        <p:txBody>
          <a:bodyPr wrap="square">
            <a:spAutoFit/>
          </a:bodyPr>
          <a:lstStyle/>
          <a:p>
            <a:pPr algn="r"/>
            <a:r>
              <a:rPr lang="en-GB" sz="400"/>
              <a:t>TELOMERE MAINTENANCE</a:t>
            </a:r>
          </a:p>
        </p:txBody>
      </p:sp>
      <p:sp>
        <p:nvSpPr>
          <p:cNvPr id="332" name="TextBox 331">
            <a:extLst>
              <a:ext uri="{FF2B5EF4-FFF2-40B4-BE49-F238E27FC236}">
                <a16:creationId xmlns:a16="http://schemas.microsoft.com/office/drawing/2014/main" id="{CDD958A5-0AD6-1C46-915D-FAA36ED479A6}"/>
              </a:ext>
            </a:extLst>
          </p:cNvPr>
          <p:cNvSpPr txBox="1"/>
          <p:nvPr/>
        </p:nvSpPr>
        <p:spPr>
          <a:xfrm>
            <a:off x="5674495" y="2902134"/>
            <a:ext cx="261522" cy="153888"/>
          </a:xfrm>
          <a:prstGeom prst="rect">
            <a:avLst/>
          </a:prstGeom>
          <a:noFill/>
        </p:spPr>
        <p:txBody>
          <a:bodyPr wrap="square">
            <a:spAutoFit/>
          </a:bodyPr>
          <a:lstStyle/>
          <a:p>
            <a:r>
              <a:rPr lang="en-GB" sz="400"/>
              <a:t>686</a:t>
            </a:r>
          </a:p>
        </p:txBody>
      </p:sp>
      <p:sp>
        <p:nvSpPr>
          <p:cNvPr id="333" name="TextBox 332">
            <a:extLst>
              <a:ext uri="{FF2B5EF4-FFF2-40B4-BE49-F238E27FC236}">
                <a16:creationId xmlns:a16="http://schemas.microsoft.com/office/drawing/2014/main" id="{4282B94D-6D00-01E9-6DF7-FBF2B03D7578}"/>
              </a:ext>
            </a:extLst>
          </p:cNvPr>
          <p:cNvSpPr txBox="1"/>
          <p:nvPr/>
        </p:nvSpPr>
        <p:spPr>
          <a:xfrm>
            <a:off x="5674495" y="2954186"/>
            <a:ext cx="261522" cy="153888"/>
          </a:xfrm>
          <a:prstGeom prst="rect">
            <a:avLst/>
          </a:prstGeom>
          <a:noFill/>
        </p:spPr>
        <p:txBody>
          <a:bodyPr wrap="square">
            <a:spAutoFit/>
          </a:bodyPr>
          <a:lstStyle/>
          <a:p>
            <a:r>
              <a:rPr lang="en-GB" sz="400"/>
              <a:t>554</a:t>
            </a:r>
          </a:p>
        </p:txBody>
      </p:sp>
      <p:sp>
        <p:nvSpPr>
          <p:cNvPr id="335" name="TextBox 334">
            <a:extLst>
              <a:ext uri="{FF2B5EF4-FFF2-40B4-BE49-F238E27FC236}">
                <a16:creationId xmlns:a16="http://schemas.microsoft.com/office/drawing/2014/main" id="{C9FEFA27-B085-F340-7F63-40067B16D884}"/>
              </a:ext>
            </a:extLst>
          </p:cNvPr>
          <p:cNvSpPr txBox="1"/>
          <p:nvPr/>
        </p:nvSpPr>
        <p:spPr>
          <a:xfrm>
            <a:off x="5674495" y="3010883"/>
            <a:ext cx="261522" cy="153888"/>
          </a:xfrm>
          <a:prstGeom prst="rect">
            <a:avLst/>
          </a:prstGeom>
          <a:noFill/>
        </p:spPr>
        <p:txBody>
          <a:bodyPr wrap="square">
            <a:spAutoFit/>
          </a:bodyPr>
          <a:lstStyle/>
          <a:p>
            <a:r>
              <a:rPr lang="en-GB" sz="400"/>
              <a:t>200</a:t>
            </a:r>
          </a:p>
        </p:txBody>
      </p:sp>
      <p:sp>
        <p:nvSpPr>
          <p:cNvPr id="336" name="TextBox 335">
            <a:extLst>
              <a:ext uri="{FF2B5EF4-FFF2-40B4-BE49-F238E27FC236}">
                <a16:creationId xmlns:a16="http://schemas.microsoft.com/office/drawing/2014/main" id="{75B76E55-8702-AD9A-BD78-B93E48CC23F6}"/>
              </a:ext>
            </a:extLst>
          </p:cNvPr>
          <p:cNvSpPr txBox="1"/>
          <p:nvPr/>
        </p:nvSpPr>
        <p:spPr>
          <a:xfrm>
            <a:off x="5674495" y="3058880"/>
            <a:ext cx="261522" cy="153888"/>
          </a:xfrm>
          <a:prstGeom prst="rect">
            <a:avLst/>
          </a:prstGeom>
          <a:noFill/>
        </p:spPr>
        <p:txBody>
          <a:bodyPr wrap="square">
            <a:spAutoFit/>
          </a:bodyPr>
          <a:lstStyle/>
          <a:p>
            <a:r>
              <a:rPr lang="en-GB" sz="400"/>
              <a:t>200</a:t>
            </a:r>
          </a:p>
        </p:txBody>
      </p:sp>
      <p:sp>
        <p:nvSpPr>
          <p:cNvPr id="337" name="TextBox 336">
            <a:extLst>
              <a:ext uri="{FF2B5EF4-FFF2-40B4-BE49-F238E27FC236}">
                <a16:creationId xmlns:a16="http://schemas.microsoft.com/office/drawing/2014/main" id="{FC71A8BF-61E2-34BF-1878-066EAC4E8564}"/>
              </a:ext>
            </a:extLst>
          </p:cNvPr>
          <p:cNvSpPr txBox="1"/>
          <p:nvPr/>
        </p:nvSpPr>
        <p:spPr>
          <a:xfrm>
            <a:off x="5674495" y="3113387"/>
            <a:ext cx="261522" cy="153888"/>
          </a:xfrm>
          <a:prstGeom prst="rect">
            <a:avLst/>
          </a:prstGeom>
          <a:noFill/>
        </p:spPr>
        <p:txBody>
          <a:bodyPr wrap="square">
            <a:spAutoFit/>
          </a:bodyPr>
          <a:lstStyle/>
          <a:p>
            <a:r>
              <a:rPr lang="en-GB" sz="400"/>
              <a:t>290</a:t>
            </a:r>
          </a:p>
        </p:txBody>
      </p:sp>
      <p:sp>
        <p:nvSpPr>
          <p:cNvPr id="338" name="TextBox 337">
            <a:extLst>
              <a:ext uri="{FF2B5EF4-FFF2-40B4-BE49-F238E27FC236}">
                <a16:creationId xmlns:a16="http://schemas.microsoft.com/office/drawing/2014/main" id="{74385C25-46FB-1C35-E67A-22702AAA9188}"/>
              </a:ext>
            </a:extLst>
          </p:cNvPr>
          <p:cNvSpPr txBox="1"/>
          <p:nvPr/>
        </p:nvSpPr>
        <p:spPr>
          <a:xfrm>
            <a:off x="5674495" y="3170752"/>
            <a:ext cx="261522" cy="153888"/>
          </a:xfrm>
          <a:prstGeom prst="rect">
            <a:avLst/>
          </a:prstGeom>
          <a:noFill/>
        </p:spPr>
        <p:txBody>
          <a:bodyPr wrap="square">
            <a:spAutoFit/>
          </a:bodyPr>
          <a:lstStyle/>
          <a:p>
            <a:r>
              <a:rPr lang="en-GB" sz="400"/>
              <a:t>200</a:t>
            </a:r>
          </a:p>
        </p:txBody>
      </p:sp>
      <p:sp>
        <p:nvSpPr>
          <p:cNvPr id="339" name="TextBox 338">
            <a:extLst>
              <a:ext uri="{FF2B5EF4-FFF2-40B4-BE49-F238E27FC236}">
                <a16:creationId xmlns:a16="http://schemas.microsoft.com/office/drawing/2014/main" id="{C8CF8F95-673F-B221-459E-D858748B364D}"/>
              </a:ext>
            </a:extLst>
          </p:cNvPr>
          <p:cNvSpPr txBox="1"/>
          <p:nvPr/>
        </p:nvSpPr>
        <p:spPr>
          <a:xfrm>
            <a:off x="5674495" y="3229111"/>
            <a:ext cx="261522" cy="153888"/>
          </a:xfrm>
          <a:prstGeom prst="rect">
            <a:avLst/>
          </a:prstGeom>
          <a:noFill/>
        </p:spPr>
        <p:txBody>
          <a:bodyPr wrap="square">
            <a:spAutoFit/>
          </a:bodyPr>
          <a:lstStyle/>
          <a:p>
            <a:r>
              <a:rPr lang="en-GB" sz="400"/>
              <a:t>200</a:t>
            </a:r>
          </a:p>
        </p:txBody>
      </p:sp>
      <p:sp>
        <p:nvSpPr>
          <p:cNvPr id="340" name="TextBox 339">
            <a:extLst>
              <a:ext uri="{FF2B5EF4-FFF2-40B4-BE49-F238E27FC236}">
                <a16:creationId xmlns:a16="http://schemas.microsoft.com/office/drawing/2014/main" id="{131C1213-F773-9A0A-D21E-47ACA826DEFB}"/>
              </a:ext>
            </a:extLst>
          </p:cNvPr>
          <p:cNvSpPr txBox="1"/>
          <p:nvPr/>
        </p:nvSpPr>
        <p:spPr>
          <a:xfrm>
            <a:off x="5674495" y="3285155"/>
            <a:ext cx="261522" cy="153888"/>
          </a:xfrm>
          <a:prstGeom prst="rect">
            <a:avLst/>
          </a:prstGeom>
          <a:noFill/>
        </p:spPr>
        <p:txBody>
          <a:bodyPr wrap="square">
            <a:spAutoFit/>
          </a:bodyPr>
          <a:lstStyle/>
          <a:p>
            <a:r>
              <a:rPr lang="en-GB" sz="400"/>
              <a:t>410</a:t>
            </a:r>
          </a:p>
        </p:txBody>
      </p:sp>
      <p:sp>
        <p:nvSpPr>
          <p:cNvPr id="341" name="TextBox 340">
            <a:extLst>
              <a:ext uri="{FF2B5EF4-FFF2-40B4-BE49-F238E27FC236}">
                <a16:creationId xmlns:a16="http://schemas.microsoft.com/office/drawing/2014/main" id="{4A0BD3C0-DECB-ECE9-E7B8-A703091FC46E}"/>
              </a:ext>
            </a:extLst>
          </p:cNvPr>
          <p:cNvSpPr txBox="1"/>
          <p:nvPr/>
        </p:nvSpPr>
        <p:spPr>
          <a:xfrm>
            <a:off x="5674495" y="3336929"/>
            <a:ext cx="261522" cy="153888"/>
          </a:xfrm>
          <a:prstGeom prst="rect">
            <a:avLst/>
          </a:prstGeom>
          <a:noFill/>
        </p:spPr>
        <p:txBody>
          <a:bodyPr wrap="square">
            <a:spAutoFit/>
          </a:bodyPr>
          <a:lstStyle/>
          <a:p>
            <a:r>
              <a:rPr lang="en-GB" sz="400"/>
              <a:t>166</a:t>
            </a:r>
          </a:p>
        </p:txBody>
      </p:sp>
      <p:sp>
        <p:nvSpPr>
          <p:cNvPr id="342" name="TextBox 341">
            <a:extLst>
              <a:ext uri="{FF2B5EF4-FFF2-40B4-BE49-F238E27FC236}">
                <a16:creationId xmlns:a16="http://schemas.microsoft.com/office/drawing/2014/main" id="{FEC344F9-BD5C-068E-CE86-04A817BA42C7}"/>
              </a:ext>
            </a:extLst>
          </p:cNvPr>
          <p:cNvSpPr txBox="1"/>
          <p:nvPr/>
        </p:nvSpPr>
        <p:spPr>
          <a:xfrm>
            <a:off x="5674495" y="3390631"/>
            <a:ext cx="261522" cy="153888"/>
          </a:xfrm>
          <a:prstGeom prst="rect">
            <a:avLst/>
          </a:prstGeom>
          <a:noFill/>
        </p:spPr>
        <p:txBody>
          <a:bodyPr wrap="square">
            <a:spAutoFit/>
          </a:bodyPr>
          <a:lstStyle/>
          <a:p>
            <a:r>
              <a:rPr lang="en-GB" sz="400"/>
              <a:t>136</a:t>
            </a:r>
          </a:p>
        </p:txBody>
      </p:sp>
      <p:sp>
        <p:nvSpPr>
          <p:cNvPr id="343" name="TextBox 342">
            <a:extLst>
              <a:ext uri="{FF2B5EF4-FFF2-40B4-BE49-F238E27FC236}">
                <a16:creationId xmlns:a16="http://schemas.microsoft.com/office/drawing/2014/main" id="{02B8D4FD-AFD8-3C3D-B11B-1E004426114B}"/>
              </a:ext>
            </a:extLst>
          </p:cNvPr>
          <p:cNvSpPr txBox="1"/>
          <p:nvPr/>
        </p:nvSpPr>
        <p:spPr>
          <a:xfrm>
            <a:off x="5674495" y="3448801"/>
            <a:ext cx="261522" cy="153888"/>
          </a:xfrm>
          <a:prstGeom prst="rect">
            <a:avLst/>
          </a:prstGeom>
          <a:noFill/>
        </p:spPr>
        <p:txBody>
          <a:bodyPr wrap="square">
            <a:spAutoFit/>
          </a:bodyPr>
          <a:lstStyle/>
          <a:p>
            <a:r>
              <a:rPr lang="en-GB" sz="400"/>
              <a:t>135</a:t>
            </a:r>
          </a:p>
        </p:txBody>
      </p:sp>
      <p:sp>
        <p:nvSpPr>
          <p:cNvPr id="344" name="TextBox 343">
            <a:extLst>
              <a:ext uri="{FF2B5EF4-FFF2-40B4-BE49-F238E27FC236}">
                <a16:creationId xmlns:a16="http://schemas.microsoft.com/office/drawing/2014/main" id="{30F5AA26-BE8E-5FD8-51C2-083CF1E72F79}"/>
              </a:ext>
            </a:extLst>
          </p:cNvPr>
          <p:cNvSpPr txBox="1"/>
          <p:nvPr/>
        </p:nvSpPr>
        <p:spPr>
          <a:xfrm>
            <a:off x="5674495" y="3499546"/>
            <a:ext cx="261522" cy="153888"/>
          </a:xfrm>
          <a:prstGeom prst="rect">
            <a:avLst/>
          </a:prstGeom>
          <a:noFill/>
        </p:spPr>
        <p:txBody>
          <a:bodyPr wrap="square">
            <a:spAutoFit/>
          </a:bodyPr>
          <a:lstStyle/>
          <a:p>
            <a:r>
              <a:rPr lang="en-GB" sz="400"/>
              <a:t>202</a:t>
            </a:r>
          </a:p>
        </p:txBody>
      </p:sp>
      <p:sp>
        <p:nvSpPr>
          <p:cNvPr id="345" name="TextBox 344">
            <a:extLst>
              <a:ext uri="{FF2B5EF4-FFF2-40B4-BE49-F238E27FC236}">
                <a16:creationId xmlns:a16="http://schemas.microsoft.com/office/drawing/2014/main" id="{55785445-C6DD-CA4B-6CFC-7DEADD124BBF}"/>
              </a:ext>
            </a:extLst>
          </p:cNvPr>
          <p:cNvSpPr txBox="1"/>
          <p:nvPr/>
        </p:nvSpPr>
        <p:spPr>
          <a:xfrm>
            <a:off x="5674495" y="3557529"/>
            <a:ext cx="261522" cy="153888"/>
          </a:xfrm>
          <a:prstGeom prst="rect">
            <a:avLst/>
          </a:prstGeom>
          <a:noFill/>
        </p:spPr>
        <p:txBody>
          <a:bodyPr wrap="square">
            <a:spAutoFit/>
          </a:bodyPr>
          <a:lstStyle/>
          <a:p>
            <a:r>
              <a:rPr lang="en-GB" sz="400"/>
              <a:t>164</a:t>
            </a:r>
          </a:p>
        </p:txBody>
      </p:sp>
      <p:sp>
        <p:nvSpPr>
          <p:cNvPr id="346" name="TextBox 345">
            <a:extLst>
              <a:ext uri="{FF2B5EF4-FFF2-40B4-BE49-F238E27FC236}">
                <a16:creationId xmlns:a16="http://schemas.microsoft.com/office/drawing/2014/main" id="{99E6679D-DA4B-6CBD-748F-1B7D57ACBA39}"/>
              </a:ext>
            </a:extLst>
          </p:cNvPr>
          <p:cNvSpPr txBox="1"/>
          <p:nvPr/>
        </p:nvSpPr>
        <p:spPr>
          <a:xfrm>
            <a:off x="5674495" y="3610779"/>
            <a:ext cx="261522" cy="153888"/>
          </a:xfrm>
          <a:prstGeom prst="rect">
            <a:avLst/>
          </a:prstGeom>
          <a:noFill/>
        </p:spPr>
        <p:txBody>
          <a:bodyPr wrap="square">
            <a:spAutoFit/>
          </a:bodyPr>
          <a:lstStyle/>
          <a:p>
            <a:r>
              <a:rPr lang="en-GB" sz="400"/>
              <a:t>32</a:t>
            </a:r>
          </a:p>
        </p:txBody>
      </p:sp>
      <p:sp>
        <p:nvSpPr>
          <p:cNvPr id="347" name="TextBox 346">
            <a:extLst>
              <a:ext uri="{FF2B5EF4-FFF2-40B4-BE49-F238E27FC236}">
                <a16:creationId xmlns:a16="http://schemas.microsoft.com/office/drawing/2014/main" id="{E69010B1-2174-17A9-93BF-CFC924B62212}"/>
              </a:ext>
            </a:extLst>
          </p:cNvPr>
          <p:cNvSpPr txBox="1"/>
          <p:nvPr/>
        </p:nvSpPr>
        <p:spPr>
          <a:xfrm>
            <a:off x="5674495" y="3667498"/>
            <a:ext cx="261522" cy="153888"/>
          </a:xfrm>
          <a:prstGeom prst="rect">
            <a:avLst/>
          </a:prstGeom>
          <a:noFill/>
        </p:spPr>
        <p:txBody>
          <a:bodyPr wrap="square">
            <a:spAutoFit/>
          </a:bodyPr>
          <a:lstStyle/>
          <a:p>
            <a:r>
              <a:rPr lang="en-GB" sz="400"/>
              <a:t>328</a:t>
            </a:r>
          </a:p>
        </p:txBody>
      </p:sp>
      <p:sp>
        <p:nvSpPr>
          <p:cNvPr id="348" name="TextBox 347">
            <a:extLst>
              <a:ext uri="{FF2B5EF4-FFF2-40B4-BE49-F238E27FC236}">
                <a16:creationId xmlns:a16="http://schemas.microsoft.com/office/drawing/2014/main" id="{BF8F40A6-7002-12C8-7DB4-92D079227193}"/>
              </a:ext>
            </a:extLst>
          </p:cNvPr>
          <p:cNvSpPr txBox="1"/>
          <p:nvPr/>
        </p:nvSpPr>
        <p:spPr>
          <a:xfrm>
            <a:off x="5674495" y="3719263"/>
            <a:ext cx="261522" cy="153888"/>
          </a:xfrm>
          <a:prstGeom prst="rect">
            <a:avLst/>
          </a:prstGeom>
          <a:noFill/>
        </p:spPr>
        <p:txBody>
          <a:bodyPr wrap="square">
            <a:spAutoFit/>
          </a:bodyPr>
          <a:lstStyle/>
          <a:p>
            <a:r>
              <a:rPr lang="en-GB" sz="400"/>
              <a:t>317</a:t>
            </a:r>
          </a:p>
        </p:txBody>
      </p:sp>
      <p:sp>
        <p:nvSpPr>
          <p:cNvPr id="349" name="TextBox 348">
            <a:extLst>
              <a:ext uri="{FF2B5EF4-FFF2-40B4-BE49-F238E27FC236}">
                <a16:creationId xmlns:a16="http://schemas.microsoft.com/office/drawing/2014/main" id="{1581E613-C731-B235-7EEC-44EDA6A148EC}"/>
              </a:ext>
            </a:extLst>
          </p:cNvPr>
          <p:cNvSpPr txBox="1"/>
          <p:nvPr/>
        </p:nvSpPr>
        <p:spPr>
          <a:xfrm>
            <a:off x="5674495" y="3775781"/>
            <a:ext cx="261522" cy="153888"/>
          </a:xfrm>
          <a:prstGeom prst="rect">
            <a:avLst/>
          </a:prstGeom>
          <a:noFill/>
        </p:spPr>
        <p:txBody>
          <a:bodyPr wrap="square">
            <a:spAutoFit/>
          </a:bodyPr>
          <a:lstStyle/>
          <a:p>
            <a:r>
              <a:rPr lang="en-GB" sz="400"/>
              <a:t>70</a:t>
            </a:r>
          </a:p>
        </p:txBody>
      </p:sp>
      <p:sp>
        <p:nvSpPr>
          <p:cNvPr id="350" name="TextBox 349">
            <a:extLst>
              <a:ext uri="{FF2B5EF4-FFF2-40B4-BE49-F238E27FC236}">
                <a16:creationId xmlns:a16="http://schemas.microsoft.com/office/drawing/2014/main" id="{8C1AA41A-01BF-7136-5B5F-A6454B6A02F2}"/>
              </a:ext>
            </a:extLst>
          </p:cNvPr>
          <p:cNvSpPr txBox="1"/>
          <p:nvPr/>
        </p:nvSpPr>
        <p:spPr>
          <a:xfrm>
            <a:off x="5674495" y="3821751"/>
            <a:ext cx="261522" cy="153888"/>
          </a:xfrm>
          <a:prstGeom prst="rect">
            <a:avLst/>
          </a:prstGeom>
          <a:noFill/>
        </p:spPr>
        <p:txBody>
          <a:bodyPr wrap="square">
            <a:spAutoFit/>
          </a:bodyPr>
          <a:lstStyle/>
          <a:p>
            <a:r>
              <a:rPr lang="en-GB" sz="400"/>
              <a:t>128</a:t>
            </a:r>
          </a:p>
        </p:txBody>
      </p:sp>
      <p:sp>
        <p:nvSpPr>
          <p:cNvPr id="351" name="TextBox 350">
            <a:extLst>
              <a:ext uri="{FF2B5EF4-FFF2-40B4-BE49-F238E27FC236}">
                <a16:creationId xmlns:a16="http://schemas.microsoft.com/office/drawing/2014/main" id="{2219B49C-0C03-C723-9B42-8C2635243B42}"/>
              </a:ext>
            </a:extLst>
          </p:cNvPr>
          <p:cNvSpPr txBox="1"/>
          <p:nvPr/>
        </p:nvSpPr>
        <p:spPr>
          <a:xfrm>
            <a:off x="5674495" y="3881265"/>
            <a:ext cx="261522" cy="153888"/>
          </a:xfrm>
          <a:prstGeom prst="rect">
            <a:avLst/>
          </a:prstGeom>
          <a:noFill/>
        </p:spPr>
        <p:txBody>
          <a:bodyPr wrap="square">
            <a:spAutoFit/>
          </a:bodyPr>
          <a:lstStyle/>
          <a:p>
            <a:r>
              <a:rPr lang="en-GB" sz="400"/>
              <a:t>81</a:t>
            </a:r>
          </a:p>
        </p:txBody>
      </p:sp>
      <p:sp>
        <p:nvSpPr>
          <p:cNvPr id="352" name="TextBox 351">
            <a:extLst>
              <a:ext uri="{FF2B5EF4-FFF2-40B4-BE49-F238E27FC236}">
                <a16:creationId xmlns:a16="http://schemas.microsoft.com/office/drawing/2014/main" id="{644F64E2-C4A1-EEF1-02F8-0D306895989A}"/>
              </a:ext>
            </a:extLst>
          </p:cNvPr>
          <p:cNvSpPr txBox="1"/>
          <p:nvPr/>
        </p:nvSpPr>
        <p:spPr>
          <a:xfrm>
            <a:off x="5674495" y="3931264"/>
            <a:ext cx="261522" cy="153888"/>
          </a:xfrm>
          <a:prstGeom prst="rect">
            <a:avLst/>
          </a:prstGeom>
          <a:noFill/>
        </p:spPr>
        <p:txBody>
          <a:bodyPr wrap="square">
            <a:spAutoFit/>
          </a:bodyPr>
          <a:lstStyle/>
          <a:p>
            <a:r>
              <a:rPr lang="en-GB" sz="400"/>
              <a:t>125</a:t>
            </a:r>
          </a:p>
        </p:txBody>
      </p:sp>
      <p:sp>
        <p:nvSpPr>
          <p:cNvPr id="353" name="TextBox 352">
            <a:extLst>
              <a:ext uri="{FF2B5EF4-FFF2-40B4-BE49-F238E27FC236}">
                <a16:creationId xmlns:a16="http://schemas.microsoft.com/office/drawing/2014/main" id="{33A5AB3E-B952-EBBC-D6DB-BA8B938BAAA9}"/>
              </a:ext>
            </a:extLst>
          </p:cNvPr>
          <p:cNvSpPr txBox="1"/>
          <p:nvPr/>
        </p:nvSpPr>
        <p:spPr>
          <a:xfrm>
            <a:off x="5674495" y="3989760"/>
            <a:ext cx="261522" cy="153888"/>
          </a:xfrm>
          <a:prstGeom prst="rect">
            <a:avLst/>
          </a:prstGeom>
          <a:noFill/>
        </p:spPr>
        <p:txBody>
          <a:bodyPr wrap="square">
            <a:spAutoFit/>
          </a:bodyPr>
          <a:lstStyle/>
          <a:p>
            <a:r>
              <a:rPr lang="en-GB" sz="400"/>
              <a:t>162</a:t>
            </a:r>
          </a:p>
        </p:txBody>
      </p:sp>
      <p:sp>
        <p:nvSpPr>
          <p:cNvPr id="354" name="TextBox 353">
            <a:extLst>
              <a:ext uri="{FF2B5EF4-FFF2-40B4-BE49-F238E27FC236}">
                <a16:creationId xmlns:a16="http://schemas.microsoft.com/office/drawing/2014/main" id="{84B1DB04-D374-4B44-19EF-42F1CE67CB36}"/>
              </a:ext>
            </a:extLst>
          </p:cNvPr>
          <p:cNvSpPr txBox="1"/>
          <p:nvPr/>
        </p:nvSpPr>
        <p:spPr>
          <a:xfrm>
            <a:off x="5674495" y="4052008"/>
            <a:ext cx="261522" cy="153888"/>
          </a:xfrm>
          <a:prstGeom prst="rect">
            <a:avLst/>
          </a:prstGeom>
          <a:noFill/>
        </p:spPr>
        <p:txBody>
          <a:bodyPr wrap="square">
            <a:spAutoFit/>
          </a:bodyPr>
          <a:lstStyle/>
          <a:p>
            <a:r>
              <a:rPr lang="en-GB" sz="400"/>
              <a:t>149</a:t>
            </a:r>
          </a:p>
        </p:txBody>
      </p:sp>
      <p:sp>
        <p:nvSpPr>
          <p:cNvPr id="355" name="TextBox 354">
            <a:extLst>
              <a:ext uri="{FF2B5EF4-FFF2-40B4-BE49-F238E27FC236}">
                <a16:creationId xmlns:a16="http://schemas.microsoft.com/office/drawing/2014/main" id="{66B33BC7-4811-D623-051B-EE2666AB7726}"/>
              </a:ext>
            </a:extLst>
          </p:cNvPr>
          <p:cNvSpPr txBox="1"/>
          <p:nvPr/>
        </p:nvSpPr>
        <p:spPr>
          <a:xfrm>
            <a:off x="5674495" y="4103214"/>
            <a:ext cx="261522" cy="153888"/>
          </a:xfrm>
          <a:prstGeom prst="rect">
            <a:avLst/>
          </a:prstGeom>
          <a:noFill/>
        </p:spPr>
        <p:txBody>
          <a:bodyPr wrap="square">
            <a:spAutoFit/>
          </a:bodyPr>
          <a:lstStyle/>
          <a:p>
            <a:r>
              <a:rPr lang="en-GB" sz="400"/>
              <a:t>88</a:t>
            </a:r>
          </a:p>
        </p:txBody>
      </p:sp>
      <p:sp>
        <p:nvSpPr>
          <p:cNvPr id="356" name="TextBox 355">
            <a:extLst>
              <a:ext uri="{FF2B5EF4-FFF2-40B4-BE49-F238E27FC236}">
                <a16:creationId xmlns:a16="http://schemas.microsoft.com/office/drawing/2014/main" id="{8FB60427-1E94-649F-955E-CC9432402BA2}"/>
              </a:ext>
            </a:extLst>
          </p:cNvPr>
          <p:cNvSpPr txBox="1"/>
          <p:nvPr/>
        </p:nvSpPr>
        <p:spPr>
          <a:xfrm>
            <a:off x="5674495" y="4153438"/>
            <a:ext cx="261522" cy="153888"/>
          </a:xfrm>
          <a:prstGeom prst="rect">
            <a:avLst/>
          </a:prstGeom>
          <a:noFill/>
        </p:spPr>
        <p:txBody>
          <a:bodyPr wrap="square">
            <a:spAutoFit/>
          </a:bodyPr>
          <a:lstStyle/>
          <a:p>
            <a:r>
              <a:rPr lang="en-GB" sz="400"/>
              <a:t>68</a:t>
            </a:r>
          </a:p>
        </p:txBody>
      </p:sp>
      <p:sp>
        <p:nvSpPr>
          <p:cNvPr id="357" name="TextBox 356">
            <a:extLst>
              <a:ext uri="{FF2B5EF4-FFF2-40B4-BE49-F238E27FC236}">
                <a16:creationId xmlns:a16="http://schemas.microsoft.com/office/drawing/2014/main" id="{FC284D50-2F2D-3C70-98C2-483477FA42B0}"/>
              </a:ext>
            </a:extLst>
          </p:cNvPr>
          <p:cNvSpPr txBox="1"/>
          <p:nvPr/>
        </p:nvSpPr>
        <p:spPr>
          <a:xfrm>
            <a:off x="5674495" y="4214275"/>
            <a:ext cx="261522" cy="153888"/>
          </a:xfrm>
          <a:prstGeom prst="rect">
            <a:avLst/>
          </a:prstGeom>
          <a:noFill/>
        </p:spPr>
        <p:txBody>
          <a:bodyPr wrap="square">
            <a:spAutoFit/>
          </a:bodyPr>
          <a:lstStyle/>
          <a:p>
            <a:r>
              <a:rPr lang="en-GB" sz="400"/>
              <a:t>109</a:t>
            </a:r>
          </a:p>
        </p:txBody>
      </p:sp>
      <p:sp>
        <p:nvSpPr>
          <p:cNvPr id="367" name="TextBox 366">
            <a:extLst>
              <a:ext uri="{FF2B5EF4-FFF2-40B4-BE49-F238E27FC236}">
                <a16:creationId xmlns:a16="http://schemas.microsoft.com/office/drawing/2014/main" id="{1BB2BCB9-4665-7C92-65BE-CC9560C4333D}"/>
              </a:ext>
            </a:extLst>
          </p:cNvPr>
          <p:cNvSpPr txBox="1"/>
          <p:nvPr/>
        </p:nvSpPr>
        <p:spPr>
          <a:xfrm>
            <a:off x="4443584" y="4527391"/>
            <a:ext cx="800637" cy="153888"/>
          </a:xfrm>
          <a:prstGeom prst="rect">
            <a:avLst/>
          </a:prstGeom>
          <a:noFill/>
        </p:spPr>
        <p:txBody>
          <a:bodyPr wrap="square" rtlCol="0">
            <a:spAutoFit/>
          </a:bodyPr>
          <a:lstStyle/>
          <a:p>
            <a:pPr algn="r"/>
            <a:r>
              <a:rPr lang="en-GB" sz="400"/>
              <a:t>TNFA SIGNALING VIA NFKB</a:t>
            </a:r>
          </a:p>
        </p:txBody>
      </p:sp>
      <p:sp>
        <p:nvSpPr>
          <p:cNvPr id="368" name="TextBox 367">
            <a:extLst>
              <a:ext uri="{FF2B5EF4-FFF2-40B4-BE49-F238E27FC236}">
                <a16:creationId xmlns:a16="http://schemas.microsoft.com/office/drawing/2014/main" id="{9FFD20FC-E946-1599-A1D4-2B14A85591EE}"/>
              </a:ext>
            </a:extLst>
          </p:cNvPr>
          <p:cNvSpPr txBox="1"/>
          <p:nvPr/>
        </p:nvSpPr>
        <p:spPr>
          <a:xfrm>
            <a:off x="4443584" y="4572683"/>
            <a:ext cx="800637" cy="153888"/>
          </a:xfrm>
          <a:prstGeom prst="rect">
            <a:avLst/>
          </a:prstGeom>
          <a:noFill/>
        </p:spPr>
        <p:txBody>
          <a:bodyPr wrap="square" rtlCol="0">
            <a:spAutoFit/>
          </a:bodyPr>
          <a:lstStyle/>
          <a:p>
            <a:pPr algn="r"/>
            <a:r>
              <a:rPr lang="en-GB" sz="400"/>
              <a:t>TGF BETA SIGNALING</a:t>
            </a:r>
          </a:p>
        </p:txBody>
      </p:sp>
      <p:grpSp>
        <p:nvGrpSpPr>
          <p:cNvPr id="373" name="Group 372">
            <a:extLst>
              <a:ext uri="{FF2B5EF4-FFF2-40B4-BE49-F238E27FC236}">
                <a16:creationId xmlns:a16="http://schemas.microsoft.com/office/drawing/2014/main" id="{35D91E4B-60C1-1299-639A-DA9708367D19}"/>
              </a:ext>
            </a:extLst>
          </p:cNvPr>
          <p:cNvGrpSpPr/>
          <p:nvPr/>
        </p:nvGrpSpPr>
        <p:grpSpPr>
          <a:xfrm>
            <a:off x="4709226" y="4417699"/>
            <a:ext cx="1238092" cy="308872"/>
            <a:chOff x="4709226" y="4417699"/>
            <a:chExt cx="1238092" cy="308872"/>
          </a:xfrm>
        </p:grpSpPr>
        <p:pic>
          <p:nvPicPr>
            <p:cNvPr id="45" name="Picture 44">
              <a:extLst>
                <a:ext uri="{FF2B5EF4-FFF2-40B4-BE49-F238E27FC236}">
                  <a16:creationId xmlns:a16="http://schemas.microsoft.com/office/drawing/2014/main" id="{5A1907BB-AEAF-32ED-DDB2-02F6D0D71735}"/>
                </a:ext>
              </a:extLst>
            </p:cNvPr>
            <p:cNvPicPr>
              <a:picLocks noChangeAspect="1"/>
            </p:cNvPicPr>
            <p:nvPr/>
          </p:nvPicPr>
          <p:blipFill rotWithShape="1">
            <a:blip r:embed="rId5"/>
            <a:srcRect r="73522" b="91110"/>
            <a:stretch/>
          </p:blipFill>
          <p:spPr>
            <a:xfrm>
              <a:off x="5151831" y="4446052"/>
              <a:ext cx="599726" cy="235799"/>
            </a:xfrm>
            <a:prstGeom prst="rect">
              <a:avLst/>
            </a:prstGeom>
          </p:spPr>
        </p:pic>
        <p:sp>
          <p:nvSpPr>
            <p:cNvPr id="365" name="TextBox 364">
              <a:extLst>
                <a:ext uri="{FF2B5EF4-FFF2-40B4-BE49-F238E27FC236}">
                  <a16:creationId xmlns:a16="http://schemas.microsoft.com/office/drawing/2014/main" id="{CBAF4C9C-269A-36FE-9E74-8BEA6159FEF5}"/>
                </a:ext>
              </a:extLst>
            </p:cNvPr>
            <p:cNvSpPr txBox="1"/>
            <p:nvPr/>
          </p:nvSpPr>
          <p:spPr>
            <a:xfrm>
              <a:off x="4712403" y="4423593"/>
              <a:ext cx="535234" cy="153888"/>
            </a:xfrm>
            <a:prstGeom prst="rect">
              <a:avLst/>
            </a:prstGeom>
            <a:noFill/>
          </p:spPr>
          <p:txBody>
            <a:bodyPr wrap="square" rtlCol="0">
              <a:spAutoFit/>
            </a:bodyPr>
            <a:lstStyle/>
            <a:p>
              <a:pPr algn="r"/>
              <a:r>
                <a:rPr lang="en-GB" sz="400"/>
                <a:t>P53 PATHWAY</a:t>
              </a:r>
            </a:p>
          </p:txBody>
        </p:sp>
        <p:sp>
          <p:nvSpPr>
            <p:cNvPr id="366" name="TextBox 365">
              <a:extLst>
                <a:ext uri="{FF2B5EF4-FFF2-40B4-BE49-F238E27FC236}">
                  <a16:creationId xmlns:a16="http://schemas.microsoft.com/office/drawing/2014/main" id="{A28C456D-693B-ED05-3FEE-3D55F9AB153C}"/>
                </a:ext>
              </a:extLst>
            </p:cNvPr>
            <p:cNvSpPr txBox="1"/>
            <p:nvPr/>
          </p:nvSpPr>
          <p:spPr>
            <a:xfrm>
              <a:off x="4709226" y="4474594"/>
              <a:ext cx="535234" cy="153888"/>
            </a:xfrm>
            <a:prstGeom prst="rect">
              <a:avLst/>
            </a:prstGeom>
            <a:noFill/>
          </p:spPr>
          <p:txBody>
            <a:bodyPr wrap="square" rtlCol="0">
              <a:spAutoFit/>
            </a:bodyPr>
            <a:lstStyle/>
            <a:p>
              <a:pPr algn="r"/>
              <a:r>
                <a:rPr lang="en-GB" sz="400"/>
                <a:t>MYOGENESIS</a:t>
              </a:r>
            </a:p>
          </p:txBody>
        </p:sp>
        <p:sp>
          <p:nvSpPr>
            <p:cNvPr id="369" name="TextBox 368">
              <a:extLst>
                <a:ext uri="{FF2B5EF4-FFF2-40B4-BE49-F238E27FC236}">
                  <a16:creationId xmlns:a16="http://schemas.microsoft.com/office/drawing/2014/main" id="{42EBA218-E695-48E0-4D61-2CC46D09F0EF}"/>
                </a:ext>
              </a:extLst>
            </p:cNvPr>
            <p:cNvSpPr txBox="1"/>
            <p:nvPr/>
          </p:nvSpPr>
          <p:spPr>
            <a:xfrm>
              <a:off x="5679342" y="4417699"/>
              <a:ext cx="261522" cy="153888"/>
            </a:xfrm>
            <a:prstGeom prst="rect">
              <a:avLst/>
            </a:prstGeom>
            <a:noFill/>
          </p:spPr>
          <p:txBody>
            <a:bodyPr wrap="square">
              <a:spAutoFit/>
            </a:bodyPr>
            <a:lstStyle/>
            <a:p>
              <a:r>
                <a:rPr lang="en-GB" sz="400"/>
                <a:t>200</a:t>
              </a:r>
            </a:p>
          </p:txBody>
        </p:sp>
        <p:sp>
          <p:nvSpPr>
            <p:cNvPr id="370" name="TextBox 369">
              <a:extLst>
                <a:ext uri="{FF2B5EF4-FFF2-40B4-BE49-F238E27FC236}">
                  <a16:creationId xmlns:a16="http://schemas.microsoft.com/office/drawing/2014/main" id="{AA728A0D-6807-DD81-9EC8-98DC16BF9708}"/>
                </a:ext>
              </a:extLst>
            </p:cNvPr>
            <p:cNvSpPr txBox="1"/>
            <p:nvPr/>
          </p:nvSpPr>
          <p:spPr>
            <a:xfrm>
              <a:off x="5678481" y="4469193"/>
              <a:ext cx="261522" cy="153888"/>
            </a:xfrm>
            <a:prstGeom prst="rect">
              <a:avLst/>
            </a:prstGeom>
            <a:noFill/>
          </p:spPr>
          <p:txBody>
            <a:bodyPr wrap="square">
              <a:spAutoFit/>
            </a:bodyPr>
            <a:lstStyle/>
            <a:p>
              <a:r>
                <a:rPr lang="en-GB" sz="400"/>
                <a:t>200</a:t>
              </a:r>
            </a:p>
          </p:txBody>
        </p:sp>
        <p:sp>
          <p:nvSpPr>
            <p:cNvPr id="371" name="TextBox 370">
              <a:extLst>
                <a:ext uri="{FF2B5EF4-FFF2-40B4-BE49-F238E27FC236}">
                  <a16:creationId xmlns:a16="http://schemas.microsoft.com/office/drawing/2014/main" id="{C0D36A63-3CE6-D13A-44CF-5B92A1120628}"/>
                </a:ext>
              </a:extLst>
            </p:cNvPr>
            <p:cNvSpPr txBox="1"/>
            <p:nvPr/>
          </p:nvSpPr>
          <p:spPr>
            <a:xfrm>
              <a:off x="5685796" y="4572683"/>
              <a:ext cx="261522" cy="153888"/>
            </a:xfrm>
            <a:prstGeom prst="rect">
              <a:avLst/>
            </a:prstGeom>
            <a:noFill/>
          </p:spPr>
          <p:txBody>
            <a:bodyPr wrap="square">
              <a:spAutoFit/>
            </a:bodyPr>
            <a:lstStyle/>
            <a:p>
              <a:r>
                <a:rPr lang="en-GB" sz="400"/>
                <a:t>54</a:t>
              </a:r>
            </a:p>
          </p:txBody>
        </p:sp>
        <p:sp>
          <p:nvSpPr>
            <p:cNvPr id="372" name="TextBox 371">
              <a:extLst>
                <a:ext uri="{FF2B5EF4-FFF2-40B4-BE49-F238E27FC236}">
                  <a16:creationId xmlns:a16="http://schemas.microsoft.com/office/drawing/2014/main" id="{B5692818-C5CE-AA67-3A9D-17E72153C31C}"/>
                </a:ext>
              </a:extLst>
            </p:cNvPr>
            <p:cNvSpPr txBox="1"/>
            <p:nvPr/>
          </p:nvSpPr>
          <p:spPr>
            <a:xfrm>
              <a:off x="5681471" y="4523516"/>
              <a:ext cx="261522" cy="153888"/>
            </a:xfrm>
            <a:prstGeom prst="rect">
              <a:avLst/>
            </a:prstGeom>
            <a:noFill/>
          </p:spPr>
          <p:txBody>
            <a:bodyPr wrap="square">
              <a:spAutoFit/>
            </a:bodyPr>
            <a:lstStyle/>
            <a:p>
              <a:r>
                <a:rPr lang="en-GB" sz="400"/>
                <a:t>200</a:t>
              </a:r>
            </a:p>
          </p:txBody>
        </p:sp>
      </p:grpSp>
      <p:pic>
        <p:nvPicPr>
          <p:cNvPr id="11" name="Picture 10">
            <a:extLst>
              <a:ext uri="{FF2B5EF4-FFF2-40B4-BE49-F238E27FC236}">
                <a16:creationId xmlns:a16="http://schemas.microsoft.com/office/drawing/2014/main" id="{04BA5DD5-B25F-99F2-4D2D-25389338DCE7}"/>
              </a:ext>
            </a:extLst>
          </p:cNvPr>
          <p:cNvPicPr>
            <a:picLocks noChangeAspect="1"/>
          </p:cNvPicPr>
          <p:nvPr/>
        </p:nvPicPr>
        <p:blipFill rotWithShape="1">
          <a:blip r:embed="rId7"/>
          <a:srcRect l="2076"/>
          <a:stretch/>
        </p:blipFill>
        <p:spPr>
          <a:xfrm>
            <a:off x="219247" y="6068373"/>
            <a:ext cx="6419505" cy="3207073"/>
          </a:xfrm>
          <a:prstGeom prst="rect">
            <a:avLst/>
          </a:prstGeom>
        </p:spPr>
      </p:pic>
      <p:pic>
        <p:nvPicPr>
          <p:cNvPr id="4" name="Picture 3">
            <a:extLst>
              <a:ext uri="{FF2B5EF4-FFF2-40B4-BE49-F238E27FC236}">
                <a16:creationId xmlns:a16="http://schemas.microsoft.com/office/drawing/2014/main" id="{147B203F-DDFF-F72B-24EA-846C847443CA}"/>
              </a:ext>
            </a:extLst>
          </p:cNvPr>
          <p:cNvPicPr>
            <a:picLocks noChangeAspect="1"/>
          </p:cNvPicPr>
          <p:nvPr/>
        </p:nvPicPr>
        <p:blipFill rotWithShape="1">
          <a:blip r:embed="rId8"/>
          <a:srcRect r="86470" b="70411"/>
          <a:stretch/>
        </p:blipFill>
        <p:spPr>
          <a:xfrm>
            <a:off x="5148840" y="2923312"/>
            <a:ext cx="614935" cy="1392554"/>
          </a:xfrm>
          <a:prstGeom prst="rect">
            <a:avLst/>
          </a:prstGeom>
        </p:spPr>
      </p:pic>
      <p:pic>
        <p:nvPicPr>
          <p:cNvPr id="5" name="Picture 4">
            <a:extLst>
              <a:ext uri="{FF2B5EF4-FFF2-40B4-BE49-F238E27FC236}">
                <a16:creationId xmlns:a16="http://schemas.microsoft.com/office/drawing/2014/main" id="{F0BDCF71-E59E-1F27-6864-D868DB7B30E7}"/>
              </a:ext>
            </a:extLst>
          </p:cNvPr>
          <p:cNvPicPr>
            <a:picLocks noChangeAspect="1"/>
          </p:cNvPicPr>
          <p:nvPr/>
        </p:nvPicPr>
        <p:blipFill rotWithShape="1">
          <a:blip r:embed="rId9"/>
          <a:srcRect r="37800" b="49073"/>
          <a:stretch/>
        </p:blipFill>
        <p:spPr>
          <a:xfrm>
            <a:off x="924676" y="827299"/>
            <a:ext cx="2201347" cy="1563676"/>
          </a:xfrm>
          <a:prstGeom prst="rect">
            <a:avLst/>
          </a:prstGeom>
        </p:spPr>
      </p:pic>
      <p:sp>
        <p:nvSpPr>
          <p:cNvPr id="37" name="TextBox 36">
            <a:extLst>
              <a:ext uri="{FF2B5EF4-FFF2-40B4-BE49-F238E27FC236}">
                <a16:creationId xmlns:a16="http://schemas.microsoft.com/office/drawing/2014/main" id="{7F86F4FE-14F2-5C3A-3417-9334942D7DEF}"/>
              </a:ext>
            </a:extLst>
          </p:cNvPr>
          <p:cNvSpPr txBox="1"/>
          <p:nvPr/>
        </p:nvSpPr>
        <p:spPr>
          <a:xfrm>
            <a:off x="5766714" y="1553982"/>
            <a:ext cx="939452" cy="184666"/>
          </a:xfrm>
          <a:prstGeom prst="rect">
            <a:avLst/>
          </a:prstGeom>
          <a:noFill/>
        </p:spPr>
        <p:txBody>
          <a:bodyPr wrap="square" rtlCol="0">
            <a:spAutoFit/>
          </a:bodyPr>
          <a:lstStyle/>
          <a:p>
            <a:r>
              <a:rPr lang="en-GB" sz="600"/>
              <a:t>capivasertib difference</a:t>
            </a:r>
          </a:p>
        </p:txBody>
      </p:sp>
      <p:sp>
        <p:nvSpPr>
          <p:cNvPr id="43" name="TextBox 42">
            <a:extLst>
              <a:ext uri="{FF2B5EF4-FFF2-40B4-BE49-F238E27FC236}">
                <a16:creationId xmlns:a16="http://schemas.microsoft.com/office/drawing/2014/main" id="{48211725-DD34-61D3-38DC-A43239F9D2CA}"/>
              </a:ext>
            </a:extLst>
          </p:cNvPr>
          <p:cNvSpPr txBox="1"/>
          <p:nvPr/>
        </p:nvSpPr>
        <p:spPr>
          <a:xfrm>
            <a:off x="5766714" y="1634613"/>
            <a:ext cx="939452" cy="184666"/>
          </a:xfrm>
          <a:prstGeom prst="rect">
            <a:avLst/>
          </a:prstGeom>
          <a:noFill/>
        </p:spPr>
        <p:txBody>
          <a:bodyPr wrap="square" rtlCol="0">
            <a:spAutoFit/>
          </a:bodyPr>
          <a:lstStyle/>
          <a:p>
            <a:r>
              <a:rPr lang="en-GB" sz="600" err="1"/>
              <a:t>fulvestrant</a:t>
            </a:r>
            <a:r>
              <a:rPr lang="en-GB" sz="600"/>
              <a:t> difference</a:t>
            </a:r>
          </a:p>
        </p:txBody>
      </p:sp>
      <p:sp>
        <p:nvSpPr>
          <p:cNvPr id="60" name="TextBox 59">
            <a:extLst>
              <a:ext uri="{FF2B5EF4-FFF2-40B4-BE49-F238E27FC236}">
                <a16:creationId xmlns:a16="http://schemas.microsoft.com/office/drawing/2014/main" id="{D0ECAC58-2999-4390-38E6-552739C585FB}"/>
              </a:ext>
            </a:extLst>
          </p:cNvPr>
          <p:cNvSpPr txBox="1"/>
          <p:nvPr/>
        </p:nvSpPr>
        <p:spPr>
          <a:xfrm>
            <a:off x="4960821" y="2333391"/>
            <a:ext cx="716788" cy="276999"/>
          </a:xfrm>
          <a:prstGeom prst="rect">
            <a:avLst/>
          </a:prstGeom>
          <a:noFill/>
        </p:spPr>
        <p:txBody>
          <a:bodyPr wrap="square" rtlCol="0">
            <a:spAutoFit/>
          </a:bodyPr>
          <a:lstStyle/>
          <a:p>
            <a:r>
              <a:rPr lang="en-GB" sz="600"/>
              <a:t>Positive log2FC in monotherapy</a:t>
            </a:r>
          </a:p>
        </p:txBody>
      </p:sp>
      <p:sp>
        <p:nvSpPr>
          <p:cNvPr id="326" name="TextBox 325">
            <a:extLst>
              <a:ext uri="{FF2B5EF4-FFF2-40B4-BE49-F238E27FC236}">
                <a16:creationId xmlns:a16="http://schemas.microsoft.com/office/drawing/2014/main" id="{25D23673-F9CA-39E6-69D5-900BD91B8300}"/>
              </a:ext>
            </a:extLst>
          </p:cNvPr>
          <p:cNvSpPr txBox="1"/>
          <p:nvPr/>
        </p:nvSpPr>
        <p:spPr>
          <a:xfrm>
            <a:off x="4253123" y="2333391"/>
            <a:ext cx="716788" cy="276999"/>
          </a:xfrm>
          <a:prstGeom prst="rect">
            <a:avLst/>
          </a:prstGeom>
          <a:noFill/>
        </p:spPr>
        <p:txBody>
          <a:bodyPr wrap="square" rtlCol="0">
            <a:spAutoFit/>
          </a:bodyPr>
          <a:lstStyle/>
          <a:p>
            <a:r>
              <a:rPr lang="en-GB" sz="600"/>
              <a:t>Negative log2FC in monotherapy</a:t>
            </a:r>
          </a:p>
        </p:txBody>
      </p:sp>
      <p:sp>
        <p:nvSpPr>
          <p:cNvPr id="327" name="TextBox 326">
            <a:extLst>
              <a:ext uri="{FF2B5EF4-FFF2-40B4-BE49-F238E27FC236}">
                <a16:creationId xmlns:a16="http://schemas.microsoft.com/office/drawing/2014/main" id="{48071B57-688B-A7E7-4E0D-F474437B1E3F}"/>
              </a:ext>
            </a:extLst>
          </p:cNvPr>
          <p:cNvSpPr txBox="1"/>
          <p:nvPr/>
        </p:nvSpPr>
        <p:spPr>
          <a:xfrm>
            <a:off x="4669024" y="2563003"/>
            <a:ext cx="716788" cy="184666"/>
          </a:xfrm>
          <a:prstGeom prst="rect">
            <a:avLst/>
          </a:prstGeom>
          <a:noFill/>
        </p:spPr>
        <p:txBody>
          <a:bodyPr wrap="square" rtlCol="0">
            <a:spAutoFit/>
          </a:bodyPr>
          <a:lstStyle/>
          <a:p>
            <a:r>
              <a:rPr lang="en-GB" sz="600" b="1"/>
              <a:t>Direction</a:t>
            </a:r>
          </a:p>
        </p:txBody>
      </p:sp>
      <p:sp>
        <p:nvSpPr>
          <p:cNvPr id="328" name="TextBox 327">
            <a:extLst>
              <a:ext uri="{FF2B5EF4-FFF2-40B4-BE49-F238E27FC236}">
                <a16:creationId xmlns:a16="http://schemas.microsoft.com/office/drawing/2014/main" id="{2C2E9226-C637-323F-96DE-CE746D639CF5}"/>
              </a:ext>
            </a:extLst>
          </p:cNvPr>
          <p:cNvSpPr txBox="1"/>
          <p:nvPr/>
        </p:nvSpPr>
        <p:spPr>
          <a:xfrm rot="16200000">
            <a:off x="3379731" y="1495090"/>
            <a:ext cx="1174802" cy="276999"/>
          </a:xfrm>
          <a:prstGeom prst="rect">
            <a:avLst/>
          </a:prstGeom>
          <a:noFill/>
        </p:spPr>
        <p:txBody>
          <a:bodyPr wrap="square" rtlCol="0">
            <a:spAutoFit/>
          </a:bodyPr>
          <a:lstStyle/>
          <a:p>
            <a:r>
              <a:rPr lang="en-GB" sz="600"/>
              <a:t>Difference in log2FC between monotherapy and combination</a:t>
            </a:r>
          </a:p>
        </p:txBody>
      </p:sp>
      <p:sp>
        <p:nvSpPr>
          <p:cNvPr id="329" name="Rectangle 328">
            <a:extLst>
              <a:ext uri="{FF2B5EF4-FFF2-40B4-BE49-F238E27FC236}">
                <a16:creationId xmlns:a16="http://schemas.microsoft.com/office/drawing/2014/main" id="{984B4CB8-F099-FA52-C3F9-D0FF2DFB0B01}"/>
              </a:ext>
            </a:extLst>
          </p:cNvPr>
          <p:cNvSpPr/>
          <p:nvPr/>
        </p:nvSpPr>
        <p:spPr>
          <a:xfrm>
            <a:off x="4077296" y="1678389"/>
            <a:ext cx="45719" cy="13902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17836064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A07066BB-B788-47E5-AD9E-431C88455864}"/>
              </a:ext>
            </a:extLst>
          </p:cNvPr>
          <p:cNvSpPr txBox="1"/>
          <p:nvPr/>
        </p:nvSpPr>
        <p:spPr>
          <a:xfrm>
            <a:off x="703297" y="205802"/>
            <a:ext cx="4630703" cy="292388"/>
          </a:xfrm>
          <a:prstGeom prst="rect">
            <a:avLst/>
          </a:prstGeom>
          <a:noFill/>
        </p:spPr>
        <p:txBody>
          <a:bodyPr wrap="square" rtlCol="0">
            <a:spAutoFit/>
          </a:bodyPr>
          <a:lstStyle/>
          <a:p>
            <a:r>
              <a:rPr lang="en-GB" sz="1300"/>
              <a:t>Supplementary Figure 5</a:t>
            </a:r>
          </a:p>
        </p:txBody>
      </p:sp>
      <p:sp>
        <p:nvSpPr>
          <p:cNvPr id="13" name="TextBox 12">
            <a:extLst>
              <a:ext uri="{FF2B5EF4-FFF2-40B4-BE49-F238E27FC236}">
                <a16:creationId xmlns:a16="http://schemas.microsoft.com/office/drawing/2014/main" id="{A252DAE2-ED94-B91A-0FA2-BA1842318B3D}"/>
              </a:ext>
            </a:extLst>
          </p:cNvPr>
          <p:cNvSpPr txBox="1"/>
          <p:nvPr/>
        </p:nvSpPr>
        <p:spPr>
          <a:xfrm>
            <a:off x="1022562" y="896694"/>
            <a:ext cx="771617"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T47D Parent</a:t>
            </a:r>
            <a:endParaRPr lang="en-GB" sz="600">
              <a:cs typeface="Arial" panose="020B0604020202020204" pitchFamily="34" charset="0"/>
            </a:endParaRPr>
          </a:p>
        </p:txBody>
      </p:sp>
      <p:sp>
        <p:nvSpPr>
          <p:cNvPr id="14" name="TextBox 13">
            <a:extLst>
              <a:ext uri="{FF2B5EF4-FFF2-40B4-BE49-F238E27FC236}">
                <a16:creationId xmlns:a16="http://schemas.microsoft.com/office/drawing/2014/main" id="{3FBF8DFD-4646-B736-BF8B-CCD208758FAE}"/>
              </a:ext>
            </a:extLst>
          </p:cNvPr>
          <p:cNvSpPr txBox="1"/>
          <p:nvPr/>
        </p:nvSpPr>
        <p:spPr>
          <a:xfrm>
            <a:off x="1807381" y="896694"/>
            <a:ext cx="530869"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T47D RB-</a:t>
            </a:r>
            <a:endParaRPr lang="en-GB" sz="600">
              <a:cs typeface="Arial" panose="020B0604020202020204" pitchFamily="34" charset="0"/>
            </a:endParaRPr>
          </a:p>
        </p:txBody>
      </p:sp>
      <p:sp>
        <p:nvSpPr>
          <p:cNvPr id="17" name="TextBox 16">
            <a:extLst>
              <a:ext uri="{FF2B5EF4-FFF2-40B4-BE49-F238E27FC236}">
                <a16:creationId xmlns:a16="http://schemas.microsoft.com/office/drawing/2014/main" id="{DAD5CD2D-FB34-76C2-AFC2-E7C4776AD1C3}"/>
              </a:ext>
            </a:extLst>
          </p:cNvPr>
          <p:cNvSpPr txBox="1"/>
          <p:nvPr/>
        </p:nvSpPr>
        <p:spPr>
          <a:xfrm>
            <a:off x="4898175" y="896694"/>
            <a:ext cx="472817"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t>T47D RB-</a:t>
            </a:r>
            <a:endParaRPr lang="en-GB" sz="600"/>
          </a:p>
        </p:txBody>
      </p:sp>
      <p:sp>
        <p:nvSpPr>
          <p:cNvPr id="23" name="TextBox 22">
            <a:extLst>
              <a:ext uri="{FF2B5EF4-FFF2-40B4-BE49-F238E27FC236}">
                <a16:creationId xmlns:a16="http://schemas.microsoft.com/office/drawing/2014/main" id="{8601994B-901E-A6BE-C029-4EB6A6021926}"/>
              </a:ext>
            </a:extLst>
          </p:cNvPr>
          <p:cNvSpPr txBox="1"/>
          <p:nvPr/>
        </p:nvSpPr>
        <p:spPr>
          <a:xfrm>
            <a:off x="5582531" y="896694"/>
            <a:ext cx="799967"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t>T47D CDH6H</a:t>
            </a:r>
            <a:endParaRPr lang="en-GB" sz="600"/>
          </a:p>
        </p:txBody>
      </p:sp>
      <p:sp>
        <p:nvSpPr>
          <p:cNvPr id="24" name="TextBox 23">
            <a:extLst>
              <a:ext uri="{FF2B5EF4-FFF2-40B4-BE49-F238E27FC236}">
                <a16:creationId xmlns:a16="http://schemas.microsoft.com/office/drawing/2014/main" id="{81089332-DEEA-E983-A187-F0A7E8CAE5F6}"/>
              </a:ext>
            </a:extLst>
          </p:cNvPr>
          <p:cNvSpPr txBox="1"/>
          <p:nvPr/>
        </p:nvSpPr>
        <p:spPr>
          <a:xfrm>
            <a:off x="4136261" y="896694"/>
            <a:ext cx="715070"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t>T47D Parent</a:t>
            </a:r>
            <a:endParaRPr lang="en-GB" sz="600"/>
          </a:p>
        </p:txBody>
      </p:sp>
      <p:sp>
        <p:nvSpPr>
          <p:cNvPr id="27" name="TextBox 26">
            <a:extLst>
              <a:ext uri="{FF2B5EF4-FFF2-40B4-BE49-F238E27FC236}">
                <a16:creationId xmlns:a16="http://schemas.microsoft.com/office/drawing/2014/main" id="{F6D18671-70D7-AED0-BB33-4EC057D7A107}"/>
              </a:ext>
            </a:extLst>
          </p:cNvPr>
          <p:cNvSpPr txBox="1"/>
          <p:nvPr/>
        </p:nvSpPr>
        <p:spPr>
          <a:xfrm>
            <a:off x="408440" y="636636"/>
            <a:ext cx="277640" cy="276999"/>
          </a:xfrm>
          <a:prstGeom prst="rect">
            <a:avLst/>
          </a:prstGeom>
          <a:noFill/>
        </p:spPr>
        <p:txBody>
          <a:bodyPr wrap="none" rtlCol="0">
            <a:spAutoFit/>
          </a:bodyPr>
          <a:lstStyle/>
          <a:p>
            <a:r>
              <a:rPr lang="en-GB" sz="1200" b="1"/>
              <a:t>A</a:t>
            </a:r>
          </a:p>
        </p:txBody>
      </p:sp>
      <p:sp>
        <p:nvSpPr>
          <p:cNvPr id="28" name="TextBox 27">
            <a:extLst>
              <a:ext uri="{FF2B5EF4-FFF2-40B4-BE49-F238E27FC236}">
                <a16:creationId xmlns:a16="http://schemas.microsoft.com/office/drawing/2014/main" id="{003C3A1C-7C4B-4DFA-331E-43142345CC66}"/>
              </a:ext>
            </a:extLst>
          </p:cNvPr>
          <p:cNvSpPr txBox="1"/>
          <p:nvPr/>
        </p:nvSpPr>
        <p:spPr>
          <a:xfrm>
            <a:off x="3392012" y="610618"/>
            <a:ext cx="277640" cy="276999"/>
          </a:xfrm>
          <a:prstGeom prst="rect">
            <a:avLst/>
          </a:prstGeom>
          <a:noFill/>
        </p:spPr>
        <p:txBody>
          <a:bodyPr wrap="none" rtlCol="0">
            <a:spAutoFit/>
          </a:bodyPr>
          <a:lstStyle/>
          <a:p>
            <a:r>
              <a:rPr lang="en-GB" sz="1200" b="1"/>
              <a:t>B</a:t>
            </a:r>
          </a:p>
        </p:txBody>
      </p:sp>
      <p:pic>
        <p:nvPicPr>
          <p:cNvPr id="29" name="Picture 28">
            <a:extLst>
              <a:ext uri="{FF2B5EF4-FFF2-40B4-BE49-F238E27FC236}">
                <a16:creationId xmlns:a16="http://schemas.microsoft.com/office/drawing/2014/main" id="{818F5A1C-4D3F-2AD6-1B08-29C1BAE83E0B}"/>
              </a:ext>
            </a:extLst>
          </p:cNvPr>
          <p:cNvPicPr>
            <a:picLocks noChangeAspect="1"/>
          </p:cNvPicPr>
          <p:nvPr/>
        </p:nvPicPr>
        <p:blipFill rotWithShape="1">
          <a:blip r:embed="rId3"/>
          <a:srcRect b="13759"/>
          <a:stretch/>
        </p:blipFill>
        <p:spPr>
          <a:xfrm>
            <a:off x="3468164" y="1045654"/>
            <a:ext cx="2761387" cy="1541919"/>
          </a:xfrm>
          <a:prstGeom prst="rect">
            <a:avLst/>
          </a:prstGeom>
        </p:spPr>
      </p:pic>
      <p:pic>
        <p:nvPicPr>
          <p:cNvPr id="30" name="Picture 29">
            <a:extLst>
              <a:ext uri="{FF2B5EF4-FFF2-40B4-BE49-F238E27FC236}">
                <a16:creationId xmlns:a16="http://schemas.microsoft.com/office/drawing/2014/main" id="{78AF99D9-EB20-50C3-2D6C-7A0F16CCBC86}"/>
              </a:ext>
            </a:extLst>
          </p:cNvPr>
          <p:cNvPicPr>
            <a:picLocks noChangeAspect="1"/>
          </p:cNvPicPr>
          <p:nvPr/>
        </p:nvPicPr>
        <p:blipFill rotWithShape="1">
          <a:blip r:embed="rId4"/>
          <a:srcRect b="14101"/>
          <a:stretch/>
        </p:blipFill>
        <p:spPr>
          <a:xfrm>
            <a:off x="402789" y="1049046"/>
            <a:ext cx="2741814" cy="1497628"/>
          </a:xfrm>
          <a:prstGeom prst="rect">
            <a:avLst/>
          </a:prstGeom>
        </p:spPr>
      </p:pic>
      <p:sp>
        <p:nvSpPr>
          <p:cNvPr id="33" name="TextBox 32">
            <a:extLst>
              <a:ext uri="{FF2B5EF4-FFF2-40B4-BE49-F238E27FC236}">
                <a16:creationId xmlns:a16="http://schemas.microsoft.com/office/drawing/2014/main" id="{54D1B0EA-54FA-A56A-6606-BF64B3146C45}"/>
              </a:ext>
            </a:extLst>
          </p:cNvPr>
          <p:cNvSpPr txBox="1"/>
          <p:nvPr/>
        </p:nvSpPr>
        <p:spPr>
          <a:xfrm>
            <a:off x="343739" y="3312348"/>
            <a:ext cx="266420" cy="276999"/>
          </a:xfrm>
          <a:prstGeom prst="rect">
            <a:avLst/>
          </a:prstGeom>
          <a:noFill/>
        </p:spPr>
        <p:txBody>
          <a:bodyPr wrap="none" rtlCol="0">
            <a:spAutoFit/>
          </a:bodyPr>
          <a:lstStyle/>
          <a:p>
            <a:r>
              <a:rPr lang="en-GB" sz="1200" b="1"/>
              <a:t>C</a:t>
            </a:r>
          </a:p>
        </p:txBody>
      </p:sp>
      <p:sp>
        <p:nvSpPr>
          <p:cNvPr id="34" name="TextBox 33">
            <a:extLst>
              <a:ext uri="{FF2B5EF4-FFF2-40B4-BE49-F238E27FC236}">
                <a16:creationId xmlns:a16="http://schemas.microsoft.com/office/drawing/2014/main" id="{AEF02140-8286-A485-048F-31B51E71C859}"/>
              </a:ext>
            </a:extLst>
          </p:cNvPr>
          <p:cNvSpPr txBox="1"/>
          <p:nvPr/>
        </p:nvSpPr>
        <p:spPr>
          <a:xfrm>
            <a:off x="3393565" y="3293433"/>
            <a:ext cx="282450" cy="276999"/>
          </a:xfrm>
          <a:prstGeom prst="rect">
            <a:avLst/>
          </a:prstGeom>
          <a:noFill/>
        </p:spPr>
        <p:txBody>
          <a:bodyPr wrap="none" rtlCol="0">
            <a:spAutoFit/>
          </a:bodyPr>
          <a:lstStyle/>
          <a:p>
            <a:r>
              <a:rPr lang="en-GB" sz="1200" b="1"/>
              <a:t>D</a:t>
            </a:r>
          </a:p>
        </p:txBody>
      </p:sp>
      <p:pic>
        <p:nvPicPr>
          <p:cNvPr id="3" name="Picture 2">
            <a:extLst>
              <a:ext uri="{FF2B5EF4-FFF2-40B4-BE49-F238E27FC236}">
                <a16:creationId xmlns:a16="http://schemas.microsoft.com/office/drawing/2014/main" id="{72C277A1-2878-43DB-A1A6-A2B4E59625C0}"/>
              </a:ext>
            </a:extLst>
          </p:cNvPr>
          <p:cNvPicPr>
            <a:picLocks noChangeAspect="1"/>
          </p:cNvPicPr>
          <p:nvPr/>
        </p:nvPicPr>
        <p:blipFill rotWithShape="1">
          <a:blip r:embed="rId5"/>
          <a:srcRect t="1" r="74268" b="48956"/>
          <a:stretch/>
        </p:blipFill>
        <p:spPr>
          <a:xfrm>
            <a:off x="731886" y="3689862"/>
            <a:ext cx="983325" cy="1542414"/>
          </a:xfrm>
          <a:prstGeom prst="rect">
            <a:avLst/>
          </a:prstGeom>
        </p:spPr>
      </p:pic>
      <p:pic>
        <p:nvPicPr>
          <p:cNvPr id="4" name="Picture 3">
            <a:extLst>
              <a:ext uri="{FF2B5EF4-FFF2-40B4-BE49-F238E27FC236}">
                <a16:creationId xmlns:a16="http://schemas.microsoft.com/office/drawing/2014/main" id="{5D4DB241-6071-9ABD-C64D-090547258C39}"/>
              </a:ext>
            </a:extLst>
          </p:cNvPr>
          <p:cNvPicPr>
            <a:picLocks noChangeAspect="1"/>
          </p:cNvPicPr>
          <p:nvPr/>
        </p:nvPicPr>
        <p:blipFill rotWithShape="1">
          <a:blip r:embed="rId5"/>
          <a:srcRect l="26158" t="1" r="56311" b="48956"/>
          <a:stretch/>
        </p:blipFill>
        <p:spPr>
          <a:xfrm>
            <a:off x="2485695" y="3689862"/>
            <a:ext cx="669909" cy="1542414"/>
          </a:xfrm>
          <a:prstGeom prst="rect">
            <a:avLst/>
          </a:prstGeom>
        </p:spPr>
      </p:pic>
      <p:pic>
        <p:nvPicPr>
          <p:cNvPr id="5" name="Picture 4">
            <a:extLst>
              <a:ext uri="{FF2B5EF4-FFF2-40B4-BE49-F238E27FC236}">
                <a16:creationId xmlns:a16="http://schemas.microsoft.com/office/drawing/2014/main" id="{DEFF951A-F40D-D6B6-0BA4-F0F94ADB8D80}"/>
              </a:ext>
            </a:extLst>
          </p:cNvPr>
          <p:cNvPicPr>
            <a:picLocks noChangeAspect="1"/>
          </p:cNvPicPr>
          <p:nvPr/>
        </p:nvPicPr>
        <p:blipFill rotWithShape="1">
          <a:blip r:embed="rId5"/>
          <a:srcRect l="43948" t="1" r="38520" b="48956"/>
          <a:stretch/>
        </p:blipFill>
        <p:spPr>
          <a:xfrm>
            <a:off x="1766010" y="3689862"/>
            <a:ext cx="669910" cy="1542414"/>
          </a:xfrm>
          <a:prstGeom prst="rect">
            <a:avLst/>
          </a:prstGeom>
        </p:spPr>
      </p:pic>
      <p:pic>
        <p:nvPicPr>
          <p:cNvPr id="6" name="Picture 5">
            <a:extLst>
              <a:ext uri="{FF2B5EF4-FFF2-40B4-BE49-F238E27FC236}">
                <a16:creationId xmlns:a16="http://schemas.microsoft.com/office/drawing/2014/main" id="{A77ADCCE-0E6B-EACD-B527-00C5281465B5}"/>
              </a:ext>
            </a:extLst>
          </p:cNvPr>
          <p:cNvPicPr>
            <a:picLocks noChangeAspect="1"/>
          </p:cNvPicPr>
          <p:nvPr/>
        </p:nvPicPr>
        <p:blipFill rotWithShape="1">
          <a:blip r:embed="rId5"/>
          <a:srcRect l="61830" t="1" r="32495" b="68077"/>
          <a:stretch/>
        </p:blipFill>
        <p:spPr>
          <a:xfrm>
            <a:off x="549452" y="3939686"/>
            <a:ext cx="172170" cy="765836"/>
          </a:xfrm>
          <a:prstGeom prst="rect">
            <a:avLst/>
          </a:prstGeom>
        </p:spPr>
      </p:pic>
      <p:sp>
        <p:nvSpPr>
          <p:cNvPr id="7" name="TextBox 6">
            <a:extLst>
              <a:ext uri="{FF2B5EF4-FFF2-40B4-BE49-F238E27FC236}">
                <a16:creationId xmlns:a16="http://schemas.microsoft.com/office/drawing/2014/main" id="{DA10C712-1CC6-1220-C9B7-E6A3DBBC7B16}"/>
              </a:ext>
            </a:extLst>
          </p:cNvPr>
          <p:cNvSpPr txBox="1"/>
          <p:nvPr/>
        </p:nvSpPr>
        <p:spPr>
          <a:xfrm>
            <a:off x="441683" y="3639068"/>
            <a:ext cx="464730" cy="323165"/>
          </a:xfrm>
          <a:prstGeom prst="rect">
            <a:avLst/>
          </a:prstGeom>
          <a:noFill/>
        </p:spPr>
        <p:txBody>
          <a:bodyPr wrap="square" rtlCol="0">
            <a:spAutoFit/>
          </a:bodyPr>
          <a:lstStyle/>
          <a:p>
            <a:r>
              <a:rPr lang="en-GB" sz="500" b="1"/>
              <a:t>Z-score of mean counts</a:t>
            </a:r>
          </a:p>
        </p:txBody>
      </p:sp>
      <p:sp>
        <p:nvSpPr>
          <p:cNvPr id="8" name="TextBox 7">
            <a:extLst>
              <a:ext uri="{FF2B5EF4-FFF2-40B4-BE49-F238E27FC236}">
                <a16:creationId xmlns:a16="http://schemas.microsoft.com/office/drawing/2014/main" id="{A898017B-4EA9-917C-71B6-63BB6E99402E}"/>
              </a:ext>
            </a:extLst>
          </p:cNvPr>
          <p:cNvSpPr txBox="1"/>
          <p:nvPr/>
        </p:nvSpPr>
        <p:spPr>
          <a:xfrm>
            <a:off x="1085265" y="3550237"/>
            <a:ext cx="771617"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MCF7 Parent</a:t>
            </a:r>
            <a:endParaRPr lang="en-GB" sz="600">
              <a:cs typeface="Arial" panose="020B0604020202020204" pitchFamily="34" charset="0"/>
            </a:endParaRPr>
          </a:p>
        </p:txBody>
      </p:sp>
      <p:sp>
        <p:nvSpPr>
          <p:cNvPr id="9" name="TextBox 8">
            <a:extLst>
              <a:ext uri="{FF2B5EF4-FFF2-40B4-BE49-F238E27FC236}">
                <a16:creationId xmlns:a16="http://schemas.microsoft.com/office/drawing/2014/main" id="{514B49CF-16CB-E2B0-F1A1-B713D7F08EC2}"/>
              </a:ext>
            </a:extLst>
          </p:cNvPr>
          <p:cNvSpPr txBox="1"/>
          <p:nvPr/>
        </p:nvSpPr>
        <p:spPr>
          <a:xfrm>
            <a:off x="1847517" y="3550237"/>
            <a:ext cx="511275"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MCF7 RB-</a:t>
            </a:r>
            <a:endParaRPr lang="en-GB" sz="600">
              <a:cs typeface="Arial" panose="020B0604020202020204" pitchFamily="34" charset="0"/>
            </a:endParaRPr>
          </a:p>
        </p:txBody>
      </p:sp>
      <p:sp>
        <p:nvSpPr>
          <p:cNvPr id="15" name="TextBox 14">
            <a:extLst>
              <a:ext uri="{FF2B5EF4-FFF2-40B4-BE49-F238E27FC236}">
                <a16:creationId xmlns:a16="http://schemas.microsoft.com/office/drawing/2014/main" id="{F8562B7B-CECD-420F-1A53-D33D77D107B6}"/>
              </a:ext>
            </a:extLst>
          </p:cNvPr>
          <p:cNvSpPr txBox="1"/>
          <p:nvPr/>
        </p:nvSpPr>
        <p:spPr>
          <a:xfrm>
            <a:off x="2543846" y="3550237"/>
            <a:ext cx="584378"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MCF7 PacqR</a:t>
            </a:r>
            <a:endParaRPr lang="en-GB" sz="600">
              <a:cs typeface="Arial" panose="020B0604020202020204" pitchFamily="34" charset="0"/>
            </a:endParaRPr>
          </a:p>
        </p:txBody>
      </p:sp>
      <p:pic>
        <p:nvPicPr>
          <p:cNvPr id="19" name="Picture 18">
            <a:extLst>
              <a:ext uri="{FF2B5EF4-FFF2-40B4-BE49-F238E27FC236}">
                <a16:creationId xmlns:a16="http://schemas.microsoft.com/office/drawing/2014/main" id="{CA762B03-9C42-0F38-DFE1-0ED8C90E53CA}"/>
              </a:ext>
            </a:extLst>
          </p:cNvPr>
          <p:cNvPicPr>
            <a:picLocks noChangeAspect="1"/>
          </p:cNvPicPr>
          <p:nvPr/>
        </p:nvPicPr>
        <p:blipFill rotWithShape="1">
          <a:blip r:embed="rId6"/>
          <a:srcRect t="-1" r="74104" b="48672"/>
          <a:stretch/>
        </p:blipFill>
        <p:spPr>
          <a:xfrm>
            <a:off x="3768484" y="3695640"/>
            <a:ext cx="984098" cy="1542414"/>
          </a:xfrm>
          <a:prstGeom prst="rect">
            <a:avLst/>
          </a:prstGeom>
        </p:spPr>
      </p:pic>
      <p:pic>
        <p:nvPicPr>
          <p:cNvPr id="20" name="Picture 19">
            <a:extLst>
              <a:ext uri="{FF2B5EF4-FFF2-40B4-BE49-F238E27FC236}">
                <a16:creationId xmlns:a16="http://schemas.microsoft.com/office/drawing/2014/main" id="{70F5E9C9-0561-A0C1-2E1C-95EACF5B4DD6}"/>
              </a:ext>
            </a:extLst>
          </p:cNvPr>
          <p:cNvPicPr>
            <a:picLocks noChangeAspect="1"/>
          </p:cNvPicPr>
          <p:nvPr/>
        </p:nvPicPr>
        <p:blipFill rotWithShape="1">
          <a:blip r:embed="rId6"/>
          <a:srcRect l="25900" t="-1" r="56315" b="48672"/>
          <a:stretch/>
        </p:blipFill>
        <p:spPr>
          <a:xfrm>
            <a:off x="5547222" y="3695640"/>
            <a:ext cx="675856" cy="1542414"/>
          </a:xfrm>
          <a:prstGeom prst="rect">
            <a:avLst/>
          </a:prstGeom>
        </p:spPr>
      </p:pic>
      <p:pic>
        <p:nvPicPr>
          <p:cNvPr id="21" name="Picture 20">
            <a:extLst>
              <a:ext uri="{FF2B5EF4-FFF2-40B4-BE49-F238E27FC236}">
                <a16:creationId xmlns:a16="http://schemas.microsoft.com/office/drawing/2014/main" id="{F19C678C-8134-00F7-F405-61BA1A7DD959}"/>
              </a:ext>
            </a:extLst>
          </p:cNvPr>
          <p:cNvPicPr>
            <a:picLocks noChangeAspect="1"/>
          </p:cNvPicPr>
          <p:nvPr/>
        </p:nvPicPr>
        <p:blipFill rotWithShape="1">
          <a:blip r:embed="rId6"/>
          <a:srcRect l="43861" t="-1" r="37992" b="48672"/>
          <a:stretch/>
        </p:blipFill>
        <p:spPr>
          <a:xfrm>
            <a:off x="4808646" y="3695640"/>
            <a:ext cx="689610" cy="1542414"/>
          </a:xfrm>
          <a:prstGeom prst="rect">
            <a:avLst/>
          </a:prstGeom>
        </p:spPr>
      </p:pic>
      <p:sp>
        <p:nvSpPr>
          <p:cNvPr id="22" name="TextBox 21">
            <a:extLst>
              <a:ext uri="{FF2B5EF4-FFF2-40B4-BE49-F238E27FC236}">
                <a16:creationId xmlns:a16="http://schemas.microsoft.com/office/drawing/2014/main" id="{557AA382-4895-7F10-B8D6-0479A8FC7615}"/>
              </a:ext>
            </a:extLst>
          </p:cNvPr>
          <p:cNvSpPr txBox="1"/>
          <p:nvPr/>
        </p:nvSpPr>
        <p:spPr>
          <a:xfrm>
            <a:off x="4120871" y="3550237"/>
            <a:ext cx="771617"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MCF7 Parent</a:t>
            </a:r>
            <a:endParaRPr lang="en-GB" sz="600">
              <a:cs typeface="Arial" panose="020B0604020202020204" pitchFamily="34" charset="0"/>
            </a:endParaRPr>
          </a:p>
        </p:txBody>
      </p:sp>
      <p:sp>
        <p:nvSpPr>
          <p:cNvPr id="25" name="TextBox 24">
            <a:extLst>
              <a:ext uri="{FF2B5EF4-FFF2-40B4-BE49-F238E27FC236}">
                <a16:creationId xmlns:a16="http://schemas.microsoft.com/office/drawing/2014/main" id="{41632CC1-87BB-A1FD-6F0F-C7898E77BC04}"/>
              </a:ext>
            </a:extLst>
          </p:cNvPr>
          <p:cNvSpPr txBox="1"/>
          <p:nvPr/>
        </p:nvSpPr>
        <p:spPr>
          <a:xfrm>
            <a:off x="5598220" y="3550237"/>
            <a:ext cx="597624"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MCF7 </a:t>
            </a:r>
            <a:r>
              <a:rPr lang="en-GB" sz="600" b="1" err="1">
                <a:cs typeface="Arial" panose="020B0604020202020204" pitchFamily="34" charset="0"/>
              </a:rPr>
              <a:t>PacqR</a:t>
            </a:r>
            <a:endParaRPr lang="en-GB" sz="600">
              <a:cs typeface="Arial" panose="020B0604020202020204" pitchFamily="34" charset="0"/>
            </a:endParaRPr>
          </a:p>
        </p:txBody>
      </p:sp>
      <p:sp>
        <p:nvSpPr>
          <p:cNvPr id="26" name="TextBox 25">
            <a:extLst>
              <a:ext uri="{FF2B5EF4-FFF2-40B4-BE49-F238E27FC236}">
                <a16:creationId xmlns:a16="http://schemas.microsoft.com/office/drawing/2014/main" id="{3F6567F8-948C-3776-04AE-1F4997F2DC06}"/>
              </a:ext>
            </a:extLst>
          </p:cNvPr>
          <p:cNvSpPr txBox="1"/>
          <p:nvPr/>
        </p:nvSpPr>
        <p:spPr>
          <a:xfrm>
            <a:off x="4907711" y="3550237"/>
            <a:ext cx="512974"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MCF7 RB-</a:t>
            </a:r>
            <a:endParaRPr lang="en-GB" sz="600">
              <a:cs typeface="Arial" panose="020B0604020202020204" pitchFamily="34" charset="0"/>
            </a:endParaRPr>
          </a:p>
        </p:txBody>
      </p:sp>
      <p:sp>
        <p:nvSpPr>
          <p:cNvPr id="18" name="TextBox 17">
            <a:extLst>
              <a:ext uri="{FF2B5EF4-FFF2-40B4-BE49-F238E27FC236}">
                <a16:creationId xmlns:a16="http://schemas.microsoft.com/office/drawing/2014/main" id="{F3340808-A7B5-D87D-BEED-63B193AD5EC3}"/>
              </a:ext>
            </a:extLst>
          </p:cNvPr>
          <p:cNvSpPr txBox="1"/>
          <p:nvPr/>
        </p:nvSpPr>
        <p:spPr>
          <a:xfrm>
            <a:off x="3497738" y="3639068"/>
            <a:ext cx="464730" cy="323165"/>
          </a:xfrm>
          <a:prstGeom prst="rect">
            <a:avLst/>
          </a:prstGeom>
          <a:noFill/>
        </p:spPr>
        <p:txBody>
          <a:bodyPr wrap="square" rtlCol="0">
            <a:spAutoFit/>
          </a:bodyPr>
          <a:lstStyle/>
          <a:p>
            <a:r>
              <a:rPr lang="en-GB" sz="500" b="1"/>
              <a:t>Z-score of mean counts</a:t>
            </a:r>
          </a:p>
        </p:txBody>
      </p:sp>
      <p:sp>
        <p:nvSpPr>
          <p:cNvPr id="47" name="TextBox 46">
            <a:extLst>
              <a:ext uri="{FF2B5EF4-FFF2-40B4-BE49-F238E27FC236}">
                <a16:creationId xmlns:a16="http://schemas.microsoft.com/office/drawing/2014/main" id="{6B92FF38-380F-BEBD-A501-D7C60EDC8E82}"/>
              </a:ext>
            </a:extLst>
          </p:cNvPr>
          <p:cNvSpPr txBox="1"/>
          <p:nvPr/>
        </p:nvSpPr>
        <p:spPr>
          <a:xfrm>
            <a:off x="1627940" y="2719290"/>
            <a:ext cx="856498" cy="323165"/>
          </a:xfrm>
          <a:prstGeom prst="rect">
            <a:avLst/>
          </a:prstGeom>
          <a:noFill/>
        </p:spPr>
        <p:txBody>
          <a:bodyPr wrap="square" lIns="91440" tIns="45720" rIns="91440" bIns="45720" anchor="t">
            <a:spAutoFit/>
          </a:bodyPr>
          <a:lstStyle/>
          <a:p>
            <a:pPr algn="ctr"/>
            <a:r>
              <a:rPr lang="en-GB" sz="500">
                <a:latin typeface="Calibri"/>
                <a:cs typeface="Calibri"/>
              </a:rPr>
              <a:t>29 of these genes were also significant in T74D RB- comparison</a:t>
            </a:r>
            <a:endParaRPr lang="en-GB" sz="500">
              <a:cs typeface="Calibri"/>
            </a:endParaRPr>
          </a:p>
        </p:txBody>
      </p:sp>
      <p:sp>
        <p:nvSpPr>
          <p:cNvPr id="48" name="TextBox 47">
            <a:extLst>
              <a:ext uri="{FF2B5EF4-FFF2-40B4-BE49-F238E27FC236}">
                <a16:creationId xmlns:a16="http://schemas.microsoft.com/office/drawing/2014/main" id="{87C71E5F-0FFD-2F68-A166-79BDB8E0A3E9}"/>
              </a:ext>
            </a:extLst>
          </p:cNvPr>
          <p:cNvSpPr txBox="1"/>
          <p:nvPr/>
        </p:nvSpPr>
        <p:spPr>
          <a:xfrm>
            <a:off x="865090" y="2732354"/>
            <a:ext cx="908606" cy="323165"/>
          </a:xfrm>
          <a:prstGeom prst="rect">
            <a:avLst/>
          </a:prstGeom>
          <a:noFill/>
        </p:spPr>
        <p:txBody>
          <a:bodyPr wrap="square">
            <a:spAutoFit/>
          </a:bodyPr>
          <a:lstStyle/>
          <a:p>
            <a:pPr algn="ctr"/>
            <a:r>
              <a:rPr lang="en-GB" sz="500">
                <a:latin typeface="Calibri"/>
                <a:cs typeface="Calibri"/>
              </a:rPr>
              <a:t>Total significant genes after capivasertib monotherapy n=483 </a:t>
            </a:r>
            <a:endParaRPr lang="en-GB" sz="1200"/>
          </a:p>
        </p:txBody>
      </p:sp>
      <p:sp>
        <p:nvSpPr>
          <p:cNvPr id="49" name="TextBox 48">
            <a:extLst>
              <a:ext uri="{FF2B5EF4-FFF2-40B4-BE49-F238E27FC236}">
                <a16:creationId xmlns:a16="http://schemas.microsoft.com/office/drawing/2014/main" id="{B58D13CD-5E78-E71C-136F-F06ECA725B0D}"/>
              </a:ext>
            </a:extLst>
          </p:cNvPr>
          <p:cNvSpPr txBox="1"/>
          <p:nvPr/>
        </p:nvSpPr>
        <p:spPr>
          <a:xfrm>
            <a:off x="2344481" y="2719077"/>
            <a:ext cx="873196" cy="323165"/>
          </a:xfrm>
          <a:prstGeom prst="rect">
            <a:avLst/>
          </a:prstGeom>
          <a:noFill/>
        </p:spPr>
        <p:txBody>
          <a:bodyPr wrap="square" lIns="91440" tIns="45720" rIns="91440" bIns="45720" anchor="t">
            <a:spAutoFit/>
          </a:bodyPr>
          <a:lstStyle/>
          <a:p>
            <a:pPr algn="ctr"/>
            <a:r>
              <a:rPr lang="en-GB" sz="500">
                <a:latin typeface="Calibri"/>
                <a:cs typeface="Calibri"/>
              </a:rPr>
              <a:t>20 of these genes were significant in T74D CDK6H comparison </a:t>
            </a:r>
            <a:endParaRPr lang="en-GB" sz="1200"/>
          </a:p>
        </p:txBody>
      </p:sp>
      <p:sp>
        <p:nvSpPr>
          <p:cNvPr id="50" name="TextBox 49">
            <a:extLst>
              <a:ext uri="{FF2B5EF4-FFF2-40B4-BE49-F238E27FC236}">
                <a16:creationId xmlns:a16="http://schemas.microsoft.com/office/drawing/2014/main" id="{A55A861A-964D-E34E-DC7C-C54EE138D129}"/>
              </a:ext>
            </a:extLst>
          </p:cNvPr>
          <p:cNvSpPr txBox="1"/>
          <p:nvPr/>
        </p:nvSpPr>
        <p:spPr>
          <a:xfrm>
            <a:off x="1620437" y="2519011"/>
            <a:ext cx="513633" cy="246221"/>
          </a:xfrm>
          <a:prstGeom prst="rect">
            <a:avLst/>
          </a:prstGeom>
          <a:noFill/>
        </p:spPr>
        <p:txBody>
          <a:bodyPr wrap="square" rtlCol="0">
            <a:spAutoFit/>
          </a:bodyPr>
          <a:lstStyle/>
          <a:p>
            <a:pPr algn="ctr"/>
            <a:r>
              <a:rPr lang="en-GB" sz="500"/>
              <a:t>T47D RB- DMSO</a:t>
            </a:r>
          </a:p>
        </p:txBody>
      </p:sp>
      <p:sp>
        <p:nvSpPr>
          <p:cNvPr id="51" name="TextBox 50">
            <a:extLst>
              <a:ext uri="{FF2B5EF4-FFF2-40B4-BE49-F238E27FC236}">
                <a16:creationId xmlns:a16="http://schemas.microsoft.com/office/drawing/2014/main" id="{6AFD9CB6-235F-7501-6D52-965F014C4D2F}"/>
              </a:ext>
            </a:extLst>
          </p:cNvPr>
          <p:cNvSpPr txBox="1"/>
          <p:nvPr/>
        </p:nvSpPr>
        <p:spPr>
          <a:xfrm>
            <a:off x="1223851" y="2519011"/>
            <a:ext cx="528711" cy="246221"/>
          </a:xfrm>
          <a:prstGeom prst="rect">
            <a:avLst/>
          </a:prstGeom>
          <a:noFill/>
        </p:spPr>
        <p:txBody>
          <a:bodyPr wrap="square" rtlCol="0">
            <a:spAutoFit/>
          </a:bodyPr>
          <a:lstStyle/>
          <a:p>
            <a:pPr algn="ctr"/>
            <a:r>
              <a:rPr lang="en-GB" sz="500"/>
              <a:t>T47D Parent capivasertib</a:t>
            </a:r>
          </a:p>
        </p:txBody>
      </p:sp>
      <p:sp>
        <p:nvSpPr>
          <p:cNvPr id="52" name="TextBox 51">
            <a:extLst>
              <a:ext uri="{FF2B5EF4-FFF2-40B4-BE49-F238E27FC236}">
                <a16:creationId xmlns:a16="http://schemas.microsoft.com/office/drawing/2014/main" id="{8EECABB6-EB54-EC48-D101-3A84490D35CD}"/>
              </a:ext>
            </a:extLst>
          </p:cNvPr>
          <p:cNvSpPr txBox="1"/>
          <p:nvPr/>
        </p:nvSpPr>
        <p:spPr>
          <a:xfrm>
            <a:off x="868995" y="2519011"/>
            <a:ext cx="526947" cy="246221"/>
          </a:xfrm>
          <a:prstGeom prst="rect">
            <a:avLst/>
          </a:prstGeom>
          <a:noFill/>
        </p:spPr>
        <p:txBody>
          <a:bodyPr wrap="square" rtlCol="0">
            <a:spAutoFit/>
          </a:bodyPr>
          <a:lstStyle/>
          <a:p>
            <a:pPr algn="ctr"/>
            <a:r>
              <a:rPr lang="en-GB" sz="500"/>
              <a:t>T47D Parent DMSO</a:t>
            </a:r>
          </a:p>
        </p:txBody>
      </p:sp>
      <p:sp>
        <p:nvSpPr>
          <p:cNvPr id="53" name="TextBox 52">
            <a:extLst>
              <a:ext uri="{FF2B5EF4-FFF2-40B4-BE49-F238E27FC236}">
                <a16:creationId xmlns:a16="http://schemas.microsoft.com/office/drawing/2014/main" id="{4A272DF7-8D3B-C054-1814-C9AB868071D5}"/>
              </a:ext>
            </a:extLst>
          </p:cNvPr>
          <p:cNvSpPr txBox="1"/>
          <p:nvPr/>
        </p:nvSpPr>
        <p:spPr>
          <a:xfrm>
            <a:off x="2351320" y="2519011"/>
            <a:ext cx="512974" cy="246221"/>
          </a:xfrm>
          <a:prstGeom prst="rect">
            <a:avLst/>
          </a:prstGeom>
          <a:noFill/>
        </p:spPr>
        <p:txBody>
          <a:bodyPr wrap="square" rtlCol="0">
            <a:spAutoFit/>
          </a:bodyPr>
          <a:lstStyle/>
          <a:p>
            <a:pPr algn="ctr"/>
            <a:r>
              <a:rPr lang="en-GB" sz="500"/>
              <a:t>T47D CDK6H DMSO</a:t>
            </a:r>
          </a:p>
        </p:txBody>
      </p:sp>
      <p:sp>
        <p:nvSpPr>
          <p:cNvPr id="54" name="TextBox 53">
            <a:extLst>
              <a:ext uri="{FF2B5EF4-FFF2-40B4-BE49-F238E27FC236}">
                <a16:creationId xmlns:a16="http://schemas.microsoft.com/office/drawing/2014/main" id="{3B85F7CD-0D98-E094-6238-23CFF7C33F01}"/>
              </a:ext>
            </a:extLst>
          </p:cNvPr>
          <p:cNvSpPr txBox="1"/>
          <p:nvPr/>
        </p:nvSpPr>
        <p:spPr>
          <a:xfrm>
            <a:off x="2685832" y="2519011"/>
            <a:ext cx="552925" cy="246221"/>
          </a:xfrm>
          <a:prstGeom prst="rect">
            <a:avLst/>
          </a:prstGeom>
          <a:noFill/>
        </p:spPr>
        <p:txBody>
          <a:bodyPr wrap="square" rtlCol="0">
            <a:spAutoFit/>
          </a:bodyPr>
          <a:lstStyle/>
          <a:p>
            <a:pPr algn="ctr"/>
            <a:r>
              <a:rPr lang="en-GB" sz="500"/>
              <a:t>T47D CDK6H capivasertib</a:t>
            </a:r>
          </a:p>
        </p:txBody>
      </p:sp>
      <p:sp>
        <p:nvSpPr>
          <p:cNvPr id="55" name="TextBox 54">
            <a:extLst>
              <a:ext uri="{FF2B5EF4-FFF2-40B4-BE49-F238E27FC236}">
                <a16:creationId xmlns:a16="http://schemas.microsoft.com/office/drawing/2014/main" id="{960AEACA-9700-D1BC-6904-AE91F015BD58}"/>
              </a:ext>
            </a:extLst>
          </p:cNvPr>
          <p:cNvSpPr txBox="1"/>
          <p:nvPr/>
        </p:nvSpPr>
        <p:spPr>
          <a:xfrm>
            <a:off x="1960302" y="2519011"/>
            <a:ext cx="552925" cy="246221"/>
          </a:xfrm>
          <a:prstGeom prst="rect">
            <a:avLst/>
          </a:prstGeom>
          <a:noFill/>
        </p:spPr>
        <p:txBody>
          <a:bodyPr wrap="square" rtlCol="0">
            <a:spAutoFit/>
          </a:bodyPr>
          <a:lstStyle/>
          <a:p>
            <a:pPr algn="ctr"/>
            <a:r>
              <a:rPr lang="en-GB" sz="500"/>
              <a:t>T47D RB- capivasertib</a:t>
            </a:r>
          </a:p>
        </p:txBody>
      </p:sp>
      <p:sp>
        <p:nvSpPr>
          <p:cNvPr id="56" name="TextBox 55">
            <a:extLst>
              <a:ext uri="{FF2B5EF4-FFF2-40B4-BE49-F238E27FC236}">
                <a16:creationId xmlns:a16="http://schemas.microsoft.com/office/drawing/2014/main" id="{E24C2910-9259-7F18-A27D-CB54463A8B1D}"/>
              </a:ext>
            </a:extLst>
          </p:cNvPr>
          <p:cNvSpPr txBox="1"/>
          <p:nvPr/>
        </p:nvSpPr>
        <p:spPr>
          <a:xfrm>
            <a:off x="2491197" y="896694"/>
            <a:ext cx="864944" cy="175433"/>
          </a:xfrm>
          <a:prstGeom prst="rect">
            <a:avLst/>
          </a:prstGeom>
          <a:noFill/>
        </p:spPr>
        <p:txBody>
          <a:bodyPr wrap="square" lIns="91440" tIns="45720" rIns="91440" bIns="45720" rtlCol="0" anchor="t">
            <a:spAutoFit/>
          </a:bodyPr>
          <a:lstStyle/>
          <a:p>
            <a:pPr>
              <a:lnSpc>
                <a:spcPct val="90000"/>
              </a:lnSpc>
              <a:spcAft>
                <a:spcPts val="275"/>
              </a:spcAft>
            </a:pPr>
            <a:r>
              <a:rPr lang="en-GB" sz="600" b="1">
                <a:cs typeface="Arial" panose="020B0604020202020204" pitchFamily="34" charset="0"/>
              </a:rPr>
              <a:t>T47D CDK6H</a:t>
            </a:r>
            <a:endParaRPr lang="en-GB" sz="600">
              <a:cs typeface="Arial" panose="020B0604020202020204" pitchFamily="34" charset="0"/>
            </a:endParaRPr>
          </a:p>
        </p:txBody>
      </p:sp>
      <p:sp>
        <p:nvSpPr>
          <p:cNvPr id="57" name="TextBox 56">
            <a:extLst>
              <a:ext uri="{FF2B5EF4-FFF2-40B4-BE49-F238E27FC236}">
                <a16:creationId xmlns:a16="http://schemas.microsoft.com/office/drawing/2014/main" id="{3FC7077D-FC72-9E36-582F-E9B5F13378A7}"/>
              </a:ext>
            </a:extLst>
          </p:cNvPr>
          <p:cNvSpPr txBox="1"/>
          <p:nvPr/>
        </p:nvSpPr>
        <p:spPr>
          <a:xfrm>
            <a:off x="4711444" y="2738554"/>
            <a:ext cx="881345" cy="323165"/>
          </a:xfrm>
          <a:prstGeom prst="rect">
            <a:avLst/>
          </a:prstGeom>
          <a:noFill/>
        </p:spPr>
        <p:txBody>
          <a:bodyPr wrap="square" lIns="91440" tIns="45720" rIns="91440" bIns="45720" anchor="t">
            <a:spAutoFit/>
          </a:bodyPr>
          <a:lstStyle/>
          <a:p>
            <a:pPr algn="ctr"/>
            <a:r>
              <a:rPr lang="en-GB" sz="500">
                <a:latin typeface="Calibri"/>
                <a:cs typeface="Calibri"/>
              </a:rPr>
              <a:t>39 of these genes were also significant in T74D RB- comparison </a:t>
            </a:r>
            <a:endParaRPr lang="en-GB" sz="1200"/>
          </a:p>
        </p:txBody>
      </p:sp>
      <p:sp>
        <p:nvSpPr>
          <p:cNvPr id="58" name="TextBox 57">
            <a:extLst>
              <a:ext uri="{FF2B5EF4-FFF2-40B4-BE49-F238E27FC236}">
                <a16:creationId xmlns:a16="http://schemas.microsoft.com/office/drawing/2014/main" id="{424E8B91-37D2-AABC-B4D1-B59E4F3FC8E5}"/>
              </a:ext>
            </a:extLst>
          </p:cNvPr>
          <p:cNvSpPr txBox="1"/>
          <p:nvPr/>
        </p:nvSpPr>
        <p:spPr>
          <a:xfrm>
            <a:off x="3963540" y="2732354"/>
            <a:ext cx="908606" cy="323165"/>
          </a:xfrm>
          <a:prstGeom prst="rect">
            <a:avLst/>
          </a:prstGeom>
          <a:noFill/>
        </p:spPr>
        <p:txBody>
          <a:bodyPr wrap="square">
            <a:spAutoFit/>
          </a:bodyPr>
          <a:lstStyle/>
          <a:p>
            <a:pPr algn="ctr"/>
            <a:r>
              <a:rPr lang="en-GB" sz="500">
                <a:latin typeface="Calibri"/>
                <a:cs typeface="Calibri"/>
              </a:rPr>
              <a:t>Total significant genes after </a:t>
            </a:r>
            <a:r>
              <a:rPr lang="en-GB" sz="500" err="1">
                <a:latin typeface="Calibri"/>
                <a:cs typeface="Calibri"/>
              </a:rPr>
              <a:t>fulvestrant</a:t>
            </a:r>
            <a:r>
              <a:rPr lang="en-GB" sz="500">
                <a:latin typeface="Calibri"/>
                <a:cs typeface="Calibri"/>
              </a:rPr>
              <a:t> monotherapy n=217 </a:t>
            </a:r>
            <a:endParaRPr lang="en-GB" sz="1200"/>
          </a:p>
        </p:txBody>
      </p:sp>
      <p:sp>
        <p:nvSpPr>
          <p:cNvPr id="59" name="TextBox 58">
            <a:extLst>
              <a:ext uri="{FF2B5EF4-FFF2-40B4-BE49-F238E27FC236}">
                <a16:creationId xmlns:a16="http://schemas.microsoft.com/office/drawing/2014/main" id="{286DA675-929D-E5C0-E2D1-54BC287F6809}"/>
              </a:ext>
            </a:extLst>
          </p:cNvPr>
          <p:cNvSpPr txBox="1"/>
          <p:nvPr/>
        </p:nvSpPr>
        <p:spPr>
          <a:xfrm>
            <a:off x="5463156" y="2736256"/>
            <a:ext cx="879571" cy="323165"/>
          </a:xfrm>
          <a:prstGeom prst="rect">
            <a:avLst/>
          </a:prstGeom>
          <a:noFill/>
        </p:spPr>
        <p:txBody>
          <a:bodyPr wrap="square" lIns="91440" tIns="45720" rIns="91440" bIns="45720" anchor="t">
            <a:spAutoFit/>
          </a:bodyPr>
          <a:lstStyle/>
          <a:p>
            <a:pPr algn="ctr"/>
            <a:r>
              <a:rPr lang="en-GB" sz="500">
                <a:latin typeface="Calibri"/>
                <a:cs typeface="Calibri"/>
              </a:rPr>
              <a:t>48 of these genes were also significant in T74D CDK6H comparison </a:t>
            </a:r>
            <a:endParaRPr lang="en-GB" sz="1200"/>
          </a:p>
        </p:txBody>
      </p:sp>
      <p:sp>
        <p:nvSpPr>
          <p:cNvPr id="60" name="TextBox 59">
            <a:extLst>
              <a:ext uri="{FF2B5EF4-FFF2-40B4-BE49-F238E27FC236}">
                <a16:creationId xmlns:a16="http://schemas.microsoft.com/office/drawing/2014/main" id="{10662019-6F45-78D5-0111-087FC48E63E5}"/>
              </a:ext>
            </a:extLst>
          </p:cNvPr>
          <p:cNvSpPr txBox="1"/>
          <p:nvPr/>
        </p:nvSpPr>
        <p:spPr>
          <a:xfrm>
            <a:off x="4721752" y="2519011"/>
            <a:ext cx="512974" cy="246221"/>
          </a:xfrm>
          <a:prstGeom prst="rect">
            <a:avLst/>
          </a:prstGeom>
          <a:noFill/>
        </p:spPr>
        <p:txBody>
          <a:bodyPr wrap="square" rtlCol="0">
            <a:spAutoFit/>
          </a:bodyPr>
          <a:lstStyle/>
          <a:p>
            <a:pPr algn="ctr"/>
            <a:r>
              <a:rPr lang="en-GB" sz="500">
                <a:solidFill>
                  <a:srgbClr val="080808"/>
                </a:solidFill>
              </a:rPr>
              <a:t>T47D RB- DMSO</a:t>
            </a:r>
          </a:p>
        </p:txBody>
      </p:sp>
      <p:sp>
        <p:nvSpPr>
          <p:cNvPr id="61" name="TextBox 60">
            <a:extLst>
              <a:ext uri="{FF2B5EF4-FFF2-40B4-BE49-F238E27FC236}">
                <a16:creationId xmlns:a16="http://schemas.microsoft.com/office/drawing/2014/main" id="{A0EAFFD8-C588-2ADD-3446-FFCEEA4FBE74}"/>
              </a:ext>
            </a:extLst>
          </p:cNvPr>
          <p:cNvSpPr txBox="1"/>
          <p:nvPr/>
        </p:nvSpPr>
        <p:spPr>
          <a:xfrm>
            <a:off x="4335283" y="2519011"/>
            <a:ext cx="512851" cy="246221"/>
          </a:xfrm>
          <a:prstGeom prst="rect">
            <a:avLst/>
          </a:prstGeom>
          <a:noFill/>
        </p:spPr>
        <p:txBody>
          <a:bodyPr wrap="square" rtlCol="0">
            <a:spAutoFit/>
          </a:bodyPr>
          <a:lstStyle/>
          <a:p>
            <a:pPr algn="ctr"/>
            <a:r>
              <a:rPr lang="en-GB" sz="500">
                <a:solidFill>
                  <a:srgbClr val="080808"/>
                </a:solidFill>
              </a:rPr>
              <a:t>T47D Parent fulvestrant</a:t>
            </a:r>
          </a:p>
        </p:txBody>
      </p:sp>
      <p:sp>
        <p:nvSpPr>
          <p:cNvPr id="62" name="TextBox 61">
            <a:extLst>
              <a:ext uri="{FF2B5EF4-FFF2-40B4-BE49-F238E27FC236}">
                <a16:creationId xmlns:a16="http://schemas.microsoft.com/office/drawing/2014/main" id="{E7BB07D2-9F51-5591-C89A-701E17F3D4BB}"/>
              </a:ext>
            </a:extLst>
          </p:cNvPr>
          <p:cNvSpPr txBox="1"/>
          <p:nvPr/>
        </p:nvSpPr>
        <p:spPr>
          <a:xfrm>
            <a:off x="3962986" y="2519011"/>
            <a:ext cx="541657" cy="246221"/>
          </a:xfrm>
          <a:prstGeom prst="rect">
            <a:avLst/>
          </a:prstGeom>
          <a:noFill/>
        </p:spPr>
        <p:txBody>
          <a:bodyPr wrap="square" rtlCol="0">
            <a:spAutoFit/>
          </a:bodyPr>
          <a:lstStyle/>
          <a:p>
            <a:pPr algn="ctr"/>
            <a:r>
              <a:rPr lang="en-GB" sz="500">
                <a:solidFill>
                  <a:srgbClr val="080808"/>
                </a:solidFill>
              </a:rPr>
              <a:t>T47D Parent DMSO</a:t>
            </a:r>
          </a:p>
        </p:txBody>
      </p:sp>
      <p:sp>
        <p:nvSpPr>
          <p:cNvPr id="63" name="TextBox 62">
            <a:extLst>
              <a:ext uri="{FF2B5EF4-FFF2-40B4-BE49-F238E27FC236}">
                <a16:creationId xmlns:a16="http://schemas.microsoft.com/office/drawing/2014/main" id="{BF342161-046B-D863-36B1-3E7F273DBED8}"/>
              </a:ext>
            </a:extLst>
          </p:cNvPr>
          <p:cNvSpPr txBox="1"/>
          <p:nvPr/>
        </p:nvSpPr>
        <p:spPr>
          <a:xfrm>
            <a:off x="5463460" y="2519011"/>
            <a:ext cx="512974" cy="246221"/>
          </a:xfrm>
          <a:prstGeom prst="rect">
            <a:avLst/>
          </a:prstGeom>
          <a:noFill/>
        </p:spPr>
        <p:txBody>
          <a:bodyPr wrap="square" rtlCol="0">
            <a:spAutoFit/>
          </a:bodyPr>
          <a:lstStyle/>
          <a:p>
            <a:pPr algn="ctr"/>
            <a:r>
              <a:rPr lang="en-GB" sz="500">
                <a:solidFill>
                  <a:srgbClr val="080808"/>
                </a:solidFill>
              </a:rPr>
              <a:t>T47D CDK6H DMSO</a:t>
            </a:r>
          </a:p>
        </p:txBody>
      </p:sp>
      <p:sp>
        <p:nvSpPr>
          <p:cNvPr id="64" name="TextBox 63">
            <a:extLst>
              <a:ext uri="{FF2B5EF4-FFF2-40B4-BE49-F238E27FC236}">
                <a16:creationId xmlns:a16="http://schemas.microsoft.com/office/drawing/2014/main" id="{5560BF61-7709-04DB-EFE6-B2C5BB7CAC4D}"/>
              </a:ext>
            </a:extLst>
          </p:cNvPr>
          <p:cNvSpPr txBox="1"/>
          <p:nvPr/>
        </p:nvSpPr>
        <p:spPr>
          <a:xfrm>
            <a:off x="5787021" y="2519011"/>
            <a:ext cx="552216" cy="246221"/>
          </a:xfrm>
          <a:prstGeom prst="rect">
            <a:avLst/>
          </a:prstGeom>
          <a:noFill/>
        </p:spPr>
        <p:txBody>
          <a:bodyPr wrap="square" rtlCol="0">
            <a:spAutoFit/>
          </a:bodyPr>
          <a:lstStyle/>
          <a:p>
            <a:pPr algn="ctr"/>
            <a:r>
              <a:rPr lang="en-GB" sz="500">
                <a:solidFill>
                  <a:srgbClr val="080808"/>
                </a:solidFill>
              </a:rPr>
              <a:t>T47D CDK6H </a:t>
            </a:r>
            <a:r>
              <a:rPr lang="en-GB" sz="500" err="1">
                <a:solidFill>
                  <a:srgbClr val="080808"/>
                </a:solidFill>
              </a:rPr>
              <a:t>fulvestrant</a:t>
            </a:r>
            <a:endParaRPr lang="en-GB" sz="500">
              <a:solidFill>
                <a:srgbClr val="080808"/>
              </a:solidFill>
            </a:endParaRPr>
          </a:p>
        </p:txBody>
      </p:sp>
      <p:sp>
        <p:nvSpPr>
          <p:cNvPr id="65" name="TextBox 64">
            <a:extLst>
              <a:ext uri="{FF2B5EF4-FFF2-40B4-BE49-F238E27FC236}">
                <a16:creationId xmlns:a16="http://schemas.microsoft.com/office/drawing/2014/main" id="{F1F4E139-A43D-EBB8-63C8-184AD796231A}"/>
              </a:ext>
            </a:extLst>
          </p:cNvPr>
          <p:cNvSpPr txBox="1"/>
          <p:nvPr/>
        </p:nvSpPr>
        <p:spPr>
          <a:xfrm>
            <a:off x="5088997" y="2519011"/>
            <a:ext cx="552216" cy="246221"/>
          </a:xfrm>
          <a:prstGeom prst="rect">
            <a:avLst/>
          </a:prstGeom>
          <a:noFill/>
        </p:spPr>
        <p:txBody>
          <a:bodyPr wrap="square" rtlCol="0">
            <a:spAutoFit/>
          </a:bodyPr>
          <a:lstStyle/>
          <a:p>
            <a:pPr algn="ctr"/>
            <a:r>
              <a:rPr lang="en-GB" sz="500">
                <a:solidFill>
                  <a:srgbClr val="080808"/>
                </a:solidFill>
              </a:rPr>
              <a:t>T47D RB- </a:t>
            </a:r>
            <a:r>
              <a:rPr lang="en-GB" sz="500" err="1">
                <a:solidFill>
                  <a:srgbClr val="080808"/>
                </a:solidFill>
              </a:rPr>
              <a:t>fulvestrant</a:t>
            </a:r>
            <a:endParaRPr lang="en-GB" sz="500">
              <a:solidFill>
                <a:srgbClr val="080808"/>
              </a:solidFill>
            </a:endParaRPr>
          </a:p>
        </p:txBody>
      </p:sp>
      <p:sp>
        <p:nvSpPr>
          <p:cNvPr id="66" name="TextBox 65">
            <a:extLst>
              <a:ext uri="{FF2B5EF4-FFF2-40B4-BE49-F238E27FC236}">
                <a16:creationId xmlns:a16="http://schemas.microsoft.com/office/drawing/2014/main" id="{DCCB3315-2A4F-E5FF-3DDD-88729D11F16B}"/>
              </a:ext>
            </a:extLst>
          </p:cNvPr>
          <p:cNvSpPr txBox="1"/>
          <p:nvPr/>
        </p:nvSpPr>
        <p:spPr>
          <a:xfrm>
            <a:off x="1677745" y="5392076"/>
            <a:ext cx="879267" cy="323165"/>
          </a:xfrm>
          <a:prstGeom prst="rect">
            <a:avLst/>
          </a:prstGeom>
          <a:noFill/>
        </p:spPr>
        <p:txBody>
          <a:bodyPr wrap="square" lIns="91440" tIns="45720" rIns="91440" bIns="45720" anchor="t">
            <a:spAutoFit/>
          </a:bodyPr>
          <a:lstStyle/>
          <a:p>
            <a:pPr algn="ctr"/>
            <a:r>
              <a:rPr lang="en-GB" sz="500">
                <a:latin typeface="Calibri"/>
                <a:cs typeface="Calibri"/>
              </a:rPr>
              <a:t>74 of these genes were also significant in MCF7 RB- comparison </a:t>
            </a:r>
            <a:endParaRPr lang="en-GB" sz="1200"/>
          </a:p>
        </p:txBody>
      </p:sp>
      <p:sp>
        <p:nvSpPr>
          <p:cNvPr id="67" name="TextBox 66">
            <a:extLst>
              <a:ext uri="{FF2B5EF4-FFF2-40B4-BE49-F238E27FC236}">
                <a16:creationId xmlns:a16="http://schemas.microsoft.com/office/drawing/2014/main" id="{7172F67C-E399-B320-5DAB-CED5E38E0849}"/>
              </a:ext>
            </a:extLst>
          </p:cNvPr>
          <p:cNvSpPr txBox="1"/>
          <p:nvPr/>
        </p:nvSpPr>
        <p:spPr>
          <a:xfrm>
            <a:off x="903651" y="5395289"/>
            <a:ext cx="908606" cy="323165"/>
          </a:xfrm>
          <a:prstGeom prst="rect">
            <a:avLst/>
          </a:prstGeom>
          <a:noFill/>
        </p:spPr>
        <p:txBody>
          <a:bodyPr wrap="square">
            <a:spAutoFit/>
          </a:bodyPr>
          <a:lstStyle/>
          <a:p>
            <a:pPr algn="ctr"/>
            <a:r>
              <a:rPr lang="en-GB" sz="500">
                <a:latin typeface="Calibri"/>
                <a:cs typeface="Calibri"/>
              </a:rPr>
              <a:t>Total significant genes after capivasertib monotherapy n=441 </a:t>
            </a:r>
            <a:endParaRPr lang="en-GB" sz="1200"/>
          </a:p>
        </p:txBody>
      </p:sp>
      <p:sp>
        <p:nvSpPr>
          <p:cNvPr id="68" name="TextBox 67">
            <a:extLst>
              <a:ext uri="{FF2B5EF4-FFF2-40B4-BE49-F238E27FC236}">
                <a16:creationId xmlns:a16="http://schemas.microsoft.com/office/drawing/2014/main" id="{0461FF12-1B9A-2790-8E5F-0498FFF8D80A}"/>
              </a:ext>
            </a:extLst>
          </p:cNvPr>
          <p:cNvSpPr txBox="1"/>
          <p:nvPr/>
        </p:nvSpPr>
        <p:spPr>
          <a:xfrm>
            <a:off x="2395423" y="5394298"/>
            <a:ext cx="850073" cy="323165"/>
          </a:xfrm>
          <a:prstGeom prst="rect">
            <a:avLst/>
          </a:prstGeom>
          <a:noFill/>
        </p:spPr>
        <p:txBody>
          <a:bodyPr wrap="square" lIns="91440" tIns="45720" rIns="91440" bIns="45720" anchor="t">
            <a:spAutoFit/>
          </a:bodyPr>
          <a:lstStyle/>
          <a:p>
            <a:pPr algn="ctr"/>
            <a:r>
              <a:rPr lang="en-GB" sz="500">
                <a:latin typeface="Calibri"/>
                <a:cs typeface="Calibri"/>
              </a:rPr>
              <a:t>35 of these genes were also significant in MCF7 </a:t>
            </a:r>
            <a:r>
              <a:rPr lang="en-GB" sz="500" err="1">
                <a:latin typeface="Calibri"/>
                <a:cs typeface="Calibri"/>
              </a:rPr>
              <a:t>PacqR</a:t>
            </a:r>
            <a:r>
              <a:rPr lang="en-GB" sz="500">
                <a:latin typeface="Calibri"/>
                <a:cs typeface="Calibri"/>
              </a:rPr>
              <a:t> comparison </a:t>
            </a:r>
            <a:endParaRPr lang="en-GB" sz="500"/>
          </a:p>
        </p:txBody>
      </p:sp>
      <p:sp>
        <p:nvSpPr>
          <p:cNvPr id="69" name="TextBox 68">
            <a:extLst>
              <a:ext uri="{FF2B5EF4-FFF2-40B4-BE49-F238E27FC236}">
                <a16:creationId xmlns:a16="http://schemas.microsoft.com/office/drawing/2014/main" id="{F9407A1F-A5B8-514F-9924-2686B7F9B5BF}"/>
              </a:ext>
            </a:extLst>
          </p:cNvPr>
          <p:cNvSpPr txBox="1"/>
          <p:nvPr/>
        </p:nvSpPr>
        <p:spPr>
          <a:xfrm>
            <a:off x="1668232" y="5189013"/>
            <a:ext cx="514594" cy="246221"/>
          </a:xfrm>
          <a:prstGeom prst="rect">
            <a:avLst/>
          </a:prstGeom>
          <a:noFill/>
        </p:spPr>
        <p:txBody>
          <a:bodyPr wrap="square" rtlCol="0">
            <a:spAutoFit/>
          </a:bodyPr>
          <a:lstStyle/>
          <a:p>
            <a:pPr algn="ctr"/>
            <a:r>
              <a:rPr lang="en-GB" sz="500"/>
              <a:t>MCF7 RB- DMSO</a:t>
            </a:r>
          </a:p>
        </p:txBody>
      </p:sp>
      <p:sp>
        <p:nvSpPr>
          <p:cNvPr id="70" name="TextBox 69">
            <a:extLst>
              <a:ext uri="{FF2B5EF4-FFF2-40B4-BE49-F238E27FC236}">
                <a16:creationId xmlns:a16="http://schemas.microsoft.com/office/drawing/2014/main" id="{0FB86B55-C36F-10F9-0E76-14FBDFC79695}"/>
              </a:ext>
            </a:extLst>
          </p:cNvPr>
          <p:cNvSpPr txBox="1"/>
          <p:nvPr/>
        </p:nvSpPr>
        <p:spPr>
          <a:xfrm>
            <a:off x="1288165" y="5189013"/>
            <a:ext cx="537421" cy="246221"/>
          </a:xfrm>
          <a:prstGeom prst="rect">
            <a:avLst/>
          </a:prstGeom>
          <a:noFill/>
        </p:spPr>
        <p:txBody>
          <a:bodyPr wrap="square" rtlCol="0">
            <a:spAutoFit/>
          </a:bodyPr>
          <a:lstStyle/>
          <a:p>
            <a:pPr algn="ctr"/>
            <a:r>
              <a:rPr lang="en-GB" sz="500"/>
              <a:t>MCF7 Parent capivasertib</a:t>
            </a:r>
          </a:p>
        </p:txBody>
      </p:sp>
      <p:sp>
        <p:nvSpPr>
          <p:cNvPr id="71" name="TextBox 70">
            <a:extLst>
              <a:ext uri="{FF2B5EF4-FFF2-40B4-BE49-F238E27FC236}">
                <a16:creationId xmlns:a16="http://schemas.microsoft.com/office/drawing/2014/main" id="{D31FE4FE-2B07-246A-6D61-CB94FEDC7D8D}"/>
              </a:ext>
            </a:extLst>
          </p:cNvPr>
          <p:cNvSpPr txBox="1"/>
          <p:nvPr/>
        </p:nvSpPr>
        <p:spPr>
          <a:xfrm>
            <a:off x="930391" y="5189013"/>
            <a:ext cx="537422" cy="246221"/>
          </a:xfrm>
          <a:prstGeom prst="rect">
            <a:avLst/>
          </a:prstGeom>
          <a:noFill/>
        </p:spPr>
        <p:txBody>
          <a:bodyPr wrap="square" rtlCol="0">
            <a:spAutoFit/>
          </a:bodyPr>
          <a:lstStyle/>
          <a:p>
            <a:pPr algn="ctr"/>
            <a:r>
              <a:rPr lang="en-GB" sz="500"/>
              <a:t>MCF7 Parent DMSO</a:t>
            </a:r>
          </a:p>
        </p:txBody>
      </p:sp>
      <p:sp>
        <p:nvSpPr>
          <p:cNvPr id="72" name="TextBox 71">
            <a:extLst>
              <a:ext uri="{FF2B5EF4-FFF2-40B4-BE49-F238E27FC236}">
                <a16:creationId xmlns:a16="http://schemas.microsoft.com/office/drawing/2014/main" id="{F6F6D018-DF1F-218C-AE75-068195864F75}"/>
              </a:ext>
            </a:extLst>
          </p:cNvPr>
          <p:cNvSpPr txBox="1"/>
          <p:nvPr/>
        </p:nvSpPr>
        <p:spPr>
          <a:xfrm>
            <a:off x="2388162" y="5189013"/>
            <a:ext cx="514594" cy="246221"/>
          </a:xfrm>
          <a:prstGeom prst="rect">
            <a:avLst/>
          </a:prstGeom>
          <a:noFill/>
        </p:spPr>
        <p:txBody>
          <a:bodyPr wrap="square" rtlCol="0">
            <a:spAutoFit/>
          </a:bodyPr>
          <a:lstStyle/>
          <a:p>
            <a:pPr algn="ctr"/>
            <a:r>
              <a:rPr lang="en-GB" sz="500"/>
              <a:t>MCF7 PacqR DMSO</a:t>
            </a:r>
          </a:p>
        </p:txBody>
      </p:sp>
      <p:sp>
        <p:nvSpPr>
          <p:cNvPr id="73" name="TextBox 72">
            <a:extLst>
              <a:ext uri="{FF2B5EF4-FFF2-40B4-BE49-F238E27FC236}">
                <a16:creationId xmlns:a16="http://schemas.microsoft.com/office/drawing/2014/main" id="{2E17E45C-EB2C-690C-887B-72AA7DFD9C6A}"/>
              </a:ext>
            </a:extLst>
          </p:cNvPr>
          <p:cNvSpPr txBox="1"/>
          <p:nvPr/>
        </p:nvSpPr>
        <p:spPr>
          <a:xfrm>
            <a:off x="2719937" y="5189013"/>
            <a:ext cx="553960" cy="246221"/>
          </a:xfrm>
          <a:prstGeom prst="rect">
            <a:avLst/>
          </a:prstGeom>
          <a:noFill/>
        </p:spPr>
        <p:txBody>
          <a:bodyPr wrap="square" rtlCol="0">
            <a:spAutoFit/>
          </a:bodyPr>
          <a:lstStyle/>
          <a:p>
            <a:pPr algn="ctr"/>
            <a:r>
              <a:rPr lang="en-GB" sz="500"/>
              <a:t>MCF7 PacqR capivasertib</a:t>
            </a:r>
          </a:p>
        </p:txBody>
      </p:sp>
      <p:sp>
        <p:nvSpPr>
          <p:cNvPr id="74" name="TextBox 73">
            <a:extLst>
              <a:ext uri="{FF2B5EF4-FFF2-40B4-BE49-F238E27FC236}">
                <a16:creationId xmlns:a16="http://schemas.microsoft.com/office/drawing/2014/main" id="{01F58F48-26F2-53AA-1B01-1A5C88B7B08B}"/>
              </a:ext>
            </a:extLst>
          </p:cNvPr>
          <p:cNvSpPr txBox="1"/>
          <p:nvPr/>
        </p:nvSpPr>
        <p:spPr>
          <a:xfrm>
            <a:off x="2002621" y="5189013"/>
            <a:ext cx="553960" cy="246221"/>
          </a:xfrm>
          <a:prstGeom prst="rect">
            <a:avLst/>
          </a:prstGeom>
          <a:noFill/>
        </p:spPr>
        <p:txBody>
          <a:bodyPr wrap="square" rtlCol="0">
            <a:spAutoFit/>
          </a:bodyPr>
          <a:lstStyle/>
          <a:p>
            <a:pPr algn="ctr"/>
            <a:r>
              <a:rPr lang="en-GB" sz="500"/>
              <a:t>MCF7 RB- capivasertib</a:t>
            </a:r>
          </a:p>
        </p:txBody>
      </p:sp>
      <p:sp>
        <p:nvSpPr>
          <p:cNvPr id="76" name="TextBox 75">
            <a:extLst>
              <a:ext uri="{FF2B5EF4-FFF2-40B4-BE49-F238E27FC236}">
                <a16:creationId xmlns:a16="http://schemas.microsoft.com/office/drawing/2014/main" id="{47952009-CEC1-F39D-0BA0-F9E0750F020C}"/>
              </a:ext>
            </a:extLst>
          </p:cNvPr>
          <p:cNvSpPr txBox="1"/>
          <p:nvPr/>
        </p:nvSpPr>
        <p:spPr>
          <a:xfrm>
            <a:off x="3949850" y="5395289"/>
            <a:ext cx="908606" cy="323165"/>
          </a:xfrm>
          <a:prstGeom prst="rect">
            <a:avLst/>
          </a:prstGeom>
          <a:noFill/>
        </p:spPr>
        <p:txBody>
          <a:bodyPr wrap="square">
            <a:spAutoFit/>
          </a:bodyPr>
          <a:lstStyle/>
          <a:p>
            <a:pPr algn="ctr"/>
            <a:r>
              <a:rPr lang="en-GB" sz="500">
                <a:latin typeface="Calibri"/>
                <a:cs typeface="Calibri"/>
              </a:rPr>
              <a:t>Total significant genes after fulvestrant monotherapy n=1161 </a:t>
            </a:r>
            <a:endParaRPr lang="en-GB" sz="1200"/>
          </a:p>
        </p:txBody>
      </p:sp>
      <p:sp>
        <p:nvSpPr>
          <p:cNvPr id="78" name="TextBox 77">
            <a:extLst>
              <a:ext uri="{FF2B5EF4-FFF2-40B4-BE49-F238E27FC236}">
                <a16:creationId xmlns:a16="http://schemas.microsoft.com/office/drawing/2014/main" id="{D9431240-81E7-8E6E-0013-8881AAF55974}"/>
              </a:ext>
            </a:extLst>
          </p:cNvPr>
          <p:cNvSpPr txBox="1"/>
          <p:nvPr/>
        </p:nvSpPr>
        <p:spPr>
          <a:xfrm>
            <a:off x="4715078" y="5189013"/>
            <a:ext cx="514594" cy="246221"/>
          </a:xfrm>
          <a:prstGeom prst="rect">
            <a:avLst/>
          </a:prstGeom>
          <a:noFill/>
        </p:spPr>
        <p:txBody>
          <a:bodyPr wrap="square" rtlCol="0">
            <a:spAutoFit/>
          </a:bodyPr>
          <a:lstStyle/>
          <a:p>
            <a:pPr algn="ctr"/>
            <a:r>
              <a:rPr lang="en-GB" sz="500"/>
              <a:t>MCF7 RB- DMSO</a:t>
            </a:r>
          </a:p>
        </p:txBody>
      </p:sp>
      <p:sp>
        <p:nvSpPr>
          <p:cNvPr id="79" name="TextBox 78">
            <a:extLst>
              <a:ext uri="{FF2B5EF4-FFF2-40B4-BE49-F238E27FC236}">
                <a16:creationId xmlns:a16="http://schemas.microsoft.com/office/drawing/2014/main" id="{BA860EC9-211F-7556-A355-AE3C68BD8805}"/>
              </a:ext>
            </a:extLst>
          </p:cNvPr>
          <p:cNvSpPr txBox="1"/>
          <p:nvPr/>
        </p:nvSpPr>
        <p:spPr>
          <a:xfrm>
            <a:off x="4317537" y="5189013"/>
            <a:ext cx="528857" cy="246221"/>
          </a:xfrm>
          <a:prstGeom prst="rect">
            <a:avLst/>
          </a:prstGeom>
          <a:noFill/>
        </p:spPr>
        <p:txBody>
          <a:bodyPr wrap="square" rtlCol="0">
            <a:spAutoFit/>
          </a:bodyPr>
          <a:lstStyle/>
          <a:p>
            <a:pPr algn="ctr"/>
            <a:r>
              <a:rPr lang="en-GB" sz="500"/>
              <a:t>MCF7 Parent fulvestrant</a:t>
            </a:r>
          </a:p>
        </p:txBody>
      </p:sp>
      <p:sp>
        <p:nvSpPr>
          <p:cNvPr id="80" name="TextBox 79">
            <a:extLst>
              <a:ext uri="{FF2B5EF4-FFF2-40B4-BE49-F238E27FC236}">
                <a16:creationId xmlns:a16="http://schemas.microsoft.com/office/drawing/2014/main" id="{FEEEAF26-48A9-444E-BCEC-8982B929454A}"/>
              </a:ext>
            </a:extLst>
          </p:cNvPr>
          <p:cNvSpPr txBox="1"/>
          <p:nvPr/>
        </p:nvSpPr>
        <p:spPr>
          <a:xfrm>
            <a:off x="3974217" y="5189013"/>
            <a:ext cx="528857" cy="246221"/>
          </a:xfrm>
          <a:prstGeom prst="rect">
            <a:avLst/>
          </a:prstGeom>
          <a:noFill/>
        </p:spPr>
        <p:txBody>
          <a:bodyPr wrap="square" rtlCol="0">
            <a:spAutoFit/>
          </a:bodyPr>
          <a:lstStyle/>
          <a:p>
            <a:pPr algn="ctr"/>
            <a:r>
              <a:rPr lang="en-GB" sz="500"/>
              <a:t>MCF7 Parent DMSO</a:t>
            </a:r>
          </a:p>
        </p:txBody>
      </p:sp>
      <p:sp>
        <p:nvSpPr>
          <p:cNvPr id="81" name="TextBox 80">
            <a:extLst>
              <a:ext uri="{FF2B5EF4-FFF2-40B4-BE49-F238E27FC236}">
                <a16:creationId xmlns:a16="http://schemas.microsoft.com/office/drawing/2014/main" id="{380720B3-70C1-7EB0-68F0-BF1DD7DF704C}"/>
              </a:ext>
            </a:extLst>
          </p:cNvPr>
          <p:cNvSpPr txBox="1"/>
          <p:nvPr/>
        </p:nvSpPr>
        <p:spPr>
          <a:xfrm>
            <a:off x="5456912" y="5189013"/>
            <a:ext cx="512974" cy="246221"/>
          </a:xfrm>
          <a:prstGeom prst="rect">
            <a:avLst/>
          </a:prstGeom>
          <a:noFill/>
        </p:spPr>
        <p:txBody>
          <a:bodyPr wrap="square" rtlCol="0">
            <a:spAutoFit/>
          </a:bodyPr>
          <a:lstStyle/>
          <a:p>
            <a:pPr algn="ctr"/>
            <a:r>
              <a:rPr lang="en-GB" sz="500"/>
              <a:t>MCF7 PacqR DMSO</a:t>
            </a:r>
          </a:p>
        </p:txBody>
      </p:sp>
      <p:sp>
        <p:nvSpPr>
          <p:cNvPr id="82" name="TextBox 81">
            <a:extLst>
              <a:ext uri="{FF2B5EF4-FFF2-40B4-BE49-F238E27FC236}">
                <a16:creationId xmlns:a16="http://schemas.microsoft.com/office/drawing/2014/main" id="{9047B7C2-24DF-3E98-AA5E-3E89D7294E53}"/>
              </a:ext>
            </a:extLst>
          </p:cNvPr>
          <p:cNvSpPr txBox="1"/>
          <p:nvPr/>
        </p:nvSpPr>
        <p:spPr>
          <a:xfrm>
            <a:off x="5787021" y="5189013"/>
            <a:ext cx="552216" cy="246221"/>
          </a:xfrm>
          <a:prstGeom prst="rect">
            <a:avLst/>
          </a:prstGeom>
          <a:noFill/>
        </p:spPr>
        <p:txBody>
          <a:bodyPr wrap="square" rtlCol="0">
            <a:spAutoFit/>
          </a:bodyPr>
          <a:lstStyle/>
          <a:p>
            <a:pPr algn="ctr"/>
            <a:r>
              <a:rPr lang="en-GB" sz="500"/>
              <a:t>MCF7 PacqR fulvestrant</a:t>
            </a:r>
          </a:p>
        </p:txBody>
      </p:sp>
      <p:sp>
        <p:nvSpPr>
          <p:cNvPr id="83" name="TextBox 82">
            <a:extLst>
              <a:ext uri="{FF2B5EF4-FFF2-40B4-BE49-F238E27FC236}">
                <a16:creationId xmlns:a16="http://schemas.microsoft.com/office/drawing/2014/main" id="{FB07AD9E-6F69-A0DB-8803-71DC9D11BD8C}"/>
              </a:ext>
            </a:extLst>
          </p:cNvPr>
          <p:cNvSpPr txBox="1"/>
          <p:nvPr/>
        </p:nvSpPr>
        <p:spPr>
          <a:xfrm>
            <a:off x="5052205" y="5189013"/>
            <a:ext cx="553960" cy="246221"/>
          </a:xfrm>
          <a:prstGeom prst="rect">
            <a:avLst/>
          </a:prstGeom>
          <a:noFill/>
        </p:spPr>
        <p:txBody>
          <a:bodyPr wrap="square" rtlCol="0">
            <a:spAutoFit/>
          </a:bodyPr>
          <a:lstStyle/>
          <a:p>
            <a:pPr algn="ctr"/>
            <a:r>
              <a:rPr lang="en-GB" sz="500"/>
              <a:t>MCF7 RB- fulvestrant</a:t>
            </a:r>
          </a:p>
        </p:txBody>
      </p:sp>
      <p:pic>
        <p:nvPicPr>
          <p:cNvPr id="10" name="Picture 9">
            <a:extLst>
              <a:ext uri="{FF2B5EF4-FFF2-40B4-BE49-F238E27FC236}">
                <a16:creationId xmlns:a16="http://schemas.microsoft.com/office/drawing/2014/main" id="{9A77F6DA-6E29-A54E-CF26-B84597DB730D}"/>
              </a:ext>
            </a:extLst>
          </p:cNvPr>
          <p:cNvPicPr>
            <a:picLocks noChangeAspect="1"/>
          </p:cNvPicPr>
          <p:nvPr/>
        </p:nvPicPr>
        <p:blipFill rotWithShape="1">
          <a:blip r:embed="rId5"/>
          <a:srcRect l="61830" t="1" r="32495" b="68077"/>
          <a:stretch/>
        </p:blipFill>
        <p:spPr>
          <a:xfrm>
            <a:off x="3618761" y="3939686"/>
            <a:ext cx="172170" cy="765836"/>
          </a:xfrm>
          <a:prstGeom prst="rect">
            <a:avLst/>
          </a:prstGeom>
        </p:spPr>
      </p:pic>
      <p:sp>
        <p:nvSpPr>
          <p:cNvPr id="16" name="TextBox 9">
            <a:extLst>
              <a:ext uri="{FF2B5EF4-FFF2-40B4-BE49-F238E27FC236}">
                <a16:creationId xmlns:a16="http://schemas.microsoft.com/office/drawing/2014/main" id="{872303DE-6925-57CD-A06B-15C783D5AAF9}"/>
              </a:ext>
            </a:extLst>
          </p:cNvPr>
          <p:cNvSpPr txBox="1"/>
          <p:nvPr/>
        </p:nvSpPr>
        <p:spPr>
          <a:xfrm>
            <a:off x="4843468" y="5389438"/>
            <a:ext cx="879267" cy="323165"/>
          </a:xfrm>
          <a:prstGeom prst="rect">
            <a:avLst/>
          </a:prstGeom>
          <a:noFill/>
        </p:spPr>
        <p:txBody>
          <a:bodyPr wrap="square">
            <a:spAutoFit/>
          </a:bodyPr>
          <a:lstStyle/>
          <a:p>
            <a:pPr algn="ctr"/>
            <a:r>
              <a:rPr lang="en-GB" sz="500">
                <a:latin typeface="Calibri"/>
                <a:cs typeface="Calibri"/>
              </a:rPr>
              <a:t>48 of these genes were also significant in MCF7 RB- comparison </a:t>
            </a:r>
            <a:endParaRPr lang="en-GB" sz="1200"/>
          </a:p>
        </p:txBody>
      </p:sp>
      <p:sp>
        <p:nvSpPr>
          <p:cNvPr id="12" name="TextBox 11">
            <a:extLst>
              <a:ext uri="{FF2B5EF4-FFF2-40B4-BE49-F238E27FC236}">
                <a16:creationId xmlns:a16="http://schemas.microsoft.com/office/drawing/2014/main" id="{0187B152-845C-98A6-EE54-54AD2E906E4E}"/>
              </a:ext>
            </a:extLst>
          </p:cNvPr>
          <p:cNvSpPr txBox="1"/>
          <p:nvPr/>
        </p:nvSpPr>
        <p:spPr>
          <a:xfrm>
            <a:off x="5560937" y="5386799"/>
            <a:ext cx="889113" cy="323165"/>
          </a:xfrm>
          <a:prstGeom prst="rect">
            <a:avLst/>
          </a:prstGeom>
          <a:noFill/>
        </p:spPr>
        <p:txBody>
          <a:bodyPr wrap="square">
            <a:spAutoFit/>
          </a:bodyPr>
          <a:lstStyle/>
          <a:p>
            <a:pPr algn="ctr"/>
            <a:r>
              <a:rPr lang="en-GB" sz="500">
                <a:latin typeface="Calibri"/>
                <a:cs typeface="Calibri"/>
              </a:rPr>
              <a:t>255 of these genes were also significant in MCF7 </a:t>
            </a:r>
            <a:r>
              <a:rPr lang="en-GB" sz="500" err="1">
                <a:latin typeface="Calibri"/>
                <a:cs typeface="Calibri"/>
              </a:rPr>
              <a:t>PacqR</a:t>
            </a:r>
            <a:r>
              <a:rPr lang="en-GB" sz="500">
                <a:latin typeface="Calibri"/>
                <a:cs typeface="Calibri"/>
              </a:rPr>
              <a:t> comparison </a:t>
            </a:r>
            <a:endParaRPr lang="en-GB" sz="500"/>
          </a:p>
        </p:txBody>
      </p:sp>
    </p:spTree>
    <p:extLst>
      <p:ext uri="{BB962C8B-B14F-4D97-AF65-F5344CB8AC3E}">
        <p14:creationId xmlns:p14="http://schemas.microsoft.com/office/powerpoint/2010/main" val="322078622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5ED4491D-E78B-441E-80CE-35F22141D8AA}"/>
              </a:ext>
            </a:extLst>
          </p:cNvPr>
          <p:cNvSpPr txBox="1"/>
          <p:nvPr/>
        </p:nvSpPr>
        <p:spPr>
          <a:xfrm>
            <a:off x="327244" y="140077"/>
            <a:ext cx="6202185" cy="292388"/>
          </a:xfrm>
          <a:prstGeom prst="rect">
            <a:avLst/>
          </a:prstGeom>
          <a:noFill/>
        </p:spPr>
        <p:txBody>
          <a:bodyPr wrap="square" lIns="91440" tIns="45720" rIns="91440" bIns="45720" rtlCol="0" anchor="t">
            <a:spAutoFit/>
          </a:bodyPr>
          <a:lstStyle/>
          <a:p>
            <a:r>
              <a:rPr lang="en-GB" sz="1300"/>
              <a:t>Supplementary Figure 6</a:t>
            </a:r>
          </a:p>
        </p:txBody>
      </p:sp>
      <p:grpSp>
        <p:nvGrpSpPr>
          <p:cNvPr id="4" name="Group 3">
            <a:extLst>
              <a:ext uri="{FF2B5EF4-FFF2-40B4-BE49-F238E27FC236}">
                <a16:creationId xmlns:a16="http://schemas.microsoft.com/office/drawing/2014/main" id="{569CAF28-BD1B-48C9-9E51-BAB32D06F495}"/>
              </a:ext>
            </a:extLst>
          </p:cNvPr>
          <p:cNvGrpSpPr/>
          <p:nvPr/>
        </p:nvGrpSpPr>
        <p:grpSpPr>
          <a:xfrm>
            <a:off x="309562" y="455349"/>
            <a:ext cx="6200776" cy="5027874"/>
            <a:chOff x="-2449885" y="2237683"/>
            <a:chExt cx="8745369" cy="7148815"/>
          </a:xfrm>
        </p:grpSpPr>
        <p:sp>
          <p:nvSpPr>
            <p:cNvPr id="8" name="TextBox 7">
              <a:extLst>
                <a:ext uri="{FF2B5EF4-FFF2-40B4-BE49-F238E27FC236}">
                  <a16:creationId xmlns:a16="http://schemas.microsoft.com/office/drawing/2014/main" id="{BAA779E0-A6DB-4690-9B6D-7EE4C82E7B1A}"/>
                </a:ext>
              </a:extLst>
            </p:cNvPr>
            <p:cNvSpPr txBox="1"/>
            <p:nvPr/>
          </p:nvSpPr>
          <p:spPr>
            <a:xfrm>
              <a:off x="-2426788" y="2237683"/>
              <a:ext cx="5746079" cy="473463"/>
            </a:xfrm>
            <a:prstGeom prst="rect">
              <a:avLst/>
            </a:prstGeom>
            <a:noFill/>
          </p:spPr>
          <p:txBody>
            <a:bodyPr wrap="square" lIns="91440" tIns="45720" rIns="91440" bIns="45720" rtlCol="0" anchor="t">
              <a:spAutoFit/>
            </a:bodyPr>
            <a:lstStyle/>
            <a:p>
              <a:pPr>
                <a:lnSpc>
                  <a:spcPct val="90000"/>
                </a:lnSpc>
                <a:spcAft>
                  <a:spcPts val="254"/>
                </a:spcAft>
              </a:pPr>
              <a:r>
                <a:rPr lang="en-GB" sz="1200" b="1"/>
                <a:t>A </a:t>
              </a:r>
              <a:r>
                <a:rPr lang="en-GB" sz="1350"/>
                <a:t>PDX Model palbociclib sensitivity</a:t>
              </a:r>
            </a:p>
          </p:txBody>
        </p:sp>
        <p:graphicFrame>
          <p:nvGraphicFramePr>
            <p:cNvPr id="2" name="Object 1">
              <a:extLst>
                <a:ext uri="{FF2B5EF4-FFF2-40B4-BE49-F238E27FC236}">
                  <a16:creationId xmlns:a16="http://schemas.microsoft.com/office/drawing/2014/main" id="{C5A22C0E-C103-4BC0-A70C-7F1503A8C1C5}"/>
                </a:ext>
              </a:extLst>
            </p:cNvPr>
            <p:cNvGraphicFramePr>
              <a:graphicFrameLocks noChangeAspect="1"/>
            </p:cNvGraphicFramePr>
            <p:nvPr>
              <p:extLst>
                <p:ext uri="{D42A27DB-BD31-4B8C-83A1-F6EECF244321}">
                  <p14:modId xmlns:p14="http://schemas.microsoft.com/office/powerpoint/2010/main" val="3645604040"/>
                </p:ext>
              </p:extLst>
            </p:nvPr>
          </p:nvGraphicFramePr>
          <p:xfrm>
            <a:off x="-2449885" y="2754948"/>
            <a:ext cx="8745369" cy="6631550"/>
          </p:xfrm>
          <a:graphic>
            <a:graphicData uri="http://schemas.openxmlformats.org/presentationml/2006/ole">
              <mc:AlternateContent xmlns:mc="http://schemas.openxmlformats.org/markup-compatibility/2006">
                <mc:Choice xmlns:v="urn:schemas-microsoft-com:vml" Requires="v">
                  <p:oleObj name="Prism 8" r:id="rId3" imgW="6994916" imgH="5307230" progId="Prism8.Document">
                    <p:embed/>
                  </p:oleObj>
                </mc:Choice>
                <mc:Fallback>
                  <p:oleObj name="Prism 8" r:id="rId3" imgW="6994916" imgH="5307230" progId="Prism8.Document">
                    <p:embed/>
                    <p:pic>
                      <p:nvPicPr>
                        <p:cNvPr id="2" name="Object 1">
                          <a:extLst>
                            <a:ext uri="{FF2B5EF4-FFF2-40B4-BE49-F238E27FC236}">
                              <a16:creationId xmlns:a16="http://schemas.microsoft.com/office/drawing/2014/main" id="{C5A22C0E-C103-4BC0-A70C-7F1503A8C1C5}"/>
                            </a:ext>
                          </a:extLst>
                        </p:cNvPr>
                        <p:cNvPicPr/>
                        <p:nvPr/>
                      </p:nvPicPr>
                      <p:blipFill>
                        <a:blip r:embed="rId4"/>
                        <a:stretch>
                          <a:fillRect/>
                        </a:stretch>
                      </p:blipFill>
                      <p:spPr>
                        <a:xfrm>
                          <a:off x="-2449885" y="2754948"/>
                          <a:ext cx="8745369" cy="6631550"/>
                        </a:xfrm>
                        <a:prstGeom prst="rect">
                          <a:avLst/>
                        </a:prstGeom>
                      </p:spPr>
                    </p:pic>
                  </p:oleObj>
                </mc:Fallback>
              </mc:AlternateContent>
            </a:graphicData>
          </a:graphic>
        </p:graphicFrame>
      </p:grpSp>
    </p:spTree>
    <p:extLst>
      <p:ext uri="{BB962C8B-B14F-4D97-AF65-F5344CB8AC3E}">
        <p14:creationId xmlns:p14="http://schemas.microsoft.com/office/powerpoint/2010/main" val="19923585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0475FDF5-3F28-F449-F6B0-9C2E08286F81}"/>
              </a:ext>
            </a:extLst>
          </p:cNvPr>
          <p:cNvSpPr txBox="1"/>
          <p:nvPr/>
        </p:nvSpPr>
        <p:spPr>
          <a:xfrm>
            <a:off x="109799" y="456750"/>
            <a:ext cx="231458" cy="279307"/>
          </a:xfrm>
          <a:prstGeom prst="rect">
            <a:avLst/>
          </a:prstGeom>
          <a:noFill/>
        </p:spPr>
        <p:txBody>
          <a:bodyPr wrap="square" rtlCol="0">
            <a:spAutoFit/>
          </a:bodyPr>
          <a:lstStyle/>
          <a:p>
            <a:pPr>
              <a:lnSpc>
                <a:spcPct val="90000"/>
              </a:lnSpc>
              <a:spcAft>
                <a:spcPts val="254"/>
              </a:spcAft>
            </a:pPr>
            <a:r>
              <a:rPr lang="en-GB" sz="1350" b="1"/>
              <a:t>A</a:t>
            </a:r>
          </a:p>
        </p:txBody>
      </p:sp>
      <p:sp>
        <p:nvSpPr>
          <p:cNvPr id="16" name="TextBox 15">
            <a:extLst>
              <a:ext uri="{FF2B5EF4-FFF2-40B4-BE49-F238E27FC236}">
                <a16:creationId xmlns:a16="http://schemas.microsoft.com/office/drawing/2014/main" id="{3526AB64-B27B-87D2-21E8-A0AF9FEB2CAD}"/>
              </a:ext>
            </a:extLst>
          </p:cNvPr>
          <p:cNvSpPr txBox="1"/>
          <p:nvPr/>
        </p:nvSpPr>
        <p:spPr>
          <a:xfrm>
            <a:off x="4739175" y="839246"/>
            <a:ext cx="231458" cy="279307"/>
          </a:xfrm>
          <a:prstGeom prst="rect">
            <a:avLst/>
          </a:prstGeom>
          <a:noFill/>
        </p:spPr>
        <p:txBody>
          <a:bodyPr wrap="square" rtlCol="0">
            <a:spAutoFit/>
          </a:bodyPr>
          <a:lstStyle/>
          <a:p>
            <a:pPr>
              <a:lnSpc>
                <a:spcPct val="90000"/>
              </a:lnSpc>
              <a:spcAft>
                <a:spcPts val="254"/>
              </a:spcAft>
            </a:pPr>
            <a:r>
              <a:rPr lang="en-GB" sz="1350" b="1" dirty="0"/>
              <a:t>B</a:t>
            </a:r>
          </a:p>
        </p:txBody>
      </p:sp>
      <p:sp>
        <p:nvSpPr>
          <p:cNvPr id="24" name="TextBox 23">
            <a:extLst>
              <a:ext uri="{FF2B5EF4-FFF2-40B4-BE49-F238E27FC236}">
                <a16:creationId xmlns:a16="http://schemas.microsoft.com/office/drawing/2014/main" id="{17F050F3-5194-D186-0D19-8152169D6E3F}"/>
              </a:ext>
            </a:extLst>
          </p:cNvPr>
          <p:cNvSpPr txBox="1"/>
          <p:nvPr/>
        </p:nvSpPr>
        <p:spPr>
          <a:xfrm>
            <a:off x="220455" y="7381308"/>
            <a:ext cx="231458" cy="279307"/>
          </a:xfrm>
          <a:prstGeom prst="rect">
            <a:avLst/>
          </a:prstGeom>
          <a:noFill/>
        </p:spPr>
        <p:txBody>
          <a:bodyPr wrap="square" rtlCol="0">
            <a:spAutoFit/>
          </a:bodyPr>
          <a:lstStyle/>
          <a:p>
            <a:pPr>
              <a:lnSpc>
                <a:spcPct val="90000"/>
              </a:lnSpc>
              <a:spcAft>
                <a:spcPts val="254"/>
              </a:spcAft>
            </a:pPr>
            <a:r>
              <a:rPr lang="en-GB" sz="1350" b="1" dirty="0"/>
              <a:t>C</a:t>
            </a:r>
          </a:p>
        </p:txBody>
      </p:sp>
      <p:graphicFrame>
        <p:nvGraphicFramePr>
          <p:cNvPr id="35" name="Object 34">
            <a:extLst>
              <a:ext uri="{FF2B5EF4-FFF2-40B4-BE49-F238E27FC236}">
                <a16:creationId xmlns:a16="http://schemas.microsoft.com/office/drawing/2014/main" id="{A4058A3D-3223-33B0-2E24-C41CA2CD53EB}"/>
              </a:ext>
            </a:extLst>
          </p:cNvPr>
          <p:cNvGraphicFramePr>
            <a:graphicFrameLocks noChangeAspect="1"/>
          </p:cNvGraphicFramePr>
          <p:nvPr>
            <p:extLst>
              <p:ext uri="{D42A27DB-BD31-4B8C-83A1-F6EECF244321}">
                <p14:modId xmlns:p14="http://schemas.microsoft.com/office/powerpoint/2010/main" val="2742792300"/>
              </p:ext>
            </p:extLst>
          </p:nvPr>
        </p:nvGraphicFramePr>
        <p:xfrm>
          <a:off x="546411" y="7687676"/>
          <a:ext cx="1238250" cy="876300"/>
        </p:xfrm>
        <a:graphic>
          <a:graphicData uri="http://schemas.openxmlformats.org/presentationml/2006/ole">
            <mc:AlternateContent xmlns:mc="http://schemas.openxmlformats.org/markup-compatibility/2006">
              <mc:Choice xmlns:v="urn:schemas-microsoft-com:vml" Requires="v">
                <p:oleObj name="Prism 8" r:id="rId3" imgW="5351199" imgH="3774014" progId="Prism8.Document">
                  <p:embed/>
                </p:oleObj>
              </mc:Choice>
              <mc:Fallback>
                <p:oleObj name="Prism 8" r:id="rId3" imgW="5351199" imgH="3774014" progId="Prism8.Document">
                  <p:embed/>
                  <p:pic>
                    <p:nvPicPr>
                      <p:cNvPr id="35" name="Object 34">
                        <a:extLst>
                          <a:ext uri="{FF2B5EF4-FFF2-40B4-BE49-F238E27FC236}">
                            <a16:creationId xmlns:a16="http://schemas.microsoft.com/office/drawing/2014/main" id="{A4058A3D-3223-33B0-2E24-C41CA2CD53EB}"/>
                          </a:ext>
                        </a:extLst>
                      </p:cNvPr>
                      <p:cNvPicPr/>
                      <p:nvPr/>
                    </p:nvPicPr>
                    <p:blipFill>
                      <a:blip r:embed="rId4"/>
                      <a:stretch>
                        <a:fillRect/>
                      </a:stretch>
                    </p:blipFill>
                    <p:spPr>
                      <a:xfrm>
                        <a:off x="546411" y="7687676"/>
                        <a:ext cx="1238250" cy="876300"/>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9BD7B739-1E3D-955C-2E6F-F70A120EE103}"/>
              </a:ext>
            </a:extLst>
          </p:cNvPr>
          <p:cNvGraphicFramePr>
            <a:graphicFrameLocks noChangeAspect="1"/>
          </p:cNvGraphicFramePr>
          <p:nvPr>
            <p:extLst>
              <p:ext uri="{D42A27DB-BD31-4B8C-83A1-F6EECF244321}">
                <p14:modId xmlns:p14="http://schemas.microsoft.com/office/powerpoint/2010/main" val="3209406251"/>
              </p:ext>
            </p:extLst>
          </p:nvPr>
        </p:nvGraphicFramePr>
        <p:xfrm>
          <a:off x="549187" y="8594138"/>
          <a:ext cx="1231900" cy="974725"/>
        </p:xfrm>
        <a:graphic>
          <a:graphicData uri="http://schemas.openxmlformats.org/presentationml/2006/ole">
            <mc:AlternateContent xmlns:mc="http://schemas.openxmlformats.org/markup-compatibility/2006">
              <mc:Choice xmlns:v="urn:schemas-microsoft-com:vml" Requires="v">
                <p:oleObj name="Prism 8" r:id="rId5" imgW="5211145" imgH="4124340" progId="Prism8.Document">
                  <p:embed/>
                </p:oleObj>
              </mc:Choice>
              <mc:Fallback>
                <p:oleObj name="Prism 8" r:id="rId5" imgW="5211145" imgH="4124340" progId="Prism8.Document">
                  <p:embed/>
                  <p:pic>
                    <p:nvPicPr>
                      <p:cNvPr id="36" name="Object 35">
                        <a:extLst>
                          <a:ext uri="{FF2B5EF4-FFF2-40B4-BE49-F238E27FC236}">
                            <a16:creationId xmlns:a16="http://schemas.microsoft.com/office/drawing/2014/main" id="{9BD7B739-1E3D-955C-2E6F-F70A120EE103}"/>
                          </a:ext>
                        </a:extLst>
                      </p:cNvPr>
                      <p:cNvPicPr/>
                      <p:nvPr/>
                    </p:nvPicPr>
                    <p:blipFill>
                      <a:blip r:embed="rId6"/>
                      <a:stretch>
                        <a:fillRect/>
                      </a:stretch>
                    </p:blipFill>
                    <p:spPr>
                      <a:xfrm>
                        <a:off x="549187" y="8594138"/>
                        <a:ext cx="1231900" cy="974725"/>
                      </a:xfrm>
                      <a:prstGeom prst="rect">
                        <a:avLst/>
                      </a:prstGeom>
                    </p:spPr>
                  </p:pic>
                </p:oleObj>
              </mc:Fallback>
            </mc:AlternateContent>
          </a:graphicData>
        </a:graphic>
      </p:graphicFrame>
      <p:graphicFrame>
        <p:nvGraphicFramePr>
          <p:cNvPr id="37" name="Object 36">
            <a:extLst>
              <a:ext uri="{FF2B5EF4-FFF2-40B4-BE49-F238E27FC236}">
                <a16:creationId xmlns:a16="http://schemas.microsoft.com/office/drawing/2014/main" id="{55709A9B-B64A-093A-A42B-A66E14DEF1C9}"/>
              </a:ext>
            </a:extLst>
          </p:cNvPr>
          <p:cNvGraphicFramePr>
            <a:graphicFrameLocks noChangeAspect="1"/>
          </p:cNvGraphicFramePr>
          <p:nvPr>
            <p:extLst>
              <p:ext uri="{D42A27DB-BD31-4B8C-83A1-F6EECF244321}">
                <p14:modId xmlns:p14="http://schemas.microsoft.com/office/powerpoint/2010/main" val="59681236"/>
              </p:ext>
            </p:extLst>
          </p:nvPr>
        </p:nvGraphicFramePr>
        <p:xfrm>
          <a:off x="1765611" y="7687677"/>
          <a:ext cx="1244600" cy="876300"/>
        </p:xfrm>
        <a:graphic>
          <a:graphicData uri="http://schemas.openxmlformats.org/presentationml/2006/ole">
            <mc:AlternateContent xmlns:mc="http://schemas.openxmlformats.org/markup-compatibility/2006">
              <mc:Choice xmlns:v="urn:schemas-microsoft-com:vml" Requires="v">
                <p:oleObj name="Prism 8" r:id="rId7" imgW="5211145" imgH="3452492" progId="Prism8.Document">
                  <p:embed/>
                </p:oleObj>
              </mc:Choice>
              <mc:Fallback>
                <p:oleObj name="Prism 8" r:id="rId7" imgW="5211145" imgH="3452492" progId="Prism8.Document">
                  <p:embed/>
                  <p:pic>
                    <p:nvPicPr>
                      <p:cNvPr id="37" name="Object 36">
                        <a:extLst>
                          <a:ext uri="{FF2B5EF4-FFF2-40B4-BE49-F238E27FC236}">
                            <a16:creationId xmlns:a16="http://schemas.microsoft.com/office/drawing/2014/main" id="{55709A9B-B64A-093A-A42B-A66E14DEF1C9}"/>
                          </a:ext>
                        </a:extLst>
                      </p:cNvPr>
                      <p:cNvPicPr/>
                      <p:nvPr/>
                    </p:nvPicPr>
                    <p:blipFill>
                      <a:blip r:embed="rId8"/>
                      <a:stretch>
                        <a:fillRect/>
                      </a:stretch>
                    </p:blipFill>
                    <p:spPr>
                      <a:xfrm>
                        <a:off x="1765611" y="7687677"/>
                        <a:ext cx="1244600" cy="876300"/>
                      </a:xfrm>
                      <a:prstGeom prst="rect">
                        <a:avLst/>
                      </a:prstGeom>
                    </p:spPr>
                  </p:pic>
                </p:oleObj>
              </mc:Fallback>
            </mc:AlternateContent>
          </a:graphicData>
        </a:graphic>
      </p:graphicFrame>
      <p:graphicFrame>
        <p:nvGraphicFramePr>
          <p:cNvPr id="38" name="Object 37">
            <a:extLst>
              <a:ext uri="{FF2B5EF4-FFF2-40B4-BE49-F238E27FC236}">
                <a16:creationId xmlns:a16="http://schemas.microsoft.com/office/drawing/2014/main" id="{06CB48F0-8299-287A-A155-249ECD8715AC}"/>
              </a:ext>
            </a:extLst>
          </p:cNvPr>
          <p:cNvGraphicFramePr>
            <a:graphicFrameLocks noChangeAspect="1"/>
          </p:cNvGraphicFramePr>
          <p:nvPr>
            <p:extLst>
              <p:ext uri="{D42A27DB-BD31-4B8C-83A1-F6EECF244321}">
                <p14:modId xmlns:p14="http://schemas.microsoft.com/office/powerpoint/2010/main" val="1176865963"/>
              </p:ext>
            </p:extLst>
          </p:nvPr>
        </p:nvGraphicFramePr>
        <p:xfrm>
          <a:off x="1772950" y="8594138"/>
          <a:ext cx="1233487" cy="974725"/>
        </p:xfrm>
        <a:graphic>
          <a:graphicData uri="http://schemas.openxmlformats.org/presentationml/2006/ole">
            <mc:AlternateContent xmlns:mc="http://schemas.openxmlformats.org/markup-compatibility/2006">
              <mc:Choice xmlns:v="urn:schemas-microsoft-com:vml" Requires="v">
                <p:oleObj name="Prism 8" r:id="rId9" imgW="5147059" imgH="3717487" progId="Prism8.Document">
                  <p:embed/>
                </p:oleObj>
              </mc:Choice>
              <mc:Fallback>
                <p:oleObj name="Prism 8" r:id="rId9" imgW="5147059" imgH="3717487" progId="Prism8.Document">
                  <p:embed/>
                  <p:pic>
                    <p:nvPicPr>
                      <p:cNvPr id="38" name="Object 37">
                        <a:extLst>
                          <a:ext uri="{FF2B5EF4-FFF2-40B4-BE49-F238E27FC236}">
                            <a16:creationId xmlns:a16="http://schemas.microsoft.com/office/drawing/2014/main" id="{06CB48F0-8299-287A-A155-249ECD8715AC}"/>
                          </a:ext>
                        </a:extLst>
                      </p:cNvPr>
                      <p:cNvPicPr/>
                      <p:nvPr/>
                    </p:nvPicPr>
                    <p:blipFill>
                      <a:blip r:embed="rId10"/>
                      <a:stretch>
                        <a:fillRect/>
                      </a:stretch>
                    </p:blipFill>
                    <p:spPr>
                      <a:xfrm>
                        <a:off x="1772950" y="8594138"/>
                        <a:ext cx="1233487" cy="974725"/>
                      </a:xfrm>
                      <a:prstGeom prst="rect">
                        <a:avLst/>
                      </a:prstGeom>
                    </p:spPr>
                  </p:pic>
                </p:oleObj>
              </mc:Fallback>
            </mc:AlternateContent>
          </a:graphicData>
        </a:graphic>
      </p:graphicFrame>
      <p:graphicFrame>
        <p:nvGraphicFramePr>
          <p:cNvPr id="39" name="Object 38">
            <a:extLst>
              <a:ext uri="{FF2B5EF4-FFF2-40B4-BE49-F238E27FC236}">
                <a16:creationId xmlns:a16="http://schemas.microsoft.com/office/drawing/2014/main" id="{CF9B2906-1C81-85C8-C863-A620A2E4297C}"/>
              </a:ext>
            </a:extLst>
          </p:cNvPr>
          <p:cNvGraphicFramePr>
            <a:graphicFrameLocks noChangeAspect="1"/>
          </p:cNvGraphicFramePr>
          <p:nvPr>
            <p:extLst>
              <p:ext uri="{D42A27DB-BD31-4B8C-83A1-F6EECF244321}">
                <p14:modId xmlns:p14="http://schemas.microsoft.com/office/powerpoint/2010/main" val="1507921293"/>
              </p:ext>
            </p:extLst>
          </p:nvPr>
        </p:nvGraphicFramePr>
        <p:xfrm>
          <a:off x="2989573" y="7687676"/>
          <a:ext cx="1260475" cy="876300"/>
        </p:xfrm>
        <a:graphic>
          <a:graphicData uri="http://schemas.openxmlformats.org/presentationml/2006/ole">
            <mc:AlternateContent xmlns:mc="http://schemas.openxmlformats.org/markup-compatibility/2006">
              <mc:Choice xmlns:v="urn:schemas-microsoft-com:vml" Requires="v">
                <p:oleObj name="Prism 8" r:id="rId11" imgW="5211145" imgH="3203699" progId="Prism8.Document">
                  <p:embed/>
                </p:oleObj>
              </mc:Choice>
              <mc:Fallback>
                <p:oleObj name="Prism 8" r:id="rId11" imgW="5211145" imgH="3203699" progId="Prism8.Document">
                  <p:embed/>
                  <p:pic>
                    <p:nvPicPr>
                      <p:cNvPr id="39" name="Object 38">
                        <a:extLst>
                          <a:ext uri="{FF2B5EF4-FFF2-40B4-BE49-F238E27FC236}">
                            <a16:creationId xmlns:a16="http://schemas.microsoft.com/office/drawing/2014/main" id="{CF9B2906-1C81-85C8-C863-A620A2E4297C}"/>
                          </a:ext>
                        </a:extLst>
                      </p:cNvPr>
                      <p:cNvPicPr/>
                      <p:nvPr/>
                    </p:nvPicPr>
                    <p:blipFill>
                      <a:blip r:embed="rId12"/>
                      <a:stretch>
                        <a:fillRect/>
                      </a:stretch>
                    </p:blipFill>
                    <p:spPr>
                      <a:xfrm>
                        <a:off x="2989573" y="7687676"/>
                        <a:ext cx="1260475" cy="876300"/>
                      </a:xfrm>
                      <a:prstGeom prst="rect">
                        <a:avLst/>
                      </a:prstGeom>
                    </p:spPr>
                  </p:pic>
                </p:oleObj>
              </mc:Fallback>
            </mc:AlternateContent>
          </a:graphicData>
        </a:graphic>
      </p:graphicFrame>
      <p:graphicFrame>
        <p:nvGraphicFramePr>
          <p:cNvPr id="40" name="Object 39">
            <a:extLst>
              <a:ext uri="{FF2B5EF4-FFF2-40B4-BE49-F238E27FC236}">
                <a16:creationId xmlns:a16="http://schemas.microsoft.com/office/drawing/2014/main" id="{9DD8CAB0-B12F-E2FB-72C6-58CA717977C9}"/>
              </a:ext>
            </a:extLst>
          </p:cNvPr>
          <p:cNvGraphicFramePr>
            <a:graphicFrameLocks noChangeAspect="1"/>
          </p:cNvGraphicFramePr>
          <p:nvPr>
            <p:extLst>
              <p:ext uri="{D42A27DB-BD31-4B8C-83A1-F6EECF244321}">
                <p14:modId xmlns:p14="http://schemas.microsoft.com/office/powerpoint/2010/main" val="14646752"/>
              </p:ext>
            </p:extLst>
          </p:nvPr>
        </p:nvGraphicFramePr>
        <p:xfrm>
          <a:off x="2990363" y="8594138"/>
          <a:ext cx="1276965" cy="974725"/>
        </p:xfrm>
        <a:graphic>
          <a:graphicData uri="http://schemas.openxmlformats.org/presentationml/2006/ole">
            <mc:AlternateContent xmlns:mc="http://schemas.openxmlformats.org/markup-compatibility/2006">
              <mc:Choice xmlns:v="urn:schemas-microsoft-com:vml" Requires="v">
                <p:oleObj name="Prism 8" r:id="rId13" imgW="5110336" imgH="3912632" progId="Prism8.Document">
                  <p:embed/>
                </p:oleObj>
              </mc:Choice>
              <mc:Fallback>
                <p:oleObj name="Prism 8" r:id="rId13" imgW="5110336" imgH="3912632" progId="Prism8.Document">
                  <p:embed/>
                  <p:pic>
                    <p:nvPicPr>
                      <p:cNvPr id="40" name="Object 39">
                        <a:extLst>
                          <a:ext uri="{FF2B5EF4-FFF2-40B4-BE49-F238E27FC236}">
                            <a16:creationId xmlns:a16="http://schemas.microsoft.com/office/drawing/2014/main" id="{9DD8CAB0-B12F-E2FB-72C6-58CA717977C9}"/>
                          </a:ext>
                        </a:extLst>
                      </p:cNvPr>
                      <p:cNvPicPr/>
                      <p:nvPr/>
                    </p:nvPicPr>
                    <p:blipFill>
                      <a:blip r:embed="rId14"/>
                      <a:stretch>
                        <a:fillRect/>
                      </a:stretch>
                    </p:blipFill>
                    <p:spPr>
                      <a:xfrm>
                        <a:off x="2990363" y="8594138"/>
                        <a:ext cx="1276965" cy="974725"/>
                      </a:xfrm>
                      <a:prstGeom prst="rect">
                        <a:avLst/>
                      </a:prstGeom>
                    </p:spPr>
                  </p:pic>
                </p:oleObj>
              </mc:Fallback>
            </mc:AlternateContent>
          </a:graphicData>
        </a:graphic>
      </p:graphicFrame>
      <p:sp>
        <p:nvSpPr>
          <p:cNvPr id="41" name="Title 14">
            <a:extLst>
              <a:ext uri="{FF2B5EF4-FFF2-40B4-BE49-F238E27FC236}">
                <a16:creationId xmlns:a16="http://schemas.microsoft.com/office/drawing/2014/main" id="{2DB41E03-24E5-EEDD-7046-25B06366DAA3}"/>
              </a:ext>
            </a:extLst>
          </p:cNvPr>
          <p:cNvSpPr txBox="1">
            <a:spLocks/>
          </p:cNvSpPr>
          <p:nvPr/>
        </p:nvSpPr>
        <p:spPr>
          <a:xfrm>
            <a:off x="5045373" y="936481"/>
            <a:ext cx="1728891" cy="194424"/>
          </a:xfrm>
          <a:prstGeom prst="rect">
            <a:avLst/>
          </a:prstGeom>
        </p:spPr>
        <p:txBody>
          <a:bodyPr vert="horz" lIns="0" tIns="0" rIns="0" bIns="0" rtlCol="0" anchor="t">
            <a:normAutofit/>
          </a:bodyPr>
          <a:lst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a:lstStyle>
          <a:p>
            <a:r>
              <a:rPr lang="en-US" sz="900" b="1" dirty="0">
                <a:solidFill>
                  <a:srgbClr val="191B1B"/>
                </a:solidFill>
              </a:rPr>
              <a:t>ST1799PBR, PIK3CA_E542K</a:t>
            </a:r>
          </a:p>
          <a:p>
            <a:endParaRPr lang="en-US" sz="900" b="1" dirty="0">
              <a:solidFill>
                <a:srgbClr val="191B1B"/>
              </a:solidFill>
            </a:endParaRPr>
          </a:p>
          <a:p>
            <a:endParaRPr lang="en-US" sz="900" b="1" dirty="0">
              <a:solidFill>
                <a:srgbClr val="191B1B"/>
              </a:solidFill>
            </a:endParaRPr>
          </a:p>
        </p:txBody>
      </p:sp>
      <p:graphicFrame>
        <p:nvGraphicFramePr>
          <p:cNvPr id="45" name="Object 44">
            <a:extLst>
              <a:ext uri="{FF2B5EF4-FFF2-40B4-BE49-F238E27FC236}">
                <a16:creationId xmlns:a16="http://schemas.microsoft.com/office/drawing/2014/main" id="{4A14629F-CFCD-DEC4-864C-A14EA62EC529}"/>
              </a:ext>
            </a:extLst>
          </p:cNvPr>
          <p:cNvGraphicFramePr>
            <a:graphicFrameLocks noChangeAspect="1"/>
          </p:cNvGraphicFramePr>
          <p:nvPr>
            <p:extLst>
              <p:ext uri="{D42A27DB-BD31-4B8C-83A1-F6EECF244321}">
                <p14:modId xmlns:p14="http://schemas.microsoft.com/office/powerpoint/2010/main" val="143989795"/>
              </p:ext>
            </p:extLst>
          </p:nvPr>
        </p:nvGraphicFramePr>
        <p:xfrm>
          <a:off x="4474156" y="7775114"/>
          <a:ext cx="1721674" cy="1777078"/>
        </p:xfrm>
        <a:graphic>
          <a:graphicData uri="http://schemas.openxmlformats.org/presentationml/2006/ole">
            <mc:AlternateContent xmlns:mc="http://schemas.openxmlformats.org/markup-compatibility/2006">
              <mc:Choice xmlns:v="urn:schemas-microsoft-com:vml" Requires="v">
                <p:oleObj name="Prism 8" r:id="rId15" imgW="6569197" imgH="6720280" progId="Prism8.Document">
                  <p:embed/>
                </p:oleObj>
              </mc:Choice>
              <mc:Fallback>
                <p:oleObj name="Prism 8" r:id="rId15" imgW="6569197" imgH="6720280" progId="Prism8.Document">
                  <p:embed/>
                  <p:pic>
                    <p:nvPicPr>
                      <p:cNvPr id="45" name="Object 44">
                        <a:extLst>
                          <a:ext uri="{FF2B5EF4-FFF2-40B4-BE49-F238E27FC236}">
                            <a16:creationId xmlns:a16="http://schemas.microsoft.com/office/drawing/2014/main" id="{4A14629F-CFCD-DEC4-864C-A14EA62EC529}"/>
                          </a:ext>
                        </a:extLst>
                      </p:cNvPr>
                      <p:cNvPicPr/>
                      <p:nvPr/>
                    </p:nvPicPr>
                    <p:blipFill>
                      <a:blip r:embed="rId16"/>
                      <a:stretch>
                        <a:fillRect/>
                      </a:stretch>
                    </p:blipFill>
                    <p:spPr>
                      <a:xfrm>
                        <a:off x="4474156" y="7775114"/>
                        <a:ext cx="1721674" cy="1777078"/>
                      </a:xfrm>
                      <a:prstGeom prst="rect">
                        <a:avLst/>
                      </a:prstGeom>
                    </p:spPr>
                  </p:pic>
                </p:oleObj>
              </mc:Fallback>
            </mc:AlternateContent>
          </a:graphicData>
        </a:graphic>
      </p:graphicFrame>
      <p:sp>
        <p:nvSpPr>
          <p:cNvPr id="7" name="Title 14">
            <a:extLst>
              <a:ext uri="{FF2B5EF4-FFF2-40B4-BE49-F238E27FC236}">
                <a16:creationId xmlns:a16="http://schemas.microsoft.com/office/drawing/2014/main" id="{690B4F0A-23A9-327F-F2C4-F9A788044BCE}"/>
              </a:ext>
            </a:extLst>
          </p:cNvPr>
          <p:cNvSpPr txBox="1">
            <a:spLocks/>
          </p:cNvSpPr>
          <p:nvPr/>
        </p:nvSpPr>
        <p:spPr>
          <a:xfrm>
            <a:off x="584228" y="7459228"/>
            <a:ext cx="2245350" cy="566678"/>
          </a:xfrm>
          <a:prstGeom prst="rect">
            <a:avLst/>
          </a:prstGeom>
        </p:spPr>
        <p:txBody>
          <a:bodyPr vert="horz" lIns="0" tIns="0" rIns="0" bIns="0" rtlCol="0" anchor="t">
            <a:normAutofit/>
          </a:bodyPr>
          <a:lstStyle>
            <a:lvl1pPr algn="l" defTabSz="914400" rtl="0" eaLnBrk="1" latinLnBrk="0" hangingPunct="1">
              <a:lnSpc>
                <a:spcPct val="100000"/>
              </a:lnSpc>
              <a:spcBef>
                <a:spcPct val="0"/>
              </a:spcBef>
              <a:buNone/>
              <a:defRPr sz="3600" kern="1200">
                <a:solidFill>
                  <a:schemeClr val="accent1"/>
                </a:solidFill>
                <a:latin typeface="+mj-lt"/>
                <a:ea typeface="+mj-ea"/>
                <a:cs typeface="+mj-cs"/>
              </a:defRPr>
            </a:lvl1pPr>
          </a:lstStyle>
          <a:p>
            <a:r>
              <a:rPr lang="en-US" sz="900" b="1">
                <a:solidFill>
                  <a:srgbClr val="191B1B"/>
                </a:solidFill>
              </a:rPr>
              <a:t>ST1799PBR, PIK3CA_E542K</a:t>
            </a:r>
          </a:p>
        </p:txBody>
      </p:sp>
      <p:sp>
        <p:nvSpPr>
          <p:cNvPr id="2" name="TextBox 1">
            <a:extLst>
              <a:ext uri="{FF2B5EF4-FFF2-40B4-BE49-F238E27FC236}">
                <a16:creationId xmlns:a16="http://schemas.microsoft.com/office/drawing/2014/main" id="{BE2508A1-9A9A-E18E-A7B4-4FE48DAA8314}"/>
              </a:ext>
            </a:extLst>
          </p:cNvPr>
          <p:cNvSpPr txBox="1"/>
          <p:nvPr/>
        </p:nvSpPr>
        <p:spPr>
          <a:xfrm>
            <a:off x="129655" y="85230"/>
            <a:ext cx="6202185" cy="292388"/>
          </a:xfrm>
          <a:prstGeom prst="rect">
            <a:avLst/>
          </a:prstGeom>
          <a:noFill/>
        </p:spPr>
        <p:txBody>
          <a:bodyPr wrap="square" lIns="91440" tIns="45720" rIns="91440" bIns="45720" rtlCol="0" anchor="t">
            <a:spAutoFit/>
          </a:bodyPr>
          <a:lstStyle/>
          <a:p>
            <a:r>
              <a:rPr lang="en-GB" sz="1300"/>
              <a:t>Supplementary Figure 7</a:t>
            </a:r>
          </a:p>
        </p:txBody>
      </p:sp>
      <p:pic>
        <p:nvPicPr>
          <p:cNvPr id="6" name="Picture 5">
            <a:extLst>
              <a:ext uri="{FF2B5EF4-FFF2-40B4-BE49-F238E27FC236}">
                <a16:creationId xmlns:a16="http://schemas.microsoft.com/office/drawing/2014/main" id="{8B93F78C-5465-C3B4-55BB-B0B78FAE47BA}"/>
              </a:ext>
            </a:extLst>
          </p:cNvPr>
          <p:cNvPicPr>
            <a:picLocks noChangeAspect="1"/>
          </p:cNvPicPr>
          <p:nvPr/>
        </p:nvPicPr>
        <p:blipFill rotWithShape="1">
          <a:blip r:embed="rId17"/>
          <a:srcRect l="47234"/>
          <a:stretch/>
        </p:blipFill>
        <p:spPr>
          <a:xfrm>
            <a:off x="4637670" y="3496260"/>
            <a:ext cx="2216447" cy="2266950"/>
          </a:xfrm>
          <a:prstGeom prst="rect">
            <a:avLst/>
          </a:prstGeom>
        </p:spPr>
      </p:pic>
      <p:pic>
        <p:nvPicPr>
          <p:cNvPr id="10" name="Picture 9">
            <a:extLst>
              <a:ext uri="{FF2B5EF4-FFF2-40B4-BE49-F238E27FC236}">
                <a16:creationId xmlns:a16="http://schemas.microsoft.com/office/drawing/2014/main" id="{74B9AF25-111D-744A-9834-77CD88FB1CD0}"/>
              </a:ext>
            </a:extLst>
          </p:cNvPr>
          <p:cNvPicPr>
            <a:picLocks noChangeAspect="1"/>
          </p:cNvPicPr>
          <p:nvPr/>
        </p:nvPicPr>
        <p:blipFill rotWithShape="1">
          <a:blip r:embed="rId18"/>
          <a:srcRect r="50472"/>
          <a:stretch/>
        </p:blipFill>
        <p:spPr>
          <a:xfrm>
            <a:off x="4594476" y="1227161"/>
            <a:ext cx="2147571" cy="2340103"/>
          </a:xfrm>
          <a:prstGeom prst="rect">
            <a:avLst/>
          </a:prstGeom>
        </p:spPr>
      </p:pic>
      <p:pic>
        <p:nvPicPr>
          <p:cNvPr id="11" name="Picture 10">
            <a:extLst>
              <a:ext uri="{FF2B5EF4-FFF2-40B4-BE49-F238E27FC236}">
                <a16:creationId xmlns:a16="http://schemas.microsoft.com/office/drawing/2014/main" id="{18C17C1E-4216-6857-83AB-2F372086566C}"/>
              </a:ext>
            </a:extLst>
          </p:cNvPr>
          <p:cNvPicPr>
            <a:picLocks noChangeAspect="1"/>
          </p:cNvPicPr>
          <p:nvPr/>
        </p:nvPicPr>
        <p:blipFill rotWithShape="1">
          <a:blip r:embed="rId19"/>
          <a:srcRect l="25584" t="6470"/>
          <a:stretch/>
        </p:blipFill>
        <p:spPr>
          <a:xfrm>
            <a:off x="463945" y="477612"/>
            <a:ext cx="4080733" cy="7020583"/>
          </a:xfrm>
          <a:prstGeom prst="rect">
            <a:avLst/>
          </a:prstGeom>
        </p:spPr>
      </p:pic>
      <p:pic>
        <p:nvPicPr>
          <p:cNvPr id="12" name="Picture 11">
            <a:extLst>
              <a:ext uri="{FF2B5EF4-FFF2-40B4-BE49-F238E27FC236}">
                <a16:creationId xmlns:a16="http://schemas.microsoft.com/office/drawing/2014/main" id="{88E0439D-DBC0-DB70-4CCC-6DE4EFB20DF1}"/>
              </a:ext>
            </a:extLst>
          </p:cNvPr>
          <p:cNvPicPr>
            <a:picLocks noChangeAspect="1"/>
          </p:cNvPicPr>
          <p:nvPr/>
        </p:nvPicPr>
        <p:blipFill rotWithShape="1">
          <a:blip r:embed="rId20"/>
          <a:srcRect r="71550" b="73620"/>
          <a:stretch/>
        </p:blipFill>
        <p:spPr>
          <a:xfrm>
            <a:off x="153719" y="696398"/>
            <a:ext cx="744185" cy="883140"/>
          </a:xfrm>
          <a:prstGeom prst="rect">
            <a:avLst/>
          </a:prstGeom>
        </p:spPr>
      </p:pic>
    </p:spTree>
    <p:extLst>
      <p:ext uri="{BB962C8B-B14F-4D97-AF65-F5344CB8AC3E}">
        <p14:creationId xmlns:p14="http://schemas.microsoft.com/office/powerpoint/2010/main" val="278346150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mso-contentType ?>
<SharedContentType xmlns="Microsoft.SharePoint.Taxonomy.ContentTypeSync" SourceId="1ee89e71-04cd-405e-9ca3-99e020c1694d" ContentTypeId="0x0101" PreviousValue="false"/>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Keyword xmlns="44a56295-c29e-4898-8136-a54736c65b82" xsi:nil="true"/>
    <Descriptions xmlns="44a56295-c29e-4898-8136-a54736c65b82" xsi:nil="true"/>
  </documentManagement>
</p:properties>
</file>

<file path=customXml/item4.xml><?xml version="1.0" encoding="utf-8"?>
<ct:contentTypeSchema xmlns:ct="http://schemas.microsoft.com/office/2006/metadata/contentType" xmlns:ma="http://schemas.microsoft.com/office/2006/metadata/properties/metaAttributes" ct:_="" ma:_="" ma:contentTypeName="Document" ma:contentTypeID="0x010100A9AF5EF96340AC48B726C506E8B15B15" ma:contentTypeVersion="14" ma:contentTypeDescription="Create a new document." ma:contentTypeScope="" ma:versionID="5f04e5f7d711c040e88f7f85bb8f2794">
  <xsd:schema xmlns:xsd="http://www.w3.org/2001/XMLSchema" xmlns:xs="http://www.w3.org/2001/XMLSchema" xmlns:p="http://schemas.microsoft.com/office/2006/metadata/properties" xmlns:ns3="44a56295-c29e-4898-8136-a54736c65b82" xmlns:ns4="a44f8e98-95b4-4cef-a66d-330f813bee15" xmlns:ns5="7eec315f-2f2a-446d-a2fc-dd0d7305dc11" targetNamespace="http://schemas.microsoft.com/office/2006/metadata/properties" ma:root="true" ma:fieldsID="59e2e67fc5d9078550713f4fdb5cb348" ns3:_="" ns4:_="" ns5:_="">
    <xsd:import namespace="44a56295-c29e-4898-8136-a54736c65b82"/>
    <xsd:import namespace="a44f8e98-95b4-4cef-a66d-330f813bee15"/>
    <xsd:import namespace="7eec315f-2f2a-446d-a2fc-dd0d7305dc11"/>
    <xsd:element name="properties">
      <xsd:complexType>
        <xsd:sequence>
          <xsd:element name="documentManagement">
            <xsd:complexType>
              <xsd:all>
                <xsd:element ref="ns3:Descriptions" minOccurs="0"/>
                <xsd:element ref="ns3:Keyword" minOccurs="0"/>
                <xsd:element ref="ns4:MediaServiceDateTaken" minOccurs="0"/>
                <xsd:element ref="ns4:MediaServiceAutoTags" minOccurs="0"/>
                <xsd:element ref="ns4:MediaServiceOCR" minOccurs="0"/>
                <xsd:element ref="ns4:MediaServiceMetadata" minOccurs="0"/>
                <xsd:element ref="ns4:MediaServiceFastMetadata" minOccurs="0"/>
                <xsd:element ref="ns4:MediaServiceLocation" minOccurs="0"/>
                <xsd:element ref="ns5:SharedWithUsers" minOccurs="0"/>
                <xsd:element ref="ns5:SharedWithDetails" minOccurs="0"/>
                <xsd:element ref="ns5:SharingHintHash" minOccurs="0"/>
                <xsd:element ref="ns4:MediaServiceAutoKeyPoints" minOccurs="0"/>
                <xsd:element ref="ns4:MediaServiceKeyPoints" minOccurs="0"/>
                <xsd:element ref="ns4:MediaServiceGenerationTime" minOccurs="0"/>
                <xsd:element ref="ns4:MediaServiceEventHashCode" minOccurs="0"/>
                <xsd:element ref="ns4: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4a56295-c29e-4898-8136-a54736c65b82" elementFormDefault="qualified">
    <xsd:import namespace="http://schemas.microsoft.com/office/2006/documentManagement/types"/>
    <xsd:import namespace="http://schemas.microsoft.com/office/infopath/2007/PartnerControls"/>
    <xsd:element name="Descriptions" ma:index="8" nillable="true" ma:displayName="Descriptions" ma:description="Describe your document to make it appear at the top of search results" ma:internalName="Descriptions">
      <xsd:simpleType>
        <xsd:restriction base="dms:Note">
          <xsd:maxLength value="255"/>
        </xsd:restriction>
      </xsd:simpleType>
    </xsd:element>
    <xsd:element name="Keyword" ma:index="9" nillable="true" ma:displayName="Keyword" ma:description="Enter list of terms separated by semi-colon(;)" ma:internalName="Keyword">
      <xsd:simpleType>
        <xsd:restriction base="dms:Text">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a44f8e98-95b4-4cef-a66d-330f813bee15" elementFormDefault="qualified">
    <xsd:import namespace="http://schemas.microsoft.com/office/2006/documentManagement/types"/>
    <xsd:import namespace="http://schemas.microsoft.com/office/infopath/2007/PartnerControls"/>
    <xsd:element name="MediaServiceDateTaken" ma:index="10" nillable="true" ma:displayName="MediaServiceDateTaken" ma:description="" ma:hidden="true" ma:internalName="MediaServiceDateTaken" ma:readOnly="true">
      <xsd:simpleType>
        <xsd:restriction base="dms:Text"/>
      </xsd:simpleType>
    </xsd:element>
    <xsd:element name="MediaServiceAutoTags" ma:index="11" nillable="true" ma:displayName="MediaServiceAutoTags" ma:description="" ma:internalName="MediaServiceAutoTags" ma:readOnly="true">
      <xsd:simpleType>
        <xsd:restriction base="dms:Text"/>
      </xsd:simpleType>
    </xsd:element>
    <xsd:element name="MediaServiceOCR" ma:index="12" nillable="true" ma:displayName="MediaServiceOCR" ma:internalName="MediaServiceOCR" ma:readOnly="true">
      <xsd:simpleType>
        <xsd:restriction base="dms:Note">
          <xsd:maxLength value="255"/>
        </xsd:restriction>
      </xsd:simpleType>
    </xsd:element>
    <xsd:element name="MediaServiceMetadata" ma:index="13" nillable="true" ma:displayName="MediaServiceMetadata" ma:description="" ma:hidden="true" ma:internalName="MediaServiceMetadata" ma:readOnly="true">
      <xsd:simpleType>
        <xsd:restriction base="dms:Note"/>
      </xsd:simpleType>
    </xsd:element>
    <xsd:element name="MediaServiceFastMetadata" ma:index="14" nillable="true" ma:displayName="MediaServiceFastMetadata" ma:description="" ma:hidden="true" ma:internalName="MediaServiceFastMetadata" ma:readOnly="true">
      <xsd:simpleType>
        <xsd:restriction base="dms:Note"/>
      </xsd:simpleType>
    </xsd:element>
    <xsd:element name="MediaServiceLocation" ma:index="15" nillable="true" ma:displayName="Location" ma:internalName="MediaServiceLocation"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element name="MediaServiceGenerationTime" ma:index="21" nillable="true" ma:displayName="MediaServiceGenerationTime" ma:hidden="true" ma:internalName="MediaServiceGenerationTime" ma:readOnly="true">
      <xsd:simpleType>
        <xsd:restriction base="dms:Text"/>
      </xsd:simpleType>
    </xsd:element>
    <xsd:element name="MediaServiceEventHashCode" ma:index="22" nillable="true" ma:displayName="MediaServiceEventHashCode" ma:hidden="true" ma:internalName="MediaServiceEventHashCode" ma:readOnly="true">
      <xsd:simpleType>
        <xsd:restriction base="dms:Text"/>
      </xsd:simpleType>
    </xsd:element>
    <xsd:element name="MediaLengthInSeconds" ma:index="23"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7eec315f-2f2a-446d-a2fc-dd0d7305dc11"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SharingHintHash" ma:index="18"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63EE447-6332-4774-A175-0A357E5A44CE}">
  <ds:schemaRefs>
    <ds:schemaRef ds:uri="Microsoft.SharePoint.Taxonomy.ContentTypeSync"/>
  </ds:schemaRefs>
</ds:datastoreItem>
</file>

<file path=customXml/itemProps2.xml><?xml version="1.0" encoding="utf-8"?>
<ds:datastoreItem xmlns:ds="http://schemas.openxmlformats.org/officeDocument/2006/customXml" ds:itemID="{BF6067CE-FAA4-4416-8BCE-D101D571B724}">
  <ds:schemaRefs>
    <ds:schemaRef ds:uri="http://schemas.microsoft.com/sharepoint/v3/contenttype/forms"/>
  </ds:schemaRefs>
</ds:datastoreItem>
</file>

<file path=customXml/itemProps3.xml><?xml version="1.0" encoding="utf-8"?>
<ds:datastoreItem xmlns:ds="http://schemas.openxmlformats.org/officeDocument/2006/customXml" ds:itemID="{4A726ABE-7478-4A3C-B9CD-D371263C9998}">
  <ds:schemaRefs>
    <ds:schemaRef ds:uri="http://purl.org/dc/elements/1.1/"/>
    <ds:schemaRef ds:uri="http://schemas.microsoft.com/office/2006/documentManagement/types"/>
    <ds:schemaRef ds:uri="44a56295-c29e-4898-8136-a54736c65b82"/>
    <ds:schemaRef ds:uri="http://purl.org/dc/terms/"/>
    <ds:schemaRef ds:uri="http://www.w3.org/XML/1998/namespace"/>
    <ds:schemaRef ds:uri="7eec315f-2f2a-446d-a2fc-dd0d7305dc11"/>
    <ds:schemaRef ds:uri="http://schemas.microsoft.com/office/infopath/2007/PartnerControls"/>
    <ds:schemaRef ds:uri="a44f8e98-95b4-4cef-a66d-330f813bee15"/>
    <ds:schemaRef ds:uri="http://schemas.openxmlformats.org/package/2006/metadata/core-properties"/>
    <ds:schemaRef ds:uri="http://schemas.microsoft.com/office/2006/metadata/properties"/>
    <ds:schemaRef ds:uri="http://purl.org/dc/dcmitype/"/>
  </ds:schemaRefs>
</ds:datastoreItem>
</file>

<file path=customXml/itemProps4.xml><?xml version="1.0" encoding="utf-8"?>
<ds:datastoreItem xmlns:ds="http://schemas.openxmlformats.org/officeDocument/2006/customXml" ds:itemID="{67851697-680A-4B68-BD3D-5E850A17CA99}">
  <ds:schemaRefs>
    <ds:schemaRef ds:uri="44a56295-c29e-4898-8136-a54736c65b82"/>
    <ds:schemaRef ds:uri="7eec315f-2f2a-446d-a2fc-dd0d7305dc11"/>
    <ds:schemaRef ds:uri="a44f8e98-95b4-4cef-a66d-330f813bee15"/>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emplate>Office Theme</Template>
  <TotalTime>165</TotalTime>
  <Words>1042</Words>
  <Application>Microsoft Office PowerPoint</Application>
  <PresentationFormat>A4 Paper (210x297 mm)</PresentationFormat>
  <Paragraphs>230</Paragraphs>
  <Slides>7</Slides>
  <Notes>6</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2" baseType="lpstr">
      <vt:lpstr>Arial</vt:lpstr>
      <vt:lpstr>Calibri</vt:lpstr>
      <vt:lpstr>Calibri Light</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Hopcroft, Lorna</dc:creator>
  <cp:lastModifiedBy>Barry, Simon</cp:lastModifiedBy>
  <cp:revision>1</cp:revision>
  <cp:lastPrinted>2023-06-08T14:41:05Z</cp:lastPrinted>
  <dcterms:created xsi:type="dcterms:W3CDTF">2022-10-04T12:03:26Z</dcterms:created>
  <dcterms:modified xsi:type="dcterms:W3CDTF">2023-06-28T12:12: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9AF5EF96340AC48B726C506E8B15B15</vt:lpwstr>
  </property>
</Properties>
</file>